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16459200" cy="9144000"/>
  <p:notesSz cx="16459200" cy="9144000"/>
  <p:defaultTextStyle>
    <a:defPPr>
      <a:defRPr kern="0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1234440" y="2834640"/>
            <a:ext cx="13990320" cy="1920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2468880" y="5120640"/>
            <a:ext cx="11521440" cy="228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822960" y="2103120"/>
            <a:ext cx="7159752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8476488" y="2103120"/>
            <a:ext cx="7159752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488695" y="3583304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" name="bg object 17"/>
          <p:cNvSpPr/>
          <p:nvPr/>
        </p:nvSpPr>
        <p:spPr>
          <a:xfrm>
            <a:off x="488695" y="2766060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" name="bg object 18"/>
          <p:cNvSpPr/>
          <p:nvPr/>
        </p:nvSpPr>
        <p:spPr>
          <a:xfrm>
            <a:off x="488695" y="1948688"/>
            <a:ext cx="15901035" cy="0"/>
          </a:xfrm>
          <a:custGeom>
            <a:avLst/>
            <a:gdLst/>
            <a:ahLst/>
            <a:cxnLst/>
            <a:rect l="l" t="t" r="r" b="b"/>
            <a:pathLst>
              <a:path w="15901035" h="0">
                <a:moveTo>
                  <a:pt x="0" y="0"/>
                </a:moveTo>
                <a:lnTo>
                  <a:pt x="15900908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" name="bg object 19"/>
          <p:cNvSpPr/>
          <p:nvPr/>
        </p:nvSpPr>
        <p:spPr>
          <a:xfrm>
            <a:off x="488696" y="567436"/>
            <a:ext cx="15901035" cy="3416935"/>
          </a:xfrm>
          <a:custGeom>
            <a:avLst/>
            <a:gdLst/>
            <a:ahLst/>
            <a:cxnLst/>
            <a:rect l="l" t="t" r="r" b="b"/>
            <a:pathLst>
              <a:path w="15901035" h="3416935">
                <a:moveTo>
                  <a:pt x="0" y="563880"/>
                </a:moveTo>
                <a:lnTo>
                  <a:pt x="15900908" y="563880"/>
                </a:lnTo>
              </a:path>
              <a:path w="15901035" h="3416935">
                <a:moveTo>
                  <a:pt x="2168271" y="3416427"/>
                </a:moveTo>
                <a:lnTo>
                  <a:pt x="2168271" y="0"/>
                </a:lnTo>
              </a:path>
              <a:path w="15901035" h="3416935">
                <a:moveTo>
                  <a:pt x="5059426" y="3416427"/>
                </a:moveTo>
                <a:lnTo>
                  <a:pt x="5059426" y="0"/>
                </a:lnTo>
              </a:path>
              <a:path w="15901035" h="3416935">
                <a:moveTo>
                  <a:pt x="7950454" y="3416427"/>
                </a:moveTo>
                <a:lnTo>
                  <a:pt x="7950454" y="0"/>
                </a:lnTo>
              </a:path>
              <a:path w="15901035" h="3416935">
                <a:moveTo>
                  <a:pt x="10841482" y="3416427"/>
                </a:moveTo>
                <a:lnTo>
                  <a:pt x="10841482" y="0"/>
                </a:lnTo>
              </a:path>
              <a:path w="15901035" h="3416935">
                <a:moveTo>
                  <a:pt x="13732637" y="3416427"/>
                </a:moveTo>
                <a:lnTo>
                  <a:pt x="13732637" y="0"/>
                </a:lnTo>
              </a:path>
            </a:pathLst>
          </a:custGeom>
          <a:ln w="6731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" name="bg object 20"/>
          <p:cNvSpPr/>
          <p:nvPr/>
        </p:nvSpPr>
        <p:spPr>
          <a:xfrm>
            <a:off x="488696" y="567436"/>
            <a:ext cx="15901035" cy="3416935"/>
          </a:xfrm>
          <a:custGeom>
            <a:avLst/>
            <a:gdLst/>
            <a:ahLst/>
            <a:cxnLst/>
            <a:rect l="l" t="t" r="r" b="b"/>
            <a:pathLst>
              <a:path w="15901035" h="3416935">
                <a:moveTo>
                  <a:pt x="0" y="2607310"/>
                </a:moveTo>
                <a:lnTo>
                  <a:pt x="15900908" y="2607310"/>
                </a:lnTo>
              </a:path>
              <a:path w="15901035" h="3416935">
                <a:moveTo>
                  <a:pt x="0" y="1789938"/>
                </a:moveTo>
                <a:lnTo>
                  <a:pt x="15900908" y="1789938"/>
                </a:lnTo>
              </a:path>
              <a:path w="15901035" h="3416935">
                <a:moveTo>
                  <a:pt x="0" y="972566"/>
                </a:moveTo>
                <a:lnTo>
                  <a:pt x="15900908" y="972566"/>
                </a:lnTo>
              </a:path>
              <a:path w="15901035" h="3416935">
                <a:moveTo>
                  <a:pt x="0" y="155321"/>
                </a:moveTo>
                <a:lnTo>
                  <a:pt x="15900908" y="155321"/>
                </a:lnTo>
              </a:path>
              <a:path w="15901035" h="3416935">
                <a:moveTo>
                  <a:pt x="722757" y="3416427"/>
                </a:moveTo>
                <a:lnTo>
                  <a:pt x="722757" y="0"/>
                </a:lnTo>
              </a:path>
              <a:path w="15901035" h="3416935">
                <a:moveTo>
                  <a:pt x="3613912" y="3416427"/>
                </a:moveTo>
                <a:lnTo>
                  <a:pt x="3613912" y="0"/>
                </a:lnTo>
              </a:path>
              <a:path w="15901035" h="3416935">
                <a:moveTo>
                  <a:pt x="6504939" y="3416427"/>
                </a:moveTo>
                <a:lnTo>
                  <a:pt x="6504939" y="0"/>
                </a:lnTo>
              </a:path>
              <a:path w="15901035" h="3416935">
                <a:moveTo>
                  <a:pt x="9395968" y="3416427"/>
                </a:moveTo>
                <a:lnTo>
                  <a:pt x="9395968" y="0"/>
                </a:lnTo>
              </a:path>
              <a:path w="15901035" h="3416935">
                <a:moveTo>
                  <a:pt x="12287123" y="3416427"/>
                </a:moveTo>
                <a:lnTo>
                  <a:pt x="12287123" y="0"/>
                </a:lnTo>
              </a:path>
              <a:path w="15901035" h="3416935">
                <a:moveTo>
                  <a:pt x="15178150" y="3416427"/>
                </a:moveTo>
                <a:lnTo>
                  <a:pt x="15178150" y="0"/>
                </a:lnTo>
              </a:path>
            </a:pathLst>
          </a:custGeom>
          <a:ln w="13589">
            <a:solidFill>
              <a:srgbClr val="EBEBEB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" name="bg object 21"/>
          <p:cNvSpPr/>
          <p:nvPr/>
        </p:nvSpPr>
        <p:spPr>
          <a:xfrm>
            <a:off x="1211452" y="722757"/>
            <a:ext cx="14340205" cy="162560"/>
          </a:xfrm>
          <a:custGeom>
            <a:avLst/>
            <a:gdLst/>
            <a:ahLst/>
            <a:cxnLst/>
            <a:rect l="l" t="t" r="r" b="b"/>
            <a:pathLst>
              <a:path w="14340205" h="162559">
                <a:moveTo>
                  <a:pt x="0" y="0"/>
                </a:moveTo>
                <a:lnTo>
                  <a:pt x="0" y="0"/>
                </a:lnTo>
                <a:lnTo>
                  <a:pt x="404749" y="0"/>
                </a:lnTo>
                <a:lnTo>
                  <a:pt x="520446" y="0"/>
                </a:lnTo>
                <a:lnTo>
                  <a:pt x="578230" y="0"/>
                </a:lnTo>
                <a:lnTo>
                  <a:pt x="636016" y="0"/>
                </a:lnTo>
                <a:lnTo>
                  <a:pt x="693928" y="0"/>
                </a:lnTo>
                <a:lnTo>
                  <a:pt x="751713" y="0"/>
                </a:lnTo>
                <a:lnTo>
                  <a:pt x="809497" y="0"/>
                </a:lnTo>
                <a:lnTo>
                  <a:pt x="867283" y="0"/>
                </a:lnTo>
                <a:lnTo>
                  <a:pt x="925195" y="0"/>
                </a:lnTo>
                <a:lnTo>
                  <a:pt x="982979" y="0"/>
                </a:lnTo>
                <a:lnTo>
                  <a:pt x="1040765" y="0"/>
                </a:lnTo>
                <a:lnTo>
                  <a:pt x="1098677" y="0"/>
                </a:lnTo>
                <a:lnTo>
                  <a:pt x="1156461" y="0"/>
                </a:lnTo>
                <a:lnTo>
                  <a:pt x="1156461" y="1397"/>
                </a:lnTo>
                <a:lnTo>
                  <a:pt x="1214247" y="1397"/>
                </a:lnTo>
                <a:lnTo>
                  <a:pt x="1272032" y="1397"/>
                </a:lnTo>
                <a:lnTo>
                  <a:pt x="1272032" y="3048"/>
                </a:lnTo>
                <a:lnTo>
                  <a:pt x="1329944" y="3048"/>
                </a:lnTo>
                <a:lnTo>
                  <a:pt x="1387729" y="3048"/>
                </a:lnTo>
                <a:lnTo>
                  <a:pt x="1445514" y="3048"/>
                </a:lnTo>
                <a:lnTo>
                  <a:pt x="1503426" y="3048"/>
                </a:lnTo>
                <a:lnTo>
                  <a:pt x="1561211" y="3048"/>
                </a:lnTo>
                <a:lnTo>
                  <a:pt x="1618996" y="3048"/>
                </a:lnTo>
                <a:lnTo>
                  <a:pt x="1676780" y="3048"/>
                </a:lnTo>
                <a:lnTo>
                  <a:pt x="1734692" y="3048"/>
                </a:lnTo>
                <a:lnTo>
                  <a:pt x="1792477" y="3048"/>
                </a:lnTo>
                <a:lnTo>
                  <a:pt x="1850263" y="3048"/>
                </a:lnTo>
                <a:lnTo>
                  <a:pt x="1908175" y="3048"/>
                </a:lnTo>
                <a:lnTo>
                  <a:pt x="1965960" y="3048"/>
                </a:lnTo>
                <a:lnTo>
                  <a:pt x="2023745" y="3048"/>
                </a:lnTo>
                <a:lnTo>
                  <a:pt x="2081530" y="3048"/>
                </a:lnTo>
                <a:lnTo>
                  <a:pt x="2139442" y="3048"/>
                </a:lnTo>
                <a:lnTo>
                  <a:pt x="2197227" y="3048"/>
                </a:lnTo>
                <a:lnTo>
                  <a:pt x="2197227" y="4699"/>
                </a:lnTo>
                <a:lnTo>
                  <a:pt x="2255012" y="4699"/>
                </a:lnTo>
                <a:lnTo>
                  <a:pt x="2255012" y="8000"/>
                </a:lnTo>
                <a:lnTo>
                  <a:pt x="2312924" y="8000"/>
                </a:lnTo>
                <a:lnTo>
                  <a:pt x="2312924" y="9651"/>
                </a:lnTo>
                <a:lnTo>
                  <a:pt x="2370709" y="9651"/>
                </a:lnTo>
                <a:lnTo>
                  <a:pt x="2370709" y="11429"/>
                </a:lnTo>
                <a:lnTo>
                  <a:pt x="2428494" y="11429"/>
                </a:lnTo>
                <a:lnTo>
                  <a:pt x="2428494" y="13081"/>
                </a:lnTo>
                <a:lnTo>
                  <a:pt x="2486406" y="13081"/>
                </a:lnTo>
                <a:lnTo>
                  <a:pt x="2544191" y="13081"/>
                </a:lnTo>
                <a:lnTo>
                  <a:pt x="2601976" y="13081"/>
                </a:lnTo>
                <a:lnTo>
                  <a:pt x="2659761" y="13081"/>
                </a:lnTo>
                <a:lnTo>
                  <a:pt x="2717673" y="13081"/>
                </a:lnTo>
                <a:lnTo>
                  <a:pt x="2775458" y="13081"/>
                </a:lnTo>
                <a:lnTo>
                  <a:pt x="2833243" y="13081"/>
                </a:lnTo>
                <a:lnTo>
                  <a:pt x="2891155" y="13081"/>
                </a:lnTo>
                <a:lnTo>
                  <a:pt x="2948940" y="13081"/>
                </a:lnTo>
                <a:lnTo>
                  <a:pt x="3006725" y="13081"/>
                </a:lnTo>
                <a:lnTo>
                  <a:pt x="3064510" y="13081"/>
                </a:lnTo>
                <a:lnTo>
                  <a:pt x="3064510" y="14859"/>
                </a:lnTo>
                <a:lnTo>
                  <a:pt x="3122422" y="14859"/>
                </a:lnTo>
                <a:lnTo>
                  <a:pt x="3180207" y="14859"/>
                </a:lnTo>
                <a:lnTo>
                  <a:pt x="3237992" y="14859"/>
                </a:lnTo>
                <a:lnTo>
                  <a:pt x="3295904" y="14859"/>
                </a:lnTo>
                <a:lnTo>
                  <a:pt x="3353689" y="14859"/>
                </a:lnTo>
                <a:lnTo>
                  <a:pt x="3411474" y="14859"/>
                </a:lnTo>
                <a:lnTo>
                  <a:pt x="3411474" y="16764"/>
                </a:lnTo>
                <a:lnTo>
                  <a:pt x="3469259" y="16764"/>
                </a:lnTo>
                <a:lnTo>
                  <a:pt x="3469259" y="18669"/>
                </a:lnTo>
                <a:lnTo>
                  <a:pt x="3527171" y="18669"/>
                </a:lnTo>
                <a:lnTo>
                  <a:pt x="3584956" y="18669"/>
                </a:lnTo>
                <a:lnTo>
                  <a:pt x="3642741" y="18669"/>
                </a:lnTo>
                <a:lnTo>
                  <a:pt x="3700653" y="18669"/>
                </a:lnTo>
                <a:lnTo>
                  <a:pt x="3758438" y="18669"/>
                </a:lnTo>
                <a:lnTo>
                  <a:pt x="3816223" y="18669"/>
                </a:lnTo>
                <a:lnTo>
                  <a:pt x="3874008" y="18669"/>
                </a:lnTo>
                <a:lnTo>
                  <a:pt x="3931920" y="18669"/>
                </a:lnTo>
                <a:lnTo>
                  <a:pt x="3989705" y="18669"/>
                </a:lnTo>
                <a:lnTo>
                  <a:pt x="4047490" y="18669"/>
                </a:lnTo>
                <a:lnTo>
                  <a:pt x="4105402" y="18669"/>
                </a:lnTo>
                <a:lnTo>
                  <a:pt x="4163187" y="18669"/>
                </a:lnTo>
                <a:lnTo>
                  <a:pt x="4220972" y="18669"/>
                </a:lnTo>
                <a:lnTo>
                  <a:pt x="4278757" y="18669"/>
                </a:lnTo>
                <a:lnTo>
                  <a:pt x="4336669" y="18669"/>
                </a:lnTo>
                <a:lnTo>
                  <a:pt x="4336669" y="20700"/>
                </a:lnTo>
                <a:lnTo>
                  <a:pt x="4394454" y="20700"/>
                </a:lnTo>
                <a:lnTo>
                  <a:pt x="4452239" y="20700"/>
                </a:lnTo>
                <a:lnTo>
                  <a:pt x="4510151" y="20700"/>
                </a:lnTo>
                <a:lnTo>
                  <a:pt x="4510151" y="22860"/>
                </a:lnTo>
                <a:lnTo>
                  <a:pt x="4567936" y="22860"/>
                </a:lnTo>
                <a:lnTo>
                  <a:pt x="4567936" y="25019"/>
                </a:lnTo>
                <a:lnTo>
                  <a:pt x="4625721" y="25019"/>
                </a:lnTo>
                <a:lnTo>
                  <a:pt x="4683506" y="25019"/>
                </a:lnTo>
                <a:lnTo>
                  <a:pt x="4741418" y="25019"/>
                </a:lnTo>
                <a:lnTo>
                  <a:pt x="4799203" y="25019"/>
                </a:lnTo>
                <a:lnTo>
                  <a:pt x="4856988" y="25019"/>
                </a:lnTo>
                <a:lnTo>
                  <a:pt x="4914900" y="25019"/>
                </a:lnTo>
                <a:lnTo>
                  <a:pt x="4972685" y="25019"/>
                </a:lnTo>
                <a:lnTo>
                  <a:pt x="5030470" y="25019"/>
                </a:lnTo>
                <a:lnTo>
                  <a:pt x="5088255" y="25019"/>
                </a:lnTo>
                <a:lnTo>
                  <a:pt x="5146167" y="25019"/>
                </a:lnTo>
                <a:lnTo>
                  <a:pt x="5203952" y="25019"/>
                </a:lnTo>
                <a:lnTo>
                  <a:pt x="5261737" y="25019"/>
                </a:lnTo>
                <a:lnTo>
                  <a:pt x="5261737" y="27304"/>
                </a:lnTo>
                <a:lnTo>
                  <a:pt x="5319649" y="27304"/>
                </a:lnTo>
                <a:lnTo>
                  <a:pt x="5377433" y="27304"/>
                </a:lnTo>
                <a:lnTo>
                  <a:pt x="5435219" y="27304"/>
                </a:lnTo>
                <a:lnTo>
                  <a:pt x="5435219" y="29591"/>
                </a:lnTo>
                <a:lnTo>
                  <a:pt x="5493004" y="29591"/>
                </a:lnTo>
                <a:lnTo>
                  <a:pt x="5550916" y="29591"/>
                </a:lnTo>
                <a:lnTo>
                  <a:pt x="5608701" y="29591"/>
                </a:lnTo>
                <a:lnTo>
                  <a:pt x="5666486" y="29591"/>
                </a:lnTo>
                <a:lnTo>
                  <a:pt x="5724398" y="29591"/>
                </a:lnTo>
                <a:lnTo>
                  <a:pt x="5724398" y="34544"/>
                </a:lnTo>
                <a:lnTo>
                  <a:pt x="5782183" y="34544"/>
                </a:lnTo>
                <a:lnTo>
                  <a:pt x="5839968" y="34544"/>
                </a:lnTo>
                <a:lnTo>
                  <a:pt x="5897753" y="34544"/>
                </a:lnTo>
                <a:lnTo>
                  <a:pt x="5955665" y="34544"/>
                </a:lnTo>
                <a:lnTo>
                  <a:pt x="6013450" y="34544"/>
                </a:lnTo>
                <a:lnTo>
                  <a:pt x="6071235" y="34544"/>
                </a:lnTo>
                <a:lnTo>
                  <a:pt x="6129147" y="34544"/>
                </a:lnTo>
                <a:lnTo>
                  <a:pt x="6186932" y="34544"/>
                </a:lnTo>
                <a:lnTo>
                  <a:pt x="6244717" y="34544"/>
                </a:lnTo>
                <a:lnTo>
                  <a:pt x="6302502" y="34544"/>
                </a:lnTo>
                <a:lnTo>
                  <a:pt x="6360414" y="34544"/>
                </a:lnTo>
                <a:lnTo>
                  <a:pt x="6418199" y="34544"/>
                </a:lnTo>
                <a:lnTo>
                  <a:pt x="6418199" y="37211"/>
                </a:lnTo>
                <a:lnTo>
                  <a:pt x="6475983" y="37211"/>
                </a:lnTo>
                <a:lnTo>
                  <a:pt x="6533896" y="37211"/>
                </a:lnTo>
                <a:lnTo>
                  <a:pt x="6533896" y="39877"/>
                </a:lnTo>
                <a:lnTo>
                  <a:pt x="6591681" y="39877"/>
                </a:lnTo>
                <a:lnTo>
                  <a:pt x="6649466" y="39877"/>
                </a:lnTo>
                <a:lnTo>
                  <a:pt x="6707251" y="39877"/>
                </a:lnTo>
                <a:lnTo>
                  <a:pt x="6707251" y="42672"/>
                </a:lnTo>
                <a:lnTo>
                  <a:pt x="6765163" y="42672"/>
                </a:lnTo>
                <a:lnTo>
                  <a:pt x="6822948" y="42672"/>
                </a:lnTo>
                <a:lnTo>
                  <a:pt x="6880733" y="42672"/>
                </a:lnTo>
                <a:lnTo>
                  <a:pt x="6880733" y="45466"/>
                </a:lnTo>
                <a:lnTo>
                  <a:pt x="6938645" y="45466"/>
                </a:lnTo>
                <a:lnTo>
                  <a:pt x="6996430" y="45466"/>
                </a:lnTo>
                <a:lnTo>
                  <a:pt x="7054215" y="45466"/>
                </a:lnTo>
                <a:lnTo>
                  <a:pt x="7112000" y="45466"/>
                </a:lnTo>
                <a:lnTo>
                  <a:pt x="7112000" y="48514"/>
                </a:lnTo>
                <a:lnTo>
                  <a:pt x="7169912" y="48514"/>
                </a:lnTo>
                <a:lnTo>
                  <a:pt x="7227697" y="48514"/>
                </a:lnTo>
                <a:lnTo>
                  <a:pt x="7285482" y="48514"/>
                </a:lnTo>
                <a:lnTo>
                  <a:pt x="7343394" y="48514"/>
                </a:lnTo>
                <a:lnTo>
                  <a:pt x="7401179" y="48514"/>
                </a:lnTo>
                <a:lnTo>
                  <a:pt x="7458964" y="48514"/>
                </a:lnTo>
                <a:lnTo>
                  <a:pt x="7516749" y="48514"/>
                </a:lnTo>
                <a:lnTo>
                  <a:pt x="7516749" y="51562"/>
                </a:lnTo>
                <a:lnTo>
                  <a:pt x="7574661" y="51562"/>
                </a:lnTo>
                <a:lnTo>
                  <a:pt x="7632446" y="51562"/>
                </a:lnTo>
                <a:lnTo>
                  <a:pt x="7632446" y="54737"/>
                </a:lnTo>
                <a:lnTo>
                  <a:pt x="7690231" y="54737"/>
                </a:lnTo>
                <a:lnTo>
                  <a:pt x="7748143" y="54737"/>
                </a:lnTo>
                <a:lnTo>
                  <a:pt x="7748143" y="57912"/>
                </a:lnTo>
                <a:lnTo>
                  <a:pt x="7805928" y="57912"/>
                </a:lnTo>
                <a:lnTo>
                  <a:pt x="7863713" y="57912"/>
                </a:lnTo>
                <a:lnTo>
                  <a:pt x="7863713" y="61214"/>
                </a:lnTo>
                <a:lnTo>
                  <a:pt x="7921625" y="61214"/>
                </a:lnTo>
                <a:lnTo>
                  <a:pt x="7979410" y="61214"/>
                </a:lnTo>
                <a:lnTo>
                  <a:pt x="8037195" y="61214"/>
                </a:lnTo>
                <a:lnTo>
                  <a:pt x="8037195" y="67945"/>
                </a:lnTo>
                <a:lnTo>
                  <a:pt x="8094980" y="67945"/>
                </a:lnTo>
                <a:lnTo>
                  <a:pt x="8152892" y="67945"/>
                </a:lnTo>
                <a:lnTo>
                  <a:pt x="8210677" y="67945"/>
                </a:lnTo>
                <a:lnTo>
                  <a:pt x="8268462" y="67945"/>
                </a:lnTo>
                <a:lnTo>
                  <a:pt x="8268462" y="75057"/>
                </a:lnTo>
                <a:lnTo>
                  <a:pt x="8326374" y="75057"/>
                </a:lnTo>
                <a:lnTo>
                  <a:pt x="8384158" y="75057"/>
                </a:lnTo>
                <a:lnTo>
                  <a:pt x="8384158" y="78613"/>
                </a:lnTo>
                <a:lnTo>
                  <a:pt x="8441944" y="78613"/>
                </a:lnTo>
                <a:lnTo>
                  <a:pt x="8499729" y="78613"/>
                </a:lnTo>
                <a:lnTo>
                  <a:pt x="8557641" y="78613"/>
                </a:lnTo>
                <a:lnTo>
                  <a:pt x="8557641" y="82423"/>
                </a:lnTo>
                <a:lnTo>
                  <a:pt x="8615426" y="82423"/>
                </a:lnTo>
                <a:lnTo>
                  <a:pt x="8673211" y="82423"/>
                </a:lnTo>
                <a:lnTo>
                  <a:pt x="8731123" y="82423"/>
                </a:lnTo>
                <a:lnTo>
                  <a:pt x="8788908" y="82423"/>
                </a:lnTo>
                <a:lnTo>
                  <a:pt x="8846693" y="82423"/>
                </a:lnTo>
                <a:lnTo>
                  <a:pt x="8904478" y="82423"/>
                </a:lnTo>
                <a:lnTo>
                  <a:pt x="8962390" y="82423"/>
                </a:lnTo>
                <a:lnTo>
                  <a:pt x="9020175" y="82423"/>
                </a:lnTo>
                <a:lnTo>
                  <a:pt x="9077960" y="82423"/>
                </a:lnTo>
                <a:lnTo>
                  <a:pt x="9135872" y="82423"/>
                </a:lnTo>
                <a:lnTo>
                  <a:pt x="9135872" y="86741"/>
                </a:lnTo>
                <a:lnTo>
                  <a:pt x="9193657" y="86741"/>
                </a:lnTo>
                <a:lnTo>
                  <a:pt x="9193657" y="90932"/>
                </a:lnTo>
                <a:lnTo>
                  <a:pt x="9251442" y="90932"/>
                </a:lnTo>
                <a:lnTo>
                  <a:pt x="9309227" y="90932"/>
                </a:lnTo>
                <a:lnTo>
                  <a:pt x="9367139" y="90932"/>
                </a:lnTo>
                <a:lnTo>
                  <a:pt x="9424924" y="90932"/>
                </a:lnTo>
                <a:lnTo>
                  <a:pt x="9482709" y="90932"/>
                </a:lnTo>
                <a:lnTo>
                  <a:pt x="9540621" y="90932"/>
                </a:lnTo>
                <a:lnTo>
                  <a:pt x="9540621" y="95758"/>
                </a:lnTo>
                <a:lnTo>
                  <a:pt x="9598406" y="95758"/>
                </a:lnTo>
                <a:lnTo>
                  <a:pt x="9656191" y="95758"/>
                </a:lnTo>
                <a:lnTo>
                  <a:pt x="9656191" y="100838"/>
                </a:lnTo>
                <a:lnTo>
                  <a:pt x="9713976" y="100838"/>
                </a:lnTo>
                <a:lnTo>
                  <a:pt x="9771888" y="100838"/>
                </a:lnTo>
                <a:lnTo>
                  <a:pt x="9771888" y="106045"/>
                </a:lnTo>
                <a:lnTo>
                  <a:pt x="9829673" y="106045"/>
                </a:lnTo>
                <a:lnTo>
                  <a:pt x="9887458" y="106045"/>
                </a:lnTo>
                <a:lnTo>
                  <a:pt x="9945370" y="106045"/>
                </a:lnTo>
                <a:lnTo>
                  <a:pt x="10003155" y="106045"/>
                </a:lnTo>
                <a:lnTo>
                  <a:pt x="10060940" y="106045"/>
                </a:lnTo>
                <a:lnTo>
                  <a:pt x="10118725" y="106045"/>
                </a:lnTo>
                <a:lnTo>
                  <a:pt x="10176637" y="106045"/>
                </a:lnTo>
                <a:lnTo>
                  <a:pt x="10234422" y="106045"/>
                </a:lnTo>
                <a:lnTo>
                  <a:pt x="10292207" y="106045"/>
                </a:lnTo>
                <a:lnTo>
                  <a:pt x="10350119" y="106045"/>
                </a:lnTo>
                <a:lnTo>
                  <a:pt x="10407904" y="106045"/>
                </a:lnTo>
                <a:lnTo>
                  <a:pt x="10465689" y="106045"/>
                </a:lnTo>
                <a:lnTo>
                  <a:pt x="10523474" y="106045"/>
                </a:lnTo>
                <a:lnTo>
                  <a:pt x="10581386" y="106045"/>
                </a:lnTo>
                <a:lnTo>
                  <a:pt x="10639171" y="106045"/>
                </a:lnTo>
                <a:lnTo>
                  <a:pt x="10696956" y="106045"/>
                </a:lnTo>
                <a:lnTo>
                  <a:pt x="10754868" y="106045"/>
                </a:lnTo>
                <a:lnTo>
                  <a:pt x="10812653" y="106045"/>
                </a:lnTo>
                <a:lnTo>
                  <a:pt x="10870438" y="106045"/>
                </a:lnTo>
                <a:lnTo>
                  <a:pt x="10928223" y="106045"/>
                </a:lnTo>
                <a:lnTo>
                  <a:pt x="10928223" y="113665"/>
                </a:lnTo>
                <a:lnTo>
                  <a:pt x="10986135" y="113665"/>
                </a:lnTo>
                <a:lnTo>
                  <a:pt x="11043920" y="113665"/>
                </a:lnTo>
                <a:lnTo>
                  <a:pt x="11101705" y="113665"/>
                </a:lnTo>
                <a:lnTo>
                  <a:pt x="11159617" y="113665"/>
                </a:lnTo>
                <a:lnTo>
                  <a:pt x="11217402" y="113665"/>
                </a:lnTo>
                <a:lnTo>
                  <a:pt x="11275187" y="113665"/>
                </a:lnTo>
                <a:lnTo>
                  <a:pt x="11332972" y="113665"/>
                </a:lnTo>
                <a:lnTo>
                  <a:pt x="11390884" y="113665"/>
                </a:lnTo>
                <a:lnTo>
                  <a:pt x="11448669" y="113665"/>
                </a:lnTo>
                <a:lnTo>
                  <a:pt x="11506454" y="113665"/>
                </a:lnTo>
                <a:lnTo>
                  <a:pt x="11564366" y="113665"/>
                </a:lnTo>
                <a:lnTo>
                  <a:pt x="11622151" y="113665"/>
                </a:lnTo>
                <a:lnTo>
                  <a:pt x="11679936" y="113665"/>
                </a:lnTo>
                <a:lnTo>
                  <a:pt x="11737721" y="113665"/>
                </a:lnTo>
                <a:lnTo>
                  <a:pt x="11795633" y="113665"/>
                </a:lnTo>
                <a:lnTo>
                  <a:pt x="11853418" y="113665"/>
                </a:lnTo>
                <a:lnTo>
                  <a:pt x="11911203" y="113665"/>
                </a:lnTo>
                <a:lnTo>
                  <a:pt x="11969115" y="113665"/>
                </a:lnTo>
                <a:lnTo>
                  <a:pt x="12026900" y="113665"/>
                </a:lnTo>
                <a:lnTo>
                  <a:pt x="12084685" y="113665"/>
                </a:lnTo>
                <a:lnTo>
                  <a:pt x="12142470" y="113665"/>
                </a:lnTo>
                <a:lnTo>
                  <a:pt x="12200382" y="113665"/>
                </a:lnTo>
                <a:lnTo>
                  <a:pt x="12258166" y="113665"/>
                </a:lnTo>
                <a:lnTo>
                  <a:pt x="12315952" y="113665"/>
                </a:lnTo>
                <a:lnTo>
                  <a:pt x="12373864" y="113665"/>
                </a:lnTo>
                <a:lnTo>
                  <a:pt x="12431649" y="113665"/>
                </a:lnTo>
                <a:lnTo>
                  <a:pt x="12489434" y="113665"/>
                </a:lnTo>
                <a:lnTo>
                  <a:pt x="12547218" y="113665"/>
                </a:lnTo>
                <a:lnTo>
                  <a:pt x="12605131" y="113665"/>
                </a:lnTo>
                <a:lnTo>
                  <a:pt x="12662916" y="113665"/>
                </a:lnTo>
                <a:lnTo>
                  <a:pt x="12720701" y="113665"/>
                </a:lnTo>
                <a:lnTo>
                  <a:pt x="12778613" y="113665"/>
                </a:lnTo>
                <a:lnTo>
                  <a:pt x="12836398" y="113665"/>
                </a:lnTo>
                <a:lnTo>
                  <a:pt x="12894183" y="113665"/>
                </a:lnTo>
                <a:lnTo>
                  <a:pt x="12951968" y="113665"/>
                </a:lnTo>
                <a:lnTo>
                  <a:pt x="13009879" y="113665"/>
                </a:lnTo>
                <a:lnTo>
                  <a:pt x="13067664" y="113665"/>
                </a:lnTo>
                <a:lnTo>
                  <a:pt x="13125450" y="113665"/>
                </a:lnTo>
                <a:lnTo>
                  <a:pt x="13183362" y="113665"/>
                </a:lnTo>
                <a:lnTo>
                  <a:pt x="13241146" y="113665"/>
                </a:lnTo>
                <a:lnTo>
                  <a:pt x="13298931" y="113665"/>
                </a:lnTo>
                <a:lnTo>
                  <a:pt x="13356843" y="113665"/>
                </a:lnTo>
                <a:lnTo>
                  <a:pt x="13414629" y="113665"/>
                </a:lnTo>
                <a:lnTo>
                  <a:pt x="13472414" y="113665"/>
                </a:lnTo>
                <a:lnTo>
                  <a:pt x="13530198" y="113665"/>
                </a:lnTo>
                <a:lnTo>
                  <a:pt x="13588110" y="113665"/>
                </a:lnTo>
                <a:lnTo>
                  <a:pt x="13645895" y="113665"/>
                </a:lnTo>
                <a:lnTo>
                  <a:pt x="13645895" y="162178"/>
                </a:lnTo>
                <a:lnTo>
                  <a:pt x="13703681" y="162178"/>
                </a:lnTo>
                <a:lnTo>
                  <a:pt x="13761592" y="162178"/>
                </a:lnTo>
                <a:lnTo>
                  <a:pt x="13819377" y="162178"/>
                </a:lnTo>
                <a:lnTo>
                  <a:pt x="13877162" y="162178"/>
                </a:lnTo>
                <a:lnTo>
                  <a:pt x="13934948" y="162178"/>
                </a:lnTo>
                <a:lnTo>
                  <a:pt x="13992860" y="162178"/>
                </a:lnTo>
                <a:lnTo>
                  <a:pt x="14050644" y="162178"/>
                </a:lnTo>
                <a:lnTo>
                  <a:pt x="14108429" y="162178"/>
                </a:lnTo>
                <a:lnTo>
                  <a:pt x="14166341" y="162178"/>
                </a:lnTo>
                <a:lnTo>
                  <a:pt x="14224127" y="162178"/>
                </a:lnTo>
                <a:lnTo>
                  <a:pt x="14281912" y="162178"/>
                </a:lnTo>
                <a:lnTo>
                  <a:pt x="14339696" y="162178"/>
                </a:lnTo>
              </a:path>
            </a:pathLst>
          </a:custGeom>
          <a:ln w="27051">
            <a:solidFill>
              <a:srgbClr val="E95359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" name="bg object 22"/>
          <p:cNvSpPr/>
          <p:nvPr/>
        </p:nvSpPr>
        <p:spPr>
          <a:xfrm>
            <a:off x="1211452" y="722757"/>
            <a:ext cx="14397990" cy="377825"/>
          </a:xfrm>
          <a:custGeom>
            <a:avLst/>
            <a:gdLst/>
            <a:ahLst/>
            <a:cxnLst/>
            <a:rect l="l" t="t" r="r" b="b"/>
            <a:pathLst>
              <a:path w="14397990" h="377825">
                <a:moveTo>
                  <a:pt x="0" y="0"/>
                </a:moveTo>
                <a:lnTo>
                  <a:pt x="0" y="635"/>
                </a:lnTo>
                <a:lnTo>
                  <a:pt x="57784" y="635"/>
                </a:lnTo>
                <a:lnTo>
                  <a:pt x="115697" y="635"/>
                </a:lnTo>
                <a:lnTo>
                  <a:pt x="115697" y="1904"/>
                </a:lnTo>
                <a:lnTo>
                  <a:pt x="173481" y="1904"/>
                </a:lnTo>
                <a:lnTo>
                  <a:pt x="173481" y="2540"/>
                </a:lnTo>
                <a:lnTo>
                  <a:pt x="231266" y="2540"/>
                </a:lnTo>
                <a:lnTo>
                  <a:pt x="231266" y="3175"/>
                </a:lnTo>
                <a:lnTo>
                  <a:pt x="289178" y="3175"/>
                </a:lnTo>
                <a:lnTo>
                  <a:pt x="346963" y="3175"/>
                </a:lnTo>
                <a:lnTo>
                  <a:pt x="346963" y="3810"/>
                </a:lnTo>
                <a:lnTo>
                  <a:pt x="404749" y="3810"/>
                </a:lnTo>
                <a:lnTo>
                  <a:pt x="404749" y="4445"/>
                </a:lnTo>
                <a:lnTo>
                  <a:pt x="462534" y="4445"/>
                </a:lnTo>
                <a:lnTo>
                  <a:pt x="462534" y="5207"/>
                </a:lnTo>
                <a:lnTo>
                  <a:pt x="520446" y="5207"/>
                </a:lnTo>
                <a:lnTo>
                  <a:pt x="520446" y="5842"/>
                </a:lnTo>
                <a:lnTo>
                  <a:pt x="578230" y="5842"/>
                </a:lnTo>
                <a:lnTo>
                  <a:pt x="636016" y="5842"/>
                </a:lnTo>
                <a:lnTo>
                  <a:pt x="636016" y="7747"/>
                </a:lnTo>
                <a:lnTo>
                  <a:pt x="693928" y="7747"/>
                </a:lnTo>
                <a:lnTo>
                  <a:pt x="693928" y="9778"/>
                </a:lnTo>
                <a:lnTo>
                  <a:pt x="751713" y="9778"/>
                </a:lnTo>
                <a:lnTo>
                  <a:pt x="751713" y="10414"/>
                </a:lnTo>
                <a:lnTo>
                  <a:pt x="809497" y="10414"/>
                </a:lnTo>
                <a:lnTo>
                  <a:pt x="809497" y="13081"/>
                </a:lnTo>
                <a:lnTo>
                  <a:pt x="867283" y="13081"/>
                </a:lnTo>
                <a:lnTo>
                  <a:pt x="867283" y="15113"/>
                </a:lnTo>
                <a:lnTo>
                  <a:pt x="925195" y="15113"/>
                </a:lnTo>
                <a:lnTo>
                  <a:pt x="925195" y="16383"/>
                </a:lnTo>
                <a:lnTo>
                  <a:pt x="982979" y="16383"/>
                </a:lnTo>
                <a:lnTo>
                  <a:pt x="1040765" y="16383"/>
                </a:lnTo>
                <a:lnTo>
                  <a:pt x="1040765" y="19176"/>
                </a:lnTo>
                <a:lnTo>
                  <a:pt x="1098677" y="19176"/>
                </a:lnTo>
                <a:lnTo>
                  <a:pt x="1098677" y="21209"/>
                </a:lnTo>
                <a:lnTo>
                  <a:pt x="1156461" y="21209"/>
                </a:lnTo>
                <a:lnTo>
                  <a:pt x="1156461" y="22606"/>
                </a:lnTo>
                <a:lnTo>
                  <a:pt x="1214247" y="22606"/>
                </a:lnTo>
                <a:lnTo>
                  <a:pt x="1214247" y="24638"/>
                </a:lnTo>
                <a:lnTo>
                  <a:pt x="1272032" y="24638"/>
                </a:lnTo>
                <a:lnTo>
                  <a:pt x="1272032" y="25400"/>
                </a:lnTo>
                <a:lnTo>
                  <a:pt x="1329944" y="25400"/>
                </a:lnTo>
                <a:lnTo>
                  <a:pt x="1329944" y="26035"/>
                </a:lnTo>
                <a:lnTo>
                  <a:pt x="1387729" y="26035"/>
                </a:lnTo>
                <a:lnTo>
                  <a:pt x="1387729" y="27432"/>
                </a:lnTo>
                <a:lnTo>
                  <a:pt x="1445514" y="27432"/>
                </a:lnTo>
                <a:lnTo>
                  <a:pt x="1503426" y="27432"/>
                </a:lnTo>
                <a:lnTo>
                  <a:pt x="1503426" y="28194"/>
                </a:lnTo>
                <a:lnTo>
                  <a:pt x="1561211" y="28194"/>
                </a:lnTo>
                <a:lnTo>
                  <a:pt x="1618996" y="28194"/>
                </a:lnTo>
                <a:lnTo>
                  <a:pt x="1618996" y="29591"/>
                </a:lnTo>
                <a:lnTo>
                  <a:pt x="1676780" y="29591"/>
                </a:lnTo>
                <a:lnTo>
                  <a:pt x="1676780" y="30352"/>
                </a:lnTo>
                <a:lnTo>
                  <a:pt x="1734692" y="30352"/>
                </a:lnTo>
                <a:lnTo>
                  <a:pt x="1734692" y="34036"/>
                </a:lnTo>
                <a:lnTo>
                  <a:pt x="1792477" y="34036"/>
                </a:lnTo>
                <a:lnTo>
                  <a:pt x="1850263" y="34036"/>
                </a:lnTo>
                <a:lnTo>
                  <a:pt x="1850263" y="34798"/>
                </a:lnTo>
                <a:lnTo>
                  <a:pt x="1908175" y="34798"/>
                </a:lnTo>
                <a:lnTo>
                  <a:pt x="1908175" y="37846"/>
                </a:lnTo>
                <a:lnTo>
                  <a:pt x="1965960" y="37846"/>
                </a:lnTo>
                <a:lnTo>
                  <a:pt x="1965960" y="39370"/>
                </a:lnTo>
                <a:lnTo>
                  <a:pt x="2023745" y="39370"/>
                </a:lnTo>
                <a:lnTo>
                  <a:pt x="2081530" y="39370"/>
                </a:lnTo>
                <a:lnTo>
                  <a:pt x="2081530" y="40894"/>
                </a:lnTo>
                <a:lnTo>
                  <a:pt x="2139442" y="40894"/>
                </a:lnTo>
                <a:lnTo>
                  <a:pt x="2139442" y="43942"/>
                </a:lnTo>
                <a:lnTo>
                  <a:pt x="2197227" y="43942"/>
                </a:lnTo>
                <a:lnTo>
                  <a:pt x="2197227" y="45593"/>
                </a:lnTo>
                <a:lnTo>
                  <a:pt x="2255012" y="45593"/>
                </a:lnTo>
                <a:lnTo>
                  <a:pt x="2255012" y="46354"/>
                </a:lnTo>
                <a:lnTo>
                  <a:pt x="2312924" y="46354"/>
                </a:lnTo>
                <a:lnTo>
                  <a:pt x="2312924" y="47878"/>
                </a:lnTo>
                <a:lnTo>
                  <a:pt x="2370709" y="47878"/>
                </a:lnTo>
                <a:lnTo>
                  <a:pt x="2370709" y="50292"/>
                </a:lnTo>
                <a:lnTo>
                  <a:pt x="2428494" y="50292"/>
                </a:lnTo>
                <a:lnTo>
                  <a:pt x="2428494" y="51181"/>
                </a:lnTo>
                <a:lnTo>
                  <a:pt x="2486406" y="51181"/>
                </a:lnTo>
                <a:lnTo>
                  <a:pt x="2486406" y="53594"/>
                </a:lnTo>
                <a:lnTo>
                  <a:pt x="2544191" y="53594"/>
                </a:lnTo>
                <a:lnTo>
                  <a:pt x="2544191" y="56007"/>
                </a:lnTo>
                <a:lnTo>
                  <a:pt x="2601976" y="56007"/>
                </a:lnTo>
                <a:lnTo>
                  <a:pt x="2601976" y="57658"/>
                </a:lnTo>
                <a:lnTo>
                  <a:pt x="2659761" y="57658"/>
                </a:lnTo>
                <a:lnTo>
                  <a:pt x="2659761" y="59309"/>
                </a:lnTo>
                <a:lnTo>
                  <a:pt x="2717673" y="59309"/>
                </a:lnTo>
                <a:lnTo>
                  <a:pt x="2717673" y="60071"/>
                </a:lnTo>
                <a:lnTo>
                  <a:pt x="2775458" y="60071"/>
                </a:lnTo>
                <a:lnTo>
                  <a:pt x="2833243" y="60071"/>
                </a:lnTo>
                <a:lnTo>
                  <a:pt x="2891155" y="60071"/>
                </a:lnTo>
                <a:lnTo>
                  <a:pt x="2891155" y="61849"/>
                </a:lnTo>
                <a:lnTo>
                  <a:pt x="2948940" y="61849"/>
                </a:lnTo>
                <a:lnTo>
                  <a:pt x="2948940" y="63500"/>
                </a:lnTo>
                <a:lnTo>
                  <a:pt x="3006725" y="63500"/>
                </a:lnTo>
                <a:lnTo>
                  <a:pt x="3064510" y="63500"/>
                </a:lnTo>
                <a:lnTo>
                  <a:pt x="3064510" y="66167"/>
                </a:lnTo>
                <a:lnTo>
                  <a:pt x="3122422" y="66167"/>
                </a:lnTo>
                <a:lnTo>
                  <a:pt x="3122422" y="69723"/>
                </a:lnTo>
                <a:lnTo>
                  <a:pt x="3180207" y="69723"/>
                </a:lnTo>
                <a:lnTo>
                  <a:pt x="3180207" y="70612"/>
                </a:lnTo>
                <a:lnTo>
                  <a:pt x="3237992" y="70612"/>
                </a:lnTo>
                <a:lnTo>
                  <a:pt x="3237992" y="71500"/>
                </a:lnTo>
                <a:lnTo>
                  <a:pt x="3295904" y="71500"/>
                </a:lnTo>
                <a:lnTo>
                  <a:pt x="3295904" y="72390"/>
                </a:lnTo>
                <a:lnTo>
                  <a:pt x="3353689" y="72390"/>
                </a:lnTo>
                <a:lnTo>
                  <a:pt x="3353689" y="73278"/>
                </a:lnTo>
                <a:lnTo>
                  <a:pt x="3411474" y="73278"/>
                </a:lnTo>
                <a:lnTo>
                  <a:pt x="3411474" y="74168"/>
                </a:lnTo>
                <a:lnTo>
                  <a:pt x="3469259" y="74168"/>
                </a:lnTo>
                <a:lnTo>
                  <a:pt x="3469259" y="76073"/>
                </a:lnTo>
                <a:lnTo>
                  <a:pt x="3527171" y="76073"/>
                </a:lnTo>
                <a:lnTo>
                  <a:pt x="3527171" y="76962"/>
                </a:lnTo>
                <a:lnTo>
                  <a:pt x="3584956" y="76962"/>
                </a:lnTo>
                <a:lnTo>
                  <a:pt x="3584956" y="77850"/>
                </a:lnTo>
                <a:lnTo>
                  <a:pt x="3642741" y="77850"/>
                </a:lnTo>
                <a:lnTo>
                  <a:pt x="3642741" y="80772"/>
                </a:lnTo>
                <a:lnTo>
                  <a:pt x="3700653" y="80772"/>
                </a:lnTo>
                <a:lnTo>
                  <a:pt x="3758438" y="80772"/>
                </a:lnTo>
                <a:lnTo>
                  <a:pt x="3758438" y="81661"/>
                </a:lnTo>
                <a:lnTo>
                  <a:pt x="3816223" y="81661"/>
                </a:lnTo>
                <a:lnTo>
                  <a:pt x="3816223" y="82676"/>
                </a:lnTo>
                <a:lnTo>
                  <a:pt x="3874008" y="82676"/>
                </a:lnTo>
                <a:lnTo>
                  <a:pt x="3874008" y="83693"/>
                </a:lnTo>
                <a:lnTo>
                  <a:pt x="3931920" y="83693"/>
                </a:lnTo>
                <a:lnTo>
                  <a:pt x="3931920" y="85598"/>
                </a:lnTo>
                <a:lnTo>
                  <a:pt x="3989705" y="85598"/>
                </a:lnTo>
                <a:lnTo>
                  <a:pt x="3989705" y="87629"/>
                </a:lnTo>
                <a:lnTo>
                  <a:pt x="4047490" y="87629"/>
                </a:lnTo>
                <a:lnTo>
                  <a:pt x="4105402" y="87629"/>
                </a:lnTo>
                <a:lnTo>
                  <a:pt x="4105402" y="89535"/>
                </a:lnTo>
                <a:lnTo>
                  <a:pt x="4163187" y="89535"/>
                </a:lnTo>
                <a:lnTo>
                  <a:pt x="4220972" y="89535"/>
                </a:lnTo>
                <a:lnTo>
                  <a:pt x="4220972" y="93725"/>
                </a:lnTo>
                <a:lnTo>
                  <a:pt x="4278757" y="93725"/>
                </a:lnTo>
                <a:lnTo>
                  <a:pt x="4278757" y="96774"/>
                </a:lnTo>
                <a:lnTo>
                  <a:pt x="4336669" y="96774"/>
                </a:lnTo>
                <a:lnTo>
                  <a:pt x="4336669" y="98806"/>
                </a:lnTo>
                <a:lnTo>
                  <a:pt x="4394454" y="98806"/>
                </a:lnTo>
                <a:lnTo>
                  <a:pt x="4394454" y="103124"/>
                </a:lnTo>
                <a:lnTo>
                  <a:pt x="4452239" y="103124"/>
                </a:lnTo>
                <a:lnTo>
                  <a:pt x="4452239" y="106299"/>
                </a:lnTo>
                <a:lnTo>
                  <a:pt x="4510151" y="106299"/>
                </a:lnTo>
                <a:lnTo>
                  <a:pt x="4510151" y="107315"/>
                </a:lnTo>
                <a:lnTo>
                  <a:pt x="4567936" y="107315"/>
                </a:lnTo>
                <a:lnTo>
                  <a:pt x="4567936" y="109474"/>
                </a:lnTo>
                <a:lnTo>
                  <a:pt x="4625721" y="109474"/>
                </a:lnTo>
                <a:lnTo>
                  <a:pt x="4683506" y="109474"/>
                </a:lnTo>
                <a:lnTo>
                  <a:pt x="4741418" y="109474"/>
                </a:lnTo>
                <a:lnTo>
                  <a:pt x="4741418" y="111760"/>
                </a:lnTo>
                <a:lnTo>
                  <a:pt x="4799203" y="111760"/>
                </a:lnTo>
                <a:lnTo>
                  <a:pt x="4799203" y="116204"/>
                </a:lnTo>
                <a:lnTo>
                  <a:pt x="4856988" y="116204"/>
                </a:lnTo>
                <a:lnTo>
                  <a:pt x="4856988" y="118491"/>
                </a:lnTo>
                <a:lnTo>
                  <a:pt x="4914900" y="118491"/>
                </a:lnTo>
                <a:lnTo>
                  <a:pt x="4914900" y="124333"/>
                </a:lnTo>
                <a:lnTo>
                  <a:pt x="4972685" y="124333"/>
                </a:lnTo>
                <a:lnTo>
                  <a:pt x="4972685" y="126619"/>
                </a:lnTo>
                <a:lnTo>
                  <a:pt x="5030470" y="126619"/>
                </a:lnTo>
                <a:lnTo>
                  <a:pt x="5030470" y="130048"/>
                </a:lnTo>
                <a:lnTo>
                  <a:pt x="5088255" y="130048"/>
                </a:lnTo>
                <a:lnTo>
                  <a:pt x="5146167" y="130048"/>
                </a:lnTo>
                <a:lnTo>
                  <a:pt x="5146167" y="132461"/>
                </a:lnTo>
                <a:lnTo>
                  <a:pt x="5203952" y="132461"/>
                </a:lnTo>
                <a:lnTo>
                  <a:pt x="5203952" y="133603"/>
                </a:lnTo>
                <a:lnTo>
                  <a:pt x="5261737" y="133603"/>
                </a:lnTo>
                <a:lnTo>
                  <a:pt x="5261737" y="134874"/>
                </a:lnTo>
                <a:lnTo>
                  <a:pt x="5319649" y="134874"/>
                </a:lnTo>
                <a:lnTo>
                  <a:pt x="5319649" y="138429"/>
                </a:lnTo>
                <a:lnTo>
                  <a:pt x="5377433" y="138429"/>
                </a:lnTo>
                <a:lnTo>
                  <a:pt x="5377433" y="140843"/>
                </a:lnTo>
                <a:lnTo>
                  <a:pt x="5435219" y="140843"/>
                </a:lnTo>
                <a:lnTo>
                  <a:pt x="5435219" y="143383"/>
                </a:lnTo>
                <a:lnTo>
                  <a:pt x="5493004" y="143383"/>
                </a:lnTo>
                <a:lnTo>
                  <a:pt x="5493004" y="144652"/>
                </a:lnTo>
                <a:lnTo>
                  <a:pt x="5550916" y="144652"/>
                </a:lnTo>
                <a:lnTo>
                  <a:pt x="5550916" y="145923"/>
                </a:lnTo>
                <a:lnTo>
                  <a:pt x="5608701" y="145923"/>
                </a:lnTo>
                <a:lnTo>
                  <a:pt x="5608701" y="147193"/>
                </a:lnTo>
                <a:lnTo>
                  <a:pt x="5666486" y="147193"/>
                </a:lnTo>
                <a:lnTo>
                  <a:pt x="5666486" y="151002"/>
                </a:lnTo>
                <a:lnTo>
                  <a:pt x="5724398" y="151002"/>
                </a:lnTo>
                <a:lnTo>
                  <a:pt x="5782183" y="151002"/>
                </a:lnTo>
                <a:lnTo>
                  <a:pt x="5839968" y="151002"/>
                </a:lnTo>
                <a:lnTo>
                  <a:pt x="5897753" y="151002"/>
                </a:lnTo>
                <a:lnTo>
                  <a:pt x="5897753" y="152400"/>
                </a:lnTo>
                <a:lnTo>
                  <a:pt x="5955665" y="152400"/>
                </a:lnTo>
                <a:lnTo>
                  <a:pt x="6013450" y="152400"/>
                </a:lnTo>
                <a:lnTo>
                  <a:pt x="6013450" y="155067"/>
                </a:lnTo>
                <a:lnTo>
                  <a:pt x="6071235" y="155067"/>
                </a:lnTo>
                <a:lnTo>
                  <a:pt x="6129147" y="155067"/>
                </a:lnTo>
                <a:lnTo>
                  <a:pt x="6186932" y="155067"/>
                </a:lnTo>
                <a:lnTo>
                  <a:pt x="6186932" y="157988"/>
                </a:lnTo>
                <a:lnTo>
                  <a:pt x="6244717" y="157988"/>
                </a:lnTo>
                <a:lnTo>
                  <a:pt x="6244717" y="159385"/>
                </a:lnTo>
                <a:lnTo>
                  <a:pt x="6302502" y="159385"/>
                </a:lnTo>
                <a:lnTo>
                  <a:pt x="6360414" y="159385"/>
                </a:lnTo>
                <a:lnTo>
                  <a:pt x="6360414" y="160782"/>
                </a:lnTo>
                <a:lnTo>
                  <a:pt x="6418199" y="160782"/>
                </a:lnTo>
                <a:lnTo>
                  <a:pt x="6418199" y="162306"/>
                </a:lnTo>
                <a:lnTo>
                  <a:pt x="6475983" y="162306"/>
                </a:lnTo>
                <a:lnTo>
                  <a:pt x="6475983" y="163829"/>
                </a:lnTo>
                <a:lnTo>
                  <a:pt x="6533896" y="163829"/>
                </a:lnTo>
                <a:lnTo>
                  <a:pt x="6533896" y="168275"/>
                </a:lnTo>
                <a:lnTo>
                  <a:pt x="6591681" y="168275"/>
                </a:lnTo>
                <a:lnTo>
                  <a:pt x="6591681" y="169799"/>
                </a:lnTo>
                <a:lnTo>
                  <a:pt x="6649466" y="169799"/>
                </a:lnTo>
                <a:lnTo>
                  <a:pt x="6649466" y="174371"/>
                </a:lnTo>
                <a:lnTo>
                  <a:pt x="6707251" y="174371"/>
                </a:lnTo>
                <a:lnTo>
                  <a:pt x="6707251" y="175895"/>
                </a:lnTo>
                <a:lnTo>
                  <a:pt x="6765163" y="175895"/>
                </a:lnTo>
                <a:lnTo>
                  <a:pt x="6765163" y="179070"/>
                </a:lnTo>
                <a:lnTo>
                  <a:pt x="6822948" y="179070"/>
                </a:lnTo>
                <a:lnTo>
                  <a:pt x="6822948" y="180594"/>
                </a:lnTo>
                <a:lnTo>
                  <a:pt x="6880733" y="180594"/>
                </a:lnTo>
                <a:lnTo>
                  <a:pt x="6880733" y="185420"/>
                </a:lnTo>
                <a:lnTo>
                  <a:pt x="6938645" y="185420"/>
                </a:lnTo>
                <a:lnTo>
                  <a:pt x="6996430" y="185420"/>
                </a:lnTo>
                <a:lnTo>
                  <a:pt x="7054215" y="185420"/>
                </a:lnTo>
                <a:lnTo>
                  <a:pt x="7112000" y="185420"/>
                </a:lnTo>
                <a:lnTo>
                  <a:pt x="7169912" y="185420"/>
                </a:lnTo>
                <a:lnTo>
                  <a:pt x="7227697" y="185420"/>
                </a:lnTo>
                <a:lnTo>
                  <a:pt x="7285482" y="185420"/>
                </a:lnTo>
                <a:lnTo>
                  <a:pt x="7285482" y="188849"/>
                </a:lnTo>
                <a:lnTo>
                  <a:pt x="7343394" y="188849"/>
                </a:lnTo>
                <a:lnTo>
                  <a:pt x="7343394" y="192277"/>
                </a:lnTo>
                <a:lnTo>
                  <a:pt x="7401179" y="192277"/>
                </a:lnTo>
                <a:lnTo>
                  <a:pt x="7458964" y="192277"/>
                </a:lnTo>
                <a:lnTo>
                  <a:pt x="7458964" y="197612"/>
                </a:lnTo>
                <a:lnTo>
                  <a:pt x="7516749" y="197612"/>
                </a:lnTo>
                <a:lnTo>
                  <a:pt x="7516749" y="199517"/>
                </a:lnTo>
                <a:lnTo>
                  <a:pt x="7574661" y="199517"/>
                </a:lnTo>
                <a:lnTo>
                  <a:pt x="7574661" y="203200"/>
                </a:lnTo>
                <a:lnTo>
                  <a:pt x="7632446" y="203200"/>
                </a:lnTo>
                <a:lnTo>
                  <a:pt x="7632446" y="203200"/>
                </a:lnTo>
                <a:lnTo>
                  <a:pt x="7690231" y="203200"/>
                </a:lnTo>
                <a:lnTo>
                  <a:pt x="7748143" y="203200"/>
                </a:lnTo>
                <a:lnTo>
                  <a:pt x="7805928" y="203200"/>
                </a:lnTo>
                <a:lnTo>
                  <a:pt x="7805928" y="205104"/>
                </a:lnTo>
                <a:lnTo>
                  <a:pt x="7863713" y="205104"/>
                </a:lnTo>
                <a:lnTo>
                  <a:pt x="7921625" y="205104"/>
                </a:lnTo>
                <a:lnTo>
                  <a:pt x="7979410" y="205104"/>
                </a:lnTo>
                <a:lnTo>
                  <a:pt x="7979410" y="209042"/>
                </a:lnTo>
                <a:lnTo>
                  <a:pt x="8037195" y="209042"/>
                </a:lnTo>
                <a:lnTo>
                  <a:pt x="8094980" y="209042"/>
                </a:lnTo>
                <a:lnTo>
                  <a:pt x="8094980" y="211200"/>
                </a:lnTo>
                <a:lnTo>
                  <a:pt x="8152892" y="211200"/>
                </a:lnTo>
                <a:lnTo>
                  <a:pt x="8210677" y="211200"/>
                </a:lnTo>
                <a:lnTo>
                  <a:pt x="8210677" y="213233"/>
                </a:lnTo>
                <a:lnTo>
                  <a:pt x="8268462" y="213233"/>
                </a:lnTo>
                <a:lnTo>
                  <a:pt x="8326374" y="213233"/>
                </a:lnTo>
                <a:lnTo>
                  <a:pt x="8384158" y="213233"/>
                </a:lnTo>
                <a:lnTo>
                  <a:pt x="8441944" y="213233"/>
                </a:lnTo>
                <a:lnTo>
                  <a:pt x="8499729" y="213233"/>
                </a:lnTo>
                <a:lnTo>
                  <a:pt x="8557641" y="213233"/>
                </a:lnTo>
                <a:lnTo>
                  <a:pt x="8557641" y="217932"/>
                </a:lnTo>
                <a:lnTo>
                  <a:pt x="8615426" y="217932"/>
                </a:lnTo>
                <a:lnTo>
                  <a:pt x="8673211" y="217932"/>
                </a:lnTo>
                <a:lnTo>
                  <a:pt x="8673211" y="220345"/>
                </a:lnTo>
                <a:lnTo>
                  <a:pt x="8731123" y="220345"/>
                </a:lnTo>
                <a:lnTo>
                  <a:pt x="8788908" y="220345"/>
                </a:lnTo>
                <a:lnTo>
                  <a:pt x="8846693" y="220345"/>
                </a:lnTo>
                <a:lnTo>
                  <a:pt x="8904478" y="220345"/>
                </a:lnTo>
                <a:lnTo>
                  <a:pt x="8962390" y="220345"/>
                </a:lnTo>
                <a:lnTo>
                  <a:pt x="8962390" y="223012"/>
                </a:lnTo>
                <a:lnTo>
                  <a:pt x="9020175" y="223012"/>
                </a:lnTo>
                <a:lnTo>
                  <a:pt x="9020175" y="228219"/>
                </a:lnTo>
                <a:lnTo>
                  <a:pt x="9077960" y="228219"/>
                </a:lnTo>
                <a:lnTo>
                  <a:pt x="9135872" y="228219"/>
                </a:lnTo>
                <a:lnTo>
                  <a:pt x="9193657" y="228219"/>
                </a:lnTo>
                <a:lnTo>
                  <a:pt x="9193657" y="236600"/>
                </a:lnTo>
                <a:lnTo>
                  <a:pt x="9251442" y="236600"/>
                </a:lnTo>
                <a:lnTo>
                  <a:pt x="9309227" y="236600"/>
                </a:lnTo>
                <a:lnTo>
                  <a:pt x="9309227" y="239395"/>
                </a:lnTo>
                <a:lnTo>
                  <a:pt x="9367139" y="239395"/>
                </a:lnTo>
                <a:lnTo>
                  <a:pt x="9424924" y="239395"/>
                </a:lnTo>
                <a:lnTo>
                  <a:pt x="9482709" y="239395"/>
                </a:lnTo>
                <a:lnTo>
                  <a:pt x="9540621" y="239395"/>
                </a:lnTo>
                <a:lnTo>
                  <a:pt x="9540621" y="242570"/>
                </a:lnTo>
                <a:lnTo>
                  <a:pt x="9598406" y="242570"/>
                </a:lnTo>
                <a:lnTo>
                  <a:pt x="9598406" y="251841"/>
                </a:lnTo>
                <a:lnTo>
                  <a:pt x="9656191" y="251841"/>
                </a:lnTo>
                <a:lnTo>
                  <a:pt x="9713976" y="251841"/>
                </a:lnTo>
                <a:lnTo>
                  <a:pt x="9713976" y="258191"/>
                </a:lnTo>
                <a:lnTo>
                  <a:pt x="9771888" y="258191"/>
                </a:lnTo>
                <a:lnTo>
                  <a:pt x="9771888" y="261493"/>
                </a:lnTo>
                <a:lnTo>
                  <a:pt x="9829673" y="261493"/>
                </a:lnTo>
                <a:lnTo>
                  <a:pt x="9887458" y="261493"/>
                </a:lnTo>
                <a:lnTo>
                  <a:pt x="9945370" y="261493"/>
                </a:lnTo>
                <a:lnTo>
                  <a:pt x="10003155" y="261493"/>
                </a:lnTo>
                <a:lnTo>
                  <a:pt x="10003155" y="265049"/>
                </a:lnTo>
                <a:lnTo>
                  <a:pt x="10060940" y="265049"/>
                </a:lnTo>
                <a:lnTo>
                  <a:pt x="10060940" y="268732"/>
                </a:lnTo>
                <a:lnTo>
                  <a:pt x="10118725" y="268732"/>
                </a:lnTo>
                <a:lnTo>
                  <a:pt x="10176637" y="268732"/>
                </a:lnTo>
                <a:lnTo>
                  <a:pt x="10234422" y="268732"/>
                </a:lnTo>
                <a:lnTo>
                  <a:pt x="10234422" y="272542"/>
                </a:lnTo>
                <a:lnTo>
                  <a:pt x="10292207" y="272542"/>
                </a:lnTo>
                <a:lnTo>
                  <a:pt x="10292207" y="276478"/>
                </a:lnTo>
                <a:lnTo>
                  <a:pt x="10350119" y="276478"/>
                </a:lnTo>
                <a:lnTo>
                  <a:pt x="10407904" y="276478"/>
                </a:lnTo>
                <a:lnTo>
                  <a:pt x="10407904" y="284861"/>
                </a:lnTo>
                <a:lnTo>
                  <a:pt x="10465689" y="284861"/>
                </a:lnTo>
                <a:lnTo>
                  <a:pt x="10523474" y="284861"/>
                </a:lnTo>
                <a:lnTo>
                  <a:pt x="10523474" y="289051"/>
                </a:lnTo>
                <a:lnTo>
                  <a:pt x="10581386" y="289051"/>
                </a:lnTo>
                <a:lnTo>
                  <a:pt x="10639171" y="289051"/>
                </a:lnTo>
                <a:lnTo>
                  <a:pt x="10639171" y="302514"/>
                </a:lnTo>
                <a:lnTo>
                  <a:pt x="10696956" y="302514"/>
                </a:lnTo>
                <a:lnTo>
                  <a:pt x="10754868" y="302514"/>
                </a:lnTo>
                <a:lnTo>
                  <a:pt x="10812653" y="302514"/>
                </a:lnTo>
                <a:lnTo>
                  <a:pt x="10870438" y="302514"/>
                </a:lnTo>
                <a:lnTo>
                  <a:pt x="10870438" y="307213"/>
                </a:lnTo>
                <a:lnTo>
                  <a:pt x="10928223" y="307213"/>
                </a:lnTo>
                <a:lnTo>
                  <a:pt x="10928223" y="311912"/>
                </a:lnTo>
                <a:lnTo>
                  <a:pt x="10986135" y="311912"/>
                </a:lnTo>
                <a:lnTo>
                  <a:pt x="10986135" y="321564"/>
                </a:lnTo>
                <a:lnTo>
                  <a:pt x="11043920" y="321564"/>
                </a:lnTo>
                <a:lnTo>
                  <a:pt x="11101705" y="321564"/>
                </a:lnTo>
                <a:lnTo>
                  <a:pt x="11101705" y="326517"/>
                </a:lnTo>
                <a:lnTo>
                  <a:pt x="11159617" y="326517"/>
                </a:lnTo>
                <a:lnTo>
                  <a:pt x="11159617" y="331470"/>
                </a:lnTo>
                <a:lnTo>
                  <a:pt x="11217402" y="331470"/>
                </a:lnTo>
                <a:lnTo>
                  <a:pt x="11217402" y="336676"/>
                </a:lnTo>
                <a:lnTo>
                  <a:pt x="11275187" y="336676"/>
                </a:lnTo>
                <a:lnTo>
                  <a:pt x="11332972" y="336676"/>
                </a:lnTo>
                <a:lnTo>
                  <a:pt x="11390884" y="336676"/>
                </a:lnTo>
                <a:lnTo>
                  <a:pt x="11448669" y="336676"/>
                </a:lnTo>
                <a:lnTo>
                  <a:pt x="11506454" y="336676"/>
                </a:lnTo>
                <a:lnTo>
                  <a:pt x="11506454" y="342646"/>
                </a:lnTo>
                <a:lnTo>
                  <a:pt x="11564366" y="342646"/>
                </a:lnTo>
                <a:lnTo>
                  <a:pt x="11564366" y="348742"/>
                </a:lnTo>
                <a:lnTo>
                  <a:pt x="11622151" y="348742"/>
                </a:lnTo>
                <a:lnTo>
                  <a:pt x="11679936" y="348742"/>
                </a:lnTo>
                <a:lnTo>
                  <a:pt x="11679936" y="355346"/>
                </a:lnTo>
                <a:lnTo>
                  <a:pt x="11737721" y="355346"/>
                </a:lnTo>
                <a:lnTo>
                  <a:pt x="11795633" y="355346"/>
                </a:lnTo>
                <a:lnTo>
                  <a:pt x="11853418" y="355346"/>
                </a:lnTo>
                <a:lnTo>
                  <a:pt x="11911203" y="355346"/>
                </a:lnTo>
                <a:lnTo>
                  <a:pt x="11969115" y="355346"/>
                </a:lnTo>
                <a:lnTo>
                  <a:pt x="12026900" y="355346"/>
                </a:lnTo>
                <a:lnTo>
                  <a:pt x="12084685" y="355346"/>
                </a:lnTo>
                <a:lnTo>
                  <a:pt x="12142470" y="355346"/>
                </a:lnTo>
                <a:lnTo>
                  <a:pt x="12200382" y="355346"/>
                </a:lnTo>
                <a:lnTo>
                  <a:pt x="12258166" y="355346"/>
                </a:lnTo>
                <a:lnTo>
                  <a:pt x="12315952" y="355346"/>
                </a:lnTo>
                <a:lnTo>
                  <a:pt x="12373864" y="355346"/>
                </a:lnTo>
                <a:lnTo>
                  <a:pt x="12431649" y="355346"/>
                </a:lnTo>
                <a:lnTo>
                  <a:pt x="12489434" y="355346"/>
                </a:lnTo>
                <a:lnTo>
                  <a:pt x="12547218" y="355346"/>
                </a:lnTo>
                <a:lnTo>
                  <a:pt x="12605131" y="355346"/>
                </a:lnTo>
                <a:lnTo>
                  <a:pt x="12662916" y="355346"/>
                </a:lnTo>
                <a:lnTo>
                  <a:pt x="12720701" y="355346"/>
                </a:lnTo>
                <a:lnTo>
                  <a:pt x="12778613" y="355346"/>
                </a:lnTo>
                <a:lnTo>
                  <a:pt x="12836398" y="355346"/>
                </a:lnTo>
                <a:lnTo>
                  <a:pt x="12894183" y="355346"/>
                </a:lnTo>
                <a:lnTo>
                  <a:pt x="12951968" y="355346"/>
                </a:lnTo>
                <a:lnTo>
                  <a:pt x="13009879" y="355346"/>
                </a:lnTo>
                <a:lnTo>
                  <a:pt x="13067664" y="355346"/>
                </a:lnTo>
                <a:lnTo>
                  <a:pt x="13125450" y="355346"/>
                </a:lnTo>
                <a:lnTo>
                  <a:pt x="13183362" y="355346"/>
                </a:lnTo>
                <a:lnTo>
                  <a:pt x="13241146" y="355346"/>
                </a:lnTo>
                <a:lnTo>
                  <a:pt x="13298931" y="355346"/>
                </a:lnTo>
                <a:lnTo>
                  <a:pt x="13298931" y="377698"/>
                </a:lnTo>
                <a:lnTo>
                  <a:pt x="13356843" y="377698"/>
                </a:lnTo>
                <a:lnTo>
                  <a:pt x="13414629" y="377698"/>
                </a:lnTo>
                <a:lnTo>
                  <a:pt x="13472414" y="377698"/>
                </a:lnTo>
                <a:lnTo>
                  <a:pt x="13530198" y="377698"/>
                </a:lnTo>
                <a:lnTo>
                  <a:pt x="13588110" y="377698"/>
                </a:lnTo>
                <a:lnTo>
                  <a:pt x="13645895" y="377698"/>
                </a:lnTo>
                <a:lnTo>
                  <a:pt x="13703681" y="377698"/>
                </a:lnTo>
                <a:lnTo>
                  <a:pt x="13761592" y="377698"/>
                </a:lnTo>
                <a:lnTo>
                  <a:pt x="13819377" y="377698"/>
                </a:lnTo>
                <a:lnTo>
                  <a:pt x="13877162" y="377698"/>
                </a:lnTo>
                <a:lnTo>
                  <a:pt x="13934948" y="377698"/>
                </a:lnTo>
                <a:lnTo>
                  <a:pt x="13992860" y="377698"/>
                </a:lnTo>
                <a:lnTo>
                  <a:pt x="14050644" y="377698"/>
                </a:lnTo>
                <a:lnTo>
                  <a:pt x="14108429" y="377698"/>
                </a:lnTo>
                <a:lnTo>
                  <a:pt x="14166341" y="377698"/>
                </a:lnTo>
                <a:lnTo>
                  <a:pt x="14224127" y="377698"/>
                </a:lnTo>
                <a:lnTo>
                  <a:pt x="14281912" y="377698"/>
                </a:lnTo>
                <a:lnTo>
                  <a:pt x="14339696" y="377698"/>
                </a:lnTo>
                <a:lnTo>
                  <a:pt x="14397608" y="377698"/>
                </a:lnTo>
              </a:path>
            </a:pathLst>
          </a:custGeom>
          <a:ln w="27051">
            <a:solidFill>
              <a:srgbClr val="41A3FF"/>
            </a:solidFill>
            <a:prstDash val="dash"/>
          </a:ln>
        </p:spPr>
        <p:txBody>
          <a:bodyPr wrap="square" lIns="0" tIns="0" rIns="0" bIns="0" rtlCol="0"/>
          <a:lstStyle/>
          <a:p/>
        </p:txBody>
      </p:sp>
      <p:sp>
        <p:nvSpPr>
          <p:cNvPr id="23" name="bg object 23"/>
          <p:cNvSpPr/>
          <p:nvPr/>
        </p:nvSpPr>
        <p:spPr>
          <a:xfrm>
            <a:off x="1211452" y="722757"/>
            <a:ext cx="14397990" cy="519430"/>
          </a:xfrm>
          <a:custGeom>
            <a:avLst/>
            <a:gdLst/>
            <a:ahLst/>
            <a:cxnLst/>
            <a:rect l="l" t="t" r="r" b="b"/>
            <a:pathLst>
              <a:path w="14397990" h="519430">
                <a:moveTo>
                  <a:pt x="0" y="0"/>
                </a:moveTo>
                <a:lnTo>
                  <a:pt x="57784" y="0"/>
                </a:lnTo>
                <a:lnTo>
                  <a:pt x="115697" y="0"/>
                </a:lnTo>
                <a:lnTo>
                  <a:pt x="115697" y="1397"/>
                </a:lnTo>
                <a:lnTo>
                  <a:pt x="173481" y="1397"/>
                </a:lnTo>
                <a:lnTo>
                  <a:pt x="173481" y="2794"/>
                </a:lnTo>
                <a:lnTo>
                  <a:pt x="231266" y="2794"/>
                </a:lnTo>
                <a:lnTo>
                  <a:pt x="231266" y="5842"/>
                </a:lnTo>
                <a:lnTo>
                  <a:pt x="289178" y="5842"/>
                </a:lnTo>
                <a:lnTo>
                  <a:pt x="289178" y="7239"/>
                </a:lnTo>
                <a:lnTo>
                  <a:pt x="346963" y="7239"/>
                </a:lnTo>
                <a:lnTo>
                  <a:pt x="346963" y="8763"/>
                </a:lnTo>
                <a:lnTo>
                  <a:pt x="404749" y="8763"/>
                </a:lnTo>
                <a:lnTo>
                  <a:pt x="404749" y="10160"/>
                </a:lnTo>
                <a:lnTo>
                  <a:pt x="462534" y="10160"/>
                </a:lnTo>
                <a:lnTo>
                  <a:pt x="462534" y="11684"/>
                </a:lnTo>
                <a:lnTo>
                  <a:pt x="520446" y="11684"/>
                </a:lnTo>
                <a:lnTo>
                  <a:pt x="578230" y="11684"/>
                </a:lnTo>
                <a:lnTo>
                  <a:pt x="578230" y="14604"/>
                </a:lnTo>
                <a:lnTo>
                  <a:pt x="636016" y="14604"/>
                </a:lnTo>
                <a:lnTo>
                  <a:pt x="636016" y="19050"/>
                </a:lnTo>
                <a:lnTo>
                  <a:pt x="693928" y="19050"/>
                </a:lnTo>
                <a:lnTo>
                  <a:pt x="693928" y="20574"/>
                </a:lnTo>
                <a:lnTo>
                  <a:pt x="751713" y="20574"/>
                </a:lnTo>
                <a:lnTo>
                  <a:pt x="809497" y="20574"/>
                </a:lnTo>
                <a:lnTo>
                  <a:pt x="809497" y="25019"/>
                </a:lnTo>
                <a:lnTo>
                  <a:pt x="867283" y="25019"/>
                </a:lnTo>
                <a:lnTo>
                  <a:pt x="867283" y="26543"/>
                </a:lnTo>
                <a:lnTo>
                  <a:pt x="925195" y="26543"/>
                </a:lnTo>
                <a:lnTo>
                  <a:pt x="925195" y="34163"/>
                </a:lnTo>
                <a:lnTo>
                  <a:pt x="982979" y="34163"/>
                </a:lnTo>
                <a:lnTo>
                  <a:pt x="982979" y="37211"/>
                </a:lnTo>
                <a:lnTo>
                  <a:pt x="1040765" y="37211"/>
                </a:lnTo>
                <a:lnTo>
                  <a:pt x="1098677" y="37211"/>
                </a:lnTo>
                <a:lnTo>
                  <a:pt x="1098677" y="38862"/>
                </a:lnTo>
                <a:lnTo>
                  <a:pt x="1156461" y="38862"/>
                </a:lnTo>
                <a:lnTo>
                  <a:pt x="1156461" y="42037"/>
                </a:lnTo>
                <a:lnTo>
                  <a:pt x="1214247" y="42037"/>
                </a:lnTo>
                <a:lnTo>
                  <a:pt x="1272032" y="42037"/>
                </a:lnTo>
                <a:lnTo>
                  <a:pt x="1272032" y="43561"/>
                </a:lnTo>
                <a:lnTo>
                  <a:pt x="1329944" y="43561"/>
                </a:lnTo>
                <a:lnTo>
                  <a:pt x="1329944" y="46736"/>
                </a:lnTo>
                <a:lnTo>
                  <a:pt x="1387729" y="46736"/>
                </a:lnTo>
                <a:lnTo>
                  <a:pt x="1387729" y="51689"/>
                </a:lnTo>
                <a:lnTo>
                  <a:pt x="1445514" y="51689"/>
                </a:lnTo>
                <a:lnTo>
                  <a:pt x="1445514" y="56515"/>
                </a:lnTo>
                <a:lnTo>
                  <a:pt x="1503426" y="56515"/>
                </a:lnTo>
                <a:lnTo>
                  <a:pt x="1561211" y="56515"/>
                </a:lnTo>
                <a:lnTo>
                  <a:pt x="1561211" y="58166"/>
                </a:lnTo>
                <a:lnTo>
                  <a:pt x="1618996" y="58166"/>
                </a:lnTo>
                <a:lnTo>
                  <a:pt x="1618996" y="63246"/>
                </a:lnTo>
                <a:lnTo>
                  <a:pt x="1676780" y="63246"/>
                </a:lnTo>
                <a:lnTo>
                  <a:pt x="1676780" y="64897"/>
                </a:lnTo>
                <a:lnTo>
                  <a:pt x="1734692" y="64897"/>
                </a:lnTo>
                <a:lnTo>
                  <a:pt x="1734692" y="66548"/>
                </a:lnTo>
                <a:lnTo>
                  <a:pt x="1792477" y="66548"/>
                </a:lnTo>
                <a:lnTo>
                  <a:pt x="1792477" y="71627"/>
                </a:lnTo>
                <a:lnTo>
                  <a:pt x="1850263" y="71627"/>
                </a:lnTo>
                <a:lnTo>
                  <a:pt x="1850263" y="73406"/>
                </a:lnTo>
                <a:lnTo>
                  <a:pt x="1908175" y="73406"/>
                </a:lnTo>
                <a:lnTo>
                  <a:pt x="1908175" y="75057"/>
                </a:lnTo>
                <a:lnTo>
                  <a:pt x="1965960" y="75057"/>
                </a:lnTo>
                <a:lnTo>
                  <a:pt x="1965960" y="76835"/>
                </a:lnTo>
                <a:lnTo>
                  <a:pt x="2023745" y="76835"/>
                </a:lnTo>
                <a:lnTo>
                  <a:pt x="2023745" y="78613"/>
                </a:lnTo>
                <a:lnTo>
                  <a:pt x="2081530" y="78613"/>
                </a:lnTo>
                <a:lnTo>
                  <a:pt x="2081530" y="85598"/>
                </a:lnTo>
                <a:lnTo>
                  <a:pt x="2139442" y="85598"/>
                </a:lnTo>
                <a:lnTo>
                  <a:pt x="2139442" y="90932"/>
                </a:lnTo>
                <a:lnTo>
                  <a:pt x="2197227" y="90932"/>
                </a:lnTo>
                <a:lnTo>
                  <a:pt x="2197227" y="92710"/>
                </a:lnTo>
                <a:lnTo>
                  <a:pt x="2255012" y="92710"/>
                </a:lnTo>
                <a:lnTo>
                  <a:pt x="2255012" y="98171"/>
                </a:lnTo>
                <a:lnTo>
                  <a:pt x="2312924" y="98171"/>
                </a:lnTo>
                <a:lnTo>
                  <a:pt x="2370709" y="98171"/>
                </a:lnTo>
                <a:lnTo>
                  <a:pt x="2370709" y="100075"/>
                </a:lnTo>
                <a:lnTo>
                  <a:pt x="2428494" y="100075"/>
                </a:lnTo>
                <a:lnTo>
                  <a:pt x="2486406" y="100075"/>
                </a:lnTo>
                <a:lnTo>
                  <a:pt x="2486406" y="101853"/>
                </a:lnTo>
                <a:lnTo>
                  <a:pt x="2544191" y="101853"/>
                </a:lnTo>
                <a:lnTo>
                  <a:pt x="2544191" y="103759"/>
                </a:lnTo>
                <a:lnTo>
                  <a:pt x="2601976" y="103759"/>
                </a:lnTo>
                <a:lnTo>
                  <a:pt x="2659761" y="103759"/>
                </a:lnTo>
                <a:lnTo>
                  <a:pt x="2717673" y="103759"/>
                </a:lnTo>
                <a:lnTo>
                  <a:pt x="2717673" y="105664"/>
                </a:lnTo>
                <a:lnTo>
                  <a:pt x="2775458" y="105664"/>
                </a:lnTo>
                <a:lnTo>
                  <a:pt x="2833243" y="105664"/>
                </a:lnTo>
                <a:lnTo>
                  <a:pt x="2833243" y="109600"/>
                </a:lnTo>
                <a:lnTo>
                  <a:pt x="2891155" y="109600"/>
                </a:lnTo>
                <a:lnTo>
                  <a:pt x="2948940" y="109600"/>
                </a:lnTo>
                <a:lnTo>
                  <a:pt x="2948940" y="111633"/>
                </a:lnTo>
                <a:lnTo>
                  <a:pt x="3006725" y="111633"/>
                </a:lnTo>
                <a:lnTo>
                  <a:pt x="3064510" y="111633"/>
                </a:lnTo>
                <a:lnTo>
                  <a:pt x="3064510" y="113665"/>
                </a:lnTo>
                <a:lnTo>
                  <a:pt x="3122422" y="113665"/>
                </a:lnTo>
                <a:lnTo>
                  <a:pt x="3180207" y="113665"/>
                </a:lnTo>
                <a:lnTo>
                  <a:pt x="3237992" y="113665"/>
                </a:lnTo>
                <a:lnTo>
                  <a:pt x="3237992" y="115824"/>
                </a:lnTo>
                <a:lnTo>
                  <a:pt x="3295904" y="115824"/>
                </a:lnTo>
                <a:lnTo>
                  <a:pt x="3353689" y="115824"/>
                </a:lnTo>
                <a:lnTo>
                  <a:pt x="3411474" y="115824"/>
                </a:lnTo>
                <a:lnTo>
                  <a:pt x="3469259" y="115824"/>
                </a:lnTo>
                <a:lnTo>
                  <a:pt x="3527171" y="115824"/>
                </a:lnTo>
                <a:lnTo>
                  <a:pt x="3527171" y="120142"/>
                </a:lnTo>
                <a:lnTo>
                  <a:pt x="3584956" y="120142"/>
                </a:lnTo>
                <a:lnTo>
                  <a:pt x="3584956" y="129032"/>
                </a:lnTo>
                <a:lnTo>
                  <a:pt x="3642741" y="129032"/>
                </a:lnTo>
                <a:lnTo>
                  <a:pt x="3700653" y="129032"/>
                </a:lnTo>
                <a:lnTo>
                  <a:pt x="3700653" y="131318"/>
                </a:lnTo>
                <a:lnTo>
                  <a:pt x="3758438" y="131318"/>
                </a:lnTo>
                <a:lnTo>
                  <a:pt x="3758438" y="133603"/>
                </a:lnTo>
                <a:lnTo>
                  <a:pt x="3816223" y="133603"/>
                </a:lnTo>
                <a:lnTo>
                  <a:pt x="3816223" y="140462"/>
                </a:lnTo>
                <a:lnTo>
                  <a:pt x="3874008" y="140462"/>
                </a:lnTo>
                <a:lnTo>
                  <a:pt x="3874008" y="142748"/>
                </a:lnTo>
                <a:lnTo>
                  <a:pt x="3931920" y="142748"/>
                </a:lnTo>
                <a:lnTo>
                  <a:pt x="3931920" y="147447"/>
                </a:lnTo>
                <a:lnTo>
                  <a:pt x="3989705" y="147447"/>
                </a:lnTo>
                <a:lnTo>
                  <a:pt x="4047490" y="147447"/>
                </a:lnTo>
                <a:lnTo>
                  <a:pt x="4047490" y="149860"/>
                </a:lnTo>
                <a:lnTo>
                  <a:pt x="4105402" y="149860"/>
                </a:lnTo>
                <a:lnTo>
                  <a:pt x="4105402" y="152273"/>
                </a:lnTo>
                <a:lnTo>
                  <a:pt x="4163187" y="152273"/>
                </a:lnTo>
                <a:lnTo>
                  <a:pt x="4163187" y="159639"/>
                </a:lnTo>
                <a:lnTo>
                  <a:pt x="4220972" y="159639"/>
                </a:lnTo>
                <a:lnTo>
                  <a:pt x="4220972" y="162051"/>
                </a:lnTo>
                <a:lnTo>
                  <a:pt x="4278757" y="162051"/>
                </a:lnTo>
                <a:lnTo>
                  <a:pt x="4336669" y="162051"/>
                </a:lnTo>
                <a:lnTo>
                  <a:pt x="4394454" y="162051"/>
                </a:lnTo>
                <a:lnTo>
                  <a:pt x="4394454" y="169672"/>
                </a:lnTo>
                <a:lnTo>
                  <a:pt x="4452239" y="169672"/>
                </a:lnTo>
                <a:lnTo>
                  <a:pt x="4452239" y="172339"/>
                </a:lnTo>
                <a:lnTo>
                  <a:pt x="4510151" y="172339"/>
                </a:lnTo>
                <a:lnTo>
                  <a:pt x="4510151" y="177546"/>
                </a:lnTo>
                <a:lnTo>
                  <a:pt x="4567936" y="177546"/>
                </a:lnTo>
                <a:lnTo>
                  <a:pt x="4625721" y="177546"/>
                </a:lnTo>
                <a:lnTo>
                  <a:pt x="4625721" y="180213"/>
                </a:lnTo>
                <a:lnTo>
                  <a:pt x="4683506" y="180213"/>
                </a:lnTo>
                <a:lnTo>
                  <a:pt x="4741418" y="180213"/>
                </a:lnTo>
                <a:lnTo>
                  <a:pt x="4799203" y="180213"/>
                </a:lnTo>
                <a:lnTo>
                  <a:pt x="4799203" y="183007"/>
                </a:lnTo>
                <a:lnTo>
                  <a:pt x="4856988" y="183007"/>
                </a:lnTo>
                <a:lnTo>
                  <a:pt x="4914900" y="183007"/>
                </a:lnTo>
                <a:lnTo>
                  <a:pt x="4972685" y="183007"/>
                </a:lnTo>
                <a:lnTo>
                  <a:pt x="4972685" y="185800"/>
                </a:lnTo>
                <a:lnTo>
                  <a:pt x="5030470" y="185800"/>
                </a:lnTo>
                <a:lnTo>
                  <a:pt x="5030470" y="188722"/>
                </a:lnTo>
                <a:lnTo>
                  <a:pt x="5088255" y="188722"/>
                </a:lnTo>
                <a:lnTo>
                  <a:pt x="5146167" y="188722"/>
                </a:lnTo>
                <a:lnTo>
                  <a:pt x="5203952" y="188722"/>
                </a:lnTo>
                <a:lnTo>
                  <a:pt x="5261737" y="188722"/>
                </a:lnTo>
                <a:lnTo>
                  <a:pt x="5261737" y="191643"/>
                </a:lnTo>
                <a:lnTo>
                  <a:pt x="5319649" y="191643"/>
                </a:lnTo>
                <a:lnTo>
                  <a:pt x="5377433" y="191643"/>
                </a:lnTo>
                <a:lnTo>
                  <a:pt x="5377433" y="194691"/>
                </a:lnTo>
                <a:lnTo>
                  <a:pt x="5435219" y="194691"/>
                </a:lnTo>
                <a:lnTo>
                  <a:pt x="5435219" y="204089"/>
                </a:lnTo>
                <a:lnTo>
                  <a:pt x="5493004" y="204089"/>
                </a:lnTo>
                <a:lnTo>
                  <a:pt x="5550916" y="204089"/>
                </a:lnTo>
                <a:lnTo>
                  <a:pt x="5608701" y="204089"/>
                </a:lnTo>
                <a:lnTo>
                  <a:pt x="5666486" y="204089"/>
                </a:lnTo>
                <a:lnTo>
                  <a:pt x="5666486" y="207264"/>
                </a:lnTo>
                <a:lnTo>
                  <a:pt x="5724398" y="207264"/>
                </a:lnTo>
                <a:lnTo>
                  <a:pt x="5724398" y="210566"/>
                </a:lnTo>
                <a:lnTo>
                  <a:pt x="5782183" y="210566"/>
                </a:lnTo>
                <a:lnTo>
                  <a:pt x="5782183" y="213995"/>
                </a:lnTo>
                <a:lnTo>
                  <a:pt x="5839968" y="213995"/>
                </a:lnTo>
                <a:lnTo>
                  <a:pt x="5839968" y="220599"/>
                </a:lnTo>
                <a:lnTo>
                  <a:pt x="5897753" y="220599"/>
                </a:lnTo>
                <a:lnTo>
                  <a:pt x="5955665" y="220599"/>
                </a:lnTo>
                <a:lnTo>
                  <a:pt x="5955665" y="224027"/>
                </a:lnTo>
                <a:lnTo>
                  <a:pt x="6013450" y="224027"/>
                </a:lnTo>
                <a:lnTo>
                  <a:pt x="6013450" y="227457"/>
                </a:lnTo>
                <a:lnTo>
                  <a:pt x="6071235" y="227457"/>
                </a:lnTo>
                <a:lnTo>
                  <a:pt x="6071235" y="234442"/>
                </a:lnTo>
                <a:lnTo>
                  <a:pt x="6129147" y="234442"/>
                </a:lnTo>
                <a:lnTo>
                  <a:pt x="6186932" y="234442"/>
                </a:lnTo>
                <a:lnTo>
                  <a:pt x="6186932" y="237998"/>
                </a:lnTo>
                <a:lnTo>
                  <a:pt x="6244717" y="237998"/>
                </a:lnTo>
                <a:lnTo>
                  <a:pt x="6302502" y="237998"/>
                </a:lnTo>
                <a:lnTo>
                  <a:pt x="6302502" y="245237"/>
                </a:lnTo>
                <a:lnTo>
                  <a:pt x="6360414" y="245237"/>
                </a:lnTo>
                <a:lnTo>
                  <a:pt x="6360414" y="252602"/>
                </a:lnTo>
                <a:lnTo>
                  <a:pt x="6418199" y="252602"/>
                </a:lnTo>
                <a:lnTo>
                  <a:pt x="6475983" y="252602"/>
                </a:lnTo>
                <a:lnTo>
                  <a:pt x="6475983" y="256286"/>
                </a:lnTo>
                <a:lnTo>
                  <a:pt x="6533896" y="256286"/>
                </a:lnTo>
                <a:lnTo>
                  <a:pt x="6591681" y="256286"/>
                </a:lnTo>
                <a:lnTo>
                  <a:pt x="6649466" y="256286"/>
                </a:lnTo>
                <a:lnTo>
                  <a:pt x="6649466" y="264160"/>
                </a:lnTo>
                <a:lnTo>
                  <a:pt x="6707251" y="264160"/>
                </a:lnTo>
                <a:lnTo>
                  <a:pt x="6707251" y="275971"/>
                </a:lnTo>
                <a:lnTo>
                  <a:pt x="6765163" y="275971"/>
                </a:lnTo>
                <a:lnTo>
                  <a:pt x="6822948" y="275971"/>
                </a:lnTo>
                <a:lnTo>
                  <a:pt x="6822948" y="280035"/>
                </a:lnTo>
                <a:lnTo>
                  <a:pt x="6880733" y="280035"/>
                </a:lnTo>
                <a:lnTo>
                  <a:pt x="6938645" y="280035"/>
                </a:lnTo>
                <a:lnTo>
                  <a:pt x="6938645" y="284225"/>
                </a:lnTo>
                <a:lnTo>
                  <a:pt x="6996430" y="284225"/>
                </a:lnTo>
                <a:lnTo>
                  <a:pt x="7054215" y="284225"/>
                </a:lnTo>
                <a:lnTo>
                  <a:pt x="7112000" y="284225"/>
                </a:lnTo>
                <a:lnTo>
                  <a:pt x="7169912" y="284225"/>
                </a:lnTo>
                <a:lnTo>
                  <a:pt x="7227697" y="284225"/>
                </a:lnTo>
                <a:lnTo>
                  <a:pt x="7227697" y="293370"/>
                </a:lnTo>
                <a:lnTo>
                  <a:pt x="7285482" y="293370"/>
                </a:lnTo>
                <a:lnTo>
                  <a:pt x="7285482" y="302514"/>
                </a:lnTo>
                <a:lnTo>
                  <a:pt x="7343394" y="302514"/>
                </a:lnTo>
                <a:lnTo>
                  <a:pt x="7401179" y="302514"/>
                </a:lnTo>
                <a:lnTo>
                  <a:pt x="7458964" y="302514"/>
                </a:lnTo>
                <a:lnTo>
                  <a:pt x="7458964" y="312039"/>
                </a:lnTo>
                <a:lnTo>
                  <a:pt x="7516749" y="312039"/>
                </a:lnTo>
                <a:lnTo>
                  <a:pt x="7516749" y="321564"/>
                </a:lnTo>
                <a:lnTo>
                  <a:pt x="7574661" y="321564"/>
                </a:lnTo>
                <a:lnTo>
                  <a:pt x="7632446" y="321564"/>
                </a:lnTo>
                <a:lnTo>
                  <a:pt x="7632446" y="326644"/>
                </a:lnTo>
                <a:lnTo>
                  <a:pt x="7690231" y="326644"/>
                </a:lnTo>
                <a:lnTo>
                  <a:pt x="7748143" y="326644"/>
                </a:lnTo>
                <a:lnTo>
                  <a:pt x="7748143" y="331724"/>
                </a:lnTo>
                <a:lnTo>
                  <a:pt x="7805928" y="331724"/>
                </a:lnTo>
                <a:lnTo>
                  <a:pt x="7805928" y="336931"/>
                </a:lnTo>
                <a:lnTo>
                  <a:pt x="7863713" y="336931"/>
                </a:lnTo>
                <a:lnTo>
                  <a:pt x="7863713" y="342265"/>
                </a:lnTo>
                <a:lnTo>
                  <a:pt x="7921625" y="342265"/>
                </a:lnTo>
                <a:lnTo>
                  <a:pt x="7921625" y="347599"/>
                </a:lnTo>
                <a:lnTo>
                  <a:pt x="7979410" y="347599"/>
                </a:lnTo>
                <a:lnTo>
                  <a:pt x="8037195" y="347599"/>
                </a:lnTo>
                <a:lnTo>
                  <a:pt x="8037195" y="353187"/>
                </a:lnTo>
                <a:lnTo>
                  <a:pt x="8094980" y="353187"/>
                </a:lnTo>
                <a:lnTo>
                  <a:pt x="8152892" y="353187"/>
                </a:lnTo>
                <a:lnTo>
                  <a:pt x="8210677" y="353187"/>
                </a:lnTo>
                <a:lnTo>
                  <a:pt x="8210677" y="364744"/>
                </a:lnTo>
                <a:lnTo>
                  <a:pt x="8268462" y="364744"/>
                </a:lnTo>
                <a:lnTo>
                  <a:pt x="8268462" y="376427"/>
                </a:lnTo>
                <a:lnTo>
                  <a:pt x="8326374" y="376427"/>
                </a:lnTo>
                <a:lnTo>
                  <a:pt x="8384158" y="376427"/>
                </a:lnTo>
                <a:lnTo>
                  <a:pt x="8441944" y="376427"/>
                </a:lnTo>
                <a:lnTo>
                  <a:pt x="8499729" y="376427"/>
                </a:lnTo>
                <a:lnTo>
                  <a:pt x="8557641" y="376427"/>
                </a:lnTo>
                <a:lnTo>
                  <a:pt x="8615426" y="376427"/>
                </a:lnTo>
                <a:lnTo>
                  <a:pt x="8673211" y="376427"/>
                </a:lnTo>
                <a:lnTo>
                  <a:pt x="8731123" y="376427"/>
                </a:lnTo>
                <a:lnTo>
                  <a:pt x="8788908" y="376427"/>
                </a:lnTo>
                <a:lnTo>
                  <a:pt x="8846693" y="376427"/>
                </a:lnTo>
                <a:lnTo>
                  <a:pt x="8904478" y="376427"/>
                </a:lnTo>
                <a:lnTo>
                  <a:pt x="8904478" y="390271"/>
                </a:lnTo>
                <a:lnTo>
                  <a:pt x="8962390" y="390271"/>
                </a:lnTo>
                <a:lnTo>
                  <a:pt x="9020175" y="390271"/>
                </a:lnTo>
                <a:lnTo>
                  <a:pt x="9077960" y="390271"/>
                </a:lnTo>
                <a:lnTo>
                  <a:pt x="9135872" y="390271"/>
                </a:lnTo>
                <a:lnTo>
                  <a:pt x="9135872" y="397764"/>
                </a:lnTo>
                <a:lnTo>
                  <a:pt x="9193657" y="397764"/>
                </a:lnTo>
                <a:lnTo>
                  <a:pt x="9251442" y="397764"/>
                </a:lnTo>
                <a:lnTo>
                  <a:pt x="9309227" y="397764"/>
                </a:lnTo>
                <a:lnTo>
                  <a:pt x="9367139" y="397764"/>
                </a:lnTo>
                <a:lnTo>
                  <a:pt x="9424924" y="397764"/>
                </a:lnTo>
                <a:lnTo>
                  <a:pt x="9482709" y="397764"/>
                </a:lnTo>
                <a:lnTo>
                  <a:pt x="9540621" y="397764"/>
                </a:lnTo>
                <a:lnTo>
                  <a:pt x="9598406" y="397764"/>
                </a:lnTo>
                <a:lnTo>
                  <a:pt x="9656191" y="397764"/>
                </a:lnTo>
                <a:lnTo>
                  <a:pt x="9713976" y="397764"/>
                </a:lnTo>
                <a:lnTo>
                  <a:pt x="9771888" y="397764"/>
                </a:lnTo>
                <a:lnTo>
                  <a:pt x="9829673" y="397764"/>
                </a:lnTo>
                <a:lnTo>
                  <a:pt x="9887458" y="397764"/>
                </a:lnTo>
                <a:lnTo>
                  <a:pt x="9945370" y="397764"/>
                </a:lnTo>
                <a:lnTo>
                  <a:pt x="10003155" y="397764"/>
                </a:lnTo>
                <a:lnTo>
                  <a:pt x="10060940" y="397764"/>
                </a:lnTo>
                <a:lnTo>
                  <a:pt x="10118725" y="397764"/>
                </a:lnTo>
                <a:lnTo>
                  <a:pt x="10176637" y="397764"/>
                </a:lnTo>
                <a:lnTo>
                  <a:pt x="10234422" y="397764"/>
                </a:lnTo>
                <a:lnTo>
                  <a:pt x="10234422" y="409067"/>
                </a:lnTo>
                <a:lnTo>
                  <a:pt x="10292207" y="409067"/>
                </a:lnTo>
                <a:lnTo>
                  <a:pt x="10350119" y="409067"/>
                </a:lnTo>
                <a:lnTo>
                  <a:pt x="10407904" y="409067"/>
                </a:lnTo>
                <a:lnTo>
                  <a:pt x="10465689" y="409067"/>
                </a:lnTo>
                <a:lnTo>
                  <a:pt x="10465689" y="421004"/>
                </a:lnTo>
                <a:lnTo>
                  <a:pt x="10523474" y="421004"/>
                </a:lnTo>
                <a:lnTo>
                  <a:pt x="10581386" y="421004"/>
                </a:lnTo>
                <a:lnTo>
                  <a:pt x="10639171" y="421004"/>
                </a:lnTo>
                <a:lnTo>
                  <a:pt x="10696956" y="421004"/>
                </a:lnTo>
                <a:lnTo>
                  <a:pt x="10754868" y="421004"/>
                </a:lnTo>
                <a:lnTo>
                  <a:pt x="10812653" y="421004"/>
                </a:lnTo>
                <a:lnTo>
                  <a:pt x="10870438" y="421004"/>
                </a:lnTo>
                <a:lnTo>
                  <a:pt x="10928223" y="421004"/>
                </a:lnTo>
                <a:lnTo>
                  <a:pt x="10986135" y="421004"/>
                </a:lnTo>
                <a:lnTo>
                  <a:pt x="11043920" y="421004"/>
                </a:lnTo>
                <a:lnTo>
                  <a:pt x="11043920" y="436118"/>
                </a:lnTo>
                <a:lnTo>
                  <a:pt x="11101705" y="436118"/>
                </a:lnTo>
                <a:lnTo>
                  <a:pt x="11159617" y="436118"/>
                </a:lnTo>
                <a:lnTo>
                  <a:pt x="11159617" y="451993"/>
                </a:lnTo>
                <a:lnTo>
                  <a:pt x="11217402" y="451993"/>
                </a:lnTo>
                <a:lnTo>
                  <a:pt x="11275187" y="451993"/>
                </a:lnTo>
                <a:lnTo>
                  <a:pt x="11332972" y="451993"/>
                </a:lnTo>
                <a:lnTo>
                  <a:pt x="11390884" y="451993"/>
                </a:lnTo>
                <a:lnTo>
                  <a:pt x="11448669" y="451993"/>
                </a:lnTo>
                <a:lnTo>
                  <a:pt x="11448669" y="470535"/>
                </a:lnTo>
                <a:lnTo>
                  <a:pt x="11506454" y="470535"/>
                </a:lnTo>
                <a:lnTo>
                  <a:pt x="11564366" y="470535"/>
                </a:lnTo>
                <a:lnTo>
                  <a:pt x="11622151" y="470535"/>
                </a:lnTo>
                <a:lnTo>
                  <a:pt x="11679936" y="470535"/>
                </a:lnTo>
                <a:lnTo>
                  <a:pt x="11737721" y="470535"/>
                </a:lnTo>
                <a:lnTo>
                  <a:pt x="11795633" y="470535"/>
                </a:lnTo>
                <a:lnTo>
                  <a:pt x="11795633" y="493522"/>
                </a:lnTo>
                <a:lnTo>
                  <a:pt x="11853418" y="493522"/>
                </a:lnTo>
                <a:lnTo>
                  <a:pt x="11911203" y="493522"/>
                </a:lnTo>
                <a:lnTo>
                  <a:pt x="11969115" y="493522"/>
                </a:lnTo>
                <a:lnTo>
                  <a:pt x="12026900" y="493522"/>
                </a:lnTo>
                <a:lnTo>
                  <a:pt x="12026900" y="519429"/>
                </a:lnTo>
                <a:lnTo>
                  <a:pt x="12142470" y="519429"/>
                </a:lnTo>
                <a:lnTo>
                  <a:pt x="12200382" y="519429"/>
                </a:lnTo>
                <a:lnTo>
                  <a:pt x="12258166" y="519429"/>
                </a:lnTo>
                <a:lnTo>
                  <a:pt x="12315952" y="519429"/>
                </a:lnTo>
                <a:lnTo>
                  <a:pt x="12373864" y="519429"/>
                </a:lnTo>
                <a:lnTo>
                  <a:pt x="12431649" y="519429"/>
                </a:lnTo>
                <a:lnTo>
                  <a:pt x="12547218" y="519429"/>
                </a:lnTo>
                <a:lnTo>
                  <a:pt x="12605131" y="519429"/>
                </a:lnTo>
                <a:lnTo>
                  <a:pt x="12662916" y="519429"/>
                </a:lnTo>
                <a:lnTo>
                  <a:pt x="12720701" y="519429"/>
                </a:lnTo>
                <a:lnTo>
                  <a:pt x="12778613" y="519429"/>
                </a:lnTo>
                <a:lnTo>
                  <a:pt x="12836398" y="519429"/>
                </a:lnTo>
                <a:lnTo>
                  <a:pt x="12894183" y="519429"/>
                </a:lnTo>
                <a:lnTo>
                  <a:pt x="12951968" y="519429"/>
                </a:lnTo>
                <a:lnTo>
                  <a:pt x="13009879" y="519429"/>
                </a:lnTo>
                <a:lnTo>
                  <a:pt x="13067664" y="519429"/>
                </a:lnTo>
                <a:lnTo>
                  <a:pt x="13125450" y="519429"/>
                </a:lnTo>
                <a:lnTo>
                  <a:pt x="13241146" y="519429"/>
                </a:lnTo>
                <a:lnTo>
                  <a:pt x="13298931" y="519429"/>
                </a:lnTo>
                <a:lnTo>
                  <a:pt x="13356843" y="519429"/>
                </a:lnTo>
                <a:lnTo>
                  <a:pt x="13414629" y="519429"/>
                </a:lnTo>
                <a:lnTo>
                  <a:pt x="13472414" y="519429"/>
                </a:lnTo>
                <a:lnTo>
                  <a:pt x="13530198" y="519429"/>
                </a:lnTo>
                <a:lnTo>
                  <a:pt x="13588110" y="519429"/>
                </a:lnTo>
                <a:lnTo>
                  <a:pt x="13645895" y="519429"/>
                </a:lnTo>
                <a:lnTo>
                  <a:pt x="13703681" y="519429"/>
                </a:lnTo>
                <a:lnTo>
                  <a:pt x="13761592" y="519429"/>
                </a:lnTo>
                <a:lnTo>
                  <a:pt x="13819377" y="519429"/>
                </a:lnTo>
                <a:lnTo>
                  <a:pt x="13934948" y="519429"/>
                </a:lnTo>
                <a:lnTo>
                  <a:pt x="13992860" y="519429"/>
                </a:lnTo>
                <a:lnTo>
                  <a:pt x="14108429" y="519429"/>
                </a:lnTo>
                <a:lnTo>
                  <a:pt x="14166341" y="519429"/>
                </a:lnTo>
                <a:lnTo>
                  <a:pt x="14224127" y="519429"/>
                </a:lnTo>
                <a:lnTo>
                  <a:pt x="14397608" y="519429"/>
                </a:lnTo>
              </a:path>
            </a:pathLst>
          </a:custGeom>
          <a:ln w="27051">
            <a:solidFill>
              <a:srgbClr val="DFD625"/>
            </a:solidFill>
            <a:prstDash val="dot"/>
          </a:ln>
        </p:spPr>
        <p:txBody>
          <a:bodyPr wrap="square" lIns="0" tIns="0" rIns="0" bIns="0" rtlCol="0"/>
          <a:lstStyle/>
          <a:p/>
        </p:txBody>
      </p:sp>
      <p:sp>
        <p:nvSpPr>
          <p:cNvPr id="24" name="bg object 24"/>
          <p:cNvSpPr/>
          <p:nvPr/>
        </p:nvSpPr>
        <p:spPr>
          <a:xfrm>
            <a:off x="1211452" y="722757"/>
            <a:ext cx="14166850" cy="850265"/>
          </a:xfrm>
          <a:custGeom>
            <a:avLst/>
            <a:gdLst/>
            <a:ahLst/>
            <a:cxnLst/>
            <a:rect l="l" t="t" r="r" b="b"/>
            <a:pathLst>
              <a:path w="14166850" h="850265">
                <a:moveTo>
                  <a:pt x="0" y="0"/>
                </a:moveTo>
                <a:lnTo>
                  <a:pt x="57784" y="0"/>
                </a:lnTo>
                <a:lnTo>
                  <a:pt x="115697" y="0"/>
                </a:lnTo>
                <a:lnTo>
                  <a:pt x="115697" y="3048"/>
                </a:lnTo>
                <a:lnTo>
                  <a:pt x="173481" y="3048"/>
                </a:lnTo>
                <a:lnTo>
                  <a:pt x="173481" y="6096"/>
                </a:lnTo>
                <a:lnTo>
                  <a:pt x="231266" y="6096"/>
                </a:lnTo>
                <a:lnTo>
                  <a:pt x="231266" y="9144"/>
                </a:lnTo>
                <a:lnTo>
                  <a:pt x="289178" y="9144"/>
                </a:lnTo>
                <a:lnTo>
                  <a:pt x="289178" y="12192"/>
                </a:lnTo>
                <a:lnTo>
                  <a:pt x="346963" y="12192"/>
                </a:lnTo>
                <a:lnTo>
                  <a:pt x="404749" y="12192"/>
                </a:lnTo>
                <a:lnTo>
                  <a:pt x="462534" y="12192"/>
                </a:lnTo>
                <a:lnTo>
                  <a:pt x="462534" y="15240"/>
                </a:lnTo>
                <a:lnTo>
                  <a:pt x="520446" y="15240"/>
                </a:lnTo>
                <a:lnTo>
                  <a:pt x="520446" y="24511"/>
                </a:lnTo>
                <a:lnTo>
                  <a:pt x="578230" y="24511"/>
                </a:lnTo>
                <a:lnTo>
                  <a:pt x="636016" y="24511"/>
                </a:lnTo>
                <a:lnTo>
                  <a:pt x="636016" y="27686"/>
                </a:lnTo>
                <a:lnTo>
                  <a:pt x="693928" y="27686"/>
                </a:lnTo>
                <a:lnTo>
                  <a:pt x="693928" y="30734"/>
                </a:lnTo>
                <a:lnTo>
                  <a:pt x="751713" y="30734"/>
                </a:lnTo>
                <a:lnTo>
                  <a:pt x="751713" y="43307"/>
                </a:lnTo>
                <a:lnTo>
                  <a:pt x="809497" y="43307"/>
                </a:lnTo>
                <a:lnTo>
                  <a:pt x="867283" y="43307"/>
                </a:lnTo>
                <a:lnTo>
                  <a:pt x="925195" y="43307"/>
                </a:lnTo>
                <a:lnTo>
                  <a:pt x="925195" y="46482"/>
                </a:lnTo>
                <a:lnTo>
                  <a:pt x="982979" y="46482"/>
                </a:lnTo>
                <a:lnTo>
                  <a:pt x="982979" y="49784"/>
                </a:lnTo>
                <a:lnTo>
                  <a:pt x="1040765" y="49784"/>
                </a:lnTo>
                <a:lnTo>
                  <a:pt x="1098677" y="49784"/>
                </a:lnTo>
                <a:lnTo>
                  <a:pt x="1156461" y="49784"/>
                </a:lnTo>
                <a:lnTo>
                  <a:pt x="1156461" y="53086"/>
                </a:lnTo>
                <a:lnTo>
                  <a:pt x="1214247" y="53086"/>
                </a:lnTo>
                <a:lnTo>
                  <a:pt x="1272032" y="53086"/>
                </a:lnTo>
                <a:lnTo>
                  <a:pt x="1329944" y="53086"/>
                </a:lnTo>
                <a:lnTo>
                  <a:pt x="1387729" y="53086"/>
                </a:lnTo>
                <a:lnTo>
                  <a:pt x="1387729" y="56515"/>
                </a:lnTo>
                <a:lnTo>
                  <a:pt x="1445514" y="56515"/>
                </a:lnTo>
                <a:lnTo>
                  <a:pt x="1503426" y="56515"/>
                </a:lnTo>
                <a:lnTo>
                  <a:pt x="1503426" y="59944"/>
                </a:lnTo>
                <a:lnTo>
                  <a:pt x="1561211" y="59944"/>
                </a:lnTo>
                <a:lnTo>
                  <a:pt x="1618996" y="59944"/>
                </a:lnTo>
                <a:lnTo>
                  <a:pt x="1618996" y="70739"/>
                </a:lnTo>
                <a:lnTo>
                  <a:pt x="1676780" y="70739"/>
                </a:lnTo>
                <a:lnTo>
                  <a:pt x="1676780" y="74295"/>
                </a:lnTo>
                <a:lnTo>
                  <a:pt x="1734692" y="74295"/>
                </a:lnTo>
                <a:lnTo>
                  <a:pt x="1734692" y="77977"/>
                </a:lnTo>
                <a:lnTo>
                  <a:pt x="1792477" y="77977"/>
                </a:lnTo>
                <a:lnTo>
                  <a:pt x="1850263" y="77977"/>
                </a:lnTo>
                <a:lnTo>
                  <a:pt x="1908175" y="77977"/>
                </a:lnTo>
                <a:lnTo>
                  <a:pt x="1908175" y="85471"/>
                </a:lnTo>
                <a:lnTo>
                  <a:pt x="1965960" y="85471"/>
                </a:lnTo>
                <a:lnTo>
                  <a:pt x="1965960" y="89281"/>
                </a:lnTo>
                <a:lnTo>
                  <a:pt x="2023745" y="89281"/>
                </a:lnTo>
                <a:lnTo>
                  <a:pt x="2023745" y="93091"/>
                </a:lnTo>
                <a:lnTo>
                  <a:pt x="2081530" y="93091"/>
                </a:lnTo>
                <a:lnTo>
                  <a:pt x="2081530" y="93091"/>
                </a:lnTo>
                <a:lnTo>
                  <a:pt x="2139442" y="93091"/>
                </a:lnTo>
                <a:lnTo>
                  <a:pt x="2197227" y="93091"/>
                </a:lnTo>
                <a:lnTo>
                  <a:pt x="2255012" y="93091"/>
                </a:lnTo>
                <a:lnTo>
                  <a:pt x="2255012" y="97027"/>
                </a:lnTo>
                <a:lnTo>
                  <a:pt x="2312924" y="97027"/>
                </a:lnTo>
                <a:lnTo>
                  <a:pt x="2370709" y="97027"/>
                </a:lnTo>
                <a:lnTo>
                  <a:pt x="2428494" y="97027"/>
                </a:lnTo>
                <a:lnTo>
                  <a:pt x="2428494" y="101092"/>
                </a:lnTo>
                <a:lnTo>
                  <a:pt x="2486406" y="101092"/>
                </a:lnTo>
                <a:lnTo>
                  <a:pt x="2486406" y="109220"/>
                </a:lnTo>
                <a:lnTo>
                  <a:pt x="2544191" y="109220"/>
                </a:lnTo>
                <a:lnTo>
                  <a:pt x="2601976" y="109220"/>
                </a:lnTo>
                <a:lnTo>
                  <a:pt x="2659761" y="109220"/>
                </a:lnTo>
                <a:lnTo>
                  <a:pt x="2659761" y="113411"/>
                </a:lnTo>
                <a:lnTo>
                  <a:pt x="2717673" y="113411"/>
                </a:lnTo>
                <a:lnTo>
                  <a:pt x="2775458" y="113411"/>
                </a:lnTo>
                <a:lnTo>
                  <a:pt x="2833243" y="113411"/>
                </a:lnTo>
                <a:lnTo>
                  <a:pt x="2891155" y="113411"/>
                </a:lnTo>
                <a:lnTo>
                  <a:pt x="2948940" y="113411"/>
                </a:lnTo>
                <a:lnTo>
                  <a:pt x="2948940" y="122300"/>
                </a:lnTo>
                <a:lnTo>
                  <a:pt x="3006725" y="122300"/>
                </a:lnTo>
                <a:lnTo>
                  <a:pt x="3064510" y="122300"/>
                </a:lnTo>
                <a:lnTo>
                  <a:pt x="3122422" y="122300"/>
                </a:lnTo>
                <a:lnTo>
                  <a:pt x="3122422" y="126873"/>
                </a:lnTo>
                <a:lnTo>
                  <a:pt x="3180207" y="126873"/>
                </a:lnTo>
                <a:lnTo>
                  <a:pt x="3180207" y="131445"/>
                </a:lnTo>
                <a:lnTo>
                  <a:pt x="3237992" y="131445"/>
                </a:lnTo>
                <a:lnTo>
                  <a:pt x="3295904" y="131445"/>
                </a:lnTo>
                <a:lnTo>
                  <a:pt x="3295904" y="136144"/>
                </a:lnTo>
                <a:lnTo>
                  <a:pt x="3353689" y="136144"/>
                </a:lnTo>
                <a:lnTo>
                  <a:pt x="3353689" y="140716"/>
                </a:lnTo>
                <a:lnTo>
                  <a:pt x="3411474" y="140716"/>
                </a:lnTo>
                <a:lnTo>
                  <a:pt x="3411474" y="145542"/>
                </a:lnTo>
                <a:lnTo>
                  <a:pt x="3469259" y="145542"/>
                </a:lnTo>
                <a:lnTo>
                  <a:pt x="3469259" y="150241"/>
                </a:lnTo>
                <a:lnTo>
                  <a:pt x="3527171" y="150241"/>
                </a:lnTo>
                <a:lnTo>
                  <a:pt x="3527171" y="159893"/>
                </a:lnTo>
                <a:lnTo>
                  <a:pt x="3584956" y="159893"/>
                </a:lnTo>
                <a:lnTo>
                  <a:pt x="3584956" y="164719"/>
                </a:lnTo>
                <a:lnTo>
                  <a:pt x="3642741" y="164719"/>
                </a:lnTo>
                <a:lnTo>
                  <a:pt x="3642741" y="169545"/>
                </a:lnTo>
                <a:lnTo>
                  <a:pt x="3700653" y="169545"/>
                </a:lnTo>
                <a:lnTo>
                  <a:pt x="3700653" y="174498"/>
                </a:lnTo>
                <a:lnTo>
                  <a:pt x="3758438" y="174498"/>
                </a:lnTo>
                <a:lnTo>
                  <a:pt x="3816223" y="174498"/>
                </a:lnTo>
                <a:lnTo>
                  <a:pt x="3816223" y="179577"/>
                </a:lnTo>
                <a:lnTo>
                  <a:pt x="3874008" y="179577"/>
                </a:lnTo>
                <a:lnTo>
                  <a:pt x="3874008" y="184785"/>
                </a:lnTo>
                <a:lnTo>
                  <a:pt x="3931920" y="184785"/>
                </a:lnTo>
                <a:lnTo>
                  <a:pt x="3931920" y="195072"/>
                </a:lnTo>
                <a:lnTo>
                  <a:pt x="3989705" y="195072"/>
                </a:lnTo>
                <a:lnTo>
                  <a:pt x="4047490" y="195072"/>
                </a:lnTo>
                <a:lnTo>
                  <a:pt x="4105402" y="195072"/>
                </a:lnTo>
                <a:lnTo>
                  <a:pt x="4105402" y="205994"/>
                </a:lnTo>
                <a:lnTo>
                  <a:pt x="4163187" y="205994"/>
                </a:lnTo>
                <a:lnTo>
                  <a:pt x="4163187" y="211582"/>
                </a:lnTo>
                <a:lnTo>
                  <a:pt x="4220972" y="211582"/>
                </a:lnTo>
                <a:lnTo>
                  <a:pt x="4278757" y="211582"/>
                </a:lnTo>
                <a:lnTo>
                  <a:pt x="4278757" y="217170"/>
                </a:lnTo>
                <a:lnTo>
                  <a:pt x="4336669" y="217170"/>
                </a:lnTo>
                <a:lnTo>
                  <a:pt x="4394454" y="217170"/>
                </a:lnTo>
                <a:lnTo>
                  <a:pt x="4452239" y="217170"/>
                </a:lnTo>
                <a:lnTo>
                  <a:pt x="4452239" y="223012"/>
                </a:lnTo>
                <a:lnTo>
                  <a:pt x="4510151" y="223012"/>
                </a:lnTo>
                <a:lnTo>
                  <a:pt x="4510151" y="234696"/>
                </a:lnTo>
                <a:lnTo>
                  <a:pt x="4567936" y="234696"/>
                </a:lnTo>
                <a:lnTo>
                  <a:pt x="4567936" y="240665"/>
                </a:lnTo>
                <a:lnTo>
                  <a:pt x="4625721" y="240665"/>
                </a:lnTo>
                <a:lnTo>
                  <a:pt x="4683506" y="240665"/>
                </a:lnTo>
                <a:lnTo>
                  <a:pt x="4683506" y="246634"/>
                </a:lnTo>
                <a:lnTo>
                  <a:pt x="4741418" y="246634"/>
                </a:lnTo>
                <a:lnTo>
                  <a:pt x="4741418" y="252729"/>
                </a:lnTo>
                <a:lnTo>
                  <a:pt x="4799203" y="252729"/>
                </a:lnTo>
                <a:lnTo>
                  <a:pt x="4856988" y="252729"/>
                </a:lnTo>
                <a:lnTo>
                  <a:pt x="4856988" y="258825"/>
                </a:lnTo>
                <a:lnTo>
                  <a:pt x="4914900" y="258825"/>
                </a:lnTo>
                <a:lnTo>
                  <a:pt x="4914900" y="265049"/>
                </a:lnTo>
                <a:lnTo>
                  <a:pt x="4972685" y="265049"/>
                </a:lnTo>
                <a:lnTo>
                  <a:pt x="4972685" y="265049"/>
                </a:lnTo>
                <a:lnTo>
                  <a:pt x="5030470" y="265049"/>
                </a:lnTo>
                <a:lnTo>
                  <a:pt x="5088255" y="265049"/>
                </a:lnTo>
                <a:lnTo>
                  <a:pt x="5146167" y="265049"/>
                </a:lnTo>
                <a:lnTo>
                  <a:pt x="5203952" y="265049"/>
                </a:lnTo>
                <a:lnTo>
                  <a:pt x="5203952" y="271525"/>
                </a:lnTo>
                <a:lnTo>
                  <a:pt x="5261737" y="271525"/>
                </a:lnTo>
                <a:lnTo>
                  <a:pt x="5319649" y="271525"/>
                </a:lnTo>
                <a:lnTo>
                  <a:pt x="5319649" y="278257"/>
                </a:lnTo>
                <a:lnTo>
                  <a:pt x="5377433" y="278257"/>
                </a:lnTo>
                <a:lnTo>
                  <a:pt x="5435219" y="278257"/>
                </a:lnTo>
                <a:lnTo>
                  <a:pt x="5435219" y="285242"/>
                </a:lnTo>
                <a:lnTo>
                  <a:pt x="5493004" y="285242"/>
                </a:lnTo>
                <a:lnTo>
                  <a:pt x="5550916" y="285242"/>
                </a:lnTo>
                <a:lnTo>
                  <a:pt x="5608701" y="285242"/>
                </a:lnTo>
                <a:lnTo>
                  <a:pt x="5666486" y="285242"/>
                </a:lnTo>
                <a:lnTo>
                  <a:pt x="5666486" y="292481"/>
                </a:lnTo>
                <a:lnTo>
                  <a:pt x="5724398" y="292481"/>
                </a:lnTo>
                <a:lnTo>
                  <a:pt x="5782183" y="292481"/>
                </a:lnTo>
                <a:lnTo>
                  <a:pt x="5839968" y="292481"/>
                </a:lnTo>
                <a:lnTo>
                  <a:pt x="5897753" y="292481"/>
                </a:lnTo>
                <a:lnTo>
                  <a:pt x="5897753" y="307848"/>
                </a:lnTo>
                <a:lnTo>
                  <a:pt x="5955665" y="307848"/>
                </a:lnTo>
                <a:lnTo>
                  <a:pt x="6013450" y="307848"/>
                </a:lnTo>
                <a:lnTo>
                  <a:pt x="6013450" y="315849"/>
                </a:lnTo>
                <a:lnTo>
                  <a:pt x="6071235" y="315849"/>
                </a:lnTo>
                <a:lnTo>
                  <a:pt x="6071235" y="331977"/>
                </a:lnTo>
                <a:lnTo>
                  <a:pt x="6129147" y="331977"/>
                </a:lnTo>
                <a:lnTo>
                  <a:pt x="6186932" y="331977"/>
                </a:lnTo>
                <a:lnTo>
                  <a:pt x="6186932" y="364617"/>
                </a:lnTo>
                <a:lnTo>
                  <a:pt x="6244717" y="364617"/>
                </a:lnTo>
                <a:lnTo>
                  <a:pt x="6302502" y="364617"/>
                </a:lnTo>
                <a:lnTo>
                  <a:pt x="6360414" y="364617"/>
                </a:lnTo>
                <a:lnTo>
                  <a:pt x="6418199" y="364617"/>
                </a:lnTo>
                <a:lnTo>
                  <a:pt x="6475983" y="364617"/>
                </a:lnTo>
                <a:lnTo>
                  <a:pt x="6475983" y="382016"/>
                </a:lnTo>
                <a:lnTo>
                  <a:pt x="6533896" y="382016"/>
                </a:lnTo>
                <a:lnTo>
                  <a:pt x="6591681" y="382016"/>
                </a:lnTo>
                <a:lnTo>
                  <a:pt x="6649466" y="382016"/>
                </a:lnTo>
                <a:lnTo>
                  <a:pt x="6707251" y="382016"/>
                </a:lnTo>
                <a:lnTo>
                  <a:pt x="6707251" y="400558"/>
                </a:lnTo>
                <a:lnTo>
                  <a:pt x="6765163" y="400558"/>
                </a:lnTo>
                <a:lnTo>
                  <a:pt x="6822948" y="400558"/>
                </a:lnTo>
                <a:lnTo>
                  <a:pt x="6822948" y="410083"/>
                </a:lnTo>
                <a:lnTo>
                  <a:pt x="6938645" y="410083"/>
                </a:lnTo>
                <a:lnTo>
                  <a:pt x="6996430" y="410083"/>
                </a:lnTo>
                <a:lnTo>
                  <a:pt x="6996430" y="419862"/>
                </a:lnTo>
                <a:lnTo>
                  <a:pt x="7054215" y="419862"/>
                </a:lnTo>
                <a:lnTo>
                  <a:pt x="7112000" y="419862"/>
                </a:lnTo>
                <a:lnTo>
                  <a:pt x="7169912" y="419862"/>
                </a:lnTo>
                <a:lnTo>
                  <a:pt x="7169912" y="430275"/>
                </a:lnTo>
                <a:lnTo>
                  <a:pt x="7227697" y="430275"/>
                </a:lnTo>
                <a:lnTo>
                  <a:pt x="7285482" y="430275"/>
                </a:lnTo>
                <a:lnTo>
                  <a:pt x="7343394" y="430275"/>
                </a:lnTo>
                <a:lnTo>
                  <a:pt x="7401179" y="430275"/>
                </a:lnTo>
                <a:lnTo>
                  <a:pt x="7401179" y="440944"/>
                </a:lnTo>
                <a:lnTo>
                  <a:pt x="7458964" y="440944"/>
                </a:lnTo>
                <a:lnTo>
                  <a:pt x="7516749" y="440944"/>
                </a:lnTo>
                <a:lnTo>
                  <a:pt x="7574661" y="440944"/>
                </a:lnTo>
                <a:lnTo>
                  <a:pt x="7632446" y="440944"/>
                </a:lnTo>
                <a:lnTo>
                  <a:pt x="7690231" y="440944"/>
                </a:lnTo>
                <a:lnTo>
                  <a:pt x="7748143" y="440944"/>
                </a:lnTo>
                <a:lnTo>
                  <a:pt x="7805928" y="440944"/>
                </a:lnTo>
                <a:lnTo>
                  <a:pt x="7805928" y="453517"/>
                </a:lnTo>
                <a:lnTo>
                  <a:pt x="7863713" y="453517"/>
                </a:lnTo>
                <a:lnTo>
                  <a:pt x="7921625" y="453517"/>
                </a:lnTo>
                <a:lnTo>
                  <a:pt x="7979410" y="453517"/>
                </a:lnTo>
                <a:lnTo>
                  <a:pt x="8037195" y="453517"/>
                </a:lnTo>
                <a:lnTo>
                  <a:pt x="8094980" y="453517"/>
                </a:lnTo>
                <a:lnTo>
                  <a:pt x="8094980" y="466851"/>
                </a:lnTo>
                <a:lnTo>
                  <a:pt x="8152892" y="466851"/>
                </a:lnTo>
                <a:lnTo>
                  <a:pt x="8210677" y="466851"/>
                </a:lnTo>
                <a:lnTo>
                  <a:pt x="8268462" y="466851"/>
                </a:lnTo>
                <a:lnTo>
                  <a:pt x="8326374" y="466851"/>
                </a:lnTo>
                <a:lnTo>
                  <a:pt x="8384158" y="466851"/>
                </a:lnTo>
                <a:lnTo>
                  <a:pt x="8441944" y="466851"/>
                </a:lnTo>
                <a:lnTo>
                  <a:pt x="8499729" y="466851"/>
                </a:lnTo>
                <a:lnTo>
                  <a:pt x="8499729" y="481329"/>
                </a:lnTo>
                <a:lnTo>
                  <a:pt x="8557641" y="481329"/>
                </a:lnTo>
                <a:lnTo>
                  <a:pt x="8557641" y="496316"/>
                </a:lnTo>
                <a:lnTo>
                  <a:pt x="8615426" y="496316"/>
                </a:lnTo>
                <a:lnTo>
                  <a:pt x="8615426" y="511810"/>
                </a:lnTo>
                <a:lnTo>
                  <a:pt x="8673211" y="511810"/>
                </a:lnTo>
                <a:lnTo>
                  <a:pt x="8673211" y="511810"/>
                </a:lnTo>
                <a:lnTo>
                  <a:pt x="8731123" y="511810"/>
                </a:lnTo>
                <a:lnTo>
                  <a:pt x="8788908" y="511810"/>
                </a:lnTo>
                <a:lnTo>
                  <a:pt x="8846693" y="511810"/>
                </a:lnTo>
                <a:lnTo>
                  <a:pt x="8904478" y="511810"/>
                </a:lnTo>
                <a:lnTo>
                  <a:pt x="8962390" y="511810"/>
                </a:lnTo>
                <a:lnTo>
                  <a:pt x="9020175" y="511810"/>
                </a:lnTo>
                <a:lnTo>
                  <a:pt x="9020175" y="528954"/>
                </a:lnTo>
                <a:lnTo>
                  <a:pt x="9077960" y="528954"/>
                </a:lnTo>
                <a:lnTo>
                  <a:pt x="9135872" y="528954"/>
                </a:lnTo>
                <a:lnTo>
                  <a:pt x="9135872" y="546989"/>
                </a:lnTo>
                <a:lnTo>
                  <a:pt x="9193657" y="546989"/>
                </a:lnTo>
                <a:lnTo>
                  <a:pt x="9193657" y="565912"/>
                </a:lnTo>
                <a:lnTo>
                  <a:pt x="9251442" y="565912"/>
                </a:lnTo>
                <a:lnTo>
                  <a:pt x="9309227" y="565912"/>
                </a:lnTo>
                <a:lnTo>
                  <a:pt x="9309227" y="585089"/>
                </a:lnTo>
                <a:lnTo>
                  <a:pt x="9424924" y="585089"/>
                </a:lnTo>
                <a:lnTo>
                  <a:pt x="9424924" y="605027"/>
                </a:lnTo>
                <a:lnTo>
                  <a:pt x="9482709" y="605027"/>
                </a:lnTo>
                <a:lnTo>
                  <a:pt x="9482709" y="624840"/>
                </a:lnTo>
                <a:lnTo>
                  <a:pt x="9540621" y="624840"/>
                </a:lnTo>
                <a:lnTo>
                  <a:pt x="9540621" y="624840"/>
                </a:lnTo>
                <a:lnTo>
                  <a:pt x="9598406" y="624840"/>
                </a:lnTo>
                <a:lnTo>
                  <a:pt x="9656191" y="624840"/>
                </a:lnTo>
                <a:lnTo>
                  <a:pt x="9713976" y="624840"/>
                </a:lnTo>
                <a:lnTo>
                  <a:pt x="9771888" y="624840"/>
                </a:lnTo>
                <a:lnTo>
                  <a:pt x="9829673" y="624840"/>
                </a:lnTo>
                <a:lnTo>
                  <a:pt x="9887458" y="624840"/>
                </a:lnTo>
                <a:lnTo>
                  <a:pt x="10003155" y="624840"/>
                </a:lnTo>
                <a:lnTo>
                  <a:pt x="10060940" y="624840"/>
                </a:lnTo>
                <a:lnTo>
                  <a:pt x="10060940" y="648970"/>
                </a:lnTo>
                <a:lnTo>
                  <a:pt x="10118725" y="648970"/>
                </a:lnTo>
                <a:lnTo>
                  <a:pt x="10176637" y="648970"/>
                </a:lnTo>
                <a:lnTo>
                  <a:pt x="10176637" y="674877"/>
                </a:lnTo>
                <a:lnTo>
                  <a:pt x="10234422" y="674877"/>
                </a:lnTo>
                <a:lnTo>
                  <a:pt x="10292207" y="674877"/>
                </a:lnTo>
                <a:lnTo>
                  <a:pt x="10350119" y="674877"/>
                </a:lnTo>
                <a:lnTo>
                  <a:pt x="10407904" y="674877"/>
                </a:lnTo>
                <a:lnTo>
                  <a:pt x="10465689" y="674877"/>
                </a:lnTo>
                <a:lnTo>
                  <a:pt x="10581386" y="674877"/>
                </a:lnTo>
                <a:lnTo>
                  <a:pt x="10639171" y="674877"/>
                </a:lnTo>
                <a:lnTo>
                  <a:pt x="10754868" y="674877"/>
                </a:lnTo>
                <a:lnTo>
                  <a:pt x="10812653" y="674877"/>
                </a:lnTo>
                <a:lnTo>
                  <a:pt x="10870438" y="674877"/>
                </a:lnTo>
                <a:lnTo>
                  <a:pt x="10986135" y="674877"/>
                </a:lnTo>
                <a:lnTo>
                  <a:pt x="11043920" y="674877"/>
                </a:lnTo>
                <a:lnTo>
                  <a:pt x="11101705" y="674877"/>
                </a:lnTo>
                <a:lnTo>
                  <a:pt x="11159617" y="674877"/>
                </a:lnTo>
                <a:lnTo>
                  <a:pt x="11217402" y="674877"/>
                </a:lnTo>
                <a:lnTo>
                  <a:pt x="11275187" y="674877"/>
                </a:lnTo>
                <a:lnTo>
                  <a:pt x="11332972" y="674877"/>
                </a:lnTo>
                <a:lnTo>
                  <a:pt x="11506454" y="674877"/>
                </a:lnTo>
                <a:lnTo>
                  <a:pt x="11564366" y="674877"/>
                </a:lnTo>
                <a:lnTo>
                  <a:pt x="11622151" y="674877"/>
                </a:lnTo>
                <a:lnTo>
                  <a:pt x="11679936" y="674877"/>
                </a:lnTo>
                <a:lnTo>
                  <a:pt x="11737721" y="674877"/>
                </a:lnTo>
                <a:lnTo>
                  <a:pt x="11795633" y="674877"/>
                </a:lnTo>
                <a:lnTo>
                  <a:pt x="11853418" y="674877"/>
                </a:lnTo>
                <a:lnTo>
                  <a:pt x="11969115" y="674877"/>
                </a:lnTo>
                <a:lnTo>
                  <a:pt x="11969115" y="739775"/>
                </a:lnTo>
                <a:lnTo>
                  <a:pt x="12026900" y="739775"/>
                </a:lnTo>
                <a:lnTo>
                  <a:pt x="12084685" y="739775"/>
                </a:lnTo>
                <a:lnTo>
                  <a:pt x="12200382" y="739775"/>
                </a:lnTo>
                <a:lnTo>
                  <a:pt x="12258166" y="739775"/>
                </a:lnTo>
                <a:lnTo>
                  <a:pt x="12315952" y="739775"/>
                </a:lnTo>
                <a:lnTo>
                  <a:pt x="12373864" y="739775"/>
                </a:lnTo>
                <a:lnTo>
                  <a:pt x="12489434" y="739775"/>
                </a:lnTo>
                <a:lnTo>
                  <a:pt x="12605131" y="739775"/>
                </a:lnTo>
                <a:lnTo>
                  <a:pt x="12662916" y="739775"/>
                </a:lnTo>
                <a:lnTo>
                  <a:pt x="12720701" y="739775"/>
                </a:lnTo>
                <a:lnTo>
                  <a:pt x="12778613" y="739775"/>
                </a:lnTo>
                <a:lnTo>
                  <a:pt x="12836398" y="739775"/>
                </a:lnTo>
                <a:lnTo>
                  <a:pt x="12894183" y="739775"/>
                </a:lnTo>
                <a:lnTo>
                  <a:pt x="12951968" y="739775"/>
                </a:lnTo>
                <a:lnTo>
                  <a:pt x="12951968" y="849757"/>
                </a:lnTo>
                <a:lnTo>
                  <a:pt x="13009879" y="849757"/>
                </a:lnTo>
                <a:lnTo>
                  <a:pt x="13067664" y="849757"/>
                </a:lnTo>
                <a:lnTo>
                  <a:pt x="13125450" y="849757"/>
                </a:lnTo>
                <a:lnTo>
                  <a:pt x="13241146" y="849757"/>
                </a:lnTo>
                <a:lnTo>
                  <a:pt x="13298931" y="849757"/>
                </a:lnTo>
                <a:lnTo>
                  <a:pt x="13356843" y="849757"/>
                </a:lnTo>
                <a:lnTo>
                  <a:pt x="13530198" y="849757"/>
                </a:lnTo>
                <a:lnTo>
                  <a:pt x="13588110" y="849757"/>
                </a:lnTo>
                <a:lnTo>
                  <a:pt x="13645895" y="849757"/>
                </a:lnTo>
                <a:lnTo>
                  <a:pt x="13761592" y="849757"/>
                </a:lnTo>
                <a:lnTo>
                  <a:pt x="13819377" y="849757"/>
                </a:lnTo>
                <a:lnTo>
                  <a:pt x="13877162" y="849757"/>
                </a:lnTo>
                <a:lnTo>
                  <a:pt x="13934948" y="849757"/>
                </a:lnTo>
                <a:lnTo>
                  <a:pt x="13992860" y="849757"/>
                </a:lnTo>
                <a:lnTo>
                  <a:pt x="14108429" y="849757"/>
                </a:lnTo>
                <a:lnTo>
                  <a:pt x="14166341" y="849757"/>
                </a:lnTo>
              </a:path>
            </a:pathLst>
          </a:custGeom>
          <a:ln w="27051">
            <a:solidFill>
              <a:srgbClr val="4DCE6B"/>
            </a:solidFill>
            <a:prstDash val="dot"/>
          </a:ln>
        </p:spPr>
        <p:txBody>
          <a:bodyPr wrap="square" lIns="0" tIns="0" rIns="0" bIns="0" rtlCol="0"/>
          <a:lstStyle/>
          <a:p/>
        </p:txBody>
      </p:sp>
      <p:sp>
        <p:nvSpPr>
          <p:cNvPr id="25" name="bg object 25"/>
          <p:cNvSpPr/>
          <p:nvPr/>
        </p:nvSpPr>
        <p:spPr>
          <a:xfrm>
            <a:off x="1211452" y="722757"/>
            <a:ext cx="14340205" cy="937894"/>
          </a:xfrm>
          <a:custGeom>
            <a:avLst/>
            <a:gdLst/>
            <a:ahLst/>
            <a:cxnLst/>
            <a:rect l="l" t="t" r="r" b="b"/>
            <a:pathLst>
              <a:path w="14340205" h="937894">
                <a:moveTo>
                  <a:pt x="0" y="0"/>
                </a:moveTo>
                <a:lnTo>
                  <a:pt x="57784" y="0"/>
                </a:lnTo>
                <a:lnTo>
                  <a:pt x="115697" y="0"/>
                </a:lnTo>
                <a:lnTo>
                  <a:pt x="115697" y="1524"/>
                </a:lnTo>
                <a:lnTo>
                  <a:pt x="173481" y="1524"/>
                </a:lnTo>
                <a:lnTo>
                  <a:pt x="173481" y="4699"/>
                </a:lnTo>
                <a:lnTo>
                  <a:pt x="231266" y="4699"/>
                </a:lnTo>
                <a:lnTo>
                  <a:pt x="231266" y="6350"/>
                </a:lnTo>
                <a:lnTo>
                  <a:pt x="289178" y="6350"/>
                </a:lnTo>
                <a:lnTo>
                  <a:pt x="289178" y="8000"/>
                </a:lnTo>
                <a:lnTo>
                  <a:pt x="346963" y="8000"/>
                </a:lnTo>
                <a:lnTo>
                  <a:pt x="346963" y="11175"/>
                </a:lnTo>
                <a:lnTo>
                  <a:pt x="404749" y="11175"/>
                </a:lnTo>
                <a:lnTo>
                  <a:pt x="404749" y="17652"/>
                </a:lnTo>
                <a:lnTo>
                  <a:pt x="462534" y="17652"/>
                </a:lnTo>
                <a:lnTo>
                  <a:pt x="462534" y="27432"/>
                </a:lnTo>
                <a:lnTo>
                  <a:pt x="520446" y="27432"/>
                </a:lnTo>
                <a:lnTo>
                  <a:pt x="520446" y="30734"/>
                </a:lnTo>
                <a:lnTo>
                  <a:pt x="578230" y="30734"/>
                </a:lnTo>
                <a:lnTo>
                  <a:pt x="578230" y="35687"/>
                </a:lnTo>
                <a:lnTo>
                  <a:pt x="636016" y="35687"/>
                </a:lnTo>
                <a:lnTo>
                  <a:pt x="636016" y="38862"/>
                </a:lnTo>
                <a:lnTo>
                  <a:pt x="693928" y="38862"/>
                </a:lnTo>
                <a:lnTo>
                  <a:pt x="693928" y="45466"/>
                </a:lnTo>
                <a:lnTo>
                  <a:pt x="751713" y="45466"/>
                </a:lnTo>
                <a:lnTo>
                  <a:pt x="751713" y="47117"/>
                </a:lnTo>
                <a:lnTo>
                  <a:pt x="809497" y="47117"/>
                </a:lnTo>
                <a:lnTo>
                  <a:pt x="809497" y="55499"/>
                </a:lnTo>
                <a:lnTo>
                  <a:pt x="867283" y="55499"/>
                </a:lnTo>
                <a:lnTo>
                  <a:pt x="925195" y="55499"/>
                </a:lnTo>
                <a:lnTo>
                  <a:pt x="925195" y="60578"/>
                </a:lnTo>
                <a:lnTo>
                  <a:pt x="982979" y="60578"/>
                </a:lnTo>
                <a:lnTo>
                  <a:pt x="1040765" y="60578"/>
                </a:lnTo>
                <a:lnTo>
                  <a:pt x="1040765" y="62357"/>
                </a:lnTo>
                <a:lnTo>
                  <a:pt x="1098677" y="62357"/>
                </a:lnTo>
                <a:lnTo>
                  <a:pt x="1098677" y="65786"/>
                </a:lnTo>
                <a:lnTo>
                  <a:pt x="1156461" y="65786"/>
                </a:lnTo>
                <a:lnTo>
                  <a:pt x="1214247" y="65786"/>
                </a:lnTo>
                <a:lnTo>
                  <a:pt x="1214247" y="69342"/>
                </a:lnTo>
                <a:lnTo>
                  <a:pt x="1272032" y="69342"/>
                </a:lnTo>
                <a:lnTo>
                  <a:pt x="1272032" y="74802"/>
                </a:lnTo>
                <a:lnTo>
                  <a:pt x="1329944" y="74802"/>
                </a:lnTo>
                <a:lnTo>
                  <a:pt x="1329944" y="78359"/>
                </a:lnTo>
                <a:lnTo>
                  <a:pt x="1387729" y="78359"/>
                </a:lnTo>
                <a:lnTo>
                  <a:pt x="1387729" y="82042"/>
                </a:lnTo>
                <a:lnTo>
                  <a:pt x="1445514" y="82042"/>
                </a:lnTo>
                <a:lnTo>
                  <a:pt x="1445514" y="89408"/>
                </a:lnTo>
                <a:lnTo>
                  <a:pt x="1503426" y="89408"/>
                </a:lnTo>
                <a:lnTo>
                  <a:pt x="1503426" y="91186"/>
                </a:lnTo>
                <a:lnTo>
                  <a:pt x="1561211" y="91186"/>
                </a:lnTo>
                <a:lnTo>
                  <a:pt x="1561211" y="93091"/>
                </a:lnTo>
                <a:lnTo>
                  <a:pt x="1618996" y="93091"/>
                </a:lnTo>
                <a:lnTo>
                  <a:pt x="1618996" y="94996"/>
                </a:lnTo>
                <a:lnTo>
                  <a:pt x="1676780" y="94996"/>
                </a:lnTo>
                <a:lnTo>
                  <a:pt x="1676780" y="106425"/>
                </a:lnTo>
                <a:lnTo>
                  <a:pt x="1734692" y="106425"/>
                </a:lnTo>
                <a:lnTo>
                  <a:pt x="1734692" y="112141"/>
                </a:lnTo>
                <a:lnTo>
                  <a:pt x="1792477" y="112141"/>
                </a:lnTo>
                <a:lnTo>
                  <a:pt x="1850263" y="112141"/>
                </a:lnTo>
                <a:lnTo>
                  <a:pt x="1850263" y="120015"/>
                </a:lnTo>
                <a:lnTo>
                  <a:pt x="1908175" y="120015"/>
                </a:lnTo>
                <a:lnTo>
                  <a:pt x="1908175" y="122047"/>
                </a:lnTo>
                <a:lnTo>
                  <a:pt x="1965960" y="122047"/>
                </a:lnTo>
                <a:lnTo>
                  <a:pt x="1965960" y="128016"/>
                </a:lnTo>
                <a:lnTo>
                  <a:pt x="2023745" y="128016"/>
                </a:lnTo>
                <a:lnTo>
                  <a:pt x="2023745" y="132079"/>
                </a:lnTo>
                <a:lnTo>
                  <a:pt x="2081530" y="132079"/>
                </a:lnTo>
                <a:lnTo>
                  <a:pt x="2139442" y="132079"/>
                </a:lnTo>
                <a:lnTo>
                  <a:pt x="2139442" y="136144"/>
                </a:lnTo>
                <a:lnTo>
                  <a:pt x="2197227" y="136144"/>
                </a:lnTo>
                <a:lnTo>
                  <a:pt x="2197227" y="140335"/>
                </a:lnTo>
                <a:lnTo>
                  <a:pt x="2255012" y="140335"/>
                </a:lnTo>
                <a:lnTo>
                  <a:pt x="2255012" y="144399"/>
                </a:lnTo>
                <a:lnTo>
                  <a:pt x="2312924" y="144399"/>
                </a:lnTo>
                <a:lnTo>
                  <a:pt x="2312924" y="146558"/>
                </a:lnTo>
                <a:lnTo>
                  <a:pt x="2370709" y="146558"/>
                </a:lnTo>
                <a:lnTo>
                  <a:pt x="2370709" y="150749"/>
                </a:lnTo>
                <a:lnTo>
                  <a:pt x="2428494" y="150749"/>
                </a:lnTo>
                <a:lnTo>
                  <a:pt x="2428494" y="152908"/>
                </a:lnTo>
                <a:lnTo>
                  <a:pt x="2486406" y="152908"/>
                </a:lnTo>
                <a:lnTo>
                  <a:pt x="2486406" y="152908"/>
                </a:lnTo>
                <a:lnTo>
                  <a:pt x="2544191" y="152908"/>
                </a:lnTo>
                <a:lnTo>
                  <a:pt x="2601976" y="152908"/>
                </a:lnTo>
                <a:lnTo>
                  <a:pt x="2659761" y="152908"/>
                </a:lnTo>
                <a:lnTo>
                  <a:pt x="2659761" y="157352"/>
                </a:lnTo>
                <a:lnTo>
                  <a:pt x="2717673" y="157352"/>
                </a:lnTo>
                <a:lnTo>
                  <a:pt x="2717673" y="159639"/>
                </a:lnTo>
                <a:lnTo>
                  <a:pt x="2775458" y="159639"/>
                </a:lnTo>
                <a:lnTo>
                  <a:pt x="2775458" y="164084"/>
                </a:lnTo>
                <a:lnTo>
                  <a:pt x="2833243" y="164084"/>
                </a:lnTo>
                <a:lnTo>
                  <a:pt x="2833243" y="166370"/>
                </a:lnTo>
                <a:lnTo>
                  <a:pt x="2891155" y="166370"/>
                </a:lnTo>
                <a:lnTo>
                  <a:pt x="2891155" y="173227"/>
                </a:lnTo>
                <a:lnTo>
                  <a:pt x="2948940" y="173227"/>
                </a:lnTo>
                <a:lnTo>
                  <a:pt x="2948940" y="177926"/>
                </a:lnTo>
                <a:lnTo>
                  <a:pt x="3006725" y="177926"/>
                </a:lnTo>
                <a:lnTo>
                  <a:pt x="3006725" y="185039"/>
                </a:lnTo>
                <a:lnTo>
                  <a:pt x="3064510" y="185039"/>
                </a:lnTo>
                <a:lnTo>
                  <a:pt x="3064510" y="189738"/>
                </a:lnTo>
                <a:lnTo>
                  <a:pt x="3122422" y="189738"/>
                </a:lnTo>
                <a:lnTo>
                  <a:pt x="3180207" y="189738"/>
                </a:lnTo>
                <a:lnTo>
                  <a:pt x="3180207" y="194564"/>
                </a:lnTo>
                <a:lnTo>
                  <a:pt x="3237992" y="194564"/>
                </a:lnTo>
                <a:lnTo>
                  <a:pt x="3237992" y="196976"/>
                </a:lnTo>
                <a:lnTo>
                  <a:pt x="3295904" y="196976"/>
                </a:lnTo>
                <a:lnTo>
                  <a:pt x="3295904" y="204343"/>
                </a:lnTo>
                <a:lnTo>
                  <a:pt x="3353689" y="204343"/>
                </a:lnTo>
                <a:lnTo>
                  <a:pt x="3353689" y="206883"/>
                </a:lnTo>
                <a:lnTo>
                  <a:pt x="3411474" y="206883"/>
                </a:lnTo>
                <a:lnTo>
                  <a:pt x="3411474" y="211836"/>
                </a:lnTo>
                <a:lnTo>
                  <a:pt x="3469259" y="211836"/>
                </a:lnTo>
                <a:lnTo>
                  <a:pt x="3469259" y="219456"/>
                </a:lnTo>
                <a:lnTo>
                  <a:pt x="3527171" y="219456"/>
                </a:lnTo>
                <a:lnTo>
                  <a:pt x="3527171" y="240029"/>
                </a:lnTo>
                <a:lnTo>
                  <a:pt x="3584956" y="240029"/>
                </a:lnTo>
                <a:lnTo>
                  <a:pt x="3584956" y="245110"/>
                </a:lnTo>
                <a:lnTo>
                  <a:pt x="3642741" y="245110"/>
                </a:lnTo>
                <a:lnTo>
                  <a:pt x="3642741" y="258191"/>
                </a:lnTo>
                <a:lnTo>
                  <a:pt x="3700653" y="258191"/>
                </a:lnTo>
                <a:lnTo>
                  <a:pt x="3700653" y="263398"/>
                </a:lnTo>
                <a:lnTo>
                  <a:pt x="3758438" y="263398"/>
                </a:lnTo>
                <a:lnTo>
                  <a:pt x="3758438" y="268732"/>
                </a:lnTo>
                <a:lnTo>
                  <a:pt x="3816223" y="268732"/>
                </a:lnTo>
                <a:lnTo>
                  <a:pt x="3816223" y="271399"/>
                </a:lnTo>
                <a:lnTo>
                  <a:pt x="3874008" y="271399"/>
                </a:lnTo>
                <a:lnTo>
                  <a:pt x="3874008" y="282194"/>
                </a:lnTo>
                <a:lnTo>
                  <a:pt x="3931920" y="282194"/>
                </a:lnTo>
                <a:lnTo>
                  <a:pt x="3931920" y="287654"/>
                </a:lnTo>
                <a:lnTo>
                  <a:pt x="3989705" y="287654"/>
                </a:lnTo>
                <a:lnTo>
                  <a:pt x="3989705" y="293243"/>
                </a:lnTo>
                <a:lnTo>
                  <a:pt x="4047490" y="293243"/>
                </a:lnTo>
                <a:lnTo>
                  <a:pt x="4047490" y="296037"/>
                </a:lnTo>
                <a:lnTo>
                  <a:pt x="4105402" y="296037"/>
                </a:lnTo>
                <a:lnTo>
                  <a:pt x="4105402" y="298831"/>
                </a:lnTo>
                <a:lnTo>
                  <a:pt x="4163187" y="298831"/>
                </a:lnTo>
                <a:lnTo>
                  <a:pt x="4220972" y="298831"/>
                </a:lnTo>
                <a:lnTo>
                  <a:pt x="4220972" y="301625"/>
                </a:lnTo>
                <a:lnTo>
                  <a:pt x="4278757" y="301625"/>
                </a:lnTo>
                <a:lnTo>
                  <a:pt x="4278757" y="307467"/>
                </a:lnTo>
                <a:lnTo>
                  <a:pt x="4336669" y="307467"/>
                </a:lnTo>
                <a:lnTo>
                  <a:pt x="4336669" y="313309"/>
                </a:lnTo>
                <a:lnTo>
                  <a:pt x="4394454" y="313309"/>
                </a:lnTo>
                <a:lnTo>
                  <a:pt x="4394454" y="319277"/>
                </a:lnTo>
                <a:lnTo>
                  <a:pt x="4452239" y="319277"/>
                </a:lnTo>
                <a:lnTo>
                  <a:pt x="4452239" y="325247"/>
                </a:lnTo>
                <a:lnTo>
                  <a:pt x="4510151" y="325247"/>
                </a:lnTo>
                <a:lnTo>
                  <a:pt x="4567936" y="325247"/>
                </a:lnTo>
                <a:lnTo>
                  <a:pt x="4567936" y="334518"/>
                </a:lnTo>
                <a:lnTo>
                  <a:pt x="4625721" y="334518"/>
                </a:lnTo>
                <a:lnTo>
                  <a:pt x="4625721" y="340741"/>
                </a:lnTo>
                <a:lnTo>
                  <a:pt x="4683506" y="340741"/>
                </a:lnTo>
                <a:lnTo>
                  <a:pt x="4683506" y="343916"/>
                </a:lnTo>
                <a:lnTo>
                  <a:pt x="4741418" y="343916"/>
                </a:lnTo>
                <a:lnTo>
                  <a:pt x="4741418" y="353568"/>
                </a:lnTo>
                <a:lnTo>
                  <a:pt x="4799203" y="353568"/>
                </a:lnTo>
                <a:lnTo>
                  <a:pt x="4799203" y="363347"/>
                </a:lnTo>
                <a:lnTo>
                  <a:pt x="4856988" y="363347"/>
                </a:lnTo>
                <a:lnTo>
                  <a:pt x="4914900" y="363347"/>
                </a:lnTo>
                <a:lnTo>
                  <a:pt x="4914900" y="366649"/>
                </a:lnTo>
                <a:lnTo>
                  <a:pt x="4972685" y="366649"/>
                </a:lnTo>
                <a:lnTo>
                  <a:pt x="4972685" y="376809"/>
                </a:lnTo>
                <a:lnTo>
                  <a:pt x="5030470" y="376809"/>
                </a:lnTo>
                <a:lnTo>
                  <a:pt x="5030470" y="383667"/>
                </a:lnTo>
                <a:lnTo>
                  <a:pt x="5088255" y="383667"/>
                </a:lnTo>
                <a:lnTo>
                  <a:pt x="5088255" y="387096"/>
                </a:lnTo>
                <a:lnTo>
                  <a:pt x="5146167" y="387096"/>
                </a:lnTo>
                <a:lnTo>
                  <a:pt x="5203952" y="387096"/>
                </a:lnTo>
                <a:lnTo>
                  <a:pt x="5203952" y="390778"/>
                </a:lnTo>
                <a:lnTo>
                  <a:pt x="5261737" y="390778"/>
                </a:lnTo>
                <a:lnTo>
                  <a:pt x="5261737" y="397891"/>
                </a:lnTo>
                <a:lnTo>
                  <a:pt x="5319649" y="397891"/>
                </a:lnTo>
                <a:lnTo>
                  <a:pt x="5377433" y="397891"/>
                </a:lnTo>
                <a:lnTo>
                  <a:pt x="5435219" y="397891"/>
                </a:lnTo>
                <a:lnTo>
                  <a:pt x="5435219" y="409321"/>
                </a:lnTo>
                <a:lnTo>
                  <a:pt x="5493004" y="409321"/>
                </a:lnTo>
                <a:lnTo>
                  <a:pt x="5550916" y="409321"/>
                </a:lnTo>
                <a:lnTo>
                  <a:pt x="5608701" y="409321"/>
                </a:lnTo>
                <a:lnTo>
                  <a:pt x="5666486" y="409321"/>
                </a:lnTo>
                <a:lnTo>
                  <a:pt x="5724398" y="409321"/>
                </a:lnTo>
                <a:lnTo>
                  <a:pt x="5724398" y="417449"/>
                </a:lnTo>
                <a:lnTo>
                  <a:pt x="5782183" y="417449"/>
                </a:lnTo>
                <a:lnTo>
                  <a:pt x="5839968" y="417449"/>
                </a:lnTo>
                <a:lnTo>
                  <a:pt x="5839968" y="421640"/>
                </a:lnTo>
                <a:lnTo>
                  <a:pt x="5897753" y="421640"/>
                </a:lnTo>
                <a:lnTo>
                  <a:pt x="5897753" y="430149"/>
                </a:lnTo>
                <a:lnTo>
                  <a:pt x="5955665" y="430149"/>
                </a:lnTo>
                <a:lnTo>
                  <a:pt x="5955665" y="434467"/>
                </a:lnTo>
                <a:lnTo>
                  <a:pt x="6013450" y="434467"/>
                </a:lnTo>
                <a:lnTo>
                  <a:pt x="6013450" y="447548"/>
                </a:lnTo>
                <a:lnTo>
                  <a:pt x="6071235" y="447548"/>
                </a:lnTo>
                <a:lnTo>
                  <a:pt x="6071235" y="451993"/>
                </a:lnTo>
                <a:lnTo>
                  <a:pt x="6129147" y="451993"/>
                </a:lnTo>
                <a:lnTo>
                  <a:pt x="6129147" y="461010"/>
                </a:lnTo>
                <a:lnTo>
                  <a:pt x="6186932" y="461010"/>
                </a:lnTo>
                <a:lnTo>
                  <a:pt x="6186932" y="470281"/>
                </a:lnTo>
                <a:lnTo>
                  <a:pt x="6244717" y="470281"/>
                </a:lnTo>
                <a:lnTo>
                  <a:pt x="6302502" y="470281"/>
                </a:lnTo>
                <a:lnTo>
                  <a:pt x="6302502" y="474979"/>
                </a:lnTo>
                <a:lnTo>
                  <a:pt x="6360414" y="474979"/>
                </a:lnTo>
                <a:lnTo>
                  <a:pt x="6360414" y="484504"/>
                </a:lnTo>
                <a:lnTo>
                  <a:pt x="6418199" y="484504"/>
                </a:lnTo>
                <a:lnTo>
                  <a:pt x="6475983" y="484504"/>
                </a:lnTo>
                <a:lnTo>
                  <a:pt x="6533896" y="484504"/>
                </a:lnTo>
                <a:lnTo>
                  <a:pt x="6591681" y="484504"/>
                </a:lnTo>
                <a:lnTo>
                  <a:pt x="6649466" y="484504"/>
                </a:lnTo>
                <a:lnTo>
                  <a:pt x="6649466" y="489458"/>
                </a:lnTo>
                <a:lnTo>
                  <a:pt x="6707251" y="489458"/>
                </a:lnTo>
                <a:lnTo>
                  <a:pt x="6765163" y="489458"/>
                </a:lnTo>
                <a:lnTo>
                  <a:pt x="6822948" y="489458"/>
                </a:lnTo>
                <a:lnTo>
                  <a:pt x="6822948" y="499745"/>
                </a:lnTo>
                <a:lnTo>
                  <a:pt x="6880733" y="499745"/>
                </a:lnTo>
                <a:lnTo>
                  <a:pt x="6880733" y="510159"/>
                </a:lnTo>
                <a:lnTo>
                  <a:pt x="6938645" y="510159"/>
                </a:lnTo>
                <a:lnTo>
                  <a:pt x="6938645" y="515493"/>
                </a:lnTo>
                <a:lnTo>
                  <a:pt x="6996430" y="515493"/>
                </a:lnTo>
                <a:lnTo>
                  <a:pt x="6996430" y="531495"/>
                </a:lnTo>
                <a:lnTo>
                  <a:pt x="7054215" y="531495"/>
                </a:lnTo>
                <a:lnTo>
                  <a:pt x="7054215" y="547877"/>
                </a:lnTo>
                <a:lnTo>
                  <a:pt x="7112000" y="547877"/>
                </a:lnTo>
                <a:lnTo>
                  <a:pt x="7112000" y="558926"/>
                </a:lnTo>
                <a:lnTo>
                  <a:pt x="7169912" y="558926"/>
                </a:lnTo>
                <a:lnTo>
                  <a:pt x="7169912" y="570229"/>
                </a:lnTo>
                <a:lnTo>
                  <a:pt x="7227697" y="570229"/>
                </a:lnTo>
                <a:lnTo>
                  <a:pt x="7227697" y="575945"/>
                </a:lnTo>
                <a:lnTo>
                  <a:pt x="7285482" y="575945"/>
                </a:lnTo>
                <a:lnTo>
                  <a:pt x="7285482" y="581660"/>
                </a:lnTo>
                <a:lnTo>
                  <a:pt x="7343394" y="581660"/>
                </a:lnTo>
                <a:lnTo>
                  <a:pt x="7343394" y="593344"/>
                </a:lnTo>
                <a:lnTo>
                  <a:pt x="7401179" y="593344"/>
                </a:lnTo>
                <a:lnTo>
                  <a:pt x="7458964" y="593344"/>
                </a:lnTo>
                <a:lnTo>
                  <a:pt x="7458964" y="599440"/>
                </a:lnTo>
                <a:lnTo>
                  <a:pt x="7516749" y="599440"/>
                </a:lnTo>
                <a:lnTo>
                  <a:pt x="7574661" y="599440"/>
                </a:lnTo>
                <a:lnTo>
                  <a:pt x="7632446" y="599440"/>
                </a:lnTo>
                <a:lnTo>
                  <a:pt x="7690231" y="599440"/>
                </a:lnTo>
                <a:lnTo>
                  <a:pt x="7690231" y="605917"/>
                </a:lnTo>
                <a:lnTo>
                  <a:pt x="7748143" y="605917"/>
                </a:lnTo>
                <a:lnTo>
                  <a:pt x="7748143" y="618998"/>
                </a:lnTo>
                <a:lnTo>
                  <a:pt x="7805928" y="618998"/>
                </a:lnTo>
                <a:lnTo>
                  <a:pt x="7863713" y="618998"/>
                </a:lnTo>
                <a:lnTo>
                  <a:pt x="7863713" y="625856"/>
                </a:lnTo>
                <a:lnTo>
                  <a:pt x="7921625" y="625856"/>
                </a:lnTo>
                <a:lnTo>
                  <a:pt x="7979410" y="625856"/>
                </a:lnTo>
                <a:lnTo>
                  <a:pt x="8037195" y="625856"/>
                </a:lnTo>
                <a:lnTo>
                  <a:pt x="8037195" y="633095"/>
                </a:lnTo>
                <a:lnTo>
                  <a:pt x="8094980" y="633095"/>
                </a:lnTo>
                <a:lnTo>
                  <a:pt x="8152892" y="633095"/>
                </a:lnTo>
                <a:lnTo>
                  <a:pt x="8210677" y="633095"/>
                </a:lnTo>
                <a:lnTo>
                  <a:pt x="8268462" y="633095"/>
                </a:lnTo>
                <a:lnTo>
                  <a:pt x="8326374" y="633095"/>
                </a:lnTo>
                <a:lnTo>
                  <a:pt x="8384158" y="633095"/>
                </a:lnTo>
                <a:lnTo>
                  <a:pt x="8441944" y="633095"/>
                </a:lnTo>
                <a:lnTo>
                  <a:pt x="8499729" y="633095"/>
                </a:lnTo>
                <a:lnTo>
                  <a:pt x="8499729" y="641731"/>
                </a:lnTo>
                <a:lnTo>
                  <a:pt x="8557641" y="641731"/>
                </a:lnTo>
                <a:lnTo>
                  <a:pt x="8615426" y="641731"/>
                </a:lnTo>
                <a:lnTo>
                  <a:pt x="8673211" y="641731"/>
                </a:lnTo>
                <a:lnTo>
                  <a:pt x="8673211" y="651001"/>
                </a:lnTo>
                <a:lnTo>
                  <a:pt x="8731123" y="651001"/>
                </a:lnTo>
                <a:lnTo>
                  <a:pt x="8788908" y="651001"/>
                </a:lnTo>
                <a:lnTo>
                  <a:pt x="8788908" y="670178"/>
                </a:lnTo>
                <a:lnTo>
                  <a:pt x="8846693" y="670178"/>
                </a:lnTo>
                <a:lnTo>
                  <a:pt x="8962390" y="670178"/>
                </a:lnTo>
                <a:lnTo>
                  <a:pt x="8962390" y="680085"/>
                </a:lnTo>
                <a:lnTo>
                  <a:pt x="9020175" y="680085"/>
                </a:lnTo>
                <a:lnTo>
                  <a:pt x="9077960" y="680085"/>
                </a:lnTo>
                <a:lnTo>
                  <a:pt x="9135872" y="680085"/>
                </a:lnTo>
                <a:lnTo>
                  <a:pt x="9193657" y="680085"/>
                </a:lnTo>
                <a:lnTo>
                  <a:pt x="9193657" y="701675"/>
                </a:lnTo>
                <a:lnTo>
                  <a:pt x="9251442" y="701675"/>
                </a:lnTo>
                <a:lnTo>
                  <a:pt x="9309227" y="701675"/>
                </a:lnTo>
                <a:lnTo>
                  <a:pt x="9309227" y="713104"/>
                </a:lnTo>
                <a:lnTo>
                  <a:pt x="9367139" y="713104"/>
                </a:lnTo>
                <a:lnTo>
                  <a:pt x="9424924" y="713104"/>
                </a:lnTo>
                <a:lnTo>
                  <a:pt x="9424924" y="725043"/>
                </a:lnTo>
                <a:lnTo>
                  <a:pt x="9482709" y="725043"/>
                </a:lnTo>
                <a:lnTo>
                  <a:pt x="9540621" y="725043"/>
                </a:lnTo>
                <a:lnTo>
                  <a:pt x="9540621" y="737235"/>
                </a:lnTo>
                <a:lnTo>
                  <a:pt x="9598406" y="737235"/>
                </a:lnTo>
                <a:lnTo>
                  <a:pt x="9656191" y="737235"/>
                </a:lnTo>
                <a:lnTo>
                  <a:pt x="9713976" y="737235"/>
                </a:lnTo>
                <a:lnTo>
                  <a:pt x="9771888" y="737235"/>
                </a:lnTo>
                <a:lnTo>
                  <a:pt x="9829673" y="737235"/>
                </a:lnTo>
                <a:lnTo>
                  <a:pt x="9887458" y="737235"/>
                </a:lnTo>
                <a:lnTo>
                  <a:pt x="9945370" y="737235"/>
                </a:lnTo>
                <a:lnTo>
                  <a:pt x="10003155" y="737235"/>
                </a:lnTo>
                <a:lnTo>
                  <a:pt x="10060940" y="737235"/>
                </a:lnTo>
                <a:lnTo>
                  <a:pt x="10118725" y="737235"/>
                </a:lnTo>
                <a:lnTo>
                  <a:pt x="10118725" y="752094"/>
                </a:lnTo>
                <a:lnTo>
                  <a:pt x="10176637" y="752094"/>
                </a:lnTo>
                <a:lnTo>
                  <a:pt x="10234422" y="752094"/>
                </a:lnTo>
                <a:lnTo>
                  <a:pt x="10234422" y="767969"/>
                </a:lnTo>
                <a:lnTo>
                  <a:pt x="10292207" y="767969"/>
                </a:lnTo>
                <a:lnTo>
                  <a:pt x="10350119" y="767969"/>
                </a:lnTo>
                <a:lnTo>
                  <a:pt x="10407904" y="767969"/>
                </a:lnTo>
                <a:lnTo>
                  <a:pt x="10407904" y="784987"/>
                </a:lnTo>
                <a:lnTo>
                  <a:pt x="10465689" y="784987"/>
                </a:lnTo>
                <a:lnTo>
                  <a:pt x="10523474" y="784987"/>
                </a:lnTo>
                <a:lnTo>
                  <a:pt x="10581386" y="784987"/>
                </a:lnTo>
                <a:lnTo>
                  <a:pt x="10639171" y="784987"/>
                </a:lnTo>
                <a:lnTo>
                  <a:pt x="10696956" y="784987"/>
                </a:lnTo>
                <a:lnTo>
                  <a:pt x="10754868" y="784987"/>
                </a:lnTo>
                <a:lnTo>
                  <a:pt x="10812653" y="784987"/>
                </a:lnTo>
                <a:lnTo>
                  <a:pt x="10870438" y="784987"/>
                </a:lnTo>
                <a:lnTo>
                  <a:pt x="10928223" y="784987"/>
                </a:lnTo>
                <a:lnTo>
                  <a:pt x="10986135" y="784987"/>
                </a:lnTo>
                <a:lnTo>
                  <a:pt x="11043920" y="784987"/>
                </a:lnTo>
                <a:lnTo>
                  <a:pt x="11101705" y="784987"/>
                </a:lnTo>
                <a:lnTo>
                  <a:pt x="11159617" y="784987"/>
                </a:lnTo>
                <a:lnTo>
                  <a:pt x="11217402" y="784987"/>
                </a:lnTo>
                <a:lnTo>
                  <a:pt x="11275187" y="784987"/>
                </a:lnTo>
                <a:lnTo>
                  <a:pt x="11332972" y="784987"/>
                </a:lnTo>
                <a:lnTo>
                  <a:pt x="11390884" y="784987"/>
                </a:lnTo>
                <a:lnTo>
                  <a:pt x="11448669" y="784987"/>
                </a:lnTo>
                <a:lnTo>
                  <a:pt x="11448669" y="814577"/>
                </a:lnTo>
                <a:lnTo>
                  <a:pt x="11506454" y="814577"/>
                </a:lnTo>
                <a:lnTo>
                  <a:pt x="11564366" y="814577"/>
                </a:lnTo>
                <a:lnTo>
                  <a:pt x="11622151" y="814577"/>
                </a:lnTo>
                <a:lnTo>
                  <a:pt x="11679936" y="814577"/>
                </a:lnTo>
                <a:lnTo>
                  <a:pt x="11737721" y="814577"/>
                </a:lnTo>
                <a:lnTo>
                  <a:pt x="11795633" y="814577"/>
                </a:lnTo>
                <a:lnTo>
                  <a:pt x="11853418" y="814577"/>
                </a:lnTo>
                <a:lnTo>
                  <a:pt x="11911203" y="814577"/>
                </a:lnTo>
                <a:lnTo>
                  <a:pt x="11969115" y="814577"/>
                </a:lnTo>
                <a:lnTo>
                  <a:pt x="11969115" y="862711"/>
                </a:lnTo>
                <a:lnTo>
                  <a:pt x="12142470" y="862711"/>
                </a:lnTo>
                <a:lnTo>
                  <a:pt x="12200382" y="862711"/>
                </a:lnTo>
                <a:lnTo>
                  <a:pt x="12258166" y="862711"/>
                </a:lnTo>
                <a:lnTo>
                  <a:pt x="12431649" y="862711"/>
                </a:lnTo>
                <a:lnTo>
                  <a:pt x="12489434" y="862711"/>
                </a:lnTo>
                <a:lnTo>
                  <a:pt x="12547218" y="862711"/>
                </a:lnTo>
                <a:lnTo>
                  <a:pt x="12662916" y="862711"/>
                </a:lnTo>
                <a:lnTo>
                  <a:pt x="12662916" y="937895"/>
                </a:lnTo>
                <a:lnTo>
                  <a:pt x="12720701" y="937895"/>
                </a:lnTo>
                <a:lnTo>
                  <a:pt x="12778613" y="937895"/>
                </a:lnTo>
                <a:lnTo>
                  <a:pt x="12836398" y="937895"/>
                </a:lnTo>
                <a:lnTo>
                  <a:pt x="12894183" y="937895"/>
                </a:lnTo>
                <a:lnTo>
                  <a:pt x="12951968" y="937895"/>
                </a:lnTo>
                <a:lnTo>
                  <a:pt x="13009879" y="937895"/>
                </a:lnTo>
                <a:lnTo>
                  <a:pt x="13067664" y="937895"/>
                </a:lnTo>
                <a:lnTo>
                  <a:pt x="13183362" y="937895"/>
                </a:lnTo>
                <a:lnTo>
                  <a:pt x="13298931" y="937895"/>
                </a:lnTo>
                <a:lnTo>
                  <a:pt x="13356843" y="937895"/>
                </a:lnTo>
                <a:lnTo>
                  <a:pt x="13472414" y="937895"/>
                </a:lnTo>
                <a:lnTo>
                  <a:pt x="13530198" y="937895"/>
                </a:lnTo>
                <a:lnTo>
                  <a:pt x="13645895" y="937895"/>
                </a:lnTo>
                <a:lnTo>
                  <a:pt x="14281912" y="937895"/>
                </a:lnTo>
                <a:lnTo>
                  <a:pt x="14339696" y="937895"/>
                </a:lnTo>
              </a:path>
            </a:pathLst>
          </a:custGeom>
          <a:ln w="27051">
            <a:solidFill>
              <a:srgbClr val="BCA7E8"/>
            </a:solidFill>
            <a:prstDash val="sysDash"/>
          </a:ln>
        </p:spPr>
        <p:txBody>
          <a:bodyPr wrap="square" lIns="0" tIns="0" rIns="0" bIns="0" rtlCol="0"/>
          <a:lstStyle/>
          <a:p/>
        </p:txBody>
      </p:sp>
      <p:sp>
        <p:nvSpPr>
          <p:cNvPr id="26" name="bg object 26"/>
          <p:cNvSpPr/>
          <p:nvPr/>
        </p:nvSpPr>
        <p:spPr>
          <a:xfrm>
            <a:off x="2367915" y="722629"/>
            <a:ext cx="13183235" cy="262890"/>
          </a:xfrm>
          <a:custGeom>
            <a:avLst/>
            <a:gdLst/>
            <a:ahLst/>
            <a:cxnLst/>
            <a:rect l="l" t="t" r="r" b="b"/>
            <a:pathLst>
              <a:path w="13183235" h="262890">
                <a:moveTo>
                  <a:pt x="5550789" y="22860"/>
                </a:moveTo>
                <a:lnTo>
                  <a:pt x="5377434" y="22860"/>
                </a:lnTo>
                <a:lnTo>
                  <a:pt x="5377434" y="20320"/>
                </a:lnTo>
                <a:lnTo>
                  <a:pt x="5261737" y="20320"/>
                </a:lnTo>
                <a:lnTo>
                  <a:pt x="5261737" y="19050"/>
                </a:lnTo>
                <a:lnTo>
                  <a:pt x="4567936" y="19050"/>
                </a:lnTo>
                <a:lnTo>
                  <a:pt x="4567936" y="17780"/>
                </a:lnTo>
                <a:lnTo>
                  <a:pt x="4567936" y="15240"/>
                </a:lnTo>
                <a:lnTo>
                  <a:pt x="4278757" y="15240"/>
                </a:lnTo>
                <a:lnTo>
                  <a:pt x="4278757" y="13970"/>
                </a:lnTo>
                <a:lnTo>
                  <a:pt x="4105275" y="13970"/>
                </a:lnTo>
                <a:lnTo>
                  <a:pt x="4105275" y="11430"/>
                </a:lnTo>
                <a:lnTo>
                  <a:pt x="3411474" y="11430"/>
                </a:lnTo>
                <a:lnTo>
                  <a:pt x="3411474" y="10160"/>
                </a:lnTo>
                <a:lnTo>
                  <a:pt x="3353689" y="10160"/>
                </a:lnTo>
                <a:lnTo>
                  <a:pt x="3353689" y="8890"/>
                </a:lnTo>
                <a:lnTo>
                  <a:pt x="3180207" y="8890"/>
                </a:lnTo>
                <a:lnTo>
                  <a:pt x="3180207" y="7620"/>
                </a:lnTo>
                <a:lnTo>
                  <a:pt x="2312797" y="7620"/>
                </a:lnTo>
                <a:lnTo>
                  <a:pt x="2312797" y="6350"/>
                </a:lnTo>
                <a:lnTo>
                  <a:pt x="2255012" y="6350"/>
                </a:lnTo>
                <a:lnTo>
                  <a:pt x="2255012" y="5080"/>
                </a:lnTo>
                <a:lnTo>
                  <a:pt x="1908048" y="5080"/>
                </a:lnTo>
                <a:lnTo>
                  <a:pt x="1908048" y="3810"/>
                </a:lnTo>
                <a:lnTo>
                  <a:pt x="1272032" y="3810"/>
                </a:lnTo>
                <a:lnTo>
                  <a:pt x="1272032" y="2540"/>
                </a:lnTo>
                <a:lnTo>
                  <a:pt x="1156462" y="2540"/>
                </a:lnTo>
                <a:lnTo>
                  <a:pt x="1156462" y="1270"/>
                </a:lnTo>
                <a:lnTo>
                  <a:pt x="1098550" y="1270"/>
                </a:lnTo>
                <a:lnTo>
                  <a:pt x="1098550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0" y="3810"/>
                </a:lnTo>
                <a:lnTo>
                  <a:pt x="0" y="5080"/>
                </a:lnTo>
                <a:lnTo>
                  <a:pt x="115570" y="5080"/>
                </a:lnTo>
                <a:lnTo>
                  <a:pt x="115570" y="6350"/>
                </a:lnTo>
                <a:lnTo>
                  <a:pt x="115570" y="7620"/>
                </a:lnTo>
                <a:lnTo>
                  <a:pt x="1040765" y="7620"/>
                </a:lnTo>
                <a:lnTo>
                  <a:pt x="1040765" y="8890"/>
                </a:lnTo>
                <a:lnTo>
                  <a:pt x="1040765" y="10160"/>
                </a:lnTo>
                <a:lnTo>
                  <a:pt x="1098550" y="10160"/>
                </a:lnTo>
                <a:lnTo>
                  <a:pt x="1098550" y="11430"/>
                </a:lnTo>
                <a:lnTo>
                  <a:pt x="1098550" y="13970"/>
                </a:lnTo>
                <a:lnTo>
                  <a:pt x="1098550" y="15240"/>
                </a:lnTo>
                <a:lnTo>
                  <a:pt x="1156462" y="15240"/>
                </a:lnTo>
                <a:lnTo>
                  <a:pt x="1156462" y="17780"/>
                </a:lnTo>
                <a:lnTo>
                  <a:pt x="1214247" y="17780"/>
                </a:lnTo>
                <a:lnTo>
                  <a:pt x="1214247" y="19050"/>
                </a:lnTo>
                <a:lnTo>
                  <a:pt x="1214247" y="20320"/>
                </a:lnTo>
                <a:lnTo>
                  <a:pt x="1272032" y="20320"/>
                </a:lnTo>
                <a:lnTo>
                  <a:pt x="1272032" y="22860"/>
                </a:lnTo>
                <a:lnTo>
                  <a:pt x="1908048" y="22860"/>
                </a:lnTo>
                <a:lnTo>
                  <a:pt x="1908048" y="24130"/>
                </a:lnTo>
                <a:lnTo>
                  <a:pt x="1908048" y="25400"/>
                </a:lnTo>
                <a:lnTo>
                  <a:pt x="2255012" y="25400"/>
                </a:lnTo>
                <a:lnTo>
                  <a:pt x="2255012" y="24130"/>
                </a:lnTo>
                <a:lnTo>
                  <a:pt x="5550789" y="24130"/>
                </a:lnTo>
                <a:lnTo>
                  <a:pt x="5550789" y="22860"/>
                </a:lnTo>
                <a:close/>
              </a:path>
              <a:path w="13183235" h="262890">
                <a:moveTo>
                  <a:pt x="5724271" y="25400"/>
                </a:moveTo>
                <a:lnTo>
                  <a:pt x="2255012" y="25400"/>
                </a:lnTo>
                <a:lnTo>
                  <a:pt x="2255012" y="26670"/>
                </a:lnTo>
                <a:lnTo>
                  <a:pt x="2255012" y="27940"/>
                </a:lnTo>
                <a:lnTo>
                  <a:pt x="2312797" y="27940"/>
                </a:lnTo>
                <a:lnTo>
                  <a:pt x="2312797" y="26670"/>
                </a:lnTo>
                <a:lnTo>
                  <a:pt x="5724271" y="26670"/>
                </a:lnTo>
                <a:lnTo>
                  <a:pt x="5724271" y="25400"/>
                </a:lnTo>
                <a:close/>
              </a:path>
              <a:path w="13183235" h="262890">
                <a:moveTo>
                  <a:pt x="7979410" y="53340"/>
                </a:moveTo>
                <a:lnTo>
                  <a:pt x="7401179" y="53340"/>
                </a:lnTo>
                <a:lnTo>
                  <a:pt x="7401179" y="50800"/>
                </a:lnTo>
                <a:lnTo>
                  <a:pt x="7227697" y="50800"/>
                </a:lnTo>
                <a:lnTo>
                  <a:pt x="7227697" y="48260"/>
                </a:lnTo>
                <a:lnTo>
                  <a:pt x="7112000" y="48260"/>
                </a:lnTo>
                <a:lnTo>
                  <a:pt x="7112000" y="44450"/>
                </a:lnTo>
                <a:lnTo>
                  <a:pt x="7112000" y="43180"/>
                </a:lnTo>
                <a:lnTo>
                  <a:pt x="6880733" y="43180"/>
                </a:lnTo>
                <a:lnTo>
                  <a:pt x="6880733" y="41910"/>
                </a:lnTo>
                <a:lnTo>
                  <a:pt x="6880733" y="38100"/>
                </a:lnTo>
                <a:lnTo>
                  <a:pt x="6707251" y="38100"/>
                </a:lnTo>
                <a:lnTo>
                  <a:pt x="6707251" y="35560"/>
                </a:lnTo>
                <a:lnTo>
                  <a:pt x="6591681" y="35560"/>
                </a:lnTo>
                <a:lnTo>
                  <a:pt x="6591681" y="33020"/>
                </a:lnTo>
                <a:lnTo>
                  <a:pt x="6475984" y="33020"/>
                </a:lnTo>
                <a:lnTo>
                  <a:pt x="6475984" y="30480"/>
                </a:lnTo>
                <a:lnTo>
                  <a:pt x="6360287" y="30480"/>
                </a:lnTo>
                <a:lnTo>
                  <a:pt x="6360287" y="27940"/>
                </a:lnTo>
                <a:lnTo>
                  <a:pt x="2312797" y="27940"/>
                </a:lnTo>
                <a:lnTo>
                  <a:pt x="2312797" y="30480"/>
                </a:lnTo>
                <a:lnTo>
                  <a:pt x="3180207" y="30480"/>
                </a:lnTo>
                <a:lnTo>
                  <a:pt x="3180207" y="33020"/>
                </a:lnTo>
                <a:lnTo>
                  <a:pt x="3353689" y="33020"/>
                </a:lnTo>
                <a:lnTo>
                  <a:pt x="3353689" y="35560"/>
                </a:lnTo>
                <a:lnTo>
                  <a:pt x="3411474" y="35560"/>
                </a:lnTo>
                <a:lnTo>
                  <a:pt x="3411474" y="38100"/>
                </a:lnTo>
                <a:lnTo>
                  <a:pt x="4105275" y="38100"/>
                </a:lnTo>
                <a:lnTo>
                  <a:pt x="4105275" y="41910"/>
                </a:lnTo>
                <a:lnTo>
                  <a:pt x="4278757" y="41910"/>
                </a:lnTo>
                <a:lnTo>
                  <a:pt x="4278757" y="43180"/>
                </a:lnTo>
                <a:lnTo>
                  <a:pt x="4278757" y="44450"/>
                </a:lnTo>
                <a:lnTo>
                  <a:pt x="4567936" y="44450"/>
                </a:lnTo>
                <a:lnTo>
                  <a:pt x="4567936" y="48260"/>
                </a:lnTo>
                <a:lnTo>
                  <a:pt x="4567936" y="50800"/>
                </a:lnTo>
                <a:lnTo>
                  <a:pt x="5261737" y="50800"/>
                </a:lnTo>
                <a:lnTo>
                  <a:pt x="5261737" y="53340"/>
                </a:lnTo>
                <a:lnTo>
                  <a:pt x="5261737" y="54610"/>
                </a:lnTo>
                <a:lnTo>
                  <a:pt x="5377434" y="54610"/>
                </a:lnTo>
                <a:lnTo>
                  <a:pt x="5377434" y="57150"/>
                </a:lnTo>
                <a:lnTo>
                  <a:pt x="5377434" y="58420"/>
                </a:lnTo>
                <a:lnTo>
                  <a:pt x="5550789" y="58420"/>
                </a:lnTo>
                <a:lnTo>
                  <a:pt x="5550789" y="57150"/>
                </a:lnTo>
                <a:lnTo>
                  <a:pt x="7979410" y="57150"/>
                </a:lnTo>
                <a:lnTo>
                  <a:pt x="7979410" y="54610"/>
                </a:lnTo>
                <a:lnTo>
                  <a:pt x="7979410" y="53340"/>
                </a:lnTo>
                <a:close/>
              </a:path>
              <a:path w="13183235" h="262890">
                <a:moveTo>
                  <a:pt x="13183235" y="58928"/>
                </a:moveTo>
                <a:lnTo>
                  <a:pt x="12489434" y="58928"/>
                </a:lnTo>
                <a:lnTo>
                  <a:pt x="12489434" y="74930"/>
                </a:lnTo>
                <a:lnTo>
                  <a:pt x="9771761" y="74930"/>
                </a:lnTo>
                <a:lnTo>
                  <a:pt x="9771761" y="72390"/>
                </a:lnTo>
                <a:lnTo>
                  <a:pt x="9771761" y="71120"/>
                </a:lnTo>
                <a:lnTo>
                  <a:pt x="8615426" y="71120"/>
                </a:lnTo>
                <a:lnTo>
                  <a:pt x="8615426" y="68580"/>
                </a:lnTo>
                <a:lnTo>
                  <a:pt x="8615426" y="67310"/>
                </a:lnTo>
                <a:lnTo>
                  <a:pt x="8499729" y="67310"/>
                </a:lnTo>
                <a:lnTo>
                  <a:pt x="8499729" y="64770"/>
                </a:lnTo>
                <a:lnTo>
                  <a:pt x="8499729" y="63500"/>
                </a:lnTo>
                <a:lnTo>
                  <a:pt x="8384159" y="63500"/>
                </a:lnTo>
                <a:lnTo>
                  <a:pt x="8384159" y="60960"/>
                </a:lnTo>
                <a:lnTo>
                  <a:pt x="8384159" y="59690"/>
                </a:lnTo>
                <a:lnTo>
                  <a:pt x="8037195" y="59690"/>
                </a:lnTo>
                <a:lnTo>
                  <a:pt x="8037195" y="58420"/>
                </a:lnTo>
                <a:lnTo>
                  <a:pt x="5550789" y="58420"/>
                </a:lnTo>
                <a:lnTo>
                  <a:pt x="5550789" y="59690"/>
                </a:lnTo>
                <a:lnTo>
                  <a:pt x="5550789" y="60960"/>
                </a:lnTo>
                <a:lnTo>
                  <a:pt x="5724271" y="60960"/>
                </a:lnTo>
                <a:lnTo>
                  <a:pt x="5724271" y="63500"/>
                </a:lnTo>
                <a:lnTo>
                  <a:pt x="5724271" y="64770"/>
                </a:lnTo>
                <a:lnTo>
                  <a:pt x="5955538" y="64770"/>
                </a:lnTo>
                <a:lnTo>
                  <a:pt x="5955538" y="67310"/>
                </a:lnTo>
                <a:lnTo>
                  <a:pt x="5955538" y="68580"/>
                </a:lnTo>
                <a:lnTo>
                  <a:pt x="6360287" y="68580"/>
                </a:lnTo>
                <a:lnTo>
                  <a:pt x="6360287" y="71120"/>
                </a:lnTo>
                <a:lnTo>
                  <a:pt x="6360287" y="72390"/>
                </a:lnTo>
                <a:lnTo>
                  <a:pt x="6475984" y="72390"/>
                </a:lnTo>
                <a:lnTo>
                  <a:pt x="6475984" y="74930"/>
                </a:lnTo>
                <a:lnTo>
                  <a:pt x="6475984" y="76200"/>
                </a:lnTo>
                <a:lnTo>
                  <a:pt x="6591681" y="76200"/>
                </a:lnTo>
                <a:lnTo>
                  <a:pt x="6591681" y="81280"/>
                </a:lnTo>
                <a:lnTo>
                  <a:pt x="6707251" y="81280"/>
                </a:lnTo>
                <a:lnTo>
                  <a:pt x="6707251" y="85090"/>
                </a:lnTo>
                <a:lnTo>
                  <a:pt x="6880733" y="85090"/>
                </a:lnTo>
                <a:lnTo>
                  <a:pt x="6880733" y="93980"/>
                </a:lnTo>
                <a:lnTo>
                  <a:pt x="7112000" y="93980"/>
                </a:lnTo>
                <a:lnTo>
                  <a:pt x="7112000" y="102870"/>
                </a:lnTo>
                <a:lnTo>
                  <a:pt x="7227697" y="102870"/>
                </a:lnTo>
                <a:lnTo>
                  <a:pt x="7227697" y="106680"/>
                </a:lnTo>
                <a:lnTo>
                  <a:pt x="7401179" y="106680"/>
                </a:lnTo>
                <a:lnTo>
                  <a:pt x="7401179" y="111760"/>
                </a:lnTo>
                <a:lnTo>
                  <a:pt x="7979410" y="111760"/>
                </a:lnTo>
                <a:lnTo>
                  <a:pt x="7979410" y="116840"/>
                </a:lnTo>
                <a:lnTo>
                  <a:pt x="8037195" y="116840"/>
                </a:lnTo>
                <a:lnTo>
                  <a:pt x="8037195" y="121920"/>
                </a:lnTo>
                <a:lnTo>
                  <a:pt x="8384159" y="121920"/>
                </a:lnTo>
                <a:lnTo>
                  <a:pt x="8384159" y="128270"/>
                </a:lnTo>
                <a:lnTo>
                  <a:pt x="8499729" y="128270"/>
                </a:lnTo>
                <a:lnTo>
                  <a:pt x="8499729" y="134620"/>
                </a:lnTo>
                <a:lnTo>
                  <a:pt x="8615426" y="134620"/>
                </a:lnTo>
                <a:lnTo>
                  <a:pt x="8615426" y="140970"/>
                </a:lnTo>
                <a:lnTo>
                  <a:pt x="9771761" y="140970"/>
                </a:lnTo>
                <a:lnTo>
                  <a:pt x="9771761" y="152400"/>
                </a:lnTo>
                <a:lnTo>
                  <a:pt x="12489434" y="152400"/>
                </a:lnTo>
                <a:lnTo>
                  <a:pt x="12489434" y="262890"/>
                </a:lnTo>
                <a:lnTo>
                  <a:pt x="13183235" y="262890"/>
                </a:lnTo>
                <a:lnTo>
                  <a:pt x="13183235" y="74930"/>
                </a:lnTo>
                <a:lnTo>
                  <a:pt x="13183235" y="58928"/>
                </a:lnTo>
                <a:close/>
              </a:path>
            </a:pathLst>
          </a:custGeom>
          <a:solidFill>
            <a:srgbClr val="E95359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7" name="bg object 27"/>
          <p:cNvSpPr/>
          <p:nvPr/>
        </p:nvSpPr>
        <p:spPr>
          <a:xfrm>
            <a:off x="6877939" y="895349"/>
            <a:ext cx="8731250" cy="274320"/>
          </a:xfrm>
          <a:custGeom>
            <a:avLst/>
            <a:gdLst/>
            <a:ahLst/>
            <a:cxnLst/>
            <a:rect l="l" t="t" r="r" b="b"/>
            <a:pathLst>
              <a:path w="8731250" h="274319">
                <a:moveTo>
                  <a:pt x="2544191" y="9791"/>
                </a:moveTo>
                <a:lnTo>
                  <a:pt x="2428494" y="9791"/>
                </a:lnTo>
                <a:lnTo>
                  <a:pt x="2428494" y="7620"/>
                </a:lnTo>
                <a:lnTo>
                  <a:pt x="2312924" y="7620"/>
                </a:lnTo>
                <a:lnTo>
                  <a:pt x="2312924" y="6350"/>
                </a:lnTo>
                <a:lnTo>
                  <a:pt x="2312924" y="5080"/>
                </a:lnTo>
                <a:lnTo>
                  <a:pt x="2139442" y="5080"/>
                </a:lnTo>
                <a:lnTo>
                  <a:pt x="2139442" y="3810"/>
                </a:lnTo>
                <a:lnTo>
                  <a:pt x="2139442" y="2540"/>
                </a:lnTo>
                <a:lnTo>
                  <a:pt x="1908175" y="2540"/>
                </a:lnTo>
                <a:lnTo>
                  <a:pt x="1908175" y="0"/>
                </a:lnTo>
                <a:lnTo>
                  <a:pt x="0" y="0"/>
                </a:lnTo>
                <a:lnTo>
                  <a:pt x="0" y="2540"/>
                </a:lnTo>
                <a:lnTo>
                  <a:pt x="231267" y="2540"/>
                </a:lnTo>
                <a:lnTo>
                  <a:pt x="231267" y="3810"/>
                </a:lnTo>
                <a:lnTo>
                  <a:pt x="346964" y="3810"/>
                </a:lnTo>
                <a:lnTo>
                  <a:pt x="346964" y="5080"/>
                </a:lnTo>
                <a:lnTo>
                  <a:pt x="346964" y="6350"/>
                </a:lnTo>
                <a:lnTo>
                  <a:pt x="520446" y="6350"/>
                </a:lnTo>
                <a:lnTo>
                  <a:pt x="520446" y="7620"/>
                </a:lnTo>
                <a:lnTo>
                  <a:pt x="520446" y="10160"/>
                </a:lnTo>
                <a:lnTo>
                  <a:pt x="578231" y="10160"/>
                </a:lnTo>
                <a:lnTo>
                  <a:pt x="578231" y="11049"/>
                </a:lnTo>
                <a:lnTo>
                  <a:pt x="2544191" y="11049"/>
                </a:lnTo>
                <a:lnTo>
                  <a:pt x="2544191" y="9791"/>
                </a:lnTo>
                <a:close/>
              </a:path>
              <a:path w="8731250" h="274319">
                <a:moveTo>
                  <a:pt x="5435219" y="101219"/>
                </a:moveTo>
                <a:lnTo>
                  <a:pt x="5319649" y="101219"/>
                </a:lnTo>
                <a:lnTo>
                  <a:pt x="5319649" y="97790"/>
                </a:lnTo>
                <a:lnTo>
                  <a:pt x="5319649" y="93980"/>
                </a:lnTo>
                <a:lnTo>
                  <a:pt x="5261737" y="93980"/>
                </a:lnTo>
                <a:lnTo>
                  <a:pt x="5261737" y="90170"/>
                </a:lnTo>
                <a:lnTo>
                  <a:pt x="5203952" y="90170"/>
                </a:lnTo>
                <a:lnTo>
                  <a:pt x="5203952" y="88900"/>
                </a:lnTo>
                <a:lnTo>
                  <a:pt x="5203952" y="86360"/>
                </a:lnTo>
                <a:lnTo>
                  <a:pt x="4972685" y="86360"/>
                </a:lnTo>
                <a:lnTo>
                  <a:pt x="4972685" y="82550"/>
                </a:lnTo>
                <a:lnTo>
                  <a:pt x="4972685" y="80010"/>
                </a:lnTo>
                <a:lnTo>
                  <a:pt x="4972685" y="76200"/>
                </a:lnTo>
                <a:lnTo>
                  <a:pt x="4972685" y="74930"/>
                </a:lnTo>
                <a:lnTo>
                  <a:pt x="4856988" y="74930"/>
                </a:lnTo>
                <a:lnTo>
                  <a:pt x="4856988" y="71120"/>
                </a:lnTo>
                <a:lnTo>
                  <a:pt x="4741418" y="71120"/>
                </a:lnTo>
                <a:lnTo>
                  <a:pt x="4741418" y="68580"/>
                </a:lnTo>
                <a:lnTo>
                  <a:pt x="4741418" y="66040"/>
                </a:lnTo>
                <a:lnTo>
                  <a:pt x="4741418" y="64770"/>
                </a:lnTo>
                <a:lnTo>
                  <a:pt x="4625721" y="64770"/>
                </a:lnTo>
                <a:lnTo>
                  <a:pt x="4625721" y="62230"/>
                </a:lnTo>
                <a:lnTo>
                  <a:pt x="4625721" y="60960"/>
                </a:lnTo>
                <a:lnTo>
                  <a:pt x="4567936" y="60960"/>
                </a:lnTo>
                <a:lnTo>
                  <a:pt x="4567936" y="59690"/>
                </a:lnTo>
                <a:lnTo>
                  <a:pt x="4567936" y="58420"/>
                </a:lnTo>
                <a:lnTo>
                  <a:pt x="4394454" y="58420"/>
                </a:lnTo>
                <a:lnTo>
                  <a:pt x="4394454" y="55880"/>
                </a:lnTo>
                <a:lnTo>
                  <a:pt x="4336669" y="55880"/>
                </a:lnTo>
                <a:lnTo>
                  <a:pt x="4336669" y="53340"/>
                </a:lnTo>
                <a:lnTo>
                  <a:pt x="4336669" y="52070"/>
                </a:lnTo>
                <a:lnTo>
                  <a:pt x="4105402" y="52070"/>
                </a:lnTo>
                <a:lnTo>
                  <a:pt x="4105402" y="49530"/>
                </a:lnTo>
                <a:lnTo>
                  <a:pt x="4047490" y="49530"/>
                </a:lnTo>
                <a:lnTo>
                  <a:pt x="4047490" y="48260"/>
                </a:lnTo>
                <a:lnTo>
                  <a:pt x="4047490" y="44450"/>
                </a:lnTo>
                <a:lnTo>
                  <a:pt x="3931920" y="44450"/>
                </a:lnTo>
                <a:lnTo>
                  <a:pt x="3931920" y="40640"/>
                </a:lnTo>
                <a:lnTo>
                  <a:pt x="3931920" y="36830"/>
                </a:lnTo>
                <a:lnTo>
                  <a:pt x="3874135" y="36830"/>
                </a:lnTo>
                <a:lnTo>
                  <a:pt x="3874135" y="34290"/>
                </a:lnTo>
                <a:lnTo>
                  <a:pt x="3642741" y="34290"/>
                </a:lnTo>
                <a:lnTo>
                  <a:pt x="3642741" y="33020"/>
                </a:lnTo>
                <a:lnTo>
                  <a:pt x="3642741" y="31750"/>
                </a:lnTo>
                <a:lnTo>
                  <a:pt x="3527171" y="31750"/>
                </a:lnTo>
                <a:lnTo>
                  <a:pt x="3527171" y="29210"/>
                </a:lnTo>
                <a:lnTo>
                  <a:pt x="3527171" y="27940"/>
                </a:lnTo>
                <a:lnTo>
                  <a:pt x="3527171" y="24130"/>
                </a:lnTo>
                <a:lnTo>
                  <a:pt x="3353689" y="24130"/>
                </a:lnTo>
                <a:lnTo>
                  <a:pt x="3353689" y="22860"/>
                </a:lnTo>
                <a:lnTo>
                  <a:pt x="3353689" y="21590"/>
                </a:lnTo>
                <a:lnTo>
                  <a:pt x="3353689" y="20320"/>
                </a:lnTo>
                <a:lnTo>
                  <a:pt x="3295904" y="20320"/>
                </a:lnTo>
                <a:lnTo>
                  <a:pt x="3295904" y="17780"/>
                </a:lnTo>
                <a:lnTo>
                  <a:pt x="3006725" y="17780"/>
                </a:lnTo>
                <a:lnTo>
                  <a:pt x="3006725" y="16510"/>
                </a:lnTo>
                <a:lnTo>
                  <a:pt x="3006725" y="15240"/>
                </a:lnTo>
                <a:lnTo>
                  <a:pt x="2891155" y="15240"/>
                </a:lnTo>
                <a:lnTo>
                  <a:pt x="2891155" y="12700"/>
                </a:lnTo>
                <a:lnTo>
                  <a:pt x="2891155" y="11430"/>
                </a:lnTo>
                <a:lnTo>
                  <a:pt x="693928" y="11430"/>
                </a:lnTo>
                <a:lnTo>
                  <a:pt x="693928" y="12700"/>
                </a:lnTo>
                <a:lnTo>
                  <a:pt x="751713" y="12700"/>
                </a:lnTo>
                <a:lnTo>
                  <a:pt x="751713" y="15240"/>
                </a:lnTo>
                <a:lnTo>
                  <a:pt x="809498" y="15240"/>
                </a:lnTo>
                <a:lnTo>
                  <a:pt x="809498" y="16510"/>
                </a:lnTo>
                <a:lnTo>
                  <a:pt x="867410" y="16510"/>
                </a:lnTo>
                <a:lnTo>
                  <a:pt x="867410" y="17780"/>
                </a:lnTo>
                <a:lnTo>
                  <a:pt x="867410" y="20320"/>
                </a:lnTo>
                <a:lnTo>
                  <a:pt x="867410" y="21590"/>
                </a:lnTo>
                <a:lnTo>
                  <a:pt x="925195" y="21590"/>
                </a:lnTo>
                <a:lnTo>
                  <a:pt x="925195" y="22860"/>
                </a:lnTo>
                <a:lnTo>
                  <a:pt x="982980" y="22860"/>
                </a:lnTo>
                <a:lnTo>
                  <a:pt x="982980" y="24130"/>
                </a:lnTo>
                <a:lnTo>
                  <a:pt x="982980" y="27940"/>
                </a:lnTo>
                <a:lnTo>
                  <a:pt x="1040765" y="27940"/>
                </a:lnTo>
                <a:lnTo>
                  <a:pt x="1040765" y="29210"/>
                </a:lnTo>
                <a:lnTo>
                  <a:pt x="1098677" y="29210"/>
                </a:lnTo>
                <a:lnTo>
                  <a:pt x="1098677" y="31750"/>
                </a:lnTo>
                <a:lnTo>
                  <a:pt x="1098677" y="33020"/>
                </a:lnTo>
                <a:lnTo>
                  <a:pt x="1156462" y="33020"/>
                </a:lnTo>
                <a:lnTo>
                  <a:pt x="1156462" y="34290"/>
                </a:lnTo>
                <a:lnTo>
                  <a:pt x="1214247" y="34290"/>
                </a:lnTo>
                <a:lnTo>
                  <a:pt x="1214247" y="36830"/>
                </a:lnTo>
                <a:lnTo>
                  <a:pt x="1214247" y="40640"/>
                </a:lnTo>
                <a:lnTo>
                  <a:pt x="1618996" y="40640"/>
                </a:lnTo>
                <a:lnTo>
                  <a:pt x="1618996" y="44450"/>
                </a:lnTo>
                <a:lnTo>
                  <a:pt x="1676908" y="44450"/>
                </a:lnTo>
                <a:lnTo>
                  <a:pt x="1676908" y="48260"/>
                </a:lnTo>
                <a:lnTo>
                  <a:pt x="1792478" y="48260"/>
                </a:lnTo>
                <a:lnTo>
                  <a:pt x="1792478" y="49530"/>
                </a:lnTo>
                <a:lnTo>
                  <a:pt x="1792478" y="52070"/>
                </a:lnTo>
                <a:lnTo>
                  <a:pt x="1792478" y="53340"/>
                </a:lnTo>
                <a:lnTo>
                  <a:pt x="1850263" y="53340"/>
                </a:lnTo>
                <a:lnTo>
                  <a:pt x="1850263" y="55880"/>
                </a:lnTo>
                <a:lnTo>
                  <a:pt x="1908175" y="55880"/>
                </a:lnTo>
                <a:lnTo>
                  <a:pt x="1908175" y="58420"/>
                </a:lnTo>
                <a:lnTo>
                  <a:pt x="1908175" y="59690"/>
                </a:lnTo>
                <a:lnTo>
                  <a:pt x="2139442" y="59690"/>
                </a:lnTo>
                <a:lnTo>
                  <a:pt x="2139442" y="60960"/>
                </a:lnTo>
                <a:lnTo>
                  <a:pt x="2139442" y="62230"/>
                </a:lnTo>
                <a:lnTo>
                  <a:pt x="2312924" y="62230"/>
                </a:lnTo>
                <a:lnTo>
                  <a:pt x="2312924" y="64770"/>
                </a:lnTo>
                <a:lnTo>
                  <a:pt x="2312924" y="66040"/>
                </a:lnTo>
                <a:lnTo>
                  <a:pt x="2428494" y="66040"/>
                </a:lnTo>
                <a:lnTo>
                  <a:pt x="2428494" y="68580"/>
                </a:lnTo>
                <a:lnTo>
                  <a:pt x="2544191" y="68580"/>
                </a:lnTo>
                <a:lnTo>
                  <a:pt x="2544191" y="71120"/>
                </a:lnTo>
                <a:lnTo>
                  <a:pt x="2891155" y="71120"/>
                </a:lnTo>
                <a:lnTo>
                  <a:pt x="2891155" y="74930"/>
                </a:lnTo>
                <a:lnTo>
                  <a:pt x="2891155" y="76200"/>
                </a:lnTo>
                <a:lnTo>
                  <a:pt x="3006725" y="76200"/>
                </a:lnTo>
                <a:lnTo>
                  <a:pt x="3006725" y="80010"/>
                </a:lnTo>
                <a:lnTo>
                  <a:pt x="3295904" y="80010"/>
                </a:lnTo>
                <a:lnTo>
                  <a:pt x="3295904" y="82550"/>
                </a:lnTo>
                <a:lnTo>
                  <a:pt x="3353689" y="82550"/>
                </a:lnTo>
                <a:lnTo>
                  <a:pt x="3353689" y="86360"/>
                </a:lnTo>
                <a:lnTo>
                  <a:pt x="3353689" y="88900"/>
                </a:lnTo>
                <a:lnTo>
                  <a:pt x="3527171" y="88900"/>
                </a:lnTo>
                <a:lnTo>
                  <a:pt x="3527171" y="90170"/>
                </a:lnTo>
                <a:lnTo>
                  <a:pt x="3527171" y="93980"/>
                </a:lnTo>
                <a:lnTo>
                  <a:pt x="3527171" y="97790"/>
                </a:lnTo>
                <a:lnTo>
                  <a:pt x="3642741" y="97790"/>
                </a:lnTo>
                <a:lnTo>
                  <a:pt x="3642741" y="101600"/>
                </a:lnTo>
                <a:lnTo>
                  <a:pt x="3874135" y="101600"/>
                </a:lnTo>
                <a:lnTo>
                  <a:pt x="3874135" y="105041"/>
                </a:lnTo>
                <a:lnTo>
                  <a:pt x="5435219" y="105041"/>
                </a:lnTo>
                <a:lnTo>
                  <a:pt x="5435219" y="101219"/>
                </a:lnTo>
                <a:close/>
              </a:path>
              <a:path w="8731250" h="274319">
                <a:moveTo>
                  <a:pt x="8731123" y="135890"/>
                </a:moveTo>
                <a:lnTo>
                  <a:pt x="7632446" y="135890"/>
                </a:lnTo>
                <a:lnTo>
                  <a:pt x="7632446" y="130810"/>
                </a:lnTo>
                <a:lnTo>
                  <a:pt x="7632446" y="128270"/>
                </a:lnTo>
                <a:lnTo>
                  <a:pt x="6013450" y="128270"/>
                </a:lnTo>
                <a:lnTo>
                  <a:pt x="6013450" y="127000"/>
                </a:lnTo>
                <a:lnTo>
                  <a:pt x="6013450" y="123190"/>
                </a:lnTo>
                <a:lnTo>
                  <a:pt x="5897880" y="123190"/>
                </a:lnTo>
                <a:lnTo>
                  <a:pt x="5897880" y="118110"/>
                </a:lnTo>
                <a:lnTo>
                  <a:pt x="5839968" y="118110"/>
                </a:lnTo>
                <a:lnTo>
                  <a:pt x="5839968" y="115570"/>
                </a:lnTo>
                <a:lnTo>
                  <a:pt x="5839968" y="114300"/>
                </a:lnTo>
                <a:lnTo>
                  <a:pt x="5550916" y="114300"/>
                </a:lnTo>
                <a:lnTo>
                  <a:pt x="5550916" y="109220"/>
                </a:lnTo>
                <a:lnTo>
                  <a:pt x="5493131" y="109220"/>
                </a:lnTo>
                <a:lnTo>
                  <a:pt x="5493131" y="105410"/>
                </a:lnTo>
                <a:lnTo>
                  <a:pt x="3931920" y="105410"/>
                </a:lnTo>
                <a:lnTo>
                  <a:pt x="3931920" y="109220"/>
                </a:lnTo>
                <a:lnTo>
                  <a:pt x="3931920" y="114300"/>
                </a:lnTo>
                <a:lnTo>
                  <a:pt x="3931920" y="115570"/>
                </a:lnTo>
                <a:lnTo>
                  <a:pt x="4047490" y="115570"/>
                </a:lnTo>
                <a:lnTo>
                  <a:pt x="4047490" y="118110"/>
                </a:lnTo>
                <a:lnTo>
                  <a:pt x="4047490" y="123190"/>
                </a:lnTo>
                <a:lnTo>
                  <a:pt x="4105402" y="123190"/>
                </a:lnTo>
                <a:lnTo>
                  <a:pt x="4105402" y="127000"/>
                </a:lnTo>
                <a:lnTo>
                  <a:pt x="4336669" y="127000"/>
                </a:lnTo>
                <a:lnTo>
                  <a:pt x="4336669" y="128270"/>
                </a:lnTo>
                <a:lnTo>
                  <a:pt x="4336669" y="130810"/>
                </a:lnTo>
                <a:lnTo>
                  <a:pt x="4394454" y="130810"/>
                </a:lnTo>
                <a:lnTo>
                  <a:pt x="4394454" y="135890"/>
                </a:lnTo>
                <a:lnTo>
                  <a:pt x="4567936" y="135890"/>
                </a:lnTo>
                <a:lnTo>
                  <a:pt x="4567936" y="139700"/>
                </a:lnTo>
                <a:lnTo>
                  <a:pt x="4625721" y="139700"/>
                </a:lnTo>
                <a:lnTo>
                  <a:pt x="4625721" y="144780"/>
                </a:lnTo>
                <a:lnTo>
                  <a:pt x="4741418" y="144780"/>
                </a:lnTo>
                <a:lnTo>
                  <a:pt x="4741418" y="153670"/>
                </a:lnTo>
                <a:lnTo>
                  <a:pt x="4856988" y="153670"/>
                </a:lnTo>
                <a:lnTo>
                  <a:pt x="4856988" y="158750"/>
                </a:lnTo>
                <a:lnTo>
                  <a:pt x="4972685" y="158750"/>
                </a:lnTo>
                <a:lnTo>
                  <a:pt x="4972685" y="175260"/>
                </a:lnTo>
                <a:lnTo>
                  <a:pt x="5203952" y="175260"/>
                </a:lnTo>
                <a:lnTo>
                  <a:pt x="5203952" y="180340"/>
                </a:lnTo>
                <a:lnTo>
                  <a:pt x="5261737" y="180340"/>
                </a:lnTo>
                <a:lnTo>
                  <a:pt x="5261737" y="186690"/>
                </a:lnTo>
                <a:lnTo>
                  <a:pt x="5319649" y="186690"/>
                </a:lnTo>
                <a:lnTo>
                  <a:pt x="5319649" y="198120"/>
                </a:lnTo>
                <a:lnTo>
                  <a:pt x="5435219" y="198120"/>
                </a:lnTo>
                <a:lnTo>
                  <a:pt x="5435219" y="203200"/>
                </a:lnTo>
                <a:lnTo>
                  <a:pt x="5493131" y="203200"/>
                </a:lnTo>
                <a:lnTo>
                  <a:pt x="5493131" y="209550"/>
                </a:lnTo>
                <a:lnTo>
                  <a:pt x="5550916" y="209550"/>
                </a:lnTo>
                <a:lnTo>
                  <a:pt x="5550916" y="215900"/>
                </a:lnTo>
                <a:lnTo>
                  <a:pt x="5839968" y="215900"/>
                </a:lnTo>
                <a:lnTo>
                  <a:pt x="5839968" y="222250"/>
                </a:lnTo>
                <a:lnTo>
                  <a:pt x="5897880" y="222250"/>
                </a:lnTo>
                <a:lnTo>
                  <a:pt x="5897880" y="229870"/>
                </a:lnTo>
                <a:lnTo>
                  <a:pt x="6013450" y="229870"/>
                </a:lnTo>
                <a:lnTo>
                  <a:pt x="6013450" y="237490"/>
                </a:lnTo>
                <a:lnTo>
                  <a:pt x="7632446" y="237490"/>
                </a:lnTo>
                <a:lnTo>
                  <a:pt x="7632446" y="274320"/>
                </a:lnTo>
                <a:lnTo>
                  <a:pt x="8731123" y="274320"/>
                </a:lnTo>
                <a:lnTo>
                  <a:pt x="8731123" y="139700"/>
                </a:lnTo>
                <a:lnTo>
                  <a:pt x="8731123" y="135890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8" name="bg object 28"/>
          <p:cNvSpPr/>
          <p:nvPr/>
        </p:nvSpPr>
        <p:spPr>
          <a:xfrm>
            <a:off x="3582162" y="784859"/>
            <a:ext cx="5204460" cy="113030"/>
          </a:xfrm>
          <a:custGeom>
            <a:avLst/>
            <a:gdLst/>
            <a:ahLst/>
            <a:cxnLst/>
            <a:rect l="l" t="t" r="r" b="b"/>
            <a:pathLst>
              <a:path w="5204459" h="113030">
                <a:moveTo>
                  <a:pt x="1272032" y="889"/>
                </a:moveTo>
                <a:lnTo>
                  <a:pt x="1156462" y="889"/>
                </a:lnTo>
                <a:lnTo>
                  <a:pt x="1156462" y="0"/>
                </a:lnTo>
                <a:lnTo>
                  <a:pt x="0" y="0"/>
                </a:lnTo>
                <a:lnTo>
                  <a:pt x="0" y="1270"/>
                </a:lnTo>
                <a:lnTo>
                  <a:pt x="115697" y="1270"/>
                </a:lnTo>
                <a:lnTo>
                  <a:pt x="115697" y="3429"/>
                </a:lnTo>
                <a:lnTo>
                  <a:pt x="1272032" y="3429"/>
                </a:lnTo>
                <a:lnTo>
                  <a:pt x="1272032" y="889"/>
                </a:lnTo>
                <a:close/>
              </a:path>
              <a:path w="5204459" h="113030">
                <a:moveTo>
                  <a:pt x="1908048" y="14859"/>
                </a:moveTo>
                <a:lnTo>
                  <a:pt x="1850263" y="14859"/>
                </a:lnTo>
                <a:lnTo>
                  <a:pt x="1850263" y="13970"/>
                </a:lnTo>
                <a:lnTo>
                  <a:pt x="1850263" y="12700"/>
                </a:lnTo>
                <a:lnTo>
                  <a:pt x="1734693" y="12700"/>
                </a:lnTo>
                <a:lnTo>
                  <a:pt x="1734693" y="11430"/>
                </a:lnTo>
                <a:lnTo>
                  <a:pt x="1734693" y="10160"/>
                </a:lnTo>
                <a:lnTo>
                  <a:pt x="1618996" y="10160"/>
                </a:lnTo>
                <a:lnTo>
                  <a:pt x="1618996" y="8890"/>
                </a:lnTo>
                <a:lnTo>
                  <a:pt x="1561211" y="8890"/>
                </a:lnTo>
                <a:lnTo>
                  <a:pt x="1561211" y="7620"/>
                </a:lnTo>
                <a:lnTo>
                  <a:pt x="1561211" y="6350"/>
                </a:lnTo>
                <a:lnTo>
                  <a:pt x="1445514" y="6350"/>
                </a:lnTo>
                <a:lnTo>
                  <a:pt x="1445514" y="5080"/>
                </a:lnTo>
                <a:lnTo>
                  <a:pt x="1387729" y="5080"/>
                </a:lnTo>
                <a:lnTo>
                  <a:pt x="1387729" y="3810"/>
                </a:lnTo>
                <a:lnTo>
                  <a:pt x="173482" y="3810"/>
                </a:lnTo>
                <a:lnTo>
                  <a:pt x="173482" y="5080"/>
                </a:lnTo>
                <a:lnTo>
                  <a:pt x="173482" y="6350"/>
                </a:lnTo>
                <a:lnTo>
                  <a:pt x="173482" y="7620"/>
                </a:lnTo>
                <a:lnTo>
                  <a:pt x="231267" y="7620"/>
                </a:lnTo>
                <a:lnTo>
                  <a:pt x="231267" y="8890"/>
                </a:lnTo>
                <a:lnTo>
                  <a:pt x="289052" y="8890"/>
                </a:lnTo>
                <a:lnTo>
                  <a:pt x="289052" y="10160"/>
                </a:lnTo>
                <a:lnTo>
                  <a:pt x="289052" y="11430"/>
                </a:lnTo>
                <a:lnTo>
                  <a:pt x="520446" y="11430"/>
                </a:lnTo>
                <a:lnTo>
                  <a:pt x="520446" y="12700"/>
                </a:lnTo>
                <a:lnTo>
                  <a:pt x="520446" y="13970"/>
                </a:lnTo>
                <a:lnTo>
                  <a:pt x="578231" y="13970"/>
                </a:lnTo>
                <a:lnTo>
                  <a:pt x="578231" y="15240"/>
                </a:lnTo>
                <a:lnTo>
                  <a:pt x="693801" y="15240"/>
                </a:lnTo>
                <a:lnTo>
                  <a:pt x="693801" y="18681"/>
                </a:lnTo>
                <a:lnTo>
                  <a:pt x="1908048" y="18681"/>
                </a:lnTo>
                <a:lnTo>
                  <a:pt x="1908048" y="14859"/>
                </a:lnTo>
                <a:close/>
              </a:path>
              <a:path w="5204459" h="113030">
                <a:moveTo>
                  <a:pt x="2197227" y="27559"/>
                </a:moveTo>
                <a:lnTo>
                  <a:pt x="2139442" y="27559"/>
                </a:lnTo>
                <a:lnTo>
                  <a:pt x="2139442" y="26289"/>
                </a:lnTo>
                <a:lnTo>
                  <a:pt x="2081530" y="26289"/>
                </a:lnTo>
                <a:lnTo>
                  <a:pt x="2081530" y="25400"/>
                </a:lnTo>
                <a:lnTo>
                  <a:pt x="2081530" y="24130"/>
                </a:lnTo>
                <a:lnTo>
                  <a:pt x="2023745" y="24130"/>
                </a:lnTo>
                <a:lnTo>
                  <a:pt x="2023745" y="22860"/>
                </a:lnTo>
                <a:lnTo>
                  <a:pt x="2023745" y="20320"/>
                </a:lnTo>
                <a:lnTo>
                  <a:pt x="1965960" y="20320"/>
                </a:lnTo>
                <a:lnTo>
                  <a:pt x="1965960" y="19050"/>
                </a:lnTo>
                <a:lnTo>
                  <a:pt x="751713" y="19050"/>
                </a:lnTo>
                <a:lnTo>
                  <a:pt x="751713" y="20320"/>
                </a:lnTo>
                <a:lnTo>
                  <a:pt x="751713" y="22860"/>
                </a:lnTo>
                <a:lnTo>
                  <a:pt x="809498" y="22860"/>
                </a:lnTo>
                <a:lnTo>
                  <a:pt x="809498" y="24130"/>
                </a:lnTo>
                <a:lnTo>
                  <a:pt x="925195" y="24130"/>
                </a:lnTo>
                <a:lnTo>
                  <a:pt x="925195" y="25400"/>
                </a:lnTo>
                <a:lnTo>
                  <a:pt x="982980" y="25400"/>
                </a:lnTo>
                <a:lnTo>
                  <a:pt x="982980" y="26670"/>
                </a:lnTo>
                <a:lnTo>
                  <a:pt x="1040765" y="26670"/>
                </a:lnTo>
                <a:lnTo>
                  <a:pt x="1040765" y="27559"/>
                </a:lnTo>
                <a:lnTo>
                  <a:pt x="1098550" y="27559"/>
                </a:lnTo>
                <a:lnTo>
                  <a:pt x="1098550" y="28829"/>
                </a:lnTo>
                <a:lnTo>
                  <a:pt x="2197227" y="28829"/>
                </a:lnTo>
                <a:lnTo>
                  <a:pt x="2197227" y="27559"/>
                </a:lnTo>
                <a:close/>
              </a:path>
              <a:path w="5204459" h="113030">
                <a:moveTo>
                  <a:pt x="3989705" y="74561"/>
                </a:moveTo>
                <a:lnTo>
                  <a:pt x="3874008" y="74561"/>
                </a:lnTo>
                <a:lnTo>
                  <a:pt x="3874008" y="73660"/>
                </a:lnTo>
                <a:lnTo>
                  <a:pt x="3816223" y="73660"/>
                </a:lnTo>
                <a:lnTo>
                  <a:pt x="3816223" y="71120"/>
                </a:lnTo>
                <a:lnTo>
                  <a:pt x="3642741" y="71120"/>
                </a:lnTo>
                <a:lnTo>
                  <a:pt x="3642741" y="69850"/>
                </a:lnTo>
                <a:lnTo>
                  <a:pt x="3642741" y="68580"/>
                </a:lnTo>
                <a:lnTo>
                  <a:pt x="3527044" y="68580"/>
                </a:lnTo>
                <a:lnTo>
                  <a:pt x="3527044" y="67310"/>
                </a:lnTo>
                <a:lnTo>
                  <a:pt x="3295777" y="67310"/>
                </a:lnTo>
                <a:lnTo>
                  <a:pt x="3295777" y="64770"/>
                </a:lnTo>
                <a:lnTo>
                  <a:pt x="3295777" y="63500"/>
                </a:lnTo>
                <a:lnTo>
                  <a:pt x="3237992" y="63500"/>
                </a:lnTo>
                <a:lnTo>
                  <a:pt x="3237992" y="62230"/>
                </a:lnTo>
                <a:lnTo>
                  <a:pt x="3180207" y="62230"/>
                </a:lnTo>
                <a:lnTo>
                  <a:pt x="3180207" y="60960"/>
                </a:lnTo>
                <a:lnTo>
                  <a:pt x="3122295" y="60960"/>
                </a:lnTo>
                <a:lnTo>
                  <a:pt x="3122295" y="59690"/>
                </a:lnTo>
                <a:lnTo>
                  <a:pt x="3064510" y="59690"/>
                </a:lnTo>
                <a:lnTo>
                  <a:pt x="3064510" y="58420"/>
                </a:lnTo>
                <a:lnTo>
                  <a:pt x="3006712" y="58420"/>
                </a:lnTo>
                <a:lnTo>
                  <a:pt x="3006712" y="55880"/>
                </a:lnTo>
                <a:lnTo>
                  <a:pt x="2948940" y="55880"/>
                </a:lnTo>
                <a:lnTo>
                  <a:pt x="2948940" y="54610"/>
                </a:lnTo>
                <a:lnTo>
                  <a:pt x="2948940" y="53340"/>
                </a:lnTo>
                <a:lnTo>
                  <a:pt x="2948940" y="52070"/>
                </a:lnTo>
                <a:lnTo>
                  <a:pt x="2891028" y="52070"/>
                </a:lnTo>
                <a:lnTo>
                  <a:pt x="2891028" y="50800"/>
                </a:lnTo>
                <a:lnTo>
                  <a:pt x="2775458" y="50800"/>
                </a:lnTo>
                <a:lnTo>
                  <a:pt x="2775458" y="49530"/>
                </a:lnTo>
                <a:lnTo>
                  <a:pt x="2775458" y="48260"/>
                </a:lnTo>
                <a:lnTo>
                  <a:pt x="2659761" y="48260"/>
                </a:lnTo>
                <a:lnTo>
                  <a:pt x="2659761" y="44450"/>
                </a:lnTo>
                <a:lnTo>
                  <a:pt x="2601976" y="44450"/>
                </a:lnTo>
                <a:lnTo>
                  <a:pt x="2601976" y="43180"/>
                </a:lnTo>
                <a:lnTo>
                  <a:pt x="2544191" y="43180"/>
                </a:lnTo>
                <a:lnTo>
                  <a:pt x="2544191" y="41910"/>
                </a:lnTo>
                <a:lnTo>
                  <a:pt x="2544191" y="40640"/>
                </a:lnTo>
                <a:lnTo>
                  <a:pt x="2544191" y="38100"/>
                </a:lnTo>
                <a:lnTo>
                  <a:pt x="2486279" y="38100"/>
                </a:lnTo>
                <a:lnTo>
                  <a:pt x="2486279" y="36830"/>
                </a:lnTo>
                <a:lnTo>
                  <a:pt x="2486279" y="35560"/>
                </a:lnTo>
                <a:lnTo>
                  <a:pt x="2428494" y="35560"/>
                </a:lnTo>
                <a:lnTo>
                  <a:pt x="2428494" y="34290"/>
                </a:lnTo>
                <a:lnTo>
                  <a:pt x="2428494" y="31750"/>
                </a:lnTo>
                <a:lnTo>
                  <a:pt x="2370709" y="31750"/>
                </a:lnTo>
                <a:lnTo>
                  <a:pt x="2370709" y="30480"/>
                </a:lnTo>
                <a:lnTo>
                  <a:pt x="2370709" y="29210"/>
                </a:lnTo>
                <a:lnTo>
                  <a:pt x="1156462" y="29210"/>
                </a:lnTo>
                <a:lnTo>
                  <a:pt x="1156462" y="30480"/>
                </a:lnTo>
                <a:lnTo>
                  <a:pt x="1214247" y="30480"/>
                </a:lnTo>
                <a:lnTo>
                  <a:pt x="1214247" y="31750"/>
                </a:lnTo>
                <a:lnTo>
                  <a:pt x="1272032" y="31750"/>
                </a:lnTo>
                <a:lnTo>
                  <a:pt x="1272032" y="34290"/>
                </a:lnTo>
                <a:lnTo>
                  <a:pt x="1387729" y="34290"/>
                </a:lnTo>
                <a:lnTo>
                  <a:pt x="1387729" y="35560"/>
                </a:lnTo>
                <a:lnTo>
                  <a:pt x="1445514" y="35560"/>
                </a:lnTo>
                <a:lnTo>
                  <a:pt x="1445514" y="36830"/>
                </a:lnTo>
                <a:lnTo>
                  <a:pt x="1503299" y="36830"/>
                </a:lnTo>
                <a:lnTo>
                  <a:pt x="1503299" y="38100"/>
                </a:lnTo>
                <a:lnTo>
                  <a:pt x="1561211" y="38100"/>
                </a:lnTo>
                <a:lnTo>
                  <a:pt x="1561211" y="40640"/>
                </a:lnTo>
                <a:lnTo>
                  <a:pt x="1618996" y="40640"/>
                </a:lnTo>
                <a:lnTo>
                  <a:pt x="1618996" y="41910"/>
                </a:lnTo>
                <a:lnTo>
                  <a:pt x="1734693" y="41910"/>
                </a:lnTo>
                <a:lnTo>
                  <a:pt x="1734693" y="43180"/>
                </a:lnTo>
                <a:lnTo>
                  <a:pt x="1734693" y="44450"/>
                </a:lnTo>
                <a:lnTo>
                  <a:pt x="1850263" y="44450"/>
                </a:lnTo>
                <a:lnTo>
                  <a:pt x="1850263" y="48260"/>
                </a:lnTo>
                <a:lnTo>
                  <a:pt x="1850263" y="49530"/>
                </a:lnTo>
                <a:lnTo>
                  <a:pt x="1908048" y="49530"/>
                </a:lnTo>
                <a:lnTo>
                  <a:pt x="1908048" y="50800"/>
                </a:lnTo>
                <a:lnTo>
                  <a:pt x="1908048" y="52070"/>
                </a:lnTo>
                <a:lnTo>
                  <a:pt x="1908048" y="53340"/>
                </a:lnTo>
                <a:lnTo>
                  <a:pt x="1965960" y="53340"/>
                </a:lnTo>
                <a:lnTo>
                  <a:pt x="1965960" y="54610"/>
                </a:lnTo>
                <a:lnTo>
                  <a:pt x="2023745" y="54610"/>
                </a:lnTo>
                <a:lnTo>
                  <a:pt x="2023745" y="55880"/>
                </a:lnTo>
                <a:lnTo>
                  <a:pt x="2023745" y="58420"/>
                </a:lnTo>
                <a:lnTo>
                  <a:pt x="2023745" y="59690"/>
                </a:lnTo>
                <a:lnTo>
                  <a:pt x="2081530" y="59690"/>
                </a:lnTo>
                <a:lnTo>
                  <a:pt x="2081530" y="60960"/>
                </a:lnTo>
                <a:lnTo>
                  <a:pt x="2081530" y="62230"/>
                </a:lnTo>
                <a:lnTo>
                  <a:pt x="2081530" y="63500"/>
                </a:lnTo>
                <a:lnTo>
                  <a:pt x="2139442" y="63500"/>
                </a:lnTo>
                <a:lnTo>
                  <a:pt x="2139442" y="64770"/>
                </a:lnTo>
                <a:lnTo>
                  <a:pt x="2197227" y="64770"/>
                </a:lnTo>
                <a:lnTo>
                  <a:pt x="2197227" y="67310"/>
                </a:lnTo>
                <a:lnTo>
                  <a:pt x="2370709" y="67310"/>
                </a:lnTo>
                <a:lnTo>
                  <a:pt x="2370709" y="68580"/>
                </a:lnTo>
                <a:lnTo>
                  <a:pt x="2370709" y="69850"/>
                </a:lnTo>
                <a:lnTo>
                  <a:pt x="2428494" y="69850"/>
                </a:lnTo>
                <a:lnTo>
                  <a:pt x="2428494" y="71120"/>
                </a:lnTo>
                <a:lnTo>
                  <a:pt x="2428494" y="73660"/>
                </a:lnTo>
                <a:lnTo>
                  <a:pt x="2428494" y="74930"/>
                </a:lnTo>
                <a:lnTo>
                  <a:pt x="2486279" y="74930"/>
                </a:lnTo>
                <a:lnTo>
                  <a:pt x="2486279" y="75831"/>
                </a:lnTo>
                <a:lnTo>
                  <a:pt x="3989705" y="75831"/>
                </a:lnTo>
                <a:lnTo>
                  <a:pt x="3989705" y="74561"/>
                </a:lnTo>
                <a:close/>
              </a:path>
              <a:path w="5204459" h="113030">
                <a:moveTo>
                  <a:pt x="5203952" y="110490"/>
                </a:moveTo>
                <a:lnTo>
                  <a:pt x="5146040" y="110490"/>
                </a:lnTo>
                <a:lnTo>
                  <a:pt x="5146040" y="107950"/>
                </a:lnTo>
                <a:lnTo>
                  <a:pt x="5088255" y="107950"/>
                </a:lnTo>
                <a:lnTo>
                  <a:pt x="5088255" y="106680"/>
                </a:lnTo>
                <a:lnTo>
                  <a:pt x="5088255" y="105410"/>
                </a:lnTo>
                <a:lnTo>
                  <a:pt x="5088255" y="104140"/>
                </a:lnTo>
                <a:lnTo>
                  <a:pt x="4972685" y="104140"/>
                </a:lnTo>
                <a:lnTo>
                  <a:pt x="4972685" y="101600"/>
                </a:lnTo>
                <a:lnTo>
                  <a:pt x="4972685" y="100330"/>
                </a:lnTo>
                <a:lnTo>
                  <a:pt x="4914773" y="100330"/>
                </a:lnTo>
                <a:lnTo>
                  <a:pt x="4914773" y="99060"/>
                </a:lnTo>
                <a:lnTo>
                  <a:pt x="4914773" y="97790"/>
                </a:lnTo>
                <a:lnTo>
                  <a:pt x="4510024" y="97790"/>
                </a:lnTo>
                <a:lnTo>
                  <a:pt x="4510024" y="95250"/>
                </a:lnTo>
                <a:lnTo>
                  <a:pt x="4510024" y="93980"/>
                </a:lnTo>
                <a:lnTo>
                  <a:pt x="4510024" y="92710"/>
                </a:lnTo>
                <a:lnTo>
                  <a:pt x="4452239" y="92710"/>
                </a:lnTo>
                <a:lnTo>
                  <a:pt x="4452239" y="91440"/>
                </a:lnTo>
                <a:lnTo>
                  <a:pt x="4394454" y="91440"/>
                </a:lnTo>
                <a:lnTo>
                  <a:pt x="4394454" y="90170"/>
                </a:lnTo>
                <a:lnTo>
                  <a:pt x="4394454" y="88900"/>
                </a:lnTo>
                <a:lnTo>
                  <a:pt x="4336542" y="88900"/>
                </a:lnTo>
                <a:lnTo>
                  <a:pt x="4336542" y="87630"/>
                </a:lnTo>
                <a:lnTo>
                  <a:pt x="4278757" y="87630"/>
                </a:lnTo>
                <a:lnTo>
                  <a:pt x="4278757" y="85090"/>
                </a:lnTo>
                <a:lnTo>
                  <a:pt x="4278757" y="83820"/>
                </a:lnTo>
                <a:lnTo>
                  <a:pt x="4220972" y="83820"/>
                </a:lnTo>
                <a:lnTo>
                  <a:pt x="4220972" y="82550"/>
                </a:lnTo>
                <a:lnTo>
                  <a:pt x="4163187" y="82550"/>
                </a:lnTo>
                <a:lnTo>
                  <a:pt x="4163187" y="78740"/>
                </a:lnTo>
                <a:lnTo>
                  <a:pt x="4105275" y="78740"/>
                </a:lnTo>
                <a:lnTo>
                  <a:pt x="4105275" y="77470"/>
                </a:lnTo>
                <a:lnTo>
                  <a:pt x="4047490" y="77470"/>
                </a:lnTo>
                <a:lnTo>
                  <a:pt x="4047490" y="76200"/>
                </a:lnTo>
                <a:lnTo>
                  <a:pt x="2544191" y="76200"/>
                </a:lnTo>
                <a:lnTo>
                  <a:pt x="2544191" y="77470"/>
                </a:lnTo>
                <a:lnTo>
                  <a:pt x="2544191" y="78740"/>
                </a:lnTo>
                <a:lnTo>
                  <a:pt x="2544191" y="82550"/>
                </a:lnTo>
                <a:lnTo>
                  <a:pt x="2601976" y="82550"/>
                </a:lnTo>
                <a:lnTo>
                  <a:pt x="2601976" y="83820"/>
                </a:lnTo>
                <a:lnTo>
                  <a:pt x="2601976" y="85090"/>
                </a:lnTo>
                <a:lnTo>
                  <a:pt x="2659761" y="85090"/>
                </a:lnTo>
                <a:lnTo>
                  <a:pt x="2659761" y="87630"/>
                </a:lnTo>
                <a:lnTo>
                  <a:pt x="2659761" y="88900"/>
                </a:lnTo>
                <a:lnTo>
                  <a:pt x="2659761" y="90170"/>
                </a:lnTo>
                <a:lnTo>
                  <a:pt x="2775458" y="90170"/>
                </a:lnTo>
                <a:lnTo>
                  <a:pt x="2775458" y="91440"/>
                </a:lnTo>
                <a:lnTo>
                  <a:pt x="2775458" y="92710"/>
                </a:lnTo>
                <a:lnTo>
                  <a:pt x="2833243" y="92710"/>
                </a:lnTo>
                <a:lnTo>
                  <a:pt x="2833243" y="93980"/>
                </a:lnTo>
                <a:lnTo>
                  <a:pt x="2891028" y="93980"/>
                </a:lnTo>
                <a:lnTo>
                  <a:pt x="2891028" y="95250"/>
                </a:lnTo>
                <a:lnTo>
                  <a:pt x="2948940" y="95250"/>
                </a:lnTo>
                <a:lnTo>
                  <a:pt x="2948940" y="97790"/>
                </a:lnTo>
                <a:lnTo>
                  <a:pt x="2948940" y="99060"/>
                </a:lnTo>
                <a:lnTo>
                  <a:pt x="3006712" y="99060"/>
                </a:lnTo>
                <a:lnTo>
                  <a:pt x="3006712" y="100330"/>
                </a:lnTo>
                <a:lnTo>
                  <a:pt x="3006712" y="101600"/>
                </a:lnTo>
                <a:lnTo>
                  <a:pt x="3064510" y="101600"/>
                </a:lnTo>
                <a:lnTo>
                  <a:pt x="3064510" y="104140"/>
                </a:lnTo>
                <a:lnTo>
                  <a:pt x="3122295" y="104140"/>
                </a:lnTo>
                <a:lnTo>
                  <a:pt x="3122295" y="105410"/>
                </a:lnTo>
                <a:lnTo>
                  <a:pt x="3180207" y="105410"/>
                </a:lnTo>
                <a:lnTo>
                  <a:pt x="3180207" y="106680"/>
                </a:lnTo>
                <a:lnTo>
                  <a:pt x="3237992" y="106680"/>
                </a:lnTo>
                <a:lnTo>
                  <a:pt x="3237992" y="107950"/>
                </a:lnTo>
                <a:lnTo>
                  <a:pt x="3295777" y="107950"/>
                </a:lnTo>
                <a:lnTo>
                  <a:pt x="3295777" y="110490"/>
                </a:lnTo>
                <a:lnTo>
                  <a:pt x="3295777" y="113030"/>
                </a:lnTo>
                <a:lnTo>
                  <a:pt x="5203952" y="113030"/>
                </a:lnTo>
                <a:lnTo>
                  <a:pt x="5203952" y="110490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9" name="bg object 29"/>
          <p:cNvSpPr/>
          <p:nvPr/>
        </p:nvSpPr>
        <p:spPr>
          <a:xfrm>
            <a:off x="1211453" y="723518"/>
            <a:ext cx="3527425" cy="62865"/>
          </a:xfrm>
          <a:custGeom>
            <a:avLst/>
            <a:gdLst/>
            <a:ahLst/>
            <a:cxnLst/>
            <a:rect l="l" t="t" r="r" b="b"/>
            <a:pathLst>
              <a:path w="3527425" h="62865">
                <a:moveTo>
                  <a:pt x="404749" y="0"/>
                </a:moveTo>
                <a:lnTo>
                  <a:pt x="0" y="0"/>
                </a:lnTo>
                <a:lnTo>
                  <a:pt x="0" y="1270"/>
                </a:lnTo>
                <a:lnTo>
                  <a:pt x="404749" y="1270"/>
                </a:lnTo>
                <a:lnTo>
                  <a:pt x="404749" y="0"/>
                </a:lnTo>
                <a:close/>
              </a:path>
              <a:path w="3527425" h="62865">
                <a:moveTo>
                  <a:pt x="867283" y="7620"/>
                </a:moveTo>
                <a:lnTo>
                  <a:pt x="809498" y="7620"/>
                </a:lnTo>
                <a:lnTo>
                  <a:pt x="809498" y="6731"/>
                </a:lnTo>
                <a:lnTo>
                  <a:pt x="809498" y="5461"/>
                </a:lnTo>
                <a:lnTo>
                  <a:pt x="693928" y="5461"/>
                </a:lnTo>
                <a:lnTo>
                  <a:pt x="693928" y="4191"/>
                </a:lnTo>
                <a:lnTo>
                  <a:pt x="693928" y="2921"/>
                </a:lnTo>
                <a:lnTo>
                  <a:pt x="636016" y="2921"/>
                </a:lnTo>
                <a:lnTo>
                  <a:pt x="636016" y="1651"/>
                </a:lnTo>
                <a:lnTo>
                  <a:pt x="115697" y="1651"/>
                </a:lnTo>
                <a:lnTo>
                  <a:pt x="115697" y="2921"/>
                </a:lnTo>
                <a:lnTo>
                  <a:pt x="115697" y="4191"/>
                </a:lnTo>
                <a:lnTo>
                  <a:pt x="173482" y="4191"/>
                </a:lnTo>
                <a:lnTo>
                  <a:pt x="173482" y="5461"/>
                </a:lnTo>
                <a:lnTo>
                  <a:pt x="231267" y="5461"/>
                </a:lnTo>
                <a:lnTo>
                  <a:pt x="231267" y="6731"/>
                </a:lnTo>
                <a:lnTo>
                  <a:pt x="404749" y="6731"/>
                </a:lnTo>
                <a:lnTo>
                  <a:pt x="404749" y="8001"/>
                </a:lnTo>
                <a:lnTo>
                  <a:pt x="462534" y="8001"/>
                </a:lnTo>
                <a:lnTo>
                  <a:pt x="462534" y="8902"/>
                </a:lnTo>
                <a:lnTo>
                  <a:pt x="867283" y="8902"/>
                </a:lnTo>
                <a:lnTo>
                  <a:pt x="867283" y="7620"/>
                </a:lnTo>
                <a:close/>
              </a:path>
              <a:path w="3527425" h="62865">
                <a:moveTo>
                  <a:pt x="1156462" y="13970"/>
                </a:moveTo>
                <a:lnTo>
                  <a:pt x="1098677" y="13970"/>
                </a:lnTo>
                <a:lnTo>
                  <a:pt x="1098677" y="11430"/>
                </a:lnTo>
                <a:lnTo>
                  <a:pt x="1040765" y="11430"/>
                </a:lnTo>
                <a:lnTo>
                  <a:pt x="1040765" y="10541"/>
                </a:lnTo>
                <a:lnTo>
                  <a:pt x="925195" y="10541"/>
                </a:lnTo>
                <a:lnTo>
                  <a:pt x="925195" y="9271"/>
                </a:lnTo>
                <a:lnTo>
                  <a:pt x="636016" y="9271"/>
                </a:lnTo>
                <a:lnTo>
                  <a:pt x="636016" y="10541"/>
                </a:lnTo>
                <a:lnTo>
                  <a:pt x="636016" y="11811"/>
                </a:lnTo>
                <a:lnTo>
                  <a:pt x="693928" y="11811"/>
                </a:lnTo>
                <a:lnTo>
                  <a:pt x="693928" y="13970"/>
                </a:lnTo>
                <a:lnTo>
                  <a:pt x="751713" y="13970"/>
                </a:lnTo>
                <a:lnTo>
                  <a:pt x="751713" y="15252"/>
                </a:lnTo>
                <a:lnTo>
                  <a:pt x="1156462" y="15252"/>
                </a:lnTo>
                <a:lnTo>
                  <a:pt x="1156462" y="13970"/>
                </a:lnTo>
                <a:close/>
              </a:path>
              <a:path w="3527425" h="62865">
                <a:moveTo>
                  <a:pt x="1908175" y="25400"/>
                </a:moveTo>
                <a:lnTo>
                  <a:pt x="1850263" y="25400"/>
                </a:lnTo>
                <a:lnTo>
                  <a:pt x="1850263" y="24511"/>
                </a:lnTo>
                <a:lnTo>
                  <a:pt x="1734693" y="24511"/>
                </a:lnTo>
                <a:lnTo>
                  <a:pt x="1734693" y="23241"/>
                </a:lnTo>
                <a:lnTo>
                  <a:pt x="1734693" y="21971"/>
                </a:lnTo>
                <a:lnTo>
                  <a:pt x="1676781" y="21971"/>
                </a:lnTo>
                <a:lnTo>
                  <a:pt x="1676781" y="20701"/>
                </a:lnTo>
                <a:lnTo>
                  <a:pt x="1618996" y="20701"/>
                </a:lnTo>
                <a:lnTo>
                  <a:pt x="1618996" y="19431"/>
                </a:lnTo>
                <a:lnTo>
                  <a:pt x="1387729" y="19431"/>
                </a:lnTo>
                <a:lnTo>
                  <a:pt x="1387729" y="18161"/>
                </a:lnTo>
                <a:lnTo>
                  <a:pt x="1329944" y="18161"/>
                </a:lnTo>
                <a:lnTo>
                  <a:pt x="1329944" y="16891"/>
                </a:lnTo>
                <a:lnTo>
                  <a:pt x="1214247" y="16891"/>
                </a:lnTo>
                <a:lnTo>
                  <a:pt x="1214247" y="15621"/>
                </a:lnTo>
                <a:lnTo>
                  <a:pt x="809498" y="15621"/>
                </a:lnTo>
                <a:lnTo>
                  <a:pt x="809498" y="16891"/>
                </a:lnTo>
                <a:lnTo>
                  <a:pt x="809498" y="18161"/>
                </a:lnTo>
                <a:lnTo>
                  <a:pt x="809498" y="19431"/>
                </a:lnTo>
                <a:lnTo>
                  <a:pt x="867283" y="19431"/>
                </a:lnTo>
                <a:lnTo>
                  <a:pt x="867283" y="20701"/>
                </a:lnTo>
                <a:lnTo>
                  <a:pt x="867283" y="21971"/>
                </a:lnTo>
                <a:lnTo>
                  <a:pt x="925195" y="21971"/>
                </a:lnTo>
                <a:lnTo>
                  <a:pt x="925195" y="23241"/>
                </a:lnTo>
                <a:lnTo>
                  <a:pt x="1040765" y="23241"/>
                </a:lnTo>
                <a:lnTo>
                  <a:pt x="1040765" y="24511"/>
                </a:lnTo>
                <a:lnTo>
                  <a:pt x="1040765" y="25781"/>
                </a:lnTo>
                <a:lnTo>
                  <a:pt x="1098677" y="25781"/>
                </a:lnTo>
                <a:lnTo>
                  <a:pt x="1098677" y="27952"/>
                </a:lnTo>
                <a:lnTo>
                  <a:pt x="1908175" y="27952"/>
                </a:lnTo>
                <a:lnTo>
                  <a:pt x="1908175" y="25400"/>
                </a:lnTo>
                <a:close/>
              </a:path>
              <a:path w="3527425" h="62865">
                <a:moveTo>
                  <a:pt x="2428494" y="38100"/>
                </a:moveTo>
                <a:lnTo>
                  <a:pt x="2370709" y="38100"/>
                </a:lnTo>
                <a:lnTo>
                  <a:pt x="2370709" y="36830"/>
                </a:lnTo>
                <a:lnTo>
                  <a:pt x="2312924" y="36830"/>
                </a:lnTo>
                <a:lnTo>
                  <a:pt x="2312924" y="35572"/>
                </a:lnTo>
                <a:lnTo>
                  <a:pt x="2255012" y="35572"/>
                </a:lnTo>
                <a:lnTo>
                  <a:pt x="2255012" y="34302"/>
                </a:lnTo>
                <a:lnTo>
                  <a:pt x="2197227" y="34302"/>
                </a:lnTo>
                <a:lnTo>
                  <a:pt x="2197227" y="33020"/>
                </a:lnTo>
                <a:lnTo>
                  <a:pt x="2139442" y="33020"/>
                </a:lnTo>
                <a:lnTo>
                  <a:pt x="2139442" y="30480"/>
                </a:lnTo>
                <a:lnTo>
                  <a:pt x="2081530" y="30480"/>
                </a:lnTo>
                <a:lnTo>
                  <a:pt x="2081530" y="29591"/>
                </a:lnTo>
                <a:lnTo>
                  <a:pt x="1965960" y="29591"/>
                </a:lnTo>
                <a:lnTo>
                  <a:pt x="1965960" y="28321"/>
                </a:lnTo>
                <a:lnTo>
                  <a:pt x="1156462" y="28321"/>
                </a:lnTo>
                <a:lnTo>
                  <a:pt x="1156462" y="29591"/>
                </a:lnTo>
                <a:lnTo>
                  <a:pt x="1156462" y="30861"/>
                </a:lnTo>
                <a:lnTo>
                  <a:pt x="1214247" y="30861"/>
                </a:lnTo>
                <a:lnTo>
                  <a:pt x="1214247" y="33020"/>
                </a:lnTo>
                <a:lnTo>
                  <a:pt x="1329944" y="33020"/>
                </a:lnTo>
                <a:lnTo>
                  <a:pt x="1329944" y="34302"/>
                </a:lnTo>
                <a:lnTo>
                  <a:pt x="1387729" y="34302"/>
                </a:lnTo>
                <a:lnTo>
                  <a:pt x="1387729" y="35572"/>
                </a:lnTo>
                <a:lnTo>
                  <a:pt x="1503426" y="35572"/>
                </a:lnTo>
                <a:lnTo>
                  <a:pt x="1503426" y="36830"/>
                </a:lnTo>
                <a:lnTo>
                  <a:pt x="1618996" y="36830"/>
                </a:lnTo>
                <a:lnTo>
                  <a:pt x="1618996" y="38100"/>
                </a:lnTo>
                <a:lnTo>
                  <a:pt x="1676781" y="38100"/>
                </a:lnTo>
                <a:lnTo>
                  <a:pt x="1676781" y="39370"/>
                </a:lnTo>
                <a:lnTo>
                  <a:pt x="2428494" y="39370"/>
                </a:lnTo>
                <a:lnTo>
                  <a:pt x="2428494" y="38100"/>
                </a:lnTo>
                <a:close/>
              </a:path>
              <a:path w="3527425" h="62865">
                <a:moveTo>
                  <a:pt x="2601976" y="43180"/>
                </a:moveTo>
                <a:lnTo>
                  <a:pt x="2544191" y="43180"/>
                </a:lnTo>
                <a:lnTo>
                  <a:pt x="2544191" y="41021"/>
                </a:lnTo>
                <a:lnTo>
                  <a:pt x="2486406" y="41021"/>
                </a:lnTo>
                <a:lnTo>
                  <a:pt x="2486406" y="39751"/>
                </a:lnTo>
                <a:lnTo>
                  <a:pt x="1734693" y="39751"/>
                </a:lnTo>
                <a:lnTo>
                  <a:pt x="1734693" y="41021"/>
                </a:lnTo>
                <a:lnTo>
                  <a:pt x="1734693" y="43561"/>
                </a:lnTo>
                <a:lnTo>
                  <a:pt x="1850263" y="43561"/>
                </a:lnTo>
                <a:lnTo>
                  <a:pt x="1850263" y="44450"/>
                </a:lnTo>
                <a:lnTo>
                  <a:pt x="2601976" y="44450"/>
                </a:lnTo>
                <a:lnTo>
                  <a:pt x="2601976" y="43180"/>
                </a:lnTo>
                <a:close/>
              </a:path>
              <a:path w="3527425" h="62865">
                <a:moveTo>
                  <a:pt x="3237992" y="55880"/>
                </a:moveTo>
                <a:lnTo>
                  <a:pt x="3122422" y="55880"/>
                </a:lnTo>
                <a:lnTo>
                  <a:pt x="3122422" y="54991"/>
                </a:lnTo>
                <a:lnTo>
                  <a:pt x="3122422" y="52451"/>
                </a:lnTo>
                <a:lnTo>
                  <a:pt x="3064510" y="52451"/>
                </a:lnTo>
                <a:lnTo>
                  <a:pt x="3064510" y="51181"/>
                </a:lnTo>
                <a:lnTo>
                  <a:pt x="3064510" y="49911"/>
                </a:lnTo>
                <a:lnTo>
                  <a:pt x="2948940" y="49911"/>
                </a:lnTo>
                <a:lnTo>
                  <a:pt x="2948940" y="48641"/>
                </a:lnTo>
                <a:lnTo>
                  <a:pt x="2891155" y="48641"/>
                </a:lnTo>
                <a:lnTo>
                  <a:pt x="2891155" y="47371"/>
                </a:lnTo>
                <a:lnTo>
                  <a:pt x="2717673" y="47371"/>
                </a:lnTo>
                <a:lnTo>
                  <a:pt x="2717673" y="46101"/>
                </a:lnTo>
                <a:lnTo>
                  <a:pt x="2659761" y="46101"/>
                </a:lnTo>
                <a:lnTo>
                  <a:pt x="2659761" y="44831"/>
                </a:lnTo>
                <a:lnTo>
                  <a:pt x="1908175" y="44831"/>
                </a:lnTo>
                <a:lnTo>
                  <a:pt x="1908175" y="46101"/>
                </a:lnTo>
                <a:lnTo>
                  <a:pt x="1908175" y="47371"/>
                </a:lnTo>
                <a:lnTo>
                  <a:pt x="1965960" y="47371"/>
                </a:lnTo>
                <a:lnTo>
                  <a:pt x="1965960" y="48641"/>
                </a:lnTo>
                <a:lnTo>
                  <a:pt x="1965960" y="49911"/>
                </a:lnTo>
                <a:lnTo>
                  <a:pt x="2081530" y="49911"/>
                </a:lnTo>
                <a:lnTo>
                  <a:pt x="2081530" y="51181"/>
                </a:lnTo>
                <a:lnTo>
                  <a:pt x="2139442" y="51181"/>
                </a:lnTo>
                <a:lnTo>
                  <a:pt x="2139442" y="52451"/>
                </a:lnTo>
                <a:lnTo>
                  <a:pt x="2139442" y="54991"/>
                </a:lnTo>
                <a:lnTo>
                  <a:pt x="2197227" y="54991"/>
                </a:lnTo>
                <a:lnTo>
                  <a:pt x="2197227" y="56261"/>
                </a:lnTo>
                <a:lnTo>
                  <a:pt x="2255012" y="56261"/>
                </a:lnTo>
                <a:lnTo>
                  <a:pt x="2255012" y="57150"/>
                </a:lnTo>
                <a:lnTo>
                  <a:pt x="3237992" y="57150"/>
                </a:lnTo>
                <a:lnTo>
                  <a:pt x="3237992" y="55880"/>
                </a:lnTo>
                <a:close/>
              </a:path>
              <a:path w="3527425" h="62865">
                <a:moveTo>
                  <a:pt x="3527171" y="61341"/>
                </a:moveTo>
                <a:lnTo>
                  <a:pt x="3469259" y="61341"/>
                </a:lnTo>
                <a:lnTo>
                  <a:pt x="3469259" y="60071"/>
                </a:lnTo>
                <a:lnTo>
                  <a:pt x="3411474" y="60071"/>
                </a:lnTo>
                <a:lnTo>
                  <a:pt x="3411474" y="58801"/>
                </a:lnTo>
                <a:lnTo>
                  <a:pt x="3295904" y="58801"/>
                </a:lnTo>
                <a:lnTo>
                  <a:pt x="3295904" y="57531"/>
                </a:lnTo>
                <a:lnTo>
                  <a:pt x="2312924" y="57531"/>
                </a:lnTo>
                <a:lnTo>
                  <a:pt x="2312924" y="58801"/>
                </a:lnTo>
                <a:lnTo>
                  <a:pt x="2312924" y="60071"/>
                </a:lnTo>
                <a:lnTo>
                  <a:pt x="2370709" y="60071"/>
                </a:lnTo>
                <a:lnTo>
                  <a:pt x="2370709" y="61341"/>
                </a:lnTo>
                <a:lnTo>
                  <a:pt x="2370709" y="62611"/>
                </a:lnTo>
                <a:lnTo>
                  <a:pt x="3527171" y="62611"/>
                </a:lnTo>
                <a:lnTo>
                  <a:pt x="3527171" y="61341"/>
                </a:lnTo>
                <a:close/>
              </a:path>
            </a:pathLst>
          </a:custGeom>
          <a:solidFill>
            <a:srgbClr val="41A3FF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0" name="bg object 30"/>
          <p:cNvSpPr/>
          <p:nvPr/>
        </p:nvSpPr>
        <p:spPr>
          <a:xfrm>
            <a:off x="5374640" y="908049"/>
            <a:ext cx="10234930" cy="444500"/>
          </a:xfrm>
          <a:custGeom>
            <a:avLst/>
            <a:gdLst/>
            <a:ahLst/>
            <a:cxnLst/>
            <a:rect l="l" t="t" r="r" b="b"/>
            <a:pathLst>
              <a:path w="10234930" h="444500">
                <a:moveTo>
                  <a:pt x="6302502" y="151130"/>
                </a:moveTo>
                <a:lnTo>
                  <a:pt x="6071235" y="151130"/>
                </a:lnTo>
                <a:lnTo>
                  <a:pt x="6071235" y="149860"/>
                </a:lnTo>
                <a:lnTo>
                  <a:pt x="6071235" y="144780"/>
                </a:lnTo>
                <a:lnTo>
                  <a:pt x="6071235" y="143510"/>
                </a:lnTo>
                <a:lnTo>
                  <a:pt x="4972685" y="143510"/>
                </a:lnTo>
                <a:lnTo>
                  <a:pt x="4972685" y="139700"/>
                </a:lnTo>
                <a:lnTo>
                  <a:pt x="4972685" y="137160"/>
                </a:lnTo>
                <a:lnTo>
                  <a:pt x="4741291" y="137160"/>
                </a:lnTo>
                <a:lnTo>
                  <a:pt x="4741291" y="125730"/>
                </a:lnTo>
                <a:lnTo>
                  <a:pt x="4105275" y="125730"/>
                </a:lnTo>
                <a:lnTo>
                  <a:pt x="4105275" y="118110"/>
                </a:lnTo>
                <a:lnTo>
                  <a:pt x="4105275" y="116840"/>
                </a:lnTo>
                <a:lnTo>
                  <a:pt x="4047490" y="116840"/>
                </a:lnTo>
                <a:lnTo>
                  <a:pt x="4047490" y="113030"/>
                </a:lnTo>
                <a:lnTo>
                  <a:pt x="4047490" y="106680"/>
                </a:lnTo>
                <a:lnTo>
                  <a:pt x="3874008" y="106680"/>
                </a:lnTo>
                <a:lnTo>
                  <a:pt x="3874008" y="105410"/>
                </a:lnTo>
                <a:lnTo>
                  <a:pt x="3874008" y="101600"/>
                </a:lnTo>
                <a:lnTo>
                  <a:pt x="3758438" y="101600"/>
                </a:lnTo>
                <a:lnTo>
                  <a:pt x="3758438" y="97790"/>
                </a:lnTo>
                <a:lnTo>
                  <a:pt x="3700526" y="97790"/>
                </a:lnTo>
                <a:lnTo>
                  <a:pt x="3700526" y="96520"/>
                </a:lnTo>
                <a:lnTo>
                  <a:pt x="3700526" y="92710"/>
                </a:lnTo>
                <a:lnTo>
                  <a:pt x="3642741" y="92710"/>
                </a:lnTo>
                <a:lnTo>
                  <a:pt x="3642741" y="88900"/>
                </a:lnTo>
                <a:lnTo>
                  <a:pt x="3584956" y="88900"/>
                </a:lnTo>
                <a:lnTo>
                  <a:pt x="3584956" y="85090"/>
                </a:lnTo>
                <a:lnTo>
                  <a:pt x="3584956" y="83820"/>
                </a:lnTo>
                <a:lnTo>
                  <a:pt x="3469259" y="83820"/>
                </a:lnTo>
                <a:lnTo>
                  <a:pt x="3469259" y="81280"/>
                </a:lnTo>
                <a:lnTo>
                  <a:pt x="3469259" y="80010"/>
                </a:lnTo>
                <a:lnTo>
                  <a:pt x="3353562" y="80010"/>
                </a:lnTo>
                <a:lnTo>
                  <a:pt x="3353562" y="76200"/>
                </a:lnTo>
                <a:lnTo>
                  <a:pt x="3353562" y="72390"/>
                </a:lnTo>
                <a:lnTo>
                  <a:pt x="3295777" y="72390"/>
                </a:lnTo>
                <a:lnTo>
                  <a:pt x="3295777" y="68580"/>
                </a:lnTo>
                <a:lnTo>
                  <a:pt x="3295777" y="64770"/>
                </a:lnTo>
                <a:lnTo>
                  <a:pt x="3295777" y="63500"/>
                </a:lnTo>
                <a:lnTo>
                  <a:pt x="3122295" y="63500"/>
                </a:lnTo>
                <a:lnTo>
                  <a:pt x="3122295" y="60960"/>
                </a:lnTo>
                <a:lnTo>
                  <a:pt x="3122295" y="57150"/>
                </a:lnTo>
                <a:lnTo>
                  <a:pt x="3122295" y="55880"/>
                </a:lnTo>
                <a:lnTo>
                  <a:pt x="3064510" y="55880"/>
                </a:lnTo>
                <a:lnTo>
                  <a:pt x="3064510" y="48260"/>
                </a:lnTo>
                <a:lnTo>
                  <a:pt x="2775458" y="48260"/>
                </a:lnTo>
                <a:lnTo>
                  <a:pt x="2775458" y="46990"/>
                </a:lnTo>
                <a:lnTo>
                  <a:pt x="2775458" y="44450"/>
                </a:lnTo>
                <a:lnTo>
                  <a:pt x="2659761" y="44450"/>
                </a:lnTo>
                <a:lnTo>
                  <a:pt x="2659761" y="43180"/>
                </a:lnTo>
                <a:lnTo>
                  <a:pt x="2659761" y="41910"/>
                </a:lnTo>
                <a:lnTo>
                  <a:pt x="2544064" y="41910"/>
                </a:lnTo>
                <a:lnTo>
                  <a:pt x="2544064" y="40640"/>
                </a:lnTo>
                <a:lnTo>
                  <a:pt x="2544064" y="36830"/>
                </a:lnTo>
                <a:lnTo>
                  <a:pt x="2544064" y="34290"/>
                </a:lnTo>
                <a:lnTo>
                  <a:pt x="2544064" y="30480"/>
                </a:lnTo>
                <a:lnTo>
                  <a:pt x="2486279" y="30480"/>
                </a:lnTo>
                <a:lnTo>
                  <a:pt x="2486279" y="27940"/>
                </a:lnTo>
                <a:lnTo>
                  <a:pt x="2486279" y="24130"/>
                </a:lnTo>
                <a:lnTo>
                  <a:pt x="2312797" y="24130"/>
                </a:lnTo>
                <a:lnTo>
                  <a:pt x="2312797" y="21590"/>
                </a:lnTo>
                <a:lnTo>
                  <a:pt x="2197227" y="21590"/>
                </a:lnTo>
                <a:lnTo>
                  <a:pt x="2197227" y="19050"/>
                </a:lnTo>
                <a:lnTo>
                  <a:pt x="2197227" y="15240"/>
                </a:lnTo>
                <a:lnTo>
                  <a:pt x="2139315" y="15240"/>
                </a:lnTo>
                <a:lnTo>
                  <a:pt x="2139315" y="10160"/>
                </a:lnTo>
                <a:lnTo>
                  <a:pt x="2139315" y="8890"/>
                </a:lnTo>
                <a:lnTo>
                  <a:pt x="2023745" y="8890"/>
                </a:lnTo>
                <a:lnTo>
                  <a:pt x="2023745" y="7620"/>
                </a:lnTo>
                <a:lnTo>
                  <a:pt x="2023745" y="5080"/>
                </a:lnTo>
                <a:lnTo>
                  <a:pt x="1908048" y="5080"/>
                </a:lnTo>
                <a:lnTo>
                  <a:pt x="1908048" y="0"/>
                </a:lnTo>
                <a:lnTo>
                  <a:pt x="0" y="0"/>
                </a:lnTo>
                <a:lnTo>
                  <a:pt x="0" y="5080"/>
                </a:lnTo>
                <a:lnTo>
                  <a:pt x="0" y="7620"/>
                </a:lnTo>
                <a:lnTo>
                  <a:pt x="57785" y="7620"/>
                </a:lnTo>
                <a:lnTo>
                  <a:pt x="57785" y="8890"/>
                </a:lnTo>
                <a:lnTo>
                  <a:pt x="57785" y="10160"/>
                </a:lnTo>
                <a:lnTo>
                  <a:pt x="231267" y="10160"/>
                </a:lnTo>
                <a:lnTo>
                  <a:pt x="231267" y="15240"/>
                </a:lnTo>
                <a:lnTo>
                  <a:pt x="231267" y="19050"/>
                </a:lnTo>
                <a:lnTo>
                  <a:pt x="289052" y="19050"/>
                </a:lnTo>
                <a:lnTo>
                  <a:pt x="289052" y="21590"/>
                </a:lnTo>
                <a:lnTo>
                  <a:pt x="346964" y="21590"/>
                </a:lnTo>
                <a:lnTo>
                  <a:pt x="346964" y="24130"/>
                </a:lnTo>
                <a:lnTo>
                  <a:pt x="346964" y="27940"/>
                </a:lnTo>
                <a:lnTo>
                  <a:pt x="462534" y="27940"/>
                </a:lnTo>
                <a:lnTo>
                  <a:pt x="462534" y="30480"/>
                </a:lnTo>
                <a:lnTo>
                  <a:pt x="636016" y="30480"/>
                </a:lnTo>
                <a:lnTo>
                  <a:pt x="636016" y="34290"/>
                </a:lnTo>
                <a:lnTo>
                  <a:pt x="809498" y="34290"/>
                </a:lnTo>
                <a:lnTo>
                  <a:pt x="809498" y="36830"/>
                </a:lnTo>
                <a:lnTo>
                  <a:pt x="867283" y="36830"/>
                </a:lnTo>
                <a:lnTo>
                  <a:pt x="867283" y="40640"/>
                </a:lnTo>
                <a:lnTo>
                  <a:pt x="1098550" y="40640"/>
                </a:lnTo>
                <a:lnTo>
                  <a:pt x="1098550" y="41910"/>
                </a:lnTo>
                <a:lnTo>
                  <a:pt x="1098550" y="43180"/>
                </a:lnTo>
                <a:lnTo>
                  <a:pt x="1214234" y="43180"/>
                </a:lnTo>
                <a:lnTo>
                  <a:pt x="1214234" y="44450"/>
                </a:lnTo>
                <a:lnTo>
                  <a:pt x="1214234" y="46990"/>
                </a:lnTo>
                <a:lnTo>
                  <a:pt x="1272032" y="46990"/>
                </a:lnTo>
                <a:lnTo>
                  <a:pt x="1272032" y="48260"/>
                </a:lnTo>
                <a:lnTo>
                  <a:pt x="1272032" y="55880"/>
                </a:lnTo>
                <a:lnTo>
                  <a:pt x="1272032" y="57150"/>
                </a:lnTo>
                <a:lnTo>
                  <a:pt x="1503299" y="57150"/>
                </a:lnTo>
                <a:lnTo>
                  <a:pt x="1503299" y="60960"/>
                </a:lnTo>
                <a:lnTo>
                  <a:pt x="1561211" y="60960"/>
                </a:lnTo>
                <a:lnTo>
                  <a:pt x="1561211" y="63500"/>
                </a:lnTo>
                <a:lnTo>
                  <a:pt x="1561211" y="64770"/>
                </a:lnTo>
                <a:lnTo>
                  <a:pt x="1618996" y="64770"/>
                </a:lnTo>
                <a:lnTo>
                  <a:pt x="1618996" y="68580"/>
                </a:lnTo>
                <a:lnTo>
                  <a:pt x="1676781" y="68580"/>
                </a:lnTo>
                <a:lnTo>
                  <a:pt x="1676781" y="72390"/>
                </a:lnTo>
                <a:lnTo>
                  <a:pt x="1676781" y="76200"/>
                </a:lnTo>
                <a:lnTo>
                  <a:pt x="1792478" y="76200"/>
                </a:lnTo>
                <a:lnTo>
                  <a:pt x="1792478" y="80010"/>
                </a:lnTo>
                <a:lnTo>
                  <a:pt x="1792478" y="81280"/>
                </a:lnTo>
                <a:lnTo>
                  <a:pt x="1850263" y="81280"/>
                </a:lnTo>
                <a:lnTo>
                  <a:pt x="1850263" y="83820"/>
                </a:lnTo>
                <a:lnTo>
                  <a:pt x="1850263" y="85090"/>
                </a:lnTo>
                <a:lnTo>
                  <a:pt x="1908048" y="85090"/>
                </a:lnTo>
                <a:lnTo>
                  <a:pt x="1908048" y="88900"/>
                </a:lnTo>
                <a:lnTo>
                  <a:pt x="1908048" y="92710"/>
                </a:lnTo>
                <a:lnTo>
                  <a:pt x="2023745" y="92710"/>
                </a:lnTo>
                <a:lnTo>
                  <a:pt x="2023745" y="96520"/>
                </a:lnTo>
                <a:lnTo>
                  <a:pt x="2139315" y="96520"/>
                </a:lnTo>
                <a:lnTo>
                  <a:pt x="2139315" y="97790"/>
                </a:lnTo>
                <a:lnTo>
                  <a:pt x="2139315" y="101600"/>
                </a:lnTo>
                <a:lnTo>
                  <a:pt x="2139315" y="105410"/>
                </a:lnTo>
                <a:lnTo>
                  <a:pt x="2197227" y="105410"/>
                </a:lnTo>
                <a:lnTo>
                  <a:pt x="2197227" y="106680"/>
                </a:lnTo>
                <a:lnTo>
                  <a:pt x="2197227" y="113030"/>
                </a:lnTo>
                <a:lnTo>
                  <a:pt x="2312797" y="113030"/>
                </a:lnTo>
                <a:lnTo>
                  <a:pt x="2312797" y="116840"/>
                </a:lnTo>
                <a:lnTo>
                  <a:pt x="2312797" y="118110"/>
                </a:lnTo>
                <a:lnTo>
                  <a:pt x="2486279" y="118110"/>
                </a:lnTo>
                <a:lnTo>
                  <a:pt x="2486279" y="125730"/>
                </a:lnTo>
                <a:lnTo>
                  <a:pt x="2544064" y="125730"/>
                </a:lnTo>
                <a:lnTo>
                  <a:pt x="2544064" y="137160"/>
                </a:lnTo>
                <a:lnTo>
                  <a:pt x="2544064" y="139700"/>
                </a:lnTo>
                <a:lnTo>
                  <a:pt x="2659761" y="139700"/>
                </a:lnTo>
                <a:lnTo>
                  <a:pt x="2659761" y="143510"/>
                </a:lnTo>
                <a:lnTo>
                  <a:pt x="2659761" y="144780"/>
                </a:lnTo>
                <a:lnTo>
                  <a:pt x="2775458" y="144780"/>
                </a:lnTo>
                <a:lnTo>
                  <a:pt x="2775458" y="149860"/>
                </a:lnTo>
                <a:lnTo>
                  <a:pt x="3064510" y="149860"/>
                </a:lnTo>
                <a:lnTo>
                  <a:pt x="3064510" y="151130"/>
                </a:lnTo>
                <a:lnTo>
                  <a:pt x="3064510" y="160020"/>
                </a:lnTo>
                <a:lnTo>
                  <a:pt x="6302502" y="160020"/>
                </a:lnTo>
                <a:lnTo>
                  <a:pt x="6302502" y="151130"/>
                </a:lnTo>
                <a:close/>
              </a:path>
              <a:path w="10234930" h="444500">
                <a:moveTo>
                  <a:pt x="10234422" y="218440"/>
                </a:moveTo>
                <a:lnTo>
                  <a:pt x="7863713" y="218440"/>
                </a:lnTo>
                <a:lnTo>
                  <a:pt x="7863713" y="215900"/>
                </a:lnTo>
                <a:lnTo>
                  <a:pt x="7863713" y="209550"/>
                </a:lnTo>
                <a:lnTo>
                  <a:pt x="7863713" y="204470"/>
                </a:lnTo>
                <a:lnTo>
                  <a:pt x="7632446" y="204470"/>
                </a:lnTo>
                <a:lnTo>
                  <a:pt x="7632446" y="203200"/>
                </a:lnTo>
                <a:lnTo>
                  <a:pt x="7632446" y="198120"/>
                </a:lnTo>
                <a:lnTo>
                  <a:pt x="7632446" y="191770"/>
                </a:lnTo>
                <a:lnTo>
                  <a:pt x="7285482" y="191770"/>
                </a:lnTo>
                <a:lnTo>
                  <a:pt x="7285482" y="181610"/>
                </a:lnTo>
                <a:lnTo>
                  <a:pt x="7285482" y="180340"/>
                </a:lnTo>
                <a:lnTo>
                  <a:pt x="6996430" y="180340"/>
                </a:lnTo>
                <a:lnTo>
                  <a:pt x="6996430" y="170180"/>
                </a:lnTo>
                <a:lnTo>
                  <a:pt x="6880733" y="170180"/>
                </a:lnTo>
                <a:lnTo>
                  <a:pt x="6880733" y="160401"/>
                </a:lnTo>
                <a:lnTo>
                  <a:pt x="3122295" y="160401"/>
                </a:lnTo>
                <a:lnTo>
                  <a:pt x="3122295" y="170561"/>
                </a:lnTo>
                <a:lnTo>
                  <a:pt x="3295777" y="170561"/>
                </a:lnTo>
                <a:lnTo>
                  <a:pt x="3295777" y="180340"/>
                </a:lnTo>
                <a:lnTo>
                  <a:pt x="3295777" y="181610"/>
                </a:lnTo>
                <a:lnTo>
                  <a:pt x="3353562" y="181610"/>
                </a:lnTo>
                <a:lnTo>
                  <a:pt x="3353562" y="191770"/>
                </a:lnTo>
                <a:lnTo>
                  <a:pt x="3469259" y="191770"/>
                </a:lnTo>
                <a:lnTo>
                  <a:pt x="3469259" y="198120"/>
                </a:lnTo>
                <a:lnTo>
                  <a:pt x="3584956" y="198120"/>
                </a:lnTo>
                <a:lnTo>
                  <a:pt x="3584956" y="203200"/>
                </a:lnTo>
                <a:lnTo>
                  <a:pt x="3642741" y="203200"/>
                </a:lnTo>
                <a:lnTo>
                  <a:pt x="3642741" y="204470"/>
                </a:lnTo>
                <a:lnTo>
                  <a:pt x="3642741" y="209550"/>
                </a:lnTo>
                <a:lnTo>
                  <a:pt x="3700526" y="209550"/>
                </a:lnTo>
                <a:lnTo>
                  <a:pt x="3700526" y="215900"/>
                </a:lnTo>
                <a:lnTo>
                  <a:pt x="3758438" y="215900"/>
                </a:lnTo>
                <a:lnTo>
                  <a:pt x="3758438" y="218440"/>
                </a:lnTo>
                <a:lnTo>
                  <a:pt x="3758438" y="222250"/>
                </a:lnTo>
                <a:lnTo>
                  <a:pt x="3874008" y="222250"/>
                </a:lnTo>
                <a:lnTo>
                  <a:pt x="3874008" y="228600"/>
                </a:lnTo>
                <a:lnTo>
                  <a:pt x="4047490" y="228600"/>
                </a:lnTo>
                <a:lnTo>
                  <a:pt x="4047490" y="241300"/>
                </a:lnTo>
                <a:lnTo>
                  <a:pt x="4105275" y="241300"/>
                </a:lnTo>
                <a:lnTo>
                  <a:pt x="4105275" y="255270"/>
                </a:lnTo>
                <a:lnTo>
                  <a:pt x="4741291" y="255270"/>
                </a:lnTo>
                <a:lnTo>
                  <a:pt x="4741291" y="271780"/>
                </a:lnTo>
                <a:lnTo>
                  <a:pt x="4972685" y="271780"/>
                </a:lnTo>
                <a:lnTo>
                  <a:pt x="4972685" y="280670"/>
                </a:lnTo>
                <a:lnTo>
                  <a:pt x="6071235" y="280670"/>
                </a:lnTo>
                <a:lnTo>
                  <a:pt x="6071235" y="294640"/>
                </a:lnTo>
                <a:lnTo>
                  <a:pt x="6302502" y="294640"/>
                </a:lnTo>
                <a:lnTo>
                  <a:pt x="6302502" y="309880"/>
                </a:lnTo>
                <a:lnTo>
                  <a:pt x="6880733" y="309880"/>
                </a:lnTo>
                <a:lnTo>
                  <a:pt x="6880733" y="330200"/>
                </a:lnTo>
                <a:lnTo>
                  <a:pt x="6996430" y="330200"/>
                </a:lnTo>
                <a:lnTo>
                  <a:pt x="6996430" y="351790"/>
                </a:lnTo>
                <a:lnTo>
                  <a:pt x="7285482" y="351790"/>
                </a:lnTo>
                <a:lnTo>
                  <a:pt x="7285482" y="377190"/>
                </a:lnTo>
                <a:lnTo>
                  <a:pt x="7632446" y="377190"/>
                </a:lnTo>
                <a:lnTo>
                  <a:pt x="7632446" y="408940"/>
                </a:lnTo>
                <a:lnTo>
                  <a:pt x="7863713" y="408940"/>
                </a:lnTo>
                <a:lnTo>
                  <a:pt x="7863713" y="444500"/>
                </a:lnTo>
                <a:lnTo>
                  <a:pt x="10234422" y="444500"/>
                </a:lnTo>
                <a:lnTo>
                  <a:pt x="10234422" y="408940"/>
                </a:lnTo>
                <a:lnTo>
                  <a:pt x="10234422" y="377190"/>
                </a:lnTo>
                <a:lnTo>
                  <a:pt x="10234422" y="222250"/>
                </a:lnTo>
                <a:lnTo>
                  <a:pt x="10234422" y="218440"/>
                </a:lnTo>
                <a:close/>
              </a:path>
            </a:pathLst>
          </a:custGeom>
          <a:solidFill>
            <a:srgbClr val="DFD625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1" name="bg object 31"/>
          <p:cNvSpPr/>
          <p:nvPr/>
        </p:nvSpPr>
        <p:spPr>
          <a:xfrm>
            <a:off x="2078736" y="759459"/>
            <a:ext cx="5204460" cy="153670"/>
          </a:xfrm>
          <a:custGeom>
            <a:avLst/>
            <a:gdLst/>
            <a:ahLst/>
            <a:cxnLst/>
            <a:rect l="l" t="t" r="r" b="b"/>
            <a:pathLst>
              <a:path w="5204459" h="153669">
                <a:moveTo>
                  <a:pt x="3295904" y="83820"/>
                </a:moveTo>
                <a:lnTo>
                  <a:pt x="3238119" y="83820"/>
                </a:lnTo>
                <a:lnTo>
                  <a:pt x="3238119" y="81280"/>
                </a:lnTo>
                <a:lnTo>
                  <a:pt x="3180207" y="81280"/>
                </a:lnTo>
                <a:lnTo>
                  <a:pt x="3180207" y="80010"/>
                </a:lnTo>
                <a:lnTo>
                  <a:pt x="3064637" y="80010"/>
                </a:lnTo>
                <a:lnTo>
                  <a:pt x="3064637" y="77470"/>
                </a:lnTo>
                <a:lnTo>
                  <a:pt x="3064637" y="76200"/>
                </a:lnTo>
                <a:lnTo>
                  <a:pt x="3006725" y="76200"/>
                </a:lnTo>
                <a:lnTo>
                  <a:pt x="3006725" y="73660"/>
                </a:lnTo>
                <a:lnTo>
                  <a:pt x="2948940" y="73660"/>
                </a:lnTo>
                <a:lnTo>
                  <a:pt x="2948940" y="71120"/>
                </a:lnTo>
                <a:lnTo>
                  <a:pt x="2948940" y="67310"/>
                </a:lnTo>
                <a:lnTo>
                  <a:pt x="2891155" y="67310"/>
                </a:lnTo>
                <a:lnTo>
                  <a:pt x="2891155" y="66040"/>
                </a:lnTo>
                <a:lnTo>
                  <a:pt x="2833370" y="66040"/>
                </a:lnTo>
                <a:lnTo>
                  <a:pt x="2833370" y="63500"/>
                </a:lnTo>
                <a:lnTo>
                  <a:pt x="2717673" y="63500"/>
                </a:lnTo>
                <a:lnTo>
                  <a:pt x="2717673" y="62230"/>
                </a:lnTo>
                <a:lnTo>
                  <a:pt x="2717673" y="59690"/>
                </a:lnTo>
                <a:lnTo>
                  <a:pt x="2717673" y="57150"/>
                </a:lnTo>
                <a:lnTo>
                  <a:pt x="2717673" y="55880"/>
                </a:lnTo>
                <a:lnTo>
                  <a:pt x="2659888" y="55880"/>
                </a:lnTo>
                <a:lnTo>
                  <a:pt x="2659888" y="52070"/>
                </a:lnTo>
                <a:lnTo>
                  <a:pt x="2370709" y="52070"/>
                </a:lnTo>
                <a:lnTo>
                  <a:pt x="2370709" y="50800"/>
                </a:lnTo>
                <a:lnTo>
                  <a:pt x="2197227" y="50800"/>
                </a:lnTo>
                <a:lnTo>
                  <a:pt x="2197227" y="49530"/>
                </a:lnTo>
                <a:lnTo>
                  <a:pt x="2081657" y="49530"/>
                </a:lnTo>
                <a:lnTo>
                  <a:pt x="2081657" y="48260"/>
                </a:lnTo>
                <a:lnTo>
                  <a:pt x="2081657" y="46990"/>
                </a:lnTo>
                <a:lnTo>
                  <a:pt x="1965960" y="46990"/>
                </a:lnTo>
                <a:lnTo>
                  <a:pt x="1965960" y="45720"/>
                </a:lnTo>
                <a:lnTo>
                  <a:pt x="1965960" y="44450"/>
                </a:lnTo>
                <a:lnTo>
                  <a:pt x="1850390" y="44450"/>
                </a:lnTo>
                <a:lnTo>
                  <a:pt x="1850390" y="41910"/>
                </a:lnTo>
                <a:lnTo>
                  <a:pt x="1676908" y="41910"/>
                </a:lnTo>
                <a:lnTo>
                  <a:pt x="1676908" y="40640"/>
                </a:lnTo>
                <a:lnTo>
                  <a:pt x="1619123" y="40640"/>
                </a:lnTo>
                <a:lnTo>
                  <a:pt x="1619123" y="39370"/>
                </a:lnTo>
                <a:lnTo>
                  <a:pt x="1503426" y="39370"/>
                </a:lnTo>
                <a:lnTo>
                  <a:pt x="1503426" y="38100"/>
                </a:lnTo>
                <a:lnTo>
                  <a:pt x="1503426" y="36830"/>
                </a:lnTo>
                <a:lnTo>
                  <a:pt x="1387729" y="36830"/>
                </a:lnTo>
                <a:lnTo>
                  <a:pt x="1387729" y="33020"/>
                </a:lnTo>
                <a:lnTo>
                  <a:pt x="1329944" y="33020"/>
                </a:lnTo>
                <a:lnTo>
                  <a:pt x="1329944" y="31750"/>
                </a:lnTo>
                <a:lnTo>
                  <a:pt x="1272159" y="31750"/>
                </a:lnTo>
                <a:lnTo>
                  <a:pt x="1272159" y="26670"/>
                </a:lnTo>
                <a:lnTo>
                  <a:pt x="1214247" y="26670"/>
                </a:lnTo>
                <a:lnTo>
                  <a:pt x="1214247" y="22860"/>
                </a:lnTo>
                <a:lnTo>
                  <a:pt x="1214247" y="20320"/>
                </a:lnTo>
                <a:lnTo>
                  <a:pt x="1156462" y="20320"/>
                </a:lnTo>
                <a:lnTo>
                  <a:pt x="1156462" y="19050"/>
                </a:lnTo>
                <a:lnTo>
                  <a:pt x="1098677" y="19050"/>
                </a:lnTo>
                <a:lnTo>
                  <a:pt x="1098677" y="17780"/>
                </a:lnTo>
                <a:lnTo>
                  <a:pt x="1040892" y="17780"/>
                </a:lnTo>
                <a:lnTo>
                  <a:pt x="1040892" y="16510"/>
                </a:lnTo>
                <a:lnTo>
                  <a:pt x="982980" y="16510"/>
                </a:lnTo>
                <a:lnTo>
                  <a:pt x="982980" y="15240"/>
                </a:lnTo>
                <a:lnTo>
                  <a:pt x="982980" y="13970"/>
                </a:lnTo>
                <a:lnTo>
                  <a:pt x="925195" y="13970"/>
                </a:lnTo>
                <a:lnTo>
                  <a:pt x="925195" y="11430"/>
                </a:lnTo>
                <a:lnTo>
                  <a:pt x="925195" y="10160"/>
                </a:lnTo>
                <a:lnTo>
                  <a:pt x="867410" y="10160"/>
                </a:lnTo>
                <a:lnTo>
                  <a:pt x="867410" y="8890"/>
                </a:lnTo>
                <a:lnTo>
                  <a:pt x="809498" y="8890"/>
                </a:lnTo>
                <a:lnTo>
                  <a:pt x="809498" y="7620"/>
                </a:lnTo>
                <a:lnTo>
                  <a:pt x="751713" y="7620"/>
                </a:lnTo>
                <a:lnTo>
                  <a:pt x="751713" y="3810"/>
                </a:lnTo>
                <a:lnTo>
                  <a:pt x="693928" y="3810"/>
                </a:lnTo>
                <a:lnTo>
                  <a:pt x="693928" y="2540"/>
                </a:lnTo>
                <a:lnTo>
                  <a:pt x="693928" y="1270"/>
                </a:lnTo>
                <a:lnTo>
                  <a:pt x="578231" y="1270"/>
                </a:lnTo>
                <a:lnTo>
                  <a:pt x="578231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57912" y="2540"/>
                </a:lnTo>
                <a:lnTo>
                  <a:pt x="57912" y="3810"/>
                </a:lnTo>
                <a:lnTo>
                  <a:pt x="57912" y="7620"/>
                </a:lnTo>
                <a:lnTo>
                  <a:pt x="57912" y="8890"/>
                </a:lnTo>
                <a:lnTo>
                  <a:pt x="57912" y="10160"/>
                </a:lnTo>
                <a:lnTo>
                  <a:pt x="57912" y="11430"/>
                </a:lnTo>
                <a:lnTo>
                  <a:pt x="115697" y="11430"/>
                </a:lnTo>
                <a:lnTo>
                  <a:pt x="115697" y="13970"/>
                </a:lnTo>
                <a:lnTo>
                  <a:pt x="115697" y="15240"/>
                </a:lnTo>
                <a:lnTo>
                  <a:pt x="231394" y="15240"/>
                </a:lnTo>
                <a:lnTo>
                  <a:pt x="231394" y="16510"/>
                </a:lnTo>
                <a:lnTo>
                  <a:pt x="231394" y="17780"/>
                </a:lnTo>
                <a:lnTo>
                  <a:pt x="289179" y="17780"/>
                </a:lnTo>
                <a:lnTo>
                  <a:pt x="289179" y="19050"/>
                </a:lnTo>
                <a:lnTo>
                  <a:pt x="289179" y="20320"/>
                </a:lnTo>
                <a:lnTo>
                  <a:pt x="404749" y="20320"/>
                </a:lnTo>
                <a:lnTo>
                  <a:pt x="404749" y="22860"/>
                </a:lnTo>
                <a:lnTo>
                  <a:pt x="462661" y="22860"/>
                </a:lnTo>
                <a:lnTo>
                  <a:pt x="462661" y="26670"/>
                </a:lnTo>
                <a:lnTo>
                  <a:pt x="520446" y="26670"/>
                </a:lnTo>
                <a:lnTo>
                  <a:pt x="520446" y="31750"/>
                </a:lnTo>
                <a:lnTo>
                  <a:pt x="520446" y="33020"/>
                </a:lnTo>
                <a:lnTo>
                  <a:pt x="578231" y="33020"/>
                </a:lnTo>
                <a:lnTo>
                  <a:pt x="578231" y="36830"/>
                </a:lnTo>
                <a:lnTo>
                  <a:pt x="578231" y="38100"/>
                </a:lnTo>
                <a:lnTo>
                  <a:pt x="693928" y="38100"/>
                </a:lnTo>
                <a:lnTo>
                  <a:pt x="693928" y="39370"/>
                </a:lnTo>
                <a:lnTo>
                  <a:pt x="693928" y="40640"/>
                </a:lnTo>
                <a:lnTo>
                  <a:pt x="751713" y="40640"/>
                </a:lnTo>
                <a:lnTo>
                  <a:pt x="751713" y="41910"/>
                </a:lnTo>
                <a:lnTo>
                  <a:pt x="751713" y="44450"/>
                </a:lnTo>
                <a:lnTo>
                  <a:pt x="751713" y="45720"/>
                </a:lnTo>
                <a:lnTo>
                  <a:pt x="809498" y="45720"/>
                </a:lnTo>
                <a:lnTo>
                  <a:pt x="809498" y="46990"/>
                </a:lnTo>
                <a:lnTo>
                  <a:pt x="809498" y="48260"/>
                </a:lnTo>
                <a:lnTo>
                  <a:pt x="867410" y="48260"/>
                </a:lnTo>
                <a:lnTo>
                  <a:pt x="867410" y="49530"/>
                </a:lnTo>
                <a:lnTo>
                  <a:pt x="925195" y="49530"/>
                </a:lnTo>
                <a:lnTo>
                  <a:pt x="925195" y="50800"/>
                </a:lnTo>
                <a:lnTo>
                  <a:pt x="925195" y="52070"/>
                </a:lnTo>
                <a:lnTo>
                  <a:pt x="925195" y="55880"/>
                </a:lnTo>
                <a:lnTo>
                  <a:pt x="982980" y="55880"/>
                </a:lnTo>
                <a:lnTo>
                  <a:pt x="982980" y="57150"/>
                </a:lnTo>
                <a:lnTo>
                  <a:pt x="1040892" y="57150"/>
                </a:lnTo>
                <a:lnTo>
                  <a:pt x="1040892" y="59690"/>
                </a:lnTo>
                <a:lnTo>
                  <a:pt x="1098677" y="59690"/>
                </a:lnTo>
                <a:lnTo>
                  <a:pt x="1098677" y="62230"/>
                </a:lnTo>
                <a:lnTo>
                  <a:pt x="1156462" y="62230"/>
                </a:lnTo>
                <a:lnTo>
                  <a:pt x="1156462" y="63500"/>
                </a:lnTo>
                <a:lnTo>
                  <a:pt x="1214247" y="63500"/>
                </a:lnTo>
                <a:lnTo>
                  <a:pt x="1214247" y="66040"/>
                </a:lnTo>
                <a:lnTo>
                  <a:pt x="1214247" y="67310"/>
                </a:lnTo>
                <a:lnTo>
                  <a:pt x="1214247" y="71120"/>
                </a:lnTo>
                <a:lnTo>
                  <a:pt x="1272159" y="71120"/>
                </a:lnTo>
                <a:lnTo>
                  <a:pt x="1272159" y="73660"/>
                </a:lnTo>
                <a:lnTo>
                  <a:pt x="1272159" y="76200"/>
                </a:lnTo>
                <a:lnTo>
                  <a:pt x="1272159" y="77470"/>
                </a:lnTo>
                <a:lnTo>
                  <a:pt x="1329944" y="77470"/>
                </a:lnTo>
                <a:lnTo>
                  <a:pt x="1329944" y="80010"/>
                </a:lnTo>
                <a:lnTo>
                  <a:pt x="1387729" y="80010"/>
                </a:lnTo>
                <a:lnTo>
                  <a:pt x="1387729" y="81280"/>
                </a:lnTo>
                <a:lnTo>
                  <a:pt x="1387729" y="83820"/>
                </a:lnTo>
                <a:lnTo>
                  <a:pt x="1387729" y="86360"/>
                </a:lnTo>
                <a:lnTo>
                  <a:pt x="1503426" y="86360"/>
                </a:lnTo>
                <a:lnTo>
                  <a:pt x="1503426" y="87630"/>
                </a:lnTo>
                <a:lnTo>
                  <a:pt x="1619123" y="87630"/>
                </a:lnTo>
                <a:lnTo>
                  <a:pt x="1619123" y="90170"/>
                </a:lnTo>
                <a:lnTo>
                  <a:pt x="3295904" y="90170"/>
                </a:lnTo>
                <a:lnTo>
                  <a:pt x="3295904" y="87630"/>
                </a:lnTo>
                <a:lnTo>
                  <a:pt x="3295904" y="86360"/>
                </a:lnTo>
                <a:lnTo>
                  <a:pt x="3295904" y="83820"/>
                </a:lnTo>
                <a:close/>
              </a:path>
              <a:path w="5204459" h="153669">
                <a:moveTo>
                  <a:pt x="3527171" y="92710"/>
                </a:moveTo>
                <a:lnTo>
                  <a:pt x="3353689" y="92710"/>
                </a:lnTo>
                <a:lnTo>
                  <a:pt x="3353689" y="90551"/>
                </a:lnTo>
                <a:lnTo>
                  <a:pt x="1676908" y="90551"/>
                </a:lnTo>
                <a:lnTo>
                  <a:pt x="1676908" y="93091"/>
                </a:lnTo>
                <a:lnTo>
                  <a:pt x="1850390" y="93091"/>
                </a:lnTo>
                <a:lnTo>
                  <a:pt x="1850390" y="95250"/>
                </a:lnTo>
                <a:lnTo>
                  <a:pt x="1965960" y="95250"/>
                </a:lnTo>
                <a:lnTo>
                  <a:pt x="1965960" y="99060"/>
                </a:lnTo>
                <a:lnTo>
                  <a:pt x="3527171" y="99060"/>
                </a:lnTo>
                <a:lnTo>
                  <a:pt x="3527171" y="95250"/>
                </a:lnTo>
                <a:lnTo>
                  <a:pt x="3527171" y="92710"/>
                </a:lnTo>
                <a:close/>
              </a:path>
              <a:path w="5204459" h="153669">
                <a:moveTo>
                  <a:pt x="4857115" y="130810"/>
                </a:moveTo>
                <a:lnTo>
                  <a:pt x="4799203" y="130810"/>
                </a:lnTo>
                <a:lnTo>
                  <a:pt x="4799203" y="128270"/>
                </a:lnTo>
                <a:lnTo>
                  <a:pt x="4567936" y="128270"/>
                </a:lnTo>
                <a:lnTo>
                  <a:pt x="4567936" y="127000"/>
                </a:lnTo>
                <a:lnTo>
                  <a:pt x="4567936" y="123190"/>
                </a:lnTo>
                <a:lnTo>
                  <a:pt x="4567936" y="120650"/>
                </a:lnTo>
                <a:lnTo>
                  <a:pt x="4510138" y="120650"/>
                </a:lnTo>
                <a:lnTo>
                  <a:pt x="4510138" y="118110"/>
                </a:lnTo>
                <a:lnTo>
                  <a:pt x="4394454" y="118110"/>
                </a:lnTo>
                <a:lnTo>
                  <a:pt x="4394454" y="115570"/>
                </a:lnTo>
                <a:lnTo>
                  <a:pt x="4163187" y="115570"/>
                </a:lnTo>
                <a:lnTo>
                  <a:pt x="4163187" y="113030"/>
                </a:lnTo>
                <a:lnTo>
                  <a:pt x="4105402" y="113030"/>
                </a:lnTo>
                <a:lnTo>
                  <a:pt x="4105402" y="110490"/>
                </a:lnTo>
                <a:lnTo>
                  <a:pt x="3931920" y="110490"/>
                </a:lnTo>
                <a:lnTo>
                  <a:pt x="3931920" y="107950"/>
                </a:lnTo>
                <a:lnTo>
                  <a:pt x="3758438" y="107950"/>
                </a:lnTo>
                <a:lnTo>
                  <a:pt x="3758438" y="106680"/>
                </a:lnTo>
                <a:lnTo>
                  <a:pt x="3758438" y="105410"/>
                </a:lnTo>
                <a:lnTo>
                  <a:pt x="3642868" y="105410"/>
                </a:lnTo>
                <a:lnTo>
                  <a:pt x="3642868" y="104140"/>
                </a:lnTo>
                <a:lnTo>
                  <a:pt x="3642868" y="101600"/>
                </a:lnTo>
                <a:lnTo>
                  <a:pt x="3584956" y="101600"/>
                </a:lnTo>
                <a:lnTo>
                  <a:pt x="3584956" y="99441"/>
                </a:lnTo>
                <a:lnTo>
                  <a:pt x="2081657" y="99441"/>
                </a:lnTo>
                <a:lnTo>
                  <a:pt x="2081657" y="101981"/>
                </a:lnTo>
                <a:lnTo>
                  <a:pt x="2197227" y="101981"/>
                </a:lnTo>
                <a:lnTo>
                  <a:pt x="2197227" y="104140"/>
                </a:lnTo>
                <a:lnTo>
                  <a:pt x="2370709" y="104140"/>
                </a:lnTo>
                <a:lnTo>
                  <a:pt x="2370709" y="105410"/>
                </a:lnTo>
                <a:lnTo>
                  <a:pt x="2370709" y="106680"/>
                </a:lnTo>
                <a:lnTo>
                  <a:pt x="2659888" y="106680"/>
                </a:lnTo>
                <a:lnTo>
                  <a:pt x="2659888" y="107950"/>
                </a:lnTo>
                <a:lnTo>
                  <a:pt x="2659888" y="110490"/>
                </a:lnTo>
                <a:lnTo>
                  <a:pt x="2717673" y="110490"/>
                </a:lnTo>
                <a:lnTo>
                  <a:pt x="2717673" y="113030"/>
                </a:lnTo>
                <a:lnTo>
                  <a:pt x="2717673" y="115570"/>
                </a:lnTo>
                <a:lnTo>
                  <a:pt x="2717673" y="118110"/>
                </a:lnTo>
                <a:lnTo>
                  <a:pt x="2717673" y="120650"/>
                </a:lnTo>
                <a:lnTo>
                  <a:pt x="2833370" y="120650"/>
                </a:lnTo>
                <a:lnTo>
                  <a:pt x="2833370" y="123190"/>
                </a:lnTo>
                <a:lnTo>
                  <a:pt x="2891155" y="123190"/>
                </a:lnTo>
                <a:lnTo>
                  <a:pt x="2891155" y="127000"/>
                </a:lnTo>
                <a:lnTo>
                  <a:pt x="2948940" y="127000"/>
                </a:lnTo>
                <a:lnTo>
                  <a:pt x="2948940" y="128270"/>
                </a:lnTo>
                <a:lnTo>
                  <a:pt x="2948940" y="130810"/>
                </a:lnTo>
                <a:lnTo>
                  <a:pt x="2948940" y="134620"/>
                </a:lnTo>
                <a:lnTo>
                  <a:pt x="4857115" y="134620"/>
                </a:lnTo>
                <a:lnTo>
                  <a:pt x="4857115" y="130810"/>
                </a:lnTo>
                <a:close/>
              </a:path>
              <a:path w="5204459" h="153669">
                <a:moveTo>
                  <a:pt x="5203952" y="148590"/>
                </a:moveTo>
                <a:lnTo>
                  <a:pt x="5146167" y="148590"/>
                </a:lnTo>
                <a:lnTo>
                  <a:pt x="5146167" y="147320"/>
                </a:lnTo>
                <a:lnTo>
                  <a:pt x="5146167" y="146050"/>
                </a:lnTo>
                <a:lnTo>
                  <a:pt x="5088382" y="146050"/>
                </a:lnTo>
                <a:lnTo>
                  <a:pt x="5088382" y="144780"/>
                </a:lnTo>
                <a:lnTo>
                  <a:pt x="5088382" y="142240"/>
                </a:lnTo>
                <a:lnTo>
                  <a:pt x="4972685" y="142240"/>
                </a:lnTo>
                <a:lnTo>
                  <a:pt x="4972685" y="137541"/>
                </a:lnTo>
                <a:lnTo>
                  <a:pt x="4914900" y="137541"/>
                </a:lnTo>
                <a:lnTo>
                  <a:pt x="4914900" y="135001"/>
                </a:lnTo>
                <a:lnTo>
                  <a:pt x="3006725" y="135001"/>
                </a:lnTo>
                <a:lnTo>
                  <a:pt x="3006725" y="137541"/>
                </a:lnTo>
                <a:lnTo>
                  <a:pt x="3064637" y="137541"/>
                </a:lnTo>
                <a:lnTo>
                  <a:pt x="3064637" y="142621"/>
                </a:lnTo>
                <a:lnTo>
                  <a:pt x="3180207" y="142621"/>
                </a:lnTo>
                <a:lnTo>
                  <a:pt x="3180207" y="144780"/>
                </a:lnTo>
                <a:lnTo>
                  <a:pt x="3238119" y="144780"/>
                </a:lnTo>
                <a:lnTo>
                  <a:pt x="3238119" y="146050"/>
                </a:lnTo>
                <a:lnTo>
                  <a:pt x="3238119" y="147320"/>
                </a:lnTo>
                <a:lnTo>
                  <a:pt x="3295904" y="147320"/>
                </a:lnTo>
                <a:lnTo>
                  <a:pt x="3295904" y="148590"/>
                </a:lnTo>
                <a:lnTo>
                  <a:pt x="3295904" y="153670"/>
                </a:lnTo>
                <a:lnTo>
                  <a:pt x="5203952" y="153670"/>
                </a:lnTo>
                <a:lnTo>
                  <a:pt x="5203952" y="148590"/>
                </a:lnTo>
                <a:close/>
              </a:path>
            </a:pathLst>
          </a:custGeom>
          <a:solidFill>
            <a:srgbClr val="DFD625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2" name="bg object 32"/>
          <p:cNvSpPr/>
          <p:nvPr/>
        </p:nvSpPr>
        <p:spPr>
          <a:xfrm>
            <a:off x="1327150" y="722629"/>
            <a:ext cx="1330325" cy="38100"/>
          </a:xfrm>
          <a:custGeom>
            <a:avLst/>
            <a:gdLst/>
            <a:ahLst/>
            <a:cxnLst/>
            <a:rect l="l" t="t" r="r" b="b"/>
            <a:pathLst>
              <a:path w="1330325" h="38100">
                <a:moveTo>
                  <a:pt x="1329817" y="34290"/>
                </a:moveTo>
                <a:lnTo>
                  <a:pt x="1272032" y="34290"/>
                </a:lnTo>
                <a:lnTo>
                  <a:pt x="1272032" y="31750"/>
                </a:lnTo>
                <a:lnTo>
                  <a:pt x="1272032" y="30480"/>
                </a:lnTo>
                <a:lnTo>
                  <a:pt x="1214247" y="30480"/>
                </a:lnTo>
                <a:lnTo>
                  <a:pt x="1214247" y="27940"/>
                </a:lnTo>
                <a:lnTo>
                  <a:pt x="1156335" y="27940"/>
                </a:lnTo>
                <a:lnTo>
                  <a:pt x="1156335" y="26670"/>
                </a:lnTo>
                <a:lnTo>
                  <a:pt x="1040765" y="26670"/>
                </a:lnTo>
                <a:lnTo>
                  <a:pt x="1040765" y="24130"/>
                </a:lnTo>
                <a:lnTo>
                  <a:pt x="982980" y="24130"/>
                </a:lnTo>
                <a:lnTo>
                  <a:pt x="982980" y="22860"/>
                </a:lnTo>
                <a:lnTo>
                  <a:pt x="867283" y="22860"/>
                </a:lnTo>
                <a:lnTo>
                  <a:pt x="867283" y="20320"/>
                </a:lnTo>
                <a:lnTo>
                  <a:pt x="809498" y="20320"/>
                </a:lnTo>
                <a:lnTo>
                  <a:pt x="809498" y="17780"/>
                </a:lnTo>
                <a:lnTo>
                  <a:pt x="809498" y="16510"/>
                </a:lnTo>
                <a:lnTo>
                  <a:pt x="809498" y="13970"/>
                </a:lnTo>
                <a:lnTo>
                  <a:pt x="693801" y="13970"/>
                </a:lnTo>
                <a:lnTo>
                  <a:pt x="693801" y="11430"/>
                </a:lnTo>
                <a:lnTo>
                  <a:pt x="693801" y="10160"/>
                </a:lnTo>
                <a:lnTo>
                  <a:pt x="578231" y="10160"/>
                </a:lnTo>
                <a:lnTo>
                  <a:pt x="578231" y="8890"/>
                </a:lnTo>
                <a:lnTo>
                  <a:pt x="520319" y="8890"/>
                </a:lnTo>
                <a:lnTo>
                  <a:pt x="520319" y="7620"/>
                </a:lnTo>
                <a:lnTo>
                  <a:pt x="520319" y="6350"/>
                </a:lnTo>
                <a:lnTo>
                  <a:pt x="462534" y="6350"/>
                </a:lnTo>
                <a:lnTo>
                  <a:pt x="462534" y="5080"/>
                </a:lnTo>
                <a:lnTo>
                  <a:pt x="462534" y="3810"/>
                </a:lnTo>
                <a:lnTo>
                  <a:pt x="346837" y="3810"/>
                </a:lnTo>
                <a:lnTo>
                  <a:pt x="346837" y="2540"/>
                </a:lnTo>
                <a:lnTo>
                  <a:pt x="231267" y="2540"/>
                </a:lnTo>
                <a:lnTo>
                  <a:pt x="231267" y="1270"/>
                </a:lnTo>
                <a:lnTo>
                  <a:pt x="173482" y="1270"/>
                </a:lnTo>
                <a:lnTo>
                  <a:pt x="173482" y="0"/>
                </a:lnTo>
                <a:lnTo>
                  <a:pt x="0" y="0"/>
                </a:lnTo>
                <a:lnTo>
                  <a:pt x="0" y="1270"/>
                </a:lnTo>
                <a:lnTo>
                  <a:pt x="0" y="2540"/>
                </a:lnTo>
                <a:lnTo>
                  <a:pt x="0" y="3810"/>
                </a:lnTo>
                <a:lnTo>
                  <a:pt x="0" y="5080"/>
                </a:lnTo>
                <a:lnTo>
                  <a:pt x="57785" y="5080"/>
                </a:lnTo>
                <a:lnTo>
                  <a:pt x="57785" y="6350"/>
                </a:lnTo>
                <a:lnTo>
                  <a:pt x="57785" y="7620"/>
                </a:lnTo>
                <a:lnTo>
                  <a:pt x="115570" y="7620"/>
                </a:lnTo>
                <a:lnTo>
                  <a:pt x="115570" y="8890"/>
                </a:lnTo>
                <a:lnTo>
                  <a:pt x="115570" y="10160"/>
                </a:lnTo>
                <a:lnTo>
                  <a:pt x="115570" y="11430"/>
                </a:lnTo>
                <a:lnTo>
                  <a:pt x="173482" y="11430"/>
                </a:lnTo>
                <a:lnTo>
                  <a:pt x="173482" y="13970"/>
                </a:lnTo>
                <a:lnTo>
                  <a:pt x="231267" y="13970"/>
                </a:lnTo>
                <a:lnTo>
                  <a:pt x="231267" y="16510"/>
                </a:lnTo>
                <a:lnTo>
                  <a:pt x="289052" y="16510"/>
                </a:lnTo>
                <a:lnTo>
                  <a:pt x="289052" y="17780"/>
                </a:lnTo>
                <a:lnTo>
                  <a:pt x="346837" y="17780"/>
                </a:lnTo>
                <a:lnTo>
                  <a:pt x="346837" y="20320"/>
                </a:lnTo>
                <a:lnTo>
                  <a:pt x="462534" y="20320"/>
                </a:lnTo>
                <a:lnTo>
                  <a:pt x="462534" y="22860"/>
                </a:lnTo>
                <a:lnTo>
                  <a:pt x="462534" y="24130"/>
                </a:lnTo>
                <a:lnTo>
                  <a:pt x="520319" y="24130"/>
                </a:lnTo>
                <a:lnTo>
                  <a:pt x="520319" y="26670"/>
                </a:lnTo>
                <a:lnTo>
                  <a:pt x="520319" y="27940"/>
                </a:lnTo>
                <a:lnTo>
                  <a:pt x="520319" y="30480"/>
                </a:lnTo>
                <a:lnTo>
                  <a:pt x="578231" y="30480"/>
                </a:lnTo>
                <a:lnTo>
                  <a:pt x="578231" y="31750"/>
                </a:lnTo>
                <a:lnTo>
                  <a:pt x="693801" y="31750"/>
                </a:lnTo>
                <a:lnTo>
                  <a:pt x="693801" y="34290"/>
                </a:lnTo>
                <a:lnTo>
                  <a:pt x="693801" y="36830"/>
                </a:lnTo>
                <a:lnTo>
                  <a:pt x="751586" y="36830"/>
                </a:lnTo>
                <a:lnTo>
                  <a:pt x="751586" y="38100"/>
                </a:lnTo>
                <a:lnTo>
                  <a:pt x="1329817" y="38100"/>
                </a:lnTo>
                <a:lnTo>
                  <a:pt x="1329817" y="36830"/>
                </a:lnTo>
                <a:lnTo>
                  <a:pt x="1329817" y="34290"/>
                </a:lnTo>
                <a:close/>
              </a:path>
            </a:pathLst>
          </a:custGeom>
          <a:solidFill>
            <a:srgbClr val="DFD625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3" name="bg object 33"/>
          <p:cNvSpPr/>
          <p:nvPr/>
        </p:nvSpPr>
        <p:spPr>
          <a:xfrm>
            <a:off x="4738624" y="918209"/>
            <a:ext cx="10639425" cy="919480"/>
          </a:xfrm>
          <a:custGeom>
            <a:avLst/>
            <a:gdLst/>
            <a:ahLst/>
            <a:cxnLst/>
            <a:rect l="l" t="t" r="r" b="b"/>
            <a:pathLst>
              <a:path w="10639425" h="919480">
                <a:moveTo>
                  <a:pt x="2659761" y="58420"/>
                </a:moveTo>
                <a:lnTo>
                  <a:pt x="2544064" y="58420"/>
                </a:lnTo>
                <a:lnTo>
                  <a:pt x="2544064" y="53340"/>
                </a:lnTo>
                <a:lnTo>
                  <a:pt x="2544064" y="45720"/>
                </a:lnTo>
                <a:lnTo>
                  <a:pt x="2486279" y="45720"/>
                </a:lnTo>
                <a:lnTo>
                  <a:pt x="2486279" y="40640"/>
                </a:lnTo>
                <a:lnTo>
                  <a:pt x="2486279" y="39370"/>
                </a:lnTo>
                <a:lnTo>
                  <a:pt x="2370582" y="39370"/>
                </a:lnTo>
                <a:lnTo>
                  <a:pt x="2370582" y="34290"/>
                </a:lnTo>
                <a:lnTo>
                  <a:pt x="2370582" y="29210"/>
                </a:lnTo>
                <a:lnTo>
                  <a:pt x="2370582" y="26670"/>
                </a:lnTo>
                <a:lnTo>
                  <a:pt x="2139315" y="26670"/>
                </a:lnTo>
                <a:lnTo>
                  <a:pt x="2139315" y="22860"/>
                </a:lnTo>
                <a:lnTo>
                  <a:pt x="2139315" y="20320"/>
                </a:lnTo>
                <a:lnTo>
                  <a:pt x="1908048" y="20320"/>
                </a:lnTo>
                <a:lnTo>
                  <a:pt x="1908048" y="16510"/>
                </a:lnTo>
                <a:lnTo>
                  <a:pt x="1908048" y="15240"/>
                </a:lnTo>
                <a:lnTo>
                  <a:pt x="1792478" y="15240"/>
                </a:lnTo>
                <a:lnTo>
                  <a:pt x="1792478" y="11430"/>
                </a:lnTo>
                <a:lnTo>
                  <a:pt x="1792478" y="8890"/>
                </a:lnTo>
                <a:lnTo>
                  <a:pt x="1676781" y="8890"/>
                </a:lnTo>
                <a:lnTo>
                  <a:pt x="1676781" y="3810"/>
                </a:lnTo>
                <a:lnTo>
                  <a:pt x="1387729" y="3810"/>
                </a:lnTo>
                <a:lnTo>
                  <a:pt x="1387729" y="0"/>
                </a:lnTo>
                <a:lnTo>
                  <a:pt x="0" y="0"/>
                </a:lnTo>
                <a:lnTo>
                  <a:pt x="0" y="3810"/>
                </a:lnTo>
                <a:lnTo>
                  <a:pt x="0" y="8890"/>
                </a:lnTo>
                <a:lnTo>
                  <a:pt x="0" y="11430"/>
                </a:lnTo>
                <a:lnTo>
                  <a:pt x="57785" y="11430"/>
                </a:lnTo>
                <a:lnTo>
                  <a:pt x="57785" y="15240"/>
                </a:lnTo>
                <a:lnTo>
                  <a:pt x="57785" y="16510"/>
                </a:lnTo>
                <a:lnTo>
                  <a:pt x="115570" y="16510"/>
                </a:lnTo>
                <a:lnTo>
                  <a:pt x="115570" y="20320"/>
                </a:lnTo>
                <a:lnTo>
                  <a:pt x="115570" y="22860"/>
                </a:lnTo>
                <a:lnTo>
                  <a:pt x="173482" y="22860"/>
                </a:lnTo>
                <a:lnTo>
                  <a:pt x="173482" y="26670"/>
                </a:lnTo>
                <a:lnTo>
                  <a:pt x="173482" y="29210"/>
                </a:lnTo>
                <a:lnTo>
                  <a:pt x="289052" y="29210"/>
                </a:lnTo>
                <a:lnTo>
                  <a:pt x="289052" y="34290"/>
                </a:lnTo>
                <a:lnTo>
                  <a:pt x="346837" y="34290"/>
                </a:lnTo>
                <a:lnTo>
                  <a:pt x="346837" y="39370"/>
                </a:lnTo>
                <a:lnTo>
                  <a:pt x="346837" y="40640"/>
                </a:lnTo>
                <a:lnTo>
                  <a:pt x="404749" y="40640"/>
                </a:lnTo>
                <a:lnTo>
                  <a:pt x="404749" y="45720"/>
                </a:lnTo>
                <a:lnTo>
                  <a:pt x="404749" y="53340"/>
                </a:lnTo>
                <a:lnTo>
                  <a:pt x="578231" y="53340"/>
                </a:lnTo>
                <a:lnTo>
                  <a:pt x="578231" y="58420"/>
                </a:lnTo>
                <a:lnTo>
                  <a:pt x="578231" y="66040"/>
                </a:lnTo>
                <a:lnTo>
                  <a:pt x="636016" y="66040"/>
                </a:lnTo>
                <a:lnTo>
                  <a:pt x="636016" y="72390"/>
                </a:lnTo>
                <a:lnTo>
                  <a:pt x="751586" y="72390"/>
                </a:lnTo>
                <a:lnTo>
                  <a:pt x="751586" y="78740"/>
                </a:lnTo>
                <a:lnTo>
                  <a:pt x="925068" y="78740"/>
                </a:lnTo>
                <a:lnTo>
                  <a:pt x="925068" y="85090"/>
                </a:lnTo>
                <a:lnTo>
                  <a:pt x="2659761" y="85090"/>
                </a:lnTo>
                <a:lnTo>
                  <a:pt x="2659761" y="78740"/>
                </a:lnTo>
                <a:lnTo>
                  <a:pt x="2659761" y="72390"/>
                </a:lnTo>
                <a:lnTo>
                  <a:pt x="2659761" y="66040"/>
                </a:lnTo>
                <a:lnTo>
                  <a:pt x="2659761" y="58420"/>
                </a:lnTo>
                <a:close/>
              </a:path>
              <a:path w="10639425" h="919480">
                <a:moveTo>
                  <a:pt x="10639171" y="355600"/>
                </a:moveTo>
                <a:lnTo>
                  <a:pt x="9424797" y="355600"/>
                </a:lnTo>
                <a:lnTo>
                  <a:pt x="9424797" y="341630"/>
                </a:lnTo>
                <a:lnTo>
                  <a:pt x="8441931" y="341630"/>
                </a:lnTo>
                <a:lnTo>
                  <a:pt x="8441931" y="340360"/>
                </a:lnTo>
                <a:lnTo>
                  <a:pt x="8441931" y="327660"/>
                </a:lnTo>
                <a:lnTo>
                  <a:pt x="8441931" y="321310"/>
                </a:lnTo>
                <a:lnTo>
                  <a:pt x="6649466" y="321310"/>
                </a:lnTo>
                <a:lnTo>
                  <a:pt x="6649466" y="314960"/>
                </a:lnTo>
                <a:lnTo>
                  <a:pt x="6649466" y="303530"/>
                </a:lnTo>
                <a:lnTo>
                  <a:pt x="6533769" y="303530"/>
                </a:lnTo>
                <a:lnTo>
                  <a:pt x="6533769" y="293370"/>
                </a:lnTo>
                <a:lnTo>
                  <a:pt x="6533769" y="287020"/>
                </a:lnTo>
                <a:lnTo>
                  <a:pt x="5955538" y="287020"/>
                </a:lnTo>
                <a:lnTo>
                  <a:pt x="5955538" y="271780"/>
                </a:lnTo>
                <a:lnTo>
                  <a:pt x="5897753" y="271780"/>
                </a:lnTo>
                <a:lnTo>
                  <a:pt x="5897753" y="270510"/>
                </a:lnTo>
                <a:lnTo>
                  <a:pt x="5897753" y="256540"/>
                </a:lnTo>
                <a:lnTo>
                  <a:pt x="5782056" y="256540"/>
                </a:lnTo>
                <a:lnTo>
                  <a:pt x="5782056" y="250190"/>
                </a:lnTo>
                <a:lnTo>
                  <a:pt x="5782056" y="242570"/>
                </a:lnTo>
                <a:lnTo>
                  <a:pt x="5666486" y="242570"/>
                </a:lnTo>
                <a:lnTo>
                  <a:pt x="5666486" y="228600"/>
                </a:lnTo>
                <a:lnTo>
                  <a:pt x="5608701" y="228600"/>
                </a:lnTo>
                <a:lnTo>
                  <a:pt x="5608701" y="214630"/>
                </a:lnTo>
                <a:lnTo>
                  <a:pt x="5493004" y="214630"/>
                </a:lnTo>
                <a:lnTo>
                  <a:pt x="5493004" y="213360"/>
                </a:lnTo>
                <a:lnTo>
                  <a:pt x="5493004" y="201930"/>
                </a:lnTo>
                <a:lnTo>
                  <a:pt x="5088255" y="201930"/>
                </a:lnTo>
                <a:lnTo>
                  <a:pt x="5088255" y="194310"/>
                </a:lnTo>
                <a:lnTo>
                  <a:pt x="5088255" y="190500"/>
                </a:lnTo>
                <a:lnTo>
                  <a:pt x="5030470" y="190500"/>
                </a:lnTo>
                <a:lnTo>
                  <a:pt x="5030470" y="184150"/>
                </a:lnTo>
                <a:lnTo>
                  <a:pt x="5030470" y="179070"/>
                </a:lnTo>
                <a:lnTo>
                  <a:pt x="4972558" y="179070"/>
                </a:lnTo>
                <a:lnTo>
                  <a:pt x="4972558" y="167640"/>
                </a:lnTo>
                <a:lnTo>
                  <a:pt x="4567809" y="167640"/>
                </a:lnTo>
                <a:lnTo>
                  <a:pt x="4567809" y="166370"/>
                </a:lnTo>
                <a:lnTo>
                  <a:pt x="4567809" y="157480"/>
                </a:lnTo>
                <a:lnTo>
                  <a:pt x="4278757" y="157480"/>
                </a:lnTo>
                <a:lnTo>
                  <a:pt x="4278757" y="149860"/>
                </a:lnTo>
                <a:lnTo>
                  <a:pt x="4278757" y="147320"/>
                </a:lnTo>
                <a:lnTo>
                  <a:pt x="3874008" y="147320"/>
                </a:lnTo>
                <a:lnTo>
                  <a:pt x="3874008" y="142240"/>
                </a:lnTo>
                <a:lnTo>
                  <a:pt x="3874008" y="139700"/>
                </a:lnTo>
                <a:lnTo>
                  <a:pt x="3642741" y="139700"/>
                </a:lnTo>
                <a:lnTo>
                  <a:pt x="3642741" y="134620"/>
                </a:lnTo>
                <a:lnTo>
                  <a:pt x="3642741" y="130810"/>
                </a:lnTo>
                <a:lnTo>
                  <a:pt x="3469259" y="130810"/>
                </a:lnTo>
                <a:lnTo>
                  <a:pt x="3469259" y="127000"/>
                </a:lnTo>
                <a:lnTo>
                  <a:pt x="3469259" y="123190"/>
                </a:lnTo>
                <a:lnTo>
                  <a:pt x="3295777" y="123190"/>
                </a:lnTo>
                <a:lnTo>
                  <a:pt x="3295777" y="120650"/>
                </a:lnTo>
                <a:lnTo>
                  <a:pt x="3295777" y="115570"/>
                </a:lnTo>
                <a:lnTo>
                  <a:pt x="3180080" y="115570"/>
                </a:lnTo>
                <a:lnTo>
                  <a:pt x="3180080" y="113030"/>
                </a:lnTo>
                <a:lnTo>
                  <a:pt x="3180080" y="105410"/>
                </a:lnTo>
                <a:lnTo>
                  <a:pt x="3180080" y="99060"/>
                </a:lnTo>
                <a:lnTo>
                  <a:pt x="2948813" y="99060"/>
                </a:lnTo>
                <a:lnTo>
                  <a:pt x="2948813" y="85598"/>
                </a:lnTo>
                <a:lnTo>
                  <a:pt x="982980" y="85598"/>
                </a:lnTo>
                <a:lnTo>
                  <a:pt x="982980" y="99568"/>
                </a:lnTo>
                <a:lnTo>
                  <a:pt x="1040765" y="99568"/>
                </a:lnTo>
                <a:lnTo>
                  <a:pt x="1040765" y="105410"/>
                </a:lnTo>
                <a:lnTo>
                  <a:pt x="1156335" y="105410"/>
                </a:lnTo>
                <a:lnTo>
                  <a:pt x="1156335" y="113030"/>
                </a:lnTo>
                <a:lnTo>
                  <a:pt x="1214247" y="113030"/>
                </a:lnTo>
                <a:lnTo>
                  <a:pt x="1214247" y="115570"/>
                </a:lnTo>
                <a:lnTo>
                  <a:pt x="1214247" y="120650"/>
                </a:lnTo>
                <a:lnTo>
                  <a:pt x="1329817" y="120650"/>
                </a:lnTo>
                <a:lnTo>
                  <a:pt x="1329817" y="123190"/>
                </a:lnTo>
                <a:lnTo>
                  <a:pt x="1329817" y="127000"/>
                </a:lnTo>
                <a:lnTo>
                  <a:pt x="1387729" y="127000"/>
                </a:lnTo>
                <a:lnTo>
                  <a:pt x="1387729" y="130810"/>
                </a:lnTo>
                <a:lnTo>
                  <a:pt x="1387729" y="134620"/>
                </a:lnTo>
                <a:lnTo>
                  <a:pt x="1676781" y="134620"/>
                </a:lnTo>
                <a:lnTo>
                  <a:pt x="1676781" y="139700"/>
                </a:lnTo>
                <a:lnTo>
                  <a:pt x="1676781" y="142240"/>
                </a:lnTo>
                <a:lnTo>
                  <a:pt x="1792478" y="142240"/>
                </a:lnTo>
                <a:lnTo>
                  <a:pt x="1792478" y="147320"/>
                </a:lnTo>
                <a:lnTo>
                  <a:pt x="1792478" y="149860"/>
                </a:lnTo>
                <a:lnTo>
                  <a:pt x="1908048" y="149860"/>
                </a:lnTo>
                <a:lnTo>
                  <a:pt x="1908048" y="157480"/>
                </a:lnTo>
                <a:lnTo>
                  <a:pt x="2139315" y="157480"/>
                </a:lnTo>
                <a:lnTo>
                  <a:pt x="2139315" y="166370"/>
                </a:lnTo>
                <a:lnTo>
                  <a:pt x="2370582" y="166370"/>
                </a:lnTo>
                <a:lnTo>
                  <a:pt x="2370582" y="167640"/>
                </a:lnTo>
                <a:lnTo>
                  <a:pt x="2370582" y="179070"/>
                </a:lnTo>
                <a:lnTo>
                  <a:pt x="2370582" y="184150"/>
                </a:lnTo>
                <a:lnTo>
                  <a:pt x="2486279" y="184150"/>
                </a:lnTo>
                <a:lnTo>
                  <a:pt x="2486279" y="190500"/>
                </a:lnTo>
                <a:lnTo>
                  <a:pt x="2486279" y="194310"/>
                </a:lnTo>
                <a:lnTo>
                  <a:pt x="2544064" y="194310"/>
                </a:lnTo>
                <a:lnTo>
                  <a:pt x="2544064" y="201930"/>
                </a:lnTo>
                <a:lnTo>
                  <a:pt x="2544064" y="213360"/>
                </a:lnTo>
                <a:lnTo>
                  <a:pt x="2659761" y="213360"/>
                </a:lnTo>
                <a:lnTo>
                  <a:pt x="2659761" y="214630"/>
                </a:lnTo>
                <a:lnTo>
                  <a:pt x="2659761" y="228600"/>
                </a:lnTo>
                <a:lnTo>
                  <a:pt x="2659761" y="242570"/>
                </a:lnTo>
                <a:lnTo>
                  <a:pt x="2659761" y="250190"/>
                </a:lnTo>
                <a:lnTo>
                  <a:pt x="2948813" y="250190"/>
                </a:lnTo>
                <a:lnTo>
                  <a:pt x="2948813" y="256540"/>
                </a:lnTo>
                <a:lnTo>
                  <a:pt x="2948813" y="270510"/>
                </a:lnTo>
                <a:lnTo>
                  <a:pt x="3180080" y="270510"/>
                </a:lnTo>
                <a:lnTo>
                  <a:pt x="3180080" y="271780"/>
                </a:lnTo>
                <a:lnTo>
                  <a:pt x="3180080" y="287020"/>
                </a:lnTo>
                <a:lnTo>
                  <a:pt x="3180080" y="293370"/>
                </a:lnTo>
                <a:lnTo>
                  <a:pt x="3295777" y="293370"/>
                </a:lnTo>
                <a:lnTo>
                  <a:pt x="3295777" y="303530"/>
                </a:lnTo>
                <a:lnTo>
                  <a:pt x="3469259" y="303530"/>
                </a:lnTo>
                <a:lnTo>
                  <a:pt x="3469259" y="314960"/>
                </a:lnTo>
                <a:lnTo>
                  <a:pt x="3642741" y="314960"/>
                </a:lnTo>
                <a:lnTo>
                  <a:pt x="3642741" y="321310"/>
                </a:lnTo>
                <a:lnTo>
                  <a:pt x="3642741" y="327660"/>
                </a:lnTo>
                <a:lnTo>
                  <a:pt x="3874008" y="327660"/>
                </a:lnTo>
                <a:lnTo>
                  <a:pt x="3874008" y="340360"/>
                </a:lnTo>
                <a:lnTo>
                  <a:pt x="4278757" y="340360"/>
                </a:lnTo>
                <a:lnTo>
                  <a:pt x="4278757" y="341630"/>
                </a:lnTo>
                <a:lnTo>
                  <a:pt x="4278757" y="355600"/>
                </a:lnTo>
                <a:lnTo>
                  <a:pt x="4567809" y="355600"/>
                </a:lnTo>
                <a:lnTo>
                  <a:pt x="4567809" y="370840"/>
                </a:lnTo>
                <a:lnTo>
                  <a:pt x="4972558" y="370840"/>
                </a:lnTo>
                <a:lnTo>
                  <a:pt x="4972558" y="388620"/>
                </a:lnTo>
                <a:lnTo>
                  <a:pt x="5030470" y="388620"/>
                </a:lnTo>
                <a:lnTo>
                  <a:pt x="5030470" y="407670"/>
                </a:lnTo>
                <a:lnTo>
                  <a:pt x="5088255" y="407670"/>
                </a:lnTo>
                <a:lnTo>
                  <a:pt x="5088255" y="426720"/>
                </a:lnTo>
                <a:lnTo>
                  <a:pt x="5493004" y="426720"/>
                </a:lnTo>
                <a:lnTo>
                  <a:pt x="5493004" y="447040"/>
                </a:lnTo>
                <a:lnTo>
                  <a:pt x="5608701" y="447040"/>
                </a:lnTo>
                <a:lnTo>
                  <a:pt x="5608701" y="469900"/>
                </a:lnTo>
                <a:lnTo>
                  <a:pt x="5666486" y="469900"/>
                </a:lnTo>
                <a:lnTo>
                  <a:pt x="5666486" y="492760"/>
                </a:lnTo>
                <a:lnTo>
                  <a:pt x="5782056" y="492760"/>
                </a:lnTo>
                <a:lnTo>
                  <a:pt x="5782056" y="516890"/>
                </a:lnTo>
                <a:lnTo>
                  <a:pt x="5897753" y="516890"/>
                </a:lnTo>
                <a:lnTo>
                  <a:pt x="5897753" y="541020"/>
                </a:lnTo>
                <a:lnTo>
                  <a:pt x="5955538" y="541020"/>
                </a:lnTo>
                <a:lnTo>
                  <a:pt x="5955538" y="565150"/>
                </a:lnTo>
                <a:lnTo>
                  <a:pt x="6533769" y="565150"/>
                </a:lnTo>
                <a:lnTo>
                  <a:pt x="6533769" y="595630"/>
                </a:lnTo>
                <a:lnTo>
                  <a:pt x="6649466" y="595630"/>
                </a:lnTo>
                <a:lnTo>
                  <a:pt x="6649466" y="628650"/>
                </a:lnTo>
                <a:lnTo>
                  <a:pt x="8441931" y="628650"/>
                </a:lnTo>
                <a:lnTo>
                  <a:pt x="8441931" y="731520"/>
                </a:lnTo>
                <a:lnTo>
                  <a:pt x="9424797" y="731520"/>
                </a:lnTo>
                <a:lnTo>
                  <a:pt x="9424797" y="919480"/>
                </a:lnTo>
                <a:lnTo>
                  <a:pt x="10639171" y="919480"/>
                </a:lnTo>
                <a:lnTo>
                  <a:pt x="10639171" y="731520"/>
                </a:lnTo>
                <a:lnTo>
                  <a:pt x="10639171" y="628650"/>
                </a:lnTo>
                <a:lnTo>
                  <a:pt x="10639171" y="370840"/>
                </a:lnTo>
                <a:lnTo>
                  <a:pt x="10639171" y="355600"/>
                </a:lnTo>
                <a:close/>
              </a:path>
            </a:pathLst>
          </a:custGeom>
          <a:solidFill>
            <a:srgbClr val="4DCE6B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4" name="bg object 34"/>
          <p:cNvSpPr/>
          <p:nvPr/>
        </p:nvSpPr>
        <p:spPr>
          <a:xfrm>
            <a:off x="1327150" y="722629"/>
            <a:ext cx="4799330" cy="199390"/>
          </a:xfrm>
          <a:custGeom>
            <a:avLst/>
            <a:gdLst/>
            <a:ahLst/>
            <a:cxnLst/>
            <a:rect l="l" t="t" r="r" b="b"/>
            <a:pathLst>
              <a:path w="4799330" h="199390">
                <a:moveTo>
                  <a:pt x="2833243" y="74930"/>
                </a:moveTo>
                <a:lnTo>
                  <a:pt x="2544064" y="74930"/>
                </a:lnTo>
                <a:lnTo>
                  <a:pt x="2544064" y="73660"/>
                </a:lnTo>
                <a:lnTo>
                  <a:pt x="2544064" y="71120"/>
                </a:lnTo>
                <a:lnTo>
                  <a:pt x="2370709" y="71120"/>
                </a:lnTo>
                <a:lnTo>
                  <a:pt x="2370709" y="69850"/>
                </a:lnTo>
                <a:lnTo>
                  <a:pt x="2370709" y="66040"/>
                </a:lnTo>
                <a:lnTo>
                  <a:pt x="2370709" y="64770"/>
                </a:lnTo>
                <a:lnTo>
                  <a:pt x="2312797" y="64770"/>
                </a:lnTo>
                <a:lnTo>
                  <a:pt x="2312797" y="62230"/>
                </a:lnTo>
                <a:lnTo>
                  <a:pt x="2139315" y="62230"/>
                </a:lnTo>
                <a:lnTo>
                  <a:pt x="2139315" y="58420"/>
                </a:lnTo>
                <a:lnTo>
                  <a:pt x="1908048" y="58420"/>
                </a:lnTo>
                <a:lnTo>
                  <a:pt x="1908048" y="55880"/>
                </a:lnTo>
                <a:lnTo>
                  <a:pt x="1850263" y="55880"/>
                </a:lnTo>
                <a:lnTo>
                  <a:pt x="1850263" y="53340"/>
                </a:lnTo>
                <a:lnTo>
                  <a:pt x="1792478" y="53340"/>
                </a:lnTo>
                <a:lnTo>
                  <a:pt x="1792478" y="49530"/>
                </a:lnTo>
                <a:lnTo>
                  <a:pt x="1792478" y="46990"/>
                </a:lnTo>
                <a:lnTo>
                  <a:pt x="1618996" y="46990"/>
                </a:lnTo>
                <a:lnTo>
                  <a:pt x="1618996" y="45720"/>
                </a:lnTo>
                <a:lnTo>
                  <a:pt x="1618996" y="44450"/>
                </a:lnTo>
                <a:lnTo>
                  <a:pt x="1561084" y="44450"/>
                </a:lnTo>
                <a:lnTo>
                  <a:pt x="1561084" y="41910"/>
                </a:lnTo>
                <a:lnTo>
                  <a:pt x="1503299" y="41910"/>
                </a:lnTo>
                <a:lnTo>
                  <a:pt x="1503299" y="33020"/>
                </a:lnTo>
                <a:lnTo>
                  <a:pt x="1387729" y="33020"/>
                </a:lnTo>
                <a:lnTo>
                  <a:pt x="1387729" y="30480"/>
                </a:lnTo>
                <a:lnTo>
                  <a:pt x="1272032" y="30480"/>
                </a:lnTo>
                <a:lnTo>
                  <a:pt x="1272032" y="29210"/>
                </a:lnTo>
                <a:lnTo>
                  <a:pt x="1272032" y="27940"/>
                </a:lnTo>
                <a:lnTo>
                  <a:pt x="1040765" y="27940"/>
                </a:lnTo>
                <a:lnTo>
                  <a:pt x="1040765" y="25400"/>
                </a:lnTo>
                <a:lnTo>
                  <a:pt x="867283" y="25400"/>
                </a:lnTo>
                <a:lnTo>
                  <a:pt x="867283" y="24130"/>
                </a:lnTo>
                <a:lnTo>
                  <a:pt x="867283" y="22860"/>
                </a:lnTo>
                <a:lnTo>
                  <a:pt x="809498" y="22860"/>
                </a:lnTo>
                <a:lnTo>
                  <a:pt x="809498" y="20320"/>
                </a:lnTo>
                <a:lnTo>
                  <a:pt x="636016" y="20320"/>
                </a:lnTo>
                <a:lnTo>
                  <a:pt x="636016" y="15240"/>
                </a:lnTo>
                <a:lnTo>
                  <a:pt x="636016" y="11430"/>
                </a:lnTo>
                <a:lnTo>
                  <a:pt x="578231" y="11430"/>
                </a:lnTo>
                <a:lnTo>
                  <a:pt x="578231" y="10160"/>
                </a:lnTo>
                <a:lnTo>
                  <a:pt x="520319" y="10160"/>
                </a:lnTo>
                <a:lnTo>
                  <a:pt x="520319" y="8890"/>
                </a:lnTo>
                <a:lnTo>
                  <a:pt x="520319" y="7620"/>
                </a:lnTo>
                <a:lnTo>
                  <a:pt x="404749" y="7620"/>
                </a:lnTo>
                <a:lnTo>
                  <a:pt x="404749" y="2540"/>
                </a:lnTo>
                <a:lnTo>
                  <a:pt x="346837" y="2540"/>
                </a:lnTo>
                <a:lnTo>
                  <a:pt x="346837" y="0"/>
                </a:lnTo>
                <a:lnTo>
                  <a:pt x="0" y="0"/>
                </a:lnTo>
                <a:lnTo>
                  <a:pt x="0" y="2540"/>
                </a:lnTo>
                <a:lnTo>
                  <a:pt x="0" y="7620"/>
                </a:lnTo>
                <a:lnTo>
                  <a:pt x="0" y="8890"/>
                </a:lnTo>
                <a:lnTo>
                  <a:pt x="57785" y="8890"/>
                </a:lnTo>
                <a:lnTo>
                  <a:pt x="57785" y="10160"/>
                </a:lnTo>
                <a:lnTo>
                  <a:pt x="57785" y="11430"/>
                </a:lnTo>
                <a:lnTo>
                  <a:pt x="57785" y="15240"/>
                </a:lnTo>
                <a:lnTo>
                  <a:pt x="115570" y="15240"/>
                </a:lnTo>
                <a:lnTo>
                  <a:pt x="115570" y="20320"/>
                </a:lnTo>
                <a:lnTo>
                  <a:pt x="173482" y="20320"/>
                </a:lnTo>
                <a:lnTo>
                  <a:pt x="173482" y="22860"/>
                </a:lnTo>
                <a:lnTo>
                  <a:pt x="173482" y="24130"/>
                </a:lnTo>
                <a:lnTo>
                  <a:pt x="346837" y="24130"/>
                </a:lnTo>
                <a:lnTo>
                  <a:pt x="346837" y="25400"/>
                </a:lnTo>
                <a:lnTo>
                  <a:pt x="346837" y="27940"/>
                </a:lnTo>
                <a:lnTo>
                  <a:pt x="346837" y="29210"/>
                </a:lnTo>
                <a:lnTo>
                  <a:pt x="404749" y="29210"/>
                </a:lnTo>
                <a:lnTo>
                  <a:pt x="404749" y="30480"/>
                </a:lnTo>
                <a:lnTo>
                  <a:pt x="404749" y="33020"/>
                </a:lnTo>
                <a:lnTo>
                  <a:pt x="404749" y="41910"/>
                </a:lnTo>
                <a:lnTo>
                  <a:pt x="520319" y="41910"/>
                </a:lnTo>
                <a:lnTo>
                  <a:pt x="520319" y="44450"/>
                </a:lnTo>
                <a:lnTo>
                  <a:pt x="520319" y="45720"/>
                </a:lnTo>
                <a:lnTo>
                  <a:pt x="578231" y="45720"/>
                </a:lnTo>
                <a:lnTo>
                  <a:pt x="578231" y="46990"/>
                </a:lnTo>
                <a:lnTo>
                  <a:pt x="578231" y="49530"/>
                </a:lnTo>
                <a:lnTo>
                  <a:pt x="636016" y="49530"/>
                </a:lnTo>
                <a:lnTo>
                  <a:pt x="636016" y="66040"/>
                </a:lnTo>
                <a:lnTo>
                  <a:pt x="809498" y="66040"/>
                </a:lnTo>
                <a:lnTo>
                  <a:pt x="809498" y="69850"/>
                </a:lnTo>
                <a:lnTo>
                  <a:pt x="867283" y="69850"/>
                </a:lnTo>
                <a:lnTo>
                  <a:pt x="867283" y="71120"/>
                </a:lnTo>
                <a:lnTo>
                  <a:pt x="867283" y="73660"/>
                </a:lnTo>
                <a:lnTo>
                  <a:pt x="1040765" y="73660"/>
                </a:lnTo>
                <a:lnTo>
                  <a:pt x="1040765" y="74930"/>
                </a:lnTo>
                <a:lnTo>
                  <a:pt x="1040765" y="78740"/>
                </a:lnTo>
                <a:lnTo>
                  <a:pt x="1272032" y="78740"/>
                </a:lnTo>
                <a:lnTo>
                  <a:pt x="1272032" y="82550"/>
                </a:lnTo>
                <a:lnTo>
                  <a:pt x="2833243" y="82550"/>
                </a:lnTo>
                <a:lnTo>
                  <a:pt x="2833243" y="78740"/>
                </a:lnTo>
                <a:lnTo>
                  <a:pt x="2833243" y="74930"/>
                </a:lnTo>
                <a:close/>
              </a:path>
              <a:path w="4799330" h="199390">
                <a:moveTo>
                  <a:pt x="3295777" y="96520"/>
                </a:moveTo>
                <a:lnTo>
                  <a:pt x="3237992" y="96520"/>
                </a:lnTo>
                <a:lnTo>
                  <a:pt x="3237992" y="92710"/>
                </a:lnTo>
                <a:lnTo>
                  <a:pt x="3180207" y="92710"/>
                </a:lnTo>
                <a:lnTo>
                  <a:pt x="3180207" y="88900"/>
                </a:lnTo>
                <a:lnTo>
                  <a:pt x="3064510" y="88900"/>
                </a:lnTo>
                <a:lnTo>
                  <a:pt x="3064510" y="86360"/>
                </a:lnTo>
                <a:lnTo>
                  <a:pt x="3006725" y="86360"/>
                </a:lnTo>
                <a:lnTo>
                  <a:pt x="3006725" y="83058"/>
                </a:lnTo>
                <a:lnTo>
                  <a:pt x="1387729" y="83058"/>
                </a:lnTo>
                <a:lnTo>
                  <a:pt x="1387729" y="86868"/>
                </a:lnTo>
                <a:lnTo>
                  <a:pt x="1503299" y="86868"/>
                </a:lnTo>
                <a:lnTo>
                  <a:pt x="1503299" y="88900"/>
                </a:lnTo>
                <a:lnTo>
                  <a:pt x="1503299" y="92710"/>
                </a:lnTo>
                <a:lnTo>
                  <a:pt x="1503299" y="96520"/>
                </a:lnTo>
                <a:lnTo>
                  <a:pt x="1503299" y="100330"/>
                </a:lnTo>
                <a:lnTo>
                  <a:pt x="3295777" y="100330"/>
                </a:lnTo>
                <a:lnTo>
                  <a:pt x="3295777" y="96520"/>
                </a:lnTo>
                <a:close/>
              </a:path>
              <a:path w="4799330" h="199390">
                <a:moveTo>
                  <a:pt x="4452239" y="173990"/>
                </a:moveTo>
                <a:lnTo>
                  <a:pt x="4394454" y="173990"/>
                </a:lnTo>
                <a:lnTo>
                  <a:pt x="4394454" y="172720"/>
                </a:lnTo>
                <a:lnTo>
                  <a:pt x="4394454" y="167640"/>
                </a:lnTo>
                <a:lnTo>
                  <a:pt x="4394454" y="163830"/>
                </a:lnTo>
                <a:lnTo>
                  <a:pt x="4336542" y="163830"/>
                </a:lnTo>
                <a:lnTo>
                  <a:pt x="4336542" y="162560"/>
                </a:lnTo>
                <a:lnTo>
                  <a:pt x="4336542" y="160020"/>
                </a:lnTo>
                <a:lnTo>
                  <a:pt x="4163060" y="160020"/>
                </a:lnTo>
                <a:lnTo>
                  <a:pt x="4163060" y="154940"/>
                </a:lnTo>
                <a:lnTo>
                  <a:pt x="4047490" y="154940"/>
                </a:lnTo>
                <a:lnTo>
                  <a:pt x="4047490" y="152400"/>
                </a:lnTo>
                <a:lnTo>
                  <a:pt x="4047490" y="149860"/>
                </a:lnTo>
                <a:lnTo>
                  <a:pt x="3989705" y="149860"/>
                </a:lnTo>
                <a:lnTo>
                  <a:pt x="3989705" y="147320"/>
                </a:lnTo>
                <a:lnTo>
                  <a:pt x="3989705" y="140970"/>
                </a:lnTo>
                <a:lnTo>
                  <a:pt x="3816223" y="140970"/>
                </a:lnTo>
                <a:lnTo>
                  <a:pt x="3816223" y="137160"/>
                </a:lnTo>
                <a:lnTo>
                  <a:pt x="3816223" y="133350"/>
                </a:lnTo>
                <a:lnTo>
                  <a:pt x="3758311" y="133350"/>
                </a:lnTo>
                <a:lnTo>
                  <a:pt x="3758311" y="132080"/>
                </a:lnTo>
                <a:lnTo>
                  <a:pt x="3758311" y="128270"/>
                </a:lnTo>
                <a:lnTo>
                  <a:pt x="3700526" y="128270"/>
                </a:lnTo>
                <a:lnTo>
                  <a:pt x="3700526" y="127000"/>
                </a:lnTo>
                <a:lnTo>
                  <a:pt x="3700526" y="124460"/>
                </a:lnTo>
                <a:lnTo>
                  <a:pt x="3584956" y="124460"/>
                </a:lnTo>
                <a:lnTo>
                  <a:pt x="3584956" y="123190"/>
                </a:lnTo>
                <a:lnTo>
                  <a:pt x="3584956" y="120650"/>
                </a:lnTo>
                <a:lnTo>
                  <a:pt x="3527044" y="120650"/>
                </a:lnTo>
                <a:lnTo>
                  <a:pt x="3527044" y="118110"/>
                </a:lnTo>
                <a:lnTo>
                  <a:pt x="3527044" y="116840"/>
                </a:lnTo>
                <a:lnTo>
                  <a:pt x="3469259" y="116840"/>
                </a:lnTo>
                <a:lnTo>
                  <a:pt x="3469259" y="111760"/>
                </a:lnTo>
                <a:lnTo>
                  <a:pt x="3411474" y="111760"/>
                </a:lnTo>
                <a:lnTo>
                  <a:pt x="3411474" y="109220"/>
                </a:lnTo>
                <a:lnTo>
                  <a:pt x="3411474" y="104140"/>
                </a:lnTo>
                <a:lnTo>
                  <a:pt x="3353562" y="104140"/>
                </a:lnTo>
                <a:lnTo>
                  <a:pt x="3353562" y="100838"/>
                </a:lnTo>
                <a:lnTo>
                  <a:pt x="1561084" y="100838"/>
                </a:lnTo>
                <a:lnTo>
                  <a:pt x="1561084" y="104648"/>
                </a:lnTo>
                <a:lnTo>
                  <a:pt x="1618996" y="104648"/>
                </a:lnTo>
                <a:lnTo>
                  <a:pt x="1618996" y="109220"/>
                </a:lnTo>
                <a:lnTo>
                  <a:pt x="1792478" y="109220"/>
                </a:lnTo>
                <a:lnTo>
                  <a:pt x="1792478" y="111760"/>
                </a:lnTo>
                <a:lnTo>
                  <a:pt x="1792478" y="116840"/>
                </a:lnTo>
                <a:lnTo>
                  <a:pt x="1792478" y="118110"/>
                </a:lnTo>
                <a:lnTo>
                  <a:pt x="1850263" y="118110"/>
                </a:lnTo>
                <a:lnTo>
                  <a:pt x="1850263" y="120650"/>
                </a:lnTo>
                <a:lnTo>
                  <a:pt x="1850263" y="123190"/>
                </a:lnTo>
                <a:lnTo>
                  <a:pt x="1908048" y="123190"/>
                </a:lnTo>
                <a:lnTo>
                  <a:pt x="1908048" y="124460"/>
                </a:lnTo>
                <a:lnTo>
                  <a:pt x="1908048" y="127000"/>
                </a:lnTo>
                <a:lnTo>
                  <a:pt x="2139315" y="127000"/>
                </a:lnTo>
                <a:lnTo>
                  <a:pt x="2139315" y="128270"/>
                </a:lnTo>
                <a:lnTo>
                  <a:pt x="2139315" y="132080"/>
                </a:lnTo>
                <a:lnTo>
                  <a:pt x="2312797" y="132080"/>
                </a:lnTo>
                <a:lnTo>
                  <a:pt x="2312797" y="133350"/>
                </a:lnTo>
                <a:lnTo>
                  <a:pt x="2312797" y="137160"/>
                </a:lnTo>
                <a:lnTo>
                  <a:pt x="2370709" y="137160"/>
                </a:lnTo>
                <a:lnTo>
                  <a:pt x="2370709" y="140970"/>
                </a:lnTo>
                <a:lnTo>
                  <a:pt x="2370709" y="147320"/>
                </a:lnTo>
                <a:lnTo>
                  <a:pt x="2544064" y="147320"/>
                </a:lnTo>
                <a:lnTo>
                  <a:pt x="2544064" y="149860"/>
                </a:lnTo>
                <a:lnTo>
                  <a:pt x="2544064" y="152400"/>
                </a:lnTo>
                <a:lnTo>
                  <a:pt x="2833243" y="152400"/>
                </a:lnTo>
                <a:lnTo>
                  <a:pt x="2833243" y="154940"/>
                </a:lnTo>
                <a:lnTo>
                  <a:pt x="2833243" y="160020"/>
                </a:lnTo>
                <a:lnTo>
                  <a:pt x="2833243" y="162560"/>
                </a:lnTo>
                <a:lnTo>
                  <a:pt x="3006725" y="162560"/>
                </a:lnTo>
                <a:lnTo>
                  <a:pt x="3006725" y="163830"/>
                </a:lnTo>
                <a:lnTo>
                  <a:pt x="3006725" y="167640"/>
                </a:lnTo>
                <a:lnTo>
                  <a:pt x="3064510" y="167640"/>
                </a:lnTo>
                <a:lnTo>
                  <a:pt x="3064510" y="172720"/>
                </a:lnTo>
                <a:lnTo>
                  <a:pt x="3180207" y="172720"/>
                </a:lnTo>
                <a:lnTo>
                  <a:pt x="3180207" y="173990"/>
                </a:lnTo>
                <a:lnTo>
                  <a:pt x="3180207" y="179070"/>
                </a:lnTo>
                <a:lnTo>
                  <a:pt x="4452239" y="179070"/>
                </a:lnTo>
                <a:lnTo>
                  <a:pt x="4452239" y="173990"/>
                </a:lnTo>
                <a:close/>
              </a:path>
              <a:path w="4799330" h="199390">
                <a:moveTo>
                  <a:pt x="4799203" y="194310"/>
                </a:moveTo>
                <a:lnTo>
                  <a:pt x="4741291" y="194310"/>
                </a:lnTo>
                <a:lnTo>
                  <a:pt x="4741291" y="190500"/>
                </a:lnTo>
                <a:lnTo>
                  <a:pt x="4741291" y="189230"/>
                </a:lnTo>
                <a:lnTo>
                  <a:pt x="4625721" y="189230"/>
                </a:lnTo>
                <a:lnTo>
                  <a:pt x="4625721" y="184150"/>
                </a:lnTo>
                <a:lnTo>
                  <a:pt x="4567809" y="184150"/>
                </a:lnTo>
                <a:lnTo>
                  <a:pt x="4567809" y="179578"/>
                </a:lnTo>
                <a:lnTo>
                  <a:pt x="3237992" y="179578"/>
                </a:lnTo>
                <a:lnTo>
                  <a:pt x="3237992" y="184658"/>
                </a:lnTo>
                <a:lnTo>
                  <a:pt x="3295777" y="184658"/>
                </a:lnTo>
                <a:lnTo>
                  <a:pt x="3295777" y="189230"/>
                </a:lnTo>
                <a:lnTo>
                  <a:pt x="3295777" y="190500"/>
                </a:lnTo>
                <a:lnTo>
                  <a:pt x="3353562" y="190500"/>
                </a:lnTo>
                <a:lnTo>
                  <a:pt x="3353562" y="194310"/>
                </a:lnTo>
                <a:lnTo>
                  <a:pt x="3353562" y="195580"/>
                </a:lnTo>
                <a:lnTo>
                  <a:pt x="3411474" y="195580"/>
                </a:lnTo>
                <a:lnTo>
                  <a:pt x="3411474" y="199390"/>
                </a:lnTo>
                <a:lnTo>
                  <a:pt x="4799203" y="199390"/>
                </a:lnTo>
                <a:lnTo>
                  <a:pt x="4799203" y="195580"/>
                </a:lnTo>
                <a:lnTo>
                  <a:pt x="4799203" y="194310"/>
                </a:lnTo>
                <a:close/>
              </a:path>
            </a:pathLst>
          </a:custGeom>
          <a:solidFill>
            <a:srgbClr val="4DCE6B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5" name="bg object 35"/>
          <p:cNvSpPr/>
          <p:nvPr/>
        </p:nvSpPr>
        <p:spPr>
          <a:xfrm>
            <a:off x="6184138" y="1144269"/>
            <a:ext cx="9367520" cy="716280"/>
          </a:xfrm>
          <a:custGeom>
            <a:avLst/>
            <a:gdLst/>
            <a:ahLst/>
            <a:cxnLst/>
            <a:rect l="l" t="t" r="r" b="b"/>
            <a:pathLst>
              <a:path w="9367519" h="716280">
                <a:moveTo>
                  <a:pt x="9367012" y="297180"/>
                </a:moveTo>
                <a:lnTo>
                  <a:pt x="7690231" y="297180"/>
                </a:lnTo>
                <a:lnTo>
                  <a:pt x="7690231" y="295910"/>
                </a:lnTo>
                <a:lnTo>
                  <a:pt x="7690231" y="287020"/>
                </a:lnTo>
                <a:lnTo>
                  <a:pt x="7690231" y="280670"/>
                </a:lnTo>
                <a:lnTo>
                  <a:pt x="6996417" y="280670"/>
                </a:lnTo>
                <a:lnTo>
                  <a:pt x="6996417" y="279400"/>
                </a:lnTo>
                <a:lnTo>
                  <a:pt x="6996417" y="264160"/>
                </a:lnTo>
                <a:lnTo>
                  <a:pt x="6996417" y="262890"/>
                </a:lnTo>
                <a:lnTo>
                  <a:pt x="6475984" y="262890"/>
                </a:lnTo>
                <a:lnTo>
                  <a:pt x="6475984" y="257810"/>
                </a:lnTo>
                <a:lnTo>
                  <a:pt x="6475984" y="251460"/>
                </a:lnTo>
                <a:lnTo>
                  <a:pt x="6475984" y="246380"/>
                </a:lnTo>
                <a:lnTo>
                  <a:pt x="5435219" y="246380"/>
                </a:lnTo>
                <a:lnTo>
                  <a:pt x="5435219" y="237490"/>
                </a:lnTo>
                <a:lnTo>
                  <a:pt x="5435219" y="233680"/>
                </a:lnTo>
                <a:lnTo>
                  <a:pt x="5261737" y="233680"/>
                </a:lnTo>
                <a:lnTo>
                  <a:pt x="5261737" y="231140"/>
                </a:lnTo>
                <a:lnTo>
                  <a:pt x="5261737" y="224790"/>
                </a:lnTo>
                <a:lnTo>
                  <a:pt x="5261737" y="222250"/>
                </a:lnTo>
                <a:lnTo>
                  <a:pt x="5146040" y="222250"/>
                </a:lnTo>
                <a:lnTo>
                  <a:pt x="5146040" y="212090"/>
                </a:lnTo>
                <a:lnTo>
                  <a:pt x="5146040" y="210820"/>
                </a:lnTo>
                <a:lnTo>
                  <a:pt x="4567936" y="210820"/>
                </a:lnTo>
                <a:lnTo>
                  <a:pt x="4567936" y="200660"/>
                </a:lnTo>
                <a:lnTo>
                  <a:pt x="4452239" y="200660"/>
                </a:lnTo>
                <a:lnTo>
                  <a:pt x="4452239" y="191770"/>
                </a:lnTo>
                <a:lnTo>
                  <a:pt x="4336542" y="191770"/>
                </a:lnTo>
                <a:lnTo>
                  <a:pt x="4336542" y="181610"/>
                </a:lnTo>
                <a:lnTo>
                  <a:pt x="4220972" y="181610"/>
                </a:lnTo>
                <a:lnTo>
                  <a:pt x="4220972" y="165100"/>
                </a:lnTo>
                <a:lnTo>
                  <a:pt x="3989705" y="165100"/>
                </a:lnTo>
                <a:lnTo>
                  <a:pt x="3989705" y="163830"/>
                </a:lnTo>
                <a:lnTo>
                  <a:pt x="3989705" y="158750"/>
                </a:lnTo>
                <a:lnTo>
                  <a:pt x="3989705" y="156210"/>
                </a:lnTo>
                <a:lnTo>
                  <a:pt x="3816223" y="156210"/>
                </a:lnTo>
                <a:lnTo>
                  <a:pt x="3816223" y="147320"/>
                </a:lnTo>
                <a:lnTo>
                  <a:pt x="3816223" y="140970"/>
                </a:lnTo>
                <a:lnTo>
                  <a:pt x="3700526" y="140970"/>
                </a:lnTo>
                <a:lnTo>
                  <a:pt x="3700526" y="135890"/>
                </a:lnTo>
                <a:lnTo>
                  <a:pt x="3700526" y="133350"/>
                </a:lnTo>
                <a:lnTo>
                  <a:pt x="3527044" y="133350"/>
                </a:lnTo>
                <a:lnTo>
                  <a:pt x="3527044" y="129540"/>
                </a:lnTo>
                <a:lnTo>
                  <a:pt x="3527044" y="125730"/>
                </a:lnTo>
                <a:lnTo>
                  <a:pt x="3064510" y="125730"/>
                </a:lnTo>
                <a:lnTo>
                  <a:pt x="3064510" y="119380"/>
                </a:lnTo>
                <a:lnTo>
                  <a:pt x="2891028" y="119380"/>
                </a:lnTo>
                <a:lnTo>
                  <a:pt x="2891028" y="114300"/>
                </a:lnTo>
                <a:lnTo>
                  <a:pt x="2891028" y="113030"/>
                </a:lnTo>
                <a:lnTo>
                  <a:pt x="2775458" y="113030"/>
                </a:lnTo>
                <a:lnTo>
                  <a:pt x="2775458" y="104140"/>
                </a:lnTo>
                <a:lnTo>
                  <a:pt x="2775458" y="102870"/>
                </a:lnTo>
                <a:lnTo>
                  <a:pt x="2717546" y="102870"/>
                </a:lnTo>
                <a:lnTo>
                  <a:pt x="2717546" y="96520"/>
                </a:lnTo>
                <a:lnTo>
                  <a:pt x="2486279" y="96520"/>
                </a:lnTo>
                <a:lnTo>
                  <a:pt x="2486279" y="93980"/>
                </a:lnTo>
                <a:lnTo>
                  <a:pt x="2486279" y="91440"/>
                </a:lnTo>
                <a:lnTo>
                  <a:pt x="2370709" y="91440"/>
                </a:lnTo>
                <a:lnTo>
                  <a:pt x="2370709" y="88900"/>
                </a:lnTo>
                <a:lnTo>
                  <a:pt x="2370709" y="81280"/>
                </a:lnTo>
                <a:lnTo>
                  <a:pt x="2312797" y="81280"/>
                </a:lnTo>
                <a:lnTo>
                  <a:pt x="2312797" y="76200"/>
                </a:lnTo>
                <a:lnTo>
                  <a:pt x="2255012" y="76200"/>
                </a:lnTo>
                <a:lnTo>
                  <a:pt x="2255012" y="73660"/>
                </a:lnTo>
                <a:lnTo>
                  <a:pt x="2255012" y="71120"/>
                </a:lnTo>
                <a:lnTo>
                  <a:pt x="2197227" y="71120"/>
                </a:lnTo>
                <a:lnTo>
                  <a:pt x="2197227" y="69850"/>
                </a:lnTo>
                <a:lnTo>
                  <a:pt x="2197227" y="60960"/>
                </a:lnTo>
                <a:lnTo>
                  <a:pt x="2139315" y="60960"/>
                </a:lnTo>
                <a:lnTo>
                  <a:pt x="2139315" y="59690"/>
                </a:lnTo>
                <a:lnTo>
                  <a:pt x="2139315" y="55880"/>
                </a:lnTo>
                <a:lnTo>
                  <a:pt x="2139315" y="50800"/>
                </a:lnTo>
                <a:lnTo>
                  <a:pt x="2081530" y="50800"/>
                </a:lnTo>
                <a:lnTo>
                  <a:pt x="2081530" y="46990"/>
                </a:lnTo>
                <a:lnTo>
                  <a:pt x="2081530" y="36830"/>
                </a:lnTo>
                <a:lnTo>
                  <a:pt x="2023745" y="36830"/>
                </a:lnTo>
                <a:lnTo>
                  <a:pt x="2023745" y="34290"/>
                </a:lnTo>
                <a:lnTo>
                  <a:pt x="2023745" y="25400"/>
                </a:lnTo>
                <a:lnTo>
                  <a:pt x="2023745" y="22860"/>
                </a:lnTo>
                <a:lnTo>
                  <a:pt x="1965960" y="22860"/>
                </a:lnTo>
                <a:lnTo>
                  <a:pt x="1965960" y="21590"/>
                </a:lnTo>
                <a:lnTo>
                  <a:pt x="1965960" y="17780"/>
                </a:lnTo>
                <a:lnTo>
                  <a:pt x="1908048" y="17780"/>
                </a:lnTo>
                <a:lnTo>
                  <a:pt x="1908048" y="10160"/>
                </a:lnTo>
                <a:lnTo>
                  <a:pt x="1908048" y="8890"/>
                </a:lnTo>
                <a:lnTo>
                  <a:pt x="1850263" y="8890"/>
                </a:lnTo>
                <a:lnTo>
                  <a:pt x="1850263" y="0"/>
                </a:lnTo>
                <a:lnTo>
                  <a:pt x="0" y="0"/>
                </a:lnTo>
                <a:lnTo>
                  <a:pt x="0" y="8890"/>
                </a:lnTo>
                <a:lnTo>
                  <a:pt x="0" y="10160"/>
                </a:lnTo>
                <a:lnTo>
                  <a:pt x="57785" y="10160"/>
                </a:lnTo>
                <a:lnTo>
                  <a:pt x="57785" y="17780"/>
                </a:lnTo>
                <a:lnTo>
                  <a:pt x="115570" y="17780"/>
                </a:lnTo>
                <a:lnTo>
                  <a:pt x="115570" y="21590"/>
                </a:lnTo>
                <a:lnTo>
                  <a:pt x="231267" y="21590"/>
                </a:lnTo>
                <a:lnTo>
                  <a:pt x="231267" y="22860"/>
                </a:lnTo>
                <a:lnTo>
                  <a:pt x="231267" y="25400"/>
                </a:lnTo>
                <a:lnTo>
                  <a:pt x="289052" y="25400"/>
                </a:lnTo>
                <a:lnTo>
                  <a:pt x="289052" y="34290"/>
                </a:lnTo>
                <a:lnTo>
                  <a:pt x="462534" y="34290"/>
                </a:lnTo>
                <a:lnTo>
                  <a:pt x="462534" y="36830"/>
                </a:lnTo>
                <a:lnTo>
                  <a:pt x="462534" y="46990"/>
                </a:lnTo>
                <a:lnTo>
                  <a:pt x="751713" y="46990"/>
                </a:lnTo>
                <a:lnTo>
                  <a:pt x="751713" y="50800"/>
                </a:lnTo>
                <a:lnTo>
                  <a:pt x="751713" y="55880"/>
                </a:lnTo>
                <a:lnTo>
                  <a:pt x="867283" y="55880"/>
                </a:lnTo>
                <a:lnTo>
                  <a:pt x="867283" y="59690"/>
                </a:lnTo>
                <a:lnTo>
                  <a:pt x="925068" y="59690"/>
                </a:lnTo>
                <a:lnTo>
                  <a:pt x="925068" y="60960"/>
                </a:lnTo>
                <a:lnTo>
                  <a:pt x="925068" y="69850"/>
                </a:lnTo>
                <a:lnTo>
                  <a:pt x="982980" y="69850"/>
                </a:lnTo>
                <a:lnTo>
                  <a:pt x="982980" y="71120"/>
                </a:lnTo>
                <a:lnTo>
                  <a:pt x="982980" y="73660"/>
                </a:lnTo>
                <a:lnTo>
                  <a:pt x="1040765" y="73660"/>
                </a:lnTo>
                <a:lnTo>
                  <a:pt x="1040765" y="76200"/>
                </a:lnTo>
                <a:lnTo>
                  <a:pt x="1040765" y="81280"/>
                </a:lnTo>
                <a:lnTo>
                  <a:pt x="1040765" y="88900"/>
                </a:lnTo>
                <a:lnTo>
                  <a:pt x="1098550" y="88900"/>
                </a:lnTo>
                <a:lnTo>
                  <a:pt x="1098550" y="91440"/>
                </a:lnTo>
                <a:lnTo>
                  <a:pt x="1098550" y="93980"/>
                </a:lnTo>
                <a:lnTo>
                  <a:pt x="1156462" y="93980"/>
                </a:lnTo>
                <a:lnTo>
                  <a:pt x="1156462" y="96520"/>
                </a:lnTo>
                <a:lnTo>
                  <a:pt x="1156462" y="102870"/>
                </a:lnTo>
                <a:lnTo>
                  <a:pt x="1156462" y="104140"/>
                </a:lnTo>
                <a:lnTo>
                  <a:pt x="1214247" y="104140"/>
                </a:lnTo>
                <a:lnTo>
                  <a:pt x="1214247" y="113030"/>
                </a:lnTo>
                <a:lnTo>
                  <a:pt x="1214247" y="114300"/>
                </a:lnTo>
                <a:lnTo>
                  <a:pt x="1329817" y="114300"/>
                </a:lnTo>
                <a:lnTo>
                  <a:pt x="1329817" y="119380"/>
                </a:lnTo>
                <a:lnTo>
                  <a:pt x="1387729" y="119380"/>
                </a:lnTo>
                <a:lnTo>
                  <a:pt x="1387729" y="125730"/>
                </a:lnTo>
                <a:lnTo>
                  <a:pt x="1387729" y="129540"/>
                </a:lnTo>
                <a:lnTo>
                  <a:pt x="1676781" y="129540"/>
                </a:lnTo>
                <a:lnTo>
                  <a:pt x="1676781" y="133350"/>
                </a:lnTo>
                <a:lnTo>
                  <a:pt x="1676781" y="135890"/>
                </a:lnTo>
                <a:lnTo>
                  <a:pt x="1850263" y="135890"/>
                </a:lnTo>
                <a:lnTo>
                  <a:pt x="1850263" y="140970"/>
                </a:lnTo>
                <a:lnTo>
                  <a:pt x="1850263" y="147320"/>
                </a:lnTo>
                <a:lnTo>
                  <a:pt x="1908048" y="147320"/>
                </a:lnTo>
                <a:lnTo>
                  <a:pt x="1908048" y="156210"/>
                </a:lnTo>
                <a:lnTo>
                  <a:pt x="1908048" y="158750"/>
                </a:lnTo>
                <a:lnTo>
                  <a:pt x="1965960" y="158750"/>
                </a:lnTo>
                <a:lnTo>
                  <a:pt x="1965960" y="163830"/>
                </a:lnTo>
                <a:lnTo>
                  <a:pt x="2023745" y="163830"/>
                </a:lnTo>
                <a:lnTo>
                  <a:pt x="2023745" y="165100"/>
                </a:lnTo>
                <a:lnTo>
                  <a:pt x="2023745" y="181610"/>
                </a:lnTo>
                <a:lnTo>
                  <a:pt x="2081530" y="181610"/>
                </a:lnTo>
                <a:lnTo>
                  <a:pt x="2081530" y="191770"/>
                </a:lnTo>
                <a:lnTo>
                  <a:pt x="2081530" y="200660"/>
                </a:lnTo>
                <a:lnTo>
                  <a:pt x="2139315" y="200660"/>
                </a:lnTo>
                <a:lnTo>
                  <a:pt x="2139315" y="210820"/>
                </a:lnTo>
                <a:lnTo>
                  <a:pt x="2139315" y="212090"/>
                </a:lnTo>
                <a:lnTo>
                  <a:pt x="2197227" y="212090"/>
                </a:lnTo>
                <a:lnTo>
                  <a:pt x="2197227" y="222250"/>
                </a:lnTo>
                <a:lnTo>
                  <a:pt x="2197227" y="224790"/>
                </a:lnTo>
                <a:lnTo>
                  <a:pt x="2255012" y="224790"/>
                </a:lnTo>
                <a:lnTo>
                  <a:pt x="2255012" y="231140"/>
                </a:lnTo>
                <a:lnTo>
                  <a:pt x="2312797" y="231140"/>
                </a:lnTo>
                <a:lnTo>
                  <a:pt x="2312797" y="233680"/>
                </a:lnTo>
                <a:lnTo>
                  <a:pt x="2312797" y="237490"/>
                </a:lnTo>
                <a:lnTo>
                  <a:pt x="2370709" y="237490"/>
                </a:lnTo>
                <a:lnTo>
                  <a:pt x="2370709" y="246380"/>
                </a:lnTo>
                <a:lnTo>
                  <a:pt x="2370709" y="251460"/>
                </a:lnTo>
                <a:lnTo>
                  <a:pt x="2486279" y="251460"/>
                </a:lnTo>
                <a:lnTo>
                  <a:pt x="2486279" y="257810"/>
                </a:lnTo>
                <a:lnTo>
                  <a:pt x="2717546" y="257810"/>
                </a:lnTo>
                <a:lnTo>
                  <a:pt x="2717546" y="262890"/>
                </a:lnTo>
                <a:lnTo>
                  <a:pt x="2717546" y="264160"/>
                </a:lnTo>
                <a:lnTo>
                  <a:pt x="2775458" y="264160"/>
                </a:lnTo>
                <a:lnTo>
                  <a:pt x="2775458" y="279400"/>
                </a:lnTo>
                <a:lnTo>
                  <a:pt x="2891028" y="279400"/>
                </a:lnTo>
                <a:lnTo>
                  <a:pt x="2891028" y="280670"/>
                </a:lnTo>
                <a:lnTo>
                  <a:pt x="2891028" y="287020"/>
                </a:lnTo>
                <a:lnTo>
                  <a:pt x="3064510" y="287020"/>
                </a:lnTo>
                <a:lnTo>
                  <a:pt x="3064510" y="295910"/>
                </a:lnTo>
                <a:lnTo>
                  <a:pt x="3527044" y="295910"/>
                </a:lnTo>
                <a:lnTo>
                  <a:pt x="3527044" y="297180"/>
                </a:lnTo>
                <a:lnTo>
                  <a:pt x="3527044" y="304800"/>
                </a:lnTo>
                <a:lnTo>
                  <a:pt x="3700526" y="304800"/>
                </a:lnTo>
                <a:lnTo>
                  <a:pt x="3700526" y="316230"/>
                </a:lnTo>
                <a:lnTo>
                  <a:pt x="3816223" y="316230"/>
                </a:lnTo>
                <a:lnTo>
                  <a:pt x="3816223" y="339090"/>
                </a:lnTo>
                <a:lnTo>
                  <a:pt x="3989705" y="339090"/>
                </a:lnTo>
                <a:lnTo>
                  <a:pt x="3989705" y="350520"/>
                </a:lnTo>
                <a:lnTo>
                  <a:pt x="4220972" y="350520"/>
                </a:lnTo>
                <a:lnTo>
                  <a:pt x="4220972" y="375920"/>
                </a:lnTo>
                <a:lnTo>
                  <a:pt x="4336542" y="375920"/>
                </a:lnTo>
                <a:lnTo>
                  <a:pt x="4336542" y="388620"/>
                </a:lnTo>
                <a:lnTo>
                  <a:pt x="4452239" y="388620"/>
                </a:lnTo>
                <a:lnTo>
                  <a:pt x="4452239" y="402590"/>
                </a:lnTo>
                <a:lnTo>
                  <a:pt x="4567936" y="402590"/>
                </a:lnTo>
                <a:lnTo>
                  <a:pt x="4567936" y="417830"/>
                </a:lnTo>
                <a:lnTo>
                  <a:pt x="5146040" y="417830"/>
                </a:lnTo>
                <a:lnTo>
                  <a:pt x="5146040" y="435610"/>
                </a:lnTo>
                <a:lnTo>
                  <a:pt x="5261737" y="435610"/>
                </a:lnTo>
                <a:lnTo>
                  <a:pt x="5261737" y="454660"/>
                </a:lnTo>
                <a:lnTo>
                  <a:pt x="5435219" y="454660"/>
                </a:lnTo>
                <a:lnTo>
                  <a:pt x="5435219" y="476250"/>
                </a:lnTo>
                <a:lnTo>
                  <a:pt x="6475984" y="476250"/>
                </a:lnTo>
                <a:lnTo>
                  <a:pt x="6475984" y="516890"/>
                </a:lnTo>
                <a:lnTo>
                  <a:pt x="6996417" y="516890"/>
                </a:lnTo>
                <a:lnTo>
                  <a:pt x="6996417" y="591820"/>
                </a:lnTo>
                <a:lnTo>
                  <a:pt x="7690231" y="591820"/>
                </a:lnTo>
                <a:lnTo>
                  <a:pt x="7690231" y="716280"/>
                </a:lnTo>
                <a:lnTo>
                  <a:pt x="9367012" y="716280"/>
                </a:lnTo>
                <a:lnTo>
                  <a:pt x="9367012" y="591820"/>
                </a:lnTo>
                <a:lnTo>
                  <a:pt x="9367012" y="516890"/>
                </a:lnTo>
                <a:lnTo>
                  <a:pt x="9367012" y="304800"/>
                </a:lnTo>
                <a:lnTo>
                  <a:pt x="9367012" y="29718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6" name="bg object 36"/>
          <p:cNvSpPr/>
          <p:nvPr/>
        </p:nvSpPr>
        <p:spPr>
          <a:xfrm>
            <a:off x="3524377" y="897889"/>
            <a:ext cx="4510405" cy="255270"/>
          </a:xfrm>
          <a:custGeom>
            <a:avLst/>
            <a:gdLst/>
            <a:ahLst/>
            <a:cxnLst/>
            <a:rect l="l" t="t" r="r" b="b"/>
            <a:pathLst>
              <a:path w="4510405" h="255269">
                <a:moveTo>
                  <a:pt x="2891028" y="154940"/>
                </a:moveTo>
                <a:lnTo>
                  <a:pt x="2775331" y="154940"/>
                </a:lnTo>
                <a:lnTo>
                  <a:pt x="2775331" y="153670"/>
                </a:lnTo>
                <a:lnTo>
                  <a:pt x="2775331" y="152400"/>
                </a:lnTo>
                <a:lnTo>
                  <a:pt x="2717546" y="152400"/>
                </a:lnTo>
                <a:lnTo>
                  <a:pt x="2717546" y="146050"/>
                </a:lnTo>
                <a:lnTo>
                  <a:pt x="2659761" y="146050"/>
                </a:lnTo>
                <a:lnTo>
                  <a:pt x="2659761" y="140970"/>
                </a:lnTo>
                <a:lnTo>
                  <a:pt x="2659761" y="138430"/>
                </a:lnTo>
                <a:lnTo>
                  <a:pt x="2659761" y="137160"/>
                </a:lnTo>
                <a:lnTo>
                  <a:pt x="2601976" y="137160"/>
                </a:lnTo>
                <a:lnTo>
                  <a:pt x="2601976" y="134620"/>
                </a:lnTo>
                <a:lnTo>
                  <a:pt x="2486279" y="134620"/>
                </a:lnTo>
                <a:lnTo>
                  <a:pt x="2486279" y="132080"/>
                </a:lnTo>
                <a:lnTo>
                  <a:pt x="2486279" y="127000"/>
                </a:lnTo>
                <a:lnTo>
                  <a:pt x="2486279" y="125730"/>
                </a:lnTo>
                <a:lnTo>
                  <a:pt x="2428494" y="125730"/>
                </a:lnTo>
                <a:lnTo>
                  <a:pt x="2428494" y="116840"/>
                </a:lnTo>
                <a:lnTo>
                  <a:pt x="2370582" y="116840"/>
                </a:lnTo>
                <a:lnTo>
                  <a:pt x="2370582" y="114300"/>
                </a:lnTo>
                <a:lnTo>
                  <a:pt x="2312797" y="114300"/>
                </a:lnTo>
                <a:lnTo>
                  <a:pt x="2312797" y="113030"/>
                </a:lnTo>
                <a:lnTo>
                  <a:pt x="2312797" y="107950"/>
                </a:lnTo>
                <a:lnTo>
                  <a:pt x="2255012" y="107950"/>
                </a:lnTo>
                <a:lnTo>
                  <a:pt x="2255012" y="106680"/>
                </a:lnTo>
                <a:lnTo>
                  <a:pt x="2255012" y="99060"/>
                </a:lnTo>
                <a:lnTo>
                  <a:pt x="2139315" y="99060"/>
                </a:lnTo>
                <a:lnTo>
                  <a:pt x="2139315" y="93980"/>
                </a:lnTo>
                <a:lnTo>
                  <a:pt x="2081530" y="93980"/>
                </a:lnTo>
                <a:lnTo>
                  <a:pt x="2081530" y="88900"/>
                </a:lnTo>
                <a:lnTo>
                  <a:pt x="2023745" y="88900"/>
                </a:lnTo>
                <a:lnTo>
                  <a:pt x="2023745" y="83820"/>
                </a:lnTo>
                <a:lnTo>
                  <a:pt x="1965833" y="83820"/>
                </a:lnTo>
                <a:lnTo>
                  <a:pt x="1965833" y="78740"/>
                </a:lnTo>
                <a:lnTo>
                  <a:pt x="1908048" y="78740"/>
                </a:lnTo>
                <a:lnTo>
                  <a:pt x="1908048" y="76200"/>
                </a:lnTo>
                <a:lnTo>
                  <a:pt x="1792478" y="76200"/>
                </a:lnTo>
                <a:lnTo>
                  <a:pt x="1792478" y="73660"/>
                </a:lnTo>
                <a:lnTo>
                  <a:pt x="1734566" y="73660"/>
                </a:lnTo>
                <a:lnTo>
                  <a:pt x="1734566" y="71120"/>
                </a:lnTo>
                <a:lnTo>
                  <a:pt x="1676781" y="71120"/>
                </a:lnTo>
                <a:lnTo>
                  <a:pt x="1676781" y="69850"/>
                </a:lnTo>
                <a:lnTo>
                  <a:pt x="1676781" y="67310"/>
                </a:lnTo>
                <a:lnTo>
                  <a:pt x="1676781" y="66040"/>
                </a:lnTo>
                <a:lnTo>
                  <a:pt x="1618996" y="66040"/>
                </a:lnTo>
                <a:lnTo>
                  <a:pt x="1618996" y="60960"/>
                </a:lnTo>
                <a:lnTo>
                  <a:pt x="1561084" y="60960"/>
                </a:lnTo>
                <a:lnTo>
                  <a:pt x="1561084" y="59690"/>
                </a:lnTo>
                <a:lnTo>
                  <a:pt x="1561084" y="55880"/>
                </a:lnTo>
                <a:lnTo>
                  <a:pt x="1561084" y="50800"/>
                </a:lnTo>
                <a:lnTo>
                  <a:pt x="1503299" y="50800"/>
                </a:lnTo>
                <a:lnTo>
                  <a:pt x="1503299" y="48260"/>
                </a:lnTo>
                <a:lnTo>
                  <a:pt x="1445514" y="48260"/>
                </a:lnTo>
                <a:lnTo>
                  <a:pt x="1445514" y="45720"/>
                </a:lnTo>
                <a:lnTo>
                  <a:pt x="1445514" y="44450"/>
                </a:lnTo>
                <a:lnTo>
                  <a:pt x="1387729" y="44450"/>
                </a:lnTo>
                <a:lnTo>
                  <a:pt x="1387729" y="39370"/>
                </a:lnTo>
                <a:lnTo>
                  <a:pt x="1329817" y="39370"/>
                </a:lnTo>
                <a:lnTo>
                  <a:pt x="1329817" y="38100"/>
                </a:lnTo>
                <a:lnTo>
                  <a:pt x="1329817" y="33020"/>
                </a:lnTo>
                <a:lnTo>
                  <a:pt x="1329817" y="27940"/>
                </a:lnTo>
                <a:lnTo>
                  <a:pt x="1272032" y="27940"/>
                </a:lnTo>
                <a:lnTo>
                  <a:pt x="1272032" y="25400"/>
                </a:lnTo>
                <a:lnTo>
                  <a:pt x="1272032" y="22860"/>
                </a:lnTo>
                <a:lnTo>
                  <a:pt x="1214247" y="22860"/>
                </a:lnTo>
                <a:lnTo>
                  <a:pt x="1214247" y="17780"/>
                </a:lnTo>
                <a:lnTo>
                  <a:pt x="1214247" y="15240"/>
                </a:lnTo>
                <a:lnTo>
                  <a:pt x="1214247" y="10160"/>
                </a:lnTo>
                <a:lnTo>
                  <a:pt x="1214247" y="7620"/>
                </a:lnTo>
                <a:lnTo>
                  <a:pt x="1214247" y="5080"/>
                </a:lnTo>
                <a:lnTo>
                  <a:pt x="1156335" y="5080"/>
                </a:lnTo>
                <a:lnTo>
                  <a:pt x="1156335" y="2540"/>
                </a:lnTo>
                <a:lnTo>
                  <a:pt x="1156335" y="0"/>
                </a:lnTo>
                <a:lnTo>
                  <a:pt x="0" y="0"/>
                </a:lnTo>
                <a:lnTo>
                  <a:pt x="0" y="2540"/>
                </a:lnTo>
                <a:lnTo>
                  <a:pt x="57785" y="2540"/>
                </a:lnTo>
                <a:lnTo>
                  <a:pt x="57785" y="5080"/>
                </a:lnTo>
                <a:lnTo>
                  <a:pt x="57785" y="7620"/>
                </a:lnTo>
                <a:lnTo>
                  <a:pt x="115570" y="7620"/>
                </a:lnTo>
                <a:lnTo>
                  <a:pt x="115570" y="10160"/>
                </a:lnTo>
                <a:lnTo>
                  <a:pt x="346837" y="10160"/>
                </a:lnTo>
                <a:lnTo>
                  <a:pt x="346837" y="15240"/>
                </a:lnTo>
                <a:lnTo>
                  <a:pt x="404749" y="15240"/>
                </a:lnTo>
                <a:lnTo>
                  <a:pt x="404749" y="17780"/>
                </a:lnTo>
                <a:lnTo>
                  <a:pt x="462534" y="17780"/>
                </a:lnTo>
                <a:lnTo>
                  <a:pt x="462534" y="22860"/>
                </a:lnTo>
                <a:lnTo>
                  <a:pt x="520319" y="22860"/>
                </a:lnTo>
                <a:lnTo>
                  <a:pt x="520319" y="25400"/>
                </a:lnTo>
                <a:lnTo>
                  <a:pt x="578231" y="25400"/>
                </a:lnTo>
                <a:lnTo>
                  <a:pt x="578231" y="27940"/>
                </a:lnTo>
                <a:lnTo>
                  <a:pt x="578231" y="33020"/>
                </a:lnTo>
                <a:lnTo>
                  <a:pt x="636016" y="33020"/>
                </a:lnTo>
                <a:lnTo>
                  <a:pt x="636016" y="38100"/>
                </a:lnTo>
                <a:lnTo>
                  <a:pt x="693801" y="38100"/>
                </a:lnTo>
                <a:lnTo>
                  <a:pt x="693801" y="39370"/>
                </a:lnTo>
                <a:lnTo>
                  <a:pt x="693801" y="44450"/>
                </a:lnTo>
                <a:lnTo>
                  <a:pt x="693801" y="45720"/>
                </a:lnTo>
                <a:lnTo>
                  <a:pt x="751586" y="45720"/>
                </a:lnTo>
                <a:lnTo>
                  <a:pt x="751586" y="48260"/>
                </a:lnTo>
                <a:lnTo>
                  <a:pt x="751586" y="50800"/>
                </a:lnTo>
                <a:lnTo>
                  <a:pt x="867283" y="50800"/>
                </a:lnTo>
                <a:lnTo>
                  <a:pt x="867283" y="55880"/>
                </a:lnTo>
                <a:lnTo>
                  <a:pt x="925068" y="55880"/>
                </a:lnTo>
                <a:lnTo>
                  <a:pt x="925068" y="59690"/>
                </a:lnTo>
                <a:lnTo>
                  <a:pt x="982980" y="59690"/>
                </a:lnTo>
                <a:lnTo>
                  <a:pt x="982980" y="60960"/>
                </a:lnTo>
                <a:lnTo>
                  <a:pt x="982980" y="66040"/>
                </a:lnTo>
                <a:lnTo>
                  <a:pt x="982980" y="67310"/>
                </a:lnTo>
                <a:lnTo>
                  <a:pt x="1040765" y="67310"/>
                </a:lnTo>
                <a:lnTo>
                  <a:pt x="1040765" y="69850"/>
                </a:lnTo>
                <a:lnTo>
                  <a:pt x="1098550" y="69850"/>
                </a:lnTo>
                <a:lnTo>
                  <a:pt x="1098550" y="71120"/>
                </a:lnTo>
                <a:lnTo>
                  <a:pt x="1098550" y="73660"/>
                </a:lnTo>
                <a:lnTo>
                  <a:pt x="1098550" y="76200"/>
                </a:lnTo>
                <a:lnTo>
                  <a:pt x="1156335" y="76200"/>
                </a:lnTo>
                <a:lnTo>
                  <a:pt x="1156335" y="78740"/>
                </a:lnTo>
                <a:lnTo>
                  <a:pt x="1156335" y="83820"/>
                </a:lnTo>
                <a:lnTo>
                  <a:pt x="1214247" y="83820"/>
                </a:lnTo>
                <a:lnTo>
                  <a:pt x="1214247" y="88900"/>
                </a:lnTo>
                <a:lnTo>
                  <a:pt x="1214247" y="93980"/>
                </a:lnTo>
                <a:lnTo>
                  <a:pt x="1214247" y="99060"/>
                </a:lnTo>
                <a:lnTo>
                  <a:pt x="1214247" y="106680"/>
                </a:lnTo>
                <a:lnTo>
                  <a:pt x="1272032" y="106680"/>
                </a:lnTo>
                <a:lnTo>
                  <a:pt x="1272032" y="107950"/>
                </a:lnTo>
                <a:lnTo>
                  <a:pt x="1272032" y="113030"/>
                </a:lnTo>
                <a:lnTo>
                  <a:pt x="1329817" y="113030"/>
                </a:lnTo>
                <a:lnTo>
                  <a:pt x="1329817" y="114300"/>
                </a:lnTo>
                <a:lnTo>
                  <a:pt x="1329817" y="116840"/>
                </a:lnTo>
                <a:lnTo>
                  <a:pt x="1329817" y="125730"/>
                </a:lnTo>
                <a:lnTo>
                  <a:pt x="1329817" y="127000"/>
                </a:lnTo>
                <a:lnTo>
                  <a:pt x="1387729" y="127000"/>
                </a:lnTo>
                <a:lnTo>
                  <a:pt x="1387729" y="132080"/>
                </a:lnTo>
                <a:lnTo>
                  <a:pt x="1445514" y="132080"/>
                </a:lnTo>
                <a:lnTo>
                  <a:pt x="1445514" y="134620"/>
                </a:lnTo>
                <a:lnTo>
                  <a:pt x="1445514" y="137160"/>
                </a:lnTo>
                <a:lnTo>
                  <a:pt x="1445514" y="138430"/>
                </a:lnTo>
                <a:lnTo>
                  <a:pt x="1503299" y="138430"/>
                </a:lnTo>
                <a:lnTo>
                  <a:pt x="1503299" y="140970"/>
                </a:lnTo>
                <a:lnTo>
                  <a:pt x="1561084" y="140970"/>
                </a:lnTo>
                <a:lnTo>
                  <a:pt x="1561084" y="146050"/>
                </a:lnTo>
                <a:lnTo>
                  <a:pt x="1561084" y="152400"/>
                </a:lnTo>
                <a:lnTo>
                  <a:pt x="1561084" y="153670"/>
                </a:lnTo>
                <a:lnTo>
                  <a:pt x="1618996" y="153670"/>
                </a:lnTo>
                <a:lnTo>
                  <a:pt x="1618996" y="154940"/>
                </a:lnTo>
                <a:lnTo>
                  <a:pt x="1618996" y="158750"/>
                </a:lnTo>
                <a:lnTo>
                  <a:pt x="2891028" y="158750"/>
                </a:lnTo>
                <a:lnTo>
                  <a:pt x="2891028" y="154940"/>
                </a:lnTo>
                <a:close/>
              </a:path>
              <a:path w="4510405" h="255269">
                <a:moveTo>
                  <a:pt x="4510024" y="246380"/>
                </a:moveTo>
                <a:lnTo>
                  <a:pt x="4336542" y="246380"/>
                </a:lnTo>
                <a:lnTo>
                  <a:pt x="4336542" y="242570"/>
                </a:lnTo>
                <a:lnTo>
                  <a:pt x="4336542" y="241300"/>
                </a:lnTo>
                <a:lnTo>
                  <a:pt x="4047490" y="241300"/>
                </a:lnTo>
                <a:lnTo>
                  <a:pt x="4047490" y="233680"/>
                </a:lnTo>
                <a:lnTo>
                  <a:pt x="3989578" y="233680"/>
                </a:lnTo>
                <a:lnTo>
                  <a:pt x="3989578" y="231140"/>
                </a:lnTo>
                <a:lnTo>
                  <a:pt x="3989578" y="228600"/>
                </a:lnTo>
                <a:lnTo>
                  <a:pt x="3874008" y="228600"/>
                </a:lnTo>
                <a:lnTo>
                  <a:pt x="3874008" y="220980"/>
                </a:lnTo>
                <a:lnTo>
                  <a:pt x="3816223" y="220980"/>
                </a:lnTo>
                <a:lnTo>
                  <a:pt x="3816223" y="217170"/>
                </a:lnTo>
                <a:lnTo>
                  <a:pt x="3816223" y="213360"/>
                </a:lnTo>
                <a:lnTo>
                  <a:pt x="3758311" y="213360"/>
                </a:lnTo>
                <a:lnTo>
                  <a:pt x="3758311" y="210820"/>
                </a:lnTo>
                <a:lnTo>
                  <a:pt x="3758311" y="209550"/>
                </a:lnTo>
                <a:lnTo>
                  <a:pt x="3700526" y="209550"/>
                </a:lnTo>
                <a:lnTo>
                  <a:pt x="3700526" y="200660"/>
                </a:lnTo>
                <a:lnTo>
                  <a:pt x="3700526" y="198120"/>
                </a:lnTo>
                <a:lnTo>
                  <a:pt x="3642741" y="198120"/>
                </a:lnTo>
                <a:lnTo>
                  <a:pt x="3642741" y="194310"/>
                </a:lnTo>
                <a:lnTo>
                  <a:pt x="3642741" y="193040"/>
                </a:lnTo>
                <a:lnTo>
                  <a:pt x="3584829" y="193040"/>
                </a:lnTo>
                <a:lnTo>
                  <a:pt x="3584829" y="186690"/>
                </a:lnTo>
                <a:lnTo>
                  <a:pt x="3527044" y="186690"/>
                </a:lnTo>
                <a:lnTo>
                  <a:pt x="3527044" y="182880"/>
                </a:lnTo>
                <a:lnTo>
                  <a:pt x="3411474" y="182880"/>
                </a:lnTo>
                <a:lnTo>
                  <a:pt x="3411474" y="180340"/>
                </a:lnTo>
                <a:lnTo>
                  <a:pt x="3411474" y="175260"/>
                </a:lnTo>
                <a:lnTo>
                  <a:pt x="3122295" y="175260"/>
                </a:lnTo>
                <a:lnTo>
                  <a:pt x="3122295" y="173990"/>
                </a:lnTo>
                <a:lnTo>
                  <a:pt x="3122295" y="171450"/>
                </a:lnTo>
                <a:lnTo>
                  <a:pt x="3122295" y="167640"/>
                </a:lnTo>
                <a:lnTo>
                  <a:pt x="3122295" y="165100"/>
                </a:lnTo>
                <a:lnTo>
                  <a:pt x="2948813" y="165100"/>
                </a:lnTo>
                <a:lnTo>
                  <a:pt x="2948813" y="159004"/>
                </a:lnTo>
                <a:lnTo>
                  <a:pt x="1676781" y="159004"/>
                </a:lnTo>
                <a:lnTo>
                  <a:pt x="1676781" y="165354"/>
                </a:lnTo>
                <a:lnTo>
                  <a:pt x="1734566" y="165354"/>
                </a:lnTo>
                <a:lnTo>
                  <a:pt x="1734566" y="167640"/>
                </a:lnTo>
                <a:lnTo>
                  <a:pt x="1792478" y="167640"/>
                </a:lnTo>
                <a:lnTo>
                  <a:pt x="1792478" y="171450"/>
                </a:lnTo>
                <a:lnTo>
                  <a:pt x="1908048" y="171450"/>
                </a:lnTo>
                <a:lnTo>
                  <a:pt x="1908048" y="173990"/>
                </a:lnTo>
                <a:lnTo>
                  <a:pt x="1965833" y="173990"/>
                </a:lnTo>
                <a:lnTo>
                  <a:pt x="1965833" y="175260"/>
                </a:lnTo>
                <a:lnTo>
                  <a:pt x="1965833" y="180340"/>
                </a:lnTo>
                <a:lnTo>
                  <a:pt x="2023745" y="180340"/>
                </a:lnTo>
                <a:lnTo>
                  <a:pt x="2023745" y="182880"/>
                </a:lnTo>
                <a:lnTo>
                  <a:pt x="2023745" y="186690"/>
                </a:lnTo>
                <a:lnTo>
                  <a:pt x="2081530" y="186690"/>
                </a:lnTo>
                <a:lnTo>
                  <a:pt x="2081530" y="193040"/>
                </a:lnTo>
                <a:lnTo>
                  <a:pt x="2081530" y="194310"/>
                </a:lnTo>
                <a:lnTo>
                  <a:pt x="2139315" y="194310"/>
                </a:lnTo>
                <a:lnTo>
                  <a:pt x="2139315" y="198120"/>
                </a:lnTo>
                <a:lnTo>
                  <a:pt x="2139315" y="200660"/>
                </a:lnTo>
                <a:lnTo>
                  <a:pt x="2255012" y="200660"/>
                </a:lnTo>
                <a:lnTo>
                  <a:pt x="2255012" y="209550"/>
                </a:lnTo>
                <a:lnTo>
                  <a:pt x="2255012" y="210820"/>
                </a:lnTo>
                <a:lnTo>
                  <a:pt x="2312797" y="210820"/>
                </a:lnTo>
                <a:lnTo>
                  <a:pt x="2312797" y="213360"/>
                </a:lnTo>
                <a:lnTo>
                  <a:pt x="2312797" y="217170"/>
                </a:lnTo>
                <a:lnTo>
                  <a:pt x="2370582" y="217170"/>
                </a:lnTo>
                <a:lnTo>
                  <a:pt x="2370582" y="220980"/>
                </a:lnTo>
                <a:lnTo>
                  <a:pt x="2428494" y="220980"/>
                </a:lnTo>
                <a:lnTo>
                  <a:pt x="2428494" y="228600"/>
                </a:lnTo>
                <a:lnTo>
                  <a:pt x="2428494" y="231140"/>
                </a:lnTo>
                <a:lnTo>
                  <a:pt x="2486279" y="231140"/>
                </a:lnTo>
                <a:lnTo>
                  <a:pt x="2486279" y="233680"/>
                </a:lnTo>
                <a:lnTo>
                  <a:pt x="2486279" y="241300"/>
                </a:lnTo>
                <a:lnTo>
                  <a:pt x="2486279" y="242570"/>
                </a:lnTo>
                <a:lnTo>
                  <a:pt x="2601976" y="242570"/>
                </a:lnTo>
                <a:lnTo>
                  <a:pt x="2601976" y="246380"/>
                </a:lnTo>
                <a:lnTo>
                  <a:pt x="2659761" y="246380"/>
                </a:lnTo>
                <a:lnTo>
                  <a:pt x="2659761" y="255270"/>
                </a:lnTo>
                <a:lnTo>
                  <a:pt x="4510024" y="255270"/>
                </a:lnTo>
                <a:lnTo>
                  <a:pt x="4510024" y="24638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7" name="bg object 37"/>
          <p:cNvSpPr/>
          <p:nvPr/>
        </p:nvSpPr>
        <p:spPr>
          <a:xfrm>
            <a:off x="1327150" y="723899"/>
            <a:ext cx="3354070" cy="176530"/>
          </a:xfrm>
          <a:custGeom>
            <a:avLst/>
            <a:gdLst/>
            <a:ahLst/>
            <a:cxnLst/>
            <a:rect l="l" t="t" r="r" b="b"/>
            <a:pathLst>
              <a:path w="3354070" h="176530">
                <a:moveTo>
                  <a:pt x="2717546" y="129540"/>
                </a:moveTo>
                <a:lnTo>
                  <a:pt x="2659761" y="129540"/>
                </a:lnTo>
                <a:lnTo>
                  <a:pt x="2659761" y="125730"/>
                </a:lnTo>
                <a:lnTo>
                  <a:pt x="2601976" y="125730"/>
                </a:lnTo>
                <a:lnTo>
                  <a:pt x="2601976" y="124460"/>
                </a:lnTo>
                <a:lnTo>
                  <a:pt x="2544064" y="124460"/>
                </a:lnTo>
                <a:lnTo>
                  <a:pt x="2544064" y="120650"/>
                </a:lnTo>
                <a:lnTo>
                  <a:pt x="2312797" y="120650"/>
                </a:lnTo>
                <a:lnTo>
                  <a:pt x="2312797" y="119380"/>
                </a:lnTo>
                <a:lnTo>
                  <a:pt x="2312797" y="118110"/>
                </a:lnTo>
                <a:lnTo>
                  <a:pt x="2255012" y="118110"/>
                </a:lnTo>
                <a:lnTo>
                  <a:pt x="2255012" y="116840"/>
                </a:lnTo>
                <a:lnTo>
                  <a:pt x="2255012" y="114300"/>
                </a:lnTo>
                <a:lnTo>
                  <a:pt x="2197227" y="114300"/>
                </a:lnTo>
                <a:lnTo>
                  <a:pt x="2197227" y="113030"/>
                </a:lnTo>
                <a:lnTo>
                  <a:pt x="2139315" y="113030"/>
                </a:lnTo>
                <a:lnTo>
                  <a:pt x="2139315" y="111760"/>
                </a:lnTo>
                <a:lnTo>
                  <a:pt x="2139315" y="109220"/>
                </a:lnTo>
                <a:lnTo>
                  <a:pt x="2081530" y="109220"/>
                </a:lnTo>
                <a:lnTo>
                  <a:pt x="2081530" y="105410"/>
                </a:lnTo>
                <a:lnTo>
                  <a:pt x="2023745" y="105410"/>
                </a:lnTo>
                <a:lnTo>
                  <a:pt x="2023745" y="104140"/>
                </a:lnTo>
                <a:lnTo>
                  <a:pt x="2023745" y="101600"/>
                </a:lnTo>
                <a:lnTo>
                  <a:pt x="1908048" y="101600"/>
                </a:lnTo>
                <a:lnTo>
                  <a:pt x="1908048" y="100330"/>
                </a:lnTo>
                <a:lnTo>
                  <a:pt x="1908048" y="97790"/>
                </a:lnTo>
                <a:lnTo>
                  <a:pt x="1850263" y="97790"/>
                </a:lnTo>
                <a:lnTo>
                  <a:pt x="1850263" y="95250"/>
                </a:lnTo>
                <a:lnTo>
                  <a:pt x="1850263" y="92710"/>
                </a:lnTo>
                <a:lnTo>
                  <a:pt x="1792478" y="92710"/>
                </a:lnTo>
                <a:lnTo>
                  <a:pt x="1792478" y="91440"/>
                </a:lnTo>
                <a:lnTo>
                  <a:pt x="1734566" y="91440"/>
                </a:lnTo>
                <a:lnTo>
                  <a:pt x="1734566" y="88900"/>
                </a:lnTo>
                <a:lnTo>
                  <a:pt x="1734566" y="85090"/>
                </a:lnTo>
                <a:lnTo>
                  <a:pt x="1618996" y="85090"/>
                </a:lnTo>
                <a:lnTo>
                  <a:pt x="1618996" y="81280"/>
                </a:lnTo>
                <a:lnTo>
                  <a:pt x="1618996" y="80010"/>
                </a:lnTo>
                <a:lnTo>
                  <a:pt x="1561084" y="80010"/>
                </a:lnTo>
                <a:lnTo>
                  <a:pt x="1561084" y="78740"/>
                </a:lnTo>
                <a:lnTo>
                  <a:pt x="1561084" y="73660"/>
                </a:lnTo>
                <a:lnTo>
                  <a:pt x="1561084" y="69850"/>
                </a:lnTo>
                <a:lnTo>
                  <a:pt x="1503299" y="69850"/>
                </a:lnTo>
                <a:lnTo>
                  <a:pt x="1503299" y="68580"/>
                </a:lnTo>
                <a:lnTo>
                  <a:pt x="1445514" y="68580"/>
                </a:lnTo>
                <a:lnTo>
                  <a:pt x="1445514" y="66040"/>
                </a:lnTo>
                <a:lnTo>
                  <a:pt x="1387729" y="66040"/>
                </a:lnTo>
                <a:lnTo>
                  <a:pt x="1387729" y="64770"/>
                </a:lnTo>
                <a:lnTo>
                  <a:pt x="1329817" y="64770"/>
                </a:lnTo>
                <a:lnTo>
                  <a:pt x="1329817" y="63500"/>
                </a:lnTo>
                <a:lnTo>
                  <a:pt x="1329817" y="60960"/>
                </a:lnTo>
                <a:lnTo>
                  <a:pt x="1329817" y="58420"/>
                </a:lnTo>
                <a:lnTo>
                  <a:pt x="1272032" y="58420"/>
                </a:lnTo>
                <a:lnTo>
                  <a:pt x="1272032" y="55880"/>
                </a:lnTo>
                <a:lnTo>
                  <a:pt x="1214247" y="55880"/>
                </a:lnTo>
                <a:lnTo>
                  <a:pt x="1214247" y="53340"/>
                </a:lnTo>
                <a:lnTo>
                  <a:pt x="1214247" y="52070"/>
                </a:lnTo>
                <a:lnTo>
                  <a:pt x="1156335" y="52070"/>
                </a:lnTo>
                <a:lnTo>
                  <a:pt x="1156335" y="49530"/>
                </a:lnTo>
                <a:lnTo>
                  <a:pt x="1156335" y="48260"/>
                </a:lnTo>
                <a:lnTo>
                  <a:pt x="1098550" y="48260"/>
                </a:lnTo>
                <a:lnTo>
                  <a:pt x="1098550" y="44450"/>
                </a:lnTo>
                <a:lnTo>
                  <a:pt x="982980" y="44450"/>
                </a:lnTo>
                <a:lnTo>
                  <a:pt x="982980" y="43180"/>
                </a:lnTo>
                <a:lnTo>
                  <a:pt x="982980" y="41910"/>
                </a:lnTo>
                <a:lnTo>
                  <a:pt x="925068" y="41910"/>
                </a:lnTo>
                <a:lnTo>
                  <a:pt x="925068" y="40640"/>
                </a:lnTo>
                <a:lnTo>
                  <a:pt x="809498" y="40640"/>
                </a:lnTo>
                <a:lnTo>
                  <a:pt x="809498" y="39370"/>
                </a:lnTo>
                <a:lnTo>
                  <a:pt x="809498" y="36830"/>
                </a:lnTo>
                <a:lnTo>
                  <a:pt x="693801" y="36830"/>
                </a:lnTo>
                <a:lnTo>
                  <a:pt x="693801" y="29210"/>
                </a:lnTo>
                <a:lnTo>
                  <a:pt x="636016" y="29210"/>
                </a:lnTo>
                <a:lnTo>
                  <a:pt x="636016" y="27940"/>
                </a:lnTo>
                <a:lnTo>
                  <a:pt x="578231" y="27940"/>
                </a:lnTo>
                <a:lnTo>
                  <a:pt x="578231" y="22860"/>
                </a:lnTo>
                <a:lnTo>
                  <a:pt x="520319" y="22860"/>
                </a:lnTo>
                <a:lnTo>
                  <a:pt x="520319" y="20320"/>
                </a:lnTo>
                <a:lnTo>
                  <a:pt x="462534" y="20320"/>
                </a:lnTo>
                <a:lnTo>
                  <a:pt x="462534" y="19050"/>
                </a:lnTo>
                <a:lnTo>
                  <a:pt x="462534" y="16510"/>
                </a:lnTo>
                <a:lnTo>
                  <a:pt x="404749" y="16510"/>
                </a:lnTo>
                <a:lnTo>
                  <a:pt x="404749" y="13970"/>
                </a:lnTo>
                <a:lnTo>
                  <a:pt x="346837" y="13970"/>
                </a:lnTo>
                <a:lnTo>
                  <a:pt x="346837" y="11430"/>
                </a:lnTo>
                <a:lnTo>
                  <a:pt x="346837" y="8890"/>
                </a:lnTo>
                <a:lnTo>
                  <a:pt x="346837" y="6350"/>
                </a:lnTo>
                <a:lnTo>
                  <a:pt x="289052" y="6350"/>
                </a:lnTo>
                <a:lnTo>
                  <a:pt x="289052" y="3810"/>
                </a:lnTo>
                <a:lnTo>
                  <a:pt x="289052" y="2540"/>
                </a:lnTo>
                <a:lnTo>
                  <a:pt x="231267" y="2540"/>
                </a:lnTo>
                <a:lnTo>
                  <a:pt x="231267" y="0"/>
                </a:lnTo>
                <a:lnTo>
                  <a:pt x="0" y="0"/>
                </a:lnTo>
                <a:lnTo>
                  <a:pt x="0" y="2540"/>
                </a:lnTo>
                <a:lnTo>
                  <a:pt x="0" y="3810"/>
                </a:lnTo>
                <a:lnTo>
                  <a:pt x="57785" y="3810"/>
                </a:lnTo>
                <a:lnTo>
                  <a:pt x="57785" y="6350"/>
                </a:lnTo>
                <a:lnTo>
                  <a:pt x="57785" y="8890"/>
                </a:lnTo>
                <a:lnTo>
                  <a:pt x="115570" y="8890"/>
                </a:lnTo>
                <a:lnTo>
                  <a:pt x="115570" y="11430"/>
                </a:lnTo>
                <a:lnTo>
                  <a:pt x="173482" y="11430"/>
                </a:lnTo>
                <a:lnTo>
                  <a:pt x="173482" y="13970"/>
                </a:lnTo>
                <a:lnTo>
                  <a:pt x="231267" y="13970"/>
                </a:lnTo>
                <a:lnTo>
                  <a:pt x="231267" y="16510"/>
                </a:lnTo>
                <a:lnTo>
                  <a:pt x="231267" y="19050"/>
                </a:lnTo>
                <a:lnTo>
                  <a:pt x="289052" y="19050"/>
                </a:lnTo>
                <a:lnTo>
                  <a:pt x="289052" y="20320"/>
                </a:lnTo>
                <a:lnTo>
                  <a:pt x="289052" y="22860"/>
                </a:lnTo>
                <a:lnTo>
                  <a:pt x="289052" y="27940"/>
                </a:lnTo>
                <a:lnTo>
                  <a:pt x="346837" y="27940"/>
                </a:lnTo>
                <a:lnTo>
                  <a:pt x="346837" y="29210"/>
                </a:lnTo>
                <a:lnTo>
                  <a:pt x="346837" y="36830"/>
                </a:lnTo>
                <a:lnTo>
                  <a:pt x="346837" y="39370"/>
                </a:lnTo>
                <a:lnTo>
                  <a:pt x="404749" y="39370"/>
                </a:lnTo>
                <a:lnTo>
                  <a:pt x="404749" y="40640"/>
                </a:lnTo>
                <a:lnTo>
                  <a:pt x="404749" y="41910"/>
                </a:lnTo>
                <a:lnTo>
                  <a:pt x="404749" y="43180"/>
                </a:lnTo>
                <a:lnTo>
                  <a:pt x="462534" y="43180"/>
                </a:lnTo>
                <a:lnTo>
                  <a:pt x="462534" y="44450"/>
                </a:lnTo>
                <a:lnTo>
                  <a:pt x="462534" y="48260"/>
                </a:lnTo>
                <a:lnTo>
                  <a:pt x="462534" y="49530"/>
                </a:lnTo>
                <a:lnTo>
                  <a:pt x="520319" y="49530"/>
                </a:lnTo>
                <a:lnTo>
                  <a:pt x="520319" y="52070"/>
                </a:lnTo>
                <a:lnTo>
                  <a:pt x="520319" y="53340"/>
                </a:lnTo>
                <a:lnTo>
                  <a:pt x="578231" y="53340"/>
                </a:lnTo>
                <a:lnTo>
                  <a:pt x="578231" y="55880"/>
                </a:lnTo>
                <a:lnTo>
                  <a:pt x="578231" y="58420"/>
                </a:lnTo>
                <a:lnTo>
                  <a:pt x="578231" y="60960"/>
                </a:lnTo>
                <a:lnTo>
                  <a:pt x="636016" y="60960"/>
                </a:lnTo>
                <a:lnTo>
                  <a:pt x="636016" y="63500"/>
                </a:lnTo>
                <a:lnTo>
                  <a:pt x="693801" y="63500"/>
                </a:lnTo>
                <a:lnTo>
                  <a:pt x="693801" y="64770"/>
                </a:lnTo>
                <a:lnTo>
                  <a:pt x="693801" y="66040"/>
                </a:lnTo>
                <a:lnTo>
                  <a:pt x="693801" y="68580"/>
                </a:lnTo>
                <a:lnTo>
                  <a:pt x="693801" y="69850"/>
                </a:lnTo>
                <a:lnTo>
                  <a:pt x="693801" y="73660"/>
                </a:lnTo>
                <a:lnTo>
                  <a:pt x="809498" y="73660"/>
                </a:lnTo>
                <a:lnTo>
                  <a:pt x="809498" y="78740"/>
                </a:lnTo>
                <a:lnTo>
                  <a:pt x="925068" y="78740"/>
                </a:lnTo>
                <a:lnTo>
                  <a:pt x="925068" y="80010"/>
                </a:lnTo>
                <a:lnTo>
                  <a:pt x="925068" y="81280"/>
                </a:lnTo>
                <a:lnTo>
                  <a:pt x="982980" y="81280"/>
                </a:lnTo>
                <a:lnTo>
                  <a:pt x="982980" y="85090"/>
                </a:lnTo>
                <a:lnTo>
                  <a:pt x="1098550" y="85090"/>
                </a:lnTo>
                <a:lnTo>
                  <a:pt x="1098550" y="88900"/>
                </a:lnTo>
                <a:lnTo>
                  <a:pt x="1156335" y="88900"/>
                </a:lnTo>
                <a:lnTo>
                  <a:pt x="1156335" y="91440"/>
                </a:lnTo>
                <a:lnTo>
                  <a:pt x="1156335" y="92710"/>
                </a:lnTo>
                <a:lnTo>
                  <a:pt x="1156335" y="95250"/>
                </a:lnTo>
                <a:lnTo>
                  <a:pt x="1214247" y="95250"/>
                </a:lnTo>
                <a:lnTo>
                  <a:pt x="1214247" y="97790"/>
                </a:lnTo>
                <a:lnTo>
                  <a:pt x="1214247" y="100330"/>
                </a:lnTo>
                <a:lnTo>
                  <a:pt x="1272032" y="100330"/>
                </a:lnTo>
                <a:lnTo>
                  <a:pt x="1272032" y="101600"/>
                </a:lnTo>
                <a:lnTo>
                  <a:pt x="1272032" y="104140"/>
                </a:lnTo>
                <a:lnTo>
                  <a:pt x="1329817" y="104140"/>
                </a:lnTo>
                <a:lnTo>
                  <a:pt x="1329817" y="105410"/>
                </a:lnTo>
                <a:lnTo>
                  <a:pt x="1329817" y="109220"/>
                </a:lnTo>
                <a:lnTo>
                  <a:pt x="1329817" y="111760"/>
                </a:lnTo>
                <a:lnTo>
                  <a:pt x="1387729" y="111760"/>
                </a:lnTo>
                <a:lnTo>
                  <a:pt x="1387729" y="113030"/>
                </a:lnTo>
                <a:lnTo>
                  <a:pt x="1387729" y="114300"/>
                </a:lnTo>
                <a:lnTo>
                  <a:pt x="1445514" y="114300"/>
                </a:lnTo>
                <a:lnTo>
                  <a:pt x="1445514" y="116840"/>
                </a:lnTo>
                <a:lnTo>
                  <a:pt x="1503299" y="116840"/>
                </a:lnTo>
                <a:lnTo>
                  <a:pt x="1503299" y="118110"/>
                </a:lnTo>
                <a:lnTo>
                  <a:pt x="1503299" y="119380"/>
                </a:lnTo>
                <a:lnTo>
                  <a:pt x="1561084" y="119380"/>
                </a:lnTo>
                <a:lnTo>
                  <a:pt x="1561084" y="120650"/>
                </a:lnTo>
                <a:lnTo>
                  <a:pt x="1561084" y="124460"/>
                </a:lnTo>
                <a:lnTo>
                  <a:pt x="1561084" y="125730"/>
                </a:lnTo>
                <a:lnTo>
                  <a:pt x="1561084" y="129540"/>
                </a:lnTo>
                <a:lnTo>
                  <a:pt x="1561084" y="132080"/>
                </a:lnTo>
                <a:lnTo>
                  <a:pt x="2717546" y="132080"/>
                </a:lnTo>
                <a:lnTo>
                  <a:pt x="2717546" y="129540"/>
                </a:lnTo>
                <a:close/>
              </a:path>
              <a:path w="3354070" h="176530">
                <a:moveTo>
                  <a:pt x="3353562" y="171450"/>
                </a:moveTo>
                <a:lnTo>
                  <a:pt x="3295777" y="171450"/>
                </a:lnTo>
                <a:lnTo>
                  <a:pt x="3295777" y="170180"/>
                </a:lnTo>
                <a:lnTo>
                  <a:pt x="3295777" y="167640"/>
                </a:lnTo>
                <a:lnTo>
                  <a:pt x="3237992" y="167640"/>
                </a:lnTo>
                <a:lnTo>
                  <a:pt x="3237992" y="165100"/>
                </a:lnTo>
                <a:lnTo>
                  <a:pt x="3180207" y="165100"/>
                </a:lnTo>
                <a:lnTo>
                  <a:pt x="3180207" y="160020"/>
                </a:lnTo>
                <a:lnTo>
                  <a:pt x="3180207" y="158750"/>
                </a:lnTo>
                <a:lnTo>
                  <a:pt x="3122295" y="158750"/>
                </a:lnTo>
                <a:lnTo>
                  <a:pt x="3122295" y="156210"/>
                </a:lnTo>
                <a:lnTo>
                  <a:pt x="3064510" y="156210"/>
                </a:lnTo>
                <a:lnTo>
                  <a:pt x="3064510" y="152400"/>
                </a:lnTo>
                <a:lnTo>
                  <a:pt x="2948813" y="152400"/>
                </a:lnTo>
                <a:lnTo>
                  <a:pt x="2948813" y="149860"/>
                </a:lnTo>
                <a:lnTo>
                  <a:pt x="2948813" y="148590"/>
                </a:lnTo>
                <a:lnTo>
                  <a:pt x="2891028" y="148590"/>
                </a:lnTo>
                <a:lnTo>
                  <a:pt x="2891028" y="147320"/>
                </a:lnTo>
                <a:lnTo>
                  <a:pt x="2891028" y="142240"/>
                </a:lnTo>
                <a:lnTo>
                  <a:pt x="2833243" y="142240"/>
                </a:lnTo>
                <a:lnTo>
                  <a:pt x="2833243" y="138430"/>
                </a:lnTo>
                <a:lnTo>
                  <a:pt x="2775458" y="138430"/>
                </a:lnTo>
                <a:lnTo>
                  <a:pt x="2775458" y="132334"/>
                </a:lnTo>
                <a:lnTo>
                  <a:pt x="1618996" y="132334"/>
                </a:lnTo>
                <a:lnTo>
                  <a:pt x="1618996" y="138684"/>
                </a:lnTo>
                <a:lnTo>
                  <a:pt x="1734566" y="138684"/>
                </a:lnTo>
                <a:lnTo>
                  <a:pt x="1734566" y="142240"/>
                </a:lnTo>
                <a:lnTo>
                  <a:pt x="1734566" y="147320"/>
                </a:lnTo>
                <a:lnTo>
                  <a:pt x="1792478" y="147320"/>
                </a:lnTo>
                <a:lnTo>
                  <a:pt x="1792478" y="148590"/>
                </a:lnTo>
                <a:lnTo>
                  <a:pt x="1792478" y="149860"/>
                </a:lnTo>
                <a:lnTo>
                  <a:pt x="1850263" y="149860"/>
                </a:lnTo>
                <a:lnTo>
                  <a:pt x="1850263" y="152400"/>
                </a:lnTo>
                <a:lnTo>
                  <a:pt x="1850263" y="156210"/>
                </a:lnTo>
                <a:lnTo>
                  <a:pt x="1908048" y="156210"/>
                </a:lnTo>
                <a:lnTo>
                  <a:pt x="1908048" y="158750"/>
                </a:lnTo>
                <a:lnTo>
                  <a:pt x="1908048" y="160020"/>
                </a:lnTo>
                <a:lnTo>
                  <a:pt x="2023745" y="160020"/>
                </a:lnTo>
                <a:lnTo>
                  <a:pt x="2023745" y="165100"/>
                </a:lnTo>
                <a:lnTo>
                  <a:pt x="2081530" y="165100"/>
                </a:lnTo>
                <a:lnTo>
                  <a:pt x="2081530" y="167640"/>
                </a:lnTo>
                <a:lnTo>
                  <a:pt x="2081530" y="170180"/>
                </a:lnTo>
                <a:lnTo>
                  <a:pt x="2139315" y="170180"/>
                </a:lnTo>
                <a:lnTo>
                  <a:pt x="2139315" y="171450"/>
                </a:lnTo>
                <a:lnTo>
                  <a:pt x="2139315" y="173990"/>
                </a:lnTo>
                <a:lnTo>
                  <a:pt x="2197227" y="173990"/>
                </a:lnTo>
                <a:lnTo>
                  <a:pt x="2197227" y="176530"/>
                </a:lnTo>
                <a:lnTo>
                  <a:pt x="3353562" y="176530"/>
                </a:lnTo>
                <a:lnTo>
                  <a:pt x="3353562" y="173990"/>
                </a:lnTo>
                <a:lnTo>
                  <a:pt x="3353562" y="17145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8" name="bg object 38"/>
          <p:cNvSpPr/>
          <p:nvPr/>
        </p:nvSpPr>
        <p:spPr>
          <a:xfrm>
            <a:off x="1327150" y="722629"/>
            <a:ext cx="231775" cy="3810"/>
          </a:xfrm>
          <a:custGeom>
            <a:avLst/>
            <a:gdLst/>
            <a:ahLst/>
            <a:cxnLst/>
            <a:rect l="l" t="t" r="r" b="b"/>
            <a:pathLst>
              <a:path w="231775" h="3809">
                <a:moveTo>
                  <a:pt x="231267" y="1270"/>
                </a:moveTo>
                <a:lnTo>
                  <a:pt x="173482" y="1270"/>
                </a:lnTo>
                <a:lnTo>
                  <a:pt x="173482" y="0"/>
                </a:lnTo>
                <a:lnTo>
                  <a:pt x="0" y="0"/>
                </a:lnTo>
                <a:lnTo>
                  <a:pt x="0" y="1270"/>
                </a:lnTo>
                <a:lnTo>
                  <a:pt x="0" y="3810"/>
                </a:lnTo>
                <a:lnTo>
                  <a:pt x="231267" y="3810"/>
                </a:lnTo>
                <a:lnTo>
                  <a:pt x="231267" y="1270"/>
                </a:lnTo>
                <a:close/>
              </a:path>
            </a:pathLst>
          </a:custGeom>
          <a:solidFill>
            <a:srgbClr val="BCA7E8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822960" y="365760"/>
            <a:ext cx="14813280" cy="1463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822960" y="2103120"/>
            <a:ext cx="1481328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5596128" y="8503920"/>
            <a:ext cx="5266944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822960" y="8503920"/>
            <a:ext cx="3785616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11850624" y="8503920"/>
            <a:ext cx="3785616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 descr=""/>
          <p:cNvSpPr txBox="1"/>
          <p:nvPr/>
        </p:nvSpPr>
        <p:spPr>
          <a:xfrm>
            <a:off x="14792706" y="739267"/>
            <a:ext cx="823594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350">
                <a:solidFill>
                  <a:srgbClr val="E95359"/>
                </a:solidFill>
                <a:latin typeface="Arial"/>
                <a:cs typeface="Arial"/>
              </a:rPr>
              <a:t>++++++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3" name="object 3" descr=""/>
          <p:cNvSpPr txBox="1"/>
          <p:nvPr/>
        </p:nvSpPr>
        <p:spPr>
          <a:xfrm>
            <a:off x="9794620" y="932433"/>
            <a:ext cx="590486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41666" sz="2100" spc="-562">
                <a:solidFill>
                  <a:srgbClr val="41A3FF"/>
                </a:solidFill>
                <a:latin typeface="Arial"/>
                <a:cs typeface="Arial"/>
              </a:rPr>
              <a:t>++++++</a:t>
            </a:r>
            <a:r>
              <a:rPr dirty="0" baseline="39682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37698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35714" sz="2100" spc="-562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31746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29761" sz="2100" spc="-562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27777" sz="2100" spc="-562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25793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23809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21825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9841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5873" sz="2100" spc="-562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13888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9920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7936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5952" sz="2100" spc="-562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3968" sz="2100" spc="-562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1984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sz="1400" spc="-375">
                <a:solidFill>
                  <a:srgbClr val="41A3FF"/>
                </a:solidFill>
                <a:latin typeface="Arial"/>
                <a:cs typeface="Arial"/>
              </a:rPr>
              <a:t>++++++++++++++++++++++++++++</a:t>
            </a:r>
            <a:r>
              <a:rPr dirty="0" baseline="-7936" sz="2100" spc="-562">
                <a:solidFill>
                  <a:srgbClr val="41A3FF"/>
                </a:solidFill>
                <a:latin typeface="Arial"/>
                <a:cs typeface="Arial"/>
              </a:rPr>
              <a:t>++++++++++++++++++++</a:t>
            </a:r>
            <a:endParaRPr baseline="-7936" sz="2100">
              <a:latin typeface="Arial"/>
              <a:cs typeface="Arial"/>
            </a:endParaRPr>
          </a:p>
        </p:txBody>
      </p:sp>
      <p:sp>
        <p:nvSpPr>
          <p:cNvPr id="4" name="object 4" descr=""/>
          <p:cNvSpPr txBox="1"/>
          <p:nvPr/>
        </p:nvSpPr>
        <p:spPr>
          <a:xfrm>
            <a:off x="9389871" y="974852"/>
            <a:ext cx="301371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5952" sz="2100" spc="-555">
                <a:solidFill>
                  <a:srgbClr val="DFD625"/>
                </a:solidFill>
                <a:latin typeface="Arial"/>
                <a:cs typeface="Arial"/>
              </a:rPr>
              <a:t>+++++++++++</a:t>
            </a:r>
            <a:r>
              <a:rPr dirty="0" baseline="1984" sz="2100" spc="-555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sz="1400" spc="-370">
                <a:solidFill>
                  <a:srgbClr val="DFD625"/>
                </a:solidFill>
                <a:latin typeface="Arial"/>
                <a:cs typeface="Arial"/>
              </a:rPr>
              <a:t>+++++++++++++++++++</a:t>
            </a:r>
            <a:r>
              <a:rPr dirty="0" baseline="-3968" sz="2100" spc="-555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baseline="-7936" sz="2100" spc="-555">
                <a:solidFill>
                  <a:srgbClr val="DFD625"/>
                </a:solidFill>
                <a:latin typeface="Arial"/>
                <a:cs typeface="Arial"/>
              </a:rPr>
              <a:t>++++++++++</a:t>
            </a:r>
            <a:r>
              <a:rPr dirty="0" baseline="-11904" sz="2100" spc="-555">
                <a:solidFill>
                  <a:srgbClr val="DFD625"/>
                </a:solidFill>
                <a:latin typeface="Arial"/>
                <a:cs typeface="Arial"/>
              </a:rPr>
              <a:t>++</a:t>
            </a:r>
            <a:endParaRPr baseline="-11904" sz="2100">
              <a:latin typeface="Arial"/>
              <a:cs typeface="Arial"/>
            </a:endParaRPr>
          </a:p>
        </p:txBody>
      </p:sp>
      <p:sp>
        <p:nvSpPr>
          <p:cNvPr id="5" name="object 5" descr=""/>
          <p:cNvSpPr txBox="1"/>
          <p:nvPr/>
        </p:nvSpPr>
        <p:spPr>
          <a:xfrm>
            <a:off x="12281027" y="1096518"/>
            <a:ext cx="3418204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1825" sz="2100" spc="-472">
                <a:solidFill>
                  <a:srgbClr val="DFD625"/>
                </a:solidFill>
                <a:latin typeface="Arial"/>
                <a:cs typeface="Arial"/>
              </a:rPr>
              <a:t>+++++</a:t>
            </a:r>
            <a:r>
              <a:rPr dirty="0" baseline="15873" sz="2100" spc="-472">
                <a:solidFill>
                  <a:srgbClr val="DFD625"/>
                </a:solidFill>
                <a:latin typeface="Arial"/>
                <a:cs typeface="Arial"/>
              </a:rPr>
              <a:t>++++++</a:t>
            </a:r>
            <a:r>
              <a:rPr dirty="0" baseline="7936" sz="2100" spc="-472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sz="1400" spc="-315">
                <a:solidFill>
                  <a:srgbClr val="DFD625"/>
                </a:solidFill>
                <a:latin typeface="Arial"/>
                <a:cs typeface="Arial"/>
              </a:rPr>
              <a:t>++++++++++++++++++++++++++++++++++</a:t>
            </a:r>
            <a:r>
              <a:rPr dirty="0" sz="1400" spc="345">
                <a:solidFill>
                  <a:srgbClr val="DFD625"/>
                </a:solidFill>
                <a:latin typeface="Arial"/>
                <a:cs typeface="Arial"/>
              </a:rPr>
              <a:t> </a:t>
            </a:r>
            <a:r>
              <a:rPr dirty="0" sz="1400" spc="-50">
                <a:solidFill>
                  <a:srgbClr val="DFD625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sp>
        <p:nvSpPr>
          <p:cNvPr id="6" name="object 6" descr=""/>
          <p:cNvSpPr txBox="1"/>
          <p:nvPr/>
        </p:nvSpPr>
        <p:spPr>
          <a:xfrm>
            <a:off x="1121410" y="701420"/>
            <a:ext cx="1376870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39682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37698" sz="2100" spc="-56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35714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33730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9761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27777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5793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3809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21825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9841" sz="2100" spc="-56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7857" sz="2100" spc="-56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5873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9920" sz="2100" spc="-562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15873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11904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9920" sz="2100" spc="-562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7936" sz="2100" spc="-562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3968" sz="2100" spc="-562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5952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3968" sz="2100" spc="-562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baseline="17857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5873" sz="2100" spc="-562">
                <a:solidFill>
                  <a:srgbClr val="41A3FF"/>
                </a:solidFill>
                <a:latin typeface="Arial"/>
                <a:cs typeface="Arial"/>
              </a:rPr>
              <a:t>++++++</a:t>
            </a:r>
            <a:r>
              <a:rPr dirty="0" baseline="13888" sz="2100" spc="-562">
                <a:solidFill>
                  <a:srgbClr val="41A3FF"/>
                </a:solidFill>
                <a:latin typeface="Arial"/>
                <a:cs typeface="Arial"/>
              </a:rPr>
              <a:t>++++++</a:t>
            </a:r>
            <a:r>
              <a:rPr dirty="0" baseline="11904" sz="2100" spc="-562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9920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7936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5952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3968" sz="2100" spc="-562">
                <a:solidFill>
                  <a:srgbClr val="41A3FF"/>
                </a:solidFill>
                <a:latin typeface="Arial"/>
                <a:cs typeface="Arial"/>
              </a:rPr>
              <a:t>++++</a:t>
            </a:r>
            <a:r>
              <a:rPr dirty="0" baseline="1984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sz="1400" spc="-375">
                <a:solidFill>
                  <a:srgbClr val="41A3FF"/>
                </a:solidFill>
                <a:latin typeface="Arial"/>
                <a:cs typeface="Arial"/>
              </a:rPr>
              <a:t>+</a:t>
            </a:r>
            <a:r>
              <a:rPr dirty="0" baseline="31746" sz="2100" spc="-562">
                <a:solidFill>
                  <a:srgbClr val="E95359"/>
                </a:solidFill>
                <a:latin typeface="Arial"/>
                <a:cs typeface="Arial"/>
              </a:rPr>
              <a:t>+++++</a:t>
            </a:r>
            <a:r>
              <a:rPr dirty="0" baseline="29761" sz="2100" spc="-562">
                <a:solidFill>
                  <a:srgbClr val="E95359"/>
                </a:solidFill>
                <a:latin typeface="Arial"/>
                <a:cs typeface="Arial"/>
              </a:rPr>
              <a:t>++++++++</a:t>
            </a:r>
            <a:r>
              <a:rPr dirty="0" baseline="27777" sz="2100" spc="-562">
                <a:solidFill>
                  <a:srgbClr val="E95359"/>
                </a:solidFill>
                <a:latin typeface="Arial"/>
                <a:cs typeface="Arial"/>
              </a:rPr>
              <a:t>++++++++++++++</a:t>
            </a:r>
            <a:r>
              <a:rPr dirty="0" baseline="25793" sz="2100" spc="-562">
                <a:solidFill>
                  <a:srgbClr val="E95359"/>
                </a:solidFill>
                <a:latin typeface="Arial"/>
                <a:cs typeface="Arial"/>
              </a:rPr>
              <a:t>++++++</a:t>
            </a:r>
            <a:r>
              <a:rPr dirty="0" baseline="23809" sz="2100" spc="-562">
                <a:solidFill>
                  <a:srgbClr val="E95359"/>
                </a:solidFill>
                <a:latin typeface="Arial"/>
                <a:cs typeface="Arial"/>
              </a:rPr>
              <a:t>+++++++++++</a:t>
            </a:r>
            <a:r>
              <a:rPr dirty="0" baseline="21825" sz="2100" spc="-562">
                <a:solidFill>
                  <a:srgbClr val="E95359"/>
                </a:solidFill>
                <a:latin typeface="Arial"/>
                <a:cs typeface="Arial"/>
              </a:rPr>
              <a:t>++++</a:t>
            </a:r>
            <a:r>
              <a:rPr dirty="0" baseline="19841" sz="2100" spc="-562">
                <a:solidFill>
                  <a:srgbClr val="E95359"/>
                </a:solidFill>
                <a:latin typeface="Arial"/>
                <a:cs typeface="Arial"/>
              </a:rPr>
              <a:t>+++++</a:t>
            </a:r>
            <a:r>
              <a:rPr dirty="0" baseline="17857" sz="2100" spc="-562">
                <a:solidFill>
                  <a:srgbClr val="E95359"/>
                </a:solidFill>
                <a:latin typeface="Arial"/>
                <a:cs typeface="Arial"/>
              </a:rPr>
              <a:t>++++</a:t>
            </a:r>
            <a:r>
              <a:rPr dirty="0" baseline="15873" sz="2100" spc="-562">
                <a:solidFill>
                  <a:srgbClr val="E95359"/>
                </a:solidFill>
                <a:latin typeface="Arial"/>
                <a:cs typeface="Arial"/>
              </a:rPr>
              <a:t>++</a:t>
            </a:r>
            <a:r>
              <a:rPr dirty="0" baseline="13888" sz="2100" spc="-562">
                <a:solidFill>
                  <a:srgbClr val="E95359"/>
                </a:solidFill>
                <a:latin typeface="Arial"/>
                <a:cs typeface="Arial"/>
              </a:rPr>
              <a:t>+++++++++++++</a:t>
            </a:r>
            <a:r>
              <a:rPr dirty="0" baseline="11904" sz="2100" spc="-562">
                <a:solidFill>
                  <a:srgbClr val="E95359"/>
                </a:solidFill>
                <a:latin typeface="Arial"/>
                <a:cs typeface="Arial"/>
              </a:rPr>
              <a:t>+</a:t>
            </a:r>
            <a:r>
              <a:rPr dirty="0" baseline="9920" sz="2100" spc="-562">
                <a:solidFill>
                  <a:srgbClr val="E95359"/>
                </a:solidFill>
                <a:latin typeface="Arial"/>
                <a:cs typeface="Arial"/>
              </a:rPr>
              <a:t>++++++</a:t>
            </a:r>
            <a:r>
              <a:rPr dirty="0" baseline="7936" sz="2100" spc="-562">
                <a:solidFill>
                  <a:srgbClr val="E95359"/>
                </a:solidFill>
                <a:latin typeface="Arial"/>
                <a:cs typeface="Arial"/>
              </a:rPr>
              <a:t>++++</a:t>
            </a:r>
            <a:r>
              <a:rPr dirty="0" baseline="5952" sz="2100" spc="-562">
                <a:solidFill>
                  <a:srgbClr val="E95359"/>
                </a:solidFill>
                <a:latin typeface="Arial"/>
                <a:cs typeface="Arial"/>
              </a:rPr>
              <a:t>++++++++++++++++++++</a:t>
            </a:r>
            <a:r>
              <a:rPr dirty="0" baseline="3968" sz="2100" spc="-562">
                <a:solidFill>
                  <a:srgbClr val="E95359"/>
                </a:solidFill>
                <a:latin typeface="Arial"/>
                <a:cs typeface="Arial"/>
              </a:rPr>
              <a:t>+++++++++++++++++++++++++++++++++++++++++++++++</a:t>
            </a:r>
            <a:endParaRPr baseline="3968" sz="2100">
              <a:latin typeface="Arial"/>
              <a:cs typeface="Arial"/>
            </a:endParaRPr>
          </a:p>
        </p:txBody>
      </p:sp>
      <p:sp>
        <p:nvSpPr>
          <p:cNvPr id="7" name="object 7" descr=""/>
          <p:cNvSpPr txBox="1"/>
          <p:nvPr/>
        </p:nvSpPr>
        <p:spPr>
          <a:xfrm>
            <a:off x="2798317" y="769493"/>
            <a:ext cx="7118984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7777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5793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21825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9841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7857" sz="2100" spc="-56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5873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3888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1904" sz="2100" spc="-562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9920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7936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5952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1984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968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5952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9920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5952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3968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984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-3968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5952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7936" sz="2100" spc="-562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5952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562">
                <a:solidFill>
                  <a:srgbClr val="DFD625"/>
                </a:solidFill>
                <a:latin typeface="Arial"/>
                <a:cs typeface="Arial"/>
              </a:rPr>
              <a:t>+++++</a:t>
            </a:r>
            <a:r>
              <a:rPr dirty="0" baseline="1984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1984" sz="2100" spc="-562">
                <a:solidFill>
                  <a:srgbClr val="DFD625"/>
                </a:solidFill>
                <a:latin typeface="Arial"/>
                <a:cs typeface="Arial"/>
              </a:rPr>
              <a:t>+++++</a:t>
            </a:r>
            <a:r>
              <a:rPr dirty="0" sz="1400" spc="-375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3968" sz="2100" spc="-562">
                <a:solidFill>
                  <a:srgbClr val="DFD625"/>
                </a:solidFill>
                <a:latin typeface="Arial"/>
                <a:cs typeface="Arial"/>
              </a:rPr>
              <a:t>+++++</a:t>
            </a:r>
            <a:r>
              <a:rPr dirty="0" baseline="-5952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11904" sz="2100" spc="-562">
                <a:solidFill>
                  <a:srgbClr val="41A3FF"/>
                </a:solidFill>
                <a:latin typeface="Arial"/>
                <a:cs typeface="Arial"/>
              </a:rPr>
              <a:t>++++++</a:t>
            </a:r>
            <a:r>
              <a:rPr dirty="0" baseline="9920" sz="2100" spc="-562">
                <a:solidFill>
                  <a:srgbClr val="41A3FF"/>
                </a:solidFill>
                <a:latin typeface="Arial"/>
                <a:cs typeface="Arial"/>
              </a:rPr>
              <a:t>+++++</a:t>
            </a:r>
            <a:r>
              <a:rPr dirty="0" baseline="7936" sz="2100" spc="-562">
                <a:solidFill>
                  <a:srgbClr val="41A3FF"/>
                </a:solidFill>
                <a:latin typeface="Arial"/>
                <a:cs typeface="Arial"/>
              </a:rPr>
              <a:t>+++</a:t>
            </a:r>
            <a:r>
              <a:rPr dirty="0" baseline="5952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3968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1984" sz="2100" spc="-562">
                <a:solidFill>
                  <a:srgbClr val="41A3FF"/>
                </a:solidFill>
                <a:latin typeface="Arial"/>
                <a:cs typeface="Arial"/>
              </a:rPr>
              <a:t>++++++++</a:t>
            </a:r>
            <a:r>
              <a:rPr dirty="0" sz="1400" spc="-375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1984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r>
              <a:rPr dirty="0" baseline="-3968" sz="2100" spc="-562">
                <a:solidFill>
                  <a:srgbClr val="41A3FF"/>
                </a:solidFill>
                <a:latin typeface="Arial"/>
                <a:cs typeface="Arial"/>
              </a:rPr>
              <a:t>+++++++</a:t>
            </a:r>
            <a:r>
              <a:rPr dirty="0" baseline="-5952" sz="2100" spc="-562">
                <a:solidFill>
                  <a:srgbClr val="41A3FF"/>
                </a:solidFill>
                <a:latin typeface="Arial"/>
                <a:cs typeface="Arial"/>
              </a:rPr>
              <a:t>++++++++++</a:t>
            </a:r>
            <a:r>
              <a:rPr dirty="0" baseline="-7936" sz="2100" spc="-562">
                <a:solidFill>
                  <a:srgbClr val="41A3FF"/>
                </a:solidFill>
                <a:latin typeface="Arial"/>
                <a:cs typeface="Arial"/>
              </a:rPr>
              <a:t>++</a:t>
            </a:r>
            <a:endParaRPr baseline="-7936" sz="2100">
              <a:latin typeface="Arial"/>
              <a:cs typeface="Arial"/>
            </a:endParaRPr>
          </a:p>
        </p:txBody>
      </p:sp>
      <p:sp>
        <p:nvSpPr>
          <p:cNvPr id="8" name="object 8" descr=""/>
          <p:cNvSpPr txBox="1"/>
          <p:nvPr/>
        </p:nvSpPr>
        <p:spPr>
          <a:xfrm>
            <a:off x="4590796" y="864869"/>
            <a:ext cx="492188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21825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9920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7936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984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75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984" sz="2100" spc="-56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3968" sz="2100" spc="-56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5952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7936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9920" sz="2100" spc="-56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1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5873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3888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1904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9920" sz="2100" spc="-562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7936" sz="2100" spc="-562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baseline="5952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984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sz="1400" spc="-375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-1984" sz="2100" spc="-562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-1984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5952" sz="2100" spc="-56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7936" sz="2100" spc="-56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15873" sz="2100" spc="-562">
                <a:solidFill>
                  <a:srgbClr val="DFD625"/>
                </a:solidFill>
                <a:latin typeface="Arial"/>
                <a:cs typeface="Arial"/>
              </a:rPr>
              <a:t>++++</a:t>
            </a:r>
            <a:r>
              <a:rPr dirty="0" baseline="13888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11904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9920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3968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1984" sz="2100" spc="-562">
                <a:solidFill>
                  <a:srgbClr val="DFD625"/>
                </a:solidFill>
                <a:latin typeface="Arial"/>
                <a:cs typeface="Arial"/>
              </a:rPr>
              <a:t>+++++++</a:t>
            </a:r>
            <a:r>
              <a:rPr dirty="0" baseline="-1984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3968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7936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9920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1904" sz="2100" spc="-562">
                <a:solidFill>
                  <a:srgbClr val="DFD625"/>
                </a:solidFill>
                <a:latin typeface="Arial"/>
                <a:cs typeface="Arial"/>
              </a:rPr>
              <a:t>++</a:t>
            </a:r>
            <a:r>
              <a:rPr dirty="0" baseline="-13888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5873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r>
              <a:rPr dirty="0" baseline="-17857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19841" sz="2100" spc="-562">
                <a:solidFill>
                  <a:srgbClr val="DFD625"/>
                </a:solidFill>
                <a:latin typeface="Arial"/>
                <a:cs typeface="Arial"/>
              </a:rPr>
              <a:t>+++</a:t>
            </a:r>
            <a:r>
              <a:rPr dirty="0" baseline="-23809" sz="2100" spc="-562">
                <a:solidFill>
                  <a:srgbClr val="DFD625"/>
                </a:solidFill>
                <a:latin typeface="Arial"/>
                <a:cs typeface="Arial"/>
              </a:rPr>
              <a:t>+</a:t>
            </a:r>
            <a:endParaRPr baseline="-23809" sz="2100">
              <a:latin typeface="Arial"/>
              <a:cs typeface="Arial"/>
            </a:endParaRPr>
          </a:p>
        </p:txBody>
      </p:sp>
      <p:sp>
        <p:nvSpPr>
          <p:cNvPr id="9" name="object 9" descr=""/>
          <p:cNvSpPr txBox="1"/>
          <p:nvPr/>
        </p:nvSpPr>
        <p:spPr>
          <a:xfrm>
            <a:off x="5573648" y="1018031"/>
            <a:ext cx="347599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35714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33730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1746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9761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7777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3809" sz="2100" spc="-53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9841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7857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5873" sz="2100" spc="-53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3888" sz="2100" spc="-53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9920" sz="2100" spc="-532">
                <a:solidFill>
                  <a:srgbClr val="BCA7E8"/>
                </a:solidFill>
                <a:latin typeface="Arial"/>
                <a:cs typeface="Arial"/>
              </a:rPr>
              <a:t>+++++</a:t>
            </a:r>
            <a:r>
              <a:rPr dirty="0" baseline="7936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5952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968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33730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23809" sz="2100" spc="-532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baseline="17857" sz="2100" spc="-532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baseline="11904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9920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5952" sz="2100" spc="-532">
                <a:solidFill>
                  <a:srgbClr val="4DCE6B"/>
                </a:solidFill>
                <a:latin typeface="Arial"/>
                <a:cs typeface="Arial"/>
              </a:rPr>
              <a:t>+++</a:t>
            </a:r>
            <a:r>
              <a:rPr dirty="0" baseline="3968" sz="2100" spc="-532">
                <a:solidFill>
                  <a:srgbClr val="4DCE6B"/>
                </a:solidFill>
                <a:latin typeface="Arial"/>
                <a:cs typeface="Arial"/>
              </a:rPr>
              <a:t>++++</a:t>
            </a:r>
            <a:r>
              <a:rPr dirty="0" sz="1400" spc="-355">
                <a:solidFill>
                  <a:srgbClr val="4DCE6B"/>
                </a:solidFill>
                <a:latin typeface="Arial"/>
                <a:cs typeface="Arial"/>
              </a:rPr>
              <a:t>+++++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10" name="object 10" descr=""/>
          <p:cNvSpPr txBox="1"/>
          <p:nvPr/>
        </p:nvSpPr>
        <p:spPr>
          <a:xfrm>
            <a:off x="7134859" y="1047368"/>
            <a:ext cx="3475990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7936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198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sz="1400" spc="-355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198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968" sz="2100" spc="-532">
                <a:solidFill>
                  <a:srgbClr val="BCA7E8"/>
                </a:solidFill>
                <a:latin typeface="Arial"/>
                <a:cs typeface="Arial"/>
              </a:rPr>
              <a:t>+++++</a:t>
            </a:r>
            <a:r>
              <a:rPr dirty="0" baseline="-5952" sz="2100" spc="-53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-9920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190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3888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19841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23809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27777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1746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3730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5714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-37698" sz="2100" spc="-53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39682" sz="2100" spc="-532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-41666" sz="2100" spc="-532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5952" sz="2100" spc="-532">
                <a:solidFill>
                  <a:srgbClr val="4DCE6B"/>
                </a:solidFill>
                <a:latin typeface="Arial"/>
                <a:cs typeface="Arial"/>
              </a:rPr>
              <a:t>+++++</a:t>
            </a:r>
            <a:r>
              <a:rPr dirty="0" baseline="1984" sz="2100" spc="-532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r>
              <a:rPr dirty="0" baseline="-3968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7936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13888" sz="2100" spc="-532">
                <a:solidFill>
                  <a:srgbClr val="4DCE6B"/>
                </a:solidFill>
                <a:latin typeface="Arial"/>
                <a:cs typeface="Arial"/>
              </a:rPr>
              <a:t>+++++++</a:t>
            </a:r>
            <a:r>
              <a:rPr dirty="0" baseline="-17857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23809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r>
              <a:rPr dirty="0" baseline="-29761" sz="2100" spc="-53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-35714" sz="2100" spc="-532">
                <a:solidFill>
                  <a:srgbClr val="4DCE6B"/>
                </a:solidFill>
                <a:latin typeface="Arial"/>
                <a:cs typeface="Arial"/>
              </a:rPr>
              <a:t>+</a:t>
            </a:r>
            <a:endParaRPr baseline="-35714" sz="2100">
              <a:latin typeface="Arial"/>
              <a:cs typeface="Arial"/>
            </a:endParaRPr>
          </a:p>
        </p:txBody>
      </p:sp>
      <p:sp>
        <p:nvSpPr>
          <p:cNvPr id="11" name="object 11" descr=""/>
          <p:cNvSpPr txBox="1"/>
          <p:nvPr/>
        </p:nvSpPr>
        <p:spPr>
          <a:xfrm>
            <a:off x="8869553" y="1257300"/>
            <a:ext cx="42856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19841" sz="2100" spc="-47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7857" sz="2100" spc="-47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13888" sz="2100" spc="-472">
                <a:solidFill>
                  <a:srgbClr val="BCA7E8"/>
                </a:solidFill>
                <a:latin typeface="Arial"/>
                <a:cs typeface="Arial"/>
              </a:rPr>
              <a:t>++++++++</a:t>
            </a:r>
            <a:r>
              <a:rPr dirty="0" baseline="11904" sz="2100" spc="-472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9920" sz="2100" spc="-47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3968" sz="2100" spc="-47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sz="1400" spc="-315">
                <a:solidFill>
                  <a:srgbClr val="BCA7E8"/>
                </a:solidFill>
                <a:latin typeface="Arial"/>
                <a:cs typeface="Arial"/>
              </a:rPr>
              <a:t>++++</a:t>
            </a:r>
            <a:r>
              <a:rPr dirty="0" baseline="-5952" sz="2100" spc="-47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-9920" sz="2100" spc="-472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7857" sz="2100" spc="-472">
                <a:solidFill>
                  <a:srgbClr val="4DCE6B"/>
                </a:solidFill>
                <a:latin typeface="Arial"/>
                <a:cs typeface="Arial"/>
              </a:rPr>
              <a:t>+++++++++</a:t>
            </a:r>
            <a:r>
              <a:rPr dirty="0" baseline="9920" sz="2100" spc="-472">
                <a:solidFill>
                  <a:srgbClr val="4DCE6B"/>
                </a:solidFill>
                <a:latin typeface="Arial"/>
                <a:cs typeface="Arial"/>
              </a:rPr>
              <a:t>++</a:t>
            </a:r>
            <a:r>
              <a:rPr dirty="0" baseline="1984" sz="2100" spc="-472">
                <a:solidFill>
                  <a:srgbClr val="4DCE6B"/>
                </a:solidFill>
                <a:latin typeface="Arial"/>
                <a:cs typeface="Arial"/>
              </a:rPr>
              <a:t>++++++++++++++++++</a:t>
            </a:r>
            <a:r>
              <a:rPr dirty="0" baseline="1984" sz="2100" spc="600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baseline="1984" sz="2100" spc="-487">
                <a:solidFill>
                  <a:srgbClr val="4DCE6B"/>
                </a:solidFill>
                <a:latin typeface="Arial"/>
                <a:cs typeface="Arial"/>
              </a:rPr>
              <a:t>+++++++</a:t>
            </a:r>
            <a:endParaRPr baseline="1984" sz="2100">
              <a:latin typeface="Arial"/>
              <a:cs typeface="Arial"/>
            </a:endParaRPr>
          </a:p>
        </p:txBody>
      </p:sp>
      <p:sp>
        <p:nvSpPr>
          <p:cNvPr id="12" name="object 12" descr=""/>
          <p:cNvSpPr txBox="1"/>
          <p:nvPr/>
        </p:nvSpPr>
        <p:spPr>
          <a:xfrm>
            <a:off x="10546333" y="1362075"/>
            <a:ext cx="492188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baseline="17857" sz="2100" spc="-480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13888" sz="2100" spc="-480">
                <a:solidFill>
                  <a:srgbClr val="BCA7E8"/>
                </a:solidFill>
                <a:latin typeface="Arial"/>
                <a:cs typeface="Arial"/>
              </a:rPr>
              <a:t>++++++++++</a:t>
            </a:r>
            <a:r>
              <a:rPr dirty="0" baseline="9920" sz="2100" spc="-480">
                <a:solidFill>
                  <a:srgbClr val="BCA7E8"/>
                </a:solidFill>
                <a:latin typeface="Arial"/>
                <a:cs typeface="Arial"/>
              </a:rPr>
              <a:t>++</a:t>
            </a:r>
            <a:r>
              <a:rPr dirty="0" baseline="5952" sz="2100" spc="-480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sz="1400" spc="-320">
                <a:solidFill>
                  <a:srgbClr val="BCA7E8"/>
                </a:solidFill>
                <a:latin typeface="Arial"/>
                <a:cs typeface="Arial"/>
              </a:rPr>
              <a:t>++++++++++++++++++</a:t>
            </a:r>
            <a:r>
              <a:rPr dirty="0" baseline="-9920" sz="2100" spc="-480">
                <a:solidFill>
                  <a:srgbClr val="BCA7E8"/>
                </a:solidFill>
                <a:latin typeface="Arial"/>
                <a:cs typeface="Arial"/>
              </a:rPr>
              <a:t>+++++++++</a:t>
            </a:r>
            <a:r>
              <a:rPr dirty="0" baseline="13888" sz="2100" spc="-480">
                <a:solidFill>
                  <a:srgbClr val="4DCE6B"/>
                </a:solidFill>
                <a:latin typeface="Arial"/>
                <a:cs typeface="Arial"/>
              </a:rPr>
              <a:t>+++++++++++++</a:t>
            </a:r>
            <a:r>
              <a:rPr dirty="0" baseline="-19841" sz="2100" spc="-480">
                <a:solidFill>
                  <a:srgbClr val="4DCE6B"/>
                </a:solidFill>
                <a:latin typeface="Arial"/>
                <a:cs typeface="Arial"/>
              </a:rPr>
              <a:t>++++++</a:t>
            </a:r>
            <a:r>
              <a:rPr dirty="0" baseline="-19841" sz="2100" spc="607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baseline="-19841" sz="2100" spc="-300">
                <a:solidFill>
                  <a:srgbClr val="4DCE6B"/>
                </a:solidFill>
                <a:latin typeface="Arial"/>
                <a:cs typeface="Arial"/>
              </a:rPr>
              <a:t>++++++++++</a:t>
            </a:r>
            <a:endParaRPr baseline="-19841" sz="2100">
              <a:latin typeface="Arial"/>
              <a:cs typeface="Arial"/>
            </a:endParaRPr>
          </a:p>
        </p:txBody>
      </p:sp>
      <p:sp>
        <p:nvSpPr>
          <p:cNvPr id="13" name="object 13" descr=""/>
          <p:cNvSpPr txBox="1"/>
          <p:nvPr/>
        </p:nvSpPr>
        <p:spPr>
          <a:xfrm>
            <a:off x="13077825" y="1515109"/>
            <a:ext cx="256349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50800">
              <a:lnSpc>
                <a:spcPct val="100000"/>
              </a:lnSpc>
              <a:spcBef>
                <a:spcPts val="100"/>
              </a:spcBef>
              <a:tabLst>
                <a:tab pos="2363470" algn="l"/>
              </a:tabLst>
            </a:pPr>
            <a:r>
              <a:rPr dirty="0" baseline="23809" sz="2100">
                <a:solidFill>
                  <a:srgbClr val="BCA7E8"/>
                </a:solidFill>
                <a:latin typeface="Arial"/>
                <a:cs typeface="Arial"/>
              </a:rPr>
              <a:t>+</a:t>
            </a:r>
            <a:r>
              <a:rPr dirty="0" baseline="23809" sz="2100" spc="225">
                <a:solidFill>
                  <a:srgbClr val="BCA7E8"/>
                </a:solidFill>
                <a:latin typeface="Arial"/>
                <a:cs typeface="Arial"/>
              </a:rPr>
              <a:t> </a:t>
            </a:r>
            <a:r>
              <a:rPr dirty="0" baseline="23809" sz="2100" spc="-359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baseline="23809" sz="2100" spc="225">
                <a:solidFill>
                  <a:srgbClr val="BCA7E8"/>
                </a:solidFill>
                <a:latin typeface="Arial"/>
                <a:cs typeface="Arial"/>
              </a:rPr>
              <a:t> </a:t>
            </a:r>
            <a:r>
              <a:rPr dirty="0" baseline="23809" sz="2100" spc="-15">
                <a:solidFill>
                  <a:srgbClr val="BCA7E8"/>
                </a:solidFill>
                <a:latin typeface="Arial"/>
                <a:cs typeface="Arial"/>
              </a:rPr>
              <a:t>+++</a:t>
            </a:r>
            <a:r>
              <a:rPr dirty="0" sz="1400" spc="-10">
                <a:solidFill>
                  <a:srgbClr val="BCA7E8"/>
                </a:solidFill>
                <a:latin typeface="Arial"/>
                <a:cs typeface="Arial"/>
              </a:rPr>
              <a:t>++++++++++++++</a:t>
            </a:r>
            <a:r>
              <a:rPr dirty="0" sz="1400">
                <a:solidFill>
                  <a:srgbClr val="BCA7E8"/>
                </a:solidFill>
                <a:latin typeface="Arial"/>
                <a:cs typeface="Arial"/>
              </a:rPr>
              <a:t>	</a:t>
            </a:r>
            <a:r>
              <a:rPr dirty="0" sz="1400" spc="-65">
                <a:solidFill>
                  <a:srgbClr val="BCA7E8"/>
                </a:solidFill>
                <a:latin typeface="Arial"/>
                <a:cs typeface="Arial"/>
              </a:rPr>
              <a:t>++</a:t>
            </a:r>
            <a:endParaRPr sz="1400">
              <a:latin typeface="Arial"/>
              <a:cs typeface="Arial"/>
            </a:endParaRPr>
          </a:p>
        </p:txBody>
      </p:sp>
      <p:sp>
        <p:nvSpPr>
          <p:cNvPr id="14" name="object 14" descr=""/>
          <p:cNvSpPr txBox="1"/>
          <p:nvPr/>
        </p:nvSpPr>
        <p:spPr>
          <a:xfrm>
            <a:off x="1776983" y="3374897"/>
            <a:ext cx="87121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latin typeface="Arial"/>
                <a:cs typeface="Arial"/>
              </a:rPr>
              <a:t>p &lt; </a:t>
            </a:r>
            <a:r>
              <a:rPr dirty="0" sz="1400" spc="-10">
                <a:latin typeface="Arial"/>
                <a:cs typeface="Arial"/>
              </a:rPr>
              <a:t>0.0001</a:t>
            </a:r>
            <a:endParaRPr sz="1400">
              <a:latin typeface="Arial"/>
              <a:cs typeface="Arial"/>
            </a:endParaRPr>
          </a:p>
        </p:txBody>
      </p:sp>
      <p:sp>
        <p:nvSpPr>
          <p:cNvPr id="15" name="object 15" descr=""/>
          <p:cNvSpPr txBox="1"/>
          <p:nvPr/>
        </p:nvSpPr>
        <p:spPr>
          <a:xfrm>
            <a:off x="1776983" y="3048000"/>
            <a:ext cx="77025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10">
                <a:latin typeface="Arial"/>
                <a:cs typeface="Arial"/>
              </a:rPr>
              <a:t>Log−rank</a:t>
            </a:r>
            <a:endParaRPr sz="1400">
              <a:latin typeface="Arial"/>
              <a:cs typeface="Arial"/>
            </a:endParaRPr>
          </a:p>
        </p:txBody>
      </p:sp>
      <p:sp>
        <p:nvSpPr>
          <p:cNvPr id="16" name="object 16" descr=""/>
          <p:cNvSpPr txBox="1"/>
          <p:nvPr/>
        </p:nvSpPr>
        <p:spPr>
          <a:xfrm>
            <a:off x="286258" y="3088766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</a:t>
            </a:r>
            <a:endParaRPr sz="900">
              <a:latin typeface="Arial"/>
              <a:cs typeface="Arial"/>
            </a:endParaRPr>
          </a:p>
        </p:txBody>
      </p:sp>
      <p:sp>
        <p:nvSpPr>
          <p:cNvPr id="17" name="object 17" descr=""/>
          <p:cNvSpPr txBox="1"/>
          <p:nvPr/>
        </p:nvSpPr>
        <p:spPr>
          <a:xfrm>
            <a:off x="286258" y="2271394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8" name="object 18" descr=""/>
          <p:cNvSpPr txBox="1"/>
          <p:nvPr/>
        </p:nvSpPr>
        <p:spPr>
          <a:xfrm>
            <a:off x="286258" y="1454022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75</a:t>
            </a:r>
            <a:endParaRPr sz="900">
              <a:latin typeface="Arial"/>
              <a:cs typeface="Arial"/>
            </a:endParaRPr>
          </a:p>
        </p:txBody>
      </p:sp>
      <p:sp>
        <p:nvSpPr>
          <p:cNvPr id="19" name="object 19" descr=""/>
          <p:cNvSpPr txBox="1"/>
          <p:nvPr/>
        </p:nvSpPr>
        <p:spPr>
          <a:xfrm>
            <a:off x="222758" y="636778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20" name="object 20" descr=""/>
          <p:cNvSpPr/>
          <p:nvPr/>
        </p:nvSpPr>
        <p:spPr>
          <a:xfrm>
            <a:off x="453898" y="722756"/>
            <a:ext cx="15213330" cy="3296285"/>
          </a:xfrm>
          <a:custGeom>
            <a:avLst/>
            <a:gdLst/>
            <a:ahLst/>
            <a:cxnLst/>
            <a:rect l="l" t="t" r="r" b="b"/>
            <a:pathLst>
              <a:path w="15213330" h="3296285">
                <a:moveTo>
                  <a:pt x="0" y="2451989"/>
                </a:moveTo>
                <a:lnTo>
                  <a:pt x="34797" y="2451989"/>
                </a:lnTo>
              </a:path>
              <a:path w="15213330" h="3296285">
                <a:moveTo>
                  <a:pt x="0" y="1634617"/>
                </a:moveTo>
                <a:lnTo>
                  <a:pt x="34797" y="1634617"/>
                </a:lnTo>
              </a:path>
              <a:path w="15213330" h="3296285">
                <a:moveTo>
                  <a:pt x="0" y="817245"/>
                </a:moveTo>
                <a:lnTo>
                  <a:pt x="34797" y="817245"/>
                </a:lnTo>
              </a:path>
              <a:path w="15213330" h="3296285">
                <a:moveTo>
                  <a:pt x="0" y="0"/>
                </a:moveTo>
                <a:lnTo>
                  <a:pt x="34797" y="0"/>
                </a:lnTo>
              </a:path>
              <a:path w="15213330" h="3296285">
                <a:moveTo>
                  <a:pt x="757555" y="3295904"/>
                </a:moveTo>
                <a:lnTo>
                  <a:pt x="757555" y="3261106"/>
                </a:lnTo>
              </a:path>
              <a:path w="15213330" h="3296285">
                <a:moveTo>
                  <a:pt x="3648710" y="3295904"/>
                </a:moveTo>
                <a:lnTo>
                  <a:pt x="3648710" y="3261106"/>
                </a:lnTo>
              </a:path>
              <a:path w="15213330" h="3296285">
                <a:moveTo>
                  <a:pt x="6539737" y="3295904"/>
                </a:moveTo>
                <a:lnTo>
                  <a:pt x="6539737" y="3261106"/>
                </a:lnTo>
              </a:path>
              <a:path w="15213330" h="3296285">
                <a:moveTo>
                  <a:pt x="9430766" y="3295904"/>
                </a:moveTo>
                <a:lnTo>
                  <a:pt x="9430766" y="3261106"/>
                </a:lnTo>
              </a:path>
              <a:path w="15213330" h="3296285">
                <a:moveTo>
                  <a:pt x="12321921" y="3295904"/>
                </a:moveTo>
                <a:lnTo>
                  <a:pt x="12321921" y="3261106"/>
                </a:lnTo>
              </a:path>
              <a:path w="15213330" h="3296285">
                <a:moveTo>
                  <a:pt x="15212948" y="3295904"/>
                </a:moveTo>
                <a:lnTo>
                  <a:pt x="15212948" y="3261106"/>
                </a:lnTo>
              </a:path>
            </a:pathLst>
          </a:custGeom>
          <a:ln w="13589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" name="object 21" descr=""/>
          <p:cNvSpPr txBox="1"/>
          <p:nvPr/>
        </p:nvSpPr>
        <p:spPr>
          <a:xfrm>
            <a:off x="1167002" y="400151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22" name="object 22" descr=""/>
          <p:cNvSpPr txBox="1"/>
          <p:nvPr/>
        </p:nvSpPr>
        <p:spPr>
          <a:xfrm>
            <a:off x="4026280" y="400151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23" name="object 23" descr=""/>
          <p:cNvSpPr txBox="1"/>
          <p:nvPr/>
        </p:nvSpPr>
        <p:spPr>
          <a:xfrm>
            <a:off x="6885558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24" name="object 24" descr=""/>
          <p:cNvSpPr txBox="1"/>
          <p:nvPr/>
        </p:nvSpPr>
        <p:spPr>
          <a:xfrm>
            <a:off x="9776714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25" name="object 25" descr=""/>
          <p:cNvSpPr txBox="1"/>
          <p:nvPr/>
        </p:nvSpPr>
        <p:spPr>
          <a:xfrm>
            <a:off x="12667742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26" name="object 26" descr=""/>
          <p:cNvSpPr txBox="1"/>
          <p:nvPr/>
        </p:nvSpPr>
        <p:spPr>
          <a:xfrm>
            <a:off x="15558769" y="400151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27" name="object 27" descr=""/>
          <p:cNvSpPr txBox="1"/>
          <p:nvPr/>
        </p:nvSpPr>
        <p:spPr>
          <a:xfrm>
            <a:off x="8271256" y="4136390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8" name="object 28" descr=""/>
          <p:cNvSpPr txBox="1"/>
          <p:nvPr/>
        </p:nvSpPr>
        <p:spPr>
          <a:xfrm>
            <a:off x="30759" y="1548175"/>
            <a:ext cx="181610" cy="145478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>
                <a:latin typeface="Arial"/>
                <a:cs typeface="Arial"/>
              </a:rPr>
              <a:t>Survival probability </a:t>
            </a:r>
            <a:r>
              <a:rPr dirty="0" sz="1100" spc="-25">
                <a:latin typeface="Arial"/>
                <a:cs typeface="Arial"/>
              </a:rPr>
              <a:t>(%)</a:t>
            </a:r>
            <a:endParaRPr sz="1100">
              <a:latin typeface="Arial"/>
              <a:cs typeface="Arial"/>
            </a:endParaRPr>
          </a:p>
        </p:txBody>
      </p:sp>
      <p:sp>
        <p:nvSpPr>
          <p:cNvPr id="29" name="object 29" descr=""/>
          <p:cNvSpPr/>
          <p:nvPr/>
        </p:nvSpPr>
        <p:spPr>
          <a:xfrm>
            <a:off x="6085459" y="148209"/>
            <a:ext cx="201930" cy="201930"/>
          </a:xfrm>
          <a:custGeom>
            <a:avLst/>
            <a:gdLst/>
            <a:ahLst/>
            <a:cxnLst/>
            <a:rect l="l" t="t" r="r" b="b"/>
            <a:pathLst>
              <a:path w="201929" h="201929">
                <a:moveTo>
                  <a:pt x="201422" y="0"/>
                </a:moveTo>
                <a:lnTo>
                  <a:pt x="0" y="0"/>
                </a:lnTo>
                <a:lnTo>
                  <a:pt x="0" y="201422"/>
                </a:lnTo>
                <a:lnTo>
                  <a:pt x="201422" y="201422"/>
                </a:lnTo>
                <a:lnTo>
                  <a:pt x="201422" y="0"/>
                </a:lnTo>
                <a:close/>
              </a:path>
            </a:pathLst>
          </a:custGeom>
          <a:solidFill>
            <a:srgbClr val="E95359">
              <a:alpha val="29798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30" name="object 30" descr=""/>
          <p:cNvSpPr txBox="1"/>
          <p:nvPr/>
        </p:nvSpPr>
        <p:spPr>
          <a:xfrm>
            <a:off x="5242178" y="108584"/>
            <a:ext cx="10090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eeth </a:t>
            </a:r>
            <a:r>
              <a:rPr dirty="0" sz="1100">
                <a:latin typeface="Arial"/>
                <a:cs typeface="Arial"/>
              </a:rPr>
              <a:t>status</a:t>
            </a:r>
            <a:r>
              <a:rPr dirty="0" sz="1100" spc="395">
                <a:latin typeface="Arial"/>
                <a:cs typeface="Arial"/>
              </a:rPr>
              <a:t> </a:t>
            </a:r>
            <a:r>
              <a:rPr dirty="0" baseline="1984" sz="2100" spc="-165" strike="sngStrike">
                <a:solidFill>
                  <a:srgbClr val="E95359"/>
                </a:solidFill>
                <a:latin typeface="Arial"/>
                <a:cs typeface="Arial"/>
              </a:rPr>
              <a:t> </a:t>
            </a:r>
            <a:r>
              <a:rPr dirty="0" baseline="1984" sz="2100" spc="-75" strike="sngStrike">
                <a:solidFill>
                  <a:srgbClr val="E95359"/>
                </a:solidFill>
                <a:latin typeface="Arial"/>
                <a:cs typeface="Arial"/>
              </a:rPr>
              <a:t>+</a:t>
            </a:r>
            <a:endParaRPr baseline="1984" sz="2100">
              <a:latin typeface="Arial"/>
              <a:cs typeface="Arial"/>
            </a:endParaRPr>
          </a:p>
        </p:txBody>
      </p:sp>
      <p:grpSp>
        <p:nvGrpSpPr>
          <p:cNvPr id="31" name="object 31" descr=""/>
          <p:cNvGrpSpPr/>
          <p:nvPr/>
        </p:nvGrpSpPr>
        <p:grpSpPr>
          <a:xfrm>
            <a:off x="7396988" y="148209"/>
            <a:ext cx="201930" cy="201930"/>
            <a:chOff x="7396988" y="148209"/>
            <a:chExt cx="201930" cy="201930"/>
          </a:xfrm>
        </p:grpSpPr>
        <p:sp>
          <p:nvSpPr>
            <p:cNvPr id="32" name="object 32" descr=""/>
            <p:cNvSpPr/>
            <p:nvPr/>
          </p:nvSpPr>
          <p:spPr>
            <a:xfrm>
              <a:off x="7409942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3" y="0"/>
                  </a:lnTo>
                </a:path>
              </a:pathLst>
            </a:custGeom>
            <a:ln w="27051">
              <a:solidFill>
                <a:srgbClr val="41A3FF"/>
              </a:solidFill>
              <a:prstDash val="dash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3" name="object 33" descr=""/>
            <p:cNvSpPr/>
            <p:nvPr/>
          </p:nvSpPr>
          <p:spPr>
            <a:xfrm>
              <a:off x="7396988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41A3FF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34" name="object 34" descr=""/>
          <p:cNvSpPr txBox="1"/>
          <p:nvPr/>
        </p:nvSpPr>
        <p:spPr>
          <a:xfrm>
            <a:off x="7433056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41A3FF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35" name="object 35" descr=""/>
          <p:cNvGrpSpPr/>
          <p:nvPr/>
        </p:nvGrpSpPr>
        <p:grpSpPr>
          <a:xfrm>
            <a:off x="8269223" y="148209"/>
            <a:ext cx="201930" cy="201930"/>
            <a:chOff x="8269223" y="148209"/>
            <a:chExt cx="201930" cy="201930"/>
          </a:xfrm>
        </p:grpSpPr>
        <p:sp>
          <p:nvSpPr>
            <p:cNvPr id="36" name="object 36" descr=""/>
            <p:cNvSpPr/>
            <p:nvPr/>
          </p:nvSpPr>
          <p:spPr>
            <a:xfrm>
              <a:off x="8282177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27051">
              <a:solidFill>
                <a:srgbClr val="DFD625"/>
              </a:solidFill>
              <a:prstDash val="dot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7" name="object 37" descr=""/>
            <p:cNvSpPr/>
            <p:nvPr/>
          </p:nvSpPr>
          <p:spPr>
            <a:xfrm>
              <a:off x="8269223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DFD625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38" name="object 38" descr=""/>
          <p:cNvSpPr txBox="1"/>
          <p:nvPr/>
        </p:nvSpPr>
        <p:spPr>
          <a:xfrm>
            <a:off x="8305292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DFD625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39" name="object 39" descr=""/>
          <p:cNvGrpSpPr/>
          <p:nvPr/>
        </p:nvGrpSpPr>
        <p:grpSpPr>
          <a:xfrm>
            <a:off x="9542653" y="148209"/>
            <a:ext cx="201930" cy="201930"/>
            <a:chOff x="9542653" y="148209"/>
            <a:chExt cx="201930" cy="201930"/>
          </a:xfrm>
        </p:grpSpPr>
        <p:sp>
          <p:nvSpPr>
            <p:cNvPr id="40" name="object 40" descr=""/>
            <p:cNvSpPr/>
            <p:nvPr/>
          </p:nvSpPr>
          <p:spPr>
            <a:xfrm>
              <a:off x="9555607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27051">
              <a:solidFill>
                <a:srgbClr val="4DCE6B"/>
              </a:solidFill>
              <a:prstDash val="dot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1" name="object 41" descr=""/>
            <p:cNvSpPr/>
            <p:nvPr/>
          </p:nvSpPr>
          <p:spPr>
            <a:xfrm>
              <a:off x="9542653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4DCE6B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42" name="object 42" descr=""/>
          <p:cNvSpPr txBox="1"/>
          <p:nvPr/>
        </p:nvSpPr>
        <p:spPr>
          <a:xfrm>
            <a:off x="9578720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4DCE6B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43" name="object 43" descr=""/>
          <p:cNvGrpSpPr/>
          <p:nvPr/>
        </p:nvGrpSpPr>
        <p:grpSpPr>
          <a:xfrm>
            <a:off x="10778108" y="148209"/>
            <a:ext cx="201930" cy="201930"/>
            <a:chOff x="10778108" y="148209"/>
            <a:chExt cx="201930" cy="201930"/>
          </a:xfrm>
        </p:grpSpPr>
        <p:sp>
          <p:nvSpPr>
            <p:cNvPr id="44" name="object 44" descr=""/>
            <p:cNvSpPr/>
            <p:nvPr/>
          </p:nvSpPr>
          <p:spPr>
            <a:xfrm>
              <a:off x="10791062" y="24891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 h="0">
                  <a:moveTo>
                    <a:pt x="0" y="0"/>
                  </a:moveTo>
                  <a:lnTo>
                    <a:pt x="175513" y="0"/>
                  </a:lnTo>
                </a:path>
              </a:pathLst>
            </a:custGeom>
            <a:ln w="27051">
              <a:solidFill>
                <a:srgbClr val="BCA7E8"/>
              </a:solidFill>
              <a:prstDash val="sysDash"/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5" name="object 45" descr=""/>
            <p:cNvSpPr/>
            <p:nvPr/>
          </p:nvSpPr>
          <p:spPr>
            <a:xfrm>
              <a:off x="10778108" y="148209"/>
              <a:ext cx="201930" cy="201930"/>
            </a:xfrm>
            <a:custGeom>
              <a:avLst/>
              <a:gdLst/>
              <a:ahLst/>
              <a:cxnLst/>
              <a:rect l="l" t="t" r="r" b="b"/>
              <a:pathLst>
                <a:path w="201929" h="201929">
                  <a:moveTo>
                    <a:pt x="201422" y="0"/>
                  </a:moveTo>
                  <a:lnTo>
                    <a:pt x="0" y="0"/>
                  </a:lnTo>
                  <a:lnTo>
                    <a:pt x="0" y="201422"/>
                  </a:lnTo>
                  <a:lnTo>
                    <a:pt x="201422" y="201422"/>
                  </a:lnTo>
                  <a:lnTo>
                    <a:pt x="201422" y="0"/>
                  </a:lnTo>
                  <a:close/>
                </a:path>
              </a:pathLst>
            </a:custGeom>
            <a:solidFill>
              <a:srgbClr val="BCA7E8">
                <a:alpha val="29798"/>
              </a:srgbClr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46" name="object 46" descr=""/>
          <p:cNvSpPr txBox="1"/>
          <p:nvPr/>
        </p:nvSpPr>
        <p:spPr>
          <a:xfrm>
            <a:off x="10814177" y="103251"/>
            <a:ext cx="129539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>
                <a:solidFill>
                  <a:srgbClr val="BCA7E8"/>
                </a:solidFill>
                <a:latin typeface="Arial"/>
                <a:cs typeface="Arial"/>
              </a:rPr>
              <a:t>+</a:t>
            </a:r>
            <a:endParaRPr sz="1400">
              <a:latin typeface="Arial"/>
              <a:cs typeface="Arial"/>
            </a:endParaRPr>
          </a:p>
        </p:txBody>
      </p:sp>
      <p:sp>
        <p:nvSpPr>
          <p:cNvPr id="47" name="object 47" descr=""/>
          <p:cNvSpPr txBox="1"/>
          <p:nvPr/>
        </p:nvSpPr>
        <p:spPr>
          <a:xfrm>
            <a:off x="6352794" y="162941"/>
            <a:ext cx="978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latin typeface="Arial"/>
                <a:cs typeface="Arial"/>
              </a:rPr>
              <a:t>Complete </a:t>
            </a:r>
            <a:r>
              <a:rPr dirty="0" sz="900" spc="-10">
                <a:latin typeface="Arial"/>
                <a:cs typeface="Arial"/>
              </a:rPr>
              <a:t>denti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48" name="object 48" descr=""/>
          <p:cNvSpPr txBox="1"/>
          <p:nvPr/>
        </p:nvSpPr>
        <p:spPr>
          <a:xfrm>
            <a:off x="7664322" y="162941"/>
            <a:ext cx="53911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0">
                <a:latin typeface="Arial"/>
                <a:cs typeface="Arial"/>
              </a:rPr>
              <a:t>Tooth</a:t>
            </a:r>
            <a:r>
              <a:rPr dirty="0" sz="900" spc="-10">
                <a:latin typeface="Arial"/>
                <a:cs typeface="Arial"/>
              </a:rPr>
              <a:t> </a:t>
            </a:r>
            <a:r>
              <a:rPr dirty="0" sz="900" spc="-20"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49" name="object 49" descr=""/>
          <p:cNvSpPr txBox="1"/>
          <p:nvPr/>
        </p:nvSpPr>
        <p:spPr>
          <a:xfrm>
            <a:off x="8536558" y="162941"/>
            <a:ext cx="9404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latin typeface="Arial"/>
                <a:cs typeface="Arial"/>
              </a:rPr>
              <a:t>Lacking </a:t>
            </a:r>
            <a:r>
              <a:rPr dirty="0" sz="900" spc="-10">
                <a:latin typeface="Arial"/>
                <a:cs typeface="Arial"/>
              </a:rPr>
              <a:t>functional</a:t>
            </a:r>
            <a:endParaRPr sz="900">
              <a:latin typeface="Arial"/>
              <a:cs typeface="Arial"/>
            </a:endParaRPr>
          </a:p>
        </p:txBody>
      </p:sp>
      <p:sp>
        <p:nvSpPr>
          <p:cNvPr id="50" name="object 50" descr=""/>
          <p:cNvSpPr txBox="1"/>
          <p:nvPr/>
        </p:nvSpPr>
        <p:spPr>
          <a:xfrm>
            <a:off x="9809988" y="162941"/>
            <a:ext cx="902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latin typeface="Arial"/>
                <a:cs typeface="Arial"/>
              </a:rPr>
              <a:t>Severe</a:t>
            </a:r>
            <a:r>
              <a:rPr dirty="0" sz="900" spc="-30">
                <a:latin typeface="Arial"/>
                <a:cs typeface="Arial"/>
              </a:rPr>
              <a:t> </a:t>
            </a:r>
            <a:r>
              <a:rPr dirty="0" sz="900">
                <a:latin typeface="Arial"/>
                <a:cs typeface="Arial"/>
              </a:rPr>
              <a:t>tooth</a:t>
            </a:r>
            <a:r>
              <a:rPr dirty="0" sz="900" spc="-25">
                <a:latin typeface="Arial"/>
                <a:cs typeface="Arial"/>
              </a:rPr>
              <a:t> </a:t>
            </a:r>
            <a:r>
              <a:rPr dirty="0" sz="900" spc="-20"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51" name="object 51" descr=""/>
          <p:cNvSpPr txBox="1"/>
          <p:nvPr/>
        </p:nvSpPr>
        <p:spPr>
          <a:xfrm>
            <a:off x="11045443" y="162941"/>
            <a:ext cx="59118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10">
                <a:latin typeface="Arial"/>
                <a:cs typeface="Arial"/>
              </a:rPr>
              <a:t>Edentulism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52" name="object 52" descr=""/>
          <p:cNvGrpSpPr/>
          <p:nvPr/>
        </p:nvGrpSpPr>
        <p:grpSpPr>
          <a:xfrm>
            <a:off x="1250950" y="4683125"/>
            <a:ext cx="15139035" cy="1678305"/>
            <a:chOff x="1250950" y="4683125"/>
            <a:chExt cx="15139035" cy="1678305"/>
          </a:xfrm>
        </p:grpSpPr>
        <p:sp>
          <p:nvSpPr>
            <p:cNvPr id="53" name="object 53" descr=""/>
            <p:cNvSpPr/>
            <p:nvPr/>
          </p:nvSpPr>
          <p:spPr>
            <a:xfrm>
              <a:off x="3315335" y="4683125"/>
              <a:ext cx="11010265" cy="1678305"/>
            </a:xfrm>
            <a:custGeom>
              <a:avLst/>
              <a:gdLst/>
              <a:ahLst/>
              <a:cxnLst/>
              <a:rect l="l" t="t" r="r" b="b"/>
              <a:pathLst>
                <a:path w="11010265" h="1678304">
                  <a:moveTo>
                    <a:pt x="0" y="1678177"/>
                  </a:moveTo>
                  <a:lnTo>
                    <a:pt x="0" y="0"/>
                  </a:lnTo>
                </a:path>
                <a:path w="11010265" h="1678304">
                  <a:moveTo>
                    <a:pt x="2752470" y="1678177"/>
                  </a:moveTo>
                  <a:lnTo>
                    <a:pt x="2752470" y="0"/>
                  </a:lnTo>
                </a:path>
                <a:path w="11010265" h="1678304">
                  <a:moveTo>
                    <a:pt x="5504942" y="1678177"/>
                  </a:moveTo>
                  <a:lnTo>
                    <a:pt x="5504942" y="0"/>
                  </a:lnTo>
                </a:path>
                <a:path w="11010265" h="1678304">
                  <a:moveTo>
                    <a:pt x="8257413" y="1678177"/>
                  </a:moveTo>
                  <a:lnTo>
                    <a:pt x="8257413" y="0"/>
                  </a:lnTo>
                </a:path>
                <a:path w="11010265" h="1678304">
                  <a:moveTo>
                    <a:pt x="11009884" y="1678177"/>
                  </a:moveTo>
                  <a:lnTo>
                    <a:pt x="11009884" y="0"/>
                  </a:lnTo>
                </a:path>
              </a:pathLst>
            </a:custGeom>
            <a:ln w="6731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4" name="object 54" descr=""/>
            <p:cNvSpPr/>
            <p:nvPr/>
          </p:nvSpPr>
          <p:spPr>
            <a:xfrm>
              <a:off x="1250950" y="4683125"/>
              <a:ext cx="15139035" cy="1678305"/>
            </a:xfrm>
            <a:custGeom>
              <a:avLst/>
              <a:gdLst/>
              <a:ahLst/>
              <a:cxnLst/>
              <a:rect l="l" t="t" r="r" b="b"/>
              <a:pathLst>
                <a:path w="15139035" h="1678304">
                  <a:moveTo>
                    <a:pt x="0" y="1484502"/>
                  </a:moveTo>
                  <a:lnTo>
                    <a:pt x="15138654" y="1484502"/>
                  </a:lnTo>
                </a:path>
                <a:path w="15139035" h="1678304">
                  <a:moveTo>
                    <a:pt x="0" y="1161796"/>
                  </a:moveTo>
                  <a:lnTo>
                    <a:pt x="15138654" y="1161796"/>
                  </a:lnTo>
                </a:path>
                <a:path w="15139035" h="1678304">
                  <a:moveTo>
                    <a:pt x="0" y="839088"/>
                  </a:moveTo>
                  <a:lnTo>
                    <a:pt x="15138654" y="839088"/>
                  </a:lnTo>
                </a:path>
                <a:path w="15139035" h="1678304">
                  <a:moveTo>
                    <a:pt x="0" y="516382"/>
                  </a:moveTo>
                  <a:lnTo>
                    <a:pt x="15138654" y="516382"/>
                  </a:lnTo>
                </a:path>
                <a:path w="15139035" h="1678304">
                  <a:moveTo>
                    <a:pt x="0" y="193675"/>
                  </a:moveTo>
                  <a:lnTo>
                    <a:pt x="15138654" y="193675"/>
                  </a:lnTo>
                </a:path>
                <a:path w="15139035" h="1678304">
                  <a:moveTo>
                    <a:pt x="688086" y="1678177"/>
                  </a:moveTo>
                  <a:lnTo>
                    <a:pt x="688086" y="0"/>
                  </a:lnTo>
                </a:path>
                <a:path w="15139035" h="1678304">
                  <a:moveTo>
                    <a:pt x="3440684" y="1678177"/>
                  </a:moveTo>
                  <a:lnTo>
                    <a:pt x="3440684" y="0"/>
                  </a:lnTo>
                </a:path>
                <a:path w="15139035" h="1678304">
                  <a:moveTo>
                    <a:pt x="6193155" y="1678177"/>
                  </a:moveTo>
                  <a:lnTo>
                    <a:pt x="6193155" y="0"/>
                  </a:lnTo>
                </a:path>
                <a:path w="15139035" h="1678304">
                  <a:moveTo>
                    <a:pt x="8945626" y="1678177"/>
                  </a:moveTo>
                  <a:lnTo>
                    <a:pt x="8945626" y="0"/>
                  </a:lnTo>
                </a:path>
                <a:path w="15139035" h="1678304">
                  <a:moveTo>
                    <a:pt x="11698097" y="1678177"/>
                  </a:moveTo>
                  <a:lnTo>
                    <a:pt x="11698097" y="0"/>
                  </a:lnTo>
                </a:path>
                <a:path w="15139035" h="1678304">
                  <a:moveTo>
                    <a:pt x="14450567" y="1678177"/>
                  </a:moveTo>
                  <a:lnTo>
                    <a:pt x="14450567" y="0"/>
                  </a:lnTo>
                </a:path>
              </a:pathLst>
            </a:custGeom>
            <a:ln w="13589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55" name="object 55" descr=""/>
          <p:cNvSpPr txBox="1"/>
          <p:nvPr/>
        </p:nvSpPr>
        <p:spPr>
          <a:xfrm>
            <a:off x="1619250" y="4782692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2245 </a:t>
            </a:r>
            <a:r>
              <a:rPr dirty="0" sz="1000" spc="-10">
                <a:solidFill>
                  <a:srgbClr val="E95359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6" name="object 56" descr=""/>
          <p:cNvSpPr txBox="1"/>
          <p:nvPr/>
        </p:nvSpPr>
        <p:spPr>
          <a:xfrm>
            <a:off x="4407153" y="4782692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1838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82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7" name="object 57" descr=""/>
          <p:cNvSpPr txBox="1"/>
          <p:nvPr/>
        </p:nvSpPr>
        <p:spPr>
          <a:xfrm>
            <a:off x="7159625" y="4782692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1311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58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8" name="object 58" descr=""/>
          <p:cNvSpPr txBox="1"/>
          <p:nvPr/>
        </p:nvSpPr>
        <p:spPr>
          <a:xfrm>
            <a:off x="9947402" y="4782692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821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3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9" name="object 59" descr=""/>
          <p:cNvSpPr txBox="1"/>
          <p:nvPr/>
        </p:nvSpPr>
        <p:spPr>
          <a:xfrm>
            <a:off x="12699872" y="4782692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333 </a:t>
            </a:r>
            <a:r>
              <a:rPr dirty="0" sz="1000" spc="-20">
                <a:solidFill>
                  <a:srgbClr val="E95359"/>
                </a:solidFill>
                <a:latin typeface="Arial"/>
                <a:cs typeface="Arial"/>
              </a:rPr>
              <a:t>(1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0" name="object 60" descr=""/>
          <p:cNvSpPr txBox="1"/>
          <p:nvPr/>
        </p:nvSpPr>
        <p:spPr>
          <a:xfrm>
            <a:off x="15558262" y="4782692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E95359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E95359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1" name="object 61" descr=""/>
          <p:cNvSpPr txBox="1"/>
          <p:nvPr/>
        </p:nvSpPr>
        <p:spPr>
          <a:xfrm>
            <a:off x="1619250" y="5105400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5029 </a:t>
            </a:r>
            <a:r>
              <a:rPr dirty="0" sz="1000" spc="-10">
                <a:solidFill>
                  <a:srgbClr val="41A3FF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2" name="object 62" descr=""/>
          <p:cNvSpPr txBox="1"/>
          <p:nvPr/>
        </p:nvSpPr>
        <p:spPr>
          <a:xfrm>
            <a:off x="4407153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3760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7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3" name="object 63" descr=""/>
          <p:cNvSpPr txBox="1"/>
          <p:nvPr/>
        </p:nvSpPr>
        <p:spPr>
          <a:xfrm>
            <a:off x="7159625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2369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4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4" name="object 64" descr=""/>
          <p:cNvSpPr txBox="1"/>
          <p:nvPr/>
        </p:nvSpPr>
        <p:spPr>
          <a:xfrm>
            <a:off x="9912095" y="510540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1254 </a:t>
            </a:r>
            <a:r>
              <a:rPr dirty="0" sz="1000" spc="-20">
                <a:solidFill>
                  <a:srgbClr val="41A3FF"/>
                </a:solidFill>
                <a:latin typeface="Arial"/>
                <a:cs typeface="Arial"/>
              </a:rPr>
              <a:t>(2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5" name="object 65" descr=""/>
          <p:cNvSpPr txBox="1"/>
          <p:nvPr/>
        </p:nvSpPr>
        <p:spPr>
          <a:xfrm>
            <a:off x="12735179" y="5105400"/>
            <a:ext cx="42799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474 </a:t>
            </a:r>
            <a:r>
              <a:rPr dirty="0" sz="1000" spc="-25">
                <a:solidFill>
                  <a:srgbClr val="41A3FF"/>
                </a:solidFill>
                <a:latin typeface="Arial"/>
                <a:cs typeface="Arial"/>
              </a:rPr>
              <a:t>(9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6" name="object 66" descr=""/>
          <p:cNvSpPr txBox="1"/>
          <p:nvPr/>
        </p:nvSpPr>
        <p:spPr>
          <a:xfrm>
            <a:off x="15558262" y="5105400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1A3FF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41A3FF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7" name="object 67" descr=""/>
          <p:cNvSpPr txBox="1"/>
          <p:nvPr/>
        </p:nvSpPr>
        <p:spPr>
          <a:xfrm>
            <a:off x="1619250" y="5428107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2246 </a:t>
            </a:r>
            <a:r>
              <a:rPr dirty="0" sz="1000" spc="-10">
                <a:solidFill>
                  <a:srgbClr val="DFD625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8" name="object 68" descr=""/>
          <p:cNvSpPr txBox="1"/>
          <p:nvPr/>
        </p:nvSpPr>
        <p:spPr>
          <a:xfrm>
            <a:off x="4407153" y="5428107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1595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71)</a:t>
            </a:r>
            <a:endParaRPr sz="1000">
              <a:latin typeface="Arial"/>
              <a:cs typeface="Arial"/>
            </a:endParaRPr>
          </a:p>
        </p:txBody>
      </p:sp>
      <p:sp>
        <p:nvSpPr>
          <p:cNvPr id="69" name="object 69" descr=""/>
          <p:cNvSpPr txBox="1"/>
          <p:nvPr/>
        </p:nvSpPr>
        <p:spPr>
          <a:xfrm>
            <a:off x="7194931" y="5428107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922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41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0" name="object 70" descr=""/>
          <p:cNvSpPr txBox="1"/>
          <p:nvPr/>
        </p:nvSpPr>
        <p:spPr>
          <a:xfrm>
            <a:off x="9947402" y="5428107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445 </a:t>
            </a:r>
            <a:r>
              <a:rPr dirty="0" sz="1000" spc="-20">
                <a:solidFill>
                  <a:srgbClr val="DFD625"/>
                </a:solidFill>
                <a:latin typeface="Arial"/>
                <a:cs typeface="Arial"/>
              </a:rPr>
              <a:t>(2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1" name="object 71" descr=""/>
          <p:cNvSpPr txBox="1"/>
          <p:nvPr/>
        </p:nvSpPr>
        <p:spPr>
          <a:xfrm>
            <a:off x="12735179" y="5428107"/>
            <a:ext cx="42799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139 </a:t>
            </a:r>
            <a:r>
              <a:rPr dirty="0" sz="1000" spc="-25">
                <a:solidFill>
                  <a:srgbClr val="DFD625"/>
                </a:solidFill>
                <a:latin typeface="Arial"/>
                <a:cs typeface="Arial"/>
              </a:rPr>
              <a:t>(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2" name="object 72" descr=""/>
          <p:cNvSpPr txBox="1"/>
          <p:nvPr/>
        </p:nvSpPr>
        <p:spPr>
          <a:xfrm>
            <a:off x="15558262" y="5428107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DFD625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DFD625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3" name="object 73" descr=""/>
          <p:cNvSpPr txBox="1"/>
          <p:nvPr/>
        </p:nvSpPr>
        <p:spPr>
          <a:xfrm>
            <a:off x="1619250" y="5750814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1073 </a:t>
            </a:r>
            <a:r>
              <a:rPr dirty="0" sz="1000" spc="-10">
                <a:solidFill>
                  <a:srgbClr val="4DCE6B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4" name="object 74" descr=""/>
          <p:cNvSpPr txBox="1"/>
          <p:nvPr/>
        </p:nvSpPr>
        <p:spPr>
          <a:xfrm>
            <a:off x="4442459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718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6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5" name="object 75" descr=""/>
          <p:cNvSpPr txBox="1"/>
          <p:nvPr/>
        </p:nvSpPr>
        <p:spPr>
          <a:xfrm>
            <a:off x="7194931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397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37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6" name="object 76" descr=""/>
          <p:cNvSpPr txBox="1"/>
          <p:nvPr/>
        </p:nvSpPr>
        <p:spPr>
          <a:xfrm>
            <a:off x="9947402" y="5750814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175 </a:t>
            </a:r>
            <a:r>
              <a:rPr dirty="0" sz="1000" spc="-20">
                <a:solidFill>
                  <a:srgbClr val="4DCE6B"/>
                </a:solidFill>
                <a:latin typeface="Arial"/>
                <a:cs typeface="Arial"/>
              </a:rPr>
              <a:t>(1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7" name="object 77" descr=""/>
          <p:cNvSpPr txBox="1"/>
          <p:nvPr/>
        </p:nvSpPr>
        <p:spPr>
          <a:xfrm>
            <a:off x="12770484" y="5750814"/>
            <a:ext cx="3575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49 </a:t>
            </a:r>
            <a:r>
              <a:rPr dirty="0" sz="1000" spc="-25">
                <a:solidFill>
                  <a:srgbClr val="4DCE6B"/>
                </a:solidFill>
                <a:latin typeface="Arial"/>
                <a:cs typeface="Arial"/>
              </a:rPr>
              <a:t>(5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8" name="object 78" descr=""/>
          <p:cNvSpPr txBox="1"/>
          <p:nvPr/>
        </p:nvSpPr>
        <p:spPr>
          <a:xfrm>
            <a:off x="15558262" y="5750814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4DCE6B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4DCE6B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79" name="object 79" descr=""/>
          <p:cNvSpPr txBox="1"/>
          <p:nvPr/>
        </p:nvSpPr>
        <p:spPr>
          <a:xfrm>
            <a:off x="1619250" y="6073520"/>
            <a:ext cx="64008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2046 </a:t>
            </a:r>
            <a:r>
              <a:rPr dirty="0" sz="1000" spc="-10">
                <a:solidFill>
                  <a:srgbClr val="BCA7E8"/>
                </a:solidFill>
                <a:latin typeface="Arial"/>
                <a:cs typeface="Arial"/>
              </a:rPr>
              <a:t>(10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0" name="object 80" descr=""/>
          <p:cNvSpPr txBox="1"/>
          <p:nvPr/>
        </p:nvSpPr>
        <p:spPr>
          <a:xfrm>
            <a:off x="4407153" y="6073520"/>
            <a:ext cx="56959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1349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66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1" name="object 81" descr=""/>
          <p:cNvSpPr txBox="1"/>
          <p:nvPr/>
        </p:nvSpPr>
        <p:spPr>
          <a:xfrm>
            <a:off x="7194931" y="6073520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691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3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2" name="object 82" descr=""/>
          <p:cNvSpPr txBox="1"/>
          <p:nvPr/>
        </p:nvSpPr>
        <p:spPr>
          <a:xfrm>
            <a:off x="9947402" y="6073520"/>
            <a:ext cx="49847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283 </a:t>
            </a:r>
            <a:r>
              <a:rPr dirty="0" sz="1000" spc="-20">
                <a:solidFill>
                  <a:srgbClr val="BCA7E8"/>
                </a:solidFill>
                <a:latin typeface="Arial"/>
                <a:cs typeface="Arial"/>
              </a:rPr>
              <a:t>(1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3" name="object 83" descr=""/>
          <p:cNvSpPr txBox="1"/>
          <p:nvPr/>
        </p:nvSpPr>
        <p:spPr>
          <a:xfrm>
            <a:off x="12770484" y="6073520"/>
            <a:ext cx="357505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76 </a:t>
            </a:r>
            <a:r>
              <a:rPr dirty="0" sz="1000" spc="-25">
                <a:solidFill>
                  <a:srgbClr val="BCA7E8"/>
                </a:solidFill>
                <a:latin typeface="Arial"/>
                <a:cs typeface="Arial"/>
              </a:rPr>
              <a:t>(4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4" name="object 84" descr=""/>
          <p:cNvSpPr txBox="1"/>
          <p:nvPr/>
        </p:nvSpPr>
        <p:spPr>
          <a:xfrm>
            <a:off x="15558262" y="6073520"/>
            <a:ext cx="287020" cy="17780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000">
                <a:solidFill>
                  <a:srgbClr val="BCA7E8"/>
                </a:solidFill>
                <a:latin typeface="Arial"/>
                <a:cs typeface="Arial"/>
              </a:rPr>
              <a:t>0 </a:t>
            </a:r>
            <a:r>
              <a:rPr dirty="0" sz="1000" spc="-25">
                <a:solidFill>
                  <a:srgbClr val="BCA7E8"/>
                </a:solidFill>
                <a:latin typeface="Arial"/>
                <a:cs typeface="Arial"/>
              </a:rPr>
              <a:t>(0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5" name="object 85" descr=""/>
          <p:cNvSpPr txBox="1"/>
          <p:nvPr/>
        </p:nvSpPr>
        <p:spPr>
          <a:xfrm>
            <a:off x="610362" y="6069076"/>
            <a:ext cx="59118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10">
                <a:solidFill>
                  <a:srgbClr val="BCA7E8"/>
                </a:solidFill>
                <a:latin typeface="Arial"/>
                <a:cs typeface="Arial"/>
              </a:rPr>
              <a:t>Edentulism</a:t>
            </a:r>
            <a:endParaRPr sz="900">
              <a:latin typeface="Arial"/>
              <a:cs typeface="Arial"/>
            </a:endParaRPr>
          </a:p>
        </p:txBody>
      </p:sp>
      <p:sp>
        <p:nvSpPr>
          <p:cNvPr id="86" name="object 86" descr=""/>
          <p:cNvSpPr txBox="1"/>
          <p:nvPr/>
        </p:nvSpPr>
        <p:spPr>
          <a:xfrm>
            <a:off x="298831" y="5746369"/>
            <a:ext cx="902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CE6B"/>
                </a:solidFill>
                <a:latin typeface="Arial"/>
                <a:cs typeface="Arial"/>
              </a:rPr>
              <a:t>Severe</a:t>
            </a:r>
            <a:r>
              <a:rPr dirty="0" sz="900" spc="-3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900">
                <a:solidFill>
                  <a:srgbClr val="4DCE6B"/>
                </a:solidFill>
                <a:latin typeface="Arial"/>
                <a:cs typeface="Arial"/>
              </a:rPr>
              <a:t>tooth</a:t>
            </a:r>
            <a:r>
              <a:rPr dirty="0" sz="900" spc="-25">
                <a:solidFill>
                  <a:srgbClr val="4DCE6B"/>
                </a:solidFill>
                <a:latin typeface="Arial"/>
                <a:cs typeface="Arial"/>
              </a:rPr>
              <a:t> </a:t>
            </a:r>
            <a:r>
              <a:rPr dirty="0" sz="900" spc="-20">
                <a:solidFill>
                  <a:srgbClr val="4DCE6B"/>
                </a:solidFill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87" name="object 87" descr=""/>
          <p:cNvSpPr txBox="1"/>
          <p:nvPr/>
        </p:nvSpPr>
        <p:spPr>
          <a:xfrm>
            <a:off x="260731" y="5423661"/>
            <a:ext cx="9404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DFD625"/>
                </a:solidFill>
                <a:latin typeface="Arial"/>
                <a:cs typeface="Arial"/>
              </a:rPr>
              <a:t>Lacking</a:t>
            </a:r>
            <a:r>
              <a:rPr dirty="0" sz="900" spc="-5">
                <a:solidFill>
                  <a:srgbClr val="DFD625"/>
                </a:solidFill>
                <a:latin typeface="Arial"/>
                <a:cs typeface="Arial"/>
              </a:rPr>
              <a:t> </a:t>
            </a:r>
            <a:r>
              <a:rPr dirty="0" sz="900" spc="-10">
                <a:solidFill>
                  <a:srgbClr val="DFD625"/>
                </a:solidFill>
                <a:latin typeface="Arial"/>
                <a:cs typeface="Arial"/>
              </a:rPr>
              <a:t>functional</a:t>
            </a:r>
            <a:endParaRPr sz="900">
              <a:latin typeface="Arial"/>
              <a:cs typeface="Arial"/>
            </a:endParaRPr>
          </a:p>
        </p:txBody>
      </p:sp>
      <p:sp>
        <p:nvSpPr>
          <p:cNvPr id="88" name="object 88" descr=""/>
          <p:cNvSpPr txBox="1"/>
          <p:nvPr/>
        </p:nvSpPr>
        <p:spPr>
          <a:xfrm>
            <a:off x="662051" y="5100954"/>
            <a:ext cx="53911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0">
                <a:solidFill>
                  <a:srgbClr val="41A3FF"/>
                </a:solidFill>
                <a:latin typeface="Arial"/>
                <a:cs typeface="Arial"/>
              </a:rPr>
              <a:t>Tooth</a:t>
            </a:r>
            <a:r>
              <a:rPr dirty="0" sz="900" spc="-10">
                <a:solidFill>
                  <a:srgbClr val="41A3FF"/>
                </a:solidFill>
                <a:latin typeface="Arial"/>
                <a:cs typeface="Arial"/>
              </a:rPr>
              <a:t> </a:t>
            </a:r>
            <a:r>
              <a:rPr dirty="0" sz="900" spc="-20">
                <a:solidFill>
                  <a:srgbClr val="41A3FF"/>
                </a:solidFill>
                <a:latin typeface="Arial"/>
                <a:cs typeface="Arial"/>
              </a:rPr>
              <a:t>loss</a:t>
            </a:r>
            <a:endParaRPr sz="900">
              <a:latin typeface="Arial"/>
              <a:cs typeface="Arial"/>
            </a:endParaRPr>
          </a:p>
        </p:txBody>
      </p:sp>
      <p:sp>
        <p:nvSpPr>
          <p:cNvPr id="89" name="object 89" descr=""/>
          <p:cNvSpPr txBox="1"/>
          <p:nvPr/>
        </p:nvSpPr>
        <p:spPr>
          <a:xfrm>
            <a:off x="222758" y="4778247"/>
            <a:ext cx="978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E95359"/>
                </a:solidFill>
                <a:latin typeface="Arial"/>
                <a:cs typeface="Arial"/>
              </a:rPr>
              <a:t>Complete</a:t>
            </a:r>
            <a:r>
              <a:rPr dirty="0" sz="900" spc="-5">
                <a:solidFill>
                  <a:srgbClr val="E95359"/>
                </a:solidFill>
                <a:latin typeface="Arial"/>
                <a:cs typeface="Arial"/>
              </a:rPr>
              <a:t> </a:t>
            </a:r>
            <a:r>
              <a:rPr dirty="0" sz="900" spc="-10">
                <a:solidFill>
                  <a:srgbClr val="E95359"/>
                </a:solidFill>
                <a:latin typeface="Arial"/>
                <a:cs typeface="Arial"/>
              </a:rPr>
              <a:t>denti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90" name="object 90" descr=""/>
          <p:cNvSpPr txBox="1"/>
          <p:nvPr/>
        </p:nvSpPr>
        <p:spPr>
          <a:xfrm>
            <a:off x="1894585" y="637895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91" name="object 91" descr=""/>
          <p:cNvSpPr txBox="1"/>
          <p:nvPr/>
        </p:nvSpPr>
        <p:spPr>
          <a:xfrm>
            <a:off x="4615307" y="637895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2" name="object 92" descr=""/>
          <p:cNvSpPr txBox="1"/>
          <p:nvPr/>
        </p:nvSpPr>
        <p:spPr>
          <a:xfrm>
            <a:off x="7336028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93" name="object 93" descr=""/>
          <p:cNvSpPr txBox="1"/>
          <p:nvPr/>
        </p:nvSpPr>
        <p:spPr>
          <a:xfrm>
            <a:off x="10088498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4" name="object 94" descr=""/>
          <p:cNvSpPr txBox="1"/>
          <p:nvPr/>
        </p:nvSpPr>
        <p:spPr>
          <a:xfrm>
            <a:off x="12840969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95" name="object 95" descr=""/>
          <p:cNvSpPr txBox="1"/>
          <p:nvPr/>
        </p:nvSpPr>
        <p:spPr>
          <a:xfrm>
            <a:off x="15593440" y="637895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96" name="object 96" descr=""/>
          <p:cNvSpPr txBox="1"/>
          <p:nvPr/>
        </p:nvSpPr>
        <p:spPr>
          <a:xfrm>
            <a:off x="8652382" y="6513830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97" name="object 97" descr=""/>
          <p:cNvSpPr txBox="1"/>
          <p:nvPr/>
        </p:nvSpPr>
        <p:spPr>
          <a:xfrm>
            <a:off x="30759" y="5133565"/>
            <a:ext cx="181610" cy="77787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20">
                <a:latin typeface="Arial"/>
                <a:cs typeface="Arial"/>
              </a:rPr>
              <a:t>Teeth</a:t>
            </a:r>
            <a:r>
              <a:rPr dirty="0" sz="1100" spc="-35">
                <a:latin typeface="Arial"/>
                <a:cs typeface="Arial"/>
              </a:rPr>
              <a:t> </a:t>
            </a:r>
            <a:r>
              <a:rPr dirty="0" sz="1100" spc="-10">
                <a:latin typeface="Arial"/>
                <a:cs typeface="Arial"/>
              </a:rPr>
              <a:t>status</a:t>
            </a:r>
            <a:endParaRPr sz="1100">
              <a:latin typeface="Arial"/>
              <a:cs typeface="Arial"/>
            </a:endParaRPr>
          </a:p>
        </p:txBody>
      </p:sp>
      <p:sp>
        <p:nvSpPr>
          <p:cNvPr id="98" name="object 98" descr=""/>
          <p:cNvSpPr txBox="1"/>
          <p:nvPr/>
        </p:nvSpPr>
        <p:spPr>
          <a:xfrm>
            <a:off x="1238250" y="4399407"/>
            <a:ext cx="1587500" cy="22352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300">
                <a:latin typeface="Arial"/>
                <a:cs typeface="Arial"/>
              </a:rPr>
              <a:t>Number at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>
                <a:latin typeface="Arial"/>
                <a:cs typeface="Arial"/>
              </a:rPr>
              <a:t>risk: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>
                <a:latin typeface="Arial"/>
                <a:cs typeface="Arial"/>
              </a:rPr>
              <a:t>n</a:t>
            </a:r>
            <a:r>
              <a:rPr dirty="0" sz="1300" spc="5">
                <a:latin typeface="Arial"/>
                <a:cs typeface="Arial"/>
              </a:rPr>
              <a:t> </a:t>
            </a:r>
            <a:r>
              <a:rPr dirty="0" sz="1300" spc="-25">
                <a:latin typeface="Arial"/>
                <a:cs typeface="Arial"/>
              </a:rPr>
              <a:t>(%)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99" name="object 99" descr=""/>
          <p:cNvGrpSpPr/>
          <p:nvPr/>
        </p:nvGrpSpPr>
        <p:grpSpPr>
          <a:xfrm>
            <a:off x="425195" y="7060565"/>
            <a:ext cx="15964535" cy="1678305"/>
            <a:chOff x="425195" y="7060565"/>
            <a:chExt cx="15964535" cy="1678305"/>
          </a:xfrm>
        </p:grpSpPr>
        <p:sp>
          <p:nvSpPr>
            <p:cNvPr id="100" name="object 100" descr=""/>
            <p:cNvSpPr/>
            <p:nvPr/>
          </p:nvSpPr>
          <p:spPr>
            <a:xfrm>
              <a:off x="425195" y="7060565"/>
              <a:ext cx="15964535" cy="1678305"/>
            </a:xfrm>
            <a:custGeom>
              <a:avLst/>
              <a:gdLst/>
              <a:ahLst/>
              <a:cxnLst/>
              <a:rect l="l" t="t" r="r" b="b"/>
              <a:pathLst>
                <a:path w="15964535" h="1678304">
                  <a:moveTo>
                    <a:pt x="0" y="1632965"/>
                  </a:moveTo>
                  <a:lnTo>
                    <a:pt x="15964408" y="1632965"/>
                  </a:lnTo>
                </a:path>
                <a:path w="15964535" h="1678304">
                  <a:moveTo>
                    <a:pt x="0" y="1617471"/>
                  </a:moveTo>
                  <a:lnTo>
                    <a:pt x="15964408" y="1617471"/>
                  </a:lnTo>
                </a:path>
                <a:path w="15964535" h="1678304">
                  <a:moveTo>
                    <a:pt x="0" y="1586356"/>
                  </a:moveTo>
                  <a:lnTo>
                    <a:pt x="15964408" y="1586356"/>
                  </a:lnTo>
                </a:path>
                <a:path w="15964535" h="1678304">
                  <a:moveTo>
                    <a:pt x="0" y="1555241"/>
                  </a:moveTo>
                  <a:lnTo>
                    <a:pt x="15964408" y="1555241"/>
                  </a:lnTo>
                </a:path>
                <a:path w="15964535" h="1678304">
                  <a:moveTo>
                    <a:pt x="0" y="1523999"/>
                  </a:moveTo>
                  <a:lnTo>
                    <a:pt x="15964408" y="1523999"/>
                  </a:lnTo>
                </a:path>
                <a:path w="15964535" h="1678304">
                  <a:moveTo>
                    <a:pt x="0" y="1492884"/>
                  </a:moveTo>
                  <a:lnTo>
                    <a:pt x="15964408" y="1492884"/>
                  </a:lnTo>
                </a:path>
                <a:path w="15964535" h="1678304">
                  <a:moveTo>
                    <a:pt x="0" y="1461769"/>
                  </a:moveTo>
                  <a:lnTo>
                    <a:pt x="15964408" y="1461769"/>
                  </a:lnTo>
                </a:path>
                <a:path w="15964535" h="1678304">
                  <a:moveTo>
                    <a:pt x="0" y="1430654"/>
                  </a:moveTo>
                  <a:lnTo>
                    <a:pt x="15964408" y="1430654"/>
                  </a:lnTo>
                </a:path>
                <a:path w="15964535" h="1678304">
                  <a:moveTo>
                    <a:pt x="0" y="1399539"/>
                  </a:moveTo>
                  <a:lnTo>
                    <a:pt x="15964408" y="1399539"/>
                  </a:lnTo>
                </a:path>
                <a:path w="15964535" h="1678304">
                  <a:moveTo>
                    <a:pt x="0" y="1368424"/>
                  </a:moveTo>
                  <a:lnTo>
                    <a:pt x="15964408" y="1368424"/>
                  </a:lnTo>
                </a:path>
                <a:path w="15964535" h="1678304">
                  <a:moveTo>
                    <a:pt x="0" y="1337309"/>
                  </a:moveTo>
                  <a:lnTo>
                    <a:pt x="15964408" y="1337309"/>
                  </a:lnTo>
                </a:path>
                <a:path w="15964535" h="1678304">
                  <a:moveTo>
                    <a:pt x="0" y="1306067"/>
                  </a:moveTo>
                  <a:lnTo>
                    <a:pt x="15964408" y="1306067"/>
                  </a:lnTo>
                </a:path>
                <a:path w="15964535" h="1678304">
                  <a:moveTo>
                    <a:pt x="0" y="1274952"/>
                  </a:moveTo>
                  <a:lnTo>
                    <a:pt x="15964408" y="1274952"/>
                  </a:lnTo>
                </a:path>
                <a:path w="15964535" h="1678304">
                  <a:moveTo>
                    <a:pt x="0" y="1243837"/>
                  </a:moveTo>
                  <a:lnTo>
                    <a:pt x="15964408" y="1243837"/>
                  </a:lnTo>
                </a:path>
                <a:path w="15964535" h="1678304">
                  <a:moveTo>
                    <a:pt x="0" y="1212722"/>
                  </a:moveTo>
                  <a:lnTo>
                    <a:pt x="15964408" y="1212722"/>
                  </a:lnTo>
                </a:path>
                <a:path w="15964535" h="1678304">
                  <a:moveTo>
                    <a:pt x="0" y="1181607"/>
                  </a:moveTo>
                  <a:lnTo>
                    <a:pt x="15964408" y="1181607"/>
                  </a:lnTo>
                </a:path>
                <a:path w="15964535" h="1678304">
                  <a:moveTo>
                    <a:pt x="0" y="1150492"/>
                  </a:moveTo>
                  <a:lnTo>
                    <a:pt x="15964408" y="1150492"/>
                  </a:lnTo>
                </a:path>
                <a:path w="15964535" h="1678304">
                  <a:moveTo>
                    <a:pt x="0" y="1119250"/>
                  </a:moveTo>
                  <a:lnTo>
                    <a:pt x="15964408" y="1119250"/>
                  </a:lnTo>
                </a:path>
                <a:path w="15964535" h="1678304">
                  <a:moveTo>
                    <a:pt x="0" y="1088135"/>
                  </a:moveTo>
                  <a:lnTo>
                    <a:pt x="15964408" y="1088135"/>
                  </a:lnTo>
                </a:path>
                <a:path w="15964535" h="1678304">
                  <a:moveTo>
                    <a:pt x="0" y="1057020"/>
                  </a:moveTo>
                  <a:lnTo>
                    <a:pt x="15964408" y="1057020"/>
                  </a:lnTo>
                </a:path>
                <a:path w="15964535" h="1678304">
                  <a:moveTo>
                    <a:pt x="0" y="1025905"/>
                  </a:moveTo>
                  <a:lnTo>
                    <a:pt x="15964408" y="1025905"/>
                  </a:lnTo>
                </a:path>
                <a:path w="15964535" h="1678304">
                  <a:moveTo>
                    <a:pt x="0" y="994790"/>
                  </a:moveTo>
                  <a:lnTo>
                    <a:pt x="15964408" y="994790"/>
                  </a:lnTo>
                </a:path>
                <a:path w="15964535" h="1678304">
                  <a:moveTo>
                    <a:pt x="0" y="963675"/>
                  </a:moveTo>
                  <a:lnTo>
                    <a:pt x="15964408" y="963675"/>
                  </a:lnTo>
                </a:path>
                <a:path w="15964535" h="1678304">
                  <a:moveTo>
                    <a:pt x="0" y="932560"/>
                  </a:moveTo>
                  <a:lnTo>
                    <a:pt x="15964408" y="932560"/>
                  </a:lnTo>
                </a:path>
                <a:path w="15964535" h="1678304">
                  <a:moveTo>
                    <a:pt x="0" y="901318"/>
                  </a:moveTo>
                  <a:lnTo>
                    <a:pt x="15964408" y="901318"/>
                  </a:lnTo>
                </a:path>
                <a:path w="15964535" h="1678304">
                  <a:moveTo>
                    <a:pt x="0" y="870203"/>
                  </a:moveTo>
                  <a:lnTo>
                    <a:pt x="15964408" y="870203"/>
                  </a:lnTo>
                </a:path>
                <a:path w="15964535" h="1678304">
                  <a:moveTo>
                    <a:pt x="0" y="839088"/>
                  </a:moveTo>
                  <a:lnTo>
                    <a:pt x="15964408" y="839088"/>
                  </a:lnTo>
                </a:path>
                <a:path w="15964535" h="1678304">
                  <a:moveTo>
                    <a:pt x="0" y="807973"/>
                  </a:moveTo>
                  <a:lnTo>
                    <a:pt x="15964408" y="807973"/>
                  </a:lnTo>
                </a:path>
                <a:path w="15964535" h="1678304">
                  <a:moveTo>
                    <a:pt x="0" y="776858"/>
                  </a:moveTo>
                  <a:lnTo>
                    <a:pt x="15964408" y="776858"/>
                  </a:lnTo>
                </a:path>
                <a:path w="15964535" h="1678304">
                  <a:moveTo>
                    <a:pt x="0" y="745743"/>
                  </a:moveTo>
                  <a:lnTo>
                    <a:pt x="15964408" y="745743"/>
                  </a:lnTo>
                </a:path>
                <a:path w="15964535" h="1678304">
                  <a:moveTo>
                    <a:pt x="0" y="714628"/>
                  </a:moveTo>
                  <a:lnTo>
                    <a:pt x="15964408" y="714628"/>
                  </a:lnTo>
                </a:path>
                <a:path w="15964535" h="1678304">
                  <a:moveTo>
                    <a:pt x="0" y="683386"/>
                  </a:moveTo>
                  <a:lnTo>
                    <a:pt x="15964408" y="683386"/>
                  </a:lnTo>
                </a:path>
                <a:path w="15964535" h="1678304">
                  <a:moveTo>
                    <a:pt x="0" y="652271"/>
                  </a:moveTo>
                  <a:lnTo>
                    <a:pt x="15964408" y="652271"/>
                  </a:lnTo>
                </a:path>
                <a:path w="15964535" h="1678304">
                  <a:moveTo>
                    <a:pt x="0" y="621156"/>
                  </a:moveTo>
                  <a:lnTo>
                    <a:pt x="15964408" y="621156"/>
                  </a:lnTo>
                </a:path>
                <a:path w="15964535" h="1678304">
                  <a:moveTo>
                    <a:pt x="0" y="590041"/>
                  </a:moveTo>
                  <a:lnTo>
                    <a:pt x="15964408" y="590041"/>
                  </a:lnTo>
                </a:path>
                <a:path w="15964535" h="1678304">
                  <a:moveTo>
                    <a:pt x="0" y="558926"/>
                  </a:moveTo>
                  <a:lnTo>
                    <a:pt x="15964408" y="558926"/>
                  </a:lnTo>
                </a:path>
                <a:path w="15964535" h="1678304">
                  <a:moveTo>
                    <a:pt x="0" y="527811"/>
                  </a:moveTo>
                  <a:lnTo>
                    <a:pt x="15964408" y="527811"/>
                  </a:lnTo>
                </a:path>
                <a:path w="15964535" h="1678304">
                  <a:moveTo>
                    <a:pt x="0" y="496569"/>
                  </a:moveTo>
                  <a:lnTo>
                    <a:pt x="15964408" y="496569"/>
                  </a:lnTo>
                </a:path>
                <a:path w="15964535" h="1678304">
                  <a:moveTo>
                    <a:pt x="0" y="465454"/>
                  </a:moveTo>
                  <a:lnTo>
                    <a:pt x="15964408" y="465454"/>
                  </a:lnTo>
                </a:path>
                <a:path w="15964535" h="1678304">
                  <a:moveTo>
                    <a:pt x="0" y="434339"/>
                  </a:moveTo>
                  <a:lnTo>
                    <a:pt x="15964408" y="434339"/>
                  </a:lnTo>
                </a:path>
                <a:path w="15964535" h="1678304">
                  <a:moveTo>
                    <a:pt x="0" y="403224"/>
                  </a:moveTo>
                  <a:lnTo>
                    <a:pt x="15964408" y="403224"/>
                  </a:lnTo>
                </a:path>
                <a:path w="15964535" h="1678304">
                  <a:moveTo>
                    <a:pt x="0" y="356488"/>
                  </a:moveTo>
                  <a:lnTo>
                    <a:pt x="15964408" y="356488"/>
                  </a:lnTo>
                </a:path>
                <a:path w="15964535" h="1678304">
                  <a:moveTo>
                    <a:pt x="0" y="309879"/>
                  </a:moveTo>
                  <a:lnTo>
                    <a:pt x="15964408" y="309879"/>
                  </a:lnTo>
                </a:path>
                <a:path w="15964535" h="1678304">
                  <a:moveTo>
                    <a:pt x="0" y="278637"/>
                  </a:moveTo>
                  <a:lnTo>
                    <a:pt x="15964408" y="278637"/>
                  </a:lnTo>
                </a:path>
                <a:path w="15964535" h="1678304">
                  <a:moveTo>
                    <a:pt x="0" y="169671"/>
                  </a:moveTo>
                  <a:lnTo>
                    <a:pt x="15964408" y="169671"/>
                  </a:lnTo>
                </a:path>
                <a:path w="15964535" h="1678304">
                  <a:moveTo>
                    <a:pt x="0" y="60705"/>
                  </a:moveTo>
                  <a:lnTo>
                    <a:pt x="15964408" y="60705"/>
                  </a:lnTo>
                </a:path>
                <a:path w="15964535" h="1678304">
                  <a:moveTo>
                    <a:pt x="0" y="45211"/>
                  </a:moveTo>
                  <a:lnTo>
                    <a:pt x="15964408" y="45211"/>
                  </a:lnTo>
                </a:path>
                <a:path w="15964535" h="1678304">
                  <a:moveTo>
                    <a:pt x="2176907" y="1678177"/>
                  </a:moveTo>
                  <a:lnTo>
                    <a:pt x="2176907" y="0"/>
                  </a:lnTo>
                </a:path>
                <a:path w="15964535" h="1678304">
                  <a:moveTo>
                    <a:pt x="5079619" y="1678177"/>
                  </a:moveTo>
                  <a:lnTo>
                    <a:pt x="5079619" y="0"/>
                  </a:lnTo>
                </a:path>
                <a:path w="15964535" h="1678304">
                  <a:moveTo>
                    <a:pt x="7982204" y="1678177"/>
                  </a:moveTo>
                  <a:lnTo>
                    <a:pt x="7982204" y="0"/>
                  </a:lnTo>
                </a:path>
                <a:path w="15964535" h="1678304">
                  <a:moveTo>
                    <a:pt x="10884789" y="1678177"/>
                  </a:moveTo>
                  <a:lnTo>
                    <a:pt x="10884789" y="0"/>
                  </a:lnTo>
                </a:path>
                <a:path w="15964535" h="1678304">
                  <a:moveTo>
                    <a:pt x="13787500" y="1678177"/>
                  </a:moveTo>
                  <a:lnTo>
                    <a:pt x="13787500" y="0"/>
                  </a:lnTo>
                </a:path>
              </a:pathLst>
            </a:custGeom>
            <a:ln w="6731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01" name="object 101" descr=""/>
            <p:cNvSpPr/>
            <p:nvPr/>
          </p:nvSpPr>
          <p:spPr>
            <a:xfrm>
              <a:off x="425195" y="7060565"/>
              <a:ext cx="15964535" cy="1678305"/>
            </a:xfrm>
            <a:custGeom>
              <a:avLst/>
              <a:gdLst/>
              <a:ahLst/>
              <a:cxnLst/>
              <a:rect l="l" t="t" r="r" b="b"/>
              <a:pathLst>
                <a:path w="15964535" h="1678304">
                  <a:moveTo>
                    <a:pt x="0" y="1601850"/>
                  </a:moveTo>
                  <a:lnTo>
                    <a:pt x="15964408" y="1601850"/>
                  </a:lnTo>
                </a:path>
                <a:path w="15964535" h="1678304">
                  <a:moveTo>
                    <a:pt x="0" y="1570735"/>
                  </a:moveTo>
                  <a:lnTo>
                    <a:pt x="15964408" y="1570735"/>
                  </a:lnTo>
                </a:path>
                <a:path w="15964535" h="1678304">
                  <a:moveTo>
                    <a:pt x="0" y="1539620"/>
                  </a:moveTo>
                  <a:lnTo>
                    <a:pt x="15964408" y="1539620"/>
                  </a:lnTo>
                </a:path>
                <a:path w="15964535" h="1678304">
                  <a:moveTo>
                    <a:pt x="0" y="1508505"/>
                  </a:moveTo>
                  <a:lnTo>
                    <a:pt x="15964408" y="1508505"/>
                  </a:lnTo>
                </a:path>
                <a:path w="15964535" h="1678304">
                  <a:moveTo>
                    <a:pt x="0" y="1477390"/>
                  </a:moveTo>
                  <a:lnTo>
                    <a:pt x="15964408" y="1477390"/>
                  </a:lnTo>
                </a:path>
                <a:path w="15964535" h="1678304">
                  <a:moveTo>
                    <a:pt x="0" y="1446275"/>
                  </a:moveTo>
                  <a:lnTo>
                    <a:pt x="15964408" y="1446275"/>
                  </a:lnTo>
                </a:path>
                <a:path w="15964535" h="1678304">
                  <a:moveTo>
                    <a:pt x="0" y="1415033"/>
                  </a:moveTo>
                  <a:lnTo>
                    <a:pt x="15964408" y="1415033"/>
                  </a:lnTo>
                </a:path>
                <a:path w="15964535" h="1678304">
                  <a:moveTo>
                    <a:pt x="0" y="1383918"/>
                  </a:moveTo>
                  <a:lnTo>
                    <a:pt x="15964408" y="1383918"/>
                  </a:lnTo>
                </a:path>
                <a:path w="15964535" h="1678304">
                  <a:moveTo>
                    <a:pt x="0" y="1352803"/>
                  </a:moveTo>
                  <a:lnTo>
                    <a:pt x="15964408" y="1352803"/>
                  </a:lnTo>
                </a:path>
                <a:path w="15964535" h="1678304">
                  <a:moveTo>
                    <a:pt x="0" y="1321688"/>
                  </a:moveTo>
                  <a:lnTo>
                    <a:pt x="15964408" y="1321688"/>
                  </a:lnTo>
                </a:path>
                <a:path w="15964535" h="1678304">
                  <a:moveTo>
                    <a:pt x="0" y="1290573"/>
                  </a:moveTo>
                  <a:lnTo>
                    <a:pt x="15964408" y="1290573"/>
                  </a:lnTo>
                </a:path>
                <a:path w="15964535" h="1678304">
                  <a:moveTo>
                    <a:pt x="0" y="1259458"/>
                  </a:moveTo>
                  <a:lnTo>
                    <a:pt x="15964408" y="1259458"/>
                  </a:lnTo>
                </a:path>
                <a:path w="15964535" h="1678304">
                  <a:moveTo>
                    <a:pt x="0" y="1228216"/>
                  </a:moveTo>
                  <a:lnTo>
                    <a:pt x="15964408" y="1228216"/>
                  </a:lnTo>
                </a:path>
                <a:path w="15964535" h="1678304">
                  <a:moveTo>
                    <a:pt x="0" y="1197101"/>
                  </a:moveTo>
                  <a:lnTo>
                    <a:pt x="15964408" y="1197101"/>
                  </a:lnTo>
                </a:path>
                <a:path w="15964535" h="1678304">
                  <a:moveTo>
                    <a:pt x="0" y="1165986"/>
                  </a:moveTo>
                  <a:lnTo>
                    <a:pt x="15964408" y="1165986"/>
                  </a:lnTo>
                </a:path>
                <a:path w="15964535" h="1678304">
                  <a:moveTo>
                    <a:pt x="0" y="1134871"/>
                  </a:moveTo>
                  <a:lnTo>
                    <a:pt x="15964408" y="1134871"/>
                  </a:lnTo>
                </a:path>
                <a:path w="15964535" h="1678304">
                  <a:moveTo>
                    <a:pt x="0" y="1103756"/>
                  </a:moveTo>
                  <a:lnTo>
                    <a:pt x="15964408" y="1103756"/>
                  </a:lnTo>
                </a:path>
                <a:path w="15964535" h="1678304">
                  <a:moveTo>
                    <a:pt x="0" y="1072641"/>
                  </a:moveTo>
                  <a:lnTo>
                    <a:pt x="15964408" y="1072641"/>
                  </a:lnTo>
                </a:path>
                <a:path w="15964535" h="1678304">
                  <a:moveTo>
                    <a:pt x="0" y="1041526"/>
                  </a:moveTo>
                  <a:lnTo>
                    <a:pt x="15964408" y="1041526"/>
                  </a:lnTo>
                </a:path>
                <a:path w="15964535" h="1678304">
                  <a:moveTo>
                    <a:pt x="0" y="1010284"/>
                  </a:moveTo>
                  <a:lnTo>
                    <a:pt x="15964408" y="1010284"/>
                  </a:lnTo>
                </a:path>
                <a:path w="15964535" h="1678304">
                  <a:moveTo>
                    <a:pt x="0" y="979169"/>
                  </a:moveTo>
                  <a:lnTo>
                    <a:pt x="15964408" y="979169"/>
                  </a:lnTo>
                </a:path>
                <a:path w="15964535" h="1678304">
                  <a:moveTo>
                    <a:pt x="0" y="948054"/>
                  </a:moveTo>
                  <a:lnTo>
                    <a:pt x="15964408" y="948054"/>
                  </a:lnTo>
                </a:path>
                <a:path w="15964535" h="1678304">
                  <a:moveTo>
                    <a:pt x="0" y="916939"/>
                  </a:moveTo>
                  <a:lnTo>
                    <a:pt x="15964408" y="916939"/>
                  </a:lnTo>
                </a:path>
                <a:path w="15964535" h="1678304">
                  <a:moveTo>
                    <a:pt x="0" y="885824"/>
                  </a:moveTo>
                  <a:lnTo>
                    <a:pt x="15964408" y="885824"/>
                  </a:lnTo>
                </a:path>
                <a:path w="15964535" h="1678304">
                  <a:moveTo>
                    <a:pt x="0" y="854709"/>
                  </a:moveTo>
                  <a:lnTo>
                    <a:pt x="15964408" y="854709"/>
                  </a:lnTo>
                </a:path>
                <a:path w="15964535" h="1678304">
                  <a:moveTo>
                    <a:pt x="0" y="823594"/>
                  </a:moveTo>
                  <a:lnTo>
                    <a:pt x="15964408" y="823594"/>
                  </a:lnTo>
                </a:path>
                <a:path w="15964535" h="1678304">
                  <a:moveTo>
                    <a:pt x="0" y="792352"/>
                  </a:moveTo>
                  <a:lnTo>
                    <a:pt x="15964408" y="792352"/>
                  </a:lnTo>
                </a:path>
                <a:path w="15964535" h="1678304">
                  <a:moveTo>
                    <a:pt x="0" y="761237"/>
                  </a:moveTo>
                  <a:lnTo>
                    <a:pt x="15964408" y="761237"/>
                  </a:lnTo>
                </a:path>
                <a:path w="15964535" h="1678304">
                  <a:moveTo>
                    <a:pt x="0" y="730122"/>
                  </a:moveTo>
                  <a:lnTo>
                    <a:pt x="15964408" y="730122"/>
                  </a:lnTo>
                </a:path>
                <a:path w="15964535" h="1678304">
                  <a:moveTo>
                    <a:pt x="0" y="699007"/>
                  </a:moveTo>
                  <a:lnTo>
                    <a:pt x="15964408" y="699007"/>
                  </a:lnTo>
                </a:path>
                <a:path w="15964535" h="1678304">
                  <a:moveTo>
                    <a:pt x="0" y="667892"/>
                  </a:moveTo>
                  <a:lnTo>
                    <a:pt x="15964408" y="667892"/>
                  </a:lnTo>
                </a:path>
                <a:path w="15964535" h="1678304">
                  <a:moveTo>
                    <a:pt x="0" y="636777"/>
                  </a:moveTo>
                  <a:lnTo>
                    <a:pt x="15964408" y="636777"/>
                  </a:lnTo>
                </a:path>
                <a:path w="15964535" h="1678304">
                  <a:moveTo>
                    <a:pt x="0" y="605535"/>
                  </a:moveTo>
                  <a:lnTo>
                    <a:pt x="15964408" y="605535"/>
                  </a:lnTo>
                </a:path>
                <a:path w="15964535" h="1678304">
                  <a:moveTo>
                    <a:pt x="0" y="574420"/>
                  </a:moveTo>
                  <a:lnTo>
                    <a:pt x="15964408" y="574420"/>
                  </a:lnTo>
                </a:path>
                <a:path w="15964535" h="1678304">
                  <a:moveTo>
                    <a:pt x="0" y="543305"/>
                  </a:moveTo>
                  <a:lnTo>
                    <a:pt x="15964408" y="543305"/>
                  </a:lnTo>
                </a:path>
                <a:path w="15964535" h="1678304">
                  <a:moveTo>
                    <a:pt x="0" y="512190"/>
                  </a:moveTo>
                  <a:lnTo>
                    <a:pt x="15964408" y="512190"/>
                  </a:lnTo>
                </a:path>
                <a:path w="15964535" h="1678304">
                  <a:moveTo>
                    <a:pt x="0" y="481075"/>
                  </a:moveTo>
                  <a:lnTo>
                    <a:pt x="15964408" y="481075"/>
                  </a:lnTo>
                </a:path>
                <a:path w="15964535" h="1678304">
                  <a:moveTo>
                    <a:pt x="0" y="449960"/>
                  </a:moveTo>
                  <a:lnTo>
                    <a:pt x="15964408" y="449960"/>
                  </a:lnTo>
                </a:path>
                <a:path w="15964535" h="1678304">
                  <a:moveTo>
                    <a:pt x="0" y="418845"/>
                  </a:moveTo>
                  <a:lnTo>
                    <a:pt x="15964408" y="418845"/>
                  </a:lnTo>
                </a:path>
                <a:path w="15964535" h="1678304">
                  <a:moveTo>
                    <a:pt x="0" y="387603"/>
                  </a:moveTo>
                  <a:lnTo>
                    <a:pt x="15964408" y="387603"/>
                  </a:lnTo>
                </a:path>
                <a:path w="15964535" h="1678304">
                  <a:moveTo>
                    <a:pt x="0" y="325373"/>
                  </a:moveTo>
                  <a:lnTo>
                    <a:pt x="15964408" y="325373"/>
                  </a:lnTo>
                </a:path>
                <a:path w="15964535" h="1678304">
                  <a:moveTo>
                    <a:pt x="0" y="294258"/>
                  </a:moveTo>
                  <a:lnTo>
                    <a:pt x="15964408" y="294258"/>
                  </a:lnTo>
                </a:path>
                <a:path w="15964535" h="1678304">
                  <a:moveTo>
                    <a:pt x="0" y="263143"/>
                  </a:moveTo>
                  <a:lnTo>
                    <a:pt x="15964408" y="263143"/>
                  </a:lnTo>
                </a:path>
                <a:path w="15964535" h="1678304">
                  <a:moveTo>
                    <a:pt x="0" y="76326"/>
                  </a:moveTo>
                  <a:lnTo>
                    <a:pt x="15964408" y="76326"/>
                  </a:lnTo>
                </a:path>
                <a:path w="15964535" h="1678304">
                  <a:moveTo>
                    <a:pt x="725678" y="1678177"/>
                  </a:moveTo>
                  <a:lnTo>
                    <a:pt x="725678" y="0"/>
                  </a:lnTo>
                </a:path>
                <a:path w="15964535" h="1678304">
                  <a:moveTo>
                    <a:pt x="3628263" y="1678177"/>
                  </a:moveTo>
                  <a:lnTo>
                    <a:pt x="3628263" y="0"/>
                  </a:lnTo>
                </a:path>
                <a:path w="15964535" h="1678304">
                  <a:moveTo>
                    <a:pt x="6530848" y="1678177"/>
                  </a:moveTo>
                  <a:lnTo>
                    <a:pt x="6530848" y="0"/>
                  </a:lnTo>
                </a:path>
                <a:path w="15964535" h="1678304">
                  <a:moveTo>
                    <a:pt x="9433560" y="1678177"/>
                  </a:moveTo>
                  <a:lnTo>
                    <a:pt x="9433560" y="0"/>
                  </a:lnTo>
                </a:path>
                <a:path w="15964535" h="1678304">
                  <a:moveTo>
                    <a:pt x="12336145" y="1678177"/>
                  </a:moveTo>
                  <a:lnTo>
                    <a:pt x="12336145" y="0"/>
                  </a:lnTo>
                </a:path>
                <a:path w="15964535" h="1678304">
                  <a:moveTo>
                    <a:pt x="15238730" y="1678177"/>
                  </a:moveTo>
                  <a:lnTo>
                    <a:pt x="15238730" y="0"/>
                  </a:lnTo>
                </a:path>
              </a:pathLst>
            </a:custGeom>
            <a:ln w="13589">
              <a:solidFill>
                <a:srgbClr val="EBEBE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02" name="object 102" descr=""/>
            <p:cNvSpPr/>
            <p:nvPr/>
          </p:nvSpPr>
          <p:spPr>
            <a:xfrm>
              <a:off x="1531112" y="7852918"/>
              <a:ext cx="4132579" cy="809625"/>
            </a:xfrm>
            <a:custGeom>
              <a:avLst/>
              <a:gdLst/>
              <a:ahLst/>
              <a:cxnLst/>
              <a:rect l="l" t="t" r="r" b="b"/>
              <a:pathLst>
                <a:path w="4132579" h="809625">
                  <a:moveTo>
                    <a:pt x="10414" y="778383"/>
                  </a:moveTo>
                  <a:lnTo>
                    <a:pt x="0" y="778383"/>
                  </a:lnTo>
                  <a:lnTo>
                    <a:pt x="0" y="809498"/>
                  </a:lnTo>
                  <a:lnTo>
                    <a:pt x="10414" y="809498"/>
                  </a:lnTo>
                  <a:lnTo>
                    <a:pt x="10414" y="778383"/>
                  </a:lnTo>
                  <a:close/>
                </a:path>
                <a:path w="4132579" h="809625">
                  <a:moveTo>
                    <a:pt x="126479" y="778383"/>
                  </a:moveTo>
                  <a:lnTo>
                    <a:pt x="116065" y="778383"/>
                  </a:lnTo>
                  <a:lnTo>
                    <a:pt x="116065" y="809498"/>
                  </a:lnTo>
                  <a:lnTo>
                    <a:pt x="126479" y="809498"/>
                  </a:lnTo>
                  <a:lnTo>
                    <a:pt x="126479" y="778383"/>
                  </a:lnTo>
                  <a:close/>
                </a:path>
                <a:path w="4132579" h="809625">
                  <a:moveTo>
                    <a:pt x="184531" y="747268"/>
                  </a:moveTo>
                  <a:lnTo>
                    <a:pt x="174117" y="747268"/>
                  </a:lnTo>
                  <a:lnTo>
                    <a:pt x="174117" y="809498"/>
                  </a:lnTo>
                  <a:lnTo>
                    <a:pt x="184531" y="809498"/>
                  </a:lnTo>
                  <a:lnTo>
                    <a:pt x="184531" y="747268"/>
                  </a:lnTo>
                  <a:close/>
                </a:path>
                <a:path w="4132579" h="809625">
                  <a:moveTo>
                    <a:pt x="242570" y="778383"/>
                  </a:moveTo>
                  <a:lnTo>
                    <a:pt x="232156" y="778383"/>
                  </a:lnTo>
                  <a:lnTo>
                    <a:pt x="232156" y="809498"/>
                  </a:lnTo>
                  <a:lnTo>
                    <a:pt x="242570" y="809498"/>
                  </a:lnTo>
                  <a:lnTo>
                    <a:pt x="242570" y="778383"/>
                  </a:lnTo>
                  <a:close/>
                </a:path>
                <a:path w="4132579" h="809625">
                  <a:moveTo>
                    <a:pt x="300609" y="529336"/>
                  </a:moveTo>
                  <a:lnTo>
                    <a:pt x="290195" y="529336"/>
                  </a:lnTo>
                  <a:lnTo>
                    <a:pt x="290195" y="809498"/>
                  </a:lnTo>
                  <a:lnTo>
                    <a:pt x="300609" y="809498"/>
                  </a:lnTo>
                  <a:lnTo>
                    <a:pt x="300609" y="529336"/>
                  </a:lnTo>
                  <a:close/>
                </a:path>
                <a:path w="4132579" h="809625">
                  <a:moveTo>
                    <a:pt x="358635" y="498094"/>
                  </a:moveTo>
                  <a:lnTo>
                    <a:pt x="348234" y="498094"/>
                  </a:lnTo>
                  <a:lnTo>
                    <a:pt x="348234" y="809498"/>
                  </a:lnTo>
                  <a:lnTo>
                    <a:pt x="358635" y="809498"/>
                  </a:lnTo>
                  <a:lnTo>
                    <a:pt x="358635" y="498094"/>
                  </a:lnTo>
                  <a:close/>
                </a:path>
                <a:path w="4132579" h="809625">
                  <a:moveTo>
                    <a:pt x="416687" y="466979"/>
                  </a:moveTo>
                  <a:lnTo>
                    <a:pt x="406273" y="466979"/>
                  </a:lnTo>
                  <a:lnTo>
                    <a:pt x="406273" y="809498"/>
                  </a:lnTo>
                  <a:lnTo>
                    <a:pt x="416687" y="809498"/>
                  </a:lnTo>
                  <a:lnTo>
                    <a:pt x="416687" y="466979"/>
                  </a:lnTo>
                  <a:close/>
                </a:path>
                <a:path w="4132579" h="809625">
                  <a:moveTo>
                    <a:pt x="474726" y="217932"/>
                  </a:moveTo>
                  <a:lnTo>
                    <a:pt x="464312" y="217932"/>
                  </a:lnTo>
                  <a:lnTo>
                    <a:pt x="464312" y="809498"/>
                  </a:lnTo>
                  <a:lnTo>
                    <a:pt x="474726" y="809498"/>
                  </a:lnTo>
                  <a:lnTo>
                    <a:pt x="474726" y="217932"/>
                  </a:lnTo>
                  <a:close/>
                </a:path>
                <a:path w="4132579" h="809625">
                  <a:moveTo>
                    <a:pt x="532879" y="466979"/>
                  </a:moveTo>
                  <a:lnTo>
                    <a:pt x="522478" y="466979"/>
                  </a:lnTo>
                  <a:lnTo>
                    <a:pt x="522478" y="809498"/>
                  </a:lnTo>
                  <a:lnTo>
                    <a:pt x="532879" y="809498"/>
                  </a:lnTo>
                  <a:lnTo>
                    <a:pt x="532879" y="466979"/>
                  </a:lnTo>
                  <a:close/>
                </a:path>
                <a:path w="4132579" h="809625">
                  <a:moveTo>
                    <a:pt x="590931" y="560451"/>
                  </a:moveTo>
                  <a:lnTo>
                    <a:pt x="580517" y="560451"/>
                  </a:lnTo>
                  <a:lnTo>
                    <a:pt x="580517" y="809498"/>
                  </a:lnTo>
                  <a:lnTo>
                    <a:pt x="590931" y="809498"/>
                  </a:lnTo>
                  <a:lnTo>
                    <a:pt x="590931" y="560451"/>
                  </a:lnTo>
                  <a:close/>
                </a:path>
                <a:path w="4132579" h="809625">
                  <a:moveTo>
                    <a:pt x="648970" y="311404"/>
                  </a:moveTo>
                  <a:lnTo>
                    <a:pt x="638556" y="311404"/>
                  </a:lnTo>
                  <a:lnTo>
                    <a:pt x="638556" y="809498"/>
                  </a:lnTo>
                  <a:lnTo>
                    <a:pt x="648970" y="809498"/>
                  </a:lnTo>
                  <a:lnTo>
                    <a:pt x="648970" y="311404"/>
                  </a:lnTo>
                  <a:close/>
                </a:path>
                <a:path w="4132579" h="809625">
                  <a:moveTo>
                    <a:pt x="707009" y="591566"/>
                  </a:moveTo>
                  <a:lnTo>
                    <a:pt x="696595" y="591566"/>
                  </a:lnTo>
                  <a:lnTo>
                    <a:pt x="696595" y="809498"/>
                  </a:lnTo>
                  <a:lnTo>
                    <a:pt x="707009" y="809498"/>
                  </a:lnTo>
                  <a:lnTo>
                    <a:pt x="707009" y="591566"/>
                  </a:lnTo>
                  <a:close/>
                </a:path>
                <a:path w="4132579" h="809625">
                  <a:moveTo>
                    <a:pt x="765035" y="342519"/>
                  </a:moveTo>
                  <a:lnTo>
                    <a:pt x="754634" y="342519"/>
                  </a:lnTo>
                  <a:lnTo>
                    <a:pt x="754634" y="809498"/>
                  </a:lnTo>
                  <a:lnTo>
                    <a:pt x="765035" y="809498"/>
                  </a:lnTo>
                  <a:lnTo>
                    <a:pt x="765035" y="342519"/>
                  </a:lnTo>
                  <a:close/>
                </a:path>
                <a:path w="4132579" h="809625">
                  <a:moveTo>
                    <a:pt x="823087" y="653796"/>
                  </a:moveTo>
                  <a:lnTo>
                    <a:pt x="812673" y="653796"/>
                  </a:lnTo>
                  <a:lnTo>
                    <a:pt x="812673" y="809498"/>
                  </a:lnTo>
                  <a:lnTo>
                    <a:pt x="823087" y="809498"/>
                  </a:lnTo>
                  <a:lnTo>
                    <a:pt x="823087" y="653796"/>
                  </a:lnTo>
                  <a:close/>
                </a:path>
                <a:path w="4132579" h="809625">
                  <a:moveTo>
                    <a:pt x="881126" y="591566"/>
                  </a:moveTo>
                  <a:lnTo>
                    <a:pt x="870712" y="591566"/>
                  </a:lnTo>
                  <a:lnTo>
                    <a:pt x="870712" y="809498"/>
                  </a:lnTo>
                  <a:lnTo>
                    <a:pt x="881126" y="809498"/>
                  </a:lnTo>
                  <a:lnTo>
                    <a:pt x="881126" y="591566"/>
                  </a:lnTo>
                  <a:close/>
                </a:path>
                <a:path w="4132579" h="809625">
                  <a:moveTo>
                    <a:pt x="939165" y="529336"/>
                  </a:moveTo>
                  <a:lnTo>
                    <a:pt x="928751" y="529336"/>
                  </a:lnTo>
                  <a:lnTo>
                    <a:pt x="928751" y="809498"/>
                  </a:lnTo>
                  <a:lnTo>
                    <a:pt x="939165" y="809498"/>
                  </a:lnTo>
                  <a:lnTo>
                    <a:pt x="939165" y="529336"/>
                  </a:lnTo>
                  <a:close/>
                </a:path>
                <a:path w="4132579" h="809625">
                  <a:moveTo>
                    <a:pt x="997191" y="498094"/>
                  </a:moveTo>
                  <a:lnTo>
                    <a:pt x="986790" y="498094"/>
                  </a:lnTo>
                  <a:lnTo>
                    <a:pt x="986790" y="809498"/>
                  </a:lnTo>
                  <a:lnTo>
                    <a:pt x="997191" y="809498"/>
                  </a:lnTo>
                  <a:lnTo>
                    <a:pt x="997191" y="498094"/>
                  </a:lnTo>
                  <a:close/>
                </a:path>
                <a:path w="4132579" h="809625">
                  <a:moveTo>
                    <a:pt x="1055243" y="435864"/>
                  </a:moveTo>
                  <a:lnTo>
                    <a:pt x="1044829" y="435864"/>
                  </a:lnTo>
                  <a:lnTo>
                    <a:pt x="1044829" y="809498"/>
                  </a:lnTo>
                  <a:lnTo>
                    <a:pt x="1055243" y="809498"/>
                  </a:lnTo>
                  <a:lnTo>
                    <a:pt x="1055243" y="435864"/>
                  </a:lnTo>
                  <a:close/>
                </a:path>
                <a:path w="4132579" h="809625">
                  <a:moveTo>
                    <a:pt x="1113409" y="435864"/>
                  </a:moveTo>
                  <a:lnTo>
                    <a:pt x="1102995" y="435864"/>
                  </a:lnTo>
                  <a:lnTo>
                    <a:pt x="1102995" y="809498"/>
                  </a:lnTo>
                  <a:lnTo>
                    <a:pt x="1113409" y="809498"/>
                  </a:lnTo>
                  <a:lnTo>
                    <a:pt x="1113409" y="435864"/>
                  </a:lnTo>
                  <a:close/>
                </a:path>
                <a:path w="4132579" h="809625">
                  <a:moveTo>
                    <a:pt x="1171435" y="560451"/>
                  </a:moveTo>
                  <a:lnTo>
                    <a:pt x="1161034" y="560451"/>
                  </a:lnTo>
                  <a:lnTo>
                    <a:pt x="1161034" y="809498"/>
                  </a:lnTo>
                  <a:lnTo>
                    <a:pt x="1171435" y="809498"/>
                  </a:lnTo>
                  <a:lnTo>
                    <a:pt x="1171435" y="560451"/>
                  </a:lnTo>
                  <a:close/>
                </a:path>
                <a:path w="4132579" h="809625">
                  <a:moveTo>
                    <a:pt x="1229487" y="435864"/>
                  </a:moveTo>
                  <a:lnTo>
                    <a:pt x="1219073" y="435864"/>
                  </a:lnTo>
                  <a:lnTo>
                    <a:pt x="1219073" y="809498"/>
                  </a:lnTo>
                  <a:lnTo>
                    <a:pt x="1229487" y="809498"/>
                  </a:lnTo>
                  <a:lnTo>
                    <a:pt x="1229487" y="435864"/>
                  </a:lnTo>
                  <a:close/>
                </a:path>
                <a:path w="4132579" h="809625">
                  <a:moveTo>
                    <a:pt x="1287526" y="498094"/>
                  </a:moveTo>
                  <a:lnTo>
                    <a:pt x="1277112" y="498094"/>
                  </a:lnTo>
                  <a:lnTo>
                    <a:pt x="1277112" y="809498"/>
                  </a:lnTo>
                  <a:lnTo>
                    <a:pt x="1287526" y="809498"/>
                  </a:lnTo>
                  <a:lnTo>
                    <a:pt x="1287526" y="498094"/>
                  </a:lnTo>
                  <a:close/>
                </a:path>
                <a:path w="4132579" h="809625">
                  <a:moveTo>
                    <a:pt x="1345565" y="560451"/>
                  </a:moveTo>
                  <a:lnTo>
                    <a:pt x="1335151" y="560451"/>
                  </a:lnTo>
                  <a:lnTo>
                    <a:pt x="1335151" y="809498"/>
                  </a:lnTo>
                  <a:lnTo>
                    <a:pt x="1345565" y="809498"/>
                  </a:lnTo>
                  <a:lnTo>
                    <a:pt x="1345565" y="560451"/>
                  </a:lnTo>
                  <a:close/>
                </a:path>
                <a:path w="4132579" h="809625">
                  <a:moveTo>
                    <a:pt x="1403591" y="529336"/>
                  </a:moveTo>
                  <a:lnTo>
                    <a:pt x="1393190" y="529336"/>
                  </a:lnTo>
                  <a:lnTo>
                    <a:pt x="1393190" y="809498"/>
                  </a:lnTo>
                  <a:lnTo>
                    <a:pt x="1403591" y="809498"/>
                  </a:lnTo>
                  <a:lnTo>
                    <a:pt x="1403591" y="529336"/>
                  </a:lnTo>
                  <a:close/>
                </a:path>
                <a:path w="4132579" h="809625">
                  <a:moveTo>
                    <a:pt x="1461643" y="93472"/>
                  </a:moveTo>
                  <a:lnTo>
                    <a:pt x="1451229" y="93472"/>
                  </a:lnTo>
                  <a:lnTo>
                    <a:pt x="1451229" y="809498"/>
                  </a:lnTo>
                  <a:lnTo>
                    <a:pt x="1461643" y="809498"/>
                  </a:lnTo>
                  <a:lnTo>
                    <a:pt x="1461643" y="93472"/>
                  </a:lnTo>
                  <a:close/>
                </a:path>
                <a:path w="4132579" h="809625">
                  <a:moveTo>
                    <a:pt x="1519682" y="435864"/>
                  </a:moveTo>
                  <a:lnTo>
                    <a:pt x="1509268" y="435864"/>
                  </a:lnTo>
                  <a:lnTo>
                    <a:pt x="1509268" y="809498"/>
                  </a:lnTo>
                  <a:lnTo>
                    <a:pt x="1519682" y="809498"/>
                  </a:lnTo>
                  <a:lnTo>
                    <a:pt x="1519682" y="435864"/>
                  </a:lnTo>
                  <a:close/>
                </a:path>
                <a:path w="4132579" h="809625">
                  <a:moveTo>
                    <a:pt x="1577721" y="404749"/>
                  </a:moveTo>
                  <a:lnTo>
                    <a:pt x="1567307" y="404749"/>
                  </a:lnTo>
                  <a:lnTo>
                    <a:pt x="1567307" y="809498"/>
                  </a:lnTo>
                  <a:lnTo>
                    <a:pt x="1577721" y="809498"/>
                  </a:lnTo>
                  <a:lnTo>
                    <a:pt x="1577721" y="404749"/>
                  </a:lnTo>
                  <a:close/>
                </a:path>
                <a:path w="4132579" h="809625">
                  <a:moveTo>
                    <a:pt x="1635887" y="622681"/>
                  </a:moveTo>
                  <a:lnTo>
                    <a:pt x="1625473" y="622681"/>
                  </a:lnTo>
                  <a:lnTo>
                    <a:pt x="1625473" y="809498"/>
                  </a:lnTo>
                  <a:lnTo>
                    <a:pt x="1635887" y="809498"/>
                  </a:lnTo>
                  <a:lnTo>
                    <a:pt x="1635887" y="622681"/>
                  </a:lnTo>
                  <a:close/>
                </a:path>
                <a:path w="4132579" h="809625">
                  <a:moveTo>
                    <a:pt x="1693926" y="591566"/>
                  </a:moveTo>
                  <a:lnTo>
                    <a:pt x="1683512" y="591566"/>
                  </a:lnTo>
                  <a:lnTo>
                    <a:pt x="1683512" y="809498"/>
                  </a:lnTo>
                  <a:lnTo>
                    <a:pt x="1693926" y="809498"/>
                  </a:lnTo>
                  <a:lnTo>
                    <a:pt x="1693926" y="591566"/>
                  </a:lnTo>
                  <a:close/>
                </a:path>
                <a:path w="4132579" h="809625">
                  <a:moveTo>
                    <a:pt x="1751965" y="435864"/>
                  </a:moveTo>
                  <a:lnTo>
                    <a:pt x="1741551" y="435864"/>
                  </a:lnTo>
                  <a:lnTo>
                    <a:pt x="1741551" y="809498"/>
                  </a:lnTo>
                  <a:lnTo>
                    <a:pt x="1751965" y="809498"/>
                  </a:lnTo>
                  <a:lnTo>
                    <a:pt x="1751965" y="435864"/>
                  </a:lnTo>
                  <a:close/>
                </a:path>
                <a:path w="4132579" h="809625">
                  <a:moveTo>
                    <a:pt x="1810004" y="404749"/>
                  </a:moveTo>
                  <a:lnTo>
                    <a:pt x="1799590" y="404749"/>
                  </a:lnTo>
                  <a:lnTo>
                    <a:pt x="1799590" y="809498"/>
                  </a:lnTo>
                  <a:lnTo>
                    <a:pt x="1810004" y="809498"/>
                  </a:lnTo>
                  <a:lnTo>
                    <a:pt x="1810004" y="404749"/>
                  </a:lnTo>
                  <a:close/>
                </a:path>
                <a:path w="4132579" h="809625">
                  <a:moveTo>
                    <a:pt x="1868043" y="466979"/>
                  </a:moveTo>
                  <a:lnTo>
                    <a:pt x="1857629" y="466979"/>
                  </a:lnTo>
                  <a:lnTo>
                    <a:pt x="1857629" y="809498"/>
                  </a:lnTo>
                  <a:lnTo>
                    <a:pt x="1868043" y="809498"/>
                  </a:lnTo>
                  <a:lnTo>
                    <a:pt x="1868043" y="466979"/>
                  </a:lnTo>
                  <a:close/>
                </a:path>
                <a:path w="4132579" h="809625">
                  <a:moveTo>
                    <a:pt x="1926069" y="560451"/>
                  </a:moveTo>
                  <a:lnTo>
                    <a:pt x="1915668" y="560451"/>
                  </a:lnTo>
                  <a:lnTo>
                    <a:pt x="1915668" y="809498"/>
                  </a:lnTo>
                  <a:lnTo>
                    <a:pt x="1926069" y="809498"/>
                  </a:lnTo>
                  <a:lnTo>
                    <a:pt x="1926069" y="560451"/>
                  </a:lnTo>
                  <a:close/>
                </a:path>
                <a:path w="4132579" h="809625">
                  <a:moveTo>
                    <a:pt x="1984121" y="716153"/>
                  </a:moveTo>
                  <a:lnTo>
                    <a:pt x="1973707" y="716153"/>
                  </a:lnTo>
                  <a:lnTo>
                    <a:pt x="1973707" y="809498"/>
                  </a:lnTo>
                  <a:lnTo>
                    <a:pt x="1984121" y="809498"/>
                  </a:lnTo>
                  <a:lnTo>
                    <a:pt x="1984121" y="716153"/>
                  </a:lnTo>
                  <a:close/>
                </a:path>
                <a:path w="4132579" h="809625">
                  <a:moveTo>
                    <a:pt x="2042160" y="622681"/>
                  </a:moveTo>
                  <a:lnTo>
                    <a:pt x="2031746" y="622681"/>
                  </a:lnTo>
                  <a:lnTo>
                    <a:pt x="2031746" y="809498"/>
                  </a:lnTo>
                  <a:lnTo>
                    <a:pt x="2042160" y="809498"/>
                  </a:lnTo>
                  <a:lnTo>
                    <a:pt x="2042160" y="622681"/>
                  </a:lnTo>
                  <a:close/>
                </a:path>
                <a:path w="4132579" h="809625">
                  <a:moveTo>
                    <a:pt x="2100199" y="311404"/>
                  </a:moveTo>
                  <a:lnTo>
                    <a:pt x="2089785" y="311404"/>
                  </a:lnTo>
                  <a:lnTo>
                    <a:pt x="2089785" y="809498"/>
                  </a:lnTo>
                  <a:lnTo>
                    <a:pt x="2100199" y="809498"/>
                  </a:lnTo>
                  <a:lnTo>
                    <a:pt x="2100199" y="311404"/>
                  </a:lnTo>
                  <a:close/>
                </a:path>
                <a:path w="4132579" h="809625">
                  <a:moveTo>
                    <a:pt x="2158365" y="435864"/>
                  </a:moveTo>
                  <a:lnTo>
                    <a:pt x="2147951" y="435864"/>
                  </a:lnTo>
                  <a:lnTo>
                    <a:pt x="2147951" y="809498"/>
                  </a:lnTo>
                  <a:lnTo>
                    <a:pt x="2158365" y="809498"/>
                  </a:lnTo>
                  <a:lnTo>
                    <a:pt x="2158365" y="435864"/>
                  </a:lnTo>
                  <a:close/>
                </a:path>
                <a:path w="4132579" h="809625">
                  <a:moveTo>
                    <a:pt x="2216404" y="560451"/>
                  </a:moveTo>
                  <a:lnTo>
                    <a:pt x="2205990" y="560451"/>
                  </a:lnTo>
                  <a:lnTo>
                    <a:pt x="2205990" y="809498"/>
                  </a:lnTo>
                  <a:lnTo>
                    <a:pt x="2216404" y="809498"/>
                  </a:lnTo>
                  <a:lnTo>
                    <a:pt x="2216404" y="560451"/>
                  </a:lnTo>
                  <a:close/>
                </a:path>
                <a:path w="4132579" h="809625">
                  <a:moveTo>
                    <a:pt x="2274443" y="591566"/>
                  </a:moveTo>
                  <a:lnTo>
                    <a:pt x="2264029" y="591566"/>
                  </a:lnTo>
                  <a:lnTo>
                    <a:pt x="2264029" y="809498"/>
                  </a:lnTo>
                  <a:lnTo>
                    <a:pt x="2274443" y="809498"/>
                  </a:lnTo>
                  <a:lnTo>
                    <a:pt x="2274443" y="591566"/>
                  </a:lnTo>
                  <a:close/>
                </a:path>
                <a:path w="4132579" h="809625">
                  <a:moveTo>
                    <a:pt x="2332469" y="591566"/>
                  </a:moveTo>
                  <a:lnTo>
                    <a:pt x="2322068" y="591566"/>
                  </a:lnTo>
                  <a:lnTo>
                    <a:pt x="2322068" y="809498"/>
                  </a:lnTo>
                  <a:lnTo>
                    <a:pt x="2332469" y="809498"/>
                  </a:lnTo>
                  <a:lnTo>
                    <a:pt x="2332469" y="591566"/>
                  </a:lnTo>
                  <a:close/>
                </a:path>
                <a:path w="4132579" h="809625">
                  <a:moveTo>
                    <a:pt x="2390521" y="435864"/>
                  </a:moveTo>
                  <a:lnTo>
                    <a:pt x="2380107" y="435864"/>
                  </a:lnTo>
                  <a:lnTo>
                    <a:pt x="2380107" y="809498"/>
                  </a:lnTo>
                  <a:lnTo>
                    <a:pt x="2390521" y="809498"/>
                  </a:lnTo>
                  <a:lnTo>
                    <a:pt x="2390521" y="435864"/>
                  </a:lnTo>
                  <a:close/>
                </a:path>
                <a:path w="4132579" h="809625">
                  <a:moveTo>
                    <a:pt x="2448560" y="498094"/>
                  </a:moveTo>
                  <a:lnTo>
                    <a:pt x="2438146" y="498094"/>
                  </a:lnTo>
                  <a:lnTo>
                    <a:pt x="2438146" y="809498"/>
                  </a:lnTo>
                  <a:lnTo>
                    <a:pt x="2448560" y="809498"/>
                  </a:lnTo>
                  <a:lnTo>
                    <a:pt x="2448560" y="498094"/>
                  </a:lnTo>
                  <a:close/>
                </a:path>
                <a:path w="4132579" h="809625">
                  <a:moveTo>
                    <a:pt x="2506599" y="498094"/>
                  </a:moveTo>
                  <a:lnTo>
                    <a:pt x="2496185" y="498094"/>
                  </a:lnTo>
                  <a:lnTo>
                    <a:pt x="2496185" y="809498"/>
                  </a:lnTo>
                  <a:lnTo>
                    <a:pt x="2506599" y="809498"/>
                  </a:lnTo>
                  <a:lnTo>
                    <a:pt x="2506599" y="498094"/>
                  </a:lnTo>
                  <a:close/>
                </a:path>
                <a:path w="4132579" h="809625">
                  <a:moveTo>
                    <a:pt x="2564638" y="529336"/>
                  </a:moveTo>
                  <a:lnTo>
                    <a:pt x="2554224" y="529336"/>
                  </a:lnTo>
                  <a:lnTo>
                    <a:pt x="2554224" y="809498"/>
                  </a:lnTo>
                  <a:lnTo>
                    <a:pt x="2564638" y="809498"/>
                  </a:lnTo>
                  <a:lnTo>
                    <a:pt x="2564638" y="529336"/>
                  </a:lnTo>
                  <a:close/>
                </a:path>
                <a:path w="4132579" h="809625">
                  <a:moveTo>
                    <a:pt x="2622677" y="622681"/>
                  </a:moveTo>
                  <a:lnTo>
                    <a:pt x="2612263" y="622681"/>
                  </a:lnTo>
                  <a:lnTo>
                    <a:pt x="2612263" y="809498"/>
                  </a:lnTo>
                  <a:lnTo>
                    <a:pt x="2622677" y="809498"/>
                  </a:lnTo>
                  <a:lnTo>
                    <a:pt x="2622677" y="622681"/>
                  </a:lnTo>
                  <a:close/>
                </a:path>
                <a:path w="4132579" h="809625">
                  <a:moveTo>
                    <a:pt x="2680716" y="498094"/>
                  </a:moveTo>
                  <a:lnTo>
                    <a:pt x="2670302" y="498094"/>
                  </a:lnTo>
                  <a:lnTo>
                    <a:pt x="2670302" y="809498"/>
                  </a:lnTo>
                  <a:lnTo>
                    <a:pt x="2680716" y="809498"/>
                  </a:lnTo>
                  <a:lnTo>
                    <a:pt x="2680716" y="498094"/>
                  </a:lnTo>
                  <a:close/>
                </a:path>
                <a:path w="4132579" h="809625">
                  <a:moveTo>
                    <a:pt x="2738869" y="435864"/>
                  </a:moveTo>
                  <a:lnTo>
                    <a:pt x="2728468" y="435864"/>
                  </a:lnTo>
                  <a:lnTo>
                    <a:pt x="2728468" y="809498"/>
                  </a:lnTo>
                  <a:lnTo>
                    <a:pt x="2738869" y="809498"/>
                  </a:lnTo>
                  <a:lnTo>
                    <a:pt x="2738869" y="435864"/>
                  </a:lnTo>
                  <a:close/>
                </a:path>
                <a:path w="4132579" h="809625">
                  <a:moveTo>
                    <a:pt x="2796921" y="529336"/>
                  </a:moveTo>
                  <a:lnTo>
                    <a:pt x="2786507" y="529336"/>
                  </a:lnTo>
                  <a:lnTo>
                    <a:pt x="2786507" y="809498"/>
                  </a:lnTo>
                  <a:lnTo>
                    <a:pt x="2796921" y="809498"/>
                  </a:lnTo>
                  <a:lnTo>
                    <a:pt x="2796921" y="529336"/>
                  </a:lnTo>
                  <a:close/>
                </a:path>
                <a:path w="4132579" h="809625">
                  <a:moveTo>
                    <a:pt x="2854960" y="311404"/>
                  </a:moveTo>
                  <a:lnTo>
                    <a:pt x="2844546" y="311404"/>
                  </a:lnTo>
                  <a:lnTo>
                    <a:pt x="2844546" y="809498"/>
                  </a:lnTo>
                  <a:lnTo>
                    <a:pt x="2854960" y="809498"/>
                  </a:lnTo>
                  <a:lnTo>
                    <a:pt x="2854960" y="311404"/>
                  </a:lnTo>
                  <a:close/>
                </a:path>
                <a:path w="4132579" h="809625">
                  <a:moveTo>
                    <a:pt x="2912999" y="560451"/>
                  </a:moveTo>
                  <a:lnTo>
                    <a:pt x="2902585" y="560451"/>
                  </a:lnTo>
                  <a:lnTo>
                    <a:pt x="2902585" y="809498"/>
                  </a:lnTo>
                  <a:lnTo>
                    <a:pt x="2912999" y="809498"/>
                  </a:lnTo>
                  <a:lnTo>
                    <a:pt x="2912999" y="560451"/>
                  </a:lnTo>
                  <a:close/>
                </a:path>
                <a:path w="4132579" h="809625">
                  <a:moveTo>
                    <a:pt x="2971038" y="560451"/>
                  </a:moveTo>
                  <a:lnTo>
                    <a:pt x="2960624" y="560451"/>
                  </a:lnTo>
                  <a:lnTo>
                    <a:pt x="2960624" y="809498"/>
                  </a:lnTo>
                  <a:lnTo>
                    <a:pt x="2971038" y="809498"/>
                  </a:lnTo>
                  <a:lnTo>
                    <a:pt x="2971038" y="560451"/>
                  </a:lnTo>
                  <a:close/>
                </a:path>
                <a:path w="4132579" h="809625">
                  <a:moveTo>
                    <a:pt x="3029077" y="591566"/>
                  </a:moveTo>
                  <a:lnTo>
                    <a:pt x="3018663" y="591566"/>
                  </a:lnTo>
                  <a:lnTo>
                    <a:pt x="3018663" y="809498"/>
                  </a:lnTo>
                  <a:lnTo>
                    <a:pt x="3029077" y="809498"/>
                  </a:lnTo>
                  <a:lnTo>
                    <a:pt x="3029077" y="591566"/>
                  </a:lnTo>
                  <a:close/>
                </a:path>
                <a:path w="4132579" h="809625">
                  <a:moveTo>
                    <a:pt x="3087116" y="560451"/>
                  </a:moveTo>
                  <a:lnTo>
                    <a:pt x="3076702" y="560451"/>
                  </a:lnTo>
                  <a:lnTo>
                    <a:pt x="3076702" y="809498"/>
                  </a:lnTo>
                  <a:lnTo>
                    <a:pt x="3087116" y="809498"/>
                  </a:lnTo>
                  <a:lnTo>
                    <a:pt x="3087116" y="560451"/>
                  </a:lnTo>
                  <a:close/>
                </a:path>
                <a:path w="4132579" h="809625">
                  <a:moveTo>
                    <a:pt x="3145155" y="311404"/>
                  </a:moveTo>
                  <a:lnTo>
                    <a:pt x="3134741" y="311404"/>
                  </a:lnTo>
                  <a:lnTo>
                    <a:pt x="3134741" y="809498"/>
                  </a:lnTo>
                  <a:lnTo>
                    <a:pt x="3145155" y="809498"/>
                  </a:lnTo>
                  <a:lnTo>
                    <a:pt x="3145155" y="311404"/>
                  </a:lnTo>
                  <a:close/>
                </a:path>
                <a:path w="4132579" h="809625">
                  <a:moveTo>
                    <a:pt x="3203194" y="653796"/>
                  </a:moveTo>
                  <a:lnTo>
                    <a:pt x="3192780" y="653796"/>
                  </a:lnTo>
                  <a:lnTo>
                    <a:pt x="3192780" y="809498"/>
                  </a:lnTo>
                  <a:lnTo>
                    <a:pt x="3203194" y="809498"/>
                  </a:lnTo>
                  <a:lnTo>
                    <a:pt x="3203194" y="653796"/>
                  </a:lnTo>
                  <a:close/>
                </a:path>
                <a:path w="4132579" h="809625">
                  <a:moveTo>
                    <a:pt x="3261360" y="373634"/>
                  </a:moveTo>
                  <a:lnTo>
                    <a:pt x="3250946" y="373634"/>
                  </a:lnTo>
                  <a:lnTo>
                    <a:pt x="3250946" y="809498"/>
                  </a:lnTo>
                  <a:lnTo>
                    <a:pt x="3261360" y="809498"/>
                  </a:lnTo>
                  <a:lnTo>
                    <a:pt x="3261360" y="373634"/>
                  </a:lnTo>
                  <a:close/>
                </a:path>
                <a:path w="4132579" h="809625">
                  <a:moveTo>
                    <a:pt x="3319399" y="591566"/>
                  </a:moveTo>
                  <a:lnTo>
                    <a:pt x="3308985" y="591566"/>
                  </a:lnTo>
                  <a:lnTo>
                    <a:pt x="3308985" y="809498"/>
                  </a:lnTo>
                  <a:lnTo>
                    <a:pt x="3319399" y="809498"/>
                  </a:lnTo>
                  <a:lnTo>
                    <a:pt x="3319399" y="591566"/>
                  </a:lnTo>
                  <a:close/>
                </a:path>
                <a:path w="4132579" h="809625">
                  <a:moveTo>
                    <a:pt x="3377438" y="653796"/>
                  </a:moveTo>
                  <a:lnTo>
                    <a:pt x="3367024" y="653796"/>
                  </a:lnTo>
                  <a:lnTo>
                    <a:pt x="3367024" y="809498"/>
                  </a:lnTo>
                  <a:lnTo>
                    <a:pt x="3377438" y="809498"/>
                  </a:lnTo>
                  <a:lnTo>
                    <a:pt x="3377438" y="653796"/>
                  </a:lnTo>
                  <a:close/>
                </a:path>
                <a:path w="4132579" h="809625">
                  <a:moveTo>
                    <a:pt x="3435477" y="529336"/>
                  </a:moveTo>
                  <a:lnTo>
                    <a:pt x="3425063" y="529336"/>
                  </a:lnTo>
                  <a:lnTo>
                    <a:pt x="3425063" y="809498"/>
                  </a:lnTo>
                  <a:lnTo>
                    <a:pt x="3435477" y="809498"/>
                  </a:lnTo>
                  <a:lnTo>
                    <a:pt x="3435477" y="529336"/>
                  </a:lnTo>
                  <a:close/>
                </a:path>
                <a:path w="4132579" h="809625">
                  <a:moveTo>
                    <a:pt x="3493516" y="404749"/>
                  </a:moveTo>
                  <a:lnTo>
                    <a:pt x="3483102" y="404749"/>
                  </a:lnTo>
                  <a:lnTo>
                    <a:pt x="3483102" y="809498"/>
                  </a:lnTo>
                  <a:lnTo>
                    <a:pt x="3493516" y="809498"/>
                  </a:lnTo>
                  <a:lnTo>
                    <a:pt x="3493516" y="404749"/>
                  </a:lnTo>
                  <a:close/>
                </a:path>
                <a:path w="4132579" h="809625">
                  <a:moveTo>
                    <a:pt x="3551555" y="311404"/>
                  </a:moveTo>
                  <a:lnTo>
                    <a:pt x="3541141" y="311404"/>
                  </a:lnTo>
                  <a:lnTo>
                    <a:pt x="3541141" y="809498"/>
                  </a:lnTo>
                  <a:lnTo>
                    <a:pt x="3551555" y="809498"/>
                  </a:lnTo>
                  <a:lnTo>
                    <a:pt x="3551555" y="311404"/>
                  </a:lnTo>
                  <a:close/>
                </a:path>
                <a:path w="4132579" h="809625">
                  <a:moveTo>
                    <a:pt x="3609594" y="622681"/>
                  </a:moveTo>
                  <a:lnTo>
                    <a:pt x="3599180" y="622681"/>
                  </a:lnTo>
                  <a:lnTo>
                    <a:pt x="3599180" y="809498"/>
                  </a:lnTo>
                  <a:lnTo>
                    <a:pt x="3609594" y="809498"/>
                  </a:lnTo>
                  <a:lnTo>
                    <a:pt x="3609594" y="622681"/>
                  </a:lnTo>
                  <a:close/>
                </a:path>
                <a:path w="4132579" h="809625">
                  <a:moveTo>
                    <a:pt x="3667620" y="249047"/>
                  </a:moveTo>
                  <a:lnTo>
                    <a:pt x="3657219" y="249047"/>
                  </a:lnTo>
                  <a:lnTo>
                    <a:pt x="3657219" y="809498"/>
                  </a:lnTo>
                  <a:lnTo>
                    <a:pt x="3667620" y="809498"/>
                  </a:lnTo>
                  <a:lnTo>
                    <a:pt x="3667620" y="249047"/>
                  </a:lnTo>
                  <a:close/>
                </a:path>
                <a:path w="4132579" h="809625">
                  <a:moveTo>
                    <a:pt x="3725672" y="498094"/>
                  </a:moveTo>
                  <a:lnTo>
                    <a:pt x="3715258" y="498094"/>
                  </a:lnTo>
                  <a:lnTo>
                    <a:pt x="3715258" y="809498"/>
                  </a:lnTo>
                  <a:lnTo>
                    <a:pt x="3725672" y="809498"/>
                  </a:lnTo>
                  <a:lnTo>
                    <a:pt x="3725672" y="498094"/>
                  </a:lnTo>
                  <a:close/>
                </a:path>
                <a:path w="4132579" h="809625">
                  <a:moveTo>
                    <a:pt x="3783838" y="529336"/>
                  </a:moveTo>
                  <a:lnTo>
                    <a:pt x="3773424" y="529336"/>
                  </a:lnTo>
                  <a:lnTo>
                    <a:pt x="3773424" y="809498"/>
                  </a:lnTo>
                  <a:lnTo>
                    <a:pt x="3783838" y="809498"/>
                  </a:lnTo>
                  <a:lnTo>
                    <a:pt x="3783838" y="529336"/>
                  </a:lnTo>
                  <a:close/>
                </a:path>
                <a:path w="4132579" h="809625">
                  <a:moveTo>
                    <a:pt x="3841877" y="217932"/>
                  </a:moveTo>
                  <a:lnTo>
                    <a:pt x="3831463" y="217932"/>
                  </a:lnTo>
                  <a:lnTo>
                    <a:pt x="3831463" y="809498"/>
                  </a:lnTo>
                  <a:lnTo>
                    <a:pt x="3841877" y="809498"/>
                  </a:lnTo>
                  <a:lnTo>
                    <a:pt x="3841877" y="217932"/>
                  </a:lnTo>
                  <a:close/>
                </a:path>
                <a:path w="4132579" h="809625">
                  <a:moveTo>
                    <a:pt x="3899916" y="466979"/>
                  </a:moveTo>
                  <a:lnTo>
                    <a:pt x="3889502" y="466979"/>
                  </a:lnTo>
                  <a:lnTo>
                    <a:pt x="3889502" y="809498"/>
                  </a:lnTo>
                  <a:lnTo>
                    <a:pt x="3899916" y="809498"/>
                  </a:lnTo>
                  <a:lnTo>
                    <a:pt x="3899916" y="466979"/>
                  </a:lnTo>
                  <a:close/>
                </a:path>
                <a:path w="4132579" h="809625">
                  <a:moveTo>
                    <a:pt x="3957955" y="373634"/>
                  </a:moveTo>
                  <a:lnTo>
                    <a:pt x="3947541" y="373634"/>
                  </a:lnTo>
                  <a:lnTo>
                    <a:pt x="3947541" y="809498"/>
                  </a:lnTo>
                  <a:lnTo>
                    <a:pt x="3957955" y="809498"/>
                  </a:lnTo>
                  <a:lnTo>
                    <a:pt x="3957955" y="373634"/>
                  </a:lnTo>
                  <a:close/>
                </a:path>
                <a:path w="4132579" h="809625">
                  <a:moveTo>
                    <a:pt x="4015994" y="0"/>
                  </a:moveTo>
                  <a:lnTo>
                    <a:pt x="4005580" y="0"/>
                  </a:lnTo>
                  <a:lnTo>
                    <a:pt x="4005580" y="809498"/>
                  </a:lnTo>
                  <a:lnTo>
                    <a:pt x="4015994" y="809498"/>
                  </a:lnTo>
                  <a:lnTo>
                    <a:pt x="4015994" y="0"/>
                  </a:lnTo>
                  <a:close/>
                </a:path>
                <a:path w="4132579" h="809625">
                  <a:moveTo>
                    <a:pt x="4074020" y="560451"/>
                  </a:moveTo>
                  <a:lnTo>
                    <a:pt x="4063619" y="560451"/>
                  </a:lnTo>
                  <a:lnTo>
                    <a:pt x="4063619" y="809498"/>
                  </a:lnTo>
                  <a:lnTo>
                    <a:pt x="4074020" y="809498"/>
                  </a:lnTo>
                  <a:lnTo>
                    <a:pt x="4074020" y="560451"/>
                  </a:lnTo>
                  <a:close/>
                </a:path>
                <a:path w="4132579" h="809625">
                  <a:moveTo>
                    <a:pt x="4132072" y="529336"/>
                  </a:moveTo>
                  <a:lnTo>
                    <a:pt x="4121658" y="529336"/>
                  </a:lnTo>
                  <a:lnTo>
                    <a:pt x="4121658" y="809498"/>
                  </a:lnTo>
                  <a:lnTo>
                    <a:pt x="4132072" y="809498"/>
                  </a:lnTo>
                  <a:lnTo>
                    <a:pt x="4132072" y="529336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3" name="object 103" descr=""/>
            <p:cNvSpPr/>
            <p:nvPr/>
          </p:nvSpPr>
          <p:spPr>
            <a:xfrm>
              <a:off x="5652770" y="8039735"/>
              <a:ext cx="4074160" cy="622935"/>
            </a:xfrm>
            <a:custGeom>
              <a:avLst/>
              <a:gdLst/>
              <a:ahLst/>
              <a:cxnLst/>
              <a:rect l="l" t="t" r="r" b="b"/>
              <a:pathLst>
                <a:path w="4074159" h="622934">
                  <a:moveTo>
                    <a:pt x="10414" y="342519"/>
                  </a:moveTo>
                  <a:lnTo>
                    <a:pt x="0" y="342519"/>
                  </a:lnTo>
                  <a:lnTo>
                    <a:pt x="0" y="622681"/>
                  </a:lnTo>
                  <a:lnTo>
                    <a:pt x="10414" y="622681"/>
                  </a:lnTo>
                  <a:lnTo>
                    <a:pt x="10414" y="342519"/>
                  </a:lnTo>
                  <a:close/>
                </a:path>
                <a:path w="4074159" h="622934">
                  <a:moveTo>
                    <a:pt x="68453" y="249047"/>
                  </a:moveTo>
                  <a:lnTo>
                    <a:pt x="58039" y="249047"/>
                  </a:lnTo>
                  <a:lnTo>
                    <a:pt x="58039" y="622681"/>
                  </a:lnTo>
                  <a:lnTo>
                    <a:pt x="68453" y="622681"/>
                  </a:lnTo>
                  <a:lnTo>
                    <a:pt x="68453" y="249047"/>
                  </a:lnTo>
                  <a:close/>
                </a:path>
                <a:path w="4074159" h="622934">
                  <a:moveTo>
                    <a:pt x="126492" y="311277"/>
                  </a:moveTo>
                  <a:lnTo>
                    <a:pt x="116078" y="311277"/>
                  </a:lnTo>
                  <a:lnTo>
                    <a:pt x="116078" y="622681"/>
                  </a:lnTo>
                  <a:lnTo>
                    <a:pt x="126492" y="622681"/>
                  </a:lnTo>
                  <a:lnTo>
                    <a:pt x="126492" y="311277"/>
                  </a:lnTo>
                  <a:close/>
                </a:path>
                <a:path w="4074159" h="622934">
                  <a:moveTo>
                    <a:pt x="184531" y="342519"/>
                  </a:moveTo>
                  <a:lnTo>
                    <a:pt x="174117" y="342519"/>
                  </a:lnTo>
                  <a:lnTo>
                    <a:pt x="174117" y="622681"/>
                  </a:lnTo>
                  <a:lnTo>
                    <a:pt x="184531" y="622681"/>
                  </a:lnTo>
                  <a:lnTo>
                    <a:pt x="184531" y="342519"/>
                  </a:lnTo>
                  <a:close/>
                </a:path>
                <a:path w="4074159" h="622934">
                  <a:moveTo>
                    <a:pt x="242697" y="249047"/>
                  </a:moveTo>
                  <a:lnTo>
                    <a:pt x="232283" y="249047"/>
                  </a:lnTo>
                  <a:lnTo>
                    <a:pt x="232283" y="622681"/>
                  </a:lnTo>
                  <a:lnTo>
                    <a:pt x="242697" y="622681"/>
                  </a:lnTo>
                  <a:lnTo>
                    <a:pt x="242697" y="249047"/>
                  </a:lnTo>
                  <a:close/>
                </a:path>
                <a:path w="4074159" h="622934">
                  <a:moveTo>
                    <a:pt x="300736" y="466979"/>
                  </a:moveTo>
                  <a:lnTo>
                    <a:pt x="290322" y="466979"/>
                  </a:lnTo>
                  <a:lnTo>
                    <a:pt x="290322" y="622681"/>
                  </a:lnTo>
                  <a:lnTo>
                    <a:pt x="300736" y="622681"/>
                  </a:lnTo>
                  <a:lnTo>
                    <a:pt x="300736" y="466979"/>
                  </a:lnTo>
                  <a:close/>
                </a:path>
                <a:path w="4074159" h="622934">
                  <a:moveTo>
                    <a:pt x="358762" y="124587"/>
                  </a:moveTo>
                  <a:lnTo>
                    <a:pt x="348361" y="124587"/>
                  </a:lnTo>
                  <a:lnTo>
                    <a:pt x="348361" y="622681"/>
                  </a:lnTo>
                  <a:lnTo>
                    <a:pt x="358762" y="622681"/>
                  </a:lnTo>
                  <a:lnTo>
                    <a:pt x="358762" y="124587"/>
                  </a:lnTo>
                  <a:close/>
                </a:path>
                <a:path w="4074159" h="622934">
                  <a:moveTo>
                    <a:pt x="416814" y="529336"/>
                  </a:moveTo>
                  <a:lnTo>
                    <a:pt x="406400" y="529336"/>
                  </a:lnTo>
                  <a:lnTo>
                    <a:pt x="406400" y="622681"/>
                  </a:lnTo>
                  <a:lnTo>
                    <a:pt x="416814" y="622681"/>
                  </a:lnTo>
                  <a:lnTo>
                    <a:pt x="416814" y="529336"/>
                  </a:lnTo>
                  <a:close/>
                </a:path>
                <a:path w="4074159" h="622934">
                  <a:moveTo>
                    <a:pt x="474853" y="280162"/>
                  </a:moveTo>
                  <a:lnTo>
                    <a:pt x="464439" y="280162"/>
                  </a:lnTo>
                  <a:lnTo>
                    <a:pt x="464439" y="622681"/>
                  </a:lnTo>
                  <a:lnTo>
                    <a:pt x="474853" y="622681"/>
                  </a:lnTo>
                  <a:lnTo>
                    <a:pt x="474853" y="280162"/>
                  </a:lnTo>
                  <a:close/>
                </a:path>
                <a:path w="4074159" h="622934">
                  <a:moveTo>
                    <a:pt x="532892" y="342519"/>
                  </a:moveTo>
                  <a:lnTo>
                    <a:pt x="522478" y="342519"/>
                  </a:lnTo>
                  <a:lnTo>
                    <a:pt x="522478" y="622681"/>
                  </a:lnTo>
                  <a:lnTo>
                    <a:pt x="532892" y="622681"/>
                  </a:lnTo>
                  <a:lnTo>
                    <a:pt x="532892" y="342519"/>
                  </a:lnTo>
                  <a:close/>
                </a:path>
                <a:path w="4074159" h="622934">
                  <a:moveTo>
                    <a:pt x="590931" y="373634"/>
                  </a:moveTo>
                  <a:lnTo>
                    <a:pt x="580517" y="373634"/>
                  </a:lnTo>
                  <a:lnTo>
                    <a:pt x="580517" y="622681"/>
                  </a:lnTo>
                  <a:lnTo>
                    <a:pt x="590931" y="622681"/>
                  </a:lnTo>
                  <a:lnTo>
                    <a:pt x="590931" y="373634"/>
                  </a:lnTo>
                  <a:close/>
                </a:path>
                <a:path w="4074159" h="622934">
                  <a:moveTo>
                    <a:pt x="648970" y="373634"/>
                  </a:moveTo>
                  <a:lnTo>
                    <a:pt x="638556" y="373634"/>
                  </a:lnTo>
                  <a:lnTo>
                    <a:pt x="638556" y="622681"/>
                  </a:lnTo>
                  <a:lnTo>
                    <a:pt x="648970" y="622681"/>
                  </a:lnTo>
                  <a:lnTo>
                    <a:pt x="648970" y="373634"/>
                  </a:lnTo>
                  <a:close/>
                </a:path>
                <a:path w="4074159" h="622934">
                  <a:moveTo>
                    <a:pt x="707009" y="498094"/>
                  </a:moveTo>
                  <a:lnTo>
                    <a:pt x="696595" y="498094"/>
                  </a:lnTo>
                  <a:lnTo>
                    <a:pt x="696595" y="622681"/>
                  </a:lnTo>
                  <a:lnTo>
                    <a:pt x="707009" y="622681"/>
                  </a:lnTo>
                  <a:lnTo>
                    <a:pt x="707009" y="498094"/>
                  </a:lnTo>
                  <a:close/>
                </a:path>
                <a:path w="4074159" h="622934">
                  <a:moveTo>
                    <a:pt x="765162" y="404749"/>
                  </a:moveTo>
                  <a:lnTo>
                    <a:pt x="754761" y="404749"/>
                  </a:lnTo>
                  <a:lnTo>
                    <a:pt x="754761" y="622681"/>
                  </a:lnTo>
                  <a:lnTo>
                    <a:pt x="765162" y="622681"/>
                  </a:lnTo>
                  <a:lnTo>
                    <a:pt x="765162" y="404749"/>
                  </a:lnTo>
                  <a:close/>
                </a:path>
                <a:path w="4074159" h="622934">
                  <a:moveTo>
                    <a:pt x="823214" y="498094"/>
                  </a:moveTo>
                  <a:lnTo>
                    <a:pt x="812800" y="498094"/>
                  </a:lnTo>
                  <a:lnTo>
                    <a:pt x="812800" y="622681"/>
                  </a:lnTo>
                  <a:lnTo>
                    <a:pt x="823214" y="622681"/>
                  </a:lnTo>
                  <a:lnTo>
                    <a:pt x="823214" y="498094"/>
                  </a:lnTo>
                  <a:close/>
                </a:path>
                <a:path w="4074159" h="622934">
                  <a:moveTo>
                    <a:pt x="881253" y="186817"/>
                  </a:moveTo>
                  <a:lnTo>
                    <a:pt x="870826" y="186817"/>
                  </a:lnTo>
                  <a:lnTo>
                    <a:pt x="870826" y="622681"/>
                  </a:lnTo>
                  <a:lnTo>
                    <a:pt x="881253" y="622681"/>
                  </a:lnTo>
                  <a:lnTo>
                    <a:pt x="881253" y="186817"/>
                  </a:lnTo>
                  <a:close/>
                </a:path>
                <a:path w="4074159" h="622934">
                  <a:moveTo>
                    <a:pt x="939292" y="217932"/>
                  </a:moveTo>
                  <a:lnTo>
                    <a:pt x="928878" y="217932"/>
                  </a:lnTo>
                  <a:lnTo>
                    <a:pt x="928878" y="622681"/>
                  </a:lnTo>
                  <a:lnTo>
                    <a:pt x="939292" y="622681"/>
                  </a:lnTo>
                  <a:lnTo>
                    <a:pt x="939292" y="217932"/>
                  </a:lnTo>
                  <a:close/>
                </a:path>
                <a:path w="4074159" h="622934">
                  <a:moveTo>
                    <a:pt x="997331" y="280162"/>
                  </a:moveTo>
                  <a:lnTo>
                    <a:pt x="986904" y="280162"/>
                  </a:lnTo>
                  <a:lnTo>
                    <a:pt x="986904" y="622681"/>
                  </a:lnTo>
                  <a:lnTo>
                    <a:pt x="997331" y="622681"/>
                  </a:lnTo>
                  <a:lnTo>
                    <a:pt x="997331" y="280162"/>
                  </a:lnTo>
                  <a:close/>
                </a:path>
                <a:path w="4074159" h="622934">
                  <a:moveTo>
                    <a:pt x="1055370" y="435864"/>
                  </a:moveTo>
                  <a:lnTo>
                    <a:pt x="1044956" y="435864"/>
                  </a:lnTo>
                  <a:lnTo>
                    <a:pt x="1044956" y="622681"/>
                  </a:lnTo>
                  <a:lnTo>
                    <a:pt x="1055370" y="622681"/>
                  </a:lnTo>
                  <a:lnTo>
                    <a:pt x="1055370" y="435864"/>
                  </a:lnTo>
                  <a:close/>
                </a:path>
                <a:path w="4074159" h="622934">
                  <a:moveTo>
                    <a:pt x="1113409" y="155702"/>
                  </a:moveTo>
                  <a:lnTo>
                    <a:pt x="1102995" y="155702"/>
                  </a:lnTo>
                  <a:lnTo>
                    <a:pt x="1102995" y="622681"/>
                  </a:lnTo>
                  <a:lnTo>
                    <a:pt x="1113409" y="622681"/>
                  </a:lnTo>
                  <a:lnTo>
                    <a:pt x="1113409" y="155702"/>
                  </a:lnTo>
                  <a:close/>
                </a:path>
                <a:path w="4074159" h="622934">
                  <a:moveTo>
                    <a:pt x="1171448" y="342519"/>
                  </a:moveTo>
                  <a:lnTo>
                    <a:pt x="1161034" y="342519"/>
                  </a:lnTo>
                  <a:lnTo>
                    <a:pt x="1161034" y="622681"/>
                  </a:lnTo>
                  <a:lnTo>
                    <a:pt x="1171448" y="622681"/>
                  </a:lnTo>
                  <a:lnTo>
                    <a:pt x="1171448" y="342519"/>
                  </a:lnTo>
                  <a:close/>
                </a:path>
                <a:path w="4074159" h="622934">
                  <a:moveTo>
                    <a:pt x="1229487" y="217932"/>
                  </a:moveTo>
                  <a:lnTo>
                    <a:pt x="1219073" y="217932"/>
                  </a:lnTo>
                  <a:lnTo>
                    <a:pt x="1219073" y="622681"/>
                  </a:lnTo>
                  <a:lnTo>
                    <a:pt x="1229487" y="622681"/>
                  </a:lnTo>
                  <a:lnTo>
                    <a:pt x="1229487" y="217932"/>
                  </a:lnTo>
                  <a:close/>
                </a:path>
                <a:path w="4074159" h="622934">
                  <a:moveTo>
                    <a:pt x="1287526" y="373634"/>
                  </a:moveTo>
                  <a:lnTo>
                    <a:pt x="1277112" y="373634"/>
                  </a:lnTo>
                  <a:lnTo>
                    <a:pt x="1277112" y="622681"/>
                  </a:lnTo>
                  <a:lnTo>
                    <a:pt x="1287526" y="622681"/>
                  </a:lnTo>
                  <a:lnTo>
                    <a:pt x="1287526" y="373634"/>
                  </a:lnTo>
                  <a:close/>
                </a:path>
                <a:path w="4074159" h="622934">
                  <a:moveTo>
                    <a:pt x="1345692" y="280162"/>
                  </a:moveTo>
                  <a:lnTo>
                    <a:pt x="1335278" y="280162"/>
                  </a:lnTo>
                  <a:lnTo>
                    <a:pt x="1335278" y="622681"/>
                  </a:lnTo>
                  <a:lnTo>
                    <a:pt x="1345692" y="622681"/>
                  </a:lnTo>
                  <a:lnTo>
                    <a:pt x="1345692" y="280162"/>
                  </a:lnTo>
                  <a:close/>
                </a:path>
                <a:path w="4074159" h="622934">
                  <a:moveTo>
                    <a:pt x="1403731" y="280162"/>
                  </a:moveTo>
                  <a:lnTo>
                    <a:pt x="1393317" y="280162"/>
                  </a:lnTo>
                  <a:lnTo>
                    <a:pt x="1393317" y="622681"/>
                  </a:lnTo>
                  <a:lnTo>
                    <a:pt x="1403731" y="622681"/>
                  </a:lnTo>
                  <a:lnTo>
                    <a:pt x="1403731" y="280162"/>
                  </a:lnTo>
                  <a:close/>
                </a:path>
                <a:path w="4074159" h="622934">
                  <a:moveTo>
                    <a:pt x="1461770" y="280162"/>
                  </a:moveTo>
                  <a:lnTo>
                    <a:pt x="1451356" y="280162"/>
                  </a:lnTo>
                  <a:lnTo>
                    <a:pt x="1451356" y="622681"/>
                  </a:lnTo>
                  <a:lnTo>
                    <a:pt x="1461770" y="622681"/>
                  </a:lnTo>
                  <a:lnTo>
                    <a:pt x="1461770" y="280162"/>
                  </a:lnTo>
                  <a:close/>
                </a:path>
                <a:path w="4074159" h="622934">
                  <a:moveTo>
                    <a:pt x="1519809" y="342519"/>
                  </a:moveTo>
                  <a:lnTo>
                    <a:pt x="1509395" y="342519"/>
                  </a:lnTo>
                  <a:lnTo>
                    <a:pt x="1509395" y="622681"/>
                  </a:lnTo>
                  <a:lnTo>
                    <a:pt x="1519809" y="622681"/>
                  </a:lnTo>
                  <a:lnTo>
                    <a:pt x="1519809" y="342519"/>
                  </a:lnTo>
                  <a:close/>
                </a:path>
                <a:path w="4074159" h="622934">
                  <a:moveTo>
                    <a:pt x="1577848" y="186817"/>
                  </a:moveTo>
                  <a:lnTo>
                    <a:pt x="1567434" y="186817"/>
                  </a:lnTo>
                  <a:lnTo>
                    <a:pt x="1567434" y="622681"/>
                  </a:lnTo>
                  <a:lnTo>
                    <a:pt x="1577848" y="622681"/>
                  </a:lnTo>
                  <a:lnTo>
                    <a:pt x="1577848" y="186817"/>
                  </a:lnTo>
                  <a:close/>
                </a:path>
                <a:path w="4074159" h="622934">
                  <a:moveTo>
                    <a:pt x="1635887" y="311277"/>
                  </a:moveTo>
                  <a:lnTo>
                    <a:pt x="1625473" y="311277"/>
                  </a:lnTo>
                  <a:lnTo>
                    <a:pt x="1625473" y="622681"/>
                  </a:lnTo>
                  <a:lnTo>
                    <a:pt x="1635887" y="622681"/>
                  </a:lnTo>
                  <a:lnTo>
                    <a:pt x="1635887" y="311277"/>
                  </a:lnTo>
                  <a:close/>
                </a:path>
                <a:path w="4074159" h="622934">
                  <a:moveTo>
                    <a:pt x="1693926" y="404749"/>
                  </a:moveTo>
                  <a:lnTo>
                    <a:pt x="1683512" y="404749"/>
                  </a:lnTo>
                  <a:lnTo>
                    <a:pt x="1683512" y="622681"/>
                  </a:lnTo>
                  <a:lnTo>
                    <a:pt x="1693926" y="622681"/>
                  </a:lnTo>
                  <a:lnTo>
                    <a:pt x="1693926" y="404749"/>
                  </a:lnTo>
                  <a:close/>
                </a:path>
                <a:path w="4074159" h="622934">
                  <a:moveTo>
                    <a:pt x="1751965" y="249047"/>
                  </a:moveTo>
                  <a:lnTo>
                    <a:pt x="1741551" y="249047"/>
                  </a:lnTo>
                  <a:lnTo>
                    <a:pt x="1741551" y="622681"/>
                  </a:lnTo>
                  <a:lnTo>
                    <a:pt x="1751965" y="622681"/>
                  </a:lnTo>
                  <a:lnTo>
                    <a:pt x="1751965" y="249047"/>
                  </a:lnTo>
                  <a:close/>
                </a:path>
                <a:path w="4074159" h="622934">
                  <a:moveTo>
                    <a:pt x="1810004" y="373634"/>
                  </a:moveTo>
                  <a:lnTo>
                    <a:pt x="1799590" y="373634"/>
                  </a:lnTo>
                  <a:lnTo>
                    <a:pt x="1799590" y="622681"/>
                  </a:lnTo>
                  <a:lnTo>
                    <a:pt x="1810004" y="622681"/>
                  </a:lnTo>
                  <a:lnTo>
                    <a:pt x="1810004" y="373634"/>
                  </a:lnTo>
                  <a:close/>
                </a:path>
                <a:path w="4074159" h="622934">
                  <a:moveTo>
                    <a:pt x="1868170" y="249047"/>
                  </a:moveTo>
                  <a:lnTo>
                    <a:pt x="1857756" y="249047"/>
                  </a:lnTo>
                  <a:lnTo>
                    <a:pt x="1857756" y="622681"/>
                  </a:lnTo>
                  <a:lnTo>
                    <a:pt x="1868170" y="622681"/>
                  </a:lnTo>
                  <a:lnTo>
                    <a:pt x="1868170" y="249047"/>
                  </a:lnTo>
                  <a:close/>
                </a:path>
                <a:path w="4074159" h="622934">
                  <a:moveTo>
                    <a:pt x="1926209" y="466979"/>
                  </a:moveTo>
                  <a:lnTo>
                    <a:pt x="1915795" y="466979"/>
                  </a:lnTo>
                  <a:lnTo>
                    <a:pt x="1915795" y="622681"/>
                  </a:lnTo>
                  <a:lnTo>
                    <a:pt x="1926209" y="622681"/>
                  </a:lnTo>
                  <a:lnTo>
                    <a:pt x="1926209" y="466979"/>
                  </a:lnTo>
                  <a:close/>
                </a:path>
                <a:path w="4074159" h="622934">
                  <a:moveTo>
                    <a:pt x="1984248" y="529336"/>
                  </a:moveTo>
                  <a:lnTo>
                    <a:pt x="1973834" y="529336"/>
                  </a:lnTo>
                  <a:lnTo>
                    <a:pt x="1973834" y="622681"/>
                  </a:lnTo>
                  <a:lnTo>
                    <a:pt x="1984248" y="622681"/>
                  </a:lnTo>
                  <a:lnTo>
                    <a:pt x="1984248" y="529336"/>
                  </a:lnTo>
                  <a:close/>
                </a:path>
                <a:path w="4074159" h="622934">
                  <a:moveTo>
                    <a:pt x="2042287" y="560451"/>
                  </a:moveTo>
                  <a:lnTo>
                    <a:pt x="2031873" y="560451"/>
                  </a:lnTo>
                  <a:lnTo>
                    <a:pt x="2031873" y="622681"/>
                  </a:lnTo>
                  <a:lnTo>
                    <a:pt x="2042287" y="622681"/>
                  </a:lnTo>
                  <a:lnTo>
                    <a:pt x="2042287" y="560451"/>
                  </a:lnTo>
                  <a:close/>
                </a:path>
                <a:path w="4074159" h="622934">
                  <a:moveTo>
                    <a:pt x="2100326" y="373634"/>
                  </a:moveTo>
                  <a:lnTo>
                    <a:pt x="2089912" y="373634"/>
                  </a:lnTo>
                  <a:lnTo>
                    <a:pt x="2089912" y="622681"/>
                  </a:lnTo>
                  <a:lnTo>
                    <a:pt x="2100326" y="622681"/>
                  </a:lnTo>
                  <a:lnTo>
                    <a:pt x="2100326" y="373634"/>
                  </a:lnTo>
                  <a:close/>
                </a:path>
                <a:path w="4074159" h="622934">
                  <a:moveTo>
                    <a:pt x="2158365" y="311277"/>
                  </a:moveTo>
                  <a:lnTo>
                    <a:pt x="2147951" y="311277"/>
                  </a:lnTo>
                  <a:lnTo>
                    <a:pt x="2147951" y="622681"/>
                  </a:lnTo>
                  <a:lnTo>
                    <a:pt x="2158365" y="622681"/>
                  </a:lnTo>
                  <a:lnTo>
                    <a:pt x="2158365" y="311277"/>
                  </a:lnTo>
                  <a:close/>
                </a:path>
                <a:path w="4074159" h="622934">
                  <a:moveTo>
                    <a:pt x="2216404" y="466979"/>
                  </a:moveTo>
                  <a:lnTo>
                    <a:pt x="2205990" y="466979"/>
                  </a:lnTo>
                  <a:lnTo>
                    <a:pt x="2205990" y="622681"/>
                  </a:lnTo>
                  <a:lnTo>
                    <a:pt x="2216404" y="622681"/>
                  </a:lnTo>
                  <a:lnTo>
                    <a:pt x="2216404" y="466979"/>
                  </a:lnTo>
                  <a:close/>
                </a:path>
                <a:path w="4074159" h="622934">
                  <a:moveTo>
                    <a:pt x="2274443" y="311277"/>
                  </a:moveTo>
                  <a:lnTo>
                    <a:pt x="2264029" y="311277"/>
                  </a:lnTo>
                  <a:lnTo>
                    <a:pt x="2264029" y="622681"/>
                  </a:lnTo>
                  <a:lnTo>
                    <a:pt x="2274443" y="622681"/>
                  </a:lnTo>
                  <a:lnTo>
                    <a:pt x="2274443" y="311277"/>
                  </a:lnTo>
                  <a:close/>
                </a:path>
                <a:path w="4074159" h="622934">
                  <a:moveTo>
                    <a:pt x="2332482" y="217932"/>
                  </a:moveTo>
                  <a:lnTo>
                    <a:pt x="2322068" y="217932"/>
                  </a:lnTo>
                  <a:lnTo>
                    <a:pt x="2322068" y="622681"/>
                  </a:lnTo>
                  <a:lnTo>
                    <a:pt x="2332482" y="622681"/>
                  </a:lnTo>
                  <a:lnTo>
                    <a:pt x="2332482" y="217932"/>
                  </a:lnTo>
                  <a:close/>
                </a:path>
                <a:path w="4074159" h="622934">
                  <a:moveTo>
                    <a:pt x="2393315" y="373634"/>
                  </a:moveTo>
                  <a:lnTo>
                    <a:pt x="2380234" y="373634"/>
                  </a:lnTo>
                  <a:lnTo>
                    <a:pt x="2380234" y="622681"/>
                  </a:lnTo>
                  <a:lnTo>
                    <a:pt x="2393315" y="622681"/>
                  </a:lnTo>
                  <a:lnTo>
                    <a:pt x="2393315" y="373634"/>
                  </a:lnTo>
                  <a:close/>
                </a:path>
                <a:path w="4074159" h="622934">
                  <a:moveTo>
                    <a:pt x="2448687" y="249047"/>
                  </a:moveTo>
                  <a:lnTo>
                    <a:pt x="2438273" y="249047"/>
                  </a:lnTo>
                  <a:lnTo>
                    <a:pt x="2438273" y="622681"/>
                  </a:lnTo>
                  <a:lnTo>
                    <a:pt x="2448687" y="622681"/>
                  </a:lnTo>
                  <a:lnTo>
                    <a:pt x="2448687" y="249047"/>
                  </a:lnTo>
                  <a:close/>
                </a:path>
                <a:path w="4074159" h="622934">
                  <a:moveTo>
                    <a:pt x="2506726" y="249047"/>
                  </a:moveTo>
                  <a:lnTo>
                    <a:pt x="2496312" y="249047"/>
                  </a:lnTo>
                  <a:lnTo>
                    <a:pt x="2496312" y="622681"/>
                  </a:lnTo>
                  <a:lnTo>
                    <a:pt x="2506726" y="622681"/>
                  </a:lnTo>
                  <a:lnTo>
                    <a:pt x="2506726" y="249047"/>
                  </a:lnTo>
                  <a:close/>
                </a:path>
                <a:path w="4074159" h="622934">
                  <a:moveTo>
                    <a:pt x="2564765" y="373634"/>
                  </a:moveTo>
                  <a:lnTo>
                    <a:pt x="2554351" y="373634"/>
                  </a:lnTo>
                  <a:lnTo>
                    <a:pt x="2554351" y="622681"/>
                  </a:lnTo>
                  <a:lnTo>
                    <a:pt x="2564765" y="622681"/>
                  </a:lnTo>
                  <a:lnTo>
                    <a:pt x="2564765" y="373634"/>
                  </a:lnTo>
                  <a:close/>
                </a:path>
                <a:path w="4074159" h="622934">
                  <a:moveTo>
                    <a:pt x="2622804" y="249047"/>
                  </a:moveTo>
                  <a:lnTo>
                    <a:pt x="2612390" y="249047"/>
                  </a:lnTo>
                  <a:lnTo>
                    <a:pt x="2612390" y="622681"/>
                  </a:lnTo>
                  <a:lnTo>
                    <a:pt x="2622804" y="622681"/>
                  </a:lnTo>
                  <a:lnTo>
                    <a:pt x="2622804" y="249047"/>
                  </a:lnTo>
                  <a:close/>
                </a:path>
                <a:path w="4074159" h="622934">
                  <a:moveTo>
                    <a:pt x="2680843" y="373634"/>
                  </a:moveTo>
                  <a:lnTo>
                    <a:pt x="2670429" y="373634"/>
                  </a:lnTo>
                  <a:lnTo>
                    <a:pt x="2670429" y="622681"/>
                  </a:lnTo>
                  <a:lnTo>
                    <a:pt x="2680843" y="622681"/>
                  </a:lnTo>
                  <a:lnTo>
                    <a:pt x="2680843" y="373634"/>
                  </a:lnTo>
                  <a:close/>
                </a:path>
                <a:path w="4074159" h="622934">
                  <a:moveTo>
                    <a:pt x="2738882" y="498094"/>
                  </a:moveTo>
                  <a:lnTo>
                    <a:pt x="2728468" y="498094"/>
                  </a:lnTo>
                  <a:lnTo>
                    <a:pt x="2728468" y="622681"/>
                  </a:lnTo>
                  <a:lnTo>
                    <a:pt x="2738882" y="622681"/>
                  </a:lnTo>
                  <a:lnTo>
                    <a:pt x="2738882" y="498094"/>
                  </a:lnTo>
                  <a:close/>
                </a:path>
                <a:path w="4074159" h="622934">
                  <a:moveTo>
                    <a:pt x="2796921" y="498094"/>
                  </a:moveTo>
                  <a:lnTo>
                    <a:pt x="2786507" y="498094"/>
                  </a:lnTo>
                  <a:lnTo>
                    <a:pt x="2786507" y="622681"/>
                  </a:lnTo>
                  <a:lnTo>
                    <a:pt x="2796921" y="622681"/>
                  </a:lnTo>
                  <a:lnTo>
                    <a:pt x="2796921" y="498094"/>
                  </a:lnTo>
                  <a:close/>
                </a:path>
                <a:path w="4074159" h="622934">
                  <a:moveTo>
                    <a:pt x="2854960" y="249047"/>
                  </a:moveTo>
                  <a:lnTo>
                    <a:pt x="2844546" y="249047"/>
                  </a:lnTo>
                  <a:lnTo>
                    <a:pt x="2844546" y="622681"/>
                  </a:lnTo>
                  <a:lnTo>
                    <a:pt x="2854960" y="622681"/>
                  </a:lnTo>
                  <a:lnTo>
                    <a:pt x="2854960" y="249047"/>
                  </a:lnTo>
                  <a:close/>
                </a:path>
                <a:path w="4074159" h="622934">
                  <a:moveTo>
                    <a:pt x="2912999" y="373634"/>
                  </a:moveTo>
                  <a:lnTo>
                    <a:pt x="2902585" y="373634"/>
                  </a:lnTo>
                  <a:lnTo>
                    <a:pt x="2902585" y="622681"/>
                  </a:lnTo>
                  <a:lnTo>
                    <a:pt x="2912999" y="622681"/>
                  </a:lnTo>
                  <a:lnTo>
                    <a:pt x="2912999" y="373634"/>
                  </a:lnTo>
                  <a:close/>
                </a:path>
                <a:path w="4074159" h="622934">
                  <a:moveTo>
                    <a:pt x="2971165" y="435864"/>
                  </a:moveTo>
                  <a:lnTo>
                    <a:pt x="2960751" y="435864"/>
                  </a:lnTo>
                  <a:lnTo>
                    <a:pt x="2960751" y="622681"/>
                  </a:lnTo>
                  <a:lnTo>
                    <a:pt x="2971165" y="622681"/>
                  </a:lnTo>
                  <a:lnTo>
                    <a:pt x="2971165" y="435864"/>
                  </a:lnTo>
                  <a:close/>
                </a:path>
                <a:path w="4074159" h="622934">
                  <a:moveTo>
                    <a:pt x="3029204" y="249047"/>
                  </a:moveTo>
                  <a:lnTo>
                    <a:pt x="3018790" y="249047"/>
                  </a:lnTo>
                  <a:lnTo>
                    <a:pt x="3018790" y="622681"/>
                  </a:lnTo>
                  <a:lnTo>
                    <a:pt x="3029204" y="622681"/>
                  </a:lnTo>
                  <a:lnTo>
                    <a:pt x="3029204" y="249047"/>
                  </a:lnTo>
                  <a:close/>
                </a:path>
                <a:path w="4074159" h="622934">
                  <a:moveTo>
                    <a:pt x="3087243" y="498094"/>
                  </a:moveTo>
                  <a:lnTo>
                    <a:pt x="3076829" y="498094"/>
                  </a:lnTo>
                  <a:lnTo>
                    <a:pt x="3076829" y="622681"/>
                  </a:lnTo>
                  <a:lnTo>
                    <a:pt x="3087243" y="622681"/>
                  </a:lnTo>
                  <a:lnTo>
                    <a:pt x="3087243" y="498094"/>
                  </a:lnTo>
                  <a:close/>
                </a:path>
                <a:path w="4074159" h="622934">
                  <a:moveTo>
                    <a:pt x="3145282" y="373634"/>
                  </a:moveTo>
                  <a:lnTo>
                    <a:pt x="3134868" y="373634"/>
                  </a:lnTo>
                  <a:lnTo>
                    <a:pt x="3134868" y="622681"/>
                  </a:lnTo>
                  <a:lnTo>
                    <a:pt x="3145282" y="622681"/>
                  </a:lnTo>
                  <a:lnTo>
                    <a:pt x="3145282" y="373634"/>
                  </a:lnTo>
                  <a:close/>
                </a:path>
                <a:path w="4074159" h="622934">
                  <a:moveTo>
                    <a:pt x="3203321" y="342519"/>
                  </a:moveTo>
                  <a:lnTo>
                    <a:pt x="3192907" y="342519"/>
                  </a:lnTo>
                  <a:lnTo>
                    <a:pt x="3192907" y="622681"/>
                  </a:lnTo>
                  <a:lnTo>
                    <a:pt x="3203321" y="622681"/>
                  </a:lnTo>
                  <a:lnTo>
                    <a:pt x="3203321" y="342519"/>
                  </a:lnTo>
                  <a:close/>
                </a:path>
                <a:path w="4074159" h="622934">
                  <a:moveTo>
                    <a:pt x="3261360" y="124587"/>
                  </a:moveTo>
                  <a:lnTo>
                    <a:pt x="3250946" y="124587"/>
                  </a:lnTo>
                  <a:lnTo>
                    <a:pt x="3250946" y="622681"/>
                  </a:lnTo>
                  <a:lnTo>
                    <a:pt x="3261360" y="622681"/>
                  </a:lnTo>
                  <a:lnTo>
                    <a:pt x="3261360" y="124587"/>
                  </a:lnTo>
                  <a:close/>
                </a:path>
                <a:path w="4074159" h="622934">
                  <a:moveTo>
                    <a:pt x="3319399" y="249047"/>
                  </a:moveTo>
                  <a:lnTo>
                    <a:pt x="3308985" y="249047"/>
                  </a:lnTo>
                  <a:lnTo>
                    <a:pt x="3308985" y="622681"/>
                  </a:lnTo>
                  <a:lnTo>
                    <a:pt x="3319399" y="622681"/>
                  </a:lnTo>
                  <a:lnTo>
                    <a:pt x="3319399" y="249047"/>
                  </a:lnTo>
                  <a:close/>
                </a:path>
                <a:path w="4074159" h="622934">
                  <a:moveTo>
                    <a:pt x="3377438" y="249047"/>
                  </a:moveTo>
                  <a:lnTo>
                    <a:pt x="3367024" y="249047"/>
                  </a:lnTo>
                  <a:lnTo>
                    <a:pt x="3367024" y="622681"/>
                  </a:lnTo>
                  <a:lnTo>
                    <a:pt x="3377438" y="622681"/>
                  </a:lnTo>
                  <a:lnTo>
                    <a:pt x="3377438" y="249047"/>
                  </a:lnTo>
                  <a:close/>
                </a:path>
                <a:path w="4074159" h="622934">
                  <a:moveTo>
                    <a:pt x="3435477" y="93345"/>
                  </a:moveTo>
                  <a:lnTo>
                    <a:pt x="3425063" y="93345"/>
                  </a:lnTo>
                  <a:lnTo>
                    <a:pt x="3425063" y="622681"/>
                  </a:lnTo>
                  <a:lnTo>
                    <a:pt x="3435477" y="622681"/>
                  </a:lnTo>
                  <a:lnTo>
                    <a:pt x="3435477" y="93345"/>
                  </a:lnTo>
                  <a:close/>
                </a:path>
                <a:path w="4074159" h="622934">
                  <a:moveTo>
                    <a:pt x="3493643" y="342519"/>
                  </a:moveTo>
                  <a:lnTo>
                    <a:pt x="3483229" y="342519"/>
                  </a:lnTo>
                  <a:lnTo>
                    <a:pt x="3483229" y="622681"/>
                  </a:lnTo>
                  <a:lnTo>
                    <a:pt x="3493643" y="622681"/>
                  </a:lnTo>
                  <a:lnTo>
                    <a:pt x="3493643" y="342519"/>
                  </a:lnTo>
                  <a:close/>
                </a:path>
                <a:path w="4074159" h="622934">
                  <a:moveTo>
                    <a:pt x="3551682" y="249047"/>
                  </a:moveTo>
                  <a:lnTo>
                    <a:pt x="3541268" y="249047"/>
                  </a:lnTo>
                  <a:lnTo>
                    <a:pt x="3541268" y="622681"/>
                  </a:lnTo>
                  <a:lnTo>
                    <a:pt x="3551682" y="622681"/>
                  </a:lnTo>
                  <a:lnTo>
                    <a:pt x="3551682" y="249047"/>
                  </a:lnTo>
                  <a:close/>
                </a:path>
                <a:path w="4074159" h="622934">
                  <a:moveTo>
                    <a:pt x="3609721" y="404749"/>
                  </a:moveTo>
                  <a:lnTo>
                    <a:pt x="3599307" y="404749"/>
                  </a:lnTo>
                  <a:lnTo>
                    <a:pt x="3599307" y="622681"/>
                  </a:lnTo>
                  <a:lnTo>
                    <a:pt x="3609721" y="622681"/>
                  </a:lnTo>
                  <a:lnTo>
                    <a:pt x="3609721" y="404749"/>
                  </a:lnTo>
                  <a:close/>
                </a:path>
                <a:path w="4074159" h="622934">
                  <a:moveTo>
                    <a:pt x="3667760" y="466979"/>
                  </a:moveTo>
                  <a:lnTo>
                    <a:pt x="3657346" y="466979"/>
                  </a:lnTo>
                  <a:lnTo>
                    <a:pt x="3657346" y="622681"/>
                  </a:lnTo>
                  <a:lnTo>
                    <a:pt x="3667760" y="622681"/>
                  </a:lnTo>
                  <a:lnTo>
                    <a:pt x="3667760" y="466979"/>
                  </a:lnTo>
                  <a:close/>
                </a:path>
                <a:path w="4074159" h="622934">
                  <a:moveTo>
                    <a:pt x="3725799" y="404749"/>
                  </a:moveTo>
                  <a:lnTo>
                    <a:pt x="3715385" y="404749"/>
                  </a:lnTo>
                  <a:lnTo>
                    <a:pt x="3715385" y="622681"/>
                  </a:lnTo>
                  <a:lnTo>
                    <a:pt x="3725799" y="622681"/>
                  </a:lnTo>
                  <a:lnTo>
                    <a:pt x="3725799" y="404749"/>
                  </a:lnTo>
                  <a:close/>
                </a:path>
                <a:path w="4074159" h="622934">
                  <a:moveTo>
                    <a:pt x="3783838" y="249047"/>
                  </a:moveTo>
                  <a:lnTo>
                    <a:pt x="3773424" y="249047"/>
                  </a:lnTo>
                  <a:lnTo>
                    <a:pt x="3773424" y="622681"/>
                  </a:lnTo>
                  <a:lnTo>
                    <a:pt x="3783838" y="622681"/>
                  </a:lnTo>
                  <a:lnTo>
                    <a:pt x="3783838" y="249047"/>
                  </a:lnTo>
                  <a:close/>
                </a:path>
                <a:path w="4074159" h="622934">
                  <a:moveTo>
                    <a:pt x="3841877" y="280162"/>
                  </a:moveTo>
                  <a:lnTo>
                    <a:pt x="3831463" y="280162"/>
                  </a:lnTo>
                  <a:lnTo>
                    <a:pt x="3831463" y="622681"/>
                  </a:lnTo>
                  <a:lnTo>
                    <a:pt x="3841877" y="622681"/>
                  </a:lnTo>
                  <a:lnTo>
                    <a:pt x="3841877" y="280162"/>
                  </a:lnTo>
                  <a:close/>
                </a:path>
                <a:path w="4074159" h="622934">
                  <a:moveTo>
                    <a:pt x="3899916" y="404749"/>
                  </a:moveTo>
                  <a:lnTo>
                    <a:pt x="3889502" y="404749"/>
                  </a:lnTo>
                  <a:lnTo>
                    <a:pt x="3889502" y="622681"/>
                  </a:lnTo>
                  <a:lnTo>
                    <a:pt x="3899916" y="622681"/>
                  </a:lnTo>
                  <a:lnTo>
                    <a:pt x="3899916" y="404749"/>
                  </a:lnTo>
                  <a:close/>
                </a:path>
                <a:path w="4074159" h="622934">
                  <a:moveTo>
                    <a:pt x="3957955" y="93345"/>
                  </a:moveTo>
                  <a:lnTo>
                    <a:pt x="3947541" y="93345"/>
                  </a:lnTo>
                  <a:lnTo>
                    <a:pt x="3947541" y="622681"/>
                  </a:lnTo>
                  <a:lnTo>
                    <a:pt x="3957955" y="622681"/>
                  </a:lnTo>
                  <a:lnTo>
                    <a:pt x="3957955" y="93345"/>
                  </a:lnTo>
                  <a:close/>
                </a:path>
                <a:path w="4074159" h="622934">
                  <a:moveTo>
                    <a:pt x="4016121" y="0"/>
                  </a:moveTo>
                  <a:lnTo>
                    <a:pt x="4005707" y="0"/>
                  </a:lnTo>
                  <a:lnTo>
                    <a:pt x="4005707" y="622681"/>
                  </a:lnTo>
                  <a:lnTo>
                    <a:pt x="4016121" y="622681"/>
                  </a:lnTo>
                  <a:lnTo>
                    <a:pt x="4016121" y="0"/>
                  </a:lnTo>
                  <a:close/>
                </a:path>
                <a:path w="4074159" h="622934">
                  <a:moveTo>
                    <a:pt x="4074160" y="404749"/>
                  </a:moveTo>
                  <a:lnTo>
                    <a:pt x="4063746" y="404749"/>
                  </a:lnTo>
                  <a:lnTo>
                    <a:pt x="4063746" y="622681"/>
                  </a:lnTo>
                  <a:lnTo>
                    <a:pt x="4074160" y="622681"/>
                  </a:lnTo>
                  <a:lnTo>
                    <a:pt x="4074160" y="404749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4" name="object 104" descr=""/>
            <p:cNvSpPr/>
            <p:nvPr/>
          </p:nvSpPr>
          <p:spPr>
            <a:xfrm>
              <a:off x="9716516" y="7884033"/>
              <a:ext cx="4076700" cy="778510"/>
            </a:xfrm>
            <a:custGeom>
              <a:avLst/>
              <a:gdLst/>
              <a:ahLst/>
              <a:cxnLst/>
              <a:rect l="l" t="t" r="r" b="b"/>
              <a:pathLst>
                <a:path w="4076700" h="778509">
                  <a:moveTo>
                    <a:pt x="10414" y="560451"/>
                  </a:moveTo>
                  <a:lnTo>
                    <a:pt x="0" y="560451"/>
                  </a:lnTo>
                  <a:lnTo>
                    <a:pt x="0" y="778383"/>
                  </a:lnTo>
                  <a:lnTo>
                    <a:pt x="10414" y="778383"/>
                  </a:lnTo>
                  <a:lnTo>
                    <a:pt x="10414" y="560451"/>
                  </a:lnTo>
                  <a:close/>
                </a:path>
                <a:path w="4076700" h="778509">
                  <a:moveTo>
                    <a:pt x="68453" y="529336"/>
                  </a:moveTo>
                  <a:lnTo>
                    <a:pt x="58039" y="529336"/>
                  </a:lnTo>
                  <a:lnTo>
                    <a:pt x="58039" y="778383"/>
                  </a:lnTo>
                  <a:lnTo>
                    <a:pt x="68453" y="778383"/>
                  </a:lnTo>
                  <a:lnTo>
                    <a:pt x="68453" y="529336"/>
                  </a:lnTo>
                  <a:close/>
                </a:path>
                <a:path w="4076700" h="778509">
                  <a:moveTo>
                    <a:pt x="126492" y="653796"/>
                  </a:moveTo>
                  <a:lnTo>
                    <a:pt x="116078" y="653796"/>
                  </a:lnTo>
                  <a:lnTo>
                    <a:pt x="116078" y="778383"/>
                  </a:lnTo>
                  <a:lnTo>
                    <a:pt x="126492" y="778383"/>
                  </a:lnTo>
                  <a:lnTo>
                    <a:pt x="126492" y="653796"/>
                  </a:lnTo>
                  <a:close/>
                </a:path>
                <a:path w="4076700" h="778509">
                  <a:moveTo>
                    <a:pt x="184531" y="560451"/>
                  </a:moveTo>
                  <a:lnTo>
                    <a:pt x="174117" y="560451"/>
                  </a:lnTo>
                  <a:lnTo>
                    <a:pt x="174117" y="778383"/>
                  </a:lnTo>
                  <a:lnTo>
                    <a:pt x="184531" y="778383"/>
                  </a:lnTo>
                  <a:lnTo>
                    <a:pt x="184531" y="560451"/>
                  </a:lnTo>
                  <a:close/>
                </a:path>
                <a:path w="4076700" h="778509">
                  <a:moveTo>
                    <a:pt x="242570" y="653796"/>
                  </a:moveTo>
                  <a:lnTo>
                    <a:pt x="232156" y="653796"/>
                  </a:lnTo>
                  <a:lnTo>
                    <a:pt x="232156" y="778383"/>
                  </a:lnTo>
                  <a:lnTo>
                    <a:pt x="242570" y="778383"/>
                  </a:lnTo>
                  <a:lnTo>
                    <a:pt x="242570" y="653796"/>
                  </a:lnTo>
                  <a:close/>
                </a:path>
                <a:path w="4076700" h="778509">
                  <a:moveTo>
                    <a:pt x="300609" y="404749"/>
                  </a:moveTo>
                  <a:lnTo>
                    <a:pt x="290195" y="404749"/>
                  </a:lnTo>
                  <a:lnTo>
                    <a:pt x="290195" y="778383"/>
                  </a:lnTo>
                  <a:lnTo>
                    <a:pt x="300609" y="778383"/>
                  </a:lnTo>
                  <a:lnTo>
                    <a:pt x="300609" y="404749"/>
                  </a:lnTo>
                  <a:close/>
                </a:path>
                <a:path w="4076700" h="778509">
                  <a:moveTo>
                    <a:pt x="361315" y="498221"/>
                  </a:moveTo>
                  <a:lnTo>
                    <a:pt x="348234" y="498221"/>
                  </a:lnTo>
                  <a:lnTo>
                    <a:pt x="348234" y="778383"/>
                  </a:lnTo>
                  <a:lnTo>
                    <a:pt x="361315" y="778383"/>
                  </a:lnTo>
                  <a:lnTo>
                    <a:pt x="361315" y="498221"/>
                  </a:lnTo>
                  <a:close/>
                </a:path>
                <a:path w="4076700" h="778509">
                  <a:moveTo>
                    <a:pt x="416687" y="560451"/>
                  </a:moveTo>
                  <a:lnTo>
                    <a:pt x="406273" y="560451"/>
                  </a:lnTo>
                  <a:lnTo>
                    <a:pt x="406273" y="778383"/>
                  </a:lnTo>
                  <a:lnTo>
                    <a:pt x="416687" y="778383"/>
                  </a:lnTo>
                  <a:lnTo>
                    <a:pt x="416687" y="560451"/>
                  </a:lnTo>
                  <a:close/>
                </a:path>
                <a:path w="4076700" h="778509">
                  <a:moveTo>
                    <a:pt x="474726" y="373634"/>
                  </a:moveTo>
                  <a:lnTo>
                    <a:pt x="464312" y="373634"/>
                  </a:lnTo>
                  <a:lnTo>
                    <a:pt x="464312" y="778383"/>
                  </a:lnTo>
                  <a:lnTo>
                    <a:pt x="474726" y="778383"/>
                  </a:lnTo>
                  <a:lnTo>
                    <a:pt x="474726" y="373634"/>
                  </a:lnTo>
                  <a:close/>
                </a:path>
                <a:path w="4076700" h="778509">
                  <a:moveTo>
                    <a:pt x="532892" y="498221"/>
                  </a:moveTo>
                  <a:lnTo>
                    <a:pt x="522478" y="498221"/>
                  </a:lnTo>
                  <a:lnTo>
                    <a:pt x="522478" y="778383"/>
                  </a:lnTo>
                  <a:lnTo>
                    <a:pt x="532892" y="778383"/>
                  </a:lnTo>
                  <a:lnTo>
                    <a:pt x="532892" y="498221"/>
                  </a:lnTo>
                  <a:close/>
                </a:path>
                <a:path w="4076700" h="778509">
                  <a:moveTo>
                    <a:pt x="590931" y="311404"/>
                  </a:moveTo>
                  <a:lnTo>
                    <a:pt x="580517" y="311404"/>
                  </a:lnTo>
                  <a:lnTo>
                    <a:pt x="580517" y="778383"/>
                  </a:lnTo>
                  <a:lnTo>
                    <a:pt x="590931" y="778383"/>
                  </a:lnTo>
                  <a:lnTo>
                    <a:pt x="590931" y="311404"/>
                  </a:lnTo>
                  <a:close/>
                </a:path>
                <a:path w="4076700" h="778509">
                  <a:moveTo>
                    <a:pt x="648970" y="498221"/>
                  </a:moveTo>
                  <a:lnTo>
                    <a:pt x="638556" y="498221"/>
                  </a:lnTo>
                  <a:lnTo>
                    <a:pt x="638556" y="778383"/>
                  </a:lnTo>
                  <a:lnTo>
                    <a:pt x="648970" y="778383"/>
                  </a:lnTo>
                  <a:lnTo>
                    <a:pt x="648970" y="498221"/>
                  </a:lnTo>
                  <a:close/>
                </a:path>
                <a:path w="4076700" h="778509">
                  <a:moveTo>
                    <a:pt x="707009" y="466979"/>
                  </a:moveTo>
                  <a:lnTo>
                    <a:pt x="696595" y="466979"/>
                  </a:lnTo>
                  <a:lnTo>
                    <a:pt x="696595" y="778383"/>
                  </a:lnTo>
                  <a:lnTo>
                    <a:pt x="707009" y="778383"/>
                  </a:lnTo>
                  <a:lnTo>
                    <a:pt x="707009" y="466979"/>
                  </a:lnTo>
                  <a:close/>
                </a:path>
                <a:path w="4076700" h="778509">
                  <a:moveTo>
                    <a:pt x="765048" y="560451"/>
                  </a:moveTo>
                  <a:lnTo>
                    <a:pt x="754634" y="560451"/>
                  </a:lnTo>
                  <a:lnTo>
                    <a:pt x="754634" y="778383"/>
                  </a:lnTo>
                  <a:lnTo>
                    <a:pt x="765048" y="778383"/>
                  </a:lnTo>
                  <a:lnTo>
                    <a:pt x="765048" y="560451"/>
                  </a:lnTo>
                  <a:close/>
                </a:path>
                <a:path w="4076700" h="778509">
                  <a:moveTo>
                    <a:pt x="825754" y="404749"/>
                  </a:moveTo>
                  <a:lnTo>
                    <a:pt x="812673" y="404749"/>
                  </a:lnTo>
                  <a:lnTo>
                    <a:pt x="812673" y="778383"/>
                  </a:lnTo>
                  <a:lnTo>
                    <a:pt x="825754" y="778383"/>
                  </a:lnTo>
                  <a:lnTo>
                    <a:pt x="825754" y="404749"/>
                  </a:lnTo>
                  <a:close/>
                </a:path>
                <a:path w="4076700" h="778509">
                  <a:moveTo>
                    <a:pt x="881126" y="0"/>
                  </a:moveTo>
                  <a:lnTo>
                    <a:pt x="870712" y="0"/>
                  </a:lnTo>
                  <a:lnTo>
                    <a:pt x="870712" y="778383"/>
                  </a:lnTo>
                  <a:lnTo>
                    <a:pt x="881126" y="778383"/>
                  </a:lnTo>
                  <a:lnTo>
                    <a:pt x="881126" y="0"/>
                  </a:lnTo>
                  <a:close/>
                </a:path>
                <a:path w="4076700" h="778509">
                  <a:moveTo>
                    <a:pt x="939165" y="249047"/>
                  </a:moveTo>
                  <a:lnTo>
                    <a:pt x="928751" y="249047"/>
                  </a:lnTo>
                  <a:lnTo>
                    <a:pt x="928751" y="778383"/>
                  </a:lnTo>
                  <a:lnTo>
                    <a:pt x="939165" y="778383"/>
                  </a:lnTo>
                  <a:lnTo>
                    <a:pt x="939165" y="249047"/>
                  </a:lnTo>
                  <a:close/>
                </a:path>
                <a:path w="4076700" h="778509">
                  <a:moveTo>
                    <a:pt x="997204" y="404749"/>
                  </a:moveTo>
                  <a:lnTo>
                    <a:pt x="986790" y="404749"/>
                  </a:lnTo>
                  <a:lnTo>
                    <a:pt x="986790" y="778383"/>
                  </a:lnTo>
                  <a:lnTo>
                    <a:pt x="997204" y="778383"/>
                  </a:lnTo>
                  <a:lnTo>
                    <a:pt x="997204" y="404749"/>
                  </a:lnTo>
                  <a:close/>
                </a:path>
                <a:path w="4076700" h="778509">
                  <a:moveTo>
                    <a:pt x="1055370" y="373634"/>
                  </a:moveTo>
                  <a:lnTo>
                    <a:pt x="1044956" y="373634"/>
                  </a:lnTo>
                  <a:lnTo>
                    <a:pt x="1044956" y="778383"/>
                  </a:lnTo>
                  <a:lnTo>
                    <a:pt x="1055370" y="778383"/>
                  </a:lnTo>
                  <a:lnTo>
                    <a:pt x="1055370" y="373634"/>
                  </a:lnTo>
                  <a:close/>
                </a:path>
                <a:path w="4076700" h="778509">
                  <a:moveTo>
                    <a:pt x="1113409" y="404749"/>
                  </a:moveTo>
                  <a:lnTo>
                    <a:pt x="1102995" y="404749"/>
                  </a:lnTo>
                  <a:lnTo>
                    <a:pt x="1102995" y="778383"/>
                  </a:lnTo>
                  <a:lnTo>
                    <a:pt x="1113409" y="778383"/>
                  </a:lnTo>
                  <a:lnTo>
                    <a:pt x="1113409" y="404749"/>
                  </a:lnTo>
                  <a:close/>
                </a:path>
                <a:path w="4076700" h="778509">
                  <a:moveTo>
                    <a:pt x="1171448" y="404749"/>
                  </a:moveTo>
                  <a:lnTo>
                    <a:pt x="1161034" y="404749"/>
                  </a:lnTo>
                  <a:lnTo>
                    <a:pt x="1161034" y="778383"/>
                  </a:lnTo>
                  <a:lnTo>
                    <a:pt x="1171448" y="778383"/>
                  </a:lnTo>
                  <a:lnTo>
                    <a:pt x="1171448" y="404749"/>
                  </a:lnTo>
                  <a:close/>
                </a:path>
                <a:path w="4076700" h="778509">
                  <a:moveTo>
                    <a:pt x="1229487" y="342519"/>
                  </a:moveTo>
                  <a:lnTo>
                    <a:pt x="1219073" y="342519"/>
                  </a:lnTo>
                  <a:lnTo>
                    <a:pt x="1219073" y="778383"/>
                  </a:lnTo>
                  <a:lnTo>
                    <a:pt x="1229487" y="778383"/>
                  </a:lnTo>
                  <a:lnTo>
                    <a:pt x="1229487" y="342519"/>
                  </a:lnTo>
                  <a:close/>
                </a:path>
                <a:path w="4076700" h="778509">
                  <a:moveTo>
                    <a:pt x="1287526" y="342519"/>
                  </a:moveTo>
                  <a:lnTo>
                    <a:pt x="1277112" y="342519"/>
                  </a:lnTo>
                  <a:lnTo>
                    <a:pt x="1277112" y="778383"/>
                  </a:lnTo>
                  <a:lnTo>
                    <a:pt x="1287526" y="778383"/>
                  </a:lnTo>
                  <a:lnTo>
                    <a:pt x="1287526" y="342519"/>
                  </a:lnTo>
                  <a:close/>
                </a:path>
                <a:path w="4076700" h="778509">
                  <a:moveTo>
                    <a:pt x="1345565" y="280289"/>
                  </a:moveTo>
                  <a:lnTo>
                    <a:pt x="1335151" y="280289"/>
                  </a:lnTo>
                  <a:lnTo>
                    <a:pt x="1335151" y="778383"/>
                  </a:lnTo>
                  <a:lnTo>
                    <a:pt x="1345565" y="778383"/>
                  </a:lnTo>
                  <a:lnTo>
                    <a:pt x="1345565" y="280289"/>
                  </a:lnTo>
                  <a:close/>
                </a:path>
                <a:path w="4076700" h="778509">
                  <a:moveTo>
                    <a:pt x="1406271" y="373634"/>
                  </a:moveTo>
                  <a:lnTo>
                    <a:pt x="1393190" y="373634"/>
                  </a:lnTo>
                  <a:lnTo>
                    <a:pt x="1393190" y="778383"/>
                  </a:lnTo>
                  <a:lnTo>
                    <a:pt x="1406271" y="778383"/>
                  </a:lnTo>
                  <a:lnTo>
                    <a:pt x="1406271" y="373634"/>
                  </a:lnTo>
                  <a:close/>
                </a:path>
                <a:path w="4076700" h="778509">
                  <a:moveTo>
                    <a:pt x="1461643" y="591566"/>
                  </a:moveTo>
                  <a:lnTo>
                    <a:pt x="1451229" y="591566"/>
                  </a:lnTo>
                  <a:lnTo>
                    <a:pt x="1451229" y="778383"/>
                  </a:lnTo>
                  <a:lnTo>
                    <a:pt x="1461643" y="778383"/>
                  </a:lnTo>
                  <a:lnTo>
                    <a:pt x="1461643" y="591566"/>
                  </a:lnTo>
                  <a:close/>
                </a:path>
                <a:path w="4076700" h="778509">
                  <a:moveTo>
                    <a:pt x="1519682" y="498221"/>
                  </a:moveTo>
                  <a:lnTo>
                    <a:pt x="1509268" y="498221"/>
                  </a:lnTo>
                  <a:lnTo>
                    <a:pt x="1509268" y="778383"/>
                  </a:lnTo>
                  <a:lnTo>
                    <a:pt x="1519682" y="778383"/>
                  </a:lnTo>
                  <a:lnTo>
                    <a:pt x="1519682" y="498221"/>
                  </a:lnTo>
                  <a:close/>
                </a:path>
                <a:path w="4076700" h="778509">
                  <a:moveTo>
                    <a:pt x="1577848" y="373634"/>
                  </a:moveTo>
                  <a:lnTo>
                    <a:pt x="1567434" y="373634"/>
                  </a:lnTo>
                  <a:lnTo>
                    <a:pt x="1567434" y="778383"/>
                  </a:lnTo>
                  <a:lnTo>
                    <a:pt x="1577848" y="778383"/>
                  </a:lnTo>
                  <a:lnTo>
                    <a:pt x="1577848" y="373634"/>
                  </a:lnTo>
                  <a:close/>
                </a:path>
                <a:path w="4076700" h="778509">
                  <a:moveTo>
                    <a:pt x="1635887" y="560451"/>
                  </a:moveTo>
                  <a:lnTo>
                    <a:pt x="1625473" y="560451"/>
                  </a:lnTo>
                  <a:lnTo>
                    <a:pt x="1625473" y="778383"/>
                  </a:lnTo>
                  <a:lnTo>
                    <a:pt x="1635887" y="778383"/>
                  </a:lnTo>
                  <a:lnTo>
                    <a:pt x="1635887" y="560451"/>
                  </a:lnTo>
                  <a:close/>
                </a:path>
                <a:path w="4076700" h="778509">
                  <a:moveTo>
                    <a:pt x="1693926" y="529336"/>
                  </a:moveTo>
                  <a:lnTo>
                    <a:pt x="1683512" y="529336"/>
                  </a:lnTo>
                  <a:lnTo>
                    <a:pt x="1683512" y="778383"/>
                  </a:lnTo>
                  <a:lnTo>
                    <a:pt x="1693926" y="778383"/>
                  </a:lnTo>
                  <a:lnTo>
                    <a:pt x="1693926" y="529336"/>
                  </a:lnTo>
                  <a:close/>
                </a:path>
                <a:path w="4076700" h="778509">
                  <a:moveTo>
                    <a:pt x="1751965" y="529336"/>
                  </a:moveTo>
                  <a:lnTo>
                    <a:pt x="1741551" y="529336"/>
                  </a:lnTo>
                  <a:lnTo>
                    <a:pt x="1741551" y="778383"/>
                  </a:lnTo>
                  <a:lnTo>
                    <a:pt x="1751965" y="778383"/>
                  </a:lnTo>
                  <a:lnTo>
                    <a:pt x="1751965" y="529336"/>
                  </a:lnTo>
                  <a:close/>
                </a:path>
                <a:path w="4076700" h="778509">
                  <a:moveTo>
                    <a:pt x="1810004" y="404749"/>
                  </a:moveTo>
                  <a:lnTo>
                    <a:pt x="1799590" y="404749"/>
                  </a:lnTo>
                  <a:lnTo>
                    <a:pt x="1799590" y="778383"/>
                  </a:lnTo>
                  <a:lnTo>
                    <a:pt x="1810004" y="778383"/>
                  </a:lnTo>
                  <a:lnTo>
                    <a:pt x="1810004" y="404749"/>
                  </a:lnTo>
                  <a:close/>
                </a:path>
                <a:path w="4076700" h="778509">
                  <a:moveTo>
                    <a:pt x="1868043" y="529336"/>
                  </a:moveTo>
                  <a:lnTo>
                    <a:pt x="1857629" y="529336"/>
                  </a:lnTo>
                  <a:lnTo>
                    <a:pt x="1857629" y="778383"/>
                  </a:lnTo>
                  <a:lnTo>
                    <a:pt x="1868043" y="778383"/>
                  </a:lnTo>
                  <a:lnTo>
                    <a:pt x="1868043" y="529336"/>
                  </a:lnTo>
                  <a:close/>
                </a:path>
                <a:path w="4076700" h="778509">
                  <a:moveTo>
                    <a:pt x="1926082" y="435864"/>
                  </a:moveTo>
                  <a:lnTo>
                    <a:pt x="1915668" y="435864"/>
                  </a:lnTo>
                  <a:lnTo>
                    <a:pt x="1915668" y="778383"/>
                  </a:lnTo>
                  <a:lnTo>
                    <a:pt x="1926082" y="778383"/>
                  </a:lnTo>
                  <a:lnTo>
                    <a:pt x="1926082" y="435864"/>
                  </a:lnTo>
                  <a:close/>
                </a:path>
                <a:path w="4076700" h="778509">
                  <a:moveTo>
                    <a:pt x="1986788" y="529336"/>
                  </a:moveTo>
                  <a:lnTo>
                    <a:pt x="1973707" y="529336"/>
                  </a:lnTo>
                  <a:lnTo>
                    <a:pt x="1973707" y="778383"/>
                  </a:lnTo>
                  <a:lnTo>
                    <a:pt x="1986788" y="778383"/>
                  </a:lnTo>
                  <a:lnTo>
                    <a:pt x="1986788" y="529336"/>
                  </a:lnTo>
                  <a:close/>
                </a:path>
                <a:path w="4076700" h="778509">
                  <a:moveTo>
                    <a:pt x="2042160" y="404749"/>
                  </a:moveTo>
                  <a:lnTo>
                    <a:pt x="2031746" y="404749"/>
                  </a:lnTo>
                  <a:lnTo>
                    <a:pt x="2031746" y="778383"/>
                  </a:lnTo>
                  <a:lnTo>
                    <a:pt x="2042160" y="778383"/>
                  </a:lnTo>
                  <a:lnTo>
                    <a:pt x="2042160" y="404749"/>
                  </a:lnTo>
                  <a:close/>
                </a:path>
                <a:path w="4076700" h="778509">
                  <a:moveTo>
                    <a:pt x="2100199" y="560451"/>
                  </a:moveTo>
                  <a:lnTo>
                    <a:pt x="2089785" y="560451"/>
                  </a:lnTo>
                  <a:lnTo>
                    <a:pt x="2089785" y="778383"/>
                  </a:lnTo>
                  <a:lnTo>
                    <a:pt x="2100199" y="778383"/>
                  </a:lnTo>
                  <a:lnTo>
                    <a:pt x="2100199" y="560451"/>
                  </a:lnTo>
                  <a:close/>
                </a:path>
                <a:path w="4076700" h="778509">
                  <a:moveTo>
                    <a:pt x="2161032" y="622681"/>
                  </a:moveTo>
                  <a:lnTo>
                    <a:pt x="2147951" y="622681"/>
                  </a:lnTo>
                  <a:lnTo>
                    <a:pt x="2147951" y="778383"/>
                  </a:lnTo>
                  <a:lnTo>
                    <a:pt x="2161032" y="778383"/>
                  </a:lnTo>
                  <a:lnTo>
                    <a:pt x="2161032" y="622681"/>
                  </a:lnTo>
                  <a:close/>
                </a:path>
                <a:path w="4076700" h="778509">
                  <a:moveTo>
                    <a:pt x="2216404" y="560451"/>
                  </a:moveTo>
                  <a:lnTo>
                    <a:pt x="2205990" y="560451"/>
                  </a:lnTo>
                  <a:lnTo>
                    <a:pt x="2205990" y="778383"/>
                  </a:lnTo>
                  <a:lnTo>
                    <a:pt x="2216404" y="778383"/>
                  </a:lnTo>
                  <a:lnTo>
                    <a:pt x="2216404" y="560451"/>
                  </a:lnTo>
                  <a:close/>
                </a:path>
                <a:path w="4076700" h="778509">
                  <a:moveTo>
                    <a:pt x="2274443" y="653796"/>
                  </a:moveTo>
                  <a:lnTo>
                    <a:pt x="2264029" y="653796"/>
                  </a:lnTo>
                  <a:lnTo>
                    <a:pt x="2264029" y="778383"/>
                  </a:lnTo>
                  <a:lnTo>
                    <a:pt x="2274443" y="778383"/>
                  </a:lnTo>
                  <a:lnTo>
                    <a:pt x="2274443" y="653796"/>
                  </a:lnTo>
                  <a:close/>
                </a:path>
                <a:path w="4076700" h="778509">
                  <a:moveTo>
                    <a:pt x="2332482" y="560451"/>
                  </a:moveTo>
                  <a:lnTo>
                    <a:pt x="2322068" y="560451"/>
                  </a:lnTo>
                  <a:lnTo>
                    <a:pt x="2322068" y="778383"/>
                  </a:lnTo>
                  <a:lnTo>
                    <a:pt x="2332482" y="778383"/>
                  </a:lnTo>
                  <a:lnTo>
                    <a:pt x="2332482" y="560451"/>
                  </a:lnTo>
                  <a:close/>
                </a:path>
                <a:path w="4076700" h="778509">
                  <a:moveTo>
                    <a:pt x="2393188" y="498221"/>
                  </a:moveTo>
                  <a:lnTo>
                    <a:pt x="2380107" y="498221"/>
                  </a:lnTo>
                  <a:lnTo>
                    <a:pt x="2380107" y="778383"/>
                  </a:lnTo>
                  <a:lnTo>
                    <a:pt x="2393188" y="778383"/>
                  </a:lnTo>
                  <a:lnTo>
                    <a:pt x="2393188" y="498221"/>
                  </a:lnTo>
                  <a:close/>
                </a:path>
                <a:path w="4076700" h="778509">
                  <a:moveTo>
                    <a:pt x="2448560" y="466979"/>
                  </a:moveTo>
                  <a:lnTo>
                    <a:pt x="2438146" y="466979"/>
                  </a:lnTo>
                  <a:lnTo>
                    <a:pt x="2438146" y="778383"/>
                  </a:lnTo>
                  <a:lnTo>
                    <a:pt x="2448560" y="778383"/>
                  </a:lnTo>
                  <a:lnTo>
                    <a:pt x="2448560" y="466979"/>
                  </a:lnTo>
                  <a:close/>
                </a:path>
                <a:path w="4076700" h="778509">
                  <a:moveTo>
                    <a:pt x="2506599" y="529336"/>
                  </a:moveTo>
                  <a:lnTo>
                    <a:pt x="2496185" y="529336"/>
                  </a:lnTo>
                  <a:lnTo>
                    <a:pt x="2496185" y="778383"/>
                  </a:lnTo>
                  <a:lnTo>
                    <a:pt x="2506599" y="778383"/>
                  </a:lnTo>
                  <a:lnTo>
                    <a:pt x="2506599" y="529336"/>
                  </a:lnTo>
                  <a:close/>
                </a:path>
                <a:path w="4076700" h="778509">
                  <a:moveTo>
                    <a:pt x="2564638" y="529336"/>
                  </a:moveTo>
                  <a:lnTo>
                    <a:pt x="2554224" y="529336"/>
                  </a:lnTo>
                  <a:lnTo>
                    <a:pt x="2554224" y="778383"/>
                  </a:lnTo>
                  <a:lnTo>
                    <a:pt x="2564638" y="778383"/>
                  </a:lnTo>
                  <a:lnTo>
                    <a:pt x="2564638" y="529336"/>
                  </a:lnTo>
                  <a:close/>
                </a:path>
                <a:path w="4076700" h="778509">
                  <a:moveTo>
                    <a:pt x="2622677" y="560451"/>
                  </a:moveTo>
                  <a:lnTo>
                    <a:pt x="2612263" y="560451"/>
                  </a:lnTo>
                  <a:lnTo>
                    <a:pt x="2612263" y="778383"/>
                  </a:lnTo>
                  <a:lnTo>
                    <a:pt x="2622677" y="778383"/>
                  </a:lnTo>
                  <a:lnTo>
                    <a:pt x="2622677" y="560451"/>
                  </a:lnTo>
                  <a:close/>
                </a:path>
                <a:path w="4076700" h="778509">
                  <a:moveTo>
                    <a:pt x="2680843" y="622681"/>
                  </a:moveTo>
                  <a:lnTo>
                    <a:pt x="2670429" y="622681"/>
                  </a:lnTo>
                  <a:lnTo>
                    <a:pt x="2670429" y="778383"/>
                  </a:lnTo>
                  <a:lnTo>
                    <a:pt x="2680843" y="778383"/>
                  </a:lnTo>
                  <a:lnTo>
                    <a:pt x="2680843" y="622681"/>
                  </a:lnTo>
                  <a:close/>
                </a:path>
                <a:path w="4076700" h="778509">
                  <a:moveTo>
                    <a:pt x="2738882" y="529336"/>
                  </a:moveTo>
                  <a:lnTo>
                    <a:pt x="2728468" y="529336"/>
                  </a:lnTo>
                  <a:lnTo>
                    <a:pt x="2728468" y="778383"/>
                  </a:lnTo>
                  <a:lnTo>
                    <a:pt x="2738882" y="778383"/>
                  </a:lnTo>
                  <a:lnTo>
                    <a:pt x="2738882" y="529336"/>
                  </a:lnTo>
                  <a:close/>
                </a:path>
                <a:path w="4076700" h="778509">
                  <a:moveTo>
                    <a:pt x="2796921" y="622681"/>
                  </a:moveTo>
                  <a:lnTo>
                    <a:pt x="2786507" y="622681"/>
                  </a:lnTo>
                  <a:lnTo>
                    <a:pt x="2786507" y="778383"/>
                  </a:lnTo>
                  <a:lnTo>
                    <a:pt x="2796921" y="778383"/>
                  </a:lnTo>
                  <a:lnTo>
                    <a:pt x="2796921" y="622681"/>
                  </a:lnTo>
                  <a:close/>
                </a:path>
                <a:path w="4076700" h="778509">
                  <a:moveTo>
                    <a:pt x="2857614" y="653796"/>
                  </a:moveTo>
                  <a:lnTo>
                    <a:pt x="2844546" y="653796"/>
                  </a:lnTo>
                  <a:lnTo>
                    <a:pt x="2844546" y="778383"/>
                  </a:lnTo>
                  <a:lnTo>
                    <a:pt x="2857614" y="778383"/>
                  </a:lnTo>
                  <a:lnTo>
                    <a:pt x="2857614" y="653796"/>
                  </a:lnTo>
                  <a:close/>
                </a:path>
                <a:path w="4076700" h="778509">
                  <a:moveTo>
                    <a:pt x="2915666" y="560451"/>
                  </a:moveTo>
                  <a:lnTo>
                    <a:pt x="2902585" y="560451"/>
                  </a:lnTo>
                  <a:lnTo>
                    <a:pt x="2902585" y="778383"/>
                  </a:lnTo>
                  <a:lnTo>
                    <a:pt x="2915666" y="778383"/>
                  </a:lnTo>
                  <a:lnTo>
                    <a:pt x="2915666" y="560451"/>
                  </a:lnTo>
                  <a:close/>
                </a:path>
                <a:path w="4076700" h="778509">
                  <a:moveTo>
                    <a:pt x="2971038" y="373634"/>
                  </a:moveTo>
                  <a:lnTo>
                    <a:pt x="2960624" y="373634"/>
                  </a:lnTo>
                  <a:lnTo>
                    <a:pt x="2960624" y="778383"/>
                  </a:lnTo>
                  <a:lnTo>
                    <a:pt x="2971038" y="778383"/>
                  </a:lnTo>
                  <a:lnTo>
                    <a:pt x="2971038" y="373634"/>
                  </a:lnTo>
                  <a:close/>
                </a:path>
                <a:path w="4076700" h="778509">
                  <a:moveTo>
                    <a:pt x="3029077" y="591566"/>
                  </a:moveTo>
                  <a:lnTo>
                    <a:pt x="3018663" y="591566"/>
                  </a:lnTo>
                  <a:lnTo>
                    <a:pt x="3018663" y="778383"/>
                  </a:lnTo>
                  <a:lnTo>
                    <a:pt x="3029077" y="778383"/>
                  </a:lnTo>
                  <a:lnTo>
                    <a:pt x="3029077" y="591566"/>
                  </a:lnTo>
                  <a:close/>
                </a:path>
                <a:path w="4076700" h="778509">
                  <a:moveTo>
                    <a:pt x="3087116" y="529336"/>
                  </a:moveTo>
                  <a:lnTo>
                    <a:pt x="3076702" y="529336"/>
                  </a:lnTo>
                  <a:lnTo>
                    <a:pt x="3076702" y="778383"/>
                  </a:lnTo>
                  <a:lnTo>
                    <a:pt x="3087116" y="778383"/>
                  </a:lnTo>
                  <a:lnTo>
                    <a:pt x="3087116" y="529336"/>
                  </a:lnTo>
                  <a:close/>
                </a:path>
                <a:path w="4076700" h="778509">
                  <a:moveTo>
                    <a:pt x="3145155" y="591566"/>
                  </a:moveTo>
                  <a:lnTo>
                    <a:pt x="3134741" y="591566"/>
                  </a:lnTo>
                  <a:lnTo>
                    <a:pt x="3134741" y="778383"/>
                  </a:lnTo>
                  <a:lnTo>
                    <a:pt x="3145155" y="778383"/>
                  </a:lnTo>
                  <a:lnTo>
                    <a:pt x="3145155" y="591566"/>
                  </a:lnTo>
                  <a:close/>
                </a:path>
                <a:path w="4076700" h="778509">
                  <a:moveTo>
                    <a:pt x="3203194" y="716153"/>
                  </a:moveTo>
                  <a:lnTo>
                    <a:pt x="3192780" y="716153"/>
                  </a:lnTo>
                  <a:lnTo>
                    <a:pt x="3192780" y="778383"/>
                  </a:lnTo>
                  <a:lnTo>
                    <a:pt x="3203194" y="778383"/>
                  </a:lnTo>
                  <a:lnTo>
                    <a:pt x="3203194" y="716153"/>
                  </a:lnTo>
                  <a:close/>
                </a:path>
                <a:path w="4076700" h="778509">
                  <a:moveTo>
                    <a:pt x="3261360" y="653796"/>
                  </a:moveTo>
                  <a:lnTo>
                    <a:pt x="3250946" y="653796"/>
                  </a:lnTo>
                  <a:lnTo>
                    <a:pt x="3250946" y="778383"/>
                  </a:lnTo>
                  <a:lnTo>
                    <a:pt x="3261360" y="778383"/>
                  </a:lnTo>
                  <a:lnTo>
                    <a:pt x="3261360" y="653796"/>
                  </a:lnTo>
                  <a:close/>
                </a:path>
                <a:path w="4076700" h="778509">
                  <a:moveTo>
                    <a:pt x="3319399" y="560451"/>
                  </a:moveTo>
                  <a:lnTo>
                    <a:pt x="3308985" y="560451"/>
                  </a:lnTo>
                  <a:lnTo>
                    <a:pt x="3308985" y="778383"/>
                  </a:lnTo>
                  <a:lnTo>
                    <a:pt x="3319399" y="778383"/>
                  </a:lnTo>
                  <a:lnTo>
                    <a:pt x="3319399" y="560451"/>
                  </a:lnTo>
                  <a:close/>
                </a:path>
                <a:path w="4076700" h="778509">
                  <a:moveTo>
                    <a:pt x="3380105" y="529336"/>
                  </a:moveTo>
                  <a:lnTo>
                    <a:pt x="3367024" y="529336"/>
                  </a:lnTo>
                  <a:lnTo>
                    <a:pt x="3367024" y="778383"/>
                  </a:lnTo>
                  <a:lnTo>
                    <a:pt x="3380105" y="778383"/>
                  </a:lnTo>
                  <a:lnTo>
                    <a:pt x="3380105" y="529336"/>
                  </a:lnTo>
                  <a:close/>
                </a:path>
                <a:path w="4076700" h="778509">
                  <a:moveTo>
                    <a:pt x="3435464" y="560451"/>
                  </a:moveTo>
                  <a:lnTo>
                    <a:pt x="3425063" y="560451"/>
                  </a:lnTo>
                  <a:lnTo>
                    <a:pt x="3425063" y="778383"/>
                  </a:lnTo>
                  <a:lnTo>
                    <a:pt x="3435464" y="778383"/>
                  </a:lnTo>
                  <a:lnTo>
                    <a:pt x="3435464" y="560451"/>
                  </a:lnTo>
                  <a:close/>
                </a:path>
                <a:path w="4076700" h="778509">
                  <a:moveTo>
                    <a:pt x="3496170" y="498221"/>
                  </a:moveTo>
                  <a:lnTo>
                    <a:pt x="3483089" y="498221"/>
                  </a:lnTo>
                  <a:lnTo>
                    <a:pt x="3483089" y="778383"/>
                  </a:lnTo>
                  <a:lnTo>
                    <a:pt x="3496170" y="778383"/>
                  </a:lnTo>
                  <a:lnTo>
                    <a:pt x="3496170" y="498221"/>
                  </a:lnTo>
                  <a:close/>
                </a:path>
                <a:path w="4076700" h="778509">
                  <a:moveTo>
                    <a:pt x="3558540" y="560451"/>
                  </a:moveTo>
                  <a:lnTo>
                    <a:pt x="3541141" y="560451"/>
                  </a:lnTo>
                  <a:lnTo>
                    <a:pt x="3541141" y="778383"/>
                  </a:lnTo>
                  <a:lnTo>
                    <a:pt x="3558540" y="778383"/>
                  </a:lnTo>
                  <a:lnTo>
                    <a:pt x="3558540" y="560451"/>
                  </a:lnTo>
                  <a:close/>
                </a:path>
                <a:path w="4076700" h="778509">
                  <a:moveTo>
                    <a:pt x="3612261" y="435864"/>
                  </a:moveTo>
                  <a:lnTo>
                    <a:pt x="3599180" y="435864"/>
                  </a:lnTo>
                  <a:lnTo>
                    <a:pt x="3599180" y="778383"/>
                  </a:lnTo>
                  <a:lnTo>
                    <a:pt x="3612261" y="778383"/>
                  </a:lnTo>
                  <a:lnTo>
                    <a:pt x="3612261" y="435864"/>
                  </a:lnTo>
                  <a:close/>
                </a:path>
                <a:path w="4076700" h="778509">
                  <a:moveTo>
                    <a:pt x="3667633" y="529336"/>
                  </a:moveTo>
                  <a:lnTo>
                    <a:pt x="3657219" y="529336"/>
                  </a:lnTo>
                  <a:lnTo>
                    <a:pt x="3657219" y="778383"/>
                  </a:lnTo>
                  <a:lnTo>
                    <a:pt x="3667633" y="778383"/>
                  </a:lnTo>
                  <a:lnTo>
                    <a:pt x="3667633" y="529336"/>
                  </a:lnTo>
                  <a:close/>
                </a:path>
                <a:path w="4076700" h="778509">
                  <a:moveTo>
                    <a:pt x="3725659" y="435864"/>
                  </a:moveTo>
                  <a:lnTo>
                    <a:pt x="3715258" y="435864"/>
                  </a:lnTo>
                  <a:lnTo>
                    <a:pt x="3715258" y="778383"/>
                  </a:lnTo>
                  <a:lnTo>
                    <a:pt x="3725659" y="778383"/>
                  </a:lnTo>
                  <a:lnTo>
                    <a:pt x="3725659" y="435864"/>
                  </a:lnTo>
                  <a:close/>
                </a:path>
                <a:path w="4076700" h="778509">
                  <a:moveTo>
                    <a:pt x="3786505" y="498221"/>
                  </a:moveTo>
                  <a:lnTo>
                    <a:pt x="3773424" y="498221"/>
                  </a:lnTo>
                  <a:lnTo>
                    <a:pt x="3773424" y="778383"/>
                  </a:lnTo>
                  <a:lnTo>
                    <a:pt x="3786505" y="778383"/>
                  </a:lnTo>
                  <a:lnTo>
                    <a:pt x="3786505" y="498221"/>
                  </a:lnTo>
                  <a:close/>
                </a:path>
                <a:path w="4076700" h="778509">
                  <a:moveTo>
                    <a:pt x="3844544" y="560451"/>
                  </a:moveTo>
                  <a:lnTo>
                    <a:pt x="3831463" y="560451"/>
                  </a:lnTo>
                  <a:lnTo>
                    <a:pt x="3831463" y="778383"/>
                  </a:lnTo>
                  <a:lnTo>
                    <a:pt x="3844544" y="778383"/>
                  </a:lnTo>
                  <a:lnTo>
                    <a:pt x="3844544" y="560451"/>
                  </a:lnTo>
                  <a:close/>
                </a:path>
                <a:path w="4076700" h="778509">
                  <a:moveTo>
                    <a:pt x="3902583" y="653796"/>
                  </a:moveTo>
                  <a:lnTo>
                    <a:pt x="3889502" y="653796"/>
                  </a:lnTo>
                  <a:lnTo>
                    <a:pt x="3889502" y="778383"/>
                  </a:lnTo>
                  <a:lnTo>
                    <a:pt x="3902583" y="778383"/>
                  </a:lnTo>
                  <a:lnTo>
                    <a:pt x="3902583" y="653796"/>
                  </a:lnTo>
                  <a:close/>
                </a:path>
                <a:path w="4076700" h="778509">
                  <a:moveTo>
                    <a:pt x="3960622" y="466979"/>
                  </a:moveTo>
                  <a:lnTo>
                    <a:pt x="3947541" y="466979"/>
                  </a:lnTo>
                  <a:lnTo>
                    <a:pt x="3947541" y="778383"/>
                  </a:lnTo>
                  <a:lnTo>
                    <a:pt x="3960622" y="778383"/>
                  </a:lnTo>
                  <a:lnTo>
                    <a:pt x="3960622" y="466979"/>
                  </a:lnTo>
                  <a:close/>
                </a:path>
                <a:path w="4076700" h="778509">
                  <a:moveTo>
                    <a:pt x="4018661" y="560451"/>
                  </a:moveTo>
                  <a:lnTo>
                    <a:pt x="4005580" y="560451"/>
                  </a:lnTo>
                  <a:lnTo>
                    <a:pt x="4005580" y="778383"/>
                  </a:lnTo>
                  <a:lnTo>
                    <a:pt x="4018661" y="778383"/>
                  </a:lnTo>
                  <a:lnTo>
                    <a:pt x="4018661" y="560451"/>
                  </a:lnTo>
                  <a:close/>
                </a:path>
                <a:path w="4076700" h="778509">
                  <a:moveTo>
                    <a:pt x="4076700" y="466979"/>
                  </a:moveTo>
                  <a:lnTo>
                    <a:pt x="4063619" y="466979"/>
                  </a:lnTo>
                  <a:lnTo>
                    <a:pt x="4063619" y="778383"/>
                  </a:lnTo>
                  <a:lnTo>
                    <a:pt x="4076700" y="778383"/>
                  </a:lnTo>
                  <a:lnTo>
                    <a:pt x="4076700" y="466979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5" name="object 105" descr=""/>
            <p:cNvSpPr/>
            <p:nvPr/>
          </p:nvSpPr>
          <p:spPr>
            <a:xfrm>
              <a:off x="13780135" y="8070850"/>
              <a:ext cx="1758950" cy="591820"/>
            </a:xfrm>
            <a:custGeom>
              <a:avLst/>
              <a:gdLst/>
              <a:ahLst/>
              <a:cxnLst/>
              <a:rect l="l" t="t" r="r" b="b"/>
              <a:pathLst>
                <a:path w="1758950" h="591820">
                  <a:moveTo>
                    <a:pt x="13081" y="280162"/>
                  </a:moveTo>
                  <a:lnTo>
                    <a:pt x="0" y="280162"/>
                  </a:lnTo>
                  <a:lnTo>
                    <a:pt x="0" y="591566"/>
                  </a:lnTo>
                  <a:lnTo>
                    <a:pt x="13081" y="591566"/>
                  </a:lnTo>
                  <a:lnTo>
                    <a:pt x="13081" y="280162"/>
                  </a:lnTo>
                  <a:close/>
                </a:path>
                <a:path w="1758950" h="591820">
                  <a:moveTo>
                    <a:pt x="68440" y="342519"/>
                  </a:moveTo>
                  <a:lnTo>
                    <a:pt x="58039" y="342519"/>
                  </a:lnTo>
                  <a:lnTo>
                    <a:pt x="58039" y="591566"/>
                  </a:lnTo>
                  <a:lnTo>
                    <a:pt x="68440" y="591566"/>
                  </a:lnTo>
                  <a:lnTo>
                    <a:pt x="68440" y="342519"/>
                  </a:lnTo>
                  <a:close/>
                </a:path>
                <a:path w="1758950" h="591820">
                  <a:moveTo>
                    <a:pt x="126492" y="373634"/>
                  </a:moveTo>
                  <a:lnTo>
                    <a:pt x="116078" y="373634"/>
                  </a:lnTo>
                  <a:lnTo>
                    <a:pt x="116078" y="591566"/>
                  </a:lnTo>
                  <a:lnTo>
                    <a:pt x="126492" y="591566"/>
                  </a:lnTo>
                  <a:lnTo>
                    <a:pt x="126492" y="373634"/>
                  </a:lnTo>
                  <a:close/>
                </a:path>
                <a:path w="1758950" h="591820">
                  <a:moveTo>
                    <a:pt x="184531" y="249047"/>
                  </a:moveTo>
                  <a:lnTo>
                    <a:pt x="174117" y="249047"/>
                  </a:lnTo>
                  <a:lnTo>
                    <a:pt x="174117" y="591566"/>
                  </a:lnTo>
                  <a:lnTo>
                    <a:pt x="184531" y="591566"/>
                  </a:lnTo>
                  <a:lnTo>
                    <a:pt x="184531" y="249047"/>
                  </a:lnTo>
                  <a:close/>
                </a:path>
                <a:path w="1758950" h="591820">
                  <a:moveTo>
                    <a:pt x="242684" y="342519"/>
                  </a:moveTo>
                  <a:lnTo>
                    <a:pt x="232283" y="342519"/>
                  </a:lnTo>
                  <a:lnTo>
                    <a:pt x="232283" y="591566"/>
                  </a:lnTo>
                  <a:lnTo>
                    <a:pt x="242684" y="591566"/>
                  </a:lnTo>
                  <a:lnTo>
                    <a:pt x="242684" y="342519"/>
                  </a:lnTo>
                  <a:close/>
                </a:path>
                <a:path w="1758950" h="591820">
                  <a:moveTo>
                    <a:pt x="300736" y="311404"/>
                  </a:moveTo>
                  <a:lnTo>
                    <a:pt x="290322" y="311404"/>
                  </a:lnTo>
                  <a:lnTo>
                    <a:pt x="290322" y="591566"/>
                  </a:lnTo>
                  <a:lnTo>
                    <a:pt x="300736" y="591566"/>
                  </a:lnTo>
                  <a:lnTo>
                    <a:pt x="300736" y="311404"/>
                  </a:lnTo>
                  <a:close/>
                </a:path>
                <a:path w="1758950" h="591820">
                  <a:moveTo>
                    <a:pt x="358775" y="249047"/>
                  </a:moveTo>
                  <a:lnTo>
                    <a:pt x="348361" y="249047"/>
                  </a:lnTo>
                  <a:lnTo>
                    <a:pt x="348361" y="591566"/>
                  </a:lnTo>
                  <a:lnTo>
                    <a:pt x="358775" y="591566"/>
                  </a:lnTo>
                  <a:lnTo>
                    <a:pt x="358775" y="249047"/>
                  </a:lnTo>
                  <a:close/>
                </a:path>
                <a:path w="1758950" h="591820">
                  <a:moveTo>
                    <a:pt x="416814" y="0"/>
                  </a:moveTo>
                  <a:lnTo>
                    <a:pt x="406400" y="0"/>
                  </a:lnTo>
                  <a:lnTo>
                    <a:pt x="406400" y="591566"/>
                  </a:lnTo>
                  <a:lnTo>
                    <a:pt x="416814" y="591566"/>
                  </a:lnTo>
                  <a:lnTo>
                    <a:pt x="416814" y="0"/>
                  </a:lnTo>
                  <a:close/>
                </a:path>
                <a:path w="1758950" h="591820">
                  <a:moveTo>
                    <a:pt x="474840" y="217932"/>
                  </a:moveTo>
                  <a:lnTo>
                    <a:pt x="464439" y="217932"/>
                  </a:lnTo>
                  <a:lnTo>
                    <a:pt x="464439" y="591566"/>
                  </a:lnTo>
                  <a:lnTo>
                    <a:pt x="474840" y="591566"/>
                  </a:lnTo>
                  <a:lnTo>
                    <a:pt x="474840" y="217932"/>
                  </a:lnTo>
                  <a:close/>
                </a:path>
                <a:path w="1758950" h="591820">
                  <a:moveTo>
                    <a:pt x="535559" y="435864"/>
                  </a:moveTo>
                  <a:lnTo>
                    <a:pt x="522478" y="435864"/>
                  </a:lnTo>
                  <a:lnTo>
                    <a:pt x="522478" y="591566"/>
                  </a:lnTo>
                  <a:lnTo>
                    <a:pt x="535559" y="591566"/>
                  </a:lnTo>
                  <a:lnTo>
                    <a:pt x="535559" y="435864"/>
                  </a:lnTo>
                  <a:close/>
                </a:path>
                <a:path w="1758950" h="591820">
                  <a:moveTo>
                    <a:pt x="597903" y="498221"/>
                  </a:moveTo>
                  <a:lnTo>
                    <a:pt x="580517" y="498221"/>
                  </a:lnTo>
                  <a:lnTo>
                    <a:pt x="580517" y="591566"/>
                  </a:lnTo>
                  <a:lnTo>
                    <a:pt x="597903" y="591566"/>
                  </a:lnTo>
                  <a:lnTo>
                    <a:pt x="597903" y="498221"/>
                  </a:lnTo>
                  <a:close/>
                </a:path>
                <a:path w="1758950" h="591820">
                  <a:moveTo>
                    <a:pt x="651637" y="404749"/>
                  </a:moveTo>
                  <a:lnTo>
                    <a:pt x="638556" y="404749"/>
                  </a:lnTo>
                  <a:lnTo>
                    <a:pt x="638556" y="591566"/>
                  </a:lnTo>
                  <a:lnTo>
                    <a:pt x="651637" y="591566"/>
                  </a:lnTo>
                  <a:lnTo>
                    <a:pt x="651637" y="404749"/>
                  </a:lnTo>
                  <a:close/>
                </a:path>
                <a:path w="1758950" h="591820">
                  <a:moveTo>
                    <a:pt x="707009" y="529336"/>
                  </a:moveTo>
                  <a:lnTo>
                    <a:pt x="696595" y="529336"/>
                  </a:lnTo>
                  <a:lnTo>
                    <a:pt x="696595" y="591566"/>
                  </a:lnTo>
                  <a:lnTo>
                    <a:pt x="707009" y="591566"/>
                  </a:lnTo>
                  <a:lnTo>
                    <a:pt x="707009" y="529336"/>
                  </a:lnTo>
                  <a:close/>
                </a:path>
                <a:path w="1758950" h="591820">
                  <a:moveTo>
                    <a:pt x="765048" y="311404"/>
                  </a:moveTo>
                  <a:lnTo>
                    <a:pt x="754634" y="311404"/>
                  </a:lnTo>
                  <a:lnTo>
                    <a:pt x="754634" y="591566"/>
                  </a:lnTo>
                  <a:lnTo>
                    <a:pt x="765048" y="591566"/>
                  </a:lnTo>
                  <a:lnTo>
                    <a:pt x="765048" y="311404"/>
                  </a:lnTo>
                  <a:close/>
                </a:path>
                <a:path w="1758950" h="591820">
                  <a:moveTo>
                    <a:pt x="830186" y="498221"/>
                  </a:moveTo>
                  <a:lnTo>
                    <a:pt x="812800" y="498221"/>
                  </a:lnTo>
                  <a:lnTo>
                    <a:pt x="812800" y="591566"/>
                  </a:lnTo>
                  <a:lnTo>
                    <a:pt x="830186" y="591566"/>
                  </a:lnTo>
                  <a:lnTo>
                    <a:pt x="830186" y="498221"/>
                  </a:lnTo>
                  <a:close/>
                </a:path>
                <a:path w="1758950" h="591820">
                  <a:moveTo>
                    <a:pt x="883907" y="435864"/>
                  </a:moveTo>
                  <a:lnTo>
                    <a:pt x="870839" y="435864"/>
                  </a:lnTo>
                  <a:lnTo>
                    <a:pt x="870839" y="591566"/>
                  </a:lnTo>
                  <a:lnTo>
                    <a:pt x="883907" y="591566"/>
                  </a:lnTo>
                  <a:lnTo>
                    <a:pt x="883907" y="435864"/>
                  </a:lnTo>
                  <a:close/>
                </a:path>
                <a:path w="1758950" h="591820">
                  <a:moveTo>
                    <a:pt x="939292" y="466979"/>
                  </a:moveTo>
                  <a:lnTo>
                    <a:pt x="928878" y="466979"/>
                  </a:lnTo>
                  <a:lnTo>
                    <a:pt x="928878" y="591566"/>
                  </a:lnTo>
                  <a:lnTo>
                    <a:pt x="939292" y="591566"/>
                  </a:lnTo>
                  <a:lnTo>
                    <a:pt x="939292" y="466979"/>
                  </a:lnTo>
                  <a:close/>
                </a:path>
                <a:path w="1758950" h="591820">
                  <a:moveTo>
                    <a:pt x="999998" y="435864"/>
                  </a:moveTo>
                  <a:lnTo>
                    <a:pt x="986917" y="435864"/>
                  </a:lnTo>
                  <a:lnTo>
                    <a:pt x="986917" y="591566"/>
                  </a:lnTo>
                  <a:lnTo>
                    <a:pt x="999998" y="591566"/>
                  </a:lnTo>
                  <a:lnTo>
                    <a:pt x="999998" y="435864"/>
                  </a:lnTo>
                  <a:close/>
                </a:path>
                <a:path w="1758950" h="591820">
                  <a:moveTo>
                    <a:pt x="1055357" y="342519"/>
                  </a:moveTo>
                  <a:lnTo>
                    <a:pt x="1044956" y="342519"/>
                  </a:lnTo>
                  <a:lnTo>
                    <a:pt x="1044956" y="591566"/>
                  </a:lnTo>
                  <a:lnTo>
                    <a:pt x="1055357" y="591566"/>
                  </a:lnTo>
                  <a:lnTo>
                    <a:pt x="1055357" y="342519"/>
                  </a:lnTo>
                  <a:close/>
                </a:path>
                <a:path w="1758950" h="591820">
                  <a:moveTo>
                    <a:pt x="1120394" y="498221"/>
                  </a:moveTo>
                  <a:lnTo>
                    <a:pt x="1102995" y="498221"/>
                  </a:lnTo>
                  <a:lnTo>
                    <a:pt x="1102995" y="591566"/>
                  </a:lnTo>
                  <a:lnTo>
                    <a:pt x="1120394" y="591566"/>
                  </a:lnTo>
                  <a:lnTo>
                    <a:pt x="1120394" y="498221"/>
                  </a:lnTo>
                  <a:close/>
                </a:path>
                <a:path w="1758950" h="591820">
                  <a:moveTo>
                    <a:pt x="1174115" y="498221"/>
                  </a:moveTo>
                  <a:lnTo>
                    <a:pt x="1161034" y="498221"/>
                  </a:lnTo>
                  <a:lnTo>
                    <a:pt x="1161034" y="591566"/>
                  </a:lnTo>
                  <a:lnTo>
                    <a:pt x="1174115" y="591566"/>
                  </a:lnTo>
                  <a:lnTo>
                    <a:pt x="1174115" y="498221"/>
                  </a:lnTo>
                  <a:close/>
                </a:path>
                <a:path w="1758950" h="591820">
                  <a:moveTo>
                    <a:pt x="1232154" y="529336"/>
                  </a:moveTo>
                  <a:lnTo>
                    <a:pt x="1219073" y="529336"/>
                  </a:lnTo>
                  <a:lnTo>
                    <a:pt x="1219073" y="591566"/>
                  </a:lnTo>
                  <a:lnTo>
                    <a:pt x="1232154" y="591566"/>
                  </a:lnTo>
                  <a:lnTo>
                    <a:pt x="1232154" y="529336"/>
                  </a:lnTo>
                  <a:close/>
                </a:path>
                <a:path w="1758950" h="591820">
                  <a:moveTo>
                    <a:pt x="1294498" y="311404"/>
                  </a:moveTo>
                  <a:lnTo>
                    <a:pt x="1277112" y="311404"/>
                  </a:lnTo>
                  <a:lnTo>
                    <a:pt x="1277112" y="591566"/>
                  </a:lnTo>
                  <a:lnTo>
                    <a:pt x="1294498" y="591566"/>
                  </a:lnTo>
                  <a:lnTo>
                    <a:pt x="1294498" y="311404"/>
                  </a:lnTo>
                  <a:close/>
                </a:path>
                <a:path w="1758950" h="591820">
                  <a:moveTo>
                    <a:pt x="1348359" y="404749"/>
                  </a:moveTo>
                  <a:lnTo>
                    <a:pt x="1335278" y="404749"/>
                  </a:lnTo>
                  <a:lnTo>
                    <a:pt x="1335278" y="591566"/>
                  </a:lnTo>
                  <a:lnTo>
                    <a:pt x="1348359" y="591566"/>
                  </a:lnTo>
                  <a:lnTo>
                    <a:pt x="1348359" y="404749"/>
                  </a:lnTo>
                  <a:close/>
                </a:path>
                <a:path w="1758950" h="591820">
                  <a:moveTo>
                    <a:pt x="1406398" y="404749"/>
                  </a:moveTo>
                  <a:lnTo>
                    <a:pt x="1393317" y="404749"/>
                  </a:lnTo>
                  <a:lnTo>
                    <a:pt x="1393317" y="591566"/>
                  </a:lnTo>
                  <a:lnTo>
                    <a:pt x="1406398" y="591566"/>
                  </a:lnTo>
                  <a:lnTo>
                    <a:pt x="1406398" y="404749"/>
                  </a:lnTo>
                  <a:close/>
                </a:path>
                <a:path w="1758950" h="591820">
                  <a:moveTo>
                    <a:pt x="1477505" y="435864"/>
                  </a:moveTo>
                  <a:lnTo>
                    <a:pt x="1451356" y="435864"/>
                  </a:lnTo>
                  <a:lnTo>
                    <a:pt x="1451356" y="591566"/>
                  </a:lnTo>
                  <a:lnTo>
                    <a:pt x="1477505" y="591566"/>
                  </a:lnTo>
                  <a:lnTo>
                    <a:pt x="1477505" y="435864"/>
                  </a:lnTo>
                  <a:close/>
                </a:path>
                <a:path w="1758950" h="591820">
                  <a:moveTo>
                    <a:pt x="1522476" y="435864"/>
                  </a:moveTo>
                  <a:lnTo>
                    <a:pt x="1509395" y="435864"/>
                  </a:lnTo>
                  <a:lnTo>
                    <a:pt x="1509395" y="591566"/>
                  </a:lnTo>
                  <a:lnTo>
                    <a:pt x="1522476" y="591566"/>
                  </a:lnTo>
                  <a:lnTo>
                    <a:pt x="1522476" y="435864"/>
                  </a:lnTo>
                  <a:close/>
                </a:path>
                <a:path w="1758950" h="591820">
                  <a:moveTo>
                    <a:pt x="1580515" y="435864"/>
                  </a:moveTo>
                  <a:lnTo>
                    <a:pt x="1567434" y="435864"/>
                  </a:lnTo>
                  <a:lnTo>
                    <a:pt x="1567434" y="591566"/>
                  </a:lnTo>
                  <a:lnTo>
                    <a:pt x="1580515" y="591566"/>
                  </a:lnTo>
                  <a:lnTo>
                    <a:pt x="1580515" y="435864"/>
                  </a:lnTo>
                  <a:close/>
                </a:path>
                <a:path w="1758950" h="591820">
                  <a:moveTo>
                    <a:pt x="1642859" y="560451"/>
                  </a:moveTo>
                  <a:lnTo>
                    <a:pt x="1625473" y="560451"/>
                  </a:lnTo>
                  <a:lnTo>
                    <a:pt x="1625473" y="591566"/>
                  </a:lnTo>
                  <a:lnTo>
                    <a:pt x="1642859" y="591566"/>
                  </a:lnTo>
                  <a:lnTo>
                    <a:pt x="1642859" y="560451"/>
                  </a:lnTo>
                  <a:close/>
                </a:path>
                <a:path w="1758950" h="591820">
                  <a:moveTo>
                    <a:pt x="1700898" y="342519"/>
                  </a:moveTo>
                  <a:lnTo>
                    <a:pt x="1683512" y="342519"/>
                  </a:lnTo>
                  <a:lnTo>
                    <a:pt x="1683512" y="591566"/>
                  </a:lnTo>
                  <a:lnTo>
                    <a:pt x="1700898" y="591566"/>
                  </a:lnTo>
                  <a:lnTo>
                    <a:pt x="1700898" y="342519"/>
                  </a:lnTo>
                  <a:close/>
                </a:path>
                <a:path w="1758950" h="591820">
                  <a:moveTo>
                    <a:pt x="1758950" y="498221"/>
                  </a:moveTo>
                  <a:lnTo>
                    <a:pt x="1741551" y="498221"/>
                  </a:lnTo>
                  <a:lnTo>
                    <a:pt x="1741551" y="591566"/>
                  </a:lnTo>
                  <a:lnTo>
                    <a:pt x="1758950" y="591566"/>
                  </a:lnTo>
                  <a:lnTo>
                    <a:pt x="1758950" y="498221"/>
                  </a:lnTo>
                  <a:close/>
                </a:path>
              </a:pathLst>
            </a:custGeom>
            <a:solidFill>
              <a:srgbClr val="E9535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6" name="object 106" descr=""/>
            <p:cNvSpPr/>
            <p:nvPr/>
          </p:nvSpPr>
          <p:spPr>
            <a:xfrm>
              <a:off x="1124712" y="7136892"/>
              <a:ext cx="4084954" cy="1525905"/>
            </a:xfrm>
            <a:custGeom>
              <a:avLst/>
              <a:gdLst/>
              <a:ahLst/>
              <a:cxnLst/>
              <a:rect l="l" t="t" r="r" b="b"/>
              <a:pathLst>
                <a:path w="4084954" h="1525904">
                  <a:moveTo>
                    <a:pt x="13081" y="1494409"/>
                  </a:moveTo>
                  <a:lnTo>
                    <a:pt x="0" y="1494409"/>
                  </a:lnTo>
                  <a:lnTo>
                    <a:pt x="0" y="1525524"/>
                  </a:lnTo>
                  <a:lnTo>
                    <a:pt x="13081" y="1525524"/>
                  </a:lnTo>
                  <a:lnTo>
                    <a:pt x="13081" y="1494409"/>
                  </a:lnTo>
                  <a:close/>
                </a:path>
                <a:path w="4084954" h="1525904">
                  <a:moveTo>
                    <a:pt x="71120" y="1432179"/>
                  </a:moveTo>
                  <a:lnTo>
                    <a:pt x="58039" y="1432179"/>
                  </a:lnTo>
                  <a:lnTo>
                    <a:pt x="58039" y="1525524"/>
                  </a:lnTo>
                  <a:lnTo>
                    <a:pt x="71120" y="1525524"/>
                  </a:lnTo>
                  <a:lnTo>
                    <a:pt x="71120" y="1432179"/>
                  </a:lnTo>
                  <a:close/>
                </a:path>
                <a:path w="4084954" h="1525904">
                  <a:moveTo>
                    <a:pt x="129159" y="1338707"/>
                  </a:moveTo>
                  <a:lnTo>
                    <a:pt x="116078" y="1338707"/>
                  </a:lnTo>
                  <a:lnTo>
                    <a:pt x="116078" y="1525524"/>
                  </a:lnTo>
                  <a:lnTo>
                    <a:pt x="129159" y="1525524"/>
                  </a:lnTo>
                  <a:lnTo>
                    <a:pt x="129159" y="1338707"/>
                  </a:lnTo>
                  <a:close/>
                </a:path>
                <a:path w="4084954" h="1525904">
                  <a:moveTo>
                    <a:pt x="187198" y="1463294"/>
                  </a:moveTo>
                  <a:lnTo>
                    <a:pt x="174117" y="1463294"/>
                  </a:lnTo>
                  <a:lnTo>
                    <a:pt x="174117" y="1525524"/>
                  </a:lnTo>
                  <a:lnTo>
                    <a:pt x="187198" y="1525524"/>
                  </a:lnTo>
                  <a:lnTo>
                    <a:pt x="187198" y="1463294"/>
                  </a:lnTo>
                  <a:close/>
                </a:path>
                <a:path w="4084954" h="1525904">
                  <a:moveTo>
                    <a:pt x="245237" y="1338707"/>
                  </a:moveTo>
                  <a:lnTo>
                    <a:pt x="232156" y="1338707"/>
                  </a:lnTo>
                  <a:lnTo>
                    <a:pt x="232156" y="1525524"/>
                  </a:lnTo>
                  <a:lnTo>
                    <a:pt x="245237" y="1525524"/>
                  </a:lnTo>
                  <a:lnTo>
                    <a:pt x="245237" y="1338707"/>
                  </a:lnTo>
                  <a:close/>
                </a:path>
                <a:path w="4084954" h="1525904">
                  <a:moveTo>
                    <a:pt x="303276" y="1463294"/>
                  </a:moveTo>
                  <a:lnTo>
                    <a:pt x="290195" y="1463294"/>
                  </a:lnTo>
                  <a:lnTo>
                    <a:pt x="290195" y="1525524"/>
                  </a:lnTo>
                  <a:lnTo>
                    <a:pt x="303276" y="1525524"/>
                  </a:lnTo>
                  <a:lnTo>
                    <a:pt x="303276" y="1463294"/>
                  </a:lnTo>
                  <a:close/>
                </a:path>
                <a:path w="4084954" h="1525904">
                  <a:moveTo>
                    <a:pt x="361315" y="1338707"/>
                  </a:moveTo>
                  <a:lnTo>
                    <a:pt x="348234" y="1338707"/>
                  </a:lnTo>
                  <a:lnTo>
                    <a:pt x="348234" y="1525524"/>
                  </a:lnTo>
                  <a:lnTo>
                    <a:pt x="361315" y="1525524"/>
                  </a:lnTo>
                  <a:lnTo>
                    <a:pt x="361315" y="1338707"/>
                  </a:lnTo>
                  <a:close/>
                </a:path>
                <a:path w="4084954" h="1525904">
                  <a:moveTo>
                    <a:pt x="427215" y="1338707"/>
                  </a:moveTo>
                  <a:lnTo>
                    <a:pt x="416814" y="1338707"/>
                  </a:lnTo>
                  <a:lnTo>
                    <a:pt x="416814" y="1525524"/>
                  </a:lnTo>
                  <a:lnTo>
                    <a:pt x="427215" y="1525524"/>
                  </a:lnTo>
                  <a:lnTo>
                    <a:pt x="427215" y="1338707"/>
                  </a:lnTo>
                  <a:close/>
                </a:path>
                <a:path w="4084954" h="1525904">
                  <a:moveTo>
                    <a:pt x="477520" y="1432179"/>
                  </a:moveTo>
                  <a:lnTo>
                    <a:pt x="464439" y="1432179"/>
                  </a:lnTo>
                  <a:lnTo>
                    <a:pt x="464439" y="1525524"/>
                  </a:lnTo>
                  <a:lnTo>
                    <a:pt x="477520" y="1525524"/>
                  </a:lnTo>
                  <a:lnTo>
                    <a:pt x="477520" y="1432179"/>
                  </a:lnTo>
                  <a:close/>
                </a:path>
                <a:path w="4084954" h="1525904">
                  <a:moveTo>
                    <a:pt x="543306" y="1307592"/>
                  </a:moveTo>
                  <a:lnTo>
                    <a:pt x="532892" y="1307592"/>
                  </a:lnTo>
                  <a:lnTo>
                    <a:pt x="532892" y="1525524"/>
                  </a:lnTo>
                  <a:lnTo>
                    <a:pt x="543306" y="1525524"/>
                  </a:lnTo>
                  <a:lnTo>
                    <a:pt x="543306" y="1307592"/>
                  </a:lnTo>
                  <a:close/>
                </a:path>
                <a:path w="4084954" h="1525904">
                  <a:moveTo>
                    <a:pt x="601345" y="1338707"/>
                  </a:moveTo>
                  <a:lnTo>
                    <a:pt x="590931" y="1338707"/>
                  </a:lnTo>
                  <a:lnTo>
                    <a:pt x="590931" y="1525524"/>
                  </a:lnTo>
                  <a:lnTo>
                    <a:pt x="601345" y="1525524"/>
                  </a:lnTo>
                  <a:lnTo>
                    <a:pt x="601345" y="1338707"/>
                  </a:lnTo>
                  <a:close/>
                </a:path>
                <a:path w="4084954" h="1525904">
                  <a:moveTo>
                    <a:pt x="659384" y="1214120"/>
                  </a:moveTo>
                  <a:lnTo>
                    <a:pt x="648970" y="1214120"/>
                  </a:lnTo>
                  <a:lnTo>
                    <a:pt x="648970" y="1525524"/>
                  </a:lnTo>
                  <a:lnTo>
                    <a:pt x="659384" y="1525524"/>
                  </a:lnTo>
                  <a:lnTo>
                    <a:pt x="659384" y="1214120"/>
                  </a:lnTo>
                  <a:close/>
                </a:path>
                <a:path w="4084954" h="1525904">
                  <a:moveTo>
                    <a:pt x="717410" y="716026"/>
                  </a:moveTo>
                  <a:lnTo>
                    <a:pt x="707009" y="716026"/>
                  </a:lnTo>
                  <a:lnTo>
                    <a:pt x="707009" y="1525524"/>
                  </a:lnTo>
                  <a:lnTo>
                    <a:pt x="717410" y="1525524"/>
                  </a:lnTo>
                  <a:lnTo>
                    <a:pt x="717410" y="716026"/>
                  </a:lnTo>
                  <a:close/>
                </a:path>
                <a:path w="4084954" h="1525904">
                  <a:moveTo>
                    <a:pt x="775462" y="560324"/>
                  </a:moveTo>
                  <a:lnTo>
                    <a:pt x="765048" y="560324"/>
                  </a:lnTo>
                  <a:lnTo>
                    <a:pt x="765048" y="1525524"/>
                  </a:lnTo>
                  <a:lnTo>
                    <a:pt x="775462" y="1525524"/>
                  </a:lnTo>
                  <a:lnTo>
                    <a:pt x="775462" y="560324"/>
                  </a:lnTo>
                  <a:close/>
                </a:path>
                <a:path w="4084954" h="1525904">
                  <a:moveTo>
                    <a:pt x="833628" y="809498"/>
                  </a:moveTo>
                  <a:lnTo>
                    <a:pt x="823214" y="809498"/>
                  </a:lnTo>
                  <a:lnTo>
                    <a:pt x="823214" y="1525524"/>
                  </a:lnTo>
                  <a:lnTo>
                    <a:pt x="833628" y="1525524"/>
                  </a:lnTo>
                  <a:lnTo>
                    <a:pt x="833628" y="809498"/>
                  </a:lnTo>
                  <a:close/>
                </a:path>
                <a:path w="4084954" h="1525904">
                  <a:moveTo>
                    <a:pt x="891654" y="498094"/>
                  </a:moveTo>
                  <a:lnTo>
                    <a:pt x="881253" y="498094"/>
                  </a:lnTo>
                  <a:lnTo>
                    <a:pt x="881253" y="1525524"/>
                  </a:lnTo>
                  <a:lnTo>
                    <a:pt x="891654" y="1525524"/>
                  </a:lnTo>
                  <a:lnTo>
                    <a:pt x="891654" y="498094"/>
                  </a:lnTo>
                  <a:close/>
                </a:path>
                <a:path w="4084954" h="1525904">
                  <a:moveTo>
                    <a:pt x="949706" y="809498"/>
                  </a:moveTo>
                  <a:lnTo>
                    <a:pt x="939292" y="809498"/>
                  </a:lnTo>
                  <a:lnTo>
                    <a:pt x="939292" y="1525524"/>
                  </a:lnTo>
                  <a:lnTo>
                    <a:pt x="949706" y="1525524"/>
                  </a:lnTo>
                  <a:lnTo>
                    <a:pt x="949706" y="809498"/>
                  </a:lnTo>
                  <a:close/>
                </a:path>
                <a:path w="4084954" h="1525904">
                  <a:moveTo>
                    <a:pt x="1007745" y="373507"/>
                  </a:moveTo>
                  <a:lnTo>
                    <a:pt x="997331" y="373507"/>
                  </a:lnTo>
                  <a:lnTo>
                    <a:pt x="997331" y="1525524"/>
                  </a:lnTo>
                  <a:lnTo>
                    <a:pt x="1007745" y="1525524"/>
                  </a:lnTo>
                  <a:lnTo>
                    <a:pt x="1007745" y="373507"/>
                  </a:lnTo>
                  <a:close/>
                </a:path>
                <a:path w="4084954" h="1525904">
                  <a:moveTo>
                    <a:pt x="1065784" y="778256"/>
                  </a:moveTo>
                  <a:lnTo>
                    <a:pt x="1055370" y="778256"/>
                  </a:lnTo>
                  <a:lnTo>
                    <a:pt x="1055370" y="1525524"/>
                  </a:lnTo>
                  <a:lnTo>
                    <a:pt x="1065784" y="1525524"/>
                  </a:lnTo>
                  <a:lnTo>
                    <a:pt x="1065784" y="778256"/>
                  </a:lnTo>
                  <a:close/>
                </a:path>
                <a:path w="4084954" h="1525904">
                  <a:moveTo>
                    <a:pt x="1123810" y="747141"/>
                  </a:moveTo>
                  <a:lnTo>
                    <a:pt x="1113409" y="747141"/>
                  </a:lnTo>
                  <a:lnTo>
                    <a:pt x="1113409" y="1525524"/>
                  </a:lnTo>
                  <a:lnTo>
                    <a:pt x="1123810" y="1525524"/>
                  </a:lnTo>
                  <a:lnTo>
                    <a:pt x="1123810" y="747141"/>
                  </a:lnTo>
                  <a:close/>
                </a:path>
                <a:path w="4084954" h="1525904">
                  <a:moveTo>
                    <a:pt x="1181862" y="435864"/>
                  </a:moveTo>
                  <a:lnTo>
                    <a:pt x="1171448" y="435864"/>
                  </a:lnTo>
                  <a:lnTo>
                    <a:pt x="1171448" y="1525524"/>
                  </a:lnTo>
                  <a:lnTo>
                    <a:pt x="1181862" y="1525524"/>
                  </a:lnTo>
                  <a:lnTo>
                    <a:pt x="1181862" y="435864"/>
                  </a:lnTo>
                  <a:close/>
                </a:path>
                <a:path w="4084954" h="1525904">
                  <a:moveTo>
                    <a:pt x="1239901" y="716026"/>
                  </a:moveTo>
                  <a:lnTo>
                    <a:pt x="1229487" y="716026"/>
                  </a:lnTo>
                  <a:lnTo>
                    <a:pt x="1229487" y="1525524"/>
                  </a:lnTo>
                  <a:lnTo>
                    <a:pt x="1239901" y="1525524"/>
                  </a:lnTo>
                  <a:lnTo>
                    <a:pt x="1239901" y="716026"/>
                  </a:lnTo>
                  <a:close/>
                </a:path>
                <a:path w="4084954" h="1525904">
                  <a:moveTo>
                    <a:pt x="1297940" y="186829"/>
                  </a:moveTo>
                  <a:lnTo>
                    <a:pt x="1287526" y="186829"/>
                  </a:lnTo>
                  <a:lnTo>
                    <a:pt x="1287526" y="1525524"/>
                  </a:lnTo>
                  <a:lnTo>
                    <a:pt x="1297940" y="1525524"/>
                  </a:lnTo>
                  <a:lnTo>
                    <a:pt x="1297940" y="186829"/>
                  </a:lnTo>
                  <a:close/>
                </a:path>
                <a:path w="4084954" h="1525904">
                  <a:moveTo>
                    <a:pt x="1356106" y="871728"/>
                  </a:moveTo>
                  <a:lnTo>
                    <a:pt x="1345692" y="871728"/>
                  </a:lnTo>
                  <a:lnTo>
                    <a:pt x="1345692" y="1525524"/>
                  </a:lnTo>
                  <a:lnTo>
                    <a:pt x="1356106" y="1525524"/>
                  </a:lnTo>
                  <a:lnTo>
                    <a:pt x="1356106" y="871728"/>
                  </a:lnTo>
                  <a:close/>
                </a:path>
                <a:path w="4084954" h="1525904">
                  <a:moveTo>
                    <a:pt x="1414145" y="716026"/>
                  </a:moveTo>
                  <a:lnTo>
                    <a:pt x="1403731" y="716026"/>
                  </a:lnTo>
                  <a:lnTo>
                    <a:pt x="1403731" y="1525524"/>
                  </a:lnTo>
                  <a:lnTo>
                    <a:pt x="1414145" y="1525524"/>
                  </a:lnTo>
                  <a:lnTo>
                    <a:pt x="1414145" y="716026"/>
                  </a:lnTo>
                  <a:close/>
                </a:path>
                <a:path w="4084954" h="1525904">
                  <a:moveTo>
                    <a:pt x="1472184" y="311277"/>
                  </a:moveTo>
                  <a:lnTo>
                    <a:pt x="1461770" y="311277"/>
                  </a:lnTo>
                  <a:lnTo>
                    <a:pt x="1461770" y="1525524"/>
                  </a:lnTo>
                  <a:lnTo>
                    <a:pt x="1472184" y="1525524"/>
                  </a:lnTo>
                  <a:lnTo>
                    <a:pt x="1472184" y="311277"/>
                  </a:lnTo>
                  <a:close/>
                </a:path>
                <a:path w="4084954" h="1525904">
                  <a:moveTo>
                    <a:pt x="1530210" y="529209"/>
                  </a:moveTo>
                  <a:lnTo>
                    <a:pt x="1519809" y="529209"/>
                  </a:lnTo>
                  <a:lnTo>
                    <a:pt x="1519809" y="1525524"/>
                  </a:lnTo>
                  <a:lnTo>
                    <a:pt x="1530210" y="1525524"/>
                  </a:lnTo>
                  <a:lnTo>
                    <a:pt x="1530210" y="529209"/>
                  </a:lnTo>
                  <a:close/>
                </a:path>
                <a:path w="4084954" h="1525904">
                  <a:moveTo>
                    <a:pt x="1588262" y="373507"/>
                  </a:moveTo>
                  <a:lnTo>
                    <a:pt x="1577848" y="373507"/>
                  </a:lnTo>
                  <a:lnTo>
                    <a:pt x="1577848" y="1525524"/>
                  </a:lnTo>
                  <a:lnTo>
                    <a:pt x="1588262" y="1525524"/>
                  </a:lnTo>
                  <a:lnTo>
                    <a:pt x="1588262" y="373507"/>
                  </a:lnTo>
                  <a:close/>
                </a:path>
                <a:path w="4084954" h="1525904">
                  <a:moveTo>
                    <a:pt x="1646301" y="560324"/>
                  </a:moveTo>
                  <a:lnTo>
                    <a:pt x="1635887" y="560324"/>
                  </a:lnTo>
                  <a:lnTo>
                    <a:pt x="1635887" y="1525524"/>
                  </a:lnTo>
                  <a:lnTo>
                    <a:pt x="1646301" y="1525524"/>
                  </a:lnTo>
                  <a:lnTo>
                    <a:pt x="1646301" y="560324"/>
                  </a:lnTo>
                  <a:close/>
                </a:path>
                <a:path w="4084954" h="1525904">
                  <a:moveTo>
                    <a:pt x="1704340" y="871728"/>
                  </a:moveTo>
                  <a:lnTo>
                    <a:pt x="1693926" y="871728"/>
                  </a:lnTo>
                  <a:lnTo>
                    <a:pt x="1693926" y="1525524"/>
                  </a:lnTo>
                  <a:lnTo>
                    <a:pt x="1704340" y="1525524"/>
                  </a:lnTo>
                  <a:lnTo>
                    <a:pt x="1704340" y="871728"/>
                  </a:lnTo>
                  <a:close/>
                </a:path>
                <a:path w="4084954" h="1525904">
                  <a:moveTo>
                    <a:pt x="1762366" y="716026"/>
                  </a:moveTo>
                  <a:lnTo>
                    <a:pt x="1751965" y="716026"/>
                  </a:lnTo>
                  <a:lnTo>
                    <a:pt x="1751965" y="1525524"/>
                  </a:lnTo>
                  <a:lnTo>
                    <a:pt x="1762366" y="1525524"/>
                  </a:lnTo>
                  <a:lnTo>
                    <a:pt x="1762366" y="716026"/>
                  </a:lnTo>
                  <a:close/>
                </a:path>
                <a:path w="4084954" h="1525904">
                  <a:moveTo>
                    <a:pt x="1820418" y="466979"/>
                  </a:moveTo>
                  <a:lnTo>
                    <a:pt x="1810004" y="466979"/>
                  </a:lnTo>
                  <a:lnTo>
                    <a:pt x="1810004" y="1525524"/>
                  </a:lnTo>
                  <a:lnTo>
                    <a:pt x="1820418" y="1525524"/>
                  </a:lnTo>
                  <a:lnTo>
                    <a:pt x="1820418" y="466979"/>
                  </a:lnTo>
                  <a:close/>
                </a:path>
                <a:path w="4084954" h="1525904">
                  <a:moveTo>
                    <a:pt x="1878584" y="249047"/>
                  </a:moveTo>
                  <a:lnTo>
                    <a:pt x="1868170" y="249047"/>
                  </a:lnTo>
                  <a:lnTo>
                    <a:pt x="1868170" y="1525524"/>
                  </a:lnTo>
                  <a:lnTo>
                    <a:pt x="1878584" y="1525524"/>
                  </a:lnTo>
                  <a:lnTo>
                    <a:pt x="1878584" y="249047"/>
                  </a:lnTo>
                  <a:close/>
                </a:path>
                <a:path w="4084954" h="1525904">
                  <a:moveTo>
                    <a:pt x="1936610" y="342404"/>
                  </a:moveTo>
                  <a:lnTo>
                    <a:pt x="1926209" y="342404"/>
                  </a:lnTo>
                  <a:lnTo>
                    <a:pt x="1926209" y="1525524"/>
                  </a:lnTo>
                  <a:lnTo>
                    <a:pt x="1936610" y="1525524"/>
                  </a:lnTo>
                  <a:lnTo>
                    <a:pt x="1936610" y="342404"/>
                  </a:lnTo>
                  <a:close/>
                </a:path>
                <a:path w="4084954" h="1525904">
                  <a:moveTo>
                    <a:pt x="1994662" y="560324"/>
                  </a:moveTo>
                  <a:lnTo>
                    <a:pt x="1984248" y="560324"/>
                  </a:lnTo>
                  <a:lnTo>
                    <a:pt x="1984248" y="1525524"/>
                  </a:lnTo>
                  <a:lnTo>
                    <a:pt x="1994662" y="1525524"/>
                  </a:lnTo>
                  <a:lnTo>
                    <a:pt x="1994662" y="560324"/>
                  </a:lnTo>
                  <a:close/>
                </a:path>
                <a:path w="4084954" h="1525904">
                  <a:moveTo>
                    <a:pt x="2052701" y="1089660"/>
                  </a:moveTo>
                  <a:lnTo>
                    <a:pt x="2042287" y="1089660"/>
                  </a:lnTo>
                  <a:lnTo>
                    <a:pt x="2042287" y="1525524"/>
                  </a:lnTo>
                  <a:lnTo>
                    <a:pt x="2052701" y="1525524"/>
                  </a:lnTo>
                  <a:lnTo>
                    <a:pt x="2052701" y="1089660"/>
                  </a:lnTo>
                  <a:close/>
                </a:path>
                <a:path w="4084954" h="1525904">
                  <a:moveTo>
                    <a:pt x="2110740" y="902843"/>
                  </a:moveTo>
                  <a:lnTo>
                    <a:pt x="2100326" y="902843"/>
                  </a:lnTo>
                  <a:lnTo>
                    <a:pt x="2100326" y="1525524"/>
                  </a:lnTo>
                  <a:lnTo>
                    <a:pt x="2110740" y="1525524"/>
                  </a:lnTo>
                  <a:lnTo>
                    <a:pt x="2110740" y="902843"/>
                  </a:lnTo>
                  <a:close/>
                </a:path>
                <a:path w="4084954" h="1525904">
                  <a:moveTo>
                    <a:pt x="2168766" y="560324"/>
                  </a:moveTo>
                  <a:lnTo>
                    <a:pt x="2158365" y="560324"/>
                  </a:lnTo>
                  <a:lnTo>
                    <a:pt x="2158365" y="1525524"/>
                  </a:lnTo>
                  <a:lnTo>
                    <a:pt x="2168766" y="1525524"/>
                  </a:lnTo>
                  <a:lnTo>
                    <a:pt x="2168766" y="560324"/>
                  </a:lnTo>
                  <a:close/>
                </a:path>
                <a:path w="4084954" h="1525904">
                  <a:moveTo>
                    <a:pt x="2226818" y="466979"/>
                  </a:moveTo>
                  <a:lnTo>
                    <a:pt x="2216404" y="466979"/>
                  </a:lnTo>
                  <a:lnTo>
                    <a:pt x="2216404" y="1525524"/>
                  </a:lnTo>
                  <a:lnTo>
                    <a:pt x="2226818" y="1525524"/>
                  </a:lnTo>
                  <a:lnTo>
                    <a:pt x="2226818" y="466979"/>
                  </a:lnTo>
                  <a:close/>
                </a:path>
                <a:path w="4084954" h="1525904">
                  <a:moveTo>
                    <a:pt x="2284844" y="217932"/>
                  </a:moveTo>
                  <a:lnTo>
                    <a:pt x="2274443" y="217932"/>
                  </a:lnTo>
                  <a:lnTo>
                    <a:pt x="2274443" y="1525524"/>
                  </a:lnTo>
                  <a:lnTo>
                    <a:pt x="2284844" y="1525524"/>
                  </a:lnTo>
                  <a:lnTo>
                    <a:pt x="2284844" y="217932"/>
                  </a:lnTo>
                  <a:close/>
                </a:path>
                <a:path w="4084954" h="1525904">
                  <a:moveTo>
                    <a:pt x="2342896" y="965073"/>
                  </a:moveTo>
                  <a:lnTo>
                    <a:pt x="2332482" y="965073"/>
                  </a:lnTo>
                  <a:lnTo>
                    <a:pt x="2332482" y="1525524"/>
                  </a:lnTo>
                  <a:lnTo>
                    <a:pt x="2342896" y="1525524"/>
                  </a:lnTo>
                  <a:lnTo>
                    <a:pt x="2342896" y="965073"/>
                  </a:lnTo>
                  <a:close/>
                </a:path>
                <a:path w="4084954" h="1525904">
                  <a:moveTo>
                    <a:pt x="2400935" y="747141"/>
                  </a:moveTo>
                  <a:lnTo>
                    <a:pt x="2390521" y="747141"/>
                  </a:lnTo>
                  <a:lnTo>
                    <a:pt x="2390521" y="1525524"/>
                  </a:lnTo>
                  <a:lnTo>
                    <a:pt x="2400935" y="1525524"/>
                  </a:lnTo>
                  <a:lnTo>
                    <a:pt x="2400935" y="747141"/>
                  </a:lnTo>
                  <a:close/>
                </a:path>
                <a:path w="4084954" h="1525904">
                  <a:moveTo>
                    <a:pt x="2459101" y="996188"/>
                  </a:moveTo>
                  <a:lnTo>
                    <a:pt x="2448687" y="996188"/>
                  </a:lnTo>
                  <a:lnTo>
                    <a:pt x="2448687" y="1525524"/>
                  </a:lnTo>
                  <a:lnTo>
                    <a:pt x="2459101" y="1525524"/>
                  </a:lnTo>
                  <a:lnTo>
                    <a:pt x="2459101" y="996188"/>
                  </a:lnTo>
                  <a:close/>
                </a:path>
                <a:path w="4084954" h="1525904">
                  <a:moveTo>
                    <a:pt x="2517140" y="404749"/>
                  </a:moveTo>
                  <a:lnTo>
                    <a:pt x="2506726" y="404749"/>
                  </a:lnTo>
                  <a:lnTo>
                    <a:pt x="2506726" y="1525524"/>
                  </a:lnTo>
                  <a:lnTo>
                    <a:pt x="2517140" y="1525524"/>
                  </a:lnTo>
                  <a:lnTo>
                    <a:pt x="2517140" y="404749"/>
                  </a:lnTo>
                  <a:close/>
                </a:path>
                <a:path w="4084954" h="1525904">
                  <a:moveTo>
                    <a:pt x="2575179" y="529209"/>
                  </a:moveTo>
                  <a:lnTo>
                    <a:pt x="2564765" y="529209"/>
                  </a:lnTo>
                  <a:lnTo>
                    <a:pt x="2564765" y="1525524"/>
                  </a:lnTo>
                  <a:lnTo>
                    <a:pt x="2575179" y="1525524"/>
                  </a:lnTo>
                  <a:lnTo>
                    <a:pt x="2575179" y="529209"/>
                  </a:lnTo>
                  <a:close/>
                </a:path>
                <a:path w="4084954" h="1525904">
                  <a:moveTo>
                    <a:pt x="2633218" y="404749"/>
                  </a:moveTo>
                  <a:lnTo>
                    <a:pt x="2622804" y="404749"/>
                  </a:lnTo>
                  <a:lnTo>
                    <a:pt x="2622804" y="1525524"/>
                  </a:lnTo>
                  <a:lnTo>
                    <a:pt x="2633218" y="1525524"/>
                  </a:lnTo>
                  <a:lnTo>
                    <a:pt x="2633218" y="404749"/>
                  </a:lnTo>
                  <a:close/>
                </a:path>
                <a:path w="4084954" h="1525904">
                  <a:moveTo>
                    <a:pt x="2691244" y="716026"/>
                  </a:moveTo>
                  <a:lnTo>
                    <a:pt x="2680843" y="716026"/>
                  </a:lnTo>
                  <a:lnTo>
                    <a:pt x="2680843" y="1525524"/>
                  </a:lnTo>
                  <a:lnTo>
                    <a:pt x="2691244" y="1525524"/>
                  </a:lnTo>
                  <a:lnTo>
                    <a:pt x="2691244" y="716026"/>
                  </a:lnTo>
                  <a:close/>
                </a:path>
                <a:path w="4084954" h="1525904">
                  <a:moveTo>
                    <a:pt x="2749296" y="840613"/>
                  </a:moveTo>
                  <a:lnTo>
                    <a:pt x="2738882" y="840613"/>
                  </a:lnTo>
                  <a:lnTo>
                    <a:pt x="2738882" y="1525524"/>
                  </a:lnTo>
                  <a:lnTo>
                    <a:pt x="2749296" y="1525524"/>
                  </a:lnTo>
                  <a:lnTo>
                    <a:pt x="2749296" y="840613"/>
                  </a:lnTo>
                  <a:close/>
                </a:path>
                <a:path w="4084954" h="1525904">
                  <a:moveTo>
                    <a:pt x="2807335" y="498094"/>
                  </a:moveTo>
                  <a:lnTo>
                    <a:pt x="2796921" y="498094"/>
                  </a:lnTo>
                  <a:lnTo>
                    <a:pt x="2796921" y="1525524"/>
                  </a:lnTo>
                  <a:lnTo>
                    <a:pt x="2807335" y="1525524"/>
                  </a:lnTo>
                  <a:lnTo>
                    <a:pt x="2807335" y="498094"/>
                  </a:lnTo>
                  <a:close/>
                </a:path>
                <a:path w="4084954" h="1525904">
                  <a:moveTo>
                    <a:pt x="2865374" y="311277"/>
                  </a:moveTo>
                  <a:lnTo>
                    <a:pt x="2854960" y="311277"/>
                  </a:lnTo>
                  <a:lnTo>
                    <a:pt x="2854960" y="1525524"/>
                  </a:lnTo>
                  <a:lnTo>
                    <a:pt x="2865374" y="1525524"/>
                  </a:lnTo>
                  <a:lnTo>
                    <a:pt x="2865374" y="311277"/>
                  </a:lnTo>
                  <a:close/>
                </a:path>
                <a:path w="4084954" h="1525904">
                  <a:moveTo>
                    <a:pt x="2923413" y="622681"/>
                  </a:moveTo>
                  <a:lnTo>
                    <a:pt x="2912999" y="622681"/>
                  </a:lnTo>
                  <a:lnTo>
                    <a:pt x="2912999" y="1525524"/>
                  </a:lnTo>
                  <a:lnTo>
                    <a:pt x="2923413" y="1525524"/>
                  </a:lnTo>
                  <a:lnTo>
                    <a:pt x="2923413" y="622681"/>
                  </a:lnTo>
                  <a:close/>
                </a:path>
                <a:path w="4084954" h="1525904">
                  <a:moveTo>
                    <a:pt x="2981579" y="653796"/>
                  </a:moveTo>
                  <a:lnTo>
                    <a:pt x="2971165" y="653796"/>
                  </a:lnTo>
                  <a:lnTo>
                    <a:pt x="2971165" y="1525524"/>
                  </a:lnTo>
                  <a:lnTo>
                    <a:pt x="2981579" y="1525524"/>
                  </a:lnTo>
                  <a:lnTo>
                    <a:pt x="2981579" y="653796"/>
                  </a:lnTo>
                  <a:close/>
                </a:path>
                <a:path w="4084954" h="1525904">
                  <a:moveTo>
                    <a:pt x="3039618" y="560324"/>
                  </a:moveTo>
                  <a:lnTo>
                    <a:pt x="3029204" y="560324"/>
                  </a:lnTo>
                  <a:lnTo>
                    <a:pt x="3029204" y="1525524"/>
                  </a:lnTo>
                  <a:lnTo>
                    <a:pt x="3039618" y="1525524"/>
                  </a:lnTo>
                  <a:lnTo>
                    <a:pt x="3039618" y="560324"/>
                  </a:lnTo>
                  <a:close/>
                </a:path>
                <a:path w="4084954" h="1525904">
                  <a:moveTo>
                    <a:pt x="3097644" y="778256"/>
                  </a:moveTo>
                  <a:lnTo>
                    <a:pt x="3087243" y="778256"/>
                  </a:lnTo>
                  <a:lnTo>
                    <a:pt x="3087243" y="1525524"/>
                  </a:lnTo>
                  <a:lnTo>
                    <a:pt x="3097644" y="1525524"/>
                  </a:lnTo>
                  <a:lnTo>
                    <a:pt x="3097644" y="778256"/>
                  </a:lnTo>
                  <a:close/>
                </a:path>
                <a:path w="4084954" h="1525904">
                  <a:moveTo>
                    <a:pt x="3155696" y="716026"/>
                  </a:moveTo>
                  <a:lnTo>
                    <a:pt x="3145282" y="716026"/>
                  </a:lnTo>
                  <a:lnTo>
                    <a:pt x="3145282" y="1525524"/>
                  </a:lnTo>
                  <a:lnTo>
                    <a:pt x="3155696" y="1525524"/>
                  </a:lnTo>
                  <a:lnTo>
                    <a:pt x="3155696" y="716026"/>
                  </a:lnTo>
                  <a:close/>
                </a:path>
                <a:path w="4084954" h="1525904">
                  <a:moveTo>
                    <a:pt x="3213735" y="186829"/>
                  </a:moveTo>
                  <a:lnTo>
                    <a:pt x="3203321" y="186829"/>
                  </a:lnTo>
                  <a:lnTo>
                    <a:pt x="3203321" y="1525524"/>
                  </a:lnTo>
                  <a:lnTo>
                    <a:pt x="3213735" y="1525524"/>
                  </a:lnTo>
                  <a:lnTo>
                    <a:pt x="3213735" y="186829"/>
                  </a:lnTo>
                  <a:close/>
                </a:path>
                <a:path w="4084954" h="1525904">
                  <a:moveTo>
                    <a:pt x="3271774" y="466979"/>
                  </a:moveTo>
                  <a:lnTo>
                    <a:pt x="3261360" y="466979"/>
                  </a:lnTo>
                  <a:lnTo>
                    <a:pt x="3261360" y="1525524"/>
                  </a:lnTo>
                  <a:lnTo>
                    <a:pt x="3271774" y="1525524"/>
                  </a:lnTo>
                  <a:lnTo>
                    <a:pt x="3271774" y="466979"/>
                  </a:lnTo>
                  <a:close/>
                </a:path>
                <a:path w="4084954" h="1525904">
                  <a:moveTo>
                    <a:pt x="3329813" y="996188"/>
                  </a:moveTo>
                  <a:lnTo>
                    <a:pt x="3319399" y="996188"/>
                  </a:lnTo>
                  <a:lnTo>
                    <a:pt x="3319399" y="1525524"/>
                  </a:lnTo>
                  <a:lnTo>
                    <a:pt x="3329813" y="1525524"/>
                  </a:lnTo>
                  <a:lnTo>
                    <a:pt x="3329813" y="996188"/>
                  </a:lnTo>
                  <a:close/>
                </a:path>
                <a:path w="4084954" h="1525904">
                  <a:moveTo>
                    <a:pt x="3387852" y="373507"/>
                  </a:moveTo>
                  <a:lnTo>
                    <a:pt x="3377438" y="373507"/>
                  </a:lnTo>
                  <a:lnTo>
                    <a:pt x="3377438" y="1525524"/>
                  </a:lnTo>
                  <a:lnTo>
                    <a:pt x="3387852" y="1525524"/>
                  </a:lnTo>
                  <a:lnTo>
                    <a:pt x="3387852" y="373507"/>
                  </a:lnTo>
                  <a:close/>
                </a:path>
                <a:path w="4084954" h="1525904">
                  <a:moveTo>
                    <a:pt x="3445891" y="747141"/>
                  </a:moveTo>
                  <a:lnTo>
                    <a:pt x="3435477" y="747141"/>
                  </a:lnTo>
                  <a:lnTo>
                    <a:pt x="3435477" y="1525524"/>
                  </a:lnTo>
                  <a:lnTo>
                    <a:pt x="3445891" y="1525524"/>
                  </a:lnTo>
                  <a:lnTo>
                    <a:pt x="3445891" y="747141"/>
                  </a:lnTo>
                  <a:close/>
                </a:path>
                <a:path w="4084954" h="1525904">
                  <a:moveTo>
                    <a:pt x="3503930" y="902843"/>
                  </a:moveTo>
                  <a:lnTo>
                    <a:pt x="3493516" y="902843"/>
                  </a:lnTo>
                  <a:lnTo>
                    <a:pt x="3493516" y="1525524"/>
                  </a:lnTo>
                  <a:lnTo>
                    <a:pt x="3503930" y="1525524"/>
                  </a:lnTo>
                  <a:lnTo>
                    <a:pt x="3503930" y="902843"/>
                  </a:lnTo>
                  <a:close/>
                </a:path>
                <a:path w="4084954" h="1525904">
                  <a:moveTo>
                    <a:pt x="3562096" y="684911"/>
                  </a:moveTo>
                  <a:lnTo>
                    <a:pt x="3551682" y="684911"/>
                  </a:lnTo>
                  <a:lnTo>
                    <a:pt x="3551682" y="1525524"/>
                  </a:lnTo>
                  <a:lnTo>
                    <a:pt x="3562096" y="1525524"/>
                  </a:lnTo>
                  <a:lnTo>
                    <a:pt x="3562096" y="684911"/>
                  </a:lnTo>
                  <a:close/>
                </a:path>
                <a:path w="4084954" h="1525904">
                  <a:moveTo>
                    <a:pt x="3620135" y="622681"/>
                  </a:moveTo>
                  <a:lnTo>
                    <a:pt x="3609721" y="622681"/>
                  </a:lnTo>
                  <a:lnTo>
                    <a:pt x="3609721" y="1525524"/>
                  </a:lnTo>
                  <a:lnTo>
                    <a:pt x="3620135" y="1525524"/>
                  </a:lnTo>
                  <a:lnTo>
                    <a:pt x="3620135" y="622681"/>
                  </a:lnTo>
                  <a:close/>
                </a:path>
                <a:path w="4084954" h="1525904">
                  <a:moveTo>
                    <a:pt x="3678174" y="1027430"/>
                  </a:moveTo>
                  <a:lnTo>
                    <a:pt x="3667760" y="1027430"/>
                  </a:lnTo>
                  <a:lnTo>
                    <a:pt x="3667760" y="1525524"/>
                  </a:lnTo>
                  <a:lnTo>
                    <a:pt x="3678174" y="1525524"/>
                  </a:lnTo>
                  <a:lnTo>
                    <a:pt x="3678174" y="1027430"/>
                  </a:lnTo>
                  <a:close/>
                </a:path>
                <a:path w="4084954" h="1525904">
                  <a:moveTo>
                    <a:pt x="3736213" y="933958"/>
                  </a:moveTo>
                  <a:lnTo>
                    <a:pt x="3725799" y="933958"/>
                  </a:lnTo>
                  <a:lnTo>
                    <a:pt x="3725799" y="1525524"/>
                  </a:lnTo>
                  <a:lnTo>
                    <a:pt x="3736213" y="1525524"/>
                  </a:lnTo>
                  <a:lnTo>
                    <a:pt x="3736213" y="933958"/>
                  </a:lnTo>
                  <a:close/>
                </a:path>
                <a:path w="4084954" h="1525904">
                  <a:moveTo>
                    <a:pt x="3794252" y="902843"/>
                  </a:moveTo>
                  <a:lnTo>
                    <a:pt x="3783838" y="902843"/>
                  </a:lnTo>
                  <a:lnTo>
                    <a:pt x="3783838" y="1525524"/>
                  </a:lnTo>
                  <a:lnTo>
                    <a:pt x="3794252" y="1525524"/>
                  </a:lnTo>
                  <a:lnTo>
                    <a:pt x="3794252" y="902843"/>
                  </a:lnTo>
                  <a:close/>
                </a:path>
                <a:path w="4084954" h="1525904">
                  <a:moveTo>
                    <a:pt x="3852291" y="1089660"/>
                  </a:moveTo>
                  <a:lnTo>
                    <a:pt x="3841877" y="1089660"/>
                  </a:lnTo>
                  <a:lnTo>
                    <a:pt x="3841877" y="1525524"/>
                  </a:lnTo>
                  <a:lnTo>
                    <a:pt x="3852291" y="1525524"/>
                  </a:lnTo>
                  <a:lnTo>
                    <a:pt x="3852291" y="1089660"/>
                  </a:lnTo>
                  <a:close/>
                </a:path>
                <a:path w="4084954" h="1525904">
                  <a:moveTo>
                    <a:pt x="3910330" y="373507"/>
                  </a:moveTo>
                  <a:lnTo>
                    <a:pt x="3899916" y="373507"/>
                  </a:lnTo>
                  <a:lnTo>
                    <a:pt x="3899916" y="1525524"/>
                  </a:lnTo>
                  <a:lnTo>
                    <a:pt x="3910330" y="1525524"/>
                  </a:lnTo>
                  <a:lnTo>
                    <a:pt x="3910330" y="373507"/>
                  </a:lnTo>
                  <a:close/>
                </a:path>
                <a:path w="4084954" h="1525904">
                  <a:moveTo>
                    <a:pt x="3968369" y="0"/>
                  </a:moveTo>
                  <a:lnTo>
                    <a:pt x="3957955" y="0"/>
                  </a:lnTo>
                  <a:lnTo>
                    <a:pt x="3957955" y="1525524"/>
                  </a:lnTo>
                  <a:lnTo>
                    <a:pt x="3968369" y="1525524"/>
                  </a:lnTo>
                  <a:lnTo>
                    <a:pt x="3968369" y="0"/>
                  </a:lnTo>
                  <a:close/>
                </a:path>
                <a:path w="4084954" h="1525904">
                  <a:moveTo>
                    <a:pt x="4026395" y="778256"/>
                  </a:moveTo>
                  <a:lnTo>
                    <a:pt x="4015994" y="778256"/>
                  </a:lnTo>
                  <a:lnTo>
                    <a:pt x="4015994" y="1525524"/>
                  </a:lnTo>
                  <a:lnTo>
                    <a:pt x="4026395" y="1525524"/>
                  </a:lnTo>
                  <a:lnTo>
                    <a:pt x="4026395" y="778256"/>
                  </a:lnTo>
                  <a:close/>
                </a:path>
                <a:path w="4084954" h="1525904">
                  <a:moveTo>
                    <a:pt x="4084574" y="591439"/>
                  </a:moveTo>
                  <a:lnTo>
                    <a:pt x="4074160" y="591439"/>
                  </a:lnTo>
                  <a:lnTo>
                    <a:pt x="4074160" y="1525524"/>
                  </a:lnTo>
                  <a:lnTo>
                    <a:pt x="4084574" y="1525524"/>
                  </a:lnTo>
                  <a:lnTo>
                    <a:pt x="4084574" y="591439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7" name="object 107" descr=""/>
            <p:cNvSpPr/>
            <p:nvPr/>
          </p:nvSpPr>
          <p:spPr>
            <a:xfrm>
              <a:off x="5198872" y="7541641"/>
              <a:ext cx="4074160" cy="1120775"/>
            </a:xfrm>
            <a:custGeom>
              <a:avLst/>
              <a:gdLst/>
              <a:ahLst/>
              <a:cxnLst/>
              <a:rect l="l" t="t" r="r" b="b"/>
              <a:pathLst>
                <a:path w="4074159" h="1120775">
                  <a:moveTo>
                    <a:pt x="10414" y="186690"/>
                  </a:moveTo>
                  <a:lnTo>
                    <a:pt x="0" y="186690"/>
                  </a:lnTo>
                  <a:lnTo>
                    <a:pt x="0" y="1120775"/>
                  </a:lnTo>
                  <a:lnTo>
                    <a:pt x="10414" y="1120775"/>
                  </a:lnTo>
                  <a:lnTo>
                    <a:pt x="10414" y="186690"/>
                  </a:lnTo>
                  <a:close/>
                </a:path>
                <a:path w="4074159" h="1120775">
                  <a:moveTo>
                    <a:pt x="68453" y="684911"/>
                  </a:moveTo>
                  <a:lnTo>
                    <a:pt x="58039" y="684911"/>
                  </a:lnTo>
                  <a:lnTo>
                    <a:pt x="58039" y="1120775"/>
                  </a:lnTo>
                  <a:lnTo>
                    <a:pt x="68453" y="1120775"/>
                  </a:lnTo>
                  <a:lnTo>
                    <a:pt x="68453" y="684911"/>
                  </a:lnTo>
                  <a:close/>
                </a:path>
                <a:path w="4074159" h="1120775">
                  <a:moveTo>
                    <a:pt x="126492" y="186690"/>
                  </a:moveTo>
                  <a:lnTo>
                    <a:pt x="116078" y="186690"/>
                  </a:lnTo>
                  <a:lnTo>
                    <a:pt x="116078" y="1120775"/>
                  </a:lnTo>
                  <a:lnTo>
                    <a:pt x="126492" y="1120775"/>
                  </a:lnTo>
                  <a:lnTo>
                    <a:pt x="126492" y="186690"/>
                  </a:lnTo>
                  <a:close/>
                </a:path>
                <a:path w="4074159" h="1120775">
                  <a:moveTo>
                    <a:pt x="184531" y="560324"/>
                  </a:moveTo>
                  <a:lnTo>
                    <a:pt x="174117" y="560324"/>
                  </a:lnTo>
                  <a:lnTo>
                    <a:pt x="174117" y="1120775"/>
                  </a:lnTo>
                  <a:lnTo>
                    <a:pt x="184531" y="1120775"/>
                  </a:lnTo>
                  <a:lnTo>
                    <a:pt x="184531" y="560324"/>
                  </a:lnTo>
                  <a:close/>
                </a:path>
                <a:path w="4074159" h="1120775">
                  <a:moveTo>
                    <a:pt x="242570" y="249047"/>
                  </a:moveTo>
                  <a:lnTo>
                    <a:pt x="232156" y="249047"/>
                  </a:lnTo>
                  <a:lnTo>
                    <a:pt x="232156" y="1120775"/>
                  </a:lnTo>
                  <a:lnTo>
                    <a:pt x="242570" y="1120775"/>
                  </a:lnTo>
                  <a:lnTo>
                    <a:pt x="242570" y="249047"/>
                  </a:lnTo>
                  <a:close/>
                </a:path>
                <a:path w="4074159" h="1120775">
                  <a:moveTo>
                    <a:pt x="300609" y="124460"/>
                  </a:moveTo>
                  <a:lnTo>
                    <a:pt x="290195" y="124460"/>
                  </a:lnTo>
                  <a:lnTo>
                    <a:pt x="290195" y="1120775"/>
                  </a:lnTo>
                  <a:lnTo>
                    <a:pt x="300609" y="1120775"/>
                  </a:lnTo>
                  <a:lnTo>
                    <a:pt x="300609" y="124460"/>
                  </a:lnTo>
                  <a:close/>
                </a:path>
                <a:path w="4074159" h="1120775">
                  <a:moveTo>
                    <a:pt x="358635" y="62230"/>
                  </a:moveTo>
                  <a:lnTo>
                    <a:pt x="348234" y="62230"/>
                  </a:lnTo>
                  <a:lnTo>
                    <a:pt x="348234" y="1120775"/>
                  </a:lnTo>
                  <a:lnTo>
                    <a:pt x="358635" y="1120775"/>
                  </a:lnTo>
                  <a:lnTo>
                    <a:pt x="358635" y="62230"/>
                  </a:lnTo>
                  <a:close/>
                </a:path>
                <a:path w="4074159" h="1120775">
                  <a:moveTo>
                    <a:pt x="416687" y="124460"/>
                  </a:moveTo>
                  <a:lnTo>
                    <a:pt x="406273" y="124460"/>
                  </a:lnTo>
                  <a:lnTo>
                    <a:pt x="406273" y="1120775"/>
                  </a:lnTo>
                  <a:lnTo>
                    <a:pt x="416687" y="1120775"/>
                  </a:lnTo>
                  <a:lnTo>
                    <a:pt x="416687" y="124460"/>
                  </a:lnTo>
                  <a:close/>
                </a:path>
                <a:path w="4074159" h="1120775">
                  <a:moveTo>
                    <a:pt x="474726" y="155575"/>
                  </a:moveTo>
                  <a:lnTo>
                    <a:pt x="464312" y="155575"/>
                  </a:lnTo>
                  <a:lnTo>
                    <a:pt x="464312" y="1120775"/>
                  </a:lnTo>
                  <a:lnTo>
                    <a:pt x="474726" y="1120775"/>
                  </a:lnTo>
                  <a:lnTo>
                    <a:pt x="474726" y="155575"/>
                  </a:lnTo>
                  <a:close/>
                </a:path>
                <a:path w="4074159" h="1120775">
                  <a:moveTo>
                    <a:pt x="532892" y="311277"/>
                  </a:moveTo>
                  <a:lnTo>
                    <a:pt x="522478" y="311277"/>
                  </a:lnTo>
                  <a:lnTo>
                    <a:pt x="522478" y="1120775"/>
                  </a:lnTo>
                  <a:lnTo>
                    <a:pt x="532892" y="1120775"/>
                  </a:lnTo>
                  <a:lnTo>
                    <a:pt x="532892" y="311277"/>
                  </a:lnTo>
                  <a:close/>
                </a:path>
                <a:path w="4074159" h="1120775">
                  <a:moveTo>
                    <a:pt x="590931" y="0"/>
                  </a:moveTo>
                  <a:lnTo>
                    <a:pt x="580517" y="0"/>
                  </a:lnTo>
                  <a:lnTo>
                    <a:pt x="580517" y="1120775"/>
                  </a:lnTo>
                  <a:lnTo>
                    <a:pt x="590931" y="1120775"/>
                  </a:lnTo>
                  <a:lnTo>
                    <a:pt x="590931" y="0"/>
                  </a:lnTo>
                  <a:close/>
                </a:path>
                <a:path w="4074159" h="1120775">
                  <a:moveTo>
                    <a:pt x="648970" y="93345"/>
                  </a:moveTo>
                  <a:lnTo>
                    <a:pt x="638556" y="93345"/>
                  </a:lnTo>
                  <a:lnTo>
                    <a:pt x="638556" y="1120775"/>
                  </a:lnTo>
                  <a:lnTo>
                    <a:pt x="648970" y="1120775"/>
                  </a:lnTo>
                  <a:lnTo>
                    <a:pt x="648970" y="93345"/>
                  </a:lnTo>
                  <a:close/>
                </a:path>
                <a:path w="4074159" h="1120775">
                  <a:moveTo>
                    <a:pt x="707009" y="373507"/>
                  </a:moveTo>
                  <a:lnTo>
                    <a:pt x="696595" y="373507"/>
                  </a:lnTo>
                  <a:lnTo>
                    <a:pt x="696595" y="1120775"/>
                  </a:lnTo>
                  <a:lnTo>
                    <a:pt x="707009" y="1120775"/>
                  </a:lnTo>
                  <a:lnTo>
                    <a:pt x="707009" y="373507"/>
                  </a:lnTo>
                  <a:close/>
                </a:path>
                <a:path w="4074159" h="1120775">
                  <a:moveTo>
                    <a:pt x="765035" y="466979"/>
                  </a:moveTo>
                  <a:lnTo>
                    <a:pt x="754634" y="466979"/>
                  </a:lnTo>
                  <a:lnTo>
                    <a:pt x="754634" y="1120775"/>
                  </a:lnTo>
                  <a:lnTo>
                    <a:pt x="765035" y="1120775"/>
                  </a:lnTo>
                  <a:lnTo>
                    <a:pt x="765035" y="466979"/>
                  </a:lnTo>
                  <a:close/>
                </a:path>
                <a:path w="4074159" h="1120775">
                  <a:moveTo>
                    <a:pt x="823087" y="653796"/>
                  </a:moveTo>
                  <a:lnTo>
                    <a:pt x="812673" y="653796"/>
                  </a:lnTo>
                  <a:lnTo>
                    <a:pt x="812673" y="1120775"/>
                  </a:lnTo>
                  <a:lnTo>
                    <a:pt x="823087" y="1120775"/>
                  </a:lnTo>
                  <a:lnTo>
                    <a:pt x="823087" y="653796"/>
                  </a:lnTo>
                  <a:close/>
                </a:path>
                <a:path w="4074159" h="1120775">
                  <a:moveTo>
                    <a:pt x="881126" y="716026"/>
                  </a:moveTo>
                  <a:lnTo>
                    <a:pt x="870712" y="716026"/>
                  </a:lnTo>
                  <a:lnTo>
                    <a:pt x="870712" y="1120775"/>
                  </a:lnTo>
                  <a:lnTo>
                    <a:pt x="881126" y="1120775"/>
                  </a:lnTo>
                  <a:lnTo>
                    <a:pt x="881126" y="716026"/>
                  </a:lnTo>
                  <a:close/>
                </a:path>
                <a:path w="4074159" h="1120775">
                  <a:moveTo>
                    <a:pt x="939165" y="342392"/>
                  </a:moveTo>
                  <a:lnTo>
                    <a:pt x="928751" y="342392"/>
                  </a:lnTo>
                  <a:lnTo>
                    <a:pt x="928751" y="1120775"/>
                  </a:lnTo>
                  <a:lnTo>
                    <a:pt x="939165" y="1120775"/>
                  </a:lnTo>
                  <a:lnTo>
                    <a:pt x="939165" y="342392"/>
                  </a:lnTo>
                  <a:close/>
                </a:path>
                <a:path w="4074159" h="1120775">
                  <a:moveTo>
                    <a:pt x="997204" y="529209"/>
                  </a:moveTo>
                  <a:lnTo>
                    <a:pt x="986790" y="529209"/>
                  </a:lnTo>
                  <a:lnTo>
                    <a:pt x="986790" y="1120775"/>
                  </a:lnTo>
                  <a:lnTo>
                    <a:pt x="997204" y="1120775"/>
                  </a:lnTo>
                  <a:lnTo>
                    <a:pt x="997204" y="529209"/>
                  </a:lnTo>
                  <a:close/>
                </a:path>
                <a:path w="4074159" h="1120775">
                  <a:moveTo>
                    <a:pt x="1055243" y="653796"/>
                  </a:moveTo>
                  <a:lnTo>
                    <a:pt x="1044829" y="653796"/>
                  </a:lnTo>
                  <a:lnTo>
                    <a:pt x="1044829" y="1120775"/>
                  </a:lnTo>
                  <a:lnTo>
                    <a:pt x="1055243" y="1120775"/>
                  </a:lnTo>
                  <a:lnTo>
                    <a:pt x="1055243" y="653796"/>
                  </a:lnTo>
                  <a:close/>
                </a:path>
                <a:path w="4074159" h="1120775">
                  <a:moveTo>
                    <a:pt x="1113409" y="435864"/>
                  </a:moveTo>
                  <a:lnTo>
                    <a:pt x="1102995" y="435864"/>
                  </a:lnTo>
                  <a:lnTo>
                    <a:pt x="1102995" y="1120775"/>
                  </a:lnTo>
                  <a:lnTo>
                    <a:pt x="1113409" y="1120775"/>
                  </a:lnTo>
                  <a:lnTo>
                    <a:pt x="1113409" y="435864"/>
                  </a:lnTo>
                  <a:close/>
                </a:path>
                <a:path w="4074159" h="1120775">
                  <a:moveTo>
                    <a:pt x="1171435" y="373507"/>
                  </a:moveTo>
                  <a:lnTo>
                    <a:pt x="1161034" y="373507"/>
                  </a:lnTo>
                  <a:lnTo>
                    <a:pt x="1161034" y="1120775"/>
                  </a:lnTo>
                  <a:lnTo>
                    <a:pt x="1171435" y="1120775"/>
                  </a:lnTo>
                  <a:lnTo>
                    <a:pt x="1171435" y="373507"/>
                  </a:lnTo>
                  <a:close/>
                </a:path>
                <a:path w="4074159" h="1120775">
                  <a:moveTo>
                    <a:pt x="1229487" y="62230"/>
                  </a:moveTo>
                  <a:lnTo>
                    <a:pt x="1219073" y="62230"/>
                  </a:lnTo>
                  <a:lnTo>
                    <a:pt x="1219073" y="1120775"/>
                  </a:lnTo>
                  <a:lnTo>
                    <a:pt x="1229487" y="1120775"/>
                  </a:lnTo>
                  <a:lnTo>
                    <a:pt x="1229487" y="62230"/>
                  </a:lnTo>
                  <a:close/>
                </a:path>
                <a:path w="4074159" h="1120775">
                  <a:moveTo>
                    <a:pt x="1287526" y="560324"/>
                  </a:moveTo>
                  <a:lnTo>
                    <a:pt x="1277112" y="560324"/>
                  </a:lnTo>
                  <a:lnTo>
                    <a:pt x="1277112" y="1120775"/>
                  </a:lnTo>
                  <a:lnTo>
                    <a:pt x="1287526" y="1120775"/>
                  </a:lnTo>
                  <a:lnTo>
                    <a:pt x="1287526" y="560324"/>
                  </a:lnTo>
                  <a:close/>
                </a:path>
                <a:path w="4074159" h="1120775">
                  <a:moveTo>
                    <a:pt x="1345565" y="280162"/>
                  </a:moveTo>
                  <a:lnTo>
                    <a:pt x="1335151" y="280162"/>
                  </a:lnTo>
                  <a:lnTo>
                    <a:pt x="1335151" y="1120775"/>
                  </a:lnTo>
                  <a:lnTo>
                    <a:pt x="1345565" y="1120775"/>
                  </a:lnTo>
                  <a:lnTo>
                    <a:pt x="1345565" y="280162"/>
                  </a:lnTo>
                  <a:close/>
                </a:path>
                <a:path w="4074159" h="1120775">
                  <a:moveTo>
                    <a:pt x="1403604" y="124460"/>
                  </a:moveTo>
                  <a:lnTo>
                    <a:pt x="1393177" y="124460"/>
                  </a:lnTo>
                  <a:lnTo>
                    <a:pt x="1393177" y="1120775"/>
                  </a:lnTo>
                  <a:lnTo>
                    <a:pt x="1403604" y="1120775"/>
                  </a:lnTo>
                  <a:lnTo>
                    <a:pt x="1403604" y="124460"/>
                  </a:lnTo>
                  <a:close/>
                </a:path>
                <a:path w="4074159" h="1120775">
                  <a:moveTo>
                    <a:pt x="1461643" y="622681"/>
                  </a:moveTo>
                  <a:lnTo>
                    <a:pt x="1451229" y="622681"/>
                  </a:lnTo>
                  <a:lnTo>
                    <a:pt x="1451229" y="1120775"/>
                  </a:lnTo>
                  <a:lnTo>
                    <a:pt x="1461643" y="1120775"/>
                  </a:lnTo>
                  <a:lnTo>
                    <a:pt x="1461643" y="622681"/>
                  </a:lnTo>
                  <a:close/>
                </a:path>
                <a:path w="4074159" h="1120775">
                  <a:moveTo>
                    <a:pt x="1519682" y="155575"/>
                  </a:moveTo>
                  <a:lnTo>
                    <a:pt x="1509268" y="155575"/>
                  </a:lnTo>
                  <a:lnTo>
                    <a:pt x="1509268" y="1120775"/>
                  </a:lnTo>
                  <a:lnTo>
                    <a:pt x="1519682" y="1120775"/>
                  </a:lnTo>
                  <a:lnTo>
                    <a:pt x="1519682" y="155575"/>
                  </a:lnTo>
                  <a:close/>
                </a:path>
                <a:path w="4074159" h="1120775">
                  <a:moveTo>
                    <a:pt x="1577721" y="373507"/>
                  </a:moveTo>
                  <a:lnTo>
                    <a:pt x="1567307" y="373507"/>
                  </a:lnTo>
                  <a:lnTo>
                    <a:pt x="1567307" y="1120775"/>
                  </a:lnTo>
                  <a:lnTo>
                    <a:pt x="1577721" y="1120775"/>
                  </a:lnTo>
                  <a:lnTo>
                    <a:pt x="1577721" y="373507"/>
                  </a:lnTo>
                  <a:close/>
                </a:path>
                <a:path w="4074159" h="1120775">
                  <a:moveTo>
                    <a:pt x="1635887" y="280162"/>
                  </a:moveTo>
                  <a:lnTo>
                    <a:pt x="1625473" y="280162"/>
                  </a:lnTo>
                  <a:lnTo>
                    <a:pt x="1625473" y="1120775"/>
                  </a:lnTo>
                  <a:lnTo>
                    <a:pt x="1635887" y="1120775"/>
                  </a:lnTo>
                  <a:lnTo>
                    <a:pt x="1635887" y="280162"/>
                  </a:lnTo>
                  <a:close/>
                </a:path>
                <a:path w="4074159" h="1120775">
                  <a:moveTo>
                    <a:pt x="1693926" y="342392"/>
                  </a:moveTo>
                  <a:lnTo>
                    <a:pt x="1683512" y="342392"/>
                  </a:lnTo>
                  <a:lnTo>
                    <a:pt x="1683512" y="1120775"/>
                  </a:lnTo>
                  <a:lnTo>
                    <a:pt x="1693926" y="1120775"/>
                  </a:lnTo>
                  <a:lnTo>
                    <a:pt x="1693926" y="342392"/>
                  </a:lnTo>
                  <a:close/>
                </a:path>
                <a:path w="4074159" h="1120775">
                  <a:moveTo>
                    <a:pt x="1751965" y="373507"/>
                  </a:moveTo>
                  <a:lnTo>
                    <a:pt x="1741551" y="373507"/>
                  </a:lnTo>
                  <a:lnTo>
                    <a:pt x="1741551" y="1120775"/>
                  </a:lnTo>
                  <a:lnTo>
                    <a:pt x="1751965" y="1120775"/>
                  </a:lnTo>
                  <a:lnTo>
                    <a:pt x="1751965" y="373507"/>
                  </a:lnTo>
                  <a:close/>
                </a:path>
                <a:path w="4074159" h="1120775">
                  <a:moveTo>
                    <a:pt x="1810004" y="217932"/>
                  </a:moveTo>
                  <a:lnTo>
                    <a:pt x="1799590" y="217932"/>
                  </a:lnTo>
                  <a:lnTo>
                    <a:pt x="1799590" y="1120775"/>
                  </a:lnTo>
                  <a:lnTo>
                    <a:pt x="1810004" y="1120775"/>
                  </a:lnTo>
                  <a:lnTo>
                    <a:pt x="1810004" y="217932"/>
                  </a:lnTo>
                  <a:close/>
                </a:path>
                <a:path w="4074159" h="1120775">
                  <a:moveTo>
                    <a:pt x="1868043" y="498094"/>
                  </a:moveTo>
                  <a:lnTo>
                    <a:pt x="1857629" y="498094"/>
                  </a:lnTo>
                  <a:lnTo>
                    <a:pt x="1857629" y="1120775"/>
                  </a:lnTo>
                  <a:lnTo>
                    <a:pt x="1868043" y="1120775"/>
                  </a:lnTo>
                  <a:lnTo>
                    <a:pt x="1868043" y="498094"/>
                  </a:lnTo>
                  <a:close/>
                </a:path>
                <a:path w="4074159" h="1120775">
                  <a:moveTo>
                    <a:pt x="1926082" y="249047"/>
                  </a:moveTo>
                  <a:lnTo>
                    <a:pt x="1915668" y="249047"/>
                  </a:lnTo>
                  <a:lnTo>
                    <a:pt x="1915668" y="1120775"/>
                  </a:lnTo>
                  <a:lnTo>
                    <a:pt x="1926082" y="1120775"/>
                  </a:lnTo>
                  <a:lnTo>
                    <a:pt x="1926082" y="249047"/>
                  </a:lnTo>
                  <a:close/>
                </a:path>
                <a:path w="4074159" h="1120775">
                  <a:moveTo>
                    <a:pt x="1984121" y="155575"/>
                  </a:moveTo>
                  <a:lnTo>
                    <a:pt x="1973707" y="155575"/>
                  </a:lnTo>
                  <a:lnTo>
                    <a:pt x="1973707" y="1120775"/>
                  </a:lnTo>
                  <a:lnTo>
                    <a:pt x="1984121" y="1120775"/>
                  </a:lnTo>
                  <a:lnTo>
                    <a:pt x="1984121" y="155575"/>
                  </a:lnTo>
                  <a:close/>
                </a:path>
                <a:path w="4074159" h="1120775">
                  <a:moveTo>
                    <a:pt x="2042160" y="498094"/>
                  </a:moveTo>
                  <a:lnTo>
                    <a:pt x="2031746" y="498094"/>
                  </a:lnTo>
                  <a:lnTo>
                    <a:pt x="2031746" y="1120775"/>
                  </a:lnTo>
                  <a:lnTo>
                    <a:pt x="2042160" y="1120775"/>
                  </a:lnTo>
                  <a:lnTo>
                    <a:pt x="2042160" y="498094"/>
                  </a:lnTo>
                  <a:close/>
                </a:path>
                <a:path w="4074159" h="1120775">
                  <a:moveTo>
                    <a:pt x="2100199" y="373507"/>
                  </a:moveTo>
                  <a:lnTo>
                    <a:pt x="2089785" y="373507"/>
                  </a:lnTo>
                  <a:lnTo>
                    <a:pt x="2089785" y="1120775"/>
                  </a:lnTo>
                  <a:lnTo>
                    <a:pt x="2100199" y="1120775"/>
                  </a:lnTo>
                  <a:lnTo>
                    <a:pt x="2100199" y="373507"/>
                  </a:lnTo>
                  <a:close/>
                </a:path>
                <a:path w="4074159" h="1120775">
                  <a:moveTo>
                    <a:pt x="2158365" y="778256"/>
                  </a:moveTo>
                  <a:lnTo>
                    <a:pt x="2147951" y="778256"/>
                  </a:lnTo>
                  <a:lnTo>
                    <a:pt x="2147951" y="1120775"/>
                  </a:lnTo>
                  <a:lnTo>
                    <a:pt x="2158365" y="1120775"/>
                  </a:lnTo>
                  <a:lnTo>
                    <a:pt x="2158365" y="778256"/>
                  </a:lnTo>
                  <a:close/>
                </a:path>
                <a:path w="4074159" h="1120775">
                  <a:moveTo>
                    <a:pt x="2216404" y="435864"/>
                  </a:moveTo>
                  <a:lnTo>
                    <a:pt x="2205990" y="435864"/>
                  </a:lnTo>
                  <a:lnTo>
                    <a:pt x="2205990" y="1120775"/>
                  </a:lnTo>
                  <a:lnTo>
                    <a:pt x="2216404" y="1120775"/>
                  </a:lnTo>
                  <a:lnTo>
                    <a:pt x="2216404" y="435864"/>
                  </a:lnTo>
                  <a:close/>
                </a:path>
                <a:path w="4074159" h="1120775">
                  <a:moveTo>
                    <a:pt x="2274443" y="716026"/>
                  </a:moveTo>
                  <a:lnTo>
                    <a:pt x="2264029" y="716026"/>
                  </a:lnTo>
                  <a:lnTo>
                    <a:pt x="2264029" y="1120775"/>
                  </a:lnTo>
                  <a:lnTo>
                    <a:pt x="2274443" y="1120775"/>
                  </a:lnTo>
                  <a:lnTo>
                    <a:pt x="2274443" y="716026"/>
                  </a:lnTo>
                  <a:close/>
                </a:path>
                <a:path w="4074159" h="1120775">
                  <a:moveTo>
                    <a:pt x="2332482" y="466979"/>
                  </a:moveTo>
                  <a:lnTo>
                    <a:pt x="2322068" y="466979"/>
                  </a:lnTo>
                  <a:lnTo>
                    <a:pt x="2322068" y="1120775"/>
                  </a:lnTo>
                  <a:lnTo>
                    <a:pt x="2332482" y="1120775"/>
                  </a:lnTo>
                  <a:lnTo>
                    <a:pt x="2332482" y="466979"/>
                  </a:lnTo>
                  <a:close/>
                </a:path>
                <a:path w="4074159" h="1120775">
                  <a:moveTo>
                    <a:pt x="2390521" y="498094"/>
                  </a:moveTo>
                  <a:lnTo>
                    <a:pt x="2380107" y="498094"/>
                  </a:lnTo>
                  <a:lnTo>
                    <a:pt x="2380107" y="1120775"/>
                  </a:lnTo>
                  <a:lnTo>
                    <a:pt x="2390521" y="1120775"/>
                  </a:lnTo>
                  <a:lnTo>
                    <a:pt x="2390521" y="498094"/>
                  </a:lnTo>
                  <a:close/>
                </a:path>
                <a:path w="4074159" h="1120775">
                  <a:moveTo>
                    <a:pt x="2448560" y="435864"/>
                  </a:moveTo>
                  <a:lnTo>
                    <a:pt x="2438146" y="435864"/>
                  </a:lnTo>
                  <a:lnTo>
                    <a:pt x="2438146" y="1120775"/>
                  </a:lnTo>
                  <a:lnTo>
                    <a:pt x="2448560" y="1120775"/>
                  </a:lnTo>
                  <a:lnTo>
                    <a:pt x="2448560" y="435864"/>
                  </a:lnTo>
                  <a:close/>
                </a:path>
                <a:path w="4074159" h="1120775">
                  <a:moveTo>
                    <a:pt x="2506599" y="591439"/>
                  </a:moveTo>
                  <a:lnTo>
                    <a:pt x="2496185" y="591439"/>
                  </a:lnTo>
                  <a:lnTo>
                    <a:pt x="2496185" y="1120775"/>
                  </a:lnTo>
                  <a:lnTo>
                    <a:pt x="2506599" y="1120775"/>
                  </a:lnTo>
                  <a:lnTo>
                    <a:pt x="2506599" y="591439"/>
                  </a:lnTo>
                  <a:close/>
                </a:path>
                <a:path w="4074159" h="1120775">
                  <a:moveTo>
                    <a:pt x="2564638" y="560324"/>
                  </a:moveTo>
                  <a:lnTo>
                    <a:pt x="2554224" y="560324"/>
                  </a:lnTo>
                  <a:lnTo>
                    <a:pt x="2554224" y="1120775"/>
                  </a:lnTo>
                  <a:lnTo>
                    <a:pt x="2564638" y="1120775"/>
                  </a:lnTo>
                  <a:lnTo>
                    <a:pt x="2564638" y="560324"/>
                  </a:lnTo>
                  <a:close/>
                </a:path>
                <a:path w="4074159" h="1120775">
                  <a:moveTo>
                    <a:pt x="2622677" y="155575"/>
                  </a:moveTo>
                  <a:lnTo>
                    <a:pt x="2612263" y="155575"/>
                  </a:lnTo>
                  <a:lnTo>
                    <a:pt x="2612263" y="1120775"/>
                  </a:lnTo>
                  <a:lnTo>
                    <a:pt x="2622677" y="1120775"/>
                  </a:lnTo>
                  <a:lnTo>
                    <a:pt x="2622677" y="155575"/>
                  </a:lnTo>
                  <a:close/>
                </a:path>
                <a:path w="4074159" h="1120775">
                  <a:moveTo>
                    <a:pt x="2680716" y="591439"/>
                  </a:moveTo>
                  <a:lnTo>
                    <a:pt x="2670302" y="591439"/>
                  </a:lnTo>
                  <a:lnTo>
                    <a:pt x="2670302" y="1120775"/>
                  </a:lnTo>
                  <a:lnTo>
                    <a:pt x="2680716" y="1120775"/>
                  </a:lnTo>
                  <a:lnTo>
                    <a:pt x="2680716" y="591439"/>
                  </a:lnTo>
                  <a:close/>
                </a:path>
                <a:path w="4074159" h="1120775">
                  <a:moveTo>
                    <a:pt x="2738882" y="529209"/>
                  </a:moveTo>
                  <a:lnTo>
                    <a:pt x="2728468" y="529209"/>
                  </a:lnTo>
                  <a:lnTo>
                    <a:pt x="2728468" y="1120775"/>
                  </a:lnTo>
                  <a:lnTo>
                    <a:pt x="2738882" y="1120775"/>
                  </a:lnTo>
                  <a:lnTo>
                    <a:pt x="2738882" y="529209"/>
                  </a:lnTo>
                  <a:close/>
                </a:path>
                <a:path w="4074159" h="1120775">
                  <a:moveTo>
                    <a:pt x="2796921" y="373507"/>
                  </a:moveTo>
                  <a:lnTo>
                    <a:pt x="2786507" y="373507"/>
                  </a:lnTo>
                  <a:lnTo>
                    <a:pt x="2786507" y="1120775"/>
                  </a:lnTo>
                  <a:lnTo>
                    <a:pt x="2796921" y="1120775"/>
                  </a:lnTo>
                  <a:lnTo>
                    <a:pt x="2796921" y="373507"/>
                  </a:lnTo>
                  <a:close/>
                </a:path>
                <a:path w="4074159" h="1120775">
                  <a:moveTo>
                    <a:pt x="2860154" y="716026"/>
                  </a:moveTo>
                  <a:lnTo>
                    <a:pt x="2847086" y="716026"/>
                  </a:lnTo>
                  <a:lnTo>
                    <a:pt x="2847086" y="1120775"/>
                  </a:lnTo>
                  <a:lnTo>
                    <a:pt x="2860154" y="1120775"/>
                  </a:lnTo>
                  <a:lnTo>
                    <a:pt x="2860154" y="716026"/>
                  </a:lnTo>
                  <a:close/>
                </a:path>
                <a:path w="4074159" h="1120775">
                  <a:moveTo>
                    <a:pt x="2912999" y="529209"/>
                  </a:moveTo>
                  <a:lnTo>
                    <a:pt x="2902585" y="529209"/>
                  </a:lnTo>
                  <a:lnTo>
                    <a:pt x="2902585" y="1120775"/>
                  </a:lnTo>
                  <a:lnTo>
                    <a:pt x="2912999" y="1120775"/>
                  </a:lnTo>
                  <a:lnTo>
                    <a:pt x="2912999" y="529209"/>
                  </a:lnTo>
                  <a:close/>
                </a:path>
                <a:path w="4074159" h="1120775">
                  <a:moveTo>
                    <a:pt x="2971038" y="280162"/>
                  </a:moveTo>
                  <a:lnTo>
                    <a:pt x="2960624" y="280162"/>
                  </a:lnTo>
                  <a:lnTo>
                    <a:pt x="2960624" y="1120775"/>
                  </a:lnTo>
                  <a:lnTo>
                    <a:pt x="2971038" y="1120775"/>
                  </a:lnTo>
                  <a:lnTo>
                    <a:pt x="2971038" y="280162"/>
                  </a:lnTo>
                  <a:close/>
                </a:path>
                <a:path w="4074159" h="1120775">
                  <a:moveTo>
                    <a:pt x="3029077" y="155575"/>
                  </a:moveTo>
                  <a:lnTo>
                    <a:pt x="3018663" y="155575"/>
                  </a:lnTo>
                  <a:lnTo>
                    <a:pt x="3018663" y="1120775"/>
                  </a:lnTo>
                  <a:lnTo>
                    <a:pt x="3029077" y="1120775"/>
                  </a:lnTo>
                  <a:lnTo>
                    <a:pt x="3029077" y="155575"/>
                  </a:lnTo>
                  <a:close/>
                </a:path>
                <a:path w="4074159" h="1120775">
                  <a:moveTo>
                    <a:pt x="3087116" y="466979"/>
                  </a:moveTo>
                  <a:lnTo>
                    <a:pt x="3076702" y="466979"/>
                  </a:lnTo>
                  <a:lnTo>
                    <a:pt x="3076702" y="1120775"/>
                  </a:lnTo>
                  <a:lnTo>
                    <a:pt x="3087116" y="1120775"/>
                  </a:lnTo>
                  <a:lnTo>
                    <a:pt x="3087116" y="466979"/>
                  </a:lnTo>
                  <a:close/>
                </a:path>
                <a:path w="4074159" h="1120775">
                  <a:moveTo>
                    <a:pt x="3145155" y="498094"/>
                  </a:moveTo>
                  <a:lnTo>
                    <a:pt x="3134741" y="498094"/>
                  </a:lnTo>
                  <a:lnTo>
                    <a:pt x="3134741" y="1120775"/>
                  </a:lnTo>
                  <a:lnTo>
                    <a:pt x="3145155" y="1120775"/>
                  </a:lnTo>
                  <a:lnTo>
                    <a:pt x="3145155" y="498094"/>
                  </a:lnTo>
                  <a:close/>
                </a:path>
                <a:path w="4074159" h="1120775">
                  <a:moveTo>
                    <a:pt x="3203194" y="716026"/>
                  </a:moveTo>
                  <a:lnTo>
                    <a:pt x="3192780" y="716026"/>
                  </a:lnTo>
                  <a:lnTo>
                    <a:pt x="3192780" y="1120775"/>
                  </a:lnTo>
                  <a:lnTo>
                    <a:pt x="3203194" y="1120775"/>
                  </a:lnTo>
                  <a:lnTo>
                    <a:pt x="3203194" y="716026"/>
                  </a:lnTo>
                  <a:close/>
                </a:path>
                <a:path w="4074159" h="1120775">
                  <a:moveTo>
                    <a:pt x="3261360" y="373507"/>
                  </a:moveTo>
                  <a:lnTo>
                    <a:pt x="3250946" y="373507"/>
                  </a:lnTo>
                  <a:lnTo>
                    <a:pt x="3250946" y="1120775"/>
                  </a:lnTo>
                  <a:lnTo>
                    <a:pt x="3261360" y="1120775"/>
                  </a:lnTo>
                  <a:lnTo>
                    <a:pt x="3261360" y="373507"/>
                  </a:lnTo>
                  <a:close/>
                </a:path>
                <a:path w="4074159" h="1120775">
                  <a:moveTo>
                    <a:pt x="3319399" y="498094"/>
                  </a:moveTo>
                  <a:lnTo>
                    <a:pt x="3308985" y="498094"/>
                  </a:lnTo>
                  <a:lnTo>
                    <a:pt x="3308985" y="1120775"/>
                  </a:lnTo>
                  <a:lnTo>
                    <a:pt x="3319399" y="1120775"/>
                  </a:lnTo>
                  <a:lnTo>
                    <a:pt x="3319399" y="498094"/>
                  </a:lnTo>
                  <a:close/>
                </a:path>
                <a:path w="4074159" h="1120775">
                  <a:moveTo>
                    <a:pt x="3377438" y="498094"/>
                  </a:moveTo>
                  <a:lnTo>
                    <a:pt x="3367024" y="498094"/>
                  </a:lnTo>
                  <a:lnTo>
                    <a:pt x="3367024" y="1120775"/>
                  </a:lnTo>
                  <a:lnTo>
                    <a:pt x="3377438" y="1120775"/>
                  </a:lnTo>
                  <a:lnTo>
                    <a:pt x="3377438" y="498094"/>
                  </a:lnTo>
                  <a:close/>
                </a:path>
                <a:path w="4074159" h="1120775">
                  <a:moveTo>
                    <a:pt x="3435477" y="435864"/>
                  </a:moveTo>
                  <a:lnTo>
                    <a:pt x="3425063" y="435864"/>
                  </a:lnTo>
                  <a:lnTo>
                    <a:pt x="3425063" y="1120775"/>
                  </a:lnTo>
                  <a:lnTo>
                    <a:pt x="3435477" y="1120775"/>
                  </a:lnTo>
                  <a:lnTo>
                    <a:pt x="3435477" y="435864"/>
                  </a:lnTo>
                  <a:close/>
                </a:path>
                <a:path w="4074159" h="1120775">
                  <a:moveTo>
                    <a:pt x="3493516" y="466979"/>
                  </a:moveTo>
                  <a:lnTo>
                    <a:pt x="3483102" y="466979"/>
                  </a:lnTo>
                  <a:lnTo>
                    <a:pt x="3483102" y="1120775"/>
                  </a:lnTo>
                  <a:lnTo>
                    <a:pt x="3493516" y="1120775"/>
                  </a:lnTo>
                  <a:lnTo>
                    <a:pt x="3493516" y="466979"/>
                  </a:lnTo>
                  <a:close/>
                </a:path>
                <a:path w="4074159" h="1120775">
                  <a:moveTo>
                    <a:pt x="3551555" y="653796"/>
                  </a:moveTo>
                  <a:lnTo>
                    <a:pt x="3541141" y="653796"/>
                  </a:lnTo>
                  <a:lnTo>
                    <a:pt x="3541141" y="1120775"/>
                  </a:lnTo>
                  <a:lnTo>
                    <a:pt x="3551555" y="1120775"/>
                  </a:lnTo>
                  <a:lnTo>
                    <a:pt x="3551555" y="653796"/>
                  </a:lnTo>
                  <a:close/>
                </a:path>
                <a:path w="4074159" h="1120775">
                  <a:moveTo>
                    <a:pt x="3609594" y="373507"/>
                  </a:moveTo>
                  <a:lnTo>
                    <a:pt x="3599180" y="373507"/>
                  </a:lnTo>
                  <a:lnTo>
                    <a:pt x="3599180" y="1120775"/>
                  </a:lnTo>
                  <a:lnTo>
                    <a:pt x="3609594" y="1120775"/>
                  </a:lnTo>
                  <a:lnTo>
                    <a:pt x="3609594" y="373507"/>
                  </a:lnTo>
                  <a:close/>
                </a:path>
                <a:path w="4074159" h="1120775">
                  <a:moveTo>
                    <a:pt x="3667633" y="186690"/>
                  </a:moveTo>
                  <a:lnTo>
                    <a:pt x="3657219" y="186690"/>
                  </a:lnTo>
                  <a:lnTo>
                    <a:pt x="3657219" y="1120775"/>
                  </a:lnTo>
                  <a:lnTo>
                    <a:pt x="3667633" y="1120775"/>
                  </a:lnTo>
                  <a:lnTo>
                    <a:pt x="3667633" y="186690"/>
                  </a:lnTo>
                  <a:close/>
                </a:path>
                <a:path w="4074159" h="1120775">
                  <a:moveTo>
                    <a:pt x="3725672" y="249047"/>
                  </a:moveTo>
                  <a:lnTo>
                    <a:pt x="3715258" y="249047"/>
                  </a:lnTo>
                  <a:lnTo>
                    <a:pt x="3715258" y="1120775"/>
                  </a:lnTo>
                  <a:lnTo>
                    <a:pt x="3725672" y="1120775"/>
                  </a:lnTo>
                  <a:lnTo>
                    <a:pt x="3725672" y="249047"/>
                  </a:lnTo>
                  <a:close/>
                </a:path>
                <a:path w="4074159" h="1120775">
                  <a:moveTo>
                    <a:pt x="3783838" y="529209"/>
                  </a:moveTo>
                  <a:lnTo>
                    <a:pt x="3773424" y="529209"/>
                  </a:lnTo>
                  <a:lnTo>
                    <a:pt x="3773424" y="1120775"/>
                  </a:lnTo>
                  <a:lnTo>
                    <a:pt x="3783838" y="1120775"/>
                  </a:lnTo>
                  <a:lnTo>
                    <a:pt x="3783838" y="529209"/>
                  </a:lnTo>
                  <a:close/>
                </a:path>
                <a:path w="4074159" h="1120775">
                  <a:moveTo>
                    <a:pt x="3841877" y="591439"/>
                  </a:moveTo>
                  <a:lnTo>
                    <a:pt x="3831463" y="591439"/>
                  </a:lnTo>
                  <a:lnTo>
                    <a:pt x="3831463" y="1120775"/>
                  </a:lnTo>
                  <a:lnTo>
                    <a:pt x="3841877" y="1120775"/>
                  </a:lnTo>
                  <a:lnTo>
                    <a:pt x="3841877" y="591439"/>
                  </a:lnTo>
                  <a:close/>
                </a:path>
                <a:path w="4074159" h="1120775">
                  <a:moveTo>
                    <a:pt x="3899916" y="653796"/>
                  </a:moveTo>
                  <a:lnTo>
                    <a:pt x="3889502" y="653796"/>
                  </a:lnTo>
                  <a:lnTo>
                    <a:pt x="3889502" y="1120775"/>
                  </a:lnTo>
                  <a:lnTo>
                    <a:pt x="3899916" y="1120775"/>
                  </a:lnTo>
                  <a:lnTo>
                    <a:pt x="3899916" y="653796"/>
                  </a:lnTo>
                  <a:close/>
                </a:path>
                <a:path w="4074159" h="1120775">
                  <a:moveTo>
                    <a:pt x="3957955" y="716026"/>
                  </a:moveTo>
                  <a:lnTo>
                    <a:pt x="3947541" y="716026"/>
                  </a:lnTo>
                  <a:lnTo>
                    <a:pt x="3947541" y="1120775"/>
                  </a:lnTo>
                  <a:lnTo>
                    <a:pt x="3957955" y="1120775"/>
                  </a:lnTo>
                  <a:lnTo>
                    <a:pt x="3957955" y="716026"/>
                  </a:lnTo>
                  <a:close/>
                </a:path>
                <a:path w="4074159" h="1120775">
                  <a:moveTo>
                    <a:pt x="4015994" y="404749"/>
                  </a:moveTo>
                  <a:lnTo>
                    <a:pt x="4005580" y="404749"/>
                  </a:lnTo>
                  <a:lnTo>
                    <a:pt x="4005580" y="1120775"/>
                  </a:lnTo>
                  <a:lnTo>
                    <a:pt x="4015994" y="1120775"/>
                  </a:lnTo>
                  <a:lnTo>
                    <a:pt x="4015994" y="404749"/>
                  </a:lnTo>
                  <a:close/>
                </a:path>
                <a:path w="4074159" h="1120775">
                  <a:moveTo>
                    <a:pt x="4074033" y="684911"/>
                  </a:moveTo>
                  <a:lnTo>
                    <a:pt x="4063619" y="684911"/>
                  </a:lnTo>
                  <a:lnTo>
                    <a:pt x="4063619" y="1120775"/>
                  </a:lnTo>
                  <a:lnTo>
                    <a:pt x="4074033" y="1120775"/>
                  </a:lnTo>
                  <a:lnTo>
                    <a:pt x="4074033" y="684911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8" name="object 108" descr=""/>
            <p:cNvSpPr/>
            <p:nvPr/>
          </p:nvSpPr>
          <p:spPr>
            <a:xfrm>
              <a:off x="9262491" y="7728331"/>
              <a:ext cx="4079875" cy="934085"/>
            </a:xfrm>
            <a:custGeom>
              <a:avLst/>
              <a:gdLst/>
              <a:ahLst/>
              <a:cxnLst/>
              <a:rect l="l" t="t" r="r" b="b"/>
              <a:pathLst>
                <a:path w="4079875" h="934084">
                  <a:moveTo>
                    <a:pt x="10414" y="498221"/>
                  </a:moveTo>
                  <a:lnTo>
                    <a:pt x="0" y="498221"/>
                  </a:lnTo>
                  <a:lnTo>
                    <a:pt x="0" y="934085"/>
                  </a:lnTo>
                  <a:lnTo>
                    <a:pt x="10414" y="934085"/>
                  </a:lnTo>
                  <a:lnTo>
                    <a:pt x="10414" y="498221"/>
                  </a:lnTo>
                  <a:close/>
                </a:path>
                <a:path w="4079875" h="934084">
                  <a:moveTo>
                    <a:pt x="68453" y="124587"/>
                  </a:moveTo>
                  <a:lnTo>
                    <a:pt x="58039" y="124587"/>
                  </a:lnTo>
                  <a:lnTo>
                    <a:pt x="58039" y="934085"/>
                  </a:lnTo>
                  <a:lnTo>
                    <a:pt x="68453" y="934085"/>
                  </a:lnTo>
                  <a:lnTo>
                    <a:pt x="68453" y="124587"/>
                  </a:lnTo>
                  <a:close/>
                </a:path>
                <a:path w="4079875" h="934084">
                  <a:moveTo>
                    <a:pt x="126492" y="218059"/>
                  </a:moveTo>
                  <a:lnTo>
                    <a:pt x="116078" y="218059"/>
                  </a:lnTo>
                  <a:lnTo>
                    <a:pt x="116078" y="934085"/>
                  </a:lnTo>
                  <a:lnTo>
                    <a:pt x="126492" y="934085"/>
                  </a:lnTo>
                  <a:lnTo>
                    <a:pt x="126492" y="218059"/>
                  </a:lnTo>
                  <a:close/>
                </a:path>
                <a:path w="4079875" h="934084">
                  <a:moveTo>
                    <a:pt x="184531" y="404749"/>
                  </a:moveTo>
                  <a:lnTo>
                    <a:pt x="174117" y="404749"/>
                  </a:lnTo>
                  <a:lnTo>
                    <a:pt x="174117" y="934085"/>
                  </a:lnTo>
                  <a:lnTo>
                    <a:pt x="184531" y="934085"/>
                  </a:lnTo>
                  <a:lnTo>
                    <a:pt x="184531" y="404749"/>
                  </a:lnTo>
                  <a:close/>
                </a:path>
                <a:path w="4079875" h="934084">
                  <a:moveTo>
                    <a:pt x="242570" y="249174"/>
                  </a:moveTo>
                  <a:lnTo>
                    <a:pt x="232156" y="249174"/>
                  </a:lnTo>
                  <a:lnTo>
                    <a:pt x="232156" y="934085"/>
                  </a:lnTo>
                  <a:lnTo>
                    <a:pt x="242570" y="934085"/>
                  </a:lnTo>
                  <a:lnTo>
                    <a:pt x="242570" y="249174"/>
                  </a:lnTo>
                  <a:close/>
                </a:path>
                <a:path w="4079875" h="934084">
                  <a:moveTo>
                    <a:pt x="300736" y="280289"/>
                  </a:moveTo>
                  <a:lnTo>
                    <a:pt x="290322" y="280289"/>
                  </a:lnTo>
                  <a:lnTo>
                    <a:pt x="290322" y="934085"/>
                  </a:lnTo>
                  <a:lnTo>
                    <a:pt x="300736" y="934085"/>
                  </a:lnTo>
                  <a:lnTo>
                    <a:pt x="300736" y="280289"/>
                  </a:lnTo>
                  <a:close/>
                </a:path>
                <a:path w="4079875" h="934084">
                  <a:moveTo>
                    <a:pt x="358775" y="0"/>
                  </a:moveTo>
                  <a:lnTo>
                    <a:pt x="348361" y="0"/>
                  </a:lnTo>
                  <a:lnTo>
                    <a:pt x="348361" y="934085"/>
                  </a:lnTo>
                  <a:lnTo>
                    <a:pt x="358775" y="934085"/>
                  </a:lnTo>
                  <a:lnTo>
                    <a:pt x="358775" y="0"/>
                  </a:lnTo>
                  <a:close/>
                </a:path>
                <a:path w="4079875" h="934084">
                  <a:moveTo>
                    <a:pt x="416814" y="124587"/>
                  </a:moveTo>
                  <a:lnTo>
                    <a:pt x="406400" y="124587"/>
                  </a:lnTo>
                  <a:lnTo>
                    <a:pt x="406400" y="934085"/>
                  </a:lnTo>
                  <a:lnTo>
                    <a:pt x="416814" y="934085"/>
                  </a:lnTo>
                  <a:lnTo>
                    <a:pt x="416814" y="124587"/>
                  </a:lnTo>
                  <a:close/>
                </a:path>
                <a:path w="4079875" h="934084">
                  <a:moveTo>
                    <a:pt x="474853" y="31242"/>
                  </a:moveTo>
                  <a:lnTo>
                    <a:pt x="464439" y="31242"/>
                  </a:lnTo>
                  <a:lnTo>
                    <a:pt x="464439" y="934085"/>
                  </a:lnTo>
                  <a:lnTo>
                    <a:pt x="474853" y="934085"/>
                  </a:lnTo>
                  <a:lnTo>
                    <a:pt x="474853" y="31242"/>
                  </a:lnTo>
                  <a:close/>
                </a:path>
                <a:path w="4079875" h="934084">
                  <a:moveTo>
                    <a:pt x="532892" y="280289"/>
                  </a:moveTo>
                  <a:lnTo>
                    <a:pt x="522478" y="280289"/>
                  </a:lnTo>
                  <a:lnTo>
                    <a:pt x="522478" y="934085"/>
                  </a:lnTo>
                  <a:lnTo>
                    <a:pt x="532892" y="934085"/>
                  </a:lnTo>
                  <a:lnTo>
                    <a:pt x="532892" y="280289"/>
                  </a:lnTo>
                  <a:close/>
                </a:path>
                <a:path w="4079875" h="934084">
                  <a:moveTo>
                    <a:pt x="590931" y="498221"/>
                  </a:moveTo>
                  <a:lnTo>
                    <a:pt x="580517" y="498221"/>
                  </a:lnTo>
                  <a:lnTo>
                    <a:pt x="580517" y="934085"/>
                  </a:lnTo>
                  <a:lnTo>
                    <a:pt x="590931" y="934085"/>
                  </a:lnTo>
                  <a:lnTo>
                    <a:pt x="590931" y="498221"/>
                  </a:lnTo>
                  <a:close/>
                </a:path>
                <a:path w="4079875" h="934084">
                  <a:moveTo>
                    <a:pt x="648970" y="280289"/>
                  </a:moveTo>
                  <a:lnTo>
                    <a:pt x="638556" y="280289"/>
                  </a:lnTo>
                  <a:lnTo>
                    <a:pt x="638556" y="934085"/>
                  </a:lnTo>
                  <a:lnTo>
                    <a:pt x="648970" y="934085"/>
                  </a:lnTo>
                  <a:lnTo>
                    <a:pt x="648970" y="280289"/>
                  </a:lnTo>
                  <a:close/>
                </a:path>
                <a:path w="4079875" h="934084">
                  <a:moveTo>
                    <a:pt x="707009" y="467106"/>
                  </a:moveTo>
                  <a:lnTo>
                    <a:pt x="696595" y="467106"/>
                  </a:lnTo>
                  <a:lnTo>
                    <a:pt x="696595" y="934085"/>
                  </a:lnTo>
                  <a:lnTo>
                    <a:pt x="707009" y="934085"/>
                  </a:lnTo>
                  <a:lnTo>
                    <a:pt x="707009" y="467106"/>
                  </a:lnTo>
                  <a:close/>
                </a:path>
                <a:path w="4079875" h="934084">
                  <a:moveTo>
                    <a:pt x="765048" y="311404"/>
                  </a:moveTo>
                  <a:lnTo>
                    <a:pt x="754634" y="311404"/>
                  </a:lnTo>
                  <a:lnTo>
                    <a:pt x="754634" y="934085"/>
                  </a:lnTo>
                  <a:lnTo>
                    <a:pt x="765048" y="934085"/>
                  </a:lnTo>
                  <a:lnTo>
                    <a:pt x="765048" y="311404"/>
                  </a:lnTo>
                  <a:close/>
                </a:path>
                <a:path w="4079875" h="934084">
                  <a:moveTo>
                    <a:pt x="828421" y="622681"/>
                  </a:moveTo>
                  <a:lnTo>
                    <a:pt x="815340" y="622681"/>
                  </a:lnTo>
                  <a:lnTo>
                    <a:pt x="815340" y="934085"/>
                  </a:lnTo>
                  <a:lnTo>
                    <a:pt x="828421" y="934085"/>
                  </a:lnTo>
                  <a:lnTo>
                    <a:pt x="828421" y="622681"/>
                  </a:lnTo>
                  <a:close/>
                </a:path>
                <a:path w="4079875" h="934084">
                  <a:moveTo>
                    <a:pt x="881253" y="311404"/>
                  </a:moveTo>
                  <a:lnTo>
                    <a:pt x="870839" y="311404"/>
                  </a:lnTo>
                  <a:lnTo>
                    <a:pt x="870839" y="934085"/>
                  </a:lnTo>
                  <a:lnTo>
                    <a:pt x="881253" y="934085"/>
                  </a:lnTo>
                  <a:lnTo>
                    <a:pt x="881253" y="311404"/>
                  </a:lnTo>
                  <a:close/>
                </a:path>
                <a:path w="4079875" h="934084">
                  <a:moveTo>
                    <a:pt x="939292" y="342519"/>
                  </a:moveTo>
                  <a:lnTo>
                    <a:pt x="928878" y="342519"/>
                  </a:lnTo>
                  <a:lnTo>
                    <a:pt x="928878" y="934085"/>
                  </a:lnTo>
                  <a:lnTo>
                    <a:pt x="939292" y="934085"/>
                  </a:lnTo>
                  <a:lnTo>
                    <a:pt x="939292" y="342519"/>
                  </a:lnTo>
                  <a:close/>
                </a:path>
                <a:path w="4079875" h="934084">
                  <a:moveTo>
                    <a:pt x="997331" y="467106"/>
                  </a:moveTo>
                  <a:lnTo>
                    <a:pt x="986917" y="467106"/>
                  </a:lnTo>
                  <a:lnTo>
                    <a:pt x="986917" y="934085"/>
                  </a:lnTo>
                  <a:lnTo>
                    <a:pt x="997331" y="934085"/>
                  </a:lnTo>
                  <a:lnTo>
                    <a:pt x="997331" y="467106"/>
                  </a:lnTo>
                  <a:close/>
                </a:path>
                <a:path w="4079875" h="934084">
                  <a:moveTo>
                    <a:pt x="1055370" y="435991"/>
                  </a:moveTo>
                  <a:lnTo>
                    <a:pt x="1044956" y="435991"/>
                  </a:lnTo>
                  <a:lnTo>
                    <a:pt x="1044956" y="934085"/>
                  </a:lnTo>
                  <a:lnTo>
                    <a:pt x="1055370" y="934085"/>
                  </a:lnTo>
                  <a:lnTo>
                    <a:pt x="1055370" y="435991"/>
                  </a:lnTo>
                  <a:close/>
                </a:path>
                <a:path w="4079875" h="934084">
                  <a:moveTo>
                    <a:pt x="1113409" y="467106"/>
                  </a:moveTo>
                  <a:lnTo>
                    <a:pt x="1102995" y="467106"/>
                  </a:lnTo>
                  <a:lnTo>
                    <a:pt x="1102995" y="934085"/>
                  </a:lnTo>
                  <a:lnTo>
                    <a:pt x="1113409" y="934085"/>
                  </a:lnTo>
                  <a:lnTo>
                    <a:pt x="1113409" y="467106"/>
                  </a:lnTo>
                  <a:close/>
                </a:path>
                <a:path w="4079875" h="934084">
                  <a:moveTo>
                    <a:pt x="1171448" y="155702"/>
                  </a:moveTo>
                  <a:lnTo>
                    <a:pt x="1161034" y="155702"/>
                  </a:lnTo>
                  <a:lnTo>
                    <a:pt x="1161034" y="934085"/>
                  </a:lnTo>
                  <a:lnTo>
                    <a:pt x="1171448" y="934085"/>
                  </a:lnTo>
                  <a:lnTo>
                    <a:pt x="1171448" y="155702"/>
                  </a:lnTo>
                  <a:close/>
                </a:path>
                <a:path w="4079875" h="934084">
                  <a:moveTo>
                    <a:pt x="1229487" y="155702"/>
                  </a:moveTo>
                  <a:lnTo>
                    <a:pt x="1219073" y="155702"/>
                  </a:lnTo>
                  <a:lnTo>
                    <a:pt x="1219073" y="934085"/>
                  </a:lnTo>
                  <a:lnTo>
                    <a:pt x="1229487" y="934085"/>
                  </a:lnTo>
                  <a:lnTo>
                    <a:pt x="1229487" y="155702"/>
                  </a:lnTo>
                  <a:close/>
                </a:path>
                <a:path w="4079875" h="934084">
                  <a:moveTo>
                    <a:pt x="1292860" y="653923"/>
                  </a:moveTo>
                  <a:lnTo>
                    <a:pt x="1279779" y="653923"/>
                  </a:lnTo>
                  <a:lnTo>
                    <a:pt x="1279779" y="934085"/>
                  </a:lnTo>
                  <a:lnTo>
                    <a:pt x="1292860" y="934085"/>
                  </a:lnTo>
                  <a:lnTo>
                    <a:pt x="1292860" y="653923"/>
                  </a:lnTo>
                  <a:close/>
                </a:path>
                <a:path w="4079875" h="934084">
                  <a:moveTo>
                    <a:pt x="1345692" y="373634"/>
                  </a:moveTo>
                  <a:lnTo>
                    <a:pt x="1335278" y="373634"/>
                  </a:lnTo>
                  <a:lnTo>
                    <a:pt x="1335278" y="934085"/>
                  </a:lnTo>
                  <a:lnTo>
                    <a:pt x="1345692" y="934085"/>
                  </a:lnTo>
                  <a:lnTo>
                    <a:pt x="1345692" y="373634"/>
                  </a:lnTo>
                  <a:close/>
                </a:path>
                <a:path w="4079875" h="934084">
                  <a:moveTo>
                    <a:pt x="1403731" y="435991"/>
                  </a:moveTo>
                  <a:lnTo>
                    <a:pt x="1393317" y="435991"/>
                  </a:lnTo>
                  <a:lnTo>
                    <a:pt x="1393317" y="934085"/>
                  </a:lnTo>
                  <a:lnTo>
                    <a:pt x="1403731" y="934085"/>
                  </a:lnTo>
                  <a:lnTo>
                    <a:pt x="1403731" y="435991"/>
                  </a:lnTo>
                  <a:close/>
                </a:path>
                <a:path w="4079875" h="934084">
                  <a:moveTo>
                    <a:pt x="1461770" y="498221"/>
                  </a:moveTo>
                  <a:lnTo>
                    <a:pt x="1451356" y="498221"/>
                  </a:lnTo>
                  <a:lnTo>
                    <a:pt x="1451356" y="934085"/>
                  </a:lnTo>
                  <a:lnTo>
                    <a:pt x="1461770" y="934085"/>
                  </a:lnTo>
                  <a:lnTo>
                    <a:pt x="1461770" y="498221"/>
                  </a:lnTo>
                  <a:close/>
                </a:path>
                <a:path w="4079875" h="934084">
                  <a:moveTo>
                    <a:pt x="1519809" y="404749"/>
                  </a:moveTo>
                  <a:lnTo>
                    <a:pt x="1509395" y="404749"/>
                  </a:lnTo>
                  <a:lnTo>
                    <a:pt x="1509395" y="934085"/>
                  </a:lnTo>
                  <a:lnTo>
                    <a:pt x="1519809" y="934085"/>
                  </a:lnTo>
                  <a:lnTo>
                    <a:pt x="1519809" y="404749"/>
                  </a:lnTo>
                  <a:close/>
                </a:path>
                <a:path w="4079875" h="934084">
                  <a:moveTo>
                    <a:pt x="1577848" y="591566"/>
                  </a:moveTo>
                  <a:lnTo>
                    <a:pt x="1567434" y="591566"/>
                  </a:lnTo>
                  <a:lnTo>
                    <a:pt x="1567434" y="934085"/>
                  </a:lnTo>
                  <a:lnTo>
                    <a:pt x="1577848" y="934085"/>
                  </a:lnTo>
                  <a:lnTo>
                    <a:pt x="1577848" y="591566"/>
                  </a:lnTo>
                  <a:close/>
                </a:path>
                <a:path w="4079875" h="934084">
                  <a:moveTo>
                    <a:pt x="1635887" y="311404"/>
                  </a:moveTo>
                  <a:lnTo>
                    <a:pt x="1625473" y="311404"/>
                  </a:lnTo>
                  <a:lnTo>
                    <a:pt x="1625473" y="934085"/>
                  </a:lnTo>
                  <a:lnTo>
                    <a:pt x="1635887" y="934085"/>
                  </a:lnTo>
                  <a:lnTo>
                    <a:pt x="1635887" y="311404"/>
                  </a:lnTo>
                  <a:close/>
                </a:path>
                <a:path w="4079875" h="934084">
                  <a:moveTo>
                    <a:pt x="1693926" y="311404"/>
                  </a:moveTo>
                  <a:lnTo>
                    <a:pt x="1683512" y="311404"/>
                  </a:lnTo>
                  <a:lnTo>
                    <a:pt x="1683512" y="934085"/>
                  </a:lnTo>
                  <a:lnTo>
                    <a:pt x="1693926" y="934085"/>
                  </a:lnTo>
                  <a:lnTo>
                    <a:pt x="1693926" y="311404"/>
                  </a:lnTo>
                  <a:close/>
                </a:path>
                <a:path w="4079875" h="934084">
                  <a:moveTo>
                    <a:pt x="1751965" y="218059"/>
                  </a:moveTo>
                  <a:lnTo>
                    <a:pt x="1741551" y="218059"/>
                  </a:lnTo>
                  <a:lnTo>
                    <a:pt x="1741551" y="934085"/>
                  </a:lnTo>
                  <a:lnTo>
                    <a:pt x="1751965" y="934085"/>
                  </a:lnTo>
                  <a:lnTo>
                    <a:pt x="1751965" y="218059"/>
                  </a:lnTo>
                  <a:close/>
                </a:path>
                <a:path w="4079875" h="934084">
                  <a:moveTo>
                    <a:pt x="1810004" y="529336"/>
                  </a:moveTo>
                  <a:lnTo>
                    <a:pt x="1799590" y="529336"/>
                  </a:lnTo>
                  <a:lnTo>
                    <a:pt x="1799590" y="934085"/>
                  </a:lnTo>
                  <a:lnTo>
                    <a:pt x="1810004" y="934085"/>
                  </a:lnTo>
                  <a:lnTo>
                    <a:pt x="1810004" y="529336"/>
                  </a:lnTo>
                  <a:close/>
                </a:path>
                <a:path w="4079875" h="934084">
                  <a:moveTo>
                    <a:pt x="1873364" y="467106"/>
                  </a:moveTo>
                  <a:lnTo>
                    <a:pt x="1860296" y="467106"/>
                  </a:lnTo>
                  <a:lnTo>
                    <a:pt x="1860296" y="934085"/>
                  </a:lnTo>
                  <a:lnTo>
                    <a:pt x="1873364" y="934085"/>
                  </a:lnTo>
                  <a:lnTo>
                    <a:pt x="1873364" y="467106"/>
                  </a:lnTo>
                  <a:close/>
                </a:path>
                <a:path w="4079875" h="934084">
                  <a:moveTo>
                    <a:pt x="1926209" y="311404"/>
                  </a:moveTo>
                  <a:lnTo>
                    <a:pt x="1915795" y="311404"/>
                  </a:lnTo>
                  <a:lnTo>
                    <a:pt x="1915795" y="934085"/>
                  </a:lnTo>
                  <a:lnTo>
                    <a:pt x="1926209" y="934085"/>
                  </a:lnTo>
                  <a:lnTo>
                    <a:pt x="1926209" y="311404"/>
                  </a:lnTo>
                  <a:close/>
                </a:path>
                <a:path w="4079875" h="934084">
                  <a:moveTo>
                    <a:pt x="1984248" y="404749"/>
                  </a:moveTo>
                  <a:lnTo>
                    <a:pt x="1973834" y="404749"/>
                  </a:lnTo>
                  <a:lnTo>
                    <a:pt x="1973834" y="934085"/>
                  </a:lnTo>
                  <a:lnTo>
                    <a:pt x="1984248" y="934085"/>
                  </a:lnTo>
                  <a:lnTo>
                    <a:pt x="1984248" y="404749"/>
                  </a:lnTo>
                  <a:close/>
                </a:path>
                <a:path w="4079875" h="934084">
                  <a:moveTo>
                    <a:pt x="2042287" y="311404"/>
                  </a:moveTo>
                  <a:lnTo>
                    <a:pt x="2031873" y="311404"/>
                  </a:lnTo>
                  <a:lnTo>
                    <a:pt x="2031873" y="934085"/>
                  </a:lnTo>
                  <a:lnTo>
                    <a:pt x="2042287" y="934085"/>
                  </a:lnTo>
                  <a:lnTo>
                    <a:pt x="2042287" y="311404"/>
                  </a:lnTo>
                  <a:close/>
                </a:path>
                <a:path w="4079875" h="934084">
                  <a:moveTo>
                    <a:pt x="2100326" y="622681"/>
                  </a:moveTo>
                  <a:lnTo>
                    <a:pt x="2089912" y="622681"/>
                  </a:lnTo>
                  <a:lnTo>
                    <a:pt x="2089912" y="934085"/>
                  </a:lnTo>
                  <a:lnTo>
                    <a:pt x="2100326" y="934085"/>
                  </a:lnTo>
                  <a:lnTo>
                    <a:pt x="2100326" y="622681"/>
                  </a:lnTo>
                  <a:close/>
                </a:path>
                <a:path w="4079875" h="934084">
                  <a:moveTo>
                    <a:pt x="2158365" y="93472"/>
                  </a:moveTo>
                  <a:lnTo>
                    <a:pt x="2147951" y="93472"/>
                  </a:lnTo>
                  <a:lnTo>
                    <a:pt x="2147951" y="934085"/>
                  </a:lnTo>
                  <a:lnTo>
                    <a:pt x="2158365" y="934085"/>
                  </a:lnTo>
                  <a:lnTo>
                    <a:pt x="2158365" y="93472"/>
                  </a:lnTo>
                  <a:close/>
                </a:path>
                <a:path w="4079875" h="934084">
                  <a:moveTo>
                    <a:pt x="2216404" y="404749"/>
                  </a:moveTo>
                  <a:lnTo>
                    <a:pt x="2205990" y="404749"/>
                  </a:lnTo>
                  <a:lnTo>
                    <a:pt x="2205990" y="934085"/>
                  </a:lnTo>
                  <a:lnTo>
                    <a:pt x="2216404" y="934085"/>
                  </a:lnTo>
                  <a:lnTo>
                    <a:pt x="2216404" y="404749"/>
                  </a:lnTo>
                  <a:close/>
                </a:path>
                <a:path w="4079875" h="934084">
                  <a:moveTo>
                    <a:pt x="2274443" y="653923"/>
                  </a:moveTo>
                  <a:lnTo>
                    <a:pt x="2264029" y="653923"/>
                  </a:lnTo>
                  <a:lnTo>
                    <a:pt x="2264029" y="934085"/>
                  </a:lnTo>
                  <a:lnTo>
                    <a:pt x="2274443" y="934085"/>
                  </a:lnTo>
                  <a:lnTo>
                    <a:pt x="2274443" y="653923"/>
                  </a:lnTo>
                  <a:close/>
                </a:path>
                <a:path w="4079875" h="934084">
                  <a:moveTo>
                    <a:pt x="2332482" y="653923"/>
                  </a:moveTo>
                  <a:lnTo>
                    <a:pt x="2322068" y="653923"/>
                  </a:lnTo>
                  <a:lnTo>
                    <a:pt x="2322068" y="934085"/>
                  </a:lnTo>
                  <a:lnTo>
                    <a:pt x="2332482" y="934085"/>
                  </a:lnTo>
                  <a:lnTo>
                    <a:pt x="2332482" y="653923"/>
                  </a:lnTo>
                  <a:close/>
                </a:path>
                <a:path w="4079875" h="934084">
                  <a:moveTo>
                    <a:pt x="2390521" y="404749"/>
                  </a:moveTo>
                  <a:lnTo>
                    <a:pt x="2380107" y="404749"/>
                  </a:lnTo>
                  <a:lnTo>
                    <a:pt x="2380107" y="934085"/>
                  </a:lnTo>
                  <a:lnTo>
                    <a:pt x="2390521" y="934085"/>
                  </a:lnTo>
                  <a:lnTo>
                    <a:pt x="2390521" y="404749"/>
                  </a:lnTo>
                  <a:close/>
                </a:path>
                <a:path w="4079875" h="934084">
                  <a:moveTo>
                    <a:pt x="2453894" y="560451"/>
                  </a:moveTo>
                  <a:lnTo>
                    <a:pt x="2440813" y="560451"/>
                  </a:lnTo>
                  <a:lnTo>
                    <a:pt x="2440813" y="934085"/>
                  </a:lnTo>
                  <a:lnTo>
                    <a:pt x="2453894" y="934085"/>
                  </a:lnTo>
                  <a:lnTo>
                    <a:pt x="2453894" y="560451"/>
                  </a:lnTo>
                  <a:close/>
                </a:path>
                <a:path w="4079875" h="934084">
                  <a:moveTo>
                    <a:pt x="2506726" y="467106"/>
                  </a:moveTo>
                  <a:lnTo>
                    <a:pt x="2496312" y="467106"/>
                  </a:lnTo>
                  <a:lnTo>
                    <a:pt x="2496312" y="934085"/>
                  </a:lnTo>
                  <a:lnTo>
                    <a:pt x="2506726" y="934085"/>
                  </a:lnTo>
                  <a:lnTo>
                    <a:pt x="2506726" y="467106"/>
                  </a:lnTo>
                  <a:close/>
                </a:path>
                <a:path w="4079875" h="934084">
                  <a:moveTo>
                    <a:pt x="2564765" y="591566"/>
                  </a:moveTo>
                  <a:lnTo>
                    <a:pt x="2554351" y="591566"/>
                  </a:lnTo>
                  <a:lnTo>
                    <a:pt x="2554351" y="934085"/>
                  </a:lnTo>
                  <a:lnTo>
                    <a:pt x="2564765" y="934085"/>
                  </a:lnTo>
                  <a:lnTo>
                    <a:pt x="2564765" y="591566"/>
                  </a:lnTo>
                  <a:close/>
                </a:path>
                <a:path w="4079875" h="934084">
                  <a:moveTo>
                    <a:pt x="2628011" y="778383"/>
                  </a:moveTo>
                  <a:lnTo>
                    <a:pt x="2614930" y="778383"/>
                  </a:lnTo>
                  <a:lnTo>
                    <a:pt x="2614930" y="934085"/>
                  </a:lnTo>
                  <a:lnTo>
                    <a:pt x="2628011" y="934085"/>
                  </a:lnTo>
                  <a:lnTo>
                    <a:pt x="2628011" y="778383"/>
                  </a:lnTo>
                  <a:close/>
                </a:path>
                <a:path w="4079875" h="934084">
                  <a:moveTo>
                    <a:pt x="2680843" y="716153"/>
                  </a:moveTo>
                  <a:lnTo>
                    <a:pt x="2670429" y="716153"/>
                  </a:lnTo>
                  <a:lnTo>
                    <a:pt x="2670429" y="934085"/>
                  </a:lnTo>
                  <a:lnTo>
                    <a:pt x="2680843" y="934085"/>
                  </a:lnTo>
                  <a:lnTo>
                    <a:pt x="2680843" y="716153"/>
                  </a:lnTo>
                  <a:close/>
                </a:path>
                <a:path w="4079875" h="934084">
                  <a:moveTo>
                    <a:pt x="2738882" y="653923"/>
                  </a:moveTo>
                  <a:lnTo>
                    <a:pt x="2728468" y="653923"/>
                  </a:lnTo>
                  <a:lnTo>
                    <a:pt x="2728468" y="934085"/>
                  </a:lnTo>
                  <a:lnTo>
                    <a:pt x="2738882" y="934085"/>
                  </a:lnTo>
                  <a:lnTo>
                    <a:pt x="2738882" y="653923"/>
                  </a:lnTo>
                  <a:close/>
                </a:path>
                <a:path w="4079875" h="934084">
                  <a:moveTo>
                    <a:pt x="2796921" y="653923"/>
                  </a:moveTo>
                  <a:lnTo>
                    <a:pt x="2786507" y="653923"/>
                  </a:lnTo>
                  <a:lnTo>
                    <a:pt x="2786507" y="934085"/>
                  </a:lnTo>
                  <a:lnTo>
                    <a:pt x="2796921" y="934085"/>
                  </a:lnTo>
                  <a:lnTo>
                    <a:pt x="2796921" y="653923"/>
                  </a:lnTo>
                  <a:close/>
                </a:path>
                <a:path w="4079875" h="934084">
                  <a:moveTo>
                    <a:pt x="2860294" y="653923"/>
                  </a:moveTo>
                  <a:lnTo>
                    <a:pt x="2847213" y="653923"/>
                  </a:lnTo>
                  <a:lnTo>
                    <a:pt x="2847213" y="934085"/>
                  </a:lnTo>
                  <a:lnTo>
                    <a:pt x="2860294" y="934085"/>
                  </a:lnTo>
                  <a:lnTo>
                    <a:pt x="2860294" y="653923"/>
                  </a:lnTo>
                  <a:close/>
                </a:path>
                <a:path w="4079875" h="934084">
                  <a:moveTo>
                    <a:pt x="2912999" y="716153"/>
                  </a:moveTo>
                  <a:lnTo>
                    <a:pt x="2902585" y="716153"/>
                  </a:lnTo>
                  <a:lnTo>
                    <a:pt x="2902585" y="934085"/>
                  </a:lnTo>
                  <a:lnTo>
                    <a:pt x="2912999" y="934085"/>
                  </a:lnTo>
                  <a:lnTo>
                    <a:pt x="2912999" y="716153"/>
                  </a:lnTo>
                  <a:close/>
                </a:path>
                <a:path w="4079875" h="934084">
                  <a:moveTo>
                    <a:pt x="2971038" y="871855"/>
                  </a:moveTo>
                  <a:lnTo>
                    <a:pt x="2960624" y="871855"/>
                  </a:lnTo>
                  <a:lnTo>
                    <a:pt x="2960624" y="934085"/>
                  </a:lnTo>
                  <a:lnTo>
                    <a:pt x="2971038" y="934085"/>
                  </a:lnTo>
                  <a:lnTo>
                    <a:pt x="2971038" y="871855"/>
                  </a:lnTo>
                  <a:close/>
                </a:path>
                <a:path w="4079875" h="934084">
                  <a:moveTo>
                    <a:pt x="3029204" y="373634"/>
                  </a:moveTo>
                  <a:lnTo>
                    <a:pt x="3018790" y="373634"/>
                  </a:lnTo>
                  <a:lnTo>
                    <a:pt x="3018790" y="934085"/>
                  </a:lnTo>
                  <a:lnTo>
                    <a:pt x="3029204" y="934085"/>
                  </a:lnTo>
                  <a:lnTo>
                    <a:pt x="3029204" y="373634"/>
                  </a:lnTo>
                  <a:close/>
                </a:path>
                <a:path w="4079875" h="934084">
                  <a:moveTo>
                    <a:pt x="3087243" y="404749"/>
                  </a:moveTo>
                  <a:lnTo>
                    <a:pt x="3076829" y="404749"/>
                  </a:lnTo>
                  <a:lnTo>
                    <a:pt x="3076829" y="934085"/>
                  </a:lnTo>
                  <a:lnTo>
                    <a:pt x="3087243" y="934085"/>
                  </a:lnTo>
                  <a:lnTo>
                    <a:pt x="3087243" y="404749"/>
                  </a:lnTo>
                  <a:close/>
                </a:path>
                <a:path w="4079875" h="934084">
                  <a:moveTo>
                    <a:pt x="3145282" y="249174"/>
                  </a:moveTo>
                  <a:lnTo>
                    <a:pt x="3134868" y="249174"/>
                  </a:lnTo>
                  <a:lnTo>
                    <a:pt x="3134868" y="934085"/>
                  </a:lnTo>
                  <a:lnTo>
                    <a:pt x="3145282" y="934085"/>
                  </a:lnTo>
                  <a:lnTo>
                    <a:pt x="3145282" y="249174"/>
                  </a:lnTo>
                  <a:close/>
                </a:path>
                <a:path w="4079875" h="934084">
                  <a:moveTo>
                    <a:pt x="3203321" y="498221"/>
                  </a:moveTo>
                  <a:lnTo>
                    <a:pt x="3192907" y="498221"/>
                  </a:lnTo>
                  <a:lnTo>
                    <a:pt x="3192907" y="934085"/>
                  </a:lnTo>
                  <a:lnTo>
                    <a:pt x="3203321" y="934085"/>
                  </a:lnTo>
                  <a:lnTo>
                    <a:pt x="3203321" y="498221"/>
                  </a:lnTo>
                  <a:close/>
                </a:path>
                <a:path w="4079875" h="934084">
                  <a:moveTo>
                    <a:pt x="3261360" y="685038"/>
                  </a:moveTo>
                  <a:lnTo>
                    <a:pt x="3250946" y="685038"/>
                  </a:lnTo>
                  <a:lnTo>
                    <a:pt x="3250946" y="934085"/>
                  </a:lnTo>
                  <a:lnTo>
                    <a:pt x="3261360" y="934085"/>
                  </a:lnTo>
                  <a:lnTo>
                    <a:pt x="3261360" y="685038"/>
                  </a:lnTo>
                  <a:close/>
                </a:path>
                <a:path w="4079875" h="934084">
                  <a:moveTo>
                    <a:pt x="3324733" y="529336"/>
                  </a:moveTo>
                  <a:lnTo>
                    <a:pt x="3311652" y="529336"/>
                  </a:lnTo>
                  <a:lnTo>
                    <a:pt x="3311652" y="934085"/>
                  </a:lnTo>
                  <a:lnTo>
                    <a:pt x="3324733" y="934085"/>
                  </a:lnTo>
                  <a:lnTo>
                    <a:pt x="3324733" y="529336"/>
                  </a:lnTo>
                  <a:close/>
                </a:path>
                <a:path w="4079875" h="934084">
                  <a:moveTo>
                    <a:pt x="3382759" y="591566"/>
                  </a:moveTo>
                  <a:lnTo>
                    <a:pt x="3369691" y="591566"/>
                  </a:lnTo>
                  <a:lnTo>
                    <a:pt x="3369691" y="934085"/>
                  </a:lnTo>
                  <a:lnTo>
                    <a:pt x="3382759" y="934085"/>
                  </a:lnTo>
                  <a:lnTo>
                    <a:pt x="3382759" y="591566"/>
                  </a:lnTo>
                  <a:close/>
                </a:path>
                <a:path w="4079875" h="934084">
                  <a:moveTo>
                    <a:pt x="3435477" y="280289"/>
                  </a:moveTo>
                  <a:lnTo>
                    <a:pt x="3425063" y="280289"/>
                  </a:lnTo>
                  <a:lnTo>
                    <a:pt x="3425063" y="934085"/>
                  </a:lnTo>
                  <a:lnTo>
                    <a:pt x="3435477" y="934085"/>
                  </a:lnTo>
                  <a:lnTo>
                    <a:pt x="3435477" y="280289"/>
                  </a:lnTo>
                  <a:close/>
                </a:path>
                <a:path w="4079875" h="934084">
                  <a:moveTo>
                    <a:pt x="3493516" y="591566"/>
                  </a:moveTo>
                  <a:lnTo>
                    <a:pt x="3483102" y="591566"/>
                  </a:lnTo>
                  <a:lnTo>
                    <a:pt x="3483102" y="934085"/>
                  </a:lnTo>
                  <a:lnTo>
                    <a:pt x="3493516" y="934085"/>
                  </a:lnTo>
                  <a:lnTo>
                    <a:pt x="3493516" y="591566"/>
                  </a:lnTo>
                  <a:close/>
                </a:path>
                <a:path w="4079875" h="934084">
                  <a:moveTo>
                    <a:pt x="3551682" y="529336"/>
                  </a:moveTo>
                  <a:lnTo>
                    <a:pt x="3541268" y="529336"/>
                  </a:lnTo>
                  <a:lnTo>
                    <a:pt x="3541268" y="934085"/>
                  </a:lnTo>
                  <a:lnTo>
                    <a:pt x="3551682" y="934085"/>
                  </a:lnTo>
                  <a:lnTo>
                    <a:pt x="3551682" y="529336"/>
                  </a:lnTo>
                  <a:close/>
                </a:path>
                <a:path w="4079875" h="934084">
                  <a:moveTo>
                    <a:pt x="3609721" y="716153"/>
                  </a:moveTo>
                  <a:lnTo>
                    <a:pt x="3599307" y="716153"/>
                  </a:lnTo>
                  <a:lnTo>
                    <a:pt x="3599307" y="934085"/>
                  </a:lnTo>
                  <a:lnTo>
                    <a:pt x="3609721" y="934085"/>
                  </a:lnTo>
                  <a:lnTo>
                    <a:pt x="3609721" y="716153"/>
                  </a:lnTo>
                  <a:close/>
                </a:path>
                <a:path w="4079875" h="934084">
                  <a:moveTo>
                    <a:pt x="3667760" y="716153"/>
                  </a:moveTo>
                  <a:lnTo>
                    <a:pt x="3657346" y="716153"/>
                  </a:lnTo>
                  <a:lnTo>
                    <a:pt x="3657346" y="934085"/>
                  </a:lnTo>
                  <a:lnTo>
                    <a:pt x="3667760" y="934085"/>
                  </a:lnTo>
                  <a:lnTo>
                    <a:pt x="3667760" y="716153"/>
                  </a:lnTo>
                  <a:close/>
                </a:path>
                <a:path w="4079875" h="934084">
                  <a:moveTo>
                    <a:pt x="3725799" y="685038"/>
                  </a:moveTo>
                  <a:lnTo>
                    <a:pt x="3715385" y="685038"/>
                  </a:lnTo>
                  <a:lnTo>
                    <a:pt x="3715385" y="934085"/>
                  </a:lnTo>
                  <a:lnTo>
                    <a:pt x="3725799" y="934085"/>
                  </a:lnTo>
                  <a:lnTo>
                    <a:pt x="3725799" y="685038"/>
                  </a:lnTo>
                  <a:close/>
                </a:path>
                <a:path w="4079875" h="934084">
                  <a:moveTo>
                    <a:pt x="3783838" y="591566"/>
                  </a:moveTo>
                  <a:lnTo>
                    <a:pt x="3773424" y="591566"/>
                  </a:lnTo>
                  <a:lnTo>
                    <a:pt x="3773424" y="934085"/>
                  </a:lnTo>
                  <a:lnTo>
                    <a:pt x="3783838" y="934085"/>
                  </a:lnTo>
                  <a:lnTo>
                    <a:pt x="3783838" y="591566"/>
                  </a:lnTo>
                  <a:close/>
                </a:path>
                <a:path w="4079875" h="934084">
                  <a:moveTo>
                    <a:pt x="3847211" y="498221"/>
                  </a:moveTo>
                  <a:lnTo>
                    <a:pt x="3834130" y="498221"/>
                  </a:lnTo>
                  <a:lnTo>
                    <a:pt x="3834130" y="934085"/>
                  </a:lnTo>
                  <a:lnTo>
                    <a:pt x="3847211" y="934085"/>
                  </a:lnTo>
                  <a:lnTo>
                    <a:pt x="3847211" y="498221"/>
                  </a:lnTo>
                  <a:close/>
                </a:path>
                <a:path w="4079875" h="934084">
                  <a:moveTo>
                    <a:pt x="3899903" y="653923"/>
                  </a:moveTo>
                  <a:lnTo>
                    <a:pt x="3889489" y="653923"/>
                  </a:lnTo>
                  <a:lnTo>
                    <a:pt x="3889489" y="934085"/>
                  </a:lnTo>
                  <a:lnTo>
                    <a:pt x="3899903" y="934085"/>
                  </a:lnTo>
                  <a:lnTo>
                    <a:pt x="3899903" y="653923"/>
                  </a:lnTo>
                  <a:close/>
                </a:path>
                <a:path w="4079875" h="934084">
                  <a:moveTo>
                    <a:pt x="3963276" y="809498"/>
                  </a:moveTo>
                  <a:lnTo>
                    <a:pt x="3950195" y="809498"/>
                  </a:lnTo>
                  <a:lnTo>
                    <a:pt x="3950195" y="934085"/>
                  </a:lnTo>
                  <a:lnTo>
                    <a:pt x="3963276" y="934085"/>
                  </a:lnTo>
                  <a:lnTo>
                    <a:pt x="3963276" y="809498"/>
                  </a:lnTo>
                  <a:close/>
                </a:path>
                <a:path w="4079875" h="934084">
                  <a:moveTo>
                    <a:pt x="4029951" y="716153"/>
                  </a:moveTo>
                  <a:lnTo>
                    <a:pt x="4012565" y="716153"/>
                  </a:lnTo>
                  <a:lnTo>
                    <a:pt x="4012565" y="934085"/>
                  </a:lnTo>
                  <a:lnTo>
                    <a:pt x="4029951" y="934085"/>
                  </a:lnTo>
                  <a:lnTo>
                    <a:pt x="4029951" y="716153"/>
                  </a:lnTo>
                  <a:close/>
                </a:path>
                <a:path w="4079875" h="934084">
                  <a:moveTo>
                    <a:pt x="4079367" y="435991"/>
                  </a:moveTo>
                  <a:lnTo>
                    <a:pt x="4066286" y="435991"/>
                  </a:lnTo>
                  <a:lnTo>
                    <a:pt x="4066286" y="934085"/>
                  </a:lnTo>
                  <a:lnTo>
                    <a:pt x="4079367" y="934085"/>
                  </a:lnTo>
                  <a:lnTo>
                    <a:pt x="4079367" y="435991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9" name="object 109" descr=""/>
            <p:cNvSpPr/>
            <p:nvPr/>
          </p:nvSpPr>
          <p:spPr>
            <a:xfrm>
              <a:off x="13328777" y="7915148"/>
              <a:ext cx="2277110" cy="747395"/>
            </a:xfrm>
            <a:custGeom>
              <a:avLst/>
              <a:gdLst/>
              <a:ahLst/>
              <a:cxnLst/>
              <a:rect l="l" t="t" r="r" b="b"/>
              <a:pathLst>
                <a:path w="2277109" h="747395">
                  <a:moveTo>
                    <a:pt x="13081" y="249174"/>
                  </a:moveTo>
                  <a:lnTo>
                    <a:pt x="0" y="249174"/>
                  </a:lnTo>
                  <a:lnTo>
                    <a:pt x="0" y="747268"/>
                  </a:lnTo>
                  <a:lnTo>
                    <a:pt x="13081" y="747268"/>
                  </a:lnTo>
                  <a:lnTo>
                    <a:pt x="13081" y="249174"/>
                  </a:lnTo>
                  <a:close/>
                </a:path>
                <a:path w="2277109" h="747395">
                  <a:moveTo>
                    <a:pt x="65913" y="342519"/>
                  </a:moveTo>
                  <a:lnTo>
                    <a:pt x="55499" y="342519"/>
                  </a:lnTo>
                  <a:lnTo>
                    <a:pt x="55499" y="747268"/>
                  </a:lnTo>
                  <a:lnTo>
                    <a:pt x="65913" y="747268"/>
                  </a:lnTo>
                  <a:lnTo>
                    <a:pt x="65913" y="342519"/>
                  </a:lnTo>
                  <a:close/>
                </a:path>
                <a:path w="2277109" h="747395">
                  <a:moveTo>
                    <a:pt x="123952" y="311404"/>
                  </a:moveTo>
                  <a:lnTo>
                    <a:pt x="113538" y="311404"/>
                  </a:lnTo>
                  <a:lnTo>
                    <a:pt x="113538" y="747268"/>
                  </a:lnTo>
                  <a:lnTo>
                    <a:pt x="123952" y="747268"/>
                  </a:lnTo>
                  <a:lnTo>
                    <a:pt x="123952" y="311404"/>
                  </a:lnTo>
                  <a:close/>
                </a:path>
                <a:path w="2277109" h="747395">
                  <a:moveTo>
                    <a:pt x="187198" y="62357"/>
                  </a:moveTo>
                  <a:lnTo>
                    <a:pt x="174117" y="62357"/>
                  </a:lnTo>
                  <a:lnTo>
                    <a:pt x="174117" y="747268"/>
                  </a:lnTo>
                  <a:lnTo>
                    <a:pt x="187198" y="747268"/>
                  </a:lnTo>
                  <a:lnTo>
                    <a:pt x="187198" y="62357"/>
                  </a:lnTo>
                  <a:close/>
                </a:path>
                <a:path w="2277109" h="747395">
                  <a:moveTo>
                    <a:pt x="245364" y="560451"/>
                  </a:moveTo>
                  <a:lnTo>
                    <a:pt x="232283" y="560451"/>
                  </a:lnTo>
                  <a:lnTo>
                    <a:pt x="232283" y="747268"/>
                  </a:lnTo>
                  <a:lnTo>
                    <a:pt x="245364" y="747268"/>
                  </a:lnTo>
                  <a:lnTo>
                    <a:pt x="245364" y="560451"/>
                  </a:lnTo>
                  <a:close/>
                </a:path>
                <a:path w="2277109" h="747395">
                  <a:moveTo>
                    <a:pt x="303390" y="622681"/>
                  </a:moveTo>
                  <a:lnTo>
                    <a:pt x="290322" y="622681"/>
                  </a:lnTo>
                  <a:lnTo>
                    <a:pt x="290322" y="747268"/>
                  </a:lnTo>
                  <a:lnTo>
                    <a:pt x="303390" y="747268"/>
                  </a:lnTo>
                  <a:lnTo>
                    <a:pt x="303390" y="622681"/>
                  </a:lnTo>
                  <a:close/>
                </a:path>
                <a:path w="2277109" h="747395">
                  <a:moveTo>
                    <a:pt x="361442" y="249174"/>
                  </a:moveTo>
                  <a:lnTo>
                    <a:pt x="348361" y="249174"/>
                  </a:lnTo>
                  <a:lnTo>
                    <a:pt x="348361" y="747268"/>
                  </a:lnTo>
                  <a:lnTo>
                    <a:pt x="361442" y="747268"/>
                  </a:lnTo>
                  <a:lnTo>
                    <a:pt x="361442" y="249174"/>
                  </a:lnTo>
                  <a:close/>
                </a:path>
                <a:path w="2277109" h="747395">
                  <a:moveTo>
                    <a:pt x="419481" y="155702"/>
                  </a:moveTo>
                  <a:lnTo>
                    <a:pt x="406400" y="155702"/>
                  </a:lnTo>
                  <a:lnTo>
                    <a:pt x="406400" y="747268"/>
                  </a:lnTo>
                  <a:lnTo>
                    <a:pt x="419481" y="747268"/>
                  </a:lnTo>
                  <a:lnTo>
                    <a:pt x="419481" y="155702"/>
                  </a:lnTo>
                  <a:close/>
                </a:path>
                <a:path w="2277109" h="747395">
                  <a:moveTo>
                    <a:pt x="477520" y="280289"/>
                  </a:moveTo>
                  <a:lnTo>
                    <a:pt x="464439" y="280289"/>
                  </a:lnTo>
                  <a:lnTo>
                    <a:pt x="464439" y="747268"/>
                  </a:lnTo>
                  <a:lnTo>
                    <a:pt x="477520" y="747268"/>
                  </a:lnTo>
                  <a:lnTo>
                    <a:pt x="477520" y="280289"/>
                  </a:lnTo>
                  <a:close/>
                </a:path>
                <a:path w="2277109" h="747395">
                  <a:moveTo>
                    <a:pt x="530225" y="373634"/>
                  </a:moveTo>
                  <a:lnTo>
                    <a:pt x="519811" y="373634"/>
                  </a:lnTo>
                  <a:lnTo>
                    <a:pt x="519811" y="747268"/>
                  </a:lnTo>
                  <a:lnTo>
                    <a:pt x="530225" y="747268"/>
                  </a:lnTo>
                  <a:lnTo>
                    <a:pt x="530225" y="373634"/>
                  </a:lnTo>
                  <a:close/>
                </a:path>
                <a:path w="2277109" h="747395">
                  <a:moveTo>
                    <a:pt x="588391" y="373634"/>
                  </a:moveTo>
                  <a:lnTo>
                    <a:pt x="577977" y="373634"/>
                  </a:lnTo>
                  <a:lnTo>
                    <a:pt x="577977" y="747268"/>
                  </a:lnTo>
                  <a:lnTo>
                    <a:pt x="588391" y="747268"/>
                  </a:lnTo>
                  <a:lnTo>
                    <a:pt x="588391" y="373634"/>
                  </a:lnTo>
                  <a:close/>
                </a:path>
                <a:path w="2277109" h="747395">
                  <a:moveTo>
                    <a:pt x="646417" y="373634"/>
                  </a:moveTo>
                  <a:lnTo>
                    <a:pt x="636016" y="373634"/>
                  </a:lnTo>
                  <a:lnTo>
                    <a:pt x="636016" y="747268"/>
                  </a:lnTo>
                  <a:lnTo>
                    <a:pt x="646417" y="747268"/>
                  </a:lnTo>
                  <a:lnTo>
                    <a:pt x="646417" y="373634"/>
                  </a:lnTo>
                  <a:close/>
                </a:path>
                <a:path w="2277109" h="747395">
                  <a:moveTo>
                    <a:pt x="704469" y="404749"/>
                  </a:moveTo>
                  <a:lnTo>
                    <a:pt x="694055" y="404749"/>
                  </a:lnTo>
                  <a:lnTo>
                    <a:pt x="694055" y="747268"/>
                  </a:lnTo>
                  <a:lnTo>
                    <a:pt x="704469" y="747268"/>
                  </a:lnTo>
                  <a:lnTo>
                    <a:pt x="704469" y="404749"/>
                  </a:lnTo>
                  <a:close/>
                </a:path>
                <a:path w="2277109" h="747395">
                  <a:moveTo>
                    <a:pt x="762508" y="529336"/>
                  </a:moveTo>
                  <a:lnTo>
                    <a:pt x="752094" y="529336"/>
                  </a:lnTo>
                  <a:lnTo>
                    <a:pt x="752094" y="747268"/>
                  </a:lnTo>
                  <a:lnTo>
                    <a:pt x="762508" y="747268"/>
                  </a:lnTo>
                  <a:lnTo>
                    <a:pt x="762508" y="529336"/>
                  </a:lnTo>
                  <a:close/>
                </a:path>
                <a:path w="2277109" h="747395">
                  <a:moveTo>
                    <a:pt x="820547" y="404749"/>
                  </a:moveTo>
                  <a:lnTo>
                    <a:pt x="810133" y="404749"/>
                  </a:lnTo>
                  <a:lnTo>
                    <a:pt x="810133" y="747268"/>
                  </a:lnTo>
                  <a:lnTo>
                    <a:pt x="820547" y="747268"/>
                  </a:lnTo>
                  <a:lnTo>
                    <a:pt x="820547" y="404749"/>
                  </a:lnTo>
                  <a:close/>
                </a:path>
                <a:path w="2277109" h="747395">
                  <a:moveTo>
                    <a:pt x="878573" y="280289"/>
                  </a:moveTo>
                  <a:lnTo>
                    <a:pt x="868172" y="280289"/>
                  </a:lnTo>
                  <a:lnTo>
                    <a:pt x="868172" y="747268"/>
                  </a:lnTo>
                  <a:lnTo>
                    <a:pt x="878573" y="747268"/>
                  </a:lnTo>
                  <a:lnTo>
                    <a:pt x="878573" y="280289"/>
                  </a:lnTo>
                  <a:close/>
                </a:path>
                <a:path w="2277109" h="747395">
                  <a:moveTo>
                    <a:pt x="936625" y="0"/>
                  </a:moveTo>
                  <a:lnTo>
                    <a:pt x="926211" y="0"/>
                  </a:lnTo>
                  <a:lnTo>
                    <a:pt x="926211" y="747268"/>
                  </a:lnTo>
                  <a:lnTo>
                    <a:pt x="936625" y="747268"/>
                  </a:lnTo>
                  <a:lnTo>
                    <a:pt x="936625" y="0"/>
                  </a:lnTo>
                  <a:close/>
                </a:path>
                <a:path w="2277109" h="747395">
                  <a:moveTo>
                    <a:pt x="999998" y="591566"/>
                  </a:moveTo>
                  <a:lnTo>
                    <a:pt x="986917" y="591566"/>
                  </a:lnTo>
                  <a:lnTo>
                    <a:pt x="986917" y="747268"/>
                  </a:lnTo>
                  <a:lnTo>
                    <a:pt x="999998" y="747268"/>
                  </a:lnTo>
                  <a:lnTo>
                    <a:pt x="999998" y="591566"/>
                  </a:lnTo>
                  <a:close/>
                </a:path>
                <a:path w="2277109" h="747395">
                  <a:moveTo>
                    <a:pt x="1066673" y="467106"/>
                  </a:moveTo>
                  <a:lnTo>
                    <a:pt x="1049274" y="467106"/>
                  </a:lnTo>
                  <a:lnTo>
                    <a:pt x="1049274" y="747268"/>
                  </a:lnTo>
                  <a:lnTo>
                    <a:pt x="1066673" y="747268"/>
                  </a:lnTo>
                  <a:lnTo>
                    <a:pt x="1066673" y="467106"/>
                  </a:lnTo>
                  <a:close/>
                </a:path>
                <a:path w="2277109" h="747395">
                  <a:moveTo>
                    <a:pt x="1116063" y="498221"/>
                  </a:moveTo>
                  <a:lnTo>
                    <a:pt x="1102995" y="498221"/>
                  </a:lnTo>
                  <a:lnTo>
                    <a:pt x="1102995" y="747268"/>
                  </a:lnTo>
                  <a:lnTo>
                    <a:pt x="1116063" y="747268"/>
                  </a:lnTo>
                  <a:lnTo>
                    <a:pt x="1116063" y="498221"/>
                  </a:lnTo>
                  <a:close/>
                </a:path>
                <a:path w="2277109" h="747395">
                  <a:moveTo>
                    <a:pt x="1168908" y="467106"/>
                  </a:moveTo>
                  <a:lnTo>
                    <a:pt x="1158494" y="467106"/>
                  </a:lnTo>
                  <a:lnTo>
                    <a:pt x="1158494" y="747268"/>
                  </a:lnTo>
                  <a:lnTo>
                    <a:pt x="1168908" y="747268"/>
                  </a:lnTo>
                  <a:lnTo>
                    <a:pt x="1168908" y="467106"/>
                  </a:lnTo>
                  <a:close/>
                </a:path>
                <a:path w="2277109" h="747395">
                  <a:moveTo>
                    <a:pt x="1226947" y="342519"/>
                  </a:moveTo>
                  <a:lnTo>
                    <a:pt x="1216533" y="342519"/>
                  </a:lnTo>
                  <a:lnTo>
                    <a:pt x="1216533" y="747268"/>
                  </a:lnTo>
                  <a:lnTo>
                    <a:pt x="1226947" y="747268"/>
                  </a:lnTo>
                  <a:lnTo>
                    <a:pt x="1226947" y="342519"/>
                  </a:lnTo>
                  <a:close/>
                </a:path>
                <a:path w="2277109" h="747395">
                  <a:moveTo>
                    <a:pt x="1298956" y="653923"/>
                  </a:moveTo>
                  <a:lnTo>
                    <a:pt x="1281557" y="653923"/>
                  </a:lnTo>
                  <a:lnTo>
                    <a:pt x="1281557" y="747268"/>
                  </a:lnTo>
                  <a:lnTo>
                    <a:pt x="1298956" y="747268"/>
                  </a:lnTo>
                  <a:lnTo>
                    <a:pt x="1298956" y="653923"/>
                  </a:lnTo>
                  <a:close/>
                </a:path>
                <a:path w="2277109" h="747395">
                  <a:moveTo>
                    <a:pt x="1348359" y="653923"/>
                  </a:moveTo>
                  <a:lnTo>
                    <a:pt x="1335278" y="653923"/>
                  </a:lnTo>
                  <a:lnTo>
                    <a:pt x="1335278" y="747268"/>
                  </a:lnTo>
                  <a:lnTo>
                    <a:pt x="1348359" y="747268"/>
                  </a:lnTo>
                  <a:lnTo>
                    <a:pt x="1348359" y="653923"/>
                  </a:lnTo>
                  <a:close/>
                </a:path>
                <a:path w="2277109" h="747395">
                  <a:moveTo>
                    <a:pt x="1401064" y="591566"/>
                  </a:moveTo>
                  <a:lnTo>
                    <a:pt x="1390650" y="591566"/>
                  </a:lnTo>
                  <a:lnTo>
                    <a:pt x="1390650" y="747268"/>
                  </a:lnTo>
                  <a:lnTo>
                    <a:pt x="1401064" y="747268"/>
                  </a:lnTo>
                  <a:lnTo>
                    <a:pt x="1401064" y="591566"/>
                  </a:lnTo>
                  <a:close/>
                </a:path>
                <a:path w="2277109" h="747395">
                  <a:moveTo>
                    <a:pt x="1464437" y="560451"/>
                  </a:moveTo>
                  <a:lnTo>
                    <a:pt x="1451356" y="560451"/>
                  </a:lnTo>
                  <a:lnTo>
                    <a:pt x="1451356" y="747268"/>
                  </a:lnTo>
                  <a:lnTo>
                    <a:pt x="1464437" y="747268"/>
                  </a:lnTo>
                  <a:lnTo>
                    <a:pt x="1464437" y="560451"/>
                  </a:lnTo>
                  <a:close/>
                </a:path>
                <a:path w="2277109" h="747395">
                  <a:moveTo>
                    <a:pt x="1517142" y="622681"/>
                  </a:moveTo>
                  <a:lnTo>
                    <a:pt x="1506728" y="622681"/>
                  </a:lnTo>
                  <a:lnTo>
                    <a:pt x="1506728" y="747268"/>
                  </a:lnTo>
                  <a:lnTo>
                    <a:pt x="1517142" y="747268"/>
                  </a:lnTo>
                  <a:lnTo>
                    <a:pt x="1517142" y="622681"/>
                  </a:lnTo>
                  <a:close/>
                </a:path>
                <a:path w="2277109" h="747395">
                  <a:moveTo>
                    <a:pt x="1589138" y="467106"/>
                  </a:moveTo>
                  <a:lnTo>
                    <a:pt x="1571752" y="467106"/>
                  </a:lnTo>
                  <a:lnTo>
                    <a:pt x="1571752" y="747268"/>
                  </a:lnTo>
                  <a:lnTo>
                    <a:pt x="1589138" y="747268"/>
                  </a:lnTo>
                  <a:lnTo>
                    <a:pt x="1589138" y="467106"/>
                  </a:lnTo>
                  <a:close/>
                </a:path>
                <a:path w="2277109" h="747395">
                  <a:moveTo>
                    <a:pt x="1638554" y="622681"/>
                  </a:moveTo>
                  <a:lnTo>
                    <a:pt x="1625473" y="622681"/>
                  </a:lnTo>
                  <a:lnTo>
                    <a:pt x="1625473" y="747268"/>
                  </a:lnTo>
                  <a:lnTo>
                    <a:pt x="1638554" y="747268"/>
                  </a:lnTo>
                  <a:lnTo>
                    <a:pt x="1638554" y="622681"/>
                  </a:lnTo>
                  <a:close/>
                </a:path>
                <a:path w="2277109" h="747395">
                  <a:moveTo>
                    <a:pt x="1696593" y="529336"/>
                  </a:moveTo>
                  <a:lnTo>
                    <a:pt x="1683512" y="529336"/>
                  </a:lnTo>
                  <a:lnTo>
                    <a:pt x="1683512" y="747268"/>
                  </a:lnTo>
                  <a:lnTo>
                    <a:pt x="1696593" y="747268"/>
                  </a:lnTo>
                  <a:lnTo>
                    <a:pt x="1696593" y="529336"/>
                  </a:lnTo>
                  <a:close/>
                </a:path>
                <a:path w="2277109" h="747395">
                  <a:moveTo>
                    <a:pt x="1763395" y="591566"/>
                  </a:moveTo>
                  <a:lnTo>
                    <a:pt x="1745996" y="591566"/>
                  </a:lnTo>
                  <a:lnTo>
                    <a:pt x="1745996" y="747268"/>
                  </a:lnTo>
                  <a:lnTo>
                    <a:pt x="1763395" y="747268"/>
                  </a:lnTo>
                  <a:lnTo>
                    <a:pt x="1763395" y="591566"/>
                  </a:lnTo>
                  <a:close/>
                </a:path>
                <a:path w="2277109" h="747395">
                  <a:moveTo>
                    <a:pt x="1812671" y="529336"/>
                  </a:moveTo>
                  <a:lnTo>
                    <a:pt x="1799590" y="529336"/>
                  </a:lnTo>
                  <a:lnTo>
                    <a:pt x="1799590" y="747268"/>
                  </a:lnTo>
                  <a:lnTo>
                    <a:pt x="1812671" y="747268"/>
                  </a:lnTo>
                  <a:lnTo>
                    <a:pt x="1812671" y="529336"/>
                  </a:lnTo>
                  <a:close/>
                </a:path>
                <a:path w="2277109" h="747395">
                  <a:moveTo>
                    <a:pt x="1870837" y="498221"/>
                  </a:moveTo>
                  <a:lnTo>
                    <a:pt x="1857756" y="498221"/>
                  </a:lnTo>
                  <a:lnTo>
                    <a:pt x="1857756" y="747268"/>
                  </a:lnTo>
                  <a:lnTo>
                    <a:pt x="1870837" y="747268"/>
                  </a:lnTo>
                  <a:lnTo>
                    <a:pt x="1870837" y="498221"/>
                  </a:lnTo>
                  <a:close/>
                </a:path>
                <a:path w="2277109" h="747395">
                  <a:moveTo>
                    <a:pt x="1954911" y="529336"/>
                  </a:moveTo>
                  <a:lnTo>
                    <a:pt x="1928749" y="529336"/>
                  </a:lnTo>
                  <a:lnTo>
                    <a:pt x="1928749" y="747268"/>
                  </a:lnTo>
                  <a:lnTo>
                    <a:pt x="1954911" y="747268"/>
                  </a:lnTo>
                  <a:lnTo>
                    <a:pt x="1954911" y="529336"/>
                  </a:lnTo>
                  <a:close/>
                </a:path>
                <a:path w="2277109" h="747395">
                  <a:moveTo>
                    <a:pt x="1986915" y="467106"/>
                  </a:moveTo>
                  <a:lnTo>
                    <a:pt x="1973834" y="467106"/>
                  </a:lnTo>
                  <a:lnTo>
                    <a:pt x="1973834" y="747268"/>
                  </a:lnTo>
                  <a:lnTo>
                    <a:pt x="1986915" y="747268"/>
                  </a:lnTo>
                  <a:lnTo>
                    <a:pt x="1986915" y="467106"/>
                  </a:lnTo>
                  <a:close/>
                </a:path>
                <a:path w="2277109" h="747395">
                  <a:moveTo>
                    <a:pt x="2044954" y="653923"/>
                  </a:moveTo>
                  <a:lnTo>
                    <a:pt x="2031873" y="653923"/>
                  </a:lnTo>
                  <a:lnTo>
                    <a:pt x="2031873" y="747268"/>
                  </a:lnTo>
                  <a:lnTo>
                    <a:pt x="2044954" y="747268"/>
                  </a:lnTo>
                  <a:lnTo>
                    <a:pt x="2044954" y="653923"/>
                  </a:lnTo>
                  <a:close/>
                </a:path>
                <a:path w="2277109" h="747395">
                  <a:moveTo>
                    <a:pt x="2111629" y="342519"/>
                  </a:moveTo>
                  <a:lnTo>
                    <a:pt x="2094230" y="342519"/>
                  </a:lnTo>
                  <a:lnTo>
                    <a:pt x="2094230" y="747268"/>
                  </a:lnTo>
                  <a:lnTo>
                    <a:pt x="2111629" y="747268"/>
                  </a:lnTo>
                  <a:lnTo>
                    <a:pt x="2111629" y="342519"/>
                  </a:lnTo>
                  <a:close/>
                </a:path>
                <a:path w="2277109" h="747395">
                  <a:moveTo>
                    <a:pt x="2169668" y="529336"/>
                  </a:moveTo>
                  <a:lnTo>
                    <a:pt x="2152269" y="529336"/>
                  </a:lnTo>
                  <a:lnTo>
                    <a:pt x="2152269" y="747268"/>
                  </a:lnTo>
                  <a:lnTo>
                    <a:pt x="2169668" y="747268"/>
                  </a:lnTo>
                  <a:lnTo>
                    <a:pt x="2169668" y="529336"/>
                  </a:lnTo>
                  <a:close/>
                </a:path>
                <a:path w="2277109" h="747395">
                  <a:moveTo>
                    <a:pt x="2227694" y="591566"/>
                  </a:moveTo>
                  <a:lnTo>
                    <a:pt x="2210308" y="591566"/>
                  </a:lnTo>
                  <a:lnTo>
                    <a:pt x="2210308" y="747268"/>
                  </a:lnTo>
                  <a:lnTo>
                    <a:pt x="2227694" y="747268"/>
                  </a:lnTo>
                  <a:lnTo>
                    <a:pt x="2227694" y="591566"/>
                  </a:lnTo>
                  <a:close/>
                </a:path>
                <a:path w="2277109" h="747395">
                  <a:moveTo>
                    <a:pt x="2277110" y="685038"/>
                  </a:moveTo>
                  <a:lnTo>
                    <a:pt x="2250948" y="685038"/>
                  </a:lnTo>
                  <a:lnTo>
                    <a:pt x="2250948" y="747268"/>
                  </a:lnTo>
                  <a:lnTo>
                    <a:pt x="2277110" y="747268"/>
                  </a:lnTo>
                  <a:lnTo>
                    <a:pt x="2277110" y="685038"/>
                  </a:lnTo>
                  <a:close/>
                </a:path>
              </a:pathLst>
            </a:custGeom>
            <a:solidFill>
              <a:srgbClr val="41A3F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0" name="object 110" descr=""/>
            <p:cNvSpPr/>
            <p:nvPr/>
          </p:nvSpPr>
          <p:spPr>
            <a:xfrm>
              <a:off x="1137793" y="7884033"/>
              <a:ext cx="4082415" cy="778510"/>
            </a:xfrm>
            <a:custGeom>
              <a:avLst/>
              <a:gdLst/>
              <a:ahLst/>
              <a:cxnLst/>
              <a:rect l="l" t="t" r="r" b="b"/>
              <a:pathLst>
                <a:path w="4082415" h="778509">
                  <a:moveTo>
                    <a:pt x="13081" y="747268"/>
                  </a:moveTo>
                  <a:lnTo>
                    <a:pt x="0" y="747268"/>
                  </a:lnTo>
                  <a:lnTo>
                    <a:pt x="0" y="778383"/>
                  </a:lnTo>
                  <a:lnTo>
                    <a:pt x="13081" y="778383"/>
                  </a:lnTo>
                  <a:lnTo>
                    <a:pt x="13081" y="747268"/>
                  </a:lnTo>
                  <a:close/>
                </a:path>
                <a:path w="4082415" h="778509">
                  <a:moveTo>
                    <a:pt x="71120" y="685038"/>
                  </a:moveTo>
                  <a:lnTo>
                    <a:pt x="58039" y="685038"/>
                  </a:lnTo>
                  <a:lnTo>
                    <a:pt x="58039" y="778383"/>
                  </a:lnTo>
                  <a:lnTo>
                    <a:pt x="71120" y="778383"/>
                  </a:lnTo>
                  <a:lnTo>
                    <a:pt x="71120" y="685038"/>
                  </a:lnTo>
                  <a:close/>
                </a:path>
                <a:path w="4082415" h="778509">
                  <a:moveTo>
                    <a:pt x="129159" y="622681"/>
                  </a:moveTo>
                  <a:lnTo>
                    <a:pt x="116078" y="622681"/>
                  </a:lnTo>
                  <a:lnTo>
                    <a:pt x="116078" y="778383"/>
                  </a:lnTo>
                  <a:lnTo>
                    <a:pt x="129159" y="778383"/>
                  </a:lnTo>
                  <a:lnTo>
                    <a:pt x="129159" y="622681"/>
                  </a:lnTo>
                  <a:close/>
                </a:path>
                <a:path w="4082415" h="778509">
                  <a:moveTo>
                    <a:pt x="187198" y="685038"/>
                  </a:moveTo>
                  <a:lnTo>
                    <a:pt x="174117" y="685038"/>
                  </a:lnTo>
                  <a:lnTo>
                    <a:pt x="174117" y="778383"/>
                  </a:lnTo>
                  <a:lnTo>
                    <a:pt x="187198" y="778383"/>
                  </a:lnTo>
                  <a:lnTo>
                    <a:pt x="187198" y="685038"/>
                  </a:lnTo>
                  <a:close/>
                </a:path>
                <a:path w="4082415" h="778509">
                  <a:moveTo>
                    <a:pt x="245237" y="653796"/>
                  </a:moveTo>
                  <a:lnTo>
                    <a:pt x="232156" y="653796"/>
                  </a:lnTo>
                  <a:lnTo>
                    <a:pt x="232156" y="778383"/>
                  </a:lnTo>
                  <a:lnTo>
                    <a:pt x="245237" y="778383"/>
                  </a:lnTo>
                  <a:lnTo>
                    <a:pt x="245237" y="653796"/>
                  </a:lnTo>
                  <a:close/>
                </a:path>
                <a:path w="4082415" h="778509">
                  <a:moveTo>
                    <a:pt x="303276" y="685038"/>
                  </a:moveTo>
                  <a:lnTo>
                    <a:pt x="290195" y="685038"/>
                  </a:lnTo>
                  <a:lnTo>
                    <a:pt x="290195" y="778383"/>
                  </a:lnTo>
                  <a:lnTo>
                    <a:pt x="303276" y="778383"/>
                  </a:lnTo>
                  <a:lnTo>
                    <a:pt x="303276" y="685038"/>
                  </a:lnTo>
                  <a:close/>
                </a:path>
                <a:path w="4082415" h="778509">
                  <a:moveTo>
                    <a:pt x="361315" y="622681"/>
                  </a:moveTo>
                  <a:lnTo>
                    <a:pt x="348234" y="622681"/>
                  </a:lnTo>
                  <a:lnTo>
                    <a:pt x="348234" y="778383"/>
                  </a:lnTo>
                  <a:lnTo>
                    <a:pt x="361315" y="778383"/>
                  </a:lnTo>
                  <a:lnTo>
                    <a:pt x="361315" y="622681"/>
                  </a:lnTo>
                  <a:close/>
                </a:path>
                <a:path w="4082415" h="778509">
                  <a:moveTo>
                    <a:pt x="424561" y="591566"/>
                  </a:moveTo>
                  <a:lnTo>
                    <a:pt x="414147" y="591566"/>
                  </a:lnTo>
                  <a:lnTo>
                    <a:pt x="414147" y="778383"/>
                  </a:lnTo>
                  <a:lnTo>
                    <a:pt x="424561" y="778383"/>
                  </a:lnTo>
                  <a:lnTo>
                    <a:pt x="424561" y="591566"/>
                  </a:lnTo>
                  <a:close/>
                </a:path>
                <a:path w="4082415" h="778509">
                  <a:moveTo>
                    <a:pt x="477520" y="685038"/>
                  </a:moveTo>
                  <a:lnTo>
                    <a:pt x="464439" y="685038"/>
                  </a:lnTo>
                  <a:lnTo>
                    <a:pt x="464439" y="778383"/>
                  </a:lnTo>
                  <a:lnTo>
                    <a:pt x="477520" y="778383"/>
                  </a:lnTo>
                  <a:lnTo>
                    <a:pt x="477520" y="685038"/>
                  </a:lnTo>
                  <a:close/>
                </a:path>
                <a:path w="4082415" h="778509">
                  <a:moveTo>
                    <a:pt x="540639" y="560451"/>
                  </a:moveTo>
                  <a:lnTo>
                    <a:pt x="530225" y="560451"/>
                  </a:lnTo>
                  <a:lnTo>
                    <a:pt x="530225" y="778383"/>
                  </a:lnTo>
                  <a:lnTo>
                    <a:pt x="540639" y="778383"/>
                  </a:lnTo>
                  <a:lnTo>
                    <a:pt x="540639" y="560451"/>
                  </a:lnTo>
                  <a:close/>
                </a:path>
                <a:path w="4082415" h="778509">
                  <a:moveTo>
                    <a:pt x="598678" y="747268"/>
                  </a:moveTo>
                  <a:lnTo>
                    <a:pt x="588264" y="747268"/>
                  </a:lnTo>
                  <a:lnTo>
                    <a:pt x="588264" y="778383"/>
                  </a:lnTo>
                  <a:lnTo>
                    <a:pt x="598678" y="778383"/>
                  </a:lnTo>
                  <a:lnTo>
                    <a:pt x="598678" y="747268"/>
                  </a:lnTo>
                  <a:close/>
                </a:path>
                <a:path w="4082415" h="778509">
                  <a:moveTo>
                    <a:pt x="656844" y="716153"/>
                  </a:moveTo>
                  <a:lnTo>
                    <a:pt x="646430" y="716153"/>
                  </a:lnTo>
                  <a:lnTo>
                    <a:pt x="646430" y="778383"/>
                  </a:lnTo>
                  <a:lnTo>
                    <a:pt x="656844" y="778383"/>
                  </a:lnTo>
                  <a:lnTo>
                    <a:pt x="656844" y="716153"/>
                  </a:lnTo>
                  <a:close/>
                </a:path>
                <a:path w="4082415" h="778509">
                  <a:moveTo>
                    <a:pt x="714883" y="685038"/>
                  </a:moveTo>
                  <a:lnTo>
                    <a:pt x="704469" y="685038"/>
                  </a:lnTo>
                  <a:lnTo>
                    <a:pt x="704469" y="778383"/>
                  </a:lnTo>
                  <a:lnTo>
                    <a:pt x="714883" y="778383"/>
                  </a:lnTo>
                  <a:lnTo>
                    <a:pt x="714883" y="685038"/>
                  </a:lnTo>
                  <a:close/>
                </a:path>
                <a:path w="4082415" h="778509">
                  <a:moveTo>
                    <a:pt x="772922" y="373634"/>
                  </a:moveTo>
                  <a:lnTo>
                    <a:pt x="762508" y="373634"/>
                  </a:lnTo>
                  <a:lnTo>
                    <a:pt x="762508" y="778383"/>
                  </a:lnTo>
                  <a:lnTo>
                    <a:pt x="772922" y="778383"/>
                  </a:lnTo>
                  <a:lnTo>
                    <a:pt x="772922" y="373634"/>
                  </a:lnTo>
                  <a:close/>
                </a:path>
                <a:path w="4082415" h="778509">
                  <a:moveTo>
                    <a:pt x="830948" y="186817"/>
                  </a:moveTo>
                  <a:lnTo>
                    <a:pt x="820547" y="186817"/>
                  </a:lnTo>
                  <a:lnTo>
                    <a:pt x="820547" y="778383"/>
                  </a:lnTo>
                  <a:lnTo>
                    <a:pt x="830948" y="778383"/>
                  </a:lnTo>
                  <a:lnTo>
                    <a:pt x="830948" y="186817"/>
                  </a:lnTo>
                  <a:close/>
                </a:path>
                <a:path w="4082415" h="778509">
                  <a:moveTo>
                    <a:pt x="889000" y="62357"/>
                  </a:moveTo>
                  <a:lnTo>
                    <a:pt x="878586" y="62357"/>
                  </a:lnTo>
                  <a:lnTo>
                    <a:pt x="878586" y="778383"/>
                  </a:lnTo>
                  <a:lnTo>
                    <a:pt x="889000" y="778383"/>
                  </a:lnTo>
                  <a:lnTo>
                    <a:pt x="889000" y="62357"/>
                  </a:lnTo>
                  <a:close/>
                </a:path>
                <a:path w="4082415" h="778509">
                  <a:moveTo>
                    <a:pt x="947039" y="0"/>
                  </a:moveTo>
                  <a:lnTo>
                    <a:pt x="936625" y="0"/>
                  </a:lnTo>
                  <a:lnTo>
                    <a:pt x="936625" y="778383"/>
                  </a:lnTo>
                  <a:lnTo>
                    <a:pt x="947039" y="778383"/>
                  </a:lnTo>
                  <a:lnTo>
                    <a:pt x="947039" y="0"/>
                  </a:lnTo>
                  <a:close/>
                </a:path>
                <a:path w="4082415" h="778509">
                  <a:moveTo>
                    <a:pt x="1005078" y="311404"/>
                  </a:moveTo>
                  <a:lnTo>
                    <a:pt x="994664" y="311404"/>
                  </a:lnTo>
                  <a:lnTo>
                    <a:pt x="994664" y="778383"/>
                  </a:lnTo>
                  <a:lnTo>
                    <a:pt x="1005078" y="778383"/>
                  </a:lnTo>
                  <a:lnTo>
                    <a:pt x="1005078" y="311404"/>
                  </a:lnTo>
                  <a:close/>
                </a:path>
                <a:path w="4082415" h="778509">
                  <a:moveTo>
                    <a:pt x="1063104" y="280289"/>
                  </a:moveTo>
                  <a:lnTo>
                    <a:pt x="1052703" y="280289"/>
                  </a:lnTo>
                  <a:lnTo>
                    <a:pt x="1052703" y="778383"/>
                  </a:lnTo>
                  <a:lnTo>
                    <a:pt x="1063104" y="778383"/>
                  </a:lnTo>
                  <a:lnTo>
                    <a:pt x="1063104" y="280289"/>
                  </a:lnTo>
                  <a:close/>
                </a:path>
                <a:path w="4082415" h="778509">
                  <a:moveTo>
                    <a:pt x="1121156" y="280289"/>
                  </a:moveTo>
                  <a:lnTo>
                    <a:pt x="1110742" y="280289"/>
                  </a:lnTo>
                  <a:lnTo>
                    <a:pt x="1110742" y="778383"/>
                  </a:lnTo>
                  <a:lnTo>
                    <a:pt x="1121156" y="778383"/>
                  </a:lnTo>
                  <a:lnTo>
                    <a:pt x="1121156" y="280289"/>
                  </a:lnTo>
                  <a:close/>
                </a:path>
                <a:path w="4082415" h="778509">
                  <a:moveTo>
                    <a:pt x="1179322" y="373634"/>
                  </a:moveTo>
                  <a:lnTo>
                    <a:pt x="1168908" y="373634"/>
                  </a:lnTo>
                  <a:lnTo>
                    <a:pt x="1168908" y="778383"/>
                  </a:lnTo>
                  <a:lnTo>
                    <a:pt x="1179322" y="778383"/>
                  </a:lnTo>
                  <a:lnTo>
                    <a:pt x="1179322" y="373634"/>
                  </a:lnTo>
                  <a:close/>
                </a:path>
                <a:path w="4082415" h="778509">
                  <a:moveTo>
                    <a:pt x="1237348" y="466979"/>
                  </a:moveTo>
                  <a:lnTo>
                    <a:pt x="1226947" y="466979"/>
                  </a:lnTo>
                  <a:lnTo>
                    <a:pt x="1226947" y="778383"/>
                  </a:lnTo>
                  <a:lnTo>
                    <a:pt x="1237348" y="778383"/>
                  </a:lnTo>
                  <a:lnTo>
                    <a:pt x="1237348" y="466979"/>
                  </a:lnTo>
                  <a:close/>
                </a:path>
                <a:path w="4082415" h="778509">
                  <a:moveTo>
                    <a:pt x="1295400" y="311404"/>
                  </a:moveTo>
                  <a:lnTo>
                    <a:pt x="1284986" y="311404"/>
                  </a:lnTo>
                  <a:lnTo>
                    <a:pt x="1284986" y="778383"/>
                  </a:lnTo>
                  <a:lnTo>
                    <a:pt x="1295400" y="778383"/>
                  </a:lnTo>
                  <a:lnTo>
                    <a:pt x="1295400" y="311404"/>
                  </a:lnTo>
                  <a:close/>
                </a:path>
                <a:path w="4082415" h="778509">
                  <a:moveTo>
                    <a:pt x="1353439" y="435864"/>
                  </a:moveTo>
                  <a:lnTo>
                    <a:pt x="1343025" y="435864"/>
                  </a:lnTo>
                  <a:lnTo>
                    <a:pt x="1343025" y="778383"/>
                  </a:lnTo>
                  <a:lnTo>
                    <a:pt x="1353439" y="778383"/>
                  </a:lnTo>
                  <a:lnTo>
                    <a:pt x="1353439" y="435864"/>
                  </a:lnTo>
                  <a:close/>
                </a:path>
                <a:path w="4082415" h="778509">
                  <a:moveTo>
                    <a:pt x="1411478" y="249047"/>
                  </a:moveTo>
                  <a:lnTo>
                    <a:pt x="1401064" y="249047"/>
                  </a:lnTo>
                  <a:lnTo>
                    <a:pt x="1401064" y="778383"/>
                  </a:lnTo>
                  <a:lnTo>
                    <a:pt x="1411478" y="778383"/>
                  </a:lnTo>
                  <a:lnTo>
                    <a:pt x="1411478" y="249047"/>
                  </a:lnTo>
                  <a:close/>
                </a:path>
                <a:path w="4082415" h="778509">
                  <a:moveTo>
                    <a:pt x="1469504" y="217932"/>
                  </a:moveTo>
                  <a:lnTo>
                    <a:pt x="1459103" y="217932"/>
                  </a:lnTo>
                  <a:lnTo>
                    <a:pt x="1459103" y="778383"/>
                  </a:lnTo>
                  <a:lnTo>
                    <a:pt x="1469504" y="778383"/>
                  </a:lnTo>
                  <a:lnTo>
                    <a:pt x="1469504" y="217932"/>
                  </a:lnTo>
                  <a:close/>
                </a:path>
                <a:path w="4082415" h="778509">
                  <a:moveTo>
                    <a:pt x="1527556" y="249047"/>
                  </a:moveTo>
                  <a:lnTo>
                    <a:pt x="1517142" y="249047"/>
                  </a:lnTo>
                  <a:lnTo>
                    <a:pt x="1517142" y="778383"/>
                  </a:lnTo>
                  <a:lnTo>
                    <a:pt x="1527556" y="778383"/>
                  </a:lnTo>
                  <a:lnTo>
                    <a:pt x="1527556" y="249047"/>
                  </a:lnTo>
                  <a:close/>
                </a:path>
                <a:path w="4082415" h="778509">
                  <a:moveTo>
                    <a:pt x="1585595" y="435864"/>
                  </a:moveTo>
                  <a:lnTo>
                    <a:pt x="1575181" y="435864"/>
                  </a:lnTo>
                  <a:lnTo>
                    <a:pt x="1575181" y="778383"/>
                  </a:lnTo>
                  <a:lnTo>
                    <a:pt x="1585595" y="778383"/>
                  </a:lnTo>
                  <a:lnTo>
                    <a:pt x="1585595" y="435864"/>
                  </a:lnTo>
                  <a:close/>
                </a:path>
                <a:path w="4082415" h="778509">
                  <a:moveTo>
                    <a:pt x="1643634" y="498221"/>
                  </a:moveTo>
                  <a:lnTo>
                    <a:pt x="1633220" y="498221"/>
                  </a:lnTo>
                  <a:lnTo>
                    <a:pt x="1633220" y="778383"/>
                  </a:lnTo>
                  <a:lnTo>
                    <a:pt x="1643634" y="778383"/>
                  </a:lnTo>
                  <a:lnTo>
                    <a:pt x="1643634" y="498221"/>
                  </a:lnTo>
                  <a:close/>
                </a:path>
                <a:path w="4082415" h="778509">
                  <a:moveTo>
                    <a:pt x="1701660" y="373634"/>
                  </a:moveTo>
                  <a:lnTo>
                    <a:pt x="1691259" y="373634"/>
                  </a:lnTo>
                  <a:lnTo>
                    <a:pt x="1691259" y="778383"/>
                  </a:lnTo>
                  <a:lnTo>
                    <a:pt x="1701660" y="778383"/>
                  </a:lnTo>
                  <a:lnTo>
                    <a:pt x="1701660" y="373634"/>
                  </a:lnTo>
                  <a:close/>
                </a:path>
                <a:path w="4082415" h="778509">
                  <a:moveTo>
                    <a:pt x="1759839" y="342519"/>
                  </a:moveTo>
                  <a:lnTo>
                    <a:pt x="1749425" y="342519"/>
                  </a:lnTo>
                  <a:lnTo>
                    <a:pt x="1749425" y="778383"/>
                  </a:lnTo>
                  <a:lnTo>
                    <a:pt x="1759839" y="778383"/>
                  </a:lnTo>
                  <a:lnTo>
                    <a:pt x="1759839" y="342519"/>
                  </a:lnTo>
                  <a:close/>
                </a:path>
                <a:path w="4082415" h="778509">
                  <a:moveTo>
                    <a:pt x="1817878" y="591566"/>
                  </a:moveTo>
                  <a:lnTo>
                    <a:pt x="1807464" y="591566"/>
                  </a:lnTo>
                  <a:lnTo>
                    <a:pt x="1807464" y="778383"/>
                  </a:lnTo>
                  <a:lnTo>
                    <a:pt x="1817878" y="778383"/>
                  </a:lnTo>
                  <a:lnTo>
                    <a:pt x="1817878" y="591566"/>
                  </a:lnTo>
                  <a:close/>
                </a:path>
                <a:path w="4082415" h="778509">
                  <a:moveTo>
                    <a:pt x="1875904" y="249047"/>
                  </a:moveTo>
                  <a:lnTo>
                    <a:pt x="1865503" y="249047"/>
                  </a:lnTo>
                  <a:lnTo>
                    <a:pt x="1865503" y="778383"/>
                  </a:lnTo>
                  <a:lnTo>
                    <a:pt x="1875904" y="778383"/>
                  </a:lnTo>
                  <a:lnTo>
                    <a:pt x="1875904" y="249047"/>
                  </a:lnTo>
                  <a:close/>
                </a:path>
                <a:path w="4082415" h="778509">
                  <a:moveTo>
                    <a:pt x="1933956" y="249047"/>
                  </a:moveTo>
                  <a:lnTo>
                    <a:pt x="1923542" y="249047"/>
                  </a:lnTo>
                  <a:lnTo>
                    <a:pt x="1923542" y="778383"/>
                  </a:lnTo>
                  <a:lnTo>
                    <a:pt x="1933956" y="778383"/>
                  </a:lnTo>
                  <a:lnTo>
                    <a:pt x="1933956" y="249047"/>
                  </a:lnTo>
                  <a:close/>
                </a:path>
                <a:path w="4082415" h="778509">
                  <a:moveTo>
                    <a:pt x="1991995" y="404749"/>
                  </a:moveTo>
                  <a:lnTo>
                    <a:pt x="1981581" y="404749"/>
                  </a:lnTo>
                  <a:lnTo>
                    <a:pt x="1981581" y="778383"/>
                  </a:lnTo>
                  <a:lnTo>
                    <a:pt x="1991995" y="778383"/>
                  </a:lnTo>
                  <a:lnTo>
                    <a:pt x="1991995" y="404749"/>
                  </a:lnTo>
                  <a:close/>
                </a:path>
                <a:path w="4082415" h="778509">
                  <a:moveTo>
                    <a:pt x="2050034" y="435864"/>
                  </a:moveTo>
                  <a:lnTo>
                    <a:pt x="2039620" y="435864"/>
                  </a:lnTo>
                  <a:lnTo>
                    <a:pt x="2039620" y="778383"/>
                  </a:lnTo>
                  <a:lnTo>
                    <a:pt x="2050034" y="778383"/>
                  </a:lnTo>
                  <a:lnTo>
                    <a:pt x="2050034" y="435864"/>
                  </a:lnTo>
                  <a:close/>
                </a:path>
                <a:path w="4082415" h="778509">
                  <a:moveTo>
                    <a:pt x="2108060" y="311404"/>
                  </a:moveTo>
                  <a:lnTo>
                    <a:pt x="2097659" y="311404"/>
                  </a:lnTo>
                  <a:lnTo>
                    <a:pt x="2097659" y="778383"/>
                  </a:lnTo>
                  <a:lnTo>
                    <a:pt x="2108060" y="778383"/>
                  </a:lnTo>
                  <a:lnTo>
                    <a:pt x="2108060" y="311404"/>
                  </a:lnTo>
                  <a:close/>
                </a:path>
                <a:path w="4082415" h="778509">
                  <a:moveTo>
                    <a:pt x="2166099" y="373634"/>
                  </a:moveTo>
                  <a:lnTo>
                    <a:pt x="2155685" y="373634"/>
                  </a:lnTo>
                  <a:lnTo>
                    <a:pt x="2155685" y="778383"/>
                  </a:lnTo>
                  <a:lnTo>
                    <a:pt x="2166099" y="778383"/>
                  </a:lnTo>
                  <a:lnTo>
                    <a:pt x="2166099" y="373634"/>
                  </a:lnTo>
                  <a:close/>
                </a:path>
                <a:path w="4082415" h="778509">
                  <a:moveTo>
                    <a:pt x="2224138" y="249047"/>
                  </a:moveTo>
                  <a:lnTo>
                    <a:pt x="2213737" y="249047"/>
                  </a:lnTo>
                  <a:lnTo>
                    <a:pt x="2213737" y="778383"/>
                  </a:lnTo>
                  <a:lnTo>
                    <a:pt x="2224138" y="778383"/>
                  </a:lnTo>
                  <a:lnTo>
                    <a:pt x="2224138" y="249047"/>
                  </a:lnTo>
                  <a:close/>
                </a:path>
                <a:path w="4082415" h="778509">
                  <a:moveTo>
                    <a:pt x="2282317" y="249047"/>
                  </a:moveTo>
                  <a:lnTo>
                    <a:pt x="2271903" y="249047"/>
                  </a:lnTo>
                  <a:lnTo>
                    <a:pt x="2271903" y="778383"/>
                  </a:lnTo>
                  <a:lnTo>
                    <a:pt x="2282317" y="778383"/>
                  </a:lnTo>
                  <a:lnTo>
                    <a:pt x="2282317" y="249047"/>
                  </a:lnTo>
                  <a:close/>
                </a:path>
                <a:path w="4082415" h="778509">
                  <a:moveTo>
                    <a:pt x="2340356" y="311404"/>
                  </a:moveTo>
                  <a:lnTo>
                    <a:pt x="2329942" y="311404"/>
                  </a:lnTo>
                  <a:lnTo>
                    <a:pt x="2329942" y="778383"/>
                  </a:lnTo>
                  <a:lnTo>
                    <a:pt x="2340356" y="778383"/>
                  </a:lnTo>
                  <a:lnTo>
                    <a:pt x="2340356" y="311404"/>
                  </a:lnTo>
                  <a:close/>
                </a:path>
                <a:path w="4082415" h="778509">
                  <a:moveTo>
                    <a:pt x="2398395" y="435864"/>
                  </a:moveTo>
                  <a:lnTo>
                    <a:pt x="2387981" y="435864"/>
                  </a:lnTo>
                  <a:lnTo>
                    <a:pt x="2387981" y="778383"/>
                  </a:lnTo>
                  <a:lnTo>
                    <a:pt x="2398395" y="778383"/>
                  </a:lnTo>
                  <a:lnTo>
                    <a:pt x="2398395" y="435864"/>
                  </a:lnTo>
                  <a:close/>
                </a:path>
                <a:path w="4082415" h="778509">
                  <a:moveTo>
                    <a:pt x="2456434" y="435864"/>
                  </a:moveTo>
                  <a:lnTo>
                    <a:pt x="2446020" y="435864"/>
                  </a:lnTo>
                  <a:lnTo>
                    <a:pt x="2446020" y="778383"/>
                  </a:lnTo>
                  <a:lnTo>
                    <a:pt x="2456434" y="778383"/>
                  </a:lnTo>
                  <a:lnTo>
                    <a:pt x="2456434" y="435864"/>
                  </a:lnTo>
                  <a:close/>
                </a:path>
                <a:path w="4082415" h="778509">
                  <a:moveTo>
                    <a:pt x="2514473" y="93472"/>
                  </a:moveTo>
                  <a:lnTo>
                    <a:pt x="2504059" y="93472"/>
                  </a:lnTo>
                  <a:lnTo>
                    <a:pt x="2504059" y="778383"/>
                  </a:lnTo>
                  <a:lnTo>
                    <a:pt x="2514473" y="778383"/>
                  </a:lnTo>
                  <a:lnTo>
                    <a:pt x="2514473" y="93472"/>
                  </a:lnTo>
                  <a:close/>
                </a:path>
                <a:path w="4082415" h="778509">
                  <a:moveTo>
                    <a:pt x="2572512" y="373634"/>
                  </a:moveTo>
                  <a:lnTo>
                    <a:pt x="2562098" y="373634"/>
                  </a:lnTo>
                  <a:lnTo>
                    <a:pt x="2562098" y="778383"/>
                  </a:lnTo>
                  <a:lnTo>
                    <a:pt x="2572512" y="778383"/>
                  </a:lnTo>
                  <a:lnTo>
                    <a:pt x="2572512" y="373634"/>
                  </a:lnTo>
                  <a:close/>
                </a:path>
                <a:path w="4082415" h="778509">
                  <a:moveTo>
                    <a:pt x="2630538" y="186817"/>
                  </a:moveTo>
                  <a:lnTo>
                    <a:pt x="2620137" y="186817"/>
                  </a:lnTo>
                  <a:lnTo>
                    <a:pt x="2620137" y="778383"/>
                  </a:lnTo>
                  <a:lnTo>
                    <a:pt x="2630538" y="778383"/>
                  </a:lnTo>
                  <a:lnTo>
                    <a:pt x="2630538" y="186817"/>
                  </a:lnTo>
                  <a:close/>
                </a:path>
                <a:path w="4082415" h="778509">
                  <a:moveTo>
                    <a:pt x="2688590" y="311404"/>
                  </a:moveTo>
                  <a:lnTo>
                    <a:pt x="2678176" y="311404"/>
                  </a:lnTo>
                  <a:lnTo>
                    <a:pt x="2678176" y="778383"/>
                  </a:lnTo>
                  <a:lnTo>
                    <a:pt x="2688590" y="778383"/>
                  </a:lnTo>
                  <a:lnTo>
                    <a:pt x="2688590" y="311404"/>
                  </a:lnTo>
                  <a:close/>
                </a:path>
                <a:path w="4082415" h="778509">
                  <a:moveTo>
                    <a:pt x="2746629" y="529336"/>
                  </a:moveTo>
                  <a:lnTo>
                    <a:pt x="2736215" y="529336"/>
                  </a:lnTo>
                  <a:lnTo>
                    <a:pt x="2736215" y="778383"/>
                  </a:lnTo>
                  <a:lnTo>
                    <a:pt x="2746629" y="778383"/>
                  </a:lnTo>
                  <a:lnTo>
                    <a:pt x="2746629" y="529336"/>
                  </a:lnTo>
                  <a:close/>
                </a:path>
                <a:path w="4082415" h="778509">
                  <a:moveTo>
                    <a:pt x="2804668" y="342519"/>
                  </a:moveTo>
                  <a:lnTo>
                    <a:pt x="2794254" y="342519"/>
                  </a:lnTo>
                  <a:lnTo>
                    <a:pt x="2794254" y="778383"/>
                  </a:lnTo>
                  <a:lnTo>
                    <a:pt x="2804668" y="778383"/>
                  </a:lnTo>
                  <a:lnTo>
                    <a:pt x="2804668" y="342519"/>
                  </a:lnTo>
                  <a:close/>
                </a:path>
                <a:path w="4082415" h="778509">
                  <a:moveTo>
                    <a:pt x="2862834" y="466979"/>
                  </a:moveTo>
                  <a:lnTo>
                    <a:pt x="2852420" y="466979"/>
                  </a:lnTo>
                  <a:lnTo>
                    <a:pt x="2852420" y="778383"/>
                  </a:lnTo>
                  <a:lnTo>
                    <a:pt x="2862834" y="778383"/>
                  </a:lnTo>
                  <a:lnTo>
                    <a:pt x="2862834" y="466979"/>
                  </a:lnTo>
                  <a:close/>
                </a:path>
                <a:path w="4082415" h="778509">
                  <a:moveTo>
                    <a:pt x="2920873" y="342519"/>
                  </a:moveTo>
                  <a:lnTo>
                    <a:pt x="2910459" y="342519"/>
                  </a:lnTo>
                  <a:lnTo>
                    <a:pt x="2910459" y="778383"/>
                  </a:lnTo>
                  <a:lnTo>
                    <a:pt x="2920873" y="778383"/>
                  </a:lnTo>
                  <a:lnTo>
                    <a:pt x="2920873" y="342519"/>
                  </a:lnTo>
                  <a:close/>
                </a:path>
                <a:path w="4082415" h="778509">
                  <a:moveTo>
                    <a:pt x="2978912" y="124587"/>
                  </a:moveTo>
                  <a:lnTo>
                    <a:pt x="2968498" y="124587"/>
                  </a:lnTo>
                  <a:lnTo>
                    <a:pt x="2968498" y="778383"/>
                  </a:lnTo>
                  <a:lnTo>
                    <a:pt x="2978912" y="778383"/>
                  </a:lnTo>
                  <a:lnTo>
                    <a:pt x="2978912" y="124587"/>
                  </a:lnTo>
                  <a:close/>
                </a:path>
                <a:path w="4082415" h="778509">
                  <a:moveTo>
                    <a:pt x="3036938" y="342519"/>
                  </a:moveTo>
                  <a:lnTo>
                    <a:pt x="3026537" y="342519"/>
                  </a:lnTo>
                  <a:lnTo>
                    <a:pt x="3026537" y="778383"/>
                  </a:lnTo>
                  <a:lnTo>
                    <a:pt x="3036938" y="778383"/>
                  </a:lnTo>
                  <a:lnTo>
                    <a:pt x="3036938" y="342519"/>
                  </a:lnTo>
                  <a:close/>
                </a:path>
                <a:path w="4082415" h="778509">
                  <a:moveTo>
                    <a:pt x="3094990" y="373634"/>
                  </a:moveTo>
                  <a:lnTo>
                    <a:pt x="3084576" y="373634"/>
                  </a:lnTo>
                  <a:lnTo>
                    <a:pt x="3084576" y="778383"/>
                  </a:lnTo>
                  <a:lnTo>
                    <a:pt x="3094990" y="778383"/>
                  </a:lnTo>
                  <a:lnTo>
                    <a:pt x="3094990" y="373634"/>
                  </a:lnTo>
                  <a:close/>
                </a:path>
                <a:path w="4082415" h="778509">
                  <a:moveTo>
                    <a:pt x="3153029" y="342519"/>
                  </a:moveTo>
                  <a:lnTo>
                    <a:pt x="3142615" y="342519"/>
                  </a:lnTo>
                  <a:lnTo>
                    <a:pt x="3142615" y="778383"/>
                  </a:lnTo>
                  <a:lnTo>
                    <a:pt x="3153029" y="778383"/>
                  </a:lnTo>
                  <a:lnTo>
                    <a:pt x="3153029" y="342519"/>
                  </a:lnTo>
                  <a:close/>
                </a:path>
                <a:path w="4082415" h="778509">
                  <a:moveTo>
                    <a:pt x="3211068" y="311404"/>
                  </a:moveTo>
                  <a:lnTo>
                    <a:pt x="3200654" y="311404"/>
                  </a:lnTo>
                  <a:lnTo>
                    <a:pt x="3200654" y="778383"/>
                  </a:lnTo>
                  <a:lnTo>
                    <a:pt x="3211068" y="778383"/>
                  </a:lnTo>
                  <a:lnTo>
                    <a:pt x="3211068" y="311404"/>
                  </a:lnTo>
                  <a:close/>
                </a:path>
                <a:path w="4082415" h="778509">
                  <a:moveTo>
                    <a:pt x="3269107" y="217932"/>
                  </a:moveTo>
                  <a:lnTo>
                    <a:pt x="3258693" y="217932"/>
                  </a:lnTo>
                  <a:lnTo>
                    <a:pt x="3258693" y="778383"/>
                  </a:lnTo>
                  <a:lnTo>
                    <a:pt x="3269107" y="778383"/>
                  </a:lnTo>
                  <a:lnTo>
                    <a:pt x="3269107" y="217932"/>
                  </a:lnTo>
                  <a:close/>
                </a:path>
                <a:path w="4082415" h="778509">
                  <a:moveTo>
                    <a:pt x="3327146" y="560451"/>
                  </a:moveTo>
                  <a:lnTo>
                    <a:pt x="3316732" y="560451"/>
                  </a:lnTo>
                  <a:lnTo>
                    <a:pt x="3316732" y="778383"/>
                  </a:lnTo>
                  <a:lnTo>
                    <a:pt x="3327146" y="778383"/>
                  </a:lnTo>
                  <a:lnTo>
                    <a:pt x="3327146" y="560451"/>
                  </a:lnTo>
                  <a:close/>
                </a:path>
                <a:path w="4082415" h="778509">
                  <a:moveTo>
                    <a:pt x="3385312" y="466979"/>
                  </a:moveTo>
                  <a:lnTo>
                    <a:pt x="3374898" y="466979"/>
                  </a:lnTo>
                  <a:lnTo>
                    <a:pt x="3374898" y="778383"/>
                  </a:lnTo>
                  <a:lnTo>
                    <a:pt x="3385312" y="778383"/>
                  </a:lnTo>
                  <a:lnTo>
                    <a:pt x="3385312" y="466979"/>
                  </a:lnTo>
                  <a:close/>
                </a:path>
                <a:path w="4082415" h="778509">
                  <a:moveTo>
                    <a:pt x="3443338" y="466979"/>
                  </a:moveTo>
                  <a:lnTo>
                    <a:pt x="3432937" y="466979"/>
                  </a:lnTo>
                  <a:lnTo>
                    <a:pt x="3432937" y="778383"/>
                  </a:lnTo>
                  <a:lnTo>
                    <a:pt x="3443338" y="778383"/>
                  </a:lnTo>
                  <a:lnTo>
                    <a:pt x="3443338" y="466979"/>
                  </a:lnTo>
                  <a:close/>
                </a:path>
                <a:path w="4082415" h="778509">
                  <a:moveTo>
                    <a:pt x="3501390" y="280289"/>
                  </a:moveTo>
                  <a:lnTo>
                    <a:pt x="3490976" y="280289"/>
                  </a:lnTo>
                  <a:lnTo>
                    <a:pt x="3490976" y="778383"/>
                  </a:lnTo>
                  <a:lnTo>
                    <a:pt x="3501390" y="778383"/>
                  </a:lnTo>
                  <a:lnTo>
                    <a:pt x="3501390" y="280289"/>
                  </a:lnTo>
                  <a:close/>
                </a:path>
                <a:path w="4082415" h="778509">
                  <a:moveTo>
                    <a:pt x="3559429" y="217932"/>
                  </a:moveTo>
                  <a:lnTo>
                    <a:pt x="3549015" y="217932"/>
                  </a:lnTo>
                  <a:lnTo>
                    <a:pt x="3549015" y="778383"/>
                  </a:lnTo>
                  <a:lnTo>
                    <a:pt x="3559429" y="778383"/>
                  </a:lnTo>
                  <a:lnTo>
                    <a:pt x="3559429" y="217932"/>
                  </a:lnTo>
                  <a:close/>
                </a:path>
                <a:path w="4082415" h="778509">
                  <a:moveTo>
                    <a:pt x="3617468" y="404749"/>
                  </a:moveTo>
                  <a:lnTo>
                    <a:pt x="3607054" y="404749"/>
                  </a:lnTo>
                  <a:lnTo>
                    <a:pt x="3607054" y="778383"/>
                  </a:lnTo>
                  <a:lnTo>
                    <a:pt x="3617468" y="778383"/>
                  </a:lnTo>
                  <a:lnTo>
                    <a:pt x="3617468" y="404749"/>
                  </a:lnTo>
                  <a:close/>
                </a:path>
                <a:path w="4082415" h="778509">
                  <a:moveTo>
                    <a:pt x="3675507" y="498221"/>
                  </a:moveTo>
                  <a:lnTo>
                    <a:pt x="3665093" y="498221"/>
                  </a:lnTo>
                  <a:lnTo>
                    <a:pt x="3665093" y="778383"/>
                  </a:lnTo>
                  <a:lnTo>
                    <a:pt x="3675507" y="778383"/>
                  </a:lnTo>
                  <a:lnTo>
                    <a:pt x="3675507" y="498221"/>
                  </a:lnTo>
                  <a:close/>
                </a:path>
                <a:path w="4082415" h="778509">
                  <a:moveTo>
                    <a:pt x="3733546" y="498221"/>
                  </a:moveTo>
                  <a:lnTo>
                    <a:pt x="3723132" y="498221"/>
                  </a:lnTo>
                  <a:lnTo>
                    <a:pt x="3723132" y="778383"/>
                  </a:lnTo>
                  <a:lnTo>
                    <a:pt x="3733546" y="778383"/>
                  </a:lnTo>
                  <a:lnTo>
                    <a:pt x="3733546" y="498221"/>
                  </a:lnTo>
                  <a:close/>
                </a:path>
                <a:path w="4082415" h="778509">
                  <a:moveTo>
                    <a:pt x="3791585" y="280289"/>
                  </a:moveTo>
                  <a:lnTo>
                    <a:pt x="3781171" y="280289"/>
                  </a:lnTo>
                  <a:lnTo>
                    <a:pt x="3781171" y="778383"/>
                  </a:lnTo>
                  <a:lnTo>
                    <a:pt x="3791585" y="778383"/>
                  </a:lnTo>
                  <a:lnTo>
                    <a:pt x="3791585" y="280289"/>
                  </a:lnTo>
                  <a:close/>
                </a:path>
                <a:path w="4082415" h="778509">
                  <a:moveTo>
                    <a:pt x="3849624" y="342519"/>
                  </a:moveTo>
                  <a:lnTo>
                    <a:pt x="3839210" y="342519"/>
                  </a:lnTo>
                  <a:lnTo>
                    <a:pt x="3839210" y="778383"/>
                  </a:lnTo>
                  <a:lnTo>
                    <a:pt x="3849624" y="778383"/>
                  </a:lnTo>
                  <a:lnTo>
                    <a:pt x="3849624" y="342519"/>
                  </a:lnTo>
                  <a:close/>
                </a:path>
                <a:path w="4082415" h="778509">
                  <a:moveTo>
                    <a:pt x="3907790" y="435864"/>
                  </a:moveTo>
                  <a:lnTo>
                    <a:pt x="3897376" y="435864"/>
                  </a:lnTo>
                  <a:lnTo>
                    <a:pt x="3897376" y="778383"/>
                  </a:lnTo>
                  <a:lnTo>
                    <a:pt x="3907790" y="778383"/>
                  </a:lnTo>
                  <a:lnTo>
                    <a:pt x="3907790" y="435864"/>
                  </a:lnTo>
                  <a:close/>
                </a:path>
                <a:path w="4082415" h="778509">
                  <a:moveTo>
                    <a:pt x="3965829" y="186817"/>
                  </a:moveTo>
                  <a:lnTo>
                    <a:pt x="3955415" y="186817"/>
                  </a:lnTo>
                  <a:lnTo>
                    <a:pt x="3955415" y="778383"/>
                  </a:lnTo>
                  <a:lnTo>
                    <a:pt x="3965829" y="778383"/>
                  </a:lnTo>
                  <a:lnTo>
                    <a:pt x="3965829" y="186817"/>
                  </a:lnTo>
                  <a:close/>
                </a:path>
                <a:path w="4082415" h="778509">
                  <a:moveTo>
                    <a:pt x="4023868" y="373634"/>
                  </a:moveTo>
                  <a:lnTo>
                    <a:pt x="4013454" y="373634"/>
                  </a:lnTo>
                  <a:lnTo>
                    <a:pt x="4013454" y="778383"/>
                  </a:lnTo>
                  <a:lnTo>
                    <a:pt x="4023868" y="778383"/>
                  </a:lnTo>
                  <a:lnTo>
                    <a:pt x="4023868" y="373634"/>
                  </a:lnTo>
                  <a:close/>
                </a:path>
                <a:path w="4082415" h="778509">
                  <a:moveTo>
                    <a:pt x="4081907" y="249047"/>
                  </a:moveTo>
                  <a:lnTo>
                    <a:pt x="4071493" y="249047"/>
                  </a:lnTo>
                  <a:lnTo>
                    <a:pt x="4071493" y="778383"/>
                  </a:lnTo>
                  <a:lnTo>
                    <a:pt x="4081907" y="778383"/>
                  </a:lnTo>
                  <a:lnTo>
                    <a:pt x="4081907" y="249047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1" name="object 111" descr=""/>
            <p:cNvSpPr/>
            <p:nvPr/>
          </p:nvSpPr>
          <p:spPr>
            <a:xfrm>
              <a:off x="5209286" y="8008620"/>
              <a:ext cx="4074160" cy="654050"/>
            </a:xfrm>
            <a:custGeom>
              <a:avLst/>
              <a:gdLst/>
              <a:ahLst/>
              <a:cxnLst/>
              <a:rect l="l" t="t" r="r" b="b"/>
              <a:pathLst>
                <a:path w="4074159" h="654050">
                  <a:moveTo>
                    <a:pt x="10414" y="124460"/>
                  </a:moveTo>
                  <a:lnTo>
                    <a:pt x="0" y="124460"/>
                  </a:lnTo>
                  <a:lnTo>
                    <a:pt x="0" y="653796"/>
                  </a:lnTo>
                  <a:lnTo>
                    <a:pt x="10414" y="653796"/>
                  </a:lnTo>
                  <a:lnTo>
                    <a:pt x="10414" y="124460"/>
                  </a:lnTo>
                  <a:close/>
                </a:path>
                <a:path w="4074159" h="654050">
                  <a:moveTo>
                    <a:pt x="68453" y="280162"/>
                  </a:moveTo>
                  <a:lnTo>
                    <a:pt x="58039" y="280162"/>
                  </a:lnTo>
                  <a:lnTo>
                    <a:pt x="58039" y="653796"/>
                  </a:lnTo>
                  <a:lnTo>
                    <a:pt x="68453" y="653796"/>
                  </a:lnTo>
                  <a:lnTo>
                    <a:pt x="68453" y="280162"/>
                  </a:lnTo>
                  <a:close/>
                </a:path>
                <a:path w="4074159" h="654050">
                  <a:moveTo>
                    <a:pt x="126492" y="342392"/>
                  </a:moveTo>
                  <a:lnTo>
                    <a:pt x="116078" y="342392"/>
                  </a:lnTo>
                  <a:lnTo>
                    <a:pt x="116078" y="653796"/>
                  </a:lnTo>
                  <a:lnTo>
                    <a:pt x="126492" y="653796"/>
                  </a:lnTo>
                  <a:lnTo>
                    <a:pt x="126492" y="342392"/>
                  </a:lnTo>
                  <a:close/>
                </a:path>
                <a:path w="4074159" h="654050">
                  <a:moveTo>
                    <a:pt x="184531" y="124460"/>
                  </a:moveTo>
                  <a:lnTo>
                    <a:pt x="174117" y="124460"/>
                  </a:lnTo>
                  <a:lnTo>
                    <a:pt x="174117" y="653796"/>
                  </a:lnTo>
                  <a:lnTo>
                    <a:pt x="184531" y="653796"/>
                  </a:lnTo>
                  <a:lnTo>
                    <a:pt x="184531" y="124460"/>
                  </a:lnTo>
                  <a:close/>
                </a:path>
                <a:path w="4074159" h="654050">
                  <a:moveTo>
                    <a:pt x="242570" y="124460"/>
                  </a:moveTo>
                  <a:lnTo>
                    <a:pt x="232156" y="124460"/>
                  </a:lnTo>
                  <a:lnTo>
                    <a:pt x="232156" y="653796"/>
                  </a:lnTo>
                  <a:lnTo>
                    <a:pt x="242570" y="653796"/>
                  </a:lnTo>
                  <a:lnTo>
                    <a:pt x="242570" y="124460"/>
                  </a:lnTo>
                  <a:close/>
                </a:path>
                <a:path w="4074159" h="654050">
                  <a:moveTo>
                    <a:pt x="300596" y="311277"/>
                  </a:moveTo>
                  <a:lnTo>
                    <a:pt x="290195" y="311277"/>
                  </a:lnTo>
                  <a:lnTo>
                    <a:pt x="290195" y="653796"/>
                  </a:lnTo>
                  <a:lnTo>
                    <a:pt x="300596" y="653796"/>
                  </a:lnTo>
                  <a:lnTo>
                    <a:pt x="300596" y="311277"/>
                  </a:lnTo>
                  <a:close/>
                </a:path>
                <a:path w="4074159" h="654050">
                  <a:moveTo>
                    <a:pt x="358648" y="155702"/>
                  </a:moveTo>
                  <a:lnTo>
                    <a:pt x="348234" y="155702"/>
                  </a:lnTo>
                  <a:lnTo>
                    <a:pt x="348234" y="653796"/>
                  </a:lnTo>
                  <a:lnTo>
                    <a:pt x="358648" y="653796"/>
                  </a:lnTo>
                  <a:lnTo>
                    <a:pt x="358648" y="155702"/>
                  </a:lnTo>
                  <a:close/>
                </a:path>
                <a:path w="4074159" h="654050">
                  <a:moveTo>
                    <a:pt x="416814" y="311277"/>
                  </a:moveTo>
                  <a:lnTo>
                    <a:pt x="406400" y="311277"/>
                  </a:lnTo>
                  <a:lnTo>
                    <a:pt x="406400" y="653796"/>
                  </a:lnTo>
                  <a:lnTo>
                    <a:pt x="416814" y="653796"/>
                  </a:lnTo>
                  <a:lnTo>
                    <a:pt x="416814" y="311277"/>
                  </a:lnTo>
                  <a:close/>
                </a:path>
                <a:path w="4074159" h="654050">
                  <a:moveTo>
                    <a:pt x="474853" y="155702"/>
                  </a:moveTo>
                  <a:lnTo>
                    <a:pt x="464439" y="155702"/>
                  </a:lnTo>
                  <a:lnTo>
                    <a:pt x="464439" y="653796"/>
                  </a:lnTo>
                  <a:lnTo>
                    <a:pt x="474853" y="653796"/>
                  </a:lnTo>
                  <a:lnTo>
                    <a:pt x="474853" y="155702"/>
                  </a:lnTo>
                  <a:close/>
                </a:path>
                <a:path w="4074159" h="654050">
                  <a:moveTo>
                    <a:pt x="532892" y="217932"/>
                  </a:moveTo>
                  <a:lnTo>
                    <a:pt x="522478" y="217932"/>
                  </a:lnTo>
                  <a:lnTo>
                    <a:pt x="522478" y="653796"/>
                  </a:lnTo>
                  <a:lnTo>
                    <a:pt x="532892" y="653796"/>
                  </a:lnTo>
                  <a:lnTo>
                    <a:pt x="532892" y="217932"/>
                  </a:lnTo>
                  <a:close/>
                </a:path>
                <a:path w="4074159" h="654050">
                  <a:moveTo>
                    <a:pt x="590931" y="124460"/>
                  </a:moveTo>
                  <a:lnTo>
                    <a:pt x="580517" y="124460"/>
                  </a:lnTo>
                  <a:lnTo>
                    <a:pt x="580517" y="653796"/>
                  </a:lnTo>
                  <a:lnTo>
                    <a:pt x="590931" y="653796"/>
                  </a:lnTo>
                  <a:lnTo>
                    <a:pt x="590931" y="124460"/>
                  </a:lnTo>
                  <a:close/>
                </a:path>
                <a:path w="4074159" h="654050">
                  <a:moveTo>
                    <a:pt x="648970" y="311277"/>
                  </a:moveTo>
                  <a:lnTo>
                    <a:pt x="638556" y="311277"/>
                  </a:lnTo>
                  <a:lnTo>
                    <a:pt x="638556" y="653796"/>
                  </a:lnTo>
                  <a:lnTo>
                    <a:pt x="648970" y="653796"/>
                  </a:lnTo>
                  <a:lnTo>
                    <a:pt x="648970" y="311277"/>
                  </a:lnTo>
                  <a:close/>
                </a:path>
                <a:path w="4074159" h="654050">
                  <a:moveTo>
                    <a:pt x="706996" y="342392"/>
                  </a:moveTo>
                  <a:lnTo>
                    <a:pt x="696595" y="342392"/>
                  </a:lnTo>
                  <a:lnTo>
                    <a:pt x="696595" y="653796"/>
                  </a:lnTo>
                  <a:lnTo>
                    <a:pt x="706996" y="653796"/>
                  </a:lnTo>
                  <a:lnTo>
                    <a:pt x="706996" y="342392"/>
                  </a:lnTo>
                  <a:close/>
                </a:path>
                <a:path w="4074159" h="654050">
                  <a:moveTo>
                    <a:pt x="765048" y="466979"/>
                  </a:moveTo>
                  <a:lnTo>
                    <a:pt x="754634" y="466979"/>
                  </a:lnTo>
                  <a:lnTo>
                    <a:pt x="754634" y="653796"/>
                  </a:lnTo>
                  <a:lnTo>
                    <a:pt x="765048" y="653796"/>
                  </a:lnTo>
                  <a:lnTo>
                    <a:pt x="765048" y="466979"/>
                  </a:lnTo>
                  <a:close/>
                </a:path>
                <a:path w="4074159" h="654050">
                  <a:moveTo>
                    <a:pt x="823087" y="311277"/>
                  </a:moveTo>
                  <a:lnTo>
                    <a:pt x="812673" y="311277"/>
                  </a:lnTo>
                  <a:lnTo>
                    <a:pt x="812673" y="653796"/>
                  </a:lnTo>
                  <a:lnTo>
                    <a:pt x="823087" y="653796"/>
                  </a:lnTo>
                  <a:lnTo>
                    <a:pt x="823087" y="311277"/>
                  </a:lnTo>
                  <a:close/>
                </a:path>
                <a:path w="4074159" h="654050">
                  <a:moveTo>
                    <a:pt x="881126" y="529209"/>
                  </a:moveTo>
                  <a:lnTo>
                    <a:pt x="870712" y="529209"/>
                  </a:lnTo>
                  <a:lnTo>
                    <a:pt x="870712" y="653796"/>
                  </a:lnTo>
                  <a:lnTo>
                    <a:pt x="881126" y="653796"/>
                  </a:lnTo>
                  <a:lnTo>
                    <a:pt x="881126" y="529209"/>
                  </a:lnTo>
                  <a:close/>
                </a:path>
                <a:path w="4074159" h="654050">
                  <a:moveTo>
                    <a:pt x="939292" y="498094"/>
                  </a:moveTo>
                  <a:lnTo>
                    <a:pt x="928878" y="498094"/>
                  </a:lnTo>
                  <a:lnTo>
                    <a:pt x="928878" y="653796"/>
                  </a:lnTo>
                  <a:lnTo>
                    <a:pt x="939292" y="653796"/>
                  </a:lnTo>
                  <a:lnTo>
                    <a:pt x="939292" y="498094"/>
                  </a:lnTo>
                  <a:close/>
                </a:path>
                <a:path w="4074159" h="654050">
                  <a:moveTo>
                    <a:pt x="997331" y="280162"/>
                  </a:moveTo>
                  <a:lnTo>
                    <a:pt x="986917" y="280162"/>
                  </a:lnTo>
                  <a:lnTo>
                    <a:pt x="986917" y="653796"/>
                  </a:lnTo>
                  <a:lnTo>
                    <a:pt x="997331" y="653796"/>
                  </a:lnTo>
                  <a:lnTo>
                    <a:pt x="997331" y="280162"/>
                  </a:lnTo>
                  <a:close/>
                </a:path>
                <a:path w="4074159" h="654050">
                  <a:moveTo>
                    <a:pt x="1055370" y="311277"/>
                  </a:moveTo>
                  <a:lnTo>
                    <a:pt x="1044956" y="311277"/>
                  </a:lnTo>
                  <a:lnTo>
                    <a:pt x="1044956" y="653796"/>
                  </a:lnTo>
                  <a:lnTo>
                    <a:pt x="1055370" y="653796"/>
                  </a:lnTo>
                  <a:lnTo>
                    <a:pt x="1055370" y="311277"/>
                  </a:lnTo>
                  <a:close/>
                </a:path>
                <a:path w="4074159" h="654050">
                  <a:moveTo>
                    <a:pt x="1113396" y="217932"/>
                  </a:moveTo>
                  <a:lnTo>
                    <a:pt x="1102995" y="217932"/>
                  </a:lnTo>
                  <a:lnTo>
                    <a:pt x="1102995" y="653796"/>
                  </a:lnTo>
                  <a:lnTo>
                    <a:pt x="1113396" y="653796"/>
                  </a:lnTo>
                  <a:lnTo>
                    <a:pt x="1113396" y="217932"/>
                  </a:lnTo>
                  <a:close/>
                </a:path>
                <a:path w="4074159" h="654050">
                  <a:moveTo>
                    <a:pt x="1171448" y="186817"/>
                  </a:moveTo>
                  <a:lnTo>
                    <a:pt x="1161034" y="186817"/>
                  </a:lnTo>
                  <a:lnTo>
                    <a:pt x="1161034" y="653796"/>
                  </a:lnTo>
                  <a:lnTo>
                    <a:pt x="1171448" y="653796"/>
                  </a:lnTo>
                  <a:lnTo>
                    <a:pt x="1171448" y="186817"/>
                  </a:lnTo>
                  <a:close/>
                </a:path>
                <a:path w="4074159" h="654050">
                  <a:moveTo>
                    <a:pt x="1229487" y="0"/>
                  </a:moveTo>
                  <a:lnTo>
                    <a:pt x="1219073" y="0"/>
                  </a:lnTo>
                  <a:lnTo>
                    <a:pt x="1219073" y="653796"/>
                  </a:lnTo>
                  <a:lnTo>
                    <a:pt x="1229487" y="653796"/>
                  </a:lnTo>
                  <a:lnTo>
                    <a:pt x="1229487" y="0"/>
                  </a:lnTo>
                  <a:close/>
                </a:path>
                <a:path w="4074159" h="654050">
                  <a:moveTo>
                    <a:pt x="1287526" y="404749"/>
                  </a:moveTo>
                  <a:lnTo>
                    <a:pt x="1277112" y="404749"/>
                  </a:lnTo>
                  <a:lnTo>
                    <a:pt x="1277112" y="653796"/>
                  </a:lnTo>
                  <a:lnTo>
                    <a:pt x="1287526" y="653796"/>
                  </a:lnTo>
                  <a:lnTo>
                    <a:pt x="1287526" y="404749"/>
                  </a:lnTo>
                  <a:close/>
                </a:path>
                <a:path w="4074159" h="654050">
                  <a:moveTo>
                    <a:pt x="1345565" y="217932"/>
                  </a:moveTo>
                  <a:lnTo>
                    <a:pt x="1335138" y="217932"/>
                  </a:lnTo>
                  <a:lnTo>
                    <a:pt x="1335138" y="653796"/>
                  </a:lnTo>
                  <a:lnTo>
                    <a:pt x="1345565" y="653796"/>
                  </a:lnTo>
                  <a:lnTo>
                    <a:pt x="1345565" y="217932"/>
                  </a:lnTo>
                  <a:close/>
                </a:path>
                <a:path w="4074159" h="654050">
                  <a:moveTo>
                    <a:pt x="1403604" y="466979"/>
                  </a:moveTo>
                  <a:lnTo>
                    <a:pt x="1393190" y="466979"/>
                  </a:lnTo>
                  <a:lnTo>
                    <a:pt x="1393190" y="653796"/>
                  </a:lnTo>
                  <a:lnTo>
                    <a:pt x="1403604" y="653796"/>
                  </a:lnTo>
                  <a:lnTo>
                    <a:pt x="1403604" y="466979"/>
                  </a:lnTo>
                  <a:close/>
                </a:path>
                <a:path w="4074159" h="654050">
                  <a:moveTo>
                    <a:pt x="1461770" y="373634"/>
                  </a:moveTo>
                  <a:lnTo>
                    <a:pt x="1451356" y="373634"/>
                  </a:lnTo>
                  <a:lnTo>
                    <a:pt x="1451356" y="653796"/>
                  </a:lnTo>
                  <a:lnTo>
                    <a:pt x="1461770" y="653796"/>
                  </a:lnTo>
                  <a:lnTo>
                    <a:pt x="1461770" y="373634"/>
                  </a:lnTo>
                  <a:close/>
                </a:path>
                <a:path w="4074159" h="654050">
                  <a:moveTo>
                    <a:pt x="1519809" y="342392"/>
                  </a:moveTo>
                  <a:lnTo>
                    <a:pt x="1509395" y="342392"/>
                  </a:lnTo>
                  <a:lnTo>
                    <a:pt x="1509395" y="653796"/>
                  </a:lnTo>
                  <a:lnTo>
                    <a:pt x="1519809" y="653796"/>
                  </a:lnTo>
                  <a:lnTo>
                    <a:pt x="1519809" y="342392"/>
                  </a:lnTo>
                  <a:close/>
                </a:path>
                <a:path w="4074159" h="654050">
                  <a:moveTo>
                    <a:pt x="1577848" y="155702"/>
                  </a:moveTo>
                  <a:lnTo>
                    <a:pt x="1567434" y="155702"/>
                  </a:lnTo>
                  <a:lnTo>
                    <a:pt x="1567434" y="653796"/>
                  </a:lnTo>
                  <a:lnTo>
                    <a:pt x="1577848" y="653796"/>
                  </a:lnTo>
                  <a:lnTo>
                    <a:pt x="1577848" y="155702"/>
                  </a:lnTo>
                  <a:close/>
                </a:path>
                <a:path w="4074159" h="654050">
                  <a:moveTo>
                    <a:pt x="1635887" y="249047"/>
                  </a:moveTo>
                  <a:lnTo>
                    <a:pt x="1625473" y="249047"/>
                  </a:lnTo>
                  <a:lnTo>
                    <a:pt x="1625473" y="653796"/>
                  </a:lnTo>
                  <a:lnTo>
                    <a:pt x="1635887" y="653796"/>
                  </a:lnTo>
                  <a:lnTo>
                    <a:pt x="1635887" y="249047"/>
                  </a:lnTo>
                  <a:close/>
                </a:path>
                <a:path w="4074159" h="654050">
                  <a:moveTo>
                    <a:pt x="1693926" y="466979"/>
                  </a:moveTo>
                  <a:lnTo>
                    <a:pt x="1683512" y="466979"/>
                  </a:lnTo>
                  <a:lnTo>
                    <a:pt x="1683512" y="653796"/>
                  </a:lnTo>
                  <a:lnTo>
                    <a:pt x="1693926" y="653796"/>
                  </a:lnTo>
                  <a:lnTo>
                    <a:pt x="1693926" y="466979"/>
                  </a:lnTo>
                  <a:close/>
                </a:path>
                <a:path w="4074159" h="654050">
                  <a:moveTo>
                    <a:pt x="1751965" y="373634"/>
                  </a:moveTo>
                  <a:lnTo>
                    <a:pt x="1741551" y="373634"/>
                  </a:lnTo>
                  <a:lnTo>
                    <a:pt x="1741551" y="653796"/>
                  </a:lnTo>
                  <a:lnTo>
                    <a:pt x="1751965" y="653796"/>
                  </a:lnTo>
                  <a:lnTo>
                    <a:pt x="1751965" y="373634"/>
                  </a:lnTo>
                  <a:close/>
                </a:path>
                <a:path w="4074159" h="654050">
                  <a:moveTo>
                    <a:pt x="1810004" y="373634"/>
                  </a:moveTo>
                  <a:lnTo>
                    <a:pt x="1799590" y="373634"/>
                  </a:lnTo>
                  <a:lnTo>
                    <a:pt x="1799590" y="653796"/>
                  </a:lnTo>
                  <a:lnTo>
                    <a:pt x="1810004" y="653796"/>
                  </a:lnTo>
                  <a:lnTo>
                    <a:pt x="1810004" y="373634"/>
                  </a:lnTo>
                  <a:close/>
                </a:path>
                <a:path w="4074159" h="654050">
                  <a:moveTo>
                    <a:pt x="1868043" y="404749"/>
                  </a:moveTo>
                  <a:lnTo>
                    <a:pt x="1857629" y="404749"/>
                  </a:lnTo>
                  <a:lnTo>
                    <a:pt x="1857629" y="653796"/>
                  </a:lnTo>
                  <a:lnTo>
                    <a:pt x="1868043" y="653796"/>
                  </a:lnTo>
                  <a:lnTo>
                    <a:pt x="1868043" y="404749"/>
                  </a:lnTo>
                  <a:close/>
                </a:path>
                <a:path w="4074159" h="654050">
                  <a:moveTo>
                    <a:pt x="1926082" y="311277"/>
                  </a:moveTo>
                  <a:lnTo>
                    <a:pt x="1915668" y="311277"/>
                  </a:lnTo>
                  <a:lnTo>
                    <a:pt x="1915668" y="653796"/>
                  </a:lnTo>
                  <a:lnTo>
                    <a:pt x="1926082" y="653796"/>
                  </a:lnTo>
                  <a:lnTo>
                    <a:pt x="1926082" y="311277"/>
                  </a:lnTo>
                  <a:close/>
                </a:path>
                <a:path w="4074159" h="654050">
                  <a:moveTo>
                    <a:pt x="1984121" y="311277"/>
                  </a:moveTo>
                  <a:lnTo>
                    <a:pt x="1973707" y="311277"/>
                  </a:lnTo>
                  <a:lnTo>
                    <a:pt x="1973707" y="653796"/>
                  </a:lnTo>
                  <a:lnTo>
                    <a:pt x="1984121" y="653796"/>
                  </a:lnTo>
                  <a:lnTo>
                    <a:pt x="1984121" y="311277"/>
                  </a:lnTo>
                  <a:close/>
                </a:path>
                <a:path w="4074159" h="654050">
                  <a:moveTo>
                    <a:pt x="2042287" y="498094"/>
                  </a:moveTo>
                  <a:lnTo>
                    <a:pt x="2031873" y="498094"/>
                  </a:lnTo>
                  <a:lnTo>
                    <a:pt x="2031873" y="653796"/>
                  </a:lnTo>
                  <a:lnTo>
                    <a:pt x="2042287" y="653796"/>
                  </a:lnTo>
                  <a:lnTo>
                    <a:pt x="2042287" y="498094"/>
                  </a:lnTo>
                  <a:close/>
                </a:path>
                <a:path w="4074159" h="654050">
                  <a:moveTo>
                    <a:pt x="2100326" y="560451"/>
                  </a:moveTo>
                  <a:lnTo>
                    <a:pt x="2089912" y="560451"/>
                  </a:lnTo>
                  <a:lnTo>
                    <a:pt x="2089912" y="653796"/>
                  </a:lnTo>
                  <a:lnTo>
                    <a:pt x="2100326" y="653796"/>
                  </a:lnTo>
                  <a:lnTo>
                    <a:pt x="2100326" y="560451"/>
                  </a:lnTo>
                  <a:close/>
                </a:path>
                <a:path w="4074159" h="654050">
                  <a:moveTo>
                    <a:pt x="2158365" y="373634"/>
                  </a:moveTo>
                  <a:lnTo>
                    <a:pt x="2147951" y="373634"/>
                  </a:lnTo>
                  <a:lnTo>
                    <a:pt x="2147951" y="653796"/>
                  </a:lnTo>
                  <a:lnTo>
                    <a:pt x="2158365" y="653796"/>
                  </a:lnTo>
                  <a:lnTo>
                    <a:pt x="2158365" y="373634"/>
                  </a:lnTo>
                  <a:close/>
                </a:path>
                <a:path w="4074159" h="654050">
                  <a:moveTo>
                    <a:pt x="2216404" y="311277"/>
                  </a:moveTo>
                  <a:lnTo>
                    <a:pt x="2205990" y="311277"/>
                  </a:lnTo>
                  <a:lnTo>
                    <a:pt x="2205990" y="653796"/>
                  </a:lnTo>
                  <a:lnTo>
                    <a:pt x="2216404" y="653796"/>
                  </a:lnTo>
                  <a:lnTo>
                    <a:pt x="2216404" y="311277"/>
                  </a:lnTo>
                  <a:close/>
                </a:path>
                <a:path w="4074159" h="654050">
                  <a:moveTo>
                    <a:pt x="2274443" y="404749"/>
                  </a:moveTo>
                  <a:lnTo>
                    <a:pt x="2264029" y="404749"/>
                  </a:lnTo>
                  <a:lnTo>
                    <a:pt x="2264029" y="653796"/>
                  </a:lnTo>
                  <a:lnTo>
                    <a:pt x="2274443" y="653796"/>
                  </a:lnTo>
                  <a:lnTo>
                    <a:pt x="2274443" y="404749"/>
                  </a:lnTo>
                  <a:close/>
                </a:path>
                <a:path w="4074159" h="654050">
                  <a:moveTo>
                    <a:pt x="2332482" y="249047"/>
                  </a:moveTo>
                  <a:lnTo>
                    <a:pt x="2322068" y="249047"/>
                  </a:lnTo>
                  <a:lnTo>
                    <a:pt x="2322068" y="653796"/>
                  </a:lnTo>
                  <a:lnTo>
                    <a:pt x="2332482" y="653796"/>
                  </a:lnTo>
                  <a:lnTo>
                    <a:pt x="2332482" y="249047"/>
                  </a:lnTo>
                  <a:close/>
                </a:path>
                <a:path w="4074159" h="654050">
                  <a:moveTo>
                    <a:pt x="2390521" y="311277"/>
                  </a:moveTo>
                  <a:lnTo>
                    <a:pt x="2380107" y="311277"/>
                  </a:lnTo>
                  <a:lnTo>
                    <a:pt x="2380107" y="653796"/>
                  </a:lnTo>
                  <a:lnTo>
                    <a:pt x="2390521" y="653796"/>
                  </a:lnTo>
                  <a:lnTo>
                    <a:pt x="2390521" y="311277"/>
                  </a:lnTo>
                  <a:close/>
                </a:path>
                <a:path w="4074159" h="654050">
                  <a:moveTo>
                    <a:pt x="2448560" y="373634"/>
                  </a:moveTo>
                  <a:lnTo>
                    <a:pt x="2438146" y="373634"/>
                  </a:lnTo>
                  <a:lnTo>
                    <a:pt x="2438146" y="653796"/>
                  </a:lnTo>
                  <a:lnTo>
                    <a:pt x="2448560" y="653796"/>
                  </a:lnTo>
                  <a:lnTo>
                    <a:pt x="2448560" y="373634"/>
                  </a:lnTo>
                  <a:close/>
                </a:path>
                <a:path w="4074159" h="654050">
                  <a:moveTo>
                    <a:pt x="2506599" y="342392"/>
                  </a:moveTo>
                  <a:lnTo>
                    <a:pt x="2496185" y="342392"/>
                  </a:lnTo>
                  <a:lnTo>
                    <a:pt x="2496185" y="653796"/>
                  </a:lnTo>
                  <a:lnTo>
                    <a:pt x="2506599" y="653796"/>
                  </a:lnTo>
                  <a:lnTo>
                    <a:pt x="2506599" y="342392"/>
                  </a:lnTo>
                  <a:close/>
                </a:path>
                <a:path w="4074159" h="654050">
                  <a:moveTo>
                    <a:pt x="2564765" y="342392"/>
                  </a:moveTo>
                  <a:lnTo>
                    <a:pt x="2554351" y="342392"/>
                  </a:lnTo>
                  <a:lnTo>
                    <a:pt x="2554351" y="653796"/>
                  </a:lnTo>
                  <a:lnTo>
                    <a:pt x="2564765" y="653796"/>
                  </a:lnTo>
                  <a:lnTo>
                    <a:pt x="2564765" y="342392"/>
                  </a:lnTo>
                  <a:close/>
                </a:path>
                <a:path w="4074159" h="654050">
                  <a:moveTo>
                    <a:pt x="2622804" y="311277"/>
                  </a:moveTo>
                  <a:lnTo>
                    <a:pt x="2612390" y="311277"/>
                  </a:lnTo>
                  <a:lnTo>
                    <a:pt x="2612390" y="653796"/>
                  </a:lnTo>
                  <a:lnTo>
                    <a:pt x="2622804" y="653796"/>
                  </a:lnTo>
                  <a:lnTo>
                    <a:pt x="2622804" y="311277"/>
                  </a:lnTo>
                  <a:close/>
                </a:path>
                <a:path w="4074159" h="654050">
                  <a:moveTo>
                    <a:pt x="2680843" y="435864"/>
                  </a:moveTo>
                  <a:lnTo>
                    <a:pt x="2670429" y="435864"/>
                  </a:lnTo>
                  <a:lnTo>
                    <a:pt x="2670429" y="653796"/>
                  </a:lnTo>
                  <a:lnTo>
                    <a:pt x="2680843" y="653796"/>
                  </a:lnTo>
                  <a:lnTo>
                    <a:pt x="2680843" y="435864"/>
                  </a:lnTo>
                  <a:close/>
                </a:path>
                <a:path w="4074159" h="654050">
                  <a:moveTo>
                    <a:pt x="2738882" y="404749"/>
                  </a:moveTo>
                  <a:lnTo>
                    <a:pt x="2728468" y="404749"/>
                  </a:lnTo>
                  <a:lnTo>
                    <a:pt x="2728468" y="653796"/>
                  </a:lnTo>
                  <a:lnTo>
                    <a:pt x="2738882" y="653796"/>
                  </a:lnTo>
                  <a:lnTo>
                    <a:pt x="2738882" y="404749"/>
                  </a:lnTo>
                  <a:close/>
                </a:path>
                <a:path w="4074159" h="654050">
                  <a:moveTo>
                    <a:pt x="2796921" y="186817"/>
                  </a:moveTo>
                  <a:lnTo>
                    <a:pt x="2786507" y="186817"/>
                  </a:lnTo>
                  <a:lnTo>
                    <a:pt x="2786507" y="653796"/>
                  </a:lnTo>
                  <a:lnTo>
                    <a:pt x="2796921" y="653796"/>
                  </a:lnTo>
                  <a:lnTo>
                    <a:pt x="2796921" y="186817"/>
                  </a:lnTo>
                  <a:close/>
                </a:path>
                <a:path w="4074159" h="654050">
                  <a:moveTo>
                    <a:pt x="2862834" y="404749"/>
                  </a:moveTo>
                  <a:lnTo>
                    <a:pt x="2849753" y="404749"/>
                  </a:lnTo>
                  <a:lnTo>
                    <a:pt x="2849753" y="653796"/>
                  </a:lnTo>
                  <a:lnTo>
                    <a:pt x="2862834" y="653796"/>
                  </a:lnTo>
                  <a:lnTo>
                    <a:pt x="2862834" y="404749"/>
                  </a:lnTo>
                  <a:close/>
                </a:path>
                <a:path w="4074159" h="654050">
                  <a:moveTo>
                    <a:pt x="2912999" y="435864"/>
                  </a:moveTo>
                  <a:lnTo>
                    <a:pt x="2902585" y="435864"/>
                  </a:lnTo>
                  <a:lnTo>
                    <a:pt x="2902585" y="653796"/>
                  </a:lnTo>
                  <a:lnTo>
                    <a:pt x="2912999" y="653796"/>
                  </a:lnTo>
                  <a:lnTo>
                    <a:pt x="2912999" y="435864"/>
                  </a:lnTo>
                  <a:close/>
                </a:path>
                <a:path w="4074159" h="654050">
                  <a:moveTo>
                    <a:pt x="2971038" y="249047"/>
                  </a:moveTo>
                  <a:lnTo>
                    <a:pt x="2960624" y="249047"/>
                  </a:lnTo>
                  <a:lnTo>
                    <a:pt x="2960624" y="653796"/>
                  </a:lnTo>
                  <a:lnTo>
                    <a:pt x="2971038" y="653796"/>
                  </a:lnTo>
                  <a:lnTo>
                    <a:pt x="2971038" y="249047"/>
                  </a:lnTo>
                  <a:close/>
                </a:path>
                <a:path w="4074159" h="654050">
                  <a:moveTo>
                    <a:pt x="3029077" y="31115"/>
                  </a:moveTo>
                  <a:lnTo>
                    <a:pt x="3018663" y="31115"/>
                  </a:lnTo>
                  <a:lnTo>
                    <a:pt x="3018663" y="653796"/>
                  </a:lnTo>
                  <a:lnTo>
                    <a:pt x="3029077" y="653796"/>
                  </a:lnTo>
                  <a:lnTo>
                    <a:pt x="3029077" y="31115"/>
                  </a:lnTo>
                  <a:close/>
                </a:path>
                <a:path w="4074159" h="654050">
                  <a:moveTo>
                    <a:pt x="3087243" y="373634"/>
                  </a:moveTo>
                  <a:lnTo>
                    <a:pt x="3076829" y="373634"/>
                  </a:lnTo>
                  <a:lnTo>
                    <a:pt x="3076829" y="653796"/>
                  </a:lnTo>
                  <a:lnTo>
                    <a:pt x="3087243" y="653796"/>
                  </a:lnTo>
                  <a:lnTo>
                    <a:pt x="3087243" y="373634"/>
                  </a:lnTo>
                  <a:close/>
                </a:path>
                <a:path w="4074159" h="654050">
                  <a:moveTo>
                    <a:pt x="3145282" y="342392"/>
                  </a:moveTo>
                  <a:lnTo>
                    <a:pt x="3134868" y="342392"/>
                  </a:lnTo>
                  <a:lnTo>
                    <a:pt x="3134868" y="653796"/>
                  </a:lnTo>
                  <a:lnTo>
                    <a:pt x="3145282" y="653796"/>
                  </a:lnTo>
                  <a:lnTo>
                    <a:pt x="3145282" y="342392"/>
                  </a:lnTo>
                  <a:close/>
                </a:path>
                <a:path w="4074159" h="654050">
                  <a:moveTo>
                    <a:pt x="3203321" y="498094"/>
                  </a:moveTo>
                  <a:lnTo>
                    <a:pt x="3192907" y="498094"/>
                  </a:lnTo>
                  <a:lnTo>
                    <a:pt x="3192907" y="653796"/>
                  </a:lnTo>
                  <a:lnTo>
                    <a:pt x="3203321" y="653796"/>
                  </a:lnTo>
                  <a:lnTo>
                    <a:pt x="3203321" y="498094"/>
                  </a:lnTo>
                  <a:close/>
                </a:path>
                <a:path w="4074159" h="654050">
                  <a:moveTo>
                    <a:pt x="3261360" y="560451"/>
                  </a:moveTo>
                  <a:lnTo>
                    <a:pt x="3250946" y="560451"/>
                  </a:lnTo>
                  <a:lnTo>
                    <a:pt x="3250946" y="653796"/>
                  </a:lnTo>
                  <a:lnTo>
                    <a:pt x="3261360" y="653796"/>
                  </a:lnTo>
                  <a:lnTo>
                    <a:pt x="3261360" y="560451"/>
                  </a:lnTo>
                  <a:close/>
                </a:path>
                <a:path w="4074159" h="654050">
                  <a:moveTo>
                    <a:pt x="3319399" y="466979"/>
                  </a:moveTo>
                  <a:lnTo>
                    <a:pt x="3308985" y="466979"/>
                  </a:lnTo>
                  <a:lnTo>
                    <a:pt x="3308985" y="653796"/>
                  </a:lnTo>
                  <a:lnTo>
                    <a:pt x="3319399" y="653796"/>
                  </a:lnTo>
                  <a:lnTo>
                    <a:pt x="3319399" y="466979"/>
                  </a:lnTo>
                  <a:close/>
                </a:path>
                <a:path w="4074159" h="654050">
                  <a:moveTo>
                    <a:pt x="3377438" y="186817"/>
                  </a:moveTo>
                  <a:lnTo>
                    <a:pt x="3367024" y="186817"/>
                  </a:lnTo>
                  <a:lnTo>
                    <a:pt x="3367024" y="653796"/>
                  </a:lnTo>
                  <a:lnTo>
                    <a:pt x="3377438" y="653796"/>
                  </a:lnTo>
                  <a:lnTo>
                    <a:pt x="3377438" y="186817"/>
                  </a:lnTo>
                  <a:close/>
                </a:path>
                <a:path w="4074159" h="654050">
                  <a:moveTo>
                    <a:pt x="3435477" y="435864"/>
                  </a:moveTo>
                  <a:lnTo>
                    <a:pt x="3425063" y="435864"/>
                  </a:lnTo>
                  <a:lnTo>
                    <a:pt x="3425063" y="653796"/>
                  </a:lnTo>
                  <a:lnTo>
                    <a:pt x="3435477" y="653796"/>
                  </a:lnTo>
                  <a:lnTo>
                    <a:pt x="3435477" y="435864"/>
                  </a:lnTo>
                  <a:close/>
                </a:path>
                <a:path w="4074159" h="654050">
                  <a:moveTo>
                    <a:pt x="3493516" y="186817"/>
                  </a:moveTo>
                  <a:lnTo>
                    <a:pt x="3483102" y="186817"/>
                  </a:lnTo>
                  <a:lnTo>
                    <a:pt x="3483102" y="653796"/>
                  </a:lnTo>
                  <a:lnTo>
                    <a:pt x="3493516" y="653796"/>
                  </a:lnTo>
                  <a:lnTo>
                    <a:pt x="3493516" y="186817"/>
                  </a:lnTo>
                  <a:close/>
                </a:path>
                <a:path w="4074159" h="654050">
                  <a:moveTo>
                    <a:pt x="3551555" y="373634"/>
                  </a:moveTo>
                  <a:lnTo>
                    <a:pt x="3541141" y="373634"/>
                  </a:lnTo>
                  <a:lnTo>
                    <a:pt x="3541141" y="653796"/>
                  </a:lnTo>
                  <a:lnTo>
                    <a:pt x="3551555" y="653796"/>
                  </a:lnTo>
                  <a:lnTo>
                    <a:pt x="3551555" y="373634"/>
                  </a:lnTo>
                  <a:close/>
                </a:path>
                <a:path w="4074159" h="654050">
                  <a:moveTo>
                    <a:pt x="3609594" y="342392"/>
                  </a:moveTo>
                  <a:lnTo>
                    <a:pt x="3599180" y="342392"/>
                  </a:lnTo>
                  <a:lnTo>
                    <a:pt x="3599180" y="653796"/>
                  </a:lnTo>
                  <a:lnTo>
                    <a:pt x="3609594" y="653796"/>
                  </a:lnTo>
                  <a:lnTo>
                    <a:pt x="3609594" y="342392"/>
                  </a:lnTo>
                  <a:close/>
                </a:path>
                <a:path w="4074159" h="654050">
                  <a:moveTo>
                    <a:pt x="3667760" y="404749"/>
                  </a:moveTo>
                  <a:lnTo>
                    <a:pt x="3657346" y="404749"/>
                  </a:lnTo>
                  <a:lnTo>
                    <a:pt x="3657346" y="653796"/>
                  </a:lnTo>
                  <a:lnTo>
                    <a:pt x="3667760" y="653796"/>
                  </a:lnTo>
                  <a:lnTo>
                    <a:pt x="3667760" y="404749"/>
                  </a:lnTo>
                  <a:close/>
                </a:path>
                <a:path w="4074159" h="654050">
                  <a:moveTo>
                    <a:pt x="3725799" y="498094"/>
                  </a:moveTo>
                  <a:lnTo>
                    <a:pt x="3715385" y="498094"/>
                  </a:lnTo>
                  <a:lnTo>
                    <a:pt x="3715385" y="653796"/>
                  </a:lnTo>
                  <a:lnTo>
                    <a:pt x="3725799" y="653796"/>
                  </a:lnTo>
                  <a:lnTo>
                    <a:pt x="3725799" y="498094"/>
                  </a:lnTo>
                  <a:close/>
                </a:path>
                <a:path w="4074159" h="654050">
                  <a:moveTo>
                    <a:pt x="3783838" y="466979"/>
                  </a:moveTo>
                  <a:lnTo>
                    <a:pt x="3773424" y="466979"/>
                  </a:lnTo>
                  <a:lnTo>
                    <a:pt x="3773424" y="653796"/>
                  </a:lnTo>
                  <a:lnTo>
                    <a:pt x="3783838" y="653796"/>
                  </a:lnTo>
                  <a:lnTo>
                    <a:pt x="3783838" y="466979"/>
                  </a:lnTo>
                  <a:close/>
                </a:path>
                <a:path w="4074159" h="654050">
                  <a:moveTo>
                    <a:pt x="3841877" y="280162"/>
                  </a:moveTo>
                  <a:lnTo>
                    <a:pt x="3831463" y="280162"/>
                  </a:lnTo>
                  <a:lnTo>
                    <a:pt x="3831463" y="653796"/>
                  </a:lnTo>
                  <a:lnTo>
                    <a:pt x="3841877" y="653796"/>
                  </a:lnTo>
                  <a:lnTo>
                    <a:pt x="3841877" y="280162"/>
                  </a:lnTo>
                  <a:close/>
                </a:path>
                <a:path w="4074159" h="654050">
                  <a:moveTo>
                    <a:pt x="3899916" y="342392"/>
                  </a:moveTo>
                  <a:lnTo>
                    <a:pt x="3889502" y="342392"/>
                  </a:lnTo>
                  <a:lnTo>
                    <a:pt x="3889502" y="653796"/>
                  </a:lnTo>
                  <a:lnTo>
                    <a:pt x="3899916" y="653796"/>
                  </a:lnTo>
                  <a:lnTo>
                    <a:pt x="3899916" y="342392"/>
                  </a:lnTo>
                  <a:close/>
                </a:path>
                <a:path w="4074159" h="654050">
                  <a:moveTo>
                    <a:pt x="3957955" y="529209"/>
                  </a:moveTo>
                  <a:lnTo>
                    <a:pt x="3947541" y="529209"/>
                  </a:lnTo>
                  <a:lnTo>
                    <a:pt x="3947541" y="653796"/>
                  </a:lnTo>
                  <a:lnTo>
                    <a:pt x="3957955" y="653796"/>
                  </a:lnTo>
                  <a:lnTo>
                    <a:pt x="3957955" y="529209"/>
                  </a:lnTo>
                  <a:close/>
                </a:path>
                <a:path w="4074159" h="654050">
                  <a:moveTo>
                    <a:pt x="4015994" y="342392"/>
                  </a:moveTo>
                  <a:lnTo>
                    <a:pt x="4005580" y="342392"/>
                  </a:lnTo>
                  <a:lnTo>
                    <a:pt x="4005580" y="653796"/>
                  </a:lnTo>
                  <a:lnTo>
                    <a:pt x="4015994" y="653796"/>
                  </a:lnTo>
                  <a:lnTo>
                    <a:pt x="4015994" y="342392"/>
                  </a:lnTo>
                  <a:close/>
                </a:path>
                <a:path w="4074159" h="654050">
                  <a:moveTo>
                    <a:pt x="4074033" y="466979"/>
                  </a:moveTo>
                  <a:lnTo>
                    <a:pt x="4063619" y="466979"/>
                  </a:lnTo>
                  <a:lnTo>
                    <a:pt x="4063619" y="653796"/>
                  </a:lnTo>
                  <a:lnTo>
                    <a:pt x="4074033" y="653796"/>
                  </a:lnTo>
                  <a:lnTo>
                    <a:pt x="4074033" y="466979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2" name="object 112" descr=""/>
            <p:cNvSpPr/>
            <p:nvPr/>
          </p:nvSpPr>
          <p:spPr>
            <a:xfrm>
              <a:off x="9272905" y="8226552"/>
              <a:ext cx="4132579" cy="436245"/>
            </a:xfrm>
            <a:custGeom>
              <a:avLst/>
              <a:gdLst/>
              <a:ahLst/>
              <a:cxnLst/>
              <a:rect l="l" t="t" r="r" b="b"/>
              <a:pathLst>
                <a:path w="4132580" h="436245">
                  <a:moveTo>
                    <a:pt x="10414" y="249047"/>
                  </a:moveTo>
                  <a:lnTo>
                    <a:pt x="0" y="249047"/>
                  </a:lnTo>
                  <a:lnTo>
                    <a:pt x="0" y="435864"/>
                  </a:lnTo>
                  <a:lnTo>
                    <a:pt x="10414" y="435864"/>
                  </a:lnTo>
                  <a:lnTo>
                    <a:pt x="10414" y="249047"/>
                  </a:lnTo>
                  <a:close/>
                </a:path>
                <a:path w="4132580" h="436245">
                  <a:moveTo>
                    <a:pt x="68453" y="217932"/>
                  </a:moveTo>
                  <a:lnTo>
                    <a:pt x="58039" y="217932"/>
                  </a:lnTo>
                  <a:lnTo>
                    <a:pt x="58039" y="435864"/>
                  </a:lnTo>
                  <a:lnTo>
                    <a:pt x="68453" y="435864"/>
                  </a:lnTo>
                  <a:lnTo>
                    <a:pt x="68453" y="217932"/>
                  </a:lnTo>
                  <a:close/>
                </a:path>
                <a:path w="4132580" h="436245">
                  <a:moveTo>
                    <a:pt x="126619" y="249047"/>
                  </a:moveTo>
                  <a:lnTo>
                    <a:pt x="116205" y="249047"/>
                  </a:lnTo>
                  <a:lnTo>
                    <a:pt x="116205" y="435864"/>
                  </a:lnTo>
                  <a:lnTo>
                    <a:pt x="126619" y="435864"/>
                  </a:lnTo>
                  <a:lnTo>
                    <a:pt x="126619" y="249047"/>
                  </a:lnTo>
                  <a:close/>
                </a:path>
                <a:path w="4132580" h="436245">
                  <a:moveTo>
                    <a:pt x="184658" y="373634"/>
                  </a:moveTo>
                  <a:lnTo>
                    <a:pt x="174244" y="373634"/>
                  </a:lnTo>
                  <a:lnTo>
                    <a:pt x="174244" y="435864"/>
                  </a:lnTo>
                  <a:lnTo>
                    <a:pt x="184658" y="435864"/>
                  </a:lnTo>
                  <a:lnTo>
                    <a:pt x="184658" y="373634"/>
                  </a:lnTo>
                  <a:close/>
                </a:path>
                <a:path w="4132580" h="436245">
                  <a:moveTo>
                    <a:pt x="242697" y="31115"/>
                  </a:moveTo>
                  <a:lnTo>
                    <a:pt x="232283" y="31115"/>
                  </a:lnTo>
                  <a:lnTo>
                    <a:pt x="232283" y="435864"/>
                  </a:lnTo>
                  <a:lnTo>
                    <a:pt x="242697" y="435864"/>
                  </a:lnTo>
                  <a:lnTo>
                    <a:pt x="242697" y="31115"/>
                  </a:lnTo>
                  <a:close/>
                </a:path>
                <a:path w="4132580" h="436245">
                  <a:moveTo>
                    <a:pt x="300736" y="311277"/>
                  </a:moveTo>
                  <a:lnTo>
                    <a:pt x="290322" y="311277"/>
                  </a:lnTo>
                  <a:lnTo>
                    <a:pt x="290322" y="435864"/>
                  </a:lnTo>
                  <a:lnTo>
                    <a:pt x="300736" y="435864"/>
                  </a:lnTo>
                  <a:lnTo>
                    <a:pt x="300736" y="311277"/>
                  </a:lnTo>
                  <a:close/>
                </a:path>
                <a:path w="4132580" h="436245">
                  <a:moveTo>
                    <a:pt x="358775" y="124460"/>
                  </a:moveTo>
                  <a:lnTo>
                    <a:pt x="348361" y="124460"/>
                  </a:lnTo>
                  <a:lnTo>
                    <a:pt x="348361" y="435864"/>
                  </a:lnTo>
                  <a:lnTo>
                    <a:pt x="358775" y="435864"/>
                  </a:lnTo>
                  <a:lnTo>
                    <a:pt x="358775" y="124460"/>
                  </a:lnTo>
                  <a:close/>
                </a:path>
                <a:path w="4132580" h="436245">
                  <a:moveTo>
                    <a:pt x="416814" y="342519"/>
                  </a:moveTo>
                  <a:lnTo>
                    <a:pt x="406400" y="342519"/>
                  </a:lnTo>
                  <a:lnTo>
                    <a:pt x="406400" y="435864"/>
                  </a:lnTo>
                  <a:lnTo>
                    <a:pt x="416814" y="435864"/>
                  </a:lnTo>
                  <a:lnTo>
                    <a:pt x="416814" y="342519"/>
                  </a:lnTo>
                  <a:close/>
                </a:path>
                <a:path w="4132580" h="436245">
                  <a:moveTo>
                    <a:pt x="474853" y="31115"/>
                  </a:moveTo>
                  <a:lnTo>
                    <a:pt x="464439" y="31115"/>
                  </a:lnTo>
                  <a:lnTo>
                    <a:pt x="464439" y="435864"/>
                  </a:lnTo>
                  <a:lnTo>
                    <a:pt x="474853" y="435864"/>
                  </a:lnTo>
                  <a:lnTo>
                    <a:pt x="474853" y="31115"/>
                  </a:lnTo>
                  <a:close/>
                </a:path>
                <a:path w="4132580" h="436245">
                  <a:moveTo>
                    <a:pt x="532892" y="280162"/>
                  </a:moveTo>
                  <a:lnTo>
                    <a:pt x="522478" y="280162"/>
                  </a:lnTo>
                  <a:lnTo>
                    <a:pt x="522478" y="435864"/>
                  </a:lnTo>
                  <a:lnTo>
                    <a:pt x="532892" y="435864"/>
                  </a:lnTo>
                  <a:lnTo>
                    <a:pt x="532892" y="280162"/>
                  </a:lnTo>
                  <a:close/>
                </a:path>
                <a:path w="4132580" h="436245">
                  <a:moveTo>
                    <a:pt x="590931" y="249047"/>
                  </a:moveTo>
                  <a:lnTo>
                    <a:pt x="580517" y="249047"/>
                  </a:lnTo>
                  <a:lnTo>
                    <a:pt x="580517" y="435864"/>
                  </a:lnTo>
                  <a:lnTo>
                    <a:pt x="590931" y="435864"/>
                  </a:lnTo>
                  <a:lnTo>
                    <a:pt x="590931" y="249047"/>
                  </a:lnTo>
                  <a:close/>
                </a:path>
                <a:path w="4132580" h="436245">
                  <a:moveTo>
                    <a:pt x="649097" y="155702"/>
                  </a:moveTo>
                  <a:lnTo>
                    <a:pt x="638683" y="155702"/>
                  </a:lnTo>
                  <a:lnTo>
                    <a:pt x="638683" y="435864"/>
                  </a:lnTo>
                  <a:lnTo>
                    <a:pt x="649097" y="435864"/>
                  </a:lnTo>
                  <a:lnTo>
                    <a:pt x="649097" y="155702"/>
                  </a:lnTo>
                  <a:close/>
                </a:path>
                <a:path w="4132580" h="436245">
                  <a:moveTo>
                    <a:pt x="707136" y="249047"/>
                  </a:moveTo>
                  <a:lnTo>
                    <a:pt x="696722" y="249047"/>
                  </a:lnTo>
                  <a:lnTo>
                    <a:pt x="696722" y="435864"/>
                  </a:lnTo>
                  <a:lnTo>
                    <a:pt x="707136" y="435864"/>
                  </a:lnTo>
                  <a:lnTo>
                    <a:pt x="707136" y="249047"/>
                  </a:lnTo>
                  <a:close/>
                </a:path>
                <a:path w="4132580" h="436245">
                  <a:moveTo>
                    <a:pt x="765175" y="249047"/>
                  </a:moveTo>
                  <a:lnTo>
                    <a:pt x="754761" y="249047"/>
                  </a:lnTo>
                  <a:lnTo>
                    <a:pt x="754761" y="435864"/>
                  </a:lnTo>
                  <a:lnTo>
                    <a:pt x="765175" y="435864"/>
                  </a:lnTo>
                  <a:lnTo>
                    <a:pt x="765175" y="249047"/>
                  </a:lnTo>
                  <a:close/>
                </a:path>
                <a:path w="4132580" h="436245">
                  <a:moveTo>
                    <a:pt x="831075" y="280162"/>
                  </a:moveTo>
                  <a:lnTo>
                    <a:pt x="818007" y="280162"/>
                  </a:lnTo>
                  <a:lnTo>
                    <a:pt x="818007" y="435864"/>
                  </a:lnTo>
                  <a:lnTo>
                    <a:pt x="831075" y="435864"/>
                  </a:lnTo>
                  <a:lnTo>
                    <a:pt x="831075" y="280162"/>
                  </a:lnTo>
                  <a:close/>
                </a:path>
                <a:path w="4132580" h="436245">
                  <a:moveTo>
                    <a:pt x="881253" y="186817"/>
                  </a:moveTo>
                  <a:lnTo>
                    <a:pt x="870839" y="186817"/>
                  </a:lnTo>
                  <a:lnTo>
                    <a:pt x="870839" y="435864"/>
                  </a:lnTo>
                  <a:lnTo>
                    <a:pt x="881253" y="435864"/>
                  </a:lnTo>
                  <a:lnTo>
                    <a:pt x="881253" y="186817"/>
                  </a:lnTo>
                  <a:close/>
                </a:path>
                <a:path w="4132580" h="436245">
                  <a:moveTo>
                    <a:pt x="939292" y="186817"/>
                  </a:moveTo>
                  <a:lnTo>
                    <a:pt x="928878" y="186817"/>
                  </a:lnTo>
                  <a:lnTo>
                    <a:pt x="928878" y="435864"/>
                  </a:lnTo>
                  <a:lnTo>
                    <a:pt x="939292" y="435864"/>
                  </a:lnTo>
                  <a:lnTo>
                    <a:pt x="939292" y="186817"/>
                  </a:lnTo>
                  <a:close/>
                </a:path>
                <a:path w="4132580" h="436245">
                  <a:moveTo>
                    <a:pt x="997331" y="31115"/>
                  </a:moveTo>
                  <a:lnTo>
                    <a:pt x="986917" y="31115"/>
                  </a:lnTo>
                  <a:lnTo>
                    <a:pt x="986917" y="435864"/>
                  </a:lnTo>
                  <a:lnTo>
                    <a:pt x="997331" y="435864"/>
                  </a:lnTo>
                  <a:lnTo>
                    <a:pt x="997331" y="31115"/>
                  </a:lnTo>
                  <a:close/>
                </a:path>
                <a:path w="4132580" h="436245">
                  <a:moveTo>
                    <a:pt x="1055370" y="342519"/>
                  </a:moveTo>
                  <a:lnTo>
                    <a:pt x="1044956" y="342519"/>
                  </a:lnTo>
                  <a:lnTo>
                    <a:pt x="1044956" y="435864"/>
                  </a:lnTo>
                  <a:lnTo>
                    <a:pt x="1055370" y="435864"/>
                  </a:lnTo>
                  <a:lnTo>
                    <a:pt x="1055370" y="342519"/>
                  </a:lnTo>
                  <a:close/>
                </a:path>
                <a:path w="4132580" h="436245">
                  <a:moveTo>
                    <a:pt x="1113409" y="342519"/>
                  </a:moveTo>
                  <a:lnTo>
                    <a:pt x="1102995" y="342519"/>
                  </a:lnTo>
                  <a:lnTo>
                    <a:pt x="1102995" y="435864"/>
                  </a:lnTo>
                  <a:lnTo>
                    <a:pt x="1113409" y="435864"/>
                  </a:lnTo>
                  <a:lnTo>
                    <a:pt x="1113409" y="342519"/>
                  </a:lnTo>
                  <a:close/>
                </a:path>
                <a:path w="4132580" h="436245">
                  <a:moveTo>
                    <a:pt x="1171448" y="186817"/>
                  </a:moveTo>
                  <a:lnTo>
                    <a:pt x="1161034" y="186817"/>
                  </a:lnTo>
                  <a:lnTo>
                    <a:pt x="1161034" y="435864"/>
                  </a:lnTo>
                  <a:lnTo>
                    <a:pt x="1171448" y="435864"/>
                  </a:lnTo>
                  <a:lnTo>
                    <a:pt x="1171448" y="186817"/>
                  </a:lnTo>
                  <a:close/>
                </a:path>
                <a:path w="4132580" h="436245">
                  <a:moveTo>
                    <a:pt x="1229614" y="155702"/>
                  </a:moveTo>
                  <a:lnTo>
                    <a:pt x="1219200" y="155702"/>
                  </a:lnTo>
                  <a:lnTo>
                    <a:pt x="1219200" y="435864"/>
                  </a:lnTo>
                  <a:lnTo>
                    <a:pt x="1229614" y="435864"/>
                  </a:lnTo>
                  <a:lnTo>
                    <a:pt x="1229614" y="155702"/>
                  </a:lnTo>
                  <a:close/>
                </a:path>
                <a:path w="4132580" h="436245">
                  <a:moveTo>
                    <a:pt x="1295527" y="155702"/>
                  </a:moveTo>
                  <a:lnTo>
                    <a:pt x="1282446" y="155702"/>
                  </a:lnTo>
                  <a:lnTo>
                    <a:pt x="1282446" y="435864"/>
                  </a:lnTo>
                  <a:lnTo>
                    <a:pt x="1295527" y="435864"/>
                  </a:lnTo>
                  <a:lnTo>
                    <a:pt x="1295527" y="155702"/>
                  </a:lnTo>
                  <a:close/>
                </a:path>
                <a:path w="4132580" h="436245">
                  <a:moveTo>
                    <a:pt x="1345692" y="186817"/>
                  </a:moveTo>
                  <a:lnTo>
                    <a:pt x="1335278" y="186817"/>
                  </a:lnTo>
                  <a:lnTo>
                    <a:pt x="1335278" y="435864"/>
                  </a:lnTo>
                  <a:lnTo>
                    <a:pt x="1345692" y="435864"/>
                  </a:lnTo>
                  <a:lnTo>
                    <a:pt x="1345692" y="186817"/>
                  </a:lnTo>
                  <a:close/>
                </a:path>
                <a:path w="4132580" h="436245">
                  <a:moveTo>
                    <a:pt x="1403731" y="342519"/>
                  </a:moveTo>
                  <a:lnTo>
                    <a:pt x="1393317" y="342519"/>
                  </a:lnTo>
                  <a:lnTo>
                    <a:pt x="1393317" y="435864"/>
                  </a:lnTo>
                  <a:lnTo>
                    <a:pt x="1403731" y="435864"/>
                  </a:lnTo>
                  <a:lnTo>
                    <a:pt x="1403731" y="342519"/>
                  </a:lnTo>
                  <a:close/>
                </a:path>
                <a:path w="4132580" h="436245">
                  <a:moveTo>
                    <a:pt x="1461770" y="186817"/>
                  </a:moveTo>
                  <a:lnTo>
                    <a:pt x="1451356" y="186817"/>
                  </a:lnTo>
                  <a:lnTo>
                    <a:pt x="1451356" y="435864"/>
                  </a:lnTo>
                  <a:lnTo>
                    <a:pt x="1461770" y="435864"/>
                  </a:lnTo>
                  <a:lnTo>
                    <a:pt x="1461770" y="186817"/>
                  </a:lnTo>
                  <a:close/>
                </a:path>
                <a:path w="4132580" h="436245">
                  <a:moveTo>
                    <a:pt x="1519809" y="311277"/>
                  </a:moveTo>
                  <a:lnTo>
                    <a:pt x="1509395" y="311277"/>
                  </a:lnTo>
                  <a:lnTo>
                    <a:pt x="1509395" y="435864"/>
                  </a:lnTo>
                  <a:lnTo>
                    <a:pt x="1519809" y="435864"/>
                  </a:lnTo>
                  <a:lnTo>
                    <a:pt x="1519809" y="311277"/>
                  </a:lnTo>
                  <a:close/>
                </a:path>
                <a:path w="4132580" h="436245">
                  <a:moveTo>
                    <a:pt x="1577848" y="0"/>
                  </a:moveTo>
                  <a:lnTo>
                    <a:pt x="1567434" y="0"/>
                  </a:lnTo>
                  <a:lnTo>
                    <a:pt x="1567434" y="435864"/>
                  </a:lnTo>
                  <a:lnTo>
                    <a:pt x="1577848" y="435864"/>
                  </a:lnTo>
                  <a:lnTo>
                    <a:pt x="1577848" y="0"/>
                  </a:lnTo>
                  <a:close/>
                </a:path>
                <a:path w="4132580" h="436245">
                  <a:moveTo>
                    <a:pt x="1635887" y="186817"/>
                  </a:moveTo>
                  <a:lnTo>
                    <a:pt x="1625473" y="186817"/>
                  </a:lnTo>
                  <a:lnTo>
                    <a:pt x="1625473" y="435864"/>
                  </a:lnTo>
                  <a:lnTo>
                    <a:pt x="1635887" y="435864"/>
                  </a:lnTo>
                  <a:lnTo>
                    <a:pt x="1635887" y="186817"/>
                  </a:lnTo>
                  <a:close/>
                </a:path>
                <a:path w="4132580" h="436245">
                  <a:moveTo>
                    <a:pt x="1693926" y="124460"/>
                  </a:moveTo>
                  <a:lnTo>
                    <a:pt x="1683512" y="124460"/>
                  </a:lnTo>
                  <a:lnTo>
                    <a:pt x="1683512" y="435864"/>
                  </a:lnTo>
                  <a:lnTo>
                    <a:pt x="1693926" y="435864"/>
                  </a:lnTo>
                  <a:lnTo>
                    <a:pt x="1693926" y="124460"/>
                  </a:lnTo>
                  <a:close/>
                </a:path>
                <a:path w="4132580" h="436245">
                  <a:moveTo>
                    <a:pt x="1752092" y="62230"/>
                  </a:moveTo>
                  <a:lnTo>
                    <a:pt x="1741678" y="62230"/>
                  </a:lnTo>
                  <a:lnTo>
                    <a:pt x="1741678" y="435864"/>
                  </a:lnTo>
                  <a:lnTo>
                    <a:pt x="1752092" y="435864"/>
                  </a:lnTo>
                  <a:lnTo>
                    <a:pt x="1752092" y="62230"/>
                  </a:lnTo>
                  <a:close/>
                </a:path>
                <a:path w="4132580" h="436245">
                  <a:moveTo>
                    <a:pt x="1810131" y="280162"/>
                  </a:moveTo>
                  <a:lnTo>
                    <a:pt x="1799717" y="280162"/>
                  </a:lnTo>
                  <a:lnTo>
                    <a:pt x="1799717" y="435864"/>
                  </a:lnTo>
                  <a:lnTo>
                    <a:pt x="1810131" y="435864"/>
                  </a:lnTo>
                  <a:lnTo>
                    <a:pt x="1810131" y="280162"/>
                  </a:lnTo>
                  <a:close/>
                </a:path>
                <a:path w="4132580" h="436245">
                  <a:moveTo>
                    <a:pt x="1876044" y="280162"/>
                  </a:moveTo>
                  <a:lnTo>
                    <a:pt x="1862963" y="280162"/>
                  </a:lnTo>
                  <a:lnTo>
                    <a:pt x="1862963" y="435864"/>
                  </a:lnTo>
                  <a:lnTo>
                    <a:pt x="1876044" y="435864"/>
                  </a:lnTo>
                  <a:lnTo>
                    <a:pt x="1876044" y="280162"/>
                  </a:lnTo>
                  <a:close/>
                </a:path>
                <a:path w="4132580" h="436245">
                  <a:moveTo>
                    <a:pt x="1926209" y="342519"/>
                  </a:moveTo>
                  <a:lnTo>
                    <a:pt x="1915795" y="342519"/>
                  </a:lnTo>
                  <a:lnTo>
                    <a:pt x="1915795" y="435864"/>
                  </a:lnTo>
                  <a:lnTo>
                    <a:pt x="1926209" y="435864"/>
                  </a:lnTo>
                  <a:lnTo>
                    <a:pt x="1926209" y="342519"/>
                  </a:lnTo>
                  <a:close/>
                </a:path>
                <a:path w="4132580" h="436245">
                  <a:moveTo>
                    <a:pt x="1984248" y="280162"/>
                  </a:moveTo>
                  <a:lnTo>
                    <a:pt x="1973834" y="280162"/>
                  </a:lnTo>
                  <a:lnTo>
                    <a:pt x="1973834" y="435864"/>
                  </a:lnTo>
                  <a:lnTo>
                    <a:pt x="1984248" y="435864"/>
                  </a:lnTo>
                  <a:lnTo>
                    <a:pt x="1984248" y="280162"/>
                  </a:lnTo>
                  <a:close/>
                </a:path>
                <a:path w="4132580" h="436245">
                  <a:moveTo>
                    <a:pt x="2042287" y="311277"/>
                  </a:moveTo>
                  <a:lnTo>
                    <a:pt x="2031873" y="311277"/>
                  </a:lnTo>
                  <a:lnTo>
                    <a:pt x="2031873" y="435864"/>
                  </a:lnTo>
                  <a:lnTo>
                    <a:pt x="2042287" y="435864"/>
                  </a:lnTo>
                  <a:lnTo>
                    <a:pt x="2042287" y="311277"/>
                  </a:lnTo>
                  <a:close/>
                </a:path>
                <a:path w="4132580" h="436245">
                  <a:moveTo>
                    <a:pt x="2100326" y="217932"/>
                  </a:moveTo>
                  <a:lnTo>
                    <a:pt x="2089912" y="217932"/>
                  </a:lnTo>
                  <a:lnTo>
                    <a:pt x="2089912" y="435864"/>
                  </a:lnTo>
                  <a:lnTo>
                    <a:pt x="2100326" y="435864"/>
                  </a:lnTo>
                  <a:lnTo>
                    <a:pt x="2100326" y="217932"/>
                  </a:lnTo>
                  <a:close/>
                </a:path>
                <a:path w="4132580" h="436245">
                  <a:moveTo>
                    <a:pt x="2158365" y="373634"/>
                  </a:moveTo>
                  <a:lnTo>
                    <a:pt x="2147951" y="373634"/>
                  </a:lnTo>
                  <a:lnTo>
                    <a:pt x="2147951" y="435864"/>
                  </a:lnTo>
                  <a:lnTo>
                    <a:pt x="2158365" y="435864"/>
                  </a:lnTo>
                  <a:lnTo>
                    <a:pt x="2158365" y="373634"/>
                  </a:lnTo>
                  <a:close/>
                </a:path>
                <a:path w="4132580" h="436245">
                  <a:moveTo>
                    <a:pt x="2216404" y="311277"/>
                  </a:moveTo>
                  <a:lnTo>
                    <a:pt x="2205990" y="311277"/>
                  </a:lnTo>
                  <a:lnTo>
                    <a:pt x="2205990" y="435864"/>
                  </a:lnTo>
                  <a:lnTo>
                    <a:pt x="2216404" y="435864"/>
                  </a:lnTo>
                  <a:lnTo>
                    <a:pt x="2216404" y="311277"/>
                  </a:lnTo>
                  <a:close/>
                </a:path>
                <a:path w="4132580" h="436245">
                  <a:moveTo>
                    <a:pt x="2274443" y="373634"/>
                  </a:moveTo>
                  <a:lnTo>
                    <a:pt x="2264029" y="373634"/>
                  </a:lnTo>
                  <a:lnTo>
                    <a:pt x="2264029" y="435864"/>
                  </a:lnTo>
                  <a:lnTo>
                    <a:pt x="2274443" y="435864"/>
                  </a:lnTo>
                  <a:lnTo>
                    <a:pt x="2274443" y="373634"/>
                  </a:lnTo>
                  <a:close/>
                </a:path>
                <a:path w="4132580" h="436245">
                  <a:moveTo>
                    <a:pt x="2332609" y="311277"/>
                  </a:moveTo>
                  <a:lnTo>
                    <a:pt x="2322195" y="311277"/>
                  </a:lnTo>
                  <a:lnTo>
                    <a:pt x="2322195" y="435864"/>
                  </a:lnTo>
                  <a:lnTo>
                    <a:pt x="2332609" y="435864"/>
                  </a:lnTo>
                  <a:lnTo>
                    <a:pt x="2332609" y="311277"/>
                  </a:lnTo>
                  <a:close/>
                </a:path>
                <a:path w="4132580" h="436245">
                  <a:moveTo>
                    <a:pt x="2390648" y="311277"/>
                  </a:moveTo>
                  <a:lnTo>
                    <a:pt x="2380234" y="311277"/>
                  </a:lnTo>
                  <a:lnTo>
                    <a:pt x="2380234" y="435864"/>
                  </a:lnTo>
                  <a:lnTo>
                    <a:pt x="2390648" y="435864"/>
                  </a:lnTo>
                  <a:lnTo>
                    <a:pt x="2390648" y="311277"/>
                  </a:lnTo>
                  <a:close/>
                </a:path>
                <a:path w="4132580" h="436245">
                  <a:moveTo>
                    <a:pt x="2456548" y="311277"/>
                  </a:moveTo>
                  <a:lnTo>
                    <a:pt x="2443480" y="311277"/>
                  </a:lnTo>
                  <a:lnTo>
                    <a:pt x="2443480" y="435864"/>
                  </a:lnTo>
                  <a:lnTo>
                    <a:pt x="2456548" y="435864"/>
                  </a:lnTo>
                  <a:lnTo>
                    <a:pt x="2456548" y="311277"/>
                  </a:lnTo>
                  <a:close/>
                </a:path>
                <a:path w="4132580" h="436245">
                  <a:moveTo>
                    <a:pt x="2506726" y="217932"/>
                  </a:moveTo>
                  <a:lnTo>
                    <a:pt x="2496312" y="217932"/>
                  </a:lnTo>
                  <a:lnTo>
                    <a:pt x="2496312" y="435864"/>
                  </a:lnTo>
                  <a:lnTo>
                    <a:pt x="2506726" y="435864"/>
                  </a:lnTo>
                  <a:lnTo>
                    <a:pt x="2506726" y="217932"/>
                  </a:lnTo>
                  <a:close/>
                </a:path>
                <a:path w="4132580" h="436245">
                  <a:moveTo>
                    <a:pt x="2564765" y="155702"/>
                  </a:moveTo>
                  <a:lnTo>
                    <a:pt x="2554351" y="155702"/>
                  </a:lnTo>
                  <a:lnTo>
                    <a:pt x="2554351" y="435864"/>
                  </a:lnTo>
                  <a:lnTo>
                    <a:pt x="2564765" y="435864"/>
                  </a:lnTo>
                  <a:lnTo>
                    <a:pt x="2564765" y="155702"/>
                  </a:lnTo>
                  <a:close/>
                </a:path>
                <a:path w="4132580" h="436245">
                  <a:moveTo>
                    <a:pt x="2630678" y="311277"/>
                  </a:moveTo>
                  <a:lnTo>
                    <a:pt x="2617597" y="311277"/>
                  </a:lnTo>
                  <a:lnTo>
                    <a:pt x="2617597" y="435864"/>
                  </a:lnTo>
                  <a:lnTo>
                    <a:pt x="2630678" y="435864"/>
                  </a:lnTo>
                  <a:lnTo>
                    <a:pt x="2630678" y="311277"/>
                  </a:lnTo>
                  <a:close/>
                </a:path>
                <a:path w="4132580" h="436245">
                  <a:moveTo>
                    <a:pt x="2680843" y="217932"/>
                  </a:moveTo>
                  <a:lnTo>
                    <a:pt x="2670429" y="217932"/>
                  </a:lnTo>
                  <a:lnTo>
                    <a:pt x="2670429" y="435864"/>
                  </a:lnTo>
                  <a:lnTo>
                    <a:pt x="2680843" y="435864"/>
                  </a:lnTo>
                  <a:lnTo>
                    <a:pt x="2680843" y="217932"/>
                  </a:lnTo>
                  <a:close/>
                </a:path>
                <a:path w="4132580" h="436245">
                  <a:moveTo>
                    <a:pt x="2738882" y="217932"/>
                  </a:moveTo>
                  <a:lnTo>
                    <a:pt x="2728468" y="217932"/>
                  </a:lnTo>
                  <a:lnTo>
                    <a:pt x="2728468" y="435864"/>
                  </a:lnTo>
                  <a:lnTo>
                    <a:pt x="2738882" y="435864"/>
                  </a:lnTo>
                  <a:lnTo>
                    <a:pt x="2738882" y="217932"/>
                  </a:lnTo>
                  <a:close/>
                </a:path>
                <a:path w="4132580" h="436245">
                  <a:moveTo>
                    <a:pt x="2796921" y="373634"/>
                  </a:moveTo>
                  <a:lnTo>
                    <a:pt x="2786507" y="373634"/>
                  </a:lnTo>
                  <a:lnTo>
                    <a:pt x="2786507" y="435864"/>
                  </a:lnTo>
                  <a:lnTo>
                    <a:pt x="2796921" y="435864"/>
                  </a:lnTo>
                  <a:lnTo>
                    <a:pt x="2796921" y="373634"/>
                  </a:lnTo>
                  <a:close/>
                </a:path>
                <a:path w="4132580" h="436245">
                  <a:moveTo>
                    <a:pt x="2862948" y="404749"/>
                  </a:moveTo>
                  <a:lnTo>
                    <a:pt x="2849880" y="404749"/>
                  </a:lnTo>
                  <a:lnTo>
                    <a:pt x="2849880" y="435864"/>
                  </a:lnTo>
                  <a:lnTo>
                    <a:pt x="2862948" y="435864"/>
                  </a:lnTo>
                  <a:lnTo>
                    <a:pt x="2862948" y="404749"/>
                  </a:lnTo>
                  <a:close/>
                </a:path>
                <a:path w="4132580" h="436245">
                  <a:moveTo>
                    <a:pt x="2913126" y="280162"/>
                  </a:moveTo>
                  <a:lnTo>
                    <a:pt x="2902712" y="280162"/>
                  </a:lnTo>
                  <a:lnTo>
                    <a:pt x="2902712" y="435864"/>
                  </a:lnTo>
                  <a:lnTo>
                    <a:pt x="2913126" y="435864"/>
                  </a:lnTo>
                  <a:lnTo>
                    <a:pt x="2913126" y="280162"/>
                  </a:lnTo>
                  <a:close/>
                </a:path>
                <a:path w="4132580" h="436245">
                  <a:moveTo>
                    <a:pt x="2971165" y="155702"/>
                  </a:moveTo>
                  <a:lnTo>
                    <a:pt x="2960751" y="155702"/>
                  </a:lnTo>
                  <a:lnTo>
                    <a:pt x="2960751" y="435864"/>
                  </a:lnTo>
                  <a:lnTo>
                    <a:pt x="2971165" y="435864"/>
                  </a:lnTo>
                  <a:lnTo>
                    <a:pt x="2971165" y="155702"/>
                  </a:lnTo>
                  <a:close/>
                </a:path>
                <a:path w="4132580" h="436245">
                  <a:moveTo>
                    <a:pt x="3029204" y="404749"/>
                  </a:moveTo>
                  <a:lnTo>
                    <a:pt x="3018790" y="404749"/>
                  </a:lnTo>
                  <a:lnTo>
                    <a:pt x="3018790" y="435864"/>
                  </a:lnTo>
                  <a:lnTo>
                    <a:pt x="3029204" y="435864"/>
                  </a:lnTo>
                  <a:lnTo>
                    <a:pt x="3029204" y="404749"/>
                  </a:lnTo>
                  <a:close/>
                </a:path>
                <a:path w="4132580" h="436245">
                  <a:moveTo>
                    <a:pt x="3087243" y="280162"/>
                  </a:moveTo>
                  <a:lnTo>
                    <a:pt x="3076829" y="280162"/>
                  </a:lnTo>
                  <a:lnTo>
                    <a:pt x="3076829" y="435864"/>
                  </a:lnTo>
                  <a:lnTo>
                    <a:pt x="3087243" y="435864"/>
                  </a:lnTo>
                  <a:lnTo>
                    <a:pt x="3087243" y="280162"/>
                  </a:lnTo>
                  <a:close/>
                </a:path>
                <a:path w="4132580" h="436245">
                  <a:moveTo>
                    <a:pt x="3145282" y="373634"/>
                  </a:moveTo>
                  <a:lnTo>
                    <a:pt x="3134868" y="373634"/>
                  </a:lnTo>
                  <a:lnTo>
                    <a:pt x="3134868" y="435864"/>
                  </a:lnTo>
                  <a:lnTo>
                    <a:pt x="3145282" y="435864"/>
                  </a:lnTo>
                  <a:lnTo>
                    <a:pt x="3145282" y="373634"/>
                  </a:lnTo>
                  <a:close/>
                </a:path>
                <a:path w="4132580" h="436245">
                  <a:moveTo>
                    <a:pt x="3203321" y="217932"/>
                  </a:moveTo>
                  <a:lnTo>
                    <a:pt x="3192907" y="217932"/>
                  </a:lnTo>
                  <a:lnTo>
                    <a:pt x="3192907" y="435864"/>
                  </a:lnTo>
                  <a:lnTo>
                    <a:pt x="3203321" y="435864"/>
                  </a:lnTo>
                  <a:lnTo>
                    <a:pt x="3203321" y="217932"/>
                  </a:lnTo>
                  <a:close/>
                </a:path>
                <a:path w="4132580" h="436245">
                  <a:moveTo>
                    <a:pt x="3261360" y="373634"/>
                  </a:moveTo>
                  <a:lnTo>
                    <a:pt x="3250946" y="373634"/>
                  </a:lnTo>
                  <a:lnTo>
                    <a:pt x="3250946" y="435864"/>
                  </a:lnTo>
                  <a:lnTo>
                    <a:pt x="3261360" y="435864"/>
                  </a:lnTo>
                  <a:lnTo>
                    <a:pt x="3261360" y="373634"/>
                  </a:lnTo>
                  <a:close/>
                </a:path>
                <a:path w="4132580" h="436245">
                  <a:moveTo>
                    <a:pt x="3327400" y="155702"/>
                  </a:moveTo>
                  <a:lnTo>
                    <a:pt x="3314319" y="155702"/>
                  </a:lnTo>
                  <a:lnTo>
                    <a:pt x="3314319" y="435864"/>
                  </a:lnTo>
                  <a:lnTo>
                    <a:pt x="3327400" y="435864"/>
                  </a:lnTo>
                  <a:lnTo>
                    <a:pt x="3327400" y="155702"/>
                  </a:lnTo>
                  <a:close/>
                </a:path>
                <a:path w="4132580" h="436245">
                  <a:moveTo>
                    <a:pt x="3385439" y="311277"/>
                  </a:moveTo>
                  <a:lnTo>
                    <a:pt x="3372358" y="311277"/>
                  </a:lnTo>
                  <a:lnTo>
                    <a:pt x="3372358" y="435864"/>
                  </a:lnTo>
                  <a:lnTo>
                    <a:pt x="3385439" y="435864"/>
                  </a:lnTo>
                  <a:lnTo>
                    <a:pt x="3385439" y="311277"/>
                  </a:lnTo>
                  <a:close/>
                </a:path>
                <a:path w="4132580" h="436245">
                  <a:moveTo>
                    <a:pt x="3435604" y="186817"/>
                  </a:moveTo>
                  <a:lnTo>
                    <a:pt x="3425190" y="186817"/>
                  </a:lnTo>
                  <a:lnTo>
                    <a:pt x="3425190" y="435864"/>
                  </a:lnTo>
                  <a:lnTo>
                    <a:pt x="3435604" y="435864"/>
                  </a:lnTo>
                  <a:lnTo>
                    <a:pt x="3435604" y="186817"/>
                  </a:lnTo>
                  <a:close/>
                </a:path>
                <a:path w="4132580" h="436245">
                  <a:moveTo>
                    <a:pt x="3493643" y="311277"/>
                  </a:moveTo>
                  <a:lnTo>
                    <a:pt x="3483229" y="311277"/>
                  </a:lnTo>
                  <a:lnTo>
                    <a:pt x="3483229" y="435864"/>
                  </a:lnTo>
                  <a:lnTo>
                    <a:pt x="3493643" y="435864"/>
                  </a:lnTo>
                  <a:lnTo>
                    <a:pt x="3493643" y="311277"/>
                  </a:lnTo>
                  <a:close/>
                </a:path>
                <a:path w="4132580" h="436245">
                  <a:moveTo>
                    <a:pt x="3551682" y="373634"/>
                  </a:moveTo>
                  <a:lnTo>
                    <a:pt x="3541268" y="373634"/>
                  </a:lnTo>
                  <a:lnTo>
                    <a:pt x="3541268" y="435864"/>
                  </a:lnTo>
                  <a:lnTo>
                    <a:pt x="3551682" y="435864"/>
                  </a:lnTo>
                  <a:lnTo>
                    <a:pt x="3551682" y="373634"/>
                  </a:lnTo>
                  <a:close/>
                </a:path>
                <a:path w="4132580" h="436245">
                  <a:moveTo>
                    <a:pt x="3609721" y="311277"/>
                  </a:moveTo>
                  <a:lnTo>
                    <a:pt x="3599307" y="311277"/>
                  </a:lnTo>
                  <a:lnTo>
                    <a:pt x="3599307" y="435864"/>
                  </a:lnTo>
                  <a:lnTo>
                    <a:pt x="3609721" y="435864"/>
                  </a:lnTo>
                  <a:lnTo>
                    <a:pt x="3609721" y="311277"/>
                  </a:lnTo>
                  <a:close/>
                </a:path>
                <a:path w="4132580" h="436245">
                  <a:moveTo>
                    <a:pt x="3667760" y="217932"/>
                  </a:moveTo>
                  <a:lnTo>
                    <a:pt x="3657346" y="217932"/>
                  </a:lnTo>
                  <a:lnTo>
                    <a:pt x="3657346" y="435864"/>
                  </a:lnTo>
                  <a:lnTo>
                    <a:pt x="3667760" y="435864"/>
                  </a:lnTo>
                  <a:lnTo>
                    <a:pt x="3667760" y="217932"/>
                  </a:lnTo>
                  <a:close/>
                </a:path>
                <a:path w="4132580" h="436245">
                  <a:moveTo>
                    <a:pt x="3725799" y="311277"/>
                  </a:moveTo>
                  <a:lnTo>
                    <a:pt x="3715385" y="311277"/>
                  </a:lnTo>
                  <a:lnTo>
                    <a:pt x="3715385" y="435864"/>
                  </a:lnTo>
                  <a:lnTo>
                    <a:pt x="3725799" y="435864"/>
                  </a:lnTo>
                  <a:lnTo>
                    <a:pt x="3725799" y="311277"/>
                  </a:lnTo>
                  <a:close/>
                </a:path>
                <a:path w="4132580" h="436245">
                  <a:moveTo>
                    <a:pt x="3783825" y="342519"/>
                  </a:moveTo>
                  <a:lnTo>
                    <a:pt x="3773424" y="342519"/>
                  </a:lnTo>
                  <a:lnTo>
                    <a:pt x="3773424" y="435864"/>
                  </a:lnTo>
                  <a:lnTo>
                    <a:pt x="3783825" y="435864"/>
                  </a:lnTo>
                  <a:lnTo>
                    <a:pt x="3783825" y="342519"/>
                  </a:lnTo>
                  <a:close/>
                </a:path>
                <a:path w="4132580" h="436245">
                  <a:moveTo>
                    <a:pt x="3849878" y="280162"/>
                  </a:moveTo>
                  <a:lnTo>
                    <a:pt x="3836797" y="280162"/>
                  </a:lnTo>
                  <a:lnTo>
                    <a:pt x="3836797" y="435864"/>
                  </a:lnTo>
                  <a:lnTo>
                    <a:pt x="3849878" y="435864"/>
                  </a:lnTo>
                  <a:lnTo>
                    <a:pt x="3849878" y="280162"/>
                  </a:lnTo>
                  <a:close/>
                </a:path>
                <a:path w="4132580" h="436245">
                  <a:moveTo>
                    <a:pt x="3899916" y="373634"/>
                  </a:moveTo>
                  <a:lnTo>
                    <a:pt x="3889502" y="373634"/>
                  </a:lnTo>
                  <a:lnTo>
                    <a:pt x="3889502" y="435864"/>
                  </a:lnTo>
                  <a:lnTo>
                    <a:pt x="3899916" y="435864"/>
                  </a:lnTo>
                  <a:lnTo>
                    <a:pt x="3899916" y="373634"/>
                  </a:lnTo>
                  <a:close/>
                </a:path>
                <a:path w="4132580" h="436245">
                  <a:moveTo>
                    <a:pt x="3965956" y="373634"/>
                  </a:moveTo>
                  <a:lnTo>
                    <a:pt x="3952875" y="373634"/>
                  </a:lnTo>
                  <a:lnTo>
                    <a:pt x="3952875" y="435864"/>
                  </a:lnTo>
                  <a:lnTo>
                    <a:pt x="3965956" y="435864"/>
                  </a:lnTo>
                  <a:lnTo>
                    <a:pt x="3965956" y="373634"/>
                  </a:lnTo>
                  <a:close/>
                </a:path>
                <a:path w="4132580" h="436245">
                  <a:moveTo>
                    <a:pt x="4082034" y="342519"/>
                  </a:moveTo>
                  <a:lnTo>
                    <a:pt x="4068953" y="342519"/>
                  </a:lnTo>
                  <a:lnTo>
                    <a:pt x="4068953" y="435864"/>
                  </a:lnTo>
                  <a:lnTo>
                    <a:pt x="4082034" y="435864"/>
                  </a:lnTo>
                  <a:lnTo>
                    <a:pt x="4082034" y="342519"/>
                  </a:lnTo>
                  <a:close/>
                </a:path>
                <a:path w="4132580" h="436245">
                  <a:moveTo>
                    <a:pt x="4132199" y="124460"/>
                  </a:moveTo>
                  <a:lnTo>
                    <a:pt x="4121785" y="124460"/>
                  </a:lnTo>
                  <a:lnTo>
                    <a:pt x="4121785" y="435864"/>
                  </a:lnTo>
                  <a:lnTo>
                    <a:pt x="4132199" y="435864"/>
                  </a:lnTo>
                  <a:lnTo>
                    <a:pt x="4132199" y="124460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3" name="object 113" descr=""/>
            <p:cNvSpPr/>
            <p:nvPr/>
          </p:nvSpPr>
          <p:spPr>
            <a:xfrm>
              <a:off x="13394690" y="8351012"/>
              <a:ext cx="2237740" cy="311785"/>
            </a:xfrm>
            <a:custGeom>
              <a:avLst/>
              <a:gdLst/>
              <a:ahLst/>
              <a:cxnLst/>
              <a:rect l="l" t="t" r="r" b="b"/>
              <a:pathLst>
                <a:path w="2237740" h="311784">
                  <a:moveTo>
                    <a:pt x="10414" y="0"/>
                  </a:moveTo>
                  <a:lnTo>
                    <a:pt x="0" y="0"/>
                  </a:lnTo>
                  <a:lnTo>
                    <a:pt x="0" y="311404"/>
                  </a:lnTo>
                  <a:lnTo>
                    <a:pt x="10414" y="311404"/>
                  </a:lnTo>
                  <a:lnTo>
                    <a:pt x="10414" y="0"/>
                  </a:lnTo>
                  <a:close/>
                </a:path>
                <a:path w="2237740" h="311784">
                  <a:moveTo>
                    <a:pt x="68453" y="186817"/>
                  </a:moveTo>
                  <a:lnTo>
                    <a:pt x="58039" y="186817"/>
                  </a:lnTo>
                  <a:lnTo>
                    <a:pt x="58039" y="311404"/>
                  </a:lnTo>
                  <a:lnTo>
                    <a:pt x="68453" y="311404"/>
                  </a:lnTo>
                  <a:lnTo>
                    <a:pt x="68453" y="186817"/>
                  </a:lnTo>
                  <a:close/>
                </a:path>
                <a:path w="2237740" h="311784">
                  <a:moveTo>
                    <a:pt x="134366" y="155702"/>
                  </a:moveTo>
                  <a:lnTo>
                    <a:pt x="121285" y="155702"/>
                  </a:lnTo>
                  <a:lnTo>
                    <a:pt x="121285" y="311404"/>
                  </a:lnTo>
                  <a:lnTo>
                    <a:pt x="134366" y="311404"/>
                  </a:lnTo>
                  <a:lnTo>
                    <a:pt x="134366" y="155702"/>
                  </a:lnTo>
                  <a:close/>
                </a:path>
                <a:path w="2237740" h="311784">
                  <a:moveTo>
                    <a:pt x="192405" y="186817"/>
                  </a:moveTo>
                  <a:lnTo>
                    <a:pt x="179324" y="186817"/>
                  </a:lnTo>
                  <a:lnTo>
                    <a:pt x="179324" y="311404"/>
                  </a:lnTo>
                  <a:lnTo>
                    <a:pt x="192405" y="311404"/>
                  </a:lnTo>
                  <a:lnTo>
                    <a:pt x="192405" y="186817"/>
                  </a:lnTo>
                  <a:close/>
                </a:path>
                <a:path w="2237740" h="311784">
                  <a:moveTo>
                    <a:pt x="250444" y="249174"/>
                  </a:moveTo>
                  <a:lnTo>
                    <a:pt x="237363" y="249174"/>
                  </a:lnTo>
                  <a:lnTo>
                    <a:pt x="237363" y="311404"/>
                  </a:lnTo>
                  <a:lnTo>
                    <a:pt x="250444" y="311404"/>
                  </a:lnTo>
                  <a:lnTo>
                    <a:pt x="250444" y="249174"/>
                  </a:lnTo>
                  <a:close/>
                </a:path>
                <a:path w="2237740" h="311784">
                  <a:moveTo>
                    <a:pt x="366649" y="155702"/>
                  </a:moveTo>
                  <a:lnTo>
                    <a:pt x="353568" y="155702"/>
                  </a:lnTo>
                  <a:lnTo>
                    <a:pt x="353568" y="311404"/>
                  </a:lnTo>
                  <a:lnTo>
                    <a:pt x="366649" y="311404"/>
                  </a:lnTo>
                  <a:lnTo>
                    <a:pt x="366649" y="155702"/>
                  </a:lnTo>
                  <a:close/>
                </a:path>
                <a:path w="2237740" h="311784">
                  <a:moveTo>
                    <a:pt x="424675" y="155702"/>
                  </a:moveTo>
                  <a:lnTo>
                    <a:pt x="411607" y="155702"/>
                  </a:lnTo>
                  <a:lnTo>
                    <a:pt x="411607" y="311404"/>
                  </a:lnTo>
                  <a:lnTo>
                    <a:pt x="424675" y="311404"/>
                  </a:lnTo>
                  <a:lnTo>
                    <a:pt x="424675" y="155702"/>
                  </a:lnTo>
                  <a:close/>
                </a:path>
                <a:path w="2237740" h="311784">
                  <a:moveTo>
                    <a:pt x="474853" y="218059"/>
                  </a:moveTo>
                  <a:lnTo>
                    <a:pt x="464439" y="218059"/>
                  </a:lnTo>
                  <a:lnTo>
                    <a:pt x="464439" y="311404"/>
                  </a:lnTo>
                  <a:lnTo>
                    <a:pt x="474853" y="311404"/>
                  </a:lnTo>
                  <a:lnTo>
                    <a:pt x="474853" y="218059"/>
                  </a:lnTo>
                  <a:close/>
                </a:path>
                <a:path w="2237740" h="311784">
                  <a:moveTo>
                    <a:pt x="532879" y="124587"/>
                  </a:moveTo>
                  <a:lnTo>
                    <a:pt x="522478" y="124587"/>
                  </a:lnTo>
                  <a:lnTo>
                    <a:pt x="522478" y="311404"/>
                  </a:lnTo>
                  <a:lnTo>
                    <a:pt x="532879" y="311404"/>
                  </a:lnTo>
                  <a:lnTo>
                    <a:pt x="532879" y="124587"/>
                  </a:lnTo>
                  <a:close/>
                </a:path>
                <a:path w="2237740" h="311784">
                  <a:moveTo>
                    <a:pt x="590931" y="249174"/>
                  </a:moveTo>
                  <a:lnTo>
                    <a:pt x="580517" y="249174"/>
                  </a:lnTo>
                  <a:lnTo>
                    <a:pt x="580517" y="311404"/>
                  </a:lnTo>
                  <a:lnTo>
                    <a:pt x="590931" y="311404"/>
                  </a:lnTo>
                  <a:lnTo>
                    <a:pt x="590931" y="249174"/>
                  </a:lnTo>
                  <a:close/>
                </a:path>
                <a:path w="2237740" h="311784">
                  <a:moveTo>
                    <a:pt x="648970" y="249174"/>
                  </a:moveTo>
                  <a:lnTo>
                    <a:pt x="638556" y="249174"/>
                  </a:lnTo>
                  <a:lnTo>
                    <a:pt x="638556" y="311404"/>
                  </a:lnTo>
                  <a:lnTo>
                    <a:pt x="648970" y="311404"/>
                  </a:lnTo>
                  <a:lnTo>
                    <a:pt x="648970" y="249174"/>
                  </a:lnTo>
                  <a:close/>
                </a:path>
                <a:path w="2237740" h="311784">
                  <a:moveTo>
                    <a:pt x="707009" y="155702"/>
                  </a:moveTo>
                  <a:lnTo>
                    <a:pt x="696595" y="155702"/>
                  </a:lnTo>
                  <a:lnTo>
                    <a:pt x="696595" y="311404"/>
                  </a:lnTo>
                  <a:lnTo>
                    <a:pt x="707009" y="311404"/>
                  </a:lnTo>
                  <a:lnTo>
                    <a:pt x="707009" y="155702"/>
                  </a:lnTo>
                  <a:close/>
                </a:path>
                <a:path w="2237740" h="311784">
                  <a:moveTo>
                    <a:pt x="765035" y="280289"/>
                  </a:moveTo>
                  <a:lnTo>
                    <a:pt x="754634" y="280289"/>
                  </a:lnTo>
                  <a:lnTo>
                    <a:pt x="754634" y="311404"/>
                  </a:lnTo>
                  <a:lnTo>
                    <a:pt x="765035" y="311404"/>
                  </a:lnTo>
                  <a:lnTo>
                    <a:pt x="765035" y="280289"/>
                  </a:lnTo>
                  <a:close/>
                </a:path>
                <a:path w="2237740" h="311784">
                  <a:moveTo>
                    <a:pt x="823087" y="155702"/>
                  </a:moveTo>
                  <a:lnTo>
                    <a:pt x="812673" y="155702"/>
                  </a:lnTo>
                  <a:lnTo>
                    <a:pt x="812673" y="311404"/>
                  </a:lnTo>
                  <a:lnTo>
                    <a:pt x="823087" y="311404"/>
                  </a:lnTo>
                  <a:lnTo>
                    <a:pt x="823087" y="155702"/>
                  </a:lnTo>
                  <a:close/>
                </a:path>
                <a:path w="2237740" h="311784">
                  <a:moveTo>
                    <a:pt x="881253" y="124587"/>
                  </a:moveTo>
                  <a:lnTo>
                    <a:pt x="870839" y="124587"/>
                  </a:lnTo>
                  <a:lnTo>
                    <a:pt x="870839" y="311404"/>
                  </a:lnTo>
                  <a:lnTo>
                    <a:pt x="881253" y="311404"/>
                  </a:lnTo>
                  <a:lnTo>
                    <a:pt x="881253" y="124587"/>
                  </a:lnTo>
                  <a:close/>
                </a:path>
                <a:path w="2237740" h="311784">
                  <a:moveTo>
                    <a:pt x="947166" y="218059"/>
                  </a:moveTo>
                  <a:lnTo>
                    <a:pt x="934085" y="218059"/>
                  </a:lnTo>
                  <a:lnTo>
                    <a:pt x="934085" y="311404"/>
                  </a:lnTo>
                  <a:lnTo>
                    <a:pt x="947166" y="311404"/>
                  </a:lnTo>
                  <a:lnTo>
                    <a:pt x="947166" y="218059"/>
                  </a:lnTo>
                  <a:close/>
                </a:path>
                <a:path w="2237740" h="311784">
                  <a:moveTo>
                    <a:pt x="1063244" y="280289"/>
                  </a:moveTo>
                  <a:lnTo>
                    <a:pt x="1050163" y="280289"/>
                  </a:lnTo>
                  <a:lnTo>
                    <a:pt x="1050163" y="311404"/>
                  </a:lnTo>
                  <a:lnTo>
                    <a:pt x="1063244" y="311404"/>
                  </a:lnTo>
                  <a:lnTo>
                    <a:pt x="1063244" y="280289"/>
                  </a:lnTo>
                  <a:close/>
                </a:path>
                <a:path w="2237740" h="311784">
                  <a:moveTo>
                    <a:pt x="1113409" y="280289"/>
                  </a:moveTo>
                  <a:lnTo>
                    <a:pt x="1102995" y="280289"/>
                  </a:lnTo>
                  <a:lnTo>
                    <a:pt x="1102995" y="311404"/>
                  </a:lnTo>
                  <a:lnTo>
                    <a:pt x="1113409" y="311404"/>
                  </a:lnTo>
                  <a:lnTo>
                    <a:pt x="1113409" y="280289"/>
                  </a:lnTo>
                  <a:close/>
                </a:path>
                <a:path w="2237740" h="311784">
                  <a:moveTo>
                    <a:pt x="1171435" y="280289"/>
                  </a:moveTo>
                  <a:lnTo>
                    <a:pt x="1161034" y="280289"/>
                  </a:lnTo>
                  <a:lnTo>
                    <a:pt x="1161034" y="311404"/>
                  </a:lnTo>
                  <a:lnTo>
                    <a:pt x="1171435" y="311404"/>
                  </a:lnTo>
                  <a:lnTo>
                    <a:pt x="1171435" y="280289"/>
                  </a:lnTo>
                  <a:close/>
                </a:path>
                <a:path w="2237740" h="311784">
                  <a:moveTo>
                    <a:pt x="1250429" y="249174"/>
                  </a:moveTo>
                  <a:lnTo>
                    <a:pt x="1233043" y="249174"/>
                  </a:lnTo>
                  <a:lnTo>
                    <a:pt x="1233043" y="311404"/>
                  </a:lnTo>
                  <a:lnTo>
                    <a:pt x="1250429" y="311404"/>
                  </a:lnTo>
                  <a:lnTo>
                    <a:pt x="1250429" y="249174"/>
                  </a:lnTo>
                  <a:close/>
                </a:path>
                <a:path w="2237740" h="311784">
                  <a:moveTo>
                    <a:pt x="1295400" y="280289"/>
                  </a:moveTo>
                  <a:lnTo>
                    <a:pt x="1282319" y="280289"/>
                  </a:lnTo>
                  <a:lnTo>
                    <a:pt x="1282319" y="311404"/>
                  </a:lnTo>
                  <a:lnTo>
                    <a:pt x="1295400" y="311404"/>
                  </a:lnTo>
                  <a:lnTo>
                    <a:pt x="1295400" y="280289"/>
                  </a:lnTo>
                  <a:close/>
                </a:path>
                <a:path w="2237740" h="311784">
                  <a:moveTo>
                    <a:pt x="1345552" y="249174"/>
                  </a:moveTo>
                  <a:lnTo>
                    <a:pt x="1335151" y="249174"/>
                  </a:lnTo>
                  <a:lnTo>
                    <a:pt x="1335151" y="311404"/>
                  </a:lnTo>
                  <a:lnTo>
                    <a:pt x="1345552" y="311404"/>
                  </a:lnTo>
                  <a:lnTo>
                    <a:pt x="1345552" y="249174"/>
                  </a:lnTo>
                  <a:close/>
                </a:path>
                <a:path w="2237740" h="311784">
                  <a:moveTo>
                    <a:pt x="1411605" y="218059"/>
                  </a:moveTo>
                  <a:lnTo>
                    <a:pt x="1398524" y="218059"/>
                  </a:lnTo>
                  <a:lnTo>
                    <a:pt x="1398524" y="311404"/>
                  </a:lnTo>
                  <a:lnTo>
                    <a:pt x="1411605" y="311404"/>
                  </a:lnTo>
                  <a:lnTo>
                    <a:pt x="1411605" y="218059"/>
                  </a:lnTo>
                  <a:close/>
                </a:path>
                <a:path w="2237740" h="311784">
                  <a:moveTo>
                    <a:pt x="1461770" y="280289"/>
                  </a:moveTo>
                  <a:lnTo>
                    <a:pt x="1451356" y="280289"/>
                  </a:lnTo>
                  <a:lnTo>
                    <a:pt x="1451356" y="311404"/>
                  </a:lnTo>
                  <a:lnTo>
                    <a:pt x="1461770" y="311404"/>
                  </a:lnTo>
                  <a:lnTo>
                    <a:pt x="1461770" y="280289"/>
                  </a:lnTo>
                  <a:close/>
                </a:path>
                <a:path w="2237740" h="311784">
                  <a:moveTo>
                    <a:pt x="1540637" y="218059"/>
                  </a:moveTo>
                  <a:lnTo>
                    <a:pt x="1523238" y="218059"/>
                  </a:lnTo>
                  <a:lnTo>
                    <a:pt x="1523238" y="311404"/>
                  </a:lnTo>
                  <a:lnTo>
                    <a:pt x="1540637" y="311404"/>
                  </a:lnTo>
                  <a:lnTo>
                    <a:pt x="1540637" y="218059"/>
                  </a:lnTo>
                  <a:close/>
                </a:path>
                <a:path w="2237740" h="311784">
                  <a:moveTo>
                    <a:pt x="1585722" y="249174"/>
                  </a:moveTo>
                  <a:lnTo>
                    <a:pt x="1572641" y="249174"/>
                  </a:lnTo>
                  <a:lnTo>
                    <a:pt x="1572641" y="311404"/>
                  </a:lnTo>
                  <a:lnTo>
                    <a:pt x="1585722" y="311404"/>
                  </a:lnTo>
                  <a:lnTo>
                    <a:pt x="1585722" y="249174"/>
                  </a:lnTo>
                  <a:close/>
                </a:path>
                <a:path w="2237740" h="311784">
                  <a:moveTo>
                    <a:pt x="1643748" y="280289"/>
                  </a:moveTo>
                  <a:lnTo>
                    <a:pt x="1630680" y="280289"/>
                  </a:lnTo>
                  <a:lnTo>
                    <a:pt x="1630680" y="311404"/>
                  </a:lnTo>
                  <a:lnTo>
                    <a:pt x="1643748" y="311404"/>
                  </a:lnTo>
                  <a:lnTo>
                    <a:pt x="1643748" y="280289"/>
                  </a:lnTo>
                  <a:close/>
                </a:path>
                <a:path w="2237740" h="311784">
                  <a:moveTo>
                    <a:pt x="1759839" y="249174"/>
                  </a:moveTo>
                  <a:lnTo>
                    <a:pt x="1746758" y="249174"/>
                  </a:lnTo>
                  <a:lnTo>
                    <a:pt x="1746758" y="311404"/>
                  </a:lnTo>
                  <a:lnTo>
                    <a:pt x="1759839" y="311404"/>
                  </a:lnTo>
                  <a:lnTo>
                    <a:pt x="1759839" y="249174"/>
                  </a:lnTo>
                  <a:close/>
                </a:path>
                <a:path w="2237740" h="311784">
                  <a:moveTo>
                    <a:pt x="1817878" y="249174"/>
                  </a:moveTo>
                  <a:lnTo>
                    <a:pt x="1804797" y="249174"/>
                  </a:lnTo>
                  <a:lnTo>
                    <a:pt x="1804797" y="311404"/>
                  </a:lnTo>
                  <a:lnTo>
                    <a:pt x="1817878" y="311404"/>
                  </a:lnTo>
                  <a:lnTo>
                    <a:pt x="1817878" y="249174"/>
                  </a:lnTo>
                  <a:close/>
                </a:path>
                <a:path w="2237740" h="311784">
                  <a:moveTo>
                    <a:pt x="1934083" y="218059"/>
                  </a:moveTo>
                  <a:lnTo>
                    <a:pt x="1921002" y="218059"/>
                  </a:lnTo>
                  <a:lnTo>
                    <a:pt x="1921002" y="311404"/>
                  </a:lnTo>
                  <a:lnTo>
                    <a:pt x="1934083" y="311404"/>
                  </a:lnTo>
                  <a:lnTo>
                    <a:pt x="1934083" y="218059"/>
                  </a:lnTo>
                  <a:close/>
                </a:path>
                <a:path w="2237740" h="311784">
                  <a:moveTo>
                    <a:pt x="1992122" y="218059"/>
                  </a:moveTo>
                  <a:lnTo>
                    <a:pt x="1979041" y="218059"/>
                  </a:lnTo>
                  <a:lnTo>
                    <a:pt x="1979041" y="311404"/>
                  </a:lnTo>
                  <a:lnTo>
                    <a:pt x="1992122" y="311404"/>
                  </a:lnTo>
                  <a:lnTo>
                    <a:pt x="1992122" y="218059"/>
                  </a:lnTo>
                  <a:close/>
                </a:path>
                <a:path w="2237740" h="311784">
                  <a:moveTo>
                    <a:pt x="2063102" y="186817"/>
                  </a:moveTo>
                  <a:lnTo>
                    <a:pt x="2045716" y="186817"/>
                  </a:lnTo>
                  <a:lnTo>
                    <a:pt x="2045716" y="311404"/>
                  </a:lnTo>
                  <a:lnTo>
                    <a:pt x="2063102" y="311404"/>
                  </a:lnTo>
                  <a:lnTo>
                    <a:pt x="2063102" y="186817"/>
                  </a:lnTo>
                  <a:close/>
                </a:path>
                <a:path w="2237740" h="311784">
                  <a:moveTo>
                    <a:pt x="2237359" y="280289"/>
                  </a:moveTo>
                  <a:lnTo>
                    <a:pt x="2211197" y="280289"/>
                  </a:lnTo>
                  <a:lnTo>
                    <a:pt x="2211197" y="311404"/>
                  </a:lnTo>
                  <a:lnTo>
                    <a:pt x="2237359" y="311404"/>
                  </a:lnTo>
                  <a:lnTo>
                    <a:pt x="2237359" y="280289"/>
                  </a:lnTo>
                  <a:close/>
                </a:path>
              </a:pathLst>
            </a:custGeom>
            <a:solidFill>
              <a:srgbClr val="DFD62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4" name="object 114" descr=""/>
            <p:cNvSpPr/>
            <p:nvPr/>
          </p:nvSpPr>
          <p:spPr>
            <a:xfrm>
              <a:off x="1150874" y="8600186"/>
              <a:ext cx="71120" cy="62230"/>
            </a:xfrm>
            <a:custGeom>
              <a:avLst/>
              <a:gdLst/>
              <a:ahLst/>
              <a:cxnLst/>
              <a:rect l="l" t="t" r="r" b="b"/>
              <a:pathLst>
                <a:path w="71119" h="62229">
                  <a:moveTo>
                    <a:pt x="13081" y="0"/>
                  </a:moveTo>
                  <a:lnTo>
                    <a:pt x="0" y="0"/>
                  </a:lnTo>
                  <a:lnTo>
                    <a:pt x="0" y="62230"/>
                  </a:lnTo>
                  <a:lnTo>
                    <a:pt x="13081" y="62230"/>
                  </a:lnTo>
                  <a:lnTo>
                    <a:pt x="13081" y="0"/>
                  </a:lnTo>
                  <a:close/>
                </a:path>
                <a:path w="71119" h="62229">
                  <a:moveTo>
                    <a:pt x="71120" y="31115"/>
                  </a:moveTo>
                  <a:lnTo>
                    <a:pt x="58039" y="31115"/>
                  </a:lnTo>
                  <a:lnTo>
                    <a:pt x="58039" y="62230"/>
                  </a:lnTo>
                  <a:lnTo>
                    <a:pt x="71120" y="62230"/>
                  </a:lnTo>
                  <a:lnTo>
                    <a:pt x="71120" y="31115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5" name="object 115" descr=""/>
            <p:cNvSpPr/>
            <p:nvPr/>
          </p:nvSpPr>
          <p:spPr>
            <a:xfrm>
              <a:off x="1266951" y="8662416"/>
              <a:ext cx="13335" cy="0"/>
            </a:xfrm>
            <a:custGeom>
              <a:avLst/>
              <a:gdLst/>
              <a:ahLst/>
              <a:cxnLst/>
              <a:rect l="l" t="t" r="r" b="b"/>
              <a:pathLst>
                <a:path w="13334" h="0">
                  <a:moveTo>
                    <a:pt x="0" y="0"/>
                  </a:moveTo>
                  <a:lnTo>
                    <a:pt x="13081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6" name="object 116" descr=""/>
            <p:cNvSpPr/>
            <p:nvPr/>
          </p:nvSpPr>
          <p:spPr>
            <a:xfrm>
              <a:off x="1324991" y="8257667"/>
              <a:ext cx="4079240" cy="405130"/>
            </a:xfrm>
            <a:custGeom>
              <a:avLst/>
              <a:gdLst/>
              <a:ahLst/>
              <a:cxnLst/>
              <a:rect l="l" t="t" r="r" b="b"/>
              <a:pathLst>
                <a:path w="4079240" h="405129">
                  <a:moveTo>
                    <a:pt x="13081" y="311404"/>
                  </a:moveTo>
                  <a:lnTo>
                    <a:pt x="0" y="311404"/>
                  </a:lnTo>
                  <a:lnTo>
                    <a:pt x="0" y="404749"/>
                  </a:lnTo>
                  <a:lnTo>
                    <a:pt x="13081" y="404749"/>
                  </a:lnTo>
                  <a:lnTo>
                    <a:pt x="13081" y="311404"/>
                  </a:lnTo>
                  <a:close/>
                </a:path>
                <a:path w="4079240" h="405129">
                  <a:moveTo>
                    <a:pt x="71120" y="342519"/>
                  </a:moveTo>
                  <a:lnTo>
                    <a:pt x="58039" y="342519"/>
                  </a:lnTo>
                  <a:lnTo>
                    <a:pt x="58039" y="404749"/>
                  </a:lnTo>
                  <a:lnTo>
                    <a:pt x="71120" y="404749"/>
                  </a:lnTo>
                  <a:lnTo>
                    <a:pt x="71120" y="342519"/>
                  </a:lnTo>
                  <a:close/>
                </a:path>
                <a:path w="4079240" h="405129">
                  <a:moveTo>
                    <a:pt x="129159" y="373634"/>
                  </a:moveTo>
                  <a:lnTo>
                    <a:pt x="116078" y="373634"/>
                  </a:lnTo>
                  <a:lnTo>
                    <a:pt x="116078" y="404749"/>
                  </a:lnTo>
                  <a:lnTo>
                    <a:pt x="129159" y="404749"/>
                  </a:lnTo>
                  <a:lnTo>
                    <a:pt x="129159" y="373634"/>
                  </a:lnTo>
                  <a:close/>
                </a:path>
                <a:path w="4079240" h="405129">
                  <a:moveTo>
                    <a:pt x="187198" y="373634"/>
                  </a:moveTo>
                  <a:lnTo>
                    <a:pt x="174117" y="373634"/>
                  </a:lnTo>
                  <a:lnTo>
                    <a:pt x="174117" y="404749"/>
                  </a:lnTo>
                  <a:lnTo>
                    <a:pt x="187198" y="404749"/>
                  </a:lnTo>
                  <a:lnTo>
                    <a:pt x="187198" y="373634"/>
                  </a:lnTo>
                  <a:close/>
                </a:path>
                <a:path w="4079240" h="405129">
                  <a:moveTo>
                    <a:pt x="247764" y="280162"/>
                  </a:moveTo>
                  <a:lnTo>
                    <a:pt x="237363" y="280162"/>
                  </a:lnTo>
                  <a:lnTo>
                    <a:pt x="237363" y="404749"/>
                  </a:lnTo>
                  <a:lnTo>
                    <a:pt x="247764" y="404749"/>
                  </a:lnTo>
                  <a:lnTo>
                    <a:pt x="247764" y="280162"/>
                  </a:lnTo>
                  <a:close/>
                </a:path>
                <a:path w="4079240" h="405129">
                  <a:moveTo>
                    <a:pt x="303276" y="373634"/>
                  </a:moveTo>
                  <a:lnTo>
                    <a:pt x="290195" y="373634"/>
                  </a:lnTo>
                  <a:lnTo>
                    <a:pt x="290195" y="404749"/>
                  </a:lnTo>
                  <a:lnTo>
                    <a:pt x="303276" y="404749"/>
                  </a:lnTo>
                  <a:lnTo>
                    <a:pt x="303276" y="373634"/>
                  </a:lnTo>
                  <a:close/>
                </a:path>
                <a:path w="4079240" h="405129">
                  <a:moveTo>
                    <a:pt x="363969" y="217932"/>
                  </a:moveTo>
                  <a:lnTo>
                    <a:pt x="353568" y="217932"/>
                  </a:lnTo>
                  <a:lnTo>
                    <a:pt x="353568" y="404749"/>
                  </a:lnTo>
                  <a:lnTo>
                    <a:pt x="363969" y="404749"/>
                  </a:lnTo>
                  <a:lnTo>
                    <a:pt x="363969" y="217932"/>
                  </a:lnTo>
                  <a:close/>
                </a:path>
                <a:path w="4079240" h="405129">
                  <a:moveTo>
                    <a:pt x="422021" y="342519"/>
                  </a:moveTo>
                  <a:lnTo>
                    <a:pt x="411607" y="342519"/>
                  </a:lnTo>
                  <a:lnTo>
                    <a:pt x="411607" y="404749"/>
                  </a:lnTo>
                  <a:lnTo>
                    <a:pt x="422021" y="404749"/>
                  </a:lnTo>
                  <a:lnTo>
                    <a:pt x="422021" y="342519"/>
                  </a:lnTo>
                  <a:close/>
                </a:path>
                <a:path w="4079240" h="405129">
                  <a:moveTo>
                    <a:pt x="480060" y="311404"/>
                  </a:moveTo>
                  <a:lnTo>
                    <a:pt x="469646" y="311404"/>
                  </a:lnTo>
                  <a:lnTo>
                    <a:pt x="469646" y="404749"/>
                  </a:lnTo>
                  <a:lnTo>
                    <a:pt x="480060" y="404749"/>
                  </a:lnTo>
                  <a:lnTo>
                    <a:pt x="480060" y="311404"/>
                  </a:lnTo>
                  <a:close/>
                </a:path>
                <a:path w="4079240" h="405129">
                  <a:moveTo>
                    <a:pt x="538099" y="249047"/>
                  </a:moveTo>
                  <a:lnTo>
                    <a:pt x="527685" y="249047"/>
                  </a:lnTo>
                  <a:lnTo>
                    <a:pt x="527685" y="404749"/>
                  </a:lnTo>
                  <a:lnTo>
                    <a:pt x="538099" y="404749"/>
                  </a:lnTo>
                  <a:lnTo>
                    <a:pt x="538099" y="249047"/>
                  </a:lnTo>
                  <a:close/>
                </a:path>
                <a:path w="4079240" h="405129">
                  <a:moveTo>
                    <a:pt x="596125" y="280162"/>
                  </a:moveTo>
                  <a:lnTo>
                    <a:pt x="585724" y="280162"/>
                  </a:lnTo>
                  <a:lnTo>
                    <a:pt x="585724" y="404749"/>
                  </a:lnTo>
                  <a:lnTo>
                    <a:pt x="596125" y="404749"/>
                  </a:lnTo>
                  <a:lnTo>
                    <a:pt x="596125" y="280162"/>
                  </a:lnTo>
                  <a:close/>
                </a:path>
                <a:path w="4079240" h="405129">
                  <a:moveTo>
                    <a:pt x="654177" y="124587"/>
                  </a:moveTo>
                  <a:lnTo>
                    <a:pt x="643763" y="124587"/>
                  </a:lnTo>
                  <a:lnTo>
                    <a:pt x="643763" y="404749"/>
                  </a:lnTo>
                  <a:lnTo>
                    <a:pt x="654177" y="404749"/>
                  </a:lnTo>
                  <a:lnTo>
                    <a:pt x="654177" y="124587"/>
                  </a:lnTo>
                  <a:close/>
                </a:path>
                <a:path w="4079240" h="405129">
                  <a:moveTo>
                    <a:pt x="712216" y="311404"/>
                  </a:moveTo>
                  <a:lnTo>
                    <a:pt x="701802" y="311404"/>
                  </a:lnTo>
                  <a:lnTo>
                    <a:pt x="701802" y="404749"/>
                  </a:lnTo>
                  <a:lnTo>
                    <a:pt x="712216" y="404749"/>
                  </a:lnTo>
                  <a:lnTo>
                    <a:pt x="712216" y="311404"/>
                  </a:lnTo>
                  <a:close/>
                </a:path>
                <a:path w="4079240" h="405129">
                  <a:moveTo>
                    <a:pt x="770255" y="186817"/>
                  </a:moveTo>
                  <a:lnTo>
                    <a:pt x="759841" y="186817"/>
                  </a:lnTo>
                  <a:lnTo>
                    <a:pt x="759841" y="404749"/>
                  </a:lnTo>
                  <a:lnTo>
                    <a:pt x="770255" y="404749"/>
                  </a:lnTo>
                  <a:lnTo>
                    <a:pt x="770255" y="186817"/>
                  </a:lnTo>
                  <a:close/>
                </a:path>
                <a:path w="4079240" h="405129">
                  <a:moveTo>
                    <a:pt x="828281" y="93345"/>
                  </a:moveTo>
                  <a:lnTo>
                    <a:pt x="817880" y="93345"/>
                  </a:lnTo>
                  <a:lnTo>
                    <a:pt x="817880" y="404749"/>
                  </a:lnTo>
                  <a:lnTo>
                    <a:pt x="828281" y="404749"/>
                  </a:lnTo>
                  <a:lnTo>
                    <a:pt x="828281" y="93345"/>
                  </a:lnTo>
                  <a:close/>
                </a:path>
                <a:path w="4079240" h="405129">
                  <a:moveTo>
                    <a:pt x="886460" y="124587"/>
                  </a:moveTo>
                  <a:lnTo>
                    <a:pt x="876046" y="124587"/>
                  </a:lnTo>
                  <a:lnTo>
                    <a:pt x="876046" y="404749"/>
                  </a:lnTo>
                  <a:lnTo>
                    <a:pt x="886460" y="404749"/>
                  </a:lnTo>
                  <a:lnTo>
                    <a:pt x="886460" y="124587"/>
                  </a:lnTo>
                  <a:close/>
                </a:path>
                <a:path w="4079240" h="405129">
                  <a:moveTo>
                    <a:pt x="944499" y="31115"/>
                  </a:moveTo>
                  <a:lnTo>
                    <a:pt x="934085" y="31115"/>
                  </a:lnTo>
                  <a:lnTo>
                    <a:pt x="934085" y="404749"/>
                  </a:lnTo>
                  <a:lnTo>
                    <a:pt x="944499" y="404749"/>
                  </a:lnTo>
                  <a:lnTo>
                    <a:pt x="944499" y="31115"/>
                  </a:lnTo>
                  <a:close/>
                </a:path>
                <a:path w="4079240" h="405129">
                  <a:moveTo>
                    <a:pt x="1002525" y="62230"/>
                  </a:moveTo>
                  <a:lnTo>
                    <a:pt x="992124" y="62230"/>
                  </a:lnTo>
                  <a:lnTo>
                    <a:pt x="992124" y="404749"/>
                  </a:lnTo>
                  <a:lnTo>
                    <a:pt x="1002525" y="404749"/>
                  </a:lnTo>
                  <a:lnTo>
                    <a:pt x="1002525" y="62230"/>
                  </a:lnTo>
                  <a:close/>
                </a:path>
                <a:path w="4079240" h="405129">
                  <a:moveTo>
                    <a:pt x="1060577" y="311404"/>
                  </a:moveTo>
                  <a:lnTo>
                    <a:pt x="1050163" y="311404"/>
                  </a:lnTo>
                  <a:lnTo>
                    <a:pt x="1050163" y="404749"/>
                  </a:lnTo>
                  <a:lnTo>
                    <a:pt x="1060577" y="404749"/>
                  </a:lnTo>
                  <a:lnTo>
                    <a:pt x="1060577" y="311404"/>
                  </a:lnTo>
                  <a:close/>
                </a:path>
                <a:path w="4079240" h="405129">
                  <a:moveTo>
                    <a:pt x="1118616" y="155702"/>
                  </a:moveTo>
                  <a:lnTo>
                    <a:pt x="1108202" y="155702"/>
                  </a:lnTo>
                  <a:lnTo>
                    <a:pt x="1108202" y="404749"/>
                  </a:lnTo>
                  <a:lnTo>
                    <a:pt x="1118616" y="404749"/>
                  </a:lnTo>
                  <a:lnTo>
                    <a:pt x="1118616" y="155702"/>
                  </a:lnTo>
                  <a:close/>
                </a:path>
                <a:path w="4079240" h="405129">
                  <a:moveTo>
                    <a:pt x="1176655" y="31115"/>
                  </a:moveTo>
                  <a:lnTo>
                    <a:pt x="1166241" y="31115"/>
                  </a:lnTo>
                  <a:lnTo>
                    <a:pt x="1166241" y="404749"/>
                  </a:lnTo>
                  <a:lnTo>
                    <a:pt x="1176655" y="404749"/>
                  </a:lnTo>
                  <a:lnTo>
                    <a:pt x="1176655" y="31115"/>
                  </a:lnTo>
                  <a:close/>
                </a:path>
                <a:path w="4079240" h="405129">
                  <a:moveTo>
                    <a:pt x="1234681" y="31115"/>
                  </a:moveTo>
                  <a:lnTo>
                    <a:pt x="1224280" y="31115"/>
                  </a:lnTo>
                  <a:lnTo>
                    <a:pt x="1224280" y="404749"/>
                  </a:lnTo>
                  <a:lnTo>
                    <a:pt x="1234681" y="404749"/>
                  </a:lnTo>
                  <a:lnTo>
                    <a:pt x="1234681" y="31115"/>
                  </a:lnTo>
                  <a:close/>
                </a:path>
                <a:path w="4079240" h="405129">
                  <a:moveTo>
                    <a:pt x="1292733" y="155702"/>
                  </a:moveTo>
                  <a:lnTo>
                    <a:pt x="1282319" y="155702"/>
                  </a:lnTo>
                  <a:lnTo>
                    <a:pt x="1282319" y="404749"/>
                  </a:lnTo>
                  <a:lnTo>
                    <a:pt x="1292733" y="404749"/>
                  </a:lnTo>
                  <a:lnTo>
                    <a:pt x="1292733" y="155702"/>
                  </a:lnTo>
                  <a:close/>
                </a:path>
                <a:path w="4079240" h="405129">
                  <a:moveTo>
                    <a:pt x="1350772" y="62230"/>
                  </a:moveTo>
                  <a:lnTo>
                    <a:pt x="1340358" y="62230"/>
                  </a:lnTo>
                  <a:lnTo>
                    <a:pt x="1340358" y="404749"/>
                  </a:lnTo>
                  <a:lnTo>
                    <a:pt x="1350772" y="404749"/>
                  </a:lnTo>
                  <a:lnTo>
                    <a:pt x="1350772" y="62230"/>
                  </a:lnTo>
                  <a:close/>
                </a:path>
                <a:path w="4079240" h="405129">
                  <a:moveTo>
                    <a:pt x="1408925" y="124587"/>
                  </a:moveTo>
                  <a:lnTo>
                    <a:pt x="1398524" y="124587"/>
                  </a:lnTo>
                  <a:lnTo>
                    <a:pt x="1398524" y="404749"/>
                  </a:lnTo>
                  <a:lnTo>
                    <a:pt x="1408925" y="404749"/>
                  </a:lnTo>
                  <a:lnTo>
                    <a:pt x="1408925" y="124587"/>
                  </a:lnTo>
                  <a:close/>
                </a:path>
                <a:path w="4079240" h="405129">
                  <a:moveTo>
                    <a:pt x="1466977" y="186817"/>
                  </a:moveTo>
                  <a:lnTo>
                    <a:pt x="1456563" y="186817"/>
                  </a:lnTo>
                  <a:lnTo>
                    <a:pt x="1456563" y="404749"/>
                  </a:lnTo>
                  <a:lnTo>
                    <a:pt x="1466977" y="404749"/>
                  </a:lnTo>
                  <a:lnTo>
                    <a:pt x="1466977" y="186817"/>
                  </a:lnTo>
                  <a:close/>
                </a:path>
                <a:path w="4079240" h="405129">
                  <a:moveTo>
                    <a:pt x="1525016" y="217932"/>
                  </a:moveTo>
                  <a:lnTo>
                    <a:pt x="1514602" y="217932"/>
                  </a:lnTo>
                  <a:lnTo>
                    <a:pt x="1514602" y="404749"/>
                  </a:lnTo>
                  <a:lnTo>
                    <a:pt x="1525016" y="404749"/>
                  </a:lnTo>
                  <a:lnTo>
                    <a:pt x="1525016" y="217932"/>
                  </a:lnTo>
                  <a:close/>
                </a:path>
                <a:path w="4079240" h="405129">
                  <a:moveTo>
                    <a:pt x="1583055" y="280162"/>
                  </a:moveTo>
                  <a:lnTo>
                    <a:pt x="1572641" y="280162"/>
                  </a:lnTo>
                  <a:lnTo>
                    <a:pt x="1572641" y="404749"/>
                  </a:lnTo>
                  <a:lnTo>
                    <a:pt x="1583055" y="404749"/>
                  </a:lnTo>
                  <a:lnTo>
                    <a:pt x="1583055" y="280162"/>
                  </a:lnTo>
                  <a:close/>
                </a:path>
                <a:path w="4079240" h="405129">
                  <a:moveTo>
                    <a:pt x="1641081" y="93345"/>
                  </a:moveTo>
                  <a:lnTo>
                    <a:pt x="1630680" y="93345"/>
                  </a:lnTo>
                  <a:lnTo>
                    <a:pt x="1630680" y="404749"/>
                  </a:lnTo>
                  <a:lnTo>
                    <a:pt x="1641081" y="404749"/>
                  </a:lnTo>
                  <a:lnTo>
                    <a:pt x="1641081" y="93345"/>
                  </a:lnTo>
                  <a:close/>
                </a:path>
                <a:path w="4079240" h="405129">
                  <a:moveTo>
                    <a:pt x="1699133" y="31115"/>
                  </a:moveTo>
                  <a:lnTo>
                    <a:pt x="1688719" y="31115"/>
                  </a:lnTo>
                  <a:lnTo>
                    <a:pt x="1688719" y="404749"/>
                  </a:lnTo>
                  <a:lnTo>
                    <a:pt x="1699133" y="404749"/>
                  </a:lnTo>
                  <a:lnTo>
                    <a:pt x="1699133" y="31115"/>
                  </a:lnTo>
                  <a:close/>
                </a:path>
                <a:path w="4079240" h="405129">
                  <a:moveTo>
                    <a:pt x="1757172" y="217932"/>
                  </a:moveTo>
                  <a:lnTo>
                    <a:pt x="1746758" y="217932"/>
                  </a:lnTo>
                  <a:lnTo>
                    <a:pt x="1746758" y="404749"/>
                  </a:lnTo>
                  <a:lnTo>
                    <a:pt x="1757172" y="404749"/>
                  </a:lnTo>
                  <a:lnTo>
                    <a:pt x="1757172" y="217932"/>
                  </a:lnTo>
                  <a:close/>
                </a:path>
                <a:path w="4079240" h="405129">
                  <a:moveTo>
                    <a:pt x="1815211" y="124587"/>
                  </a:moveTo>
                  <a:lnTo>
                    <a:pt x="1804797" y="124587"/>
                  </a:lnTo>
                  <a:lnTo>
                    <a:pt x="1804797" y="404749"/>
                  </a:lnTo>
                  <a:lnTo>
                    <a:pt x="1815211" y="404749"/>
                  </a:lnTo>
                  <a:lnTo>
                    <a:pt x="1815211" y="124587"/>
                  </a:lnTo>
                  <a:close/>
                </a:path>
                <a:path w="4079240" h="405129">
                  <a:moveTo>
                    <a:pt x="1873237" y="249047"/>
                  </a:moveTo>
                  <a:lnTo>
                    <a:pt x="1862836" y="249047"/>
                  </a:lnTo>
                  <a:lnTo>
                    <a:pt x="1862836" y="404749"/>
                  </a:lnTo>
                  <a:lnTo>
                    <a:pt x="1873237" y="404749"/>
                  </a:lnTo>
                  <a:lnTo>
                    <a:pt x="1873237" y="249047"/>
                  </a:lnTo>
                  <a:close/>
                </a:path>
                <a:path w="4079240" h="405129">
                  <a:moveTo>
                    <a:pt x="1931289" y="186817"/>
                  </a:moveTo>
                  <a:lnTo>
                    <a:pt x="1920875" y="186817"/>
                  </a:lnTo>
                  <a:lnTo>
                    <a:pt x="1920875" y="404749"/>
                  </a:lnTo>
                  <a:lnTo>
                    <a:pt x="1931289" y="404749"/>
                  </a:lnTo>
                  <a:lnTo>
                    <a:pt x="1931289" y="186817"/>
                  </a:lnTo>
                  <a:close/>
                </a:path>
                <a:path w="4079240" h="405129">
                  <a:moveTo>
                    <a:pt x="1989455" y="186817"/>
                  </a:moveTo>
                  <a:lnTo>
                    <a:pt x="1979041" y="186817"/>
                  </a:lnTo>
                  <a:lnTo>
                    <a:pt x="1979041" y="404749"/>
                  </a:lnTo>
                  <a:lnTo>
                    <a:pt x="1989455" y="404749"/>
                  </a:lnTo>
                  <a:lnTo>
                    <a:pt x="1989455" y="186817"/>
                  </a:lnTo>
                  <a:close/>
                </a:path>
                <a:path w="4079240" h="405129">
                  <a:moveTo>
                    <a:pt x="2047494" y="280162"/>
                  </a:moveTo>
                  <a:lnTo>
                    <a:pt x="2037080" y="280162"/>
                  </a:lnTo>
                  <a:lnTo>
                    <a:pt x="2037080" y="404749"/>
                  </a:lnTo>
                  <a:lnTo>
                    <a:pt x="2047494" y="404749"/>
                  </a:lnTo>
                  <a:lnTo>
                    <a:pt x="2047494" y="280162"/>
                  </a:lnTo>
                  <a:close/>
                </a:path>
                <a:path w="4079240" h="405129">
                  <a:moveTo>
                    <a:pt x="2105533" y="186817"/>
                  </a:moveTo>
                  <a:lnTo>
                    <a:pt x="2095119" y="186817"/>
                  </a:lnTo>
                  <a:lnTo>
                    <a:pt x="2095119" y="404749"/>
                  </a:lnTo>
                  <a:lnTo>
                    <a:pt x="2105533" y="404749"/>
                  </a:lnTo>
                  <a:lnTo>
                    <a:pt x="2105533" y="186817"/>
                  </a:lnTo>
                  <a:close/>
                </a:path>
                <a:path w="4079240" h="405129">
                  <a:moveTo>
                    <a:pt x="2163572" y="31115"/>
                  </a:moveTo>
                  <a:lnTo>
                    <a:pt x="2153158" y="31115"/>
                  </a:lnTo>
                  <a:lnTo>
                    <a:pt x="2153158" y="404749"/>
                  </a:lnTo>
                  <a:lnTo>
                    <a:pt x="2163572" y="404749"/>
                  </a:lnTo>
                  <a:lnTo>
                    <a:pt x="2163572" y="31115"/>
                  </a:lnTo>
                  <a:close/>
                </a:path>
                <a:path w="4079240" h="405129">
                  <a:moveTo>
                    <a:pt x="2221611" y="249047"/>
                  </a:moveTo>
                  <a:lnTo>
                    <a:pt x="2211197" y="249047"/>
                  </a:lnTo>
                  <a:lnTo>
                    <a:pt x="2211197" y="404749"/>
                  </a:lnTo>
                  <a:lnTo>
                    <a:pt x="2221611" y="404749"/>
                  </a:lnTo>
                  <a:lnTo>
                    <a:pt x="2221611" y="249047"/>
                  </a:lnTo>
                  <a:close/>
                </a:path>
                <a:path w="4079240" h="405129">
                  <a:moveTo>
                    <a:pt x="2279650" y="249047"/>
                  </a:moveTo>
                  <a:lnTo>
                    <a:pt x="2269236" y="249047"/>
                  </a:lnTo>
                  <a:lnTo>
                    <a:pt x="2269236" y="404749"/>
                  </a:lnTo>
                  <a:lnTo>
                    <a:pt x="2279650" y="404749"/>
                  </a:lnTo>
                  <a:lnTo>
                    <a:pt x="2279650" y="249047"/>
                  </a:lnTo>
                  <a:close/>
                </a:path>
                <a:path w="4079240" h="405129">
                  <a:moveTo>
                    <a:pt x="2337689" y="217932"/>
                  </a:moveTo>
                  <a:lnTo>
                    <a:pt x="2327275" y="217932"/>
                  </a:lnTo>
                  <a:lnTo>
                    <a:pt x="2327275" y="404749"/>
                  </a:lnTo>
                  <a:lnTo>
                    <a:pt x="2337689" y="404749"/>
                  </a:lnTo>
                  <a:lnTo>
                    <a:pt x="2337689" y="217932"/>
                  </a:lnTo>
                  <a:close/>
                </a:path>
                <a:path w="4079240" h="405129">
                  <a:moveTo>
                    <a:pt x="2395715" y="93345"/>
                  </a:moveTo>
                  <a:lnTo>
                    <a:pt x="2385314" y="93345"/>
                  </a:lnTo>
                  <a:lnTo>
                    <a:pt x="2385314" y="404749"/>
                  </a:lnTo>
                  <a:lnTo>
                    <a:pt x="2395715" y="404749"/>
                  </a:lnTo>
                  <a:lnTo>
                    <a:pt x="2395715" y="93345"/>
                  </a:lnTo>
                  <a:close/>
                </a:path>
                <a:path w="4079240" h="405129">
                  <a:moveTo>
                    <a:pt x="2453767" y="93345"/>
                  </a:moveTo>
                  <a:lnTo>
                    <a:pt x="2443353" y="93345"/>
                  </a:lnTo>
                  <a:lnTo>
                    <a:pt x="2443353" y="404749"/>
                  </a:lnTo>
                  <a:lnTo>
                    <a:pt x="2453767" y="404749"/>
                  </a:lnTo>
                  <a:lnTo>
                    <a:pt x="2453767" y="93345"/>
                  </a:lnTo>
                  <a:close/>
                </a:path>
                <a:path w="4079240" h="405129">
                  <a:moveTo>
                    <a:pt x="2511933" y="217932"/>
                  </a:moveTo>
                  <a:lnTo>
                    <a:pt x="2501519" y="217932"/>
                  </a:lnTo>
                  <a:lnTo>
                    <a:pt x="2501519" y="404749"/>
                  </a:lnTo>
                  <a:lnTo>
                    <a:pt x="2511933" y="404749"/>
                  </a:lnTo>
                  <a:lnTo>
                    <a:pt x="2511933" y="217932"/>
                  </a:lnTo>
                  <a:close/>
                </a:path>
                <a:path w="4079240" h="405129">
                  <a:moveTo>
                    <a:pt x="2569972" y="217932"/>
                  </a:moveTo>
                  <a:lnTo>
                    <a:pt x="2559558" y="217932"/>
                  </a:lnTo>
                  <a:lnTo>
                    <a:pt x="2559558" y="404749"/>
                  </a:lnTo>
                  <a:lnTo>
                    <a:pt x="2569972" y="404749"/>
                  </a:lnTo>
                  <a:lnTo>
                    <a:pt x="2569972" y="217932"/>
                  </a:lnTo>
                  <a:close/>
                </a:path>
                <a:path w="4079240" h="405129">
                  <a:moveTo>
                    <a:pt x="2628011" y="155702"/>
                  </a:moveTo>
                  <a:lnTo>
                    <a:pt x="2617597" y="155702"/>
                  </a:lnTo>
                  <a:lnTo>
                    <a:pt x="2617597" y="404749"/>
                  </a:lnTo>
                  <a:lnTo>
                    <a:pt x="2628011" y="404749"/>
                  </a:lnTo>
                  <a:lnTo>
                    <a:pt x="2628011" y="155702"/>
                  </a:lnTo>
                  <a:close/>
                </a:path>
                <a:path w="4079240" h="405129">
                  <a:moveTo>
                    <a:pt x="2686050" y="62230"/>
                  </a:moveTo>
                  <a:lnTo>
                    <a:pt x="2675636" y="62230"/>
                  </a:lnTo>
                  <a:lnTo>
                    <a:pt x="2675636" y="404749"/>
                  </a:lnTo>
                  <a:lnTo>
                    <a:pt x="2686050" y="404749"/>
                  </a:lnTo>
                  <a:lnTo>
                    <a:pt x="2686050" y="62230"/>
                  </a:lnTo>
                  <a:close/>
                </a:path>
                <a:path w="4079240" h="405129">
                  <a:moveTo>
                    <a:pt x="2744089" y="186817"/>
                  </a:moveTo>
                  <a:lnTo>
                    <a:pt x="2733675" y="186817"/>
                  </a:lnTo>
                  <a:lnTo>
                    <a:pt x="2733675" y="404749"/>
                  </a:lnTo>
                  <a:lnTo>
                    <a:pt x="2744089" y="404749"/>
                  </a:lnTo>
                  <a:lnTo>
                    <a:pt x="2744089" y="186817"/>
                  </a:lnTo>
                  <a:close/>
                </a:path>
                <a:path w="4079240" h="405129">
                  <a:moveTo>
                    <a:pt x="2802115" y="186817"/>
                  </a:moveTo>
                  <a:lnTo>
                    <a:pt x="2791714" y="186817"/>
                  </a:lnTo>
                  <a:lnTo>
                    <a:pt x="2791714" y="404749"/>
                  </a:lnTo>
                  <a:lnTo>
                    <a:pt x="2802115" y="404749"/>
                  </a:lnTo>
                  <a:lnTo>
                    <a:pt x="2802115" y="186817"/>
                  </a:lnTo>
                  <a:close/>
                </a:path>
                <a:path w="4079240" h="405129">
                  <a:moveTo>
                    <a:pt x="2860167" y="217932"/>
                  </a:moveTo>
                  <a:lnTo>
                    <a:pt x="2849753" y="217932"/>
                  </a:lnTo>
                  <a:lnTo>
                    <a:pt x="2849753" y="404749"/>
                  </a:lnTo>
                  <a:lnTo>
                    <a:pt x="2860167" y="404749"/>
                  </a:lnTo>
                  <a:lnTo>
                    <a:pt x="2860167" y="217932"/>
                  </a:lnTo>
                  <a:close/>
                </a:path>
                <a:path w="4079240" h="405129">
                  <a:moveTo>
                    <a:pt x="2918206" y="280162"/>
                  </a:moveTo>
                  <a:lnTo>
                    <a:pt x="2907792" y="280162"/>
                  </a:lnTo>
                  <a:lnTo>
                    <a:pt x="2907792" y="404749"/>
                  </a:lnTo>
                  <a:lnTo>
                    <a:pt x="2918206" y="404749"/>
                  </a:lnTo>
                  <a:lnTo>
                    <a:pt x="2918206" y="280162"/>
                  </a:lnTo>
                  <a:close/>
                </a:path>
                <a:path w="4079240" h="405129">
                  <a:moveTo>
                    <a:pt x="2976245" y="186817"/>
                  </a:moveTo>
                  <a:lnTo>
                    <a:pt x="2965831" y="186817"/>
                  </a:lnTo>
                  <a:lnTo>
                    <a:pt x="2965831" y="404749"/>
                  </a:lnTo>
                  <a:lnTo>
                    <a:pt x="2976245" y="404749"/>
                  </a:lnTo>
                  <a:lnTo>
                    <a:pt x="2976245" y="186817"/>
                  </a:lnTo>
                  <a:close/>
                </a:path>
                <a:path w="4079240" h="405129">
                  <a:moveTo>
                    <a:pt x="3034411" y="311404"/>
                  </a:moveTo>
                  <a:lnTo>
                    <a:pt x="3023997" y="311404"/>
                  </a:lnTo>
                  <a:lnTo>
                    <a:pt x="3023997" y="404749"/>
                  </a:lnTo>
                  <a:lnTo>
                    <a:pt x="3034411" y="404749"/>
                  </a:lnTo>
                  <a:lnTo>
                    <a:pt x="3034411" y="311404"/>
                  </a:lnTo>
                  <a:close/>
                </a:path>
                <a:path w="4079240" h="405129">
                  <a:moveTo>
                    <a:pt x="3092450" y="249047"/>
                  </a:moveTo>
                  <a:lnTo>
                    <a:pt x="3082036" y="249047"/>
                  </a:lnTo>
                  <a:lnTo>
                    <a:pt x="3082036" y="404749"/>
                  </a:lnTo>
                  <a:lnTo>
                    <a:pt x="3092450" y="404749"/>
                  </a:lnTo>
                  <a:lnTo>
                    <a:pt x="3092450" y="249047"/>
                  </a:lnTo>
                  <a:close/>
                </a:path>
                <a:path w="4079240" h="405129">
                  <a:moveTo>
                    <a:pt x="3150489" y="373634"/>
                  </a:moveTo>
                  <a:lnTo>
                    <a:pt x="3140075" y="373634"/>
                  </a:lnTo>
                  <a:lnTo>
                    <a:pt x="3140075" y="404749"/>
                  </a:lnTo>
                  <a:lnTo>
                    <a:pt x="3150489" y="404749"/>
                  </a:lnTo>
                  <a:lnTo>
                    <a:pt x="3150489" y="373634"/>
                  </a:lnTo>
                  <a:close/>
                </a:path>
                <a:path w="4079240" h="405129">
                  <a:moveTo>
                    <a:pt x="3208515" y="0"/>
                  </a:moveTo>
                  <a:lnTo>
                    <a:pt x="3198114" y="0"/>
                  </a:lnTo>
                  <a:lnTo>
                    <a:pt x="3198114" y="404749"/>
                  </a:lnTo>
                  <a:lnTo>
                    <a:pt x="3208515" y="404749"/>
                  </a:lnTo>
                  <a:lnTo>
                    <a:pt x="3208515" y="0"/>
                  </a:lnTo>
                  <a:close/>
                </a:path>
                <a:path w="4079240" h="405129">
                  <a:moveTo>
                    <a:pt x="3266567" y="311404"/>
                  </a:moveTo>
                  <a:lnTo>
                    <a:pt x="3256153" y="311404"/>
                  </a:lnTo>
                  <a:lnTo>
                    <a:pt x="3256153" y="404749"/>
                  </a:lnTo>
                  <a:lnTo>
                    <a:pt x="3266567" y="404749"/>
                  </a:lnTo>
                  <a:lnTo>
                    <a:pt x="3266567" y="311404"/>
                  </a:lnTo>
                  <a:close/>
                </a:path>
                <a:path w="4079240" h="405129">
                  <a:moveTo>
                    <a:pt x="3324606" y="311404"/>
                  </a:moveTo>
                  <a:lnTo>
                    <a:pt x="3314192" y="311404"/>
                  </a:lnTo>
                  <a:lnTo>
                    <a:pt x="3314192" y="404749"/>
                  </a:lnTo>
                  <a:lnTo>
                    <a:pt x="3324606" y="404749"/>
                  </a:lnTo>
                  <a:lnTo>
                    <a:pt x="3324606" y="311404"/>
                  </a:lnTo>
                  <a:close/>
                </a:path>
                <a:path w="4079240" h="405129">
                  <a:moveTo>
                    <a:pt x="3382645" y="124587"/>
                  </a:moveTo>
                  <a:lnTo>
                    <a:pt x="3372231" y="124587"/>
                  </a:lnTo>
                  <a:lnTo>
                    <a:pt x="3372231" y="404749"/>
                  </a:lnTo>
                  <a:lnTo>
                    <a:pt x="3382645" y="404749"/>
                  </a:lnTo>
                  <a:lnTo>
                    <a:pt x="3382645" y="124587"/>
                  </a:lnTo>
                  <a:close/>
                </a:path>
                <a:path w="4079240" h="405129">
                  <a:moveTo>
                    <a:pt x="3440684" y="249047"/>
                  </a:moveTo>
                  <a:lnTo>
                    <a:pt x="3430270" y="249047"/>
                  </a:lnTo>
                  <a:lnTo>
                    <a:pt x="3430270" y="404749"/>
                  </a:lnTo>
                  <a:lnTo>
                    <a:pt x="3440684" y="404749"/>
                  </a:lnTo>
                  <a:lnTo>
                    <a:pt x="3440684" y="249047"/>
                  </a:lnTo>
                  <a:close/>
                </a:path>
                <a:path w="4079240" h="405129">
                  <a:moveTo>
                    <a:pt x="3498723" y="155702"/>
                  </a:moveTo>
                  <a:lnTo>
                    <a:pt x="3488309" y="155702"/>
                  </a:lnTo>
                  <a:lnTo>
                    <a:pt x="3488309" y="404749"/>
                  </a:lnTo>
                  <a:lnTo>
                    <a:pt x="3498723" y="404749"/>
                  </a:lnTo>
                  <a:lnTo>
                    <a:pt x="3498723" y="155702"/>
                  </a:lnTo>
                  <a:close/>
                </a:path>
                <a:path w="4079240" h="405129">
                  <a:moveTo>
                    <a:pt x="3556762" y="217932"/>
                  </a:moveTo>
                  <a:lnTo>
                    <a:pt x="3546348" y="217932"/>
                  </a:lnTo>
                  <a:lnTo>
                    <a:pt x="3546348" y="404749"/>
                  </a:lnTo>
                  <a:lnTo>
                    <a:pt x="3556762" y="404749"/>
                  </a:lnTo>
                  <a:lnTo>
                    <a:pt x="3556762" y="217932"/>
                  </a:lnTo>
                  <a:close/>
                </a:path>
                <a:path w="4079240" h="405129">
                  <a:moveTo>
                    <a:pt x="3614915" y="186817"/>
                  </a:moveTo>
                  <a:lnTo>
                    <a:pt x="3604514" y="186817"/>
                  </a:lnTo>
                  <a:lnTo>
                    <a:pt x="3604514" y="404749"/>
                  </a:lnTo>
                  <a:lnTo>
                    <a:pt x="3614915" y="404749"/>
                  </a:lnTo>
                  <a:lnTo>
                    <a:pt x="3614915" y="186817"/>
                  </a:lnTo>
                  <a:close/>
                </a:path>
                <a:path w="4079240" h="405129">
                  <a:moveTo>
                    <a:pt x="3672967" y="249047"/>
                  </a:moveTo>
                  <a:lnTo>
                    <a:pt x="3662553" y="249047"/>
                  </a:lnTo>
                  <a:lnTo>
                    <a:pt x="3662553" y="404749"/>
                  </a:lnTo>
                  <a:lnTo>
                    <a:pt x="3672967" y="404749"/>
                  </a:lnTo>
                  <a:lnTo>
                    <a:pt x="3672967" y="249047"/>
                  </a:lnTo>
                  <a:close/>
                </a:path>
                <a:path w="4079240" h="405129">
                  <a:moveTo>
                    <a:pt x="3731006" y="93345"/>
                  </a:moveTo>
                  <a:lnTo>
                    <a:pt x="3720592" y="93345"/>
                  </a:lnTo>
                  <a:lnTo>
                    <a:pt x="3720592" y="404749"/>
                  </a:lnTo>
                  <a:lnTo>
                    <a:pt x="3731006" y="404749"/>
                  </a:lnTo>
                  <a:lnTo>
                    <a:pt x="3731006" y="93345"/>
                  </a:lnTo>
                  <a:close/>
                </a:path>
                <a:path w="4079240" h="405129">
                  <a:moveTo>
                    <a:pt x="3789045" y="62230"/>
                  </a:moveTo>
                  <a:lnTo>
                    <a:pt x="3778631" y="62230"/>
                  </a:lnTo>
                  <a:lnTo>
                    <a:pt x="3778631" y="404749"/>
                  </a:lnTo>
                  <a:lnTo>
                    <a:pt x="3789045" y="404749"/>
                  </a:lnTo>
                  <a:lnTo>
                    <a:pt x="3789045" y="62230"/>
                  </a:lnTo>
                  <a:close/>
                </a:path>
                <a:path w="4079240" h="405129">
                  <a:moveTo>
                    <a:pt x="3847084" y="62230"/>
                  </a:moveTo>
                  <a:lnTo>
                    <a:pt x="3836670" y="62230"/>
                  </a:lnTo>
                  <a:lnTo>
                    <a:pt x="3836670" y="404749"/>
                  </a:lnTo>
                  <a:lnTo>
                    <a:pt x="3847084" y="404749"/>
                  </a:lnTo>
                  <a:lnTo>
                    <a:pt x="3847084" y="62230"/>
                  </a:lnTo>
                  <a:close/>
                </a:path>
                <a:path w="4079240" h="405129">
                  <a:moveTo>
                    <a:pt x="3905123" y="186817"/>
                  </a:moveTo>
                  <a:lnTo>
                    <a:pt x="3894709" y="186817"/>
                  </a:lnTo>
                  <a:lnTo>
                    <a:pt x="3894709" y="404749"/>
                  </a:lnTo>
                  <a:lnTo>
                    <a:pt x="3905123" y="404749"/>
                  </a:lnTo>
                  <a:lnTo>
                    <a:pt x="3905123" y="186817"/>
                  </a:lnTo>
                  <a:close/>
                </a:path>
                <a:path w="4079240" h="405129">
                  <a:moveTo>
                    <a:pt x="3963162" y="93345"/>
                  </a:moveTo>
                  <a:lnTo>
                    <a:pt x="3952748" y="93345"/>
                  </a:lnTo>
                  <a:lnTo>
                    <a:pt x="3952748" y="404749"/>
                  </a:lnTo>
                  <a:lnTo>
                    <a:pt x="3963162" y="404749"/>
                  </a:lnTo>
                  <a:lnTo>
                    <a:pt x="3963162" y="93345"/>
                  </a:lnTo>
                  <a:close/>
                </a:path>
                <a:path w="4079240" h="405129">
                  <a:moveTo>
                    <a:pt x="4021201" y="311404"/>
                  </a:moveTo>
                  <a:lnTo>
                    <a:pt x="4010787" y="311404"/>
                  </a:lnTo>
                  <a:lnTo>
                    <a:pt x="4010787" y="404749"/>
                  </a:lnTo>
                  <a:lnTo>
                    <a:pt x="4021201" y="404749"/>
                  </a:lnTo>
                  <a:lnTo>
                    <a:pt x="4021201" y="311404"/>
                  </a:lnTo>
                  <a:close/>
                </a:path>
                <a:path w="4079240" h="405129">
                  <a:moveTo>
                    <a:pt x="4079240" y="311404"/>
                  </a:moveTo>
                  <a:lnTo>
                    <a:pt x="4068826" y="311404"/>
                  </a:lnTo>
                  <a:lnTo>
                    <a:pt x="4068826" y="404749"/>
                  </a:lnTo>
                  <a:lnTo>
                    <a:pt x="4079240" y="404749"/>
                  </a:lnTo>
                  <a:lnTo>
                    <a:pt x="4079240" y="311404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7" name="object 117" descr=""/>
            <p:cNvSpPr/>
            <p:nvPr/>
          </p:nvSpPr>
          <p:spPr>
            <a:xfrm>
              <a:off x="5393817" y="8288782"/>
              <a:ext cx="3842385" cy="374015"/>
            </a:xfrm>
            <a:custGeom>
              <a:avLst/>
              <a:gdLst/>
              <a:ahLst/>
              <a:cxnLst/>
              <a:rect l="l" t="t" r="r" b="b"/>
              <a:pathLst>
                <a:path w="3842384" h="374015">
                  <a:moveTo>
                    <a:pt x="10414" y="280289"/>
                  </a:moveTo>
                  <a:lnTo>
                    <a:pt x="0" y="280289"/>
                  </a:lnTo>
                  <a:lnTo>
                    <a:pt x="0" y="373634"/>
                  </a:lnTo>
                  <a:lnTo>
                    <a:pt x="10414" y="373634"/>
                  </a:lnTo>
                  <a:lnTo>
                    <a:pt x="10414" y="280289"/>
                  </a:lnTo>
                  <a:close/>
                </a:path>
                <a:path w="3842384" h="374015">
                  <a:moveTo>
                    <a:pt x="68580" y="280289"/>
                  </a:moveTo>
                  <a:lnTo>
                    <a:pt x="58166" y="280289"/>
                  </a:lnTo>
                  <a:lnTo>
                    <a:pt x="58166" y="373634"/>
                  </a:lnTo>
                  <a:lnTo>
                    <a:pt x="68580" y="373634"/>
                  </a:lnTo>
                  <a:lnTo>
                    <a:pt x="68580" y="280289"/>
                  </a:lnTo>
                  <a:close/>
                </a:path>
                <a:path w="3842384" h="374015">
                  <a:moveTo>
                    <a:pt x="126619" y="217932"/>
                  </a:moveTo>
                  <a:lnTo>
                    <a:pt x="116205" y="217932"/>
                  </a:lnTo>
                  <a:lnTo>
                    <a:pt x="116205" y="373634"/>
                  </a:lnTo>
                  <a:lnTo>
                    <a:pt x="126619" y="373634"/>
                  </a:lnTo>
                  <a:lnTo>
                    <a:pt x="126619" y="217932"/>
                  </a:lnTo>
                  <a:close/>
                </a:path>
                <a:path w="3842384" h="374015">
                  <a:moveTo>
                    <a:pt x="184658" y="93472"/>
                  </a:moveTo>
                  <a:lnTo>
                    <a:pt x="174244" y="93472"/>
                  </a:lnTo>
                  <a:lnTo>
                    <a:pt x="174244" y="373634"/>
                  </a:lnTo>
                  <a:lnTo>
                    <a:pt x="184658" y="373634"/>
                  </a:lnTo>
                  <a:lnTo>
                    <a:pt x="184658" y="93472"/>
                  </a:lnTo>
                  <a:close/>
                </a:path>
                <a:path w="3842384" h="374015">
                  <a:moveTo>
                    <a:pt x="242697" y="186817"/>
                  </a:moveTo>
                  <a:lnTo>
                    <a:pt x="232283" y="186817"/>
                  </a:lnTo>
                  <a:lnTo>
                    <a:pt x="232283" y="373634"/>
                  </a:lnTo>
                  <a:lnTo>
                    <a:pt x="242697" y="373634"/>
                  </a:lnTo>
                  <a:lnTo>
                    <a:pt x="242697" y="186817"/>
                  </a:lnTo>
                  <a:close/>
                </a:path>
                <a:path w="3842384" h="374015">
                  <a:moveTo>
                    <a:pt x="300736" y="280289"/>
                  </a:moveTo>
                  <a:lnTo>
                    <a:pt x="290322" y="280289"/>
                  </a:lnTo>
                  <a:lnTo>
                    <a:pt x="290322" y="373634"/>
                  </a:lnTo>
                  <a:lnTo>
                    <a:pt x="300736" y="373634"/>
                  </a:lnTo>
                  <a:lnTo>
                    <a:pt x="300736" y="280289"/>
                  </a:lnTo>
                  <a:close/>
                </a:path>
                <a:path w="3842384" h="374015">
                  <a:moveTo>
                    <a:pt x="358775" y="249047"/>
                  </a:moveTo>
                  <a:lnTo>
                    <a:pt x="348361" y="249047"/>
                  </a:lnTo>
                  <a:lnTo>
                    <a:pt x="348361" y="373634"/>
                  </a:lnTo>
                  <a:lnTo>
                    <a:pt x="358775" y="373634"/>
                  </a:lnTo>
                  <a:lnTo>
                    <a:pt x="358775" y="249047"/>
                  </a:lnTo>
                  <a:close/>
                </a:path>
                <a:path w="3842384" h="374015">
                  <a:moveTo>
                    <a:pt x="416814" y="186817"/>
                  </a:moveTo>
                  <a:lnTo>
                    <a:pt x="406400" y="186817"/>
                  </a:lnTo>
                  <a:lnTo>
                    <a:pt x="406400" y="373634"/>
                  </a:lnTo>
                  <a:lnTo>
                    <a:pt x="416814" y="373634"/>
                  </a:lnTo>
                  <a:lnTo>
                    <a:pt x="416814" y="186817"/>
                  </a:lnTo>
                  <a:close/>
                </a:path>
                <a:path w="3842384" h="374015">
                  <a:moveTo>
                    <a:pt x="474840" y="249047"/>
                  </a:moveTo>
                  <a:lnTo>
                    <a:pt x="464439" y="249047"/>
                  </a:lnTo>
                  <a:lnTo>
                    <a:pt x="464439" y="373634"/>
                  </a:lnTo>
                  <a:lnTo>
                    <a:pt x="474840" y="373634"/>
                  </a:lnTo>
                  <a:lnTo>
                    <a:pt x="474840" y="249047"/>
                  </a:lnTo>
                  <a:close/>
                </a:path>
                <a:path w="3842384" h="374015">
                  <a:moveTo>
                    <a:pt x="532892" y="342519"/>
                  </a:moveTo>
                  <a:lnTo>
                    <a:pt x="522478" y="342519"/>
                  </a:lnTo>
                  <a:lnTo>
                    <a:pt x="522478" y="373634"/>
                  </a:lnTo>
                  <a:lnTo>
                    <a:pt x="532892" y="373634"/>
                  </a:lnTo>
                  <a:lnTo>
                    <a:pt x="532892" y="342519"/>
                  </a:lnTo>
                  <a:close/>
                </a:path>
                <a:path w="3842384" h="374015">
                  <a:moveTo>
                    <a:pt x="591058" y="311404"/>
                  </a:moveTo>
                  <a:lnTo>
                    <a:pt x="580644" y="311404"/>
                  </a:lnTo>
                  <a:lnTo>
                    <a:pt x="580644" y="373634"/>
                  </a:lnTo>
                  <a:lnTo>
                    <a:pt x="591058" y="373634"/>
                  </a:lnTo>
                  <a:lnTo>
                    <a:pt x="591058" y="311404"/>
                  </a:lnTo>
                  <a:close/>
                </a:path>
                <a:path w="3842384" h="374015">
                  <a:moveTo>
                    <a:pt x="649097" y="124587"/>
                  </a:moveTo>
                  <a:lnTo>
                    <a:pt x="638683" y="124587"/>
                  </a:lnTo>
                  <a:lnTo>
                    <a:pt x="638683" y="373634"/>
                  </a:lnTo>
                  <a:lnTo>
                    <a:pt x="649097" y="373634"/>
                  </a:lnTo>
                  <a:lnTo>
                    <a:pt x="649097" y="124587"/>
                  </a:lnTo>
                  <a:close/>
                </a:path>
                <a:path w="3842384" h="374015">
                  <a:moveTo>
                    <a:pt x="707136" y="249047"/>
                  </a:moveTo>
                  <a:lnTo>
                    <a:pt x="696722" y="249047"/>
                  </a:lnTo>
                  <a:lnTo>
                    <a:pt x="696722" y="373634"/>
                  </a:lnTo>
                  <a:lnTo>
                    <a:pt x="707136" y="373634"/>
                  </a:lnTo>
                  <a:lnTo>
                    <a:pt x="707136" y="249047"/>
                  </a:lnTo>
                  <a:close/>
                </a:path>
                <a:path w="3842384" h="374015">
                  <a:moveTo>
                    <a:pt x="765175" y="249047"/>
                  </a:moveTo>
                  <a:lnTo>
                    <a:pt x="754761" y="249047"/>
                  </a:lnTo>
                  <a:lnTo>
                    <a:pt x="754761" y="373634"/>
                  </a:lnTo>
                  <a:lnTo>
                    <a:pt x="765175" y="373634"/>
                  </a:lnTo>
                  <a:lnTo>
                    <a:pt x="765175" y="249047"/>
                  </a:lnTo>
                  <a:close/>
                </a:path>
                <a:path w="3842384" h="374015">
                  <a:moveTo>
                    <a:pt x="823214" y="217932"/>
                  </a:moveTo>
                  <a:lnTo>
                    <a:pt x="812800" y="217932"/>
                  </a:lnTo>
                  <a:lnTo>
                    <a:pt x="812800" y="373634"/>
                  </a:lnTo>
                  <a:lnTo>
                    <a:pt x="823214" y="373634"/>
                  </a:lnTo>
                  <a:lnTo>
                    <a:pt x="823214" y="217932"/>
                  </a:lnTo>
                  <a:close/>
                </a:path>
                <a:path w="3842384" h="374015">
                  <a:moveTo>
                    <a:pt x="881240" y="217932"/>
                  </a:moveTo>
                  <a:lnTo>
                    <a:pt x="870839" y="217932"/>
                  </a:lnTo>
                  <a:lnTo>
                    <a:pt x="870839" y="373634"/>
                  </a:lnTo>
                  <a:lnTo>
                    <a:pt x="881240" y="373634"/>
                  </a:lnTo>
                  <a:lnTo>
                    <a:pt x="881240" y="217932"/>
                  </a:lnTo>
                  <a:close/>
                </a:path>
                <a:path w="3842384" h="374015">
                  <a:moveTo>
                    <a:pt x="939292" y="249047"/>
                  </a:moveTo>
                  <a:lnTo>
                    <a:pt x="928878" y="249047"/>
                  </a:lnTo>
                  <a:lnTo>
                    <a:pt x="928878" y="373634"/>
                  </a:lnTo>
                  <a:lnTo>
                    <a:pt x="939292" y="373634"/>
                  </a:lnTo>
                  <a:lnTo>
                    <a:pt x="939292" y="249047"/>
                  </a:lnTo>
                  <a:close/>
                </a:path>
                <a:path w="3842384" h="374015">
                  <a:moveTo>
                    <a:pt x="997331" y="217932"/>
                  </a:moveTo>
                  <a:lnTo>
                    <a:pt x="986917" y="217932"/>
                  </a:lnTo>
                  <a:lnTo>
                    <a:pt x="986917" y="373634"/>
                  </a:lnTo>
                  <a:lnTo>
                    <a:pt x="997331" y="373634"/>
                  </a:lnTo>
                  <a:lnTo>
                    <a:pt x="997331" y="217932"/>
                  </a:lnTo>
                  <a:close/>
                </a:path>
                <a:path w="3842384" h="374015">
                  <a:moveTo>
                    <a:pt x="1055370" y="0"/>
                  </a:moveTo>
                  <a:lnTo>
                    <a:pt x="1044956" y="0"/>
                  </a:lnTo>
                  <a:lnTo>
                    <a:pt x="1044956" y="373634"/>
                  </a:lnTo>
                  <a:lnTo>
                    <a:pt x="1055370" y="373634"/>
                  </a:lnTo>
                  <a:lnTo>
                    <a:pt x="1055370" y="0"/>
                  </a:lnTo>
                  <a:close/>
                </a:path>
                <a:path w="3842384" h="374015">
                  <a:moveTo>
                    <a:pt x="1113409" y="186817"/>
                  </a:moveTo>
                  <a:lnTo>
                    <a:pt x="1102995" y="186817"/>
                  </a:lnTo>
                  <a:lnTo>
                    <a:pt x="1102995" y="373634"/>
                  </a:lnTo>
                  <a:lnTo>
                    <a:pt x="1113409" y="373634"/>
                  </a:lnTo>
                  <a:lnTo>
                    <a:pt x="1113409" y="186817"/>
                  </a:lnTo>
                  <a:close/>
                </a:path>
                <a:path w="3842384" h="374015">
                  <a:moveTo>
                    <a:pt x="1171575" y="249047"/>
                  </a:moveTo>
                  <a:lnTo>
                    <a:pt x="1161161" y="249047"/>
                  </a:lnTo>
                  <a:lnTo>
                    <a:pt x="1161161" y="373634"/>
                  </a:lnTo>
                  <a:lnTo>
                    <a:pt x="1171575" y="373634"/>
                  </a:lnTo>
                  <a:lnTo>
                    <a:pt x="1171575" y="249047"/>
                  </a:lnTo>
                  <a:close/>
                </a:path>
                <a:path w="3842384" h="374015">
                  <a:moveTo>
                    <a:pt x="1229614" y="249047"/>
                  </a:moveTo>
                  <a:lnTo>
                    <a:pt x="1219200" y="249047"/>
                  </a:lnTo>
                  <a:lnTo>
                    <a:pt x="1219200" y="373634"/>
                  </a:lnTo>
                  <a:lnTo>
                    <a:pt x="1229614" y="373634"/>
                  </a:lnTo>
                  <a:lnTo>
                    <a:pt x="1229614" y="249047"/>
                  </a:lnTo>
                  <a:close/>
                </a:path>
                <a:path w="3842384" h="374015">
                  <a:moveTo>
                    <a:pt x="1287653" y="155702"/>
                  </a:moveTo>
                  <a:lnTo>
                    <a:pt x="1277239" y="155702"/>
                  </a:lnTo>
                  <a:lnTo>
                    <a:pt x="1277239" y="373634"/>
                  </a:lnTo>
                  <a:lnTo>
                    <a:pt x="1287653" y="373634"/>
                  </a:lnTo>
                  <a:lnTo>
                    <a:pt x="1287653" y="155702"/>
                  </a:lnTo>
                  <a:close/>
                </a:path>
                <a:path w="3842384" h="374015">
                  <a:moveTo>
                    <a:pt x="1345692" y="155702"/>
                  </a:moveTo>
                  <a:lnTo>
                    <a:pt x="1335278" y="155702"/>
                  </a:lnTo>
                  <a:lnTo>
                    <a:pt x="1335278" y="373634"/>
                  </a:lnTo>
                  <a:lnTo>
                    <a:pt x="1345692" y="373634"/>
                  </a:lnTo>
                  <a:lnTo>
                    <a:pt x="1345692" y="155702"/>
                  </a:lnTo>
                  <a:close/>
                </a:path>
                <a:path w="3842384" h="374015">
                  <a:moveTo>
                    <a:pt x="1403731" y="217932"/>
                  </a:moveTo>
                  <a:lnTo>
                    <a:pt x="1393317" y="217932"/>
                  </a:lnTo>
                  <a:lnTo>
                    <a:pt x="1393317" y="373634"/>
                  </a:lnTo>
                  <a:lnTo>
                    <a:pt x="1403731" y="373634"/>
                  </a:lnTo>
                  <a:lnTo>
                    <a:pt x="1403731" y="217932"/>
                  </a:lnTo>
                  <a:close/>
                </a:path>
                <a:path w="3842384" h="374015">
                  <a:moveTo>
                    <a:pt x="1461770" y="249047"/>
                  </a:moveTo>
                  <a:lnTo>
                    <a:pt x="1451356" y="249047"/>
                  </a:lnTo>
                  <a:lnTo>
                    <a:pt x="1451356" y="373634"/>
                  </a:lnTo>
                  <a:lnTo>
                    <a:pt x="1461770" y="373634"/>
                  </a:lnTo>
                  <a:lnTo>
                    <a:pt x="1461770" y="249047"/>
                  </a:lnTo>
                  <a:close/>
                </a:path>
                <a:path w="3842384" h="374015">
                  <a:moveTo>
                    <a:pt x="1519809" y="155702"/>
                  </a:moveTo>
                  <a:lnTo>
                    <a:pt x="1509395" y="155702"/>
                  </a:lnTo>
                  <a:lnTo>
                    <a:pt x="1509395" y="373634"/>
                  </a:lnTo>
                  <a:lnTo>
                    <a:pt x="1519809" y="373634"/>
                  </a:lnTo>
                  <a:lnTo>
                    <a:pt x="1519809" y="155702"/>
                  </a:lnTo>
                  <a:close/>
                </a:path>
                <a:path w="3842384" h="374015">
                  <a:moveTo>
                    <a:pt x="1577848" y="249047"/>
                  </a:moveTo>
                  <a:lnTo>
                    <a:pt x="1567434" y="249047"/>
                  </a:lnTo>
                  <a:lnTo>
                    <a:pt x="1567434" y="373634"/>
                  </a:lnTo>
                  <a:lnTo>
                    <a:pt x="1577848" y="373634"/>
                  </a:lnTo>
                  <a:lnTo>
                    <a:pt x="1577848" y="249047"/>
                  </a:lnTo>
                  <a:close/>
                </a:path>
                <a:path w="3842384" h="374015">
                  <a:moveTo>
                    <a:pt x="1635887" y="186817"/>
                  </a:moveTo>
                  <a:lnTo>
                    <a:pt x="1625473" y="186817"/>
                  </a:lnTo>
                  <a:lnTo>
                    <a:pt x="1625473" y="373634"/>
                  </a:lnTo>
                  <a:lnTo>
                    <a:pt x="1635887" y="373634"/>
                  </a:lnTo>
                  <a:lnTo>
                    <a:pt x="1635887" y="186817"/>
                  </a:lnTo>
                  <a:close/>
                </a:path>
                <a:path w="3842384" h="374015">
                  <a:moveTo>
                    <a:pt x="1694053" y="249047"/>
                  </a:moveTo>
                  <a:lnTo>
                    <a:pt x="1683639" y="249047"/>
                  </a:lnTo>
                  <a:lnTo>
                    <a:pt x="1683639" y="373634"/>
                  </a:lnTo>
                  <a:lnTo>
                    <a:pt x="1694053" y="373634"/>
                  </a:lnTo>
                  <a:lnTo>
                    <a:pt x="1694053" y="249047"/>
                  </a:lnTo>
                  <a:close/>
                </a:path>
                <a:path w="3842384" h="374015">
                  <a:moveTo>
                    <a:pt x="1752092" y="124587"/>
                  </a:moveTo>
                  <a:lnTo>
                    <a:pt x="1741678" y="124587"/>
                  </a:lnTo>
                  <a:lnTo>
                    <a:pt x="1741678" y="373634"/>
                  </a:lnTo>
                  <a:lnTo>
                    <a:pt x="1752092" y="373634"/>
                  </a:lnTo>
                  <a:lnTo>
                    <a:pt x="1752092" y="124587"/>
                  </a:lnTo>
                  <a:close/>
                </a:path>
                <a:path w="3842384" h="374015">
                  <a:moveTo>
                    <a:pt x="1810131" y="217932"/>
                  </a:moveTo>
                  <a:lnTo>
                    <a:pt x="1799717" y="217932"/>
                  </a:lnTo>
                  <a:lnTo>
                    <a:pt x="1799717" y="373634"/>
                  </a:lnTo>
                  <a:lnTo>
                    <a:pt x="1810131" y="373634"/>
                  </a:lnTo>
                  <a:lnTo>
                    <a:pt x="1810131" y="217932"/>
                  </a:lnTo>
                  <a:close/>
                </a:path>
                <a:path w="3842384" h="374015">
                  <a:moveTo>
                    <a:pt x="1868170" y="280289"/>
                  </a:moveTo>
                  <a:lnTo>
                    <a:pt x="1857756" y="280289"/>
                  </a:lnTo>
                  <a:lnTo>
                    <a:pt x="1857756" y="373634"/>
                  </a:lnTo>
                  <a:lnTo>
                    <a:pt x="1868170" y="373634"/>
                  </a:lnTo>
                  <a:lnTo>
                    <a:pt x="1868170" y="280289"/>
                  </a:lnTo>
                  <a:close/>
                </a:path>
                <a:path w="3842384" h="374015">
                  <a:moveTo>
                    <a:pt x="1926209" y="311404"/>
                  </a:moveTo>
                  <a:lnTo>
                    <a:pt x="1915795" y="311404"/>
                  </a:lnTo>
                  <a:lnTo>
                    <a:pt x="1915795" y="373634"/>
                  </a:lnTo>
                  <a:lnTo>
                    <a:pt x="1926209" y="373634"/>
                  </a:lnTo>
                  <a:lnTo>
                    <a:pt x="1926209" y="311404"/>
                  </a:lnTo>
                  <a:close/>
                </a:path>
                <a:path w="3842384" h="374015">
                  <a:moveTo>
                    <a:pt x="1984248" y="217932"/>
                  </a:moveTo>
                  <a:lnTo>
                    <a:pt x="1973834" y="217932"/>
                  </a:lnTo>
                  <a:lnTo>
                    <a:pt x="1973834" y="373634"/>
                  </a:lnTo>
                  <a:lnTo>
                    <a:pt x="1984248" y="373634"/>
                  </a:lnTo>
                  <a:lnTo>
                    <a:pt x="1984248" y="217932"/>
                  </a:lnTo>
                  <a:close/>
                </a:path>
                <a:path w="3842384" h="374015">
                  <a:moveTo>
                    <a:pt x="2042287" y="311404"/>
                  </a:moveTo>
                  <a:lnTo>
                    <a:pt x="2031873" y="311404"/>
                  </a:lnTo>
                  <a:lnTo>
                    <a:pt x="2031873" y="373634"/>
                  </a:lnTo>
                  <a:lnTo>
                    <a:pt x="2042287" y="373634"/>
                  </a:lnTo>
                  <a:lnTo>
                    <a:pt x="2042287" y="311404"/>
                  </a:lnTo>
                  <a:close/>
                </a:path>
                <a:path w="3842384" h="374015">
                  <a:moveTo>
                    <a:pt x="2100326" y="217932"/>
                  </a:moveTo>
                  <a:lnTo>
                    <a:pt x="2089912" y="217932"/>
                  </a:lnTo>
                  <a:lnTo>
                    <a:pt x="2089912" y="373634"/>
                  </a:lnTo>
                  <a:lnTo>
                    <a:pt x="2100326" y="373634"/>
                  </a:lnTo>
                  <a:lnTo>
                    <a:pt x="2100326" y="217932"/>
                  </a:lnTo>
                  <a:close/>
                </a:path>
                <a:path w="3842384" h="374015">
                  <a:moveTo>
                    <a:pt x="2158365" y="249047"/>
                  </a:moveTo>
                  <a:lnTo>
                    <a:pt x="2147951" y="249047"/>
                  </a:lnTo>
                  <a:lnTo>
                    <a:pt x="2147951" y="373634"/>
                  </a:lnTo>
                  <a:lnTo>
                    <a:pt x="2158365" y="373634"/>
                  </a:lnTo>
                  <a:lnTo>
                    <a:pt x="2158365" y="249047"/>
                  </a:lnTo>
                  <a:close/>
                </a:path>
                <a:path w="3842384" h="374015">
                  <a:moveTo>
                    <a:pt x="2216531" y="155702"/>
                  </a:moveTo>
                  <a:lnTo>
                    <a:pt x="2206117" y="155702"/>
                  </a:lnTo>
                  <a:lnTo>
                    <a:pt x="2206117" y="373634"/>
                  </a:lnTo>
                  <a:lnTo>
                    <a:pt x="2216531" y="373634"/>
                  </a:lnTo>
                  <a:lnTo>
                    <a:pt x="2216531" y="155702"/>
                  </a:lnTo>
                  <a:close/>
                </a:path>
                <a:path w="3842384" h="374015">
                  <a:moveTo>
                    <a:pt x="2274570" y="124587"/>
                  </a:moveTo>
                  <a:lnTo>
                    <a:pt x="2264156" y="124587"/>
                  </a:lnTo>
                  <a:lnTo>
                    <a:pt x="2264156" y="373634"/>
                  </a:lnTo>
                  <a:lnTo>
                    <a:pt x="2274570" y="373634"/>
                  </a:lnTo>
                  <a:lnTo>
                    <a:pt x="2274570" y="124587"/>
                  </a:lnTo>
                  <a:close/>
                </a:path>
                <a:path w="3842384" h="374015">
                  <a:moveTo>
                    <a:pt x="2332609" y="217932"/>
                  </a:moveTo>
                  <a:lnTo>
                    <a:pt x="2322195" y="217932"/>
                  </a:lnTo>
                  <a:lnTo>
                    <a:pt x="2322195" y="373634"/>
                  </a:lnTo>
                  <a:lnTo>
                    <a:pt x="2332609" y="373634"/>
                  </a:lnTo>
                  <a:lnTo>
                    <a:pt x="2332609" y="217932"/>
                  </a:lnTo>
                  <a:close/>
                </a:path>
                <a:path w="3842384" h="374015">
                  <a:moveTo>
                    <a:pt x="2390648" y="280289"/>
                  </a:moveTo>
                  <a:lnTo>
                    <a:pt x="2380234" y="280289"/>
                  </a:lnTo>
                  <a:lnTo>
                    <a:pt x="2380234" y="373634"/>
                  </a:lnTo>
                  <a:lnTo>
                    <a:pt x="2390648" y="373634"/>
                  </a:lnTo>
                  <a:lnTo>
                    <a:pt x="2390648" y="280289"/>
                  </a:lnTo>
                  <a:close/>
                </a:path>
                <a:path w="3842384" h="374015">
                  <a:moveTo>
                    <a:pt x="2448687" y="280289"/>
                  </a:moveTo>
                  <a:lnTo>
                    <a:pt x="2438273" y="280289"/>
                  </a:lnTo>
                  <a:lnTo>
                    <a:pt x="2438273" y="373634"/>
                  </a:lnTo>
                  <a:lnTo>
                    <a:pt x="2448687" y="373634"/>
                  </a:lnTo>
                  <a:lnTo>
                    <a:pt x="2448687" y="280289"/>
                  </a:lnTo>
                  <a:close/>
                </a:path>
                <a:path w="3842384" h="374015">
                  <a:moveTo>
                    <a:pt x="2506726" y="280289"/>
                  </a:moveTo>
                  <a:lnTo>
                    <a:pt x="2496312" y="280289"/>
                  </a:lnTo>
                  <a:lnTo>
                    <a:pt x="2496312" y="373634"/>
                  </a:lnTo>
                  <a:lnTo>
                    <a:pt x="2506726" y="373634"/>
                  </a:lnTo>
                  <a:lnTo>
                    <a:pt x="2506726" y="280289"/>
                  </a:lnTo>
                  <a:close/>
                </a:path>
                <a:path w="3842384" h="374015">
                  <a:moveTo>
                    <a:pt x="2564765" y="217932"/>
                  </a:moveTo>
                  <a:lnTo>
                    <a:pt x="2554351" y="217932"/>
                  </a:lnTo>
                  <a:lnTo>
                    <a:pt x="2554351" y="373634"/>
                  </a:lnTo>
                  <a:lnTo>
                    <a:pt x="2564765" y="373634"/>
                  </a:lnTo>
                  <a:lnTo>
                    <a:pt x="2564765" y="217932"/>
                  </a:lnTo>
                  <a:close/>
                </a:path>
                <a:path w="3842384" h="374015">
                  <a:moveTo>
                    <a:pt x="2622804" y="217932"/>
                  </a:moveTo>
                  <a:lnTo>
                    <a:pt x="2612390" y="217932"/>
                  </a:lnTo>
                  <a:lnTo>
                    <a:pt x="2612390" y="373634"/>
                  </a:lnTo>
                  <a:lnTo>
                    <a:pt x="2622804" y="373634"/>
                  </a:lnTo>
                  <a:lnTo>
                    <a:pt x="2622804" y="217932"/>
                  </a:lnTo>
                  <a:close/>
                </a:path>
                <a:path w="3842384" h="374015">
                  <a:moveTo>
                    <a:pt x="2738882" y="249047"/>
                  </a:moveTo>
                  <a:lnTo>
                    <a:pt x="2728468" y="249047"/>
                  </a:lnTo>
                  <a:lnTo>
                    <a:pt x="2728468" y="373634"/>
                  </a:lnTo>
                  <a:lnTo>
                    <a:pt x="2738882" y="373634"/>
                  </a:lnTo>
                  <a:lnTo>
                    <a:pt x="2738882" y="249047"/>
                  </a:lnTo>
                  <a:close/>
                </a:path>
                <a:path w="3842384" h="374015">
                  <a:moveTo>
                    <a:pt x="2797048" y="249047"/>
                  </a:moveTo>
                  <a:lnTo>
                    <a:pt x="2786634" y="249047"/>
                  </a:lnTo>
                  <a:lnTo>
                    <a:pt x="2786634" y="373634"/>
                  </a:lnTo>
                  <a:lnTo>
                    <a:pt x="2797048" y="373634"/>
                  </a:lnTo>
                  <a:lnTo>
                    <a:pt x="2797048" y="249047"/>
                  </a:lnTo>
                  <a:close/>
                </a:path>
                <a:path w="3842384" h="374015">
                  <a:moveTo>
                    <a:pt x="2855087" y="124587"/>
                  </a:moveTo>
                  <a:lnTo>
                    <a:pt x="2844673" y="124587"/>
                  </a:lnTo>
                  <a:lnTo>
                    <a:pt x="2844673" y="373634"/>
                  </a:lnTo>
                  <a:lnTo>
                    <a:pt x="2855087" y="373634"/>
                  </a:lnTo>
                  <a:lnTo>
                    <a:pt x="2855087" y="124587"/>
                  </a:lnTo>
                  <a:close/>
                </a:path>
                <a:path w="3842384" h="374015">
                  <a:moveTo>
                    <a:pt x="2913126" y="186817"/>
                  </a:moveTo>
                  <a:lnTo>
                    <a:pt x="2902712" y="186817"/>
                  </a:lnTo>
                  <a:lnTo>
                    <a:pt x="2902712" y="373634"/>
                  </a:lnTo>
                  <a:lnTo>
                    <a:pt x="2913126" y="373634"/>
                  </a:lnTo>
                  <a:lnTo>
                    <a:pt x="2913126" y="186817"/>
                  </a:lnTo>
                  <a:close/>
                </a:path>
                <a:path w="3842384" h="374015">
                  <a:moveTo>
                    <a:pt x="2971165" y="342519"/>
                  </a:moveTo>
                  <a:lnTo>
                    <a:pt x="2960751" y="342519"/>
                  </a:lnTo>
                  <a:lnTo>
                    <a:pt x="2960751" y="373634"/>
                  </a:lnTo>
                  <a:lnTo>
                    <a:pt x="2971165" y="373634"/>
                  </a:lnTo>
                  <a:lnTo>
                    <a:pt x="2971165" y="342519"/>
                  </a:lnTo>
                  <a:close/>
                </a:path>
                <a:path w="3842384" h="374015">
                  <a:moveTo>
                    <a:pt x="3029204" y="342519"/>
                  </a:moveTo>
                  <a:lnTo>
                    <a:pt x="3018790" y="342519"/>
                  </a:lnTo>
                  <a:lnTo>
                    <a:pt x="3018790" y="373634"/>
                  </a:lnTo>
                  <a:lnTo>
                    <a:pt x="3029204" y="373634"/>
                  </a:lnTo>
                  <a:lnTo>
                    <a:pt x="3029204" y="342519"/>
                  </a:lnTo>
                  <a:close/>
                </a:path>
                <a:path w="3842384" h="374015">
                  <a:moveTo>
                    <a:pt x="3087243" y="311404"/>
                  </a:moveTo>
                  <a:lnTo>
                    <a:pt x="3076829" y="311404"/>
                  </a:lnTo>
                  <a:lnTo>
                    <a:pt x="3076829" y="373634"/>
                  </a:lnTo>
                  <a:lnTo>
                    <a:pt x="3087243" y="373634"/>
                  </a:lnTo>
                  <a:lnTo>
                    <a:pt x="3087243" y="311404"/>
                  </a:lnTo>
                  <a:close/>
                </a:path>
                <a:path w="3842384" h="374015">
                  <a:moveTo>
                    <a:pt x="3145282" y="342519"/>
                  </a:moveTo>
                  <a:lnTo>
                    <a:pt x="3134868" y="342519"/>
                  </a:lnTo>
                  <a:lnTo>
                    <a:pt x="3134868" y="373634"/>
                  </a:lnTo>
                  <a:lnTo>
                    <a:pt x="3145282" y="373634"/>
                  </a:lnTo>
                  <a:lnTo>
                    <a:pt x="3145282" y="342519"/>
                  </a:lnTo>
                  <a:close/>
                </a:path>
                <a:path w="3842384" h="374015">
                  <a:moveTo>
                    <a:pt x="3203321" y="62230"/>
                  </a:moveTo>
                  <a:lnTo>
                    <a:pt x="3192907" y="62230"/>
                  </a:lnTo>
                  <a:lnTo>
                    <a:pt x="3192907" y="373634"/>
                  </a:lnTo>
                  <a:lnTo>
                    <a:pt x="3203321" y="373634"/>
                  </a:lnTo>
                  <a:lnTo>
                    <a:pt x="3203321" y="62230"/>
                  </a:lnTo>
                  <a:close/>
                </a:path>
                <a:path w="3842384" h="374015">
                  <a:moveTo>
                    <a:pt x="3261360" y="249047"/>
                  </a:moveTo>
                  <a:lnTo>
                    <a:pt x="3250946" y="249047"/>
                  </a:lnTo>
                  <a:lnTo>
                    <a:pt x="3250946" y="373634"/>
                  </a:lnTo>
                  <a:lnTo>
                    <a:pt x="3261360" y="373634"/>
                  </a:lnTo>
                  <a:lnTo>
                    <a:pt x="3261360" y="249047"/>
                  </a:lnTo>
                  <a:close/>
                </a:path>
                <a:path w="3842384" h="374015">
                  <a:moveTo>
                    <a:pt x="3319526" y="186817"/>
                  </a:moveTo>
                  <a:lnTo>
                    <a:pt x="3309112" y="186817"/>
                  </a:lnTo>
                  <a:lnTo>
                    <a:pt x="3309112" y="373634"/>
                  </a:lnTo>
                  <a:lnTo>
                    <a:pt x="3319526" y="373634"/>
                  </a:lnTo>
                  <a:lnTo>
                    <a:pt x="3319526" y="186817"/>
                  </a:lnTo>
                  <a:close/>
                </a:path>
                <a:path w="3842384" h="374015">
                  <a:moveTo>
                    <a:pt x="3377565" y="186817"/>
                  </a:moveTo>
                  <a:lnTo>
                    <a:pt x="3367151" y="186817"/>
                  </a:lnTo>
                  <a:lnTo>
                    <a:pt x="3367151" y="373634"/>
                  </a:lnTo>
                  <a:lnTo>
                    <a:pt x="3377565" y="373634"/>
                  </a:lnTo>
                  <a:lnTo>
                    <a:pt x="3377565" y="186817"/>
                  </a:lnTo>
                  <a:close/>
                </a:path>
                <a:path w="3842384" h="374015">
                  <a:moveTo>
                    <a:pt x="3435604" y="280289"/>
                  </a:moveTo>
                  <a:lnTo>
                    <a:pt x="3425190" y="280289"/>
                  </a:lnTo>
                  <a:lnTo>
                    <a:pt x="3425190" y="373634"/>
                  </a:lnTo>
                  <a:lnTo>
                    <a:pt x="3435604" y="373634"/>
                  </a:lnTo>
                  <a:lnTo>
                    <a:pt x="3435604" y="280289"/>
                  </a:lnTo>
                  <a:close/>
                </a:path>
                <a:path w="3842384" h="374015">
                  <a:moveTo>
                    <a:pt x="3493643" y="217932"/>
                  </a:moveTo>
                  <a:lnTo>
                    <a:pt x="3483229" y="217932"/>
                  </a:lnTo>
                  <a:lnTo>
                    <a:pt x="3483229" y="373634"/>
                  </a:lnTo>
                  <a:lnTo>
                    <a:pt x="3493643" y="373634"/>
                  </a:lnTo>
                  <a:lnTo>
                    <a:pt x="3493643" y="217932"/>
                  </a:lnTo>
                  <a:close/>
                </a:path>
                <a:path w="3842384" h="374015">
                  <a:moveTo>
                    <a:pt x="3551682" y="124587"/>
                  </a:moveTo>
                  <a:lnTo>
                    <a:pt x="3541268" y="124587"/>
                  </a:lnTo>
                  <a:lnTo>
                    <a:pt x="3541268" y="373634"/>
                  </a:lnTo>
                  <a:lnTo>
                    <a:pt x="3551682" y="373634"/>
                  </a:lnTo>
                  <a:lnTo>
                    <a:pt x="3551682" y="124587"/>
                  </a:lnTo>
                  <a:close/>
                </a:path>
                <a:path w="3842384" h="374015">
                  <a:moveTo>
                    <a:pt x="3609721" y="342519"/>
                  </a:moveTo>
                  <a:lnTo>
                    <a:pt x="3599307" y="342519"/>
                  </a:lnTo>
                  <a:lnTo>
                    <a:pt x="3599307" y="373634"/>
                  </a:lnTo>
                  <a:lnTo>
                    <a:pt x="3609721" y="373634"/>
                  </a:lnTo>
                  <a:lnTo>
                    <a:pt x="3609721" y="342519"/>
                  </a:lnTo>
                  <a:close/>
                </a:path>
                <a:path w="3842384" h="374015">
                  <a:moveTo>
                    <a:pt x="3667760" y="311404"/>
                  </a:moveTo>
                  <a:lnTo>
                    <a:pt x="3657346" y="311404"/>
                  </a:lnTo>
                  <a:lnTo>
                    <a:pt x="3657346" y="373634"/>
                  </a:lnTo>
                  <a:lnTo>
                    <a:pt x="3667760" y="373634"/>
                  </a:lnTo>
                  <a:lnTo>
                    <a:pt x="3667760" y="311404"/>
                  </a:lnTo>
                  <a:close/>
                </a:path>
                <a:path w="3842384" h="374015">
                  <a:moveTo>
                    <a:pt x="3725799" y="342519"/>
                  </a:moveTo>
                  <a:lnTo>
                    <a:pt x="3715385" y="342519"/>
                  </a:lnTo>
                  <a:lnTo>
                    <a:pt x="3715385" y="373634"/>
                  </a:lnTo>
                  <a:lnTo>
                    <a:pt x="3725799" y="373634"/>
                  </a:lnTo>
                  <a:lnTo>
                    <a:pt x="3725799" y="342519"/>
                  </a:lnTo>
                  <a:close/>
                </a:path>
                <a:path w="3842384" h="374015">
                  <a:moveTo>
                    <a:pt x="3783838" y="186817"/>
                  </a:moveTo>
                  <a:lnTo>
                    <a:pt x="3773424" y="186817"/>
                  </a:lnTo>
                  <a:lnTo>
                    <a:pt x="3773424" y="373634"/>
                  </a:lnTo>
                  <a:lnTo>
                    <a:pt x="3783838" y="373634"/>
                  </a:lnTo>
                  <a:lnTo>
                    <a:pt x="3783838" y="186817"/>
                  </a:lnTo>
                  <a:close/>
                </a:path>
                <a:path w="3842384" h="374015">
                  <a:moveTo>
                    <a:pt x="3841877" y="311404"/>
                  </a:moveTo>
                  <a:lnTo>
                    <a:pt x="3831463" y="311404"/>
                  </a:lnTo>
                  <a:lnTo>
                    <a:pt x="3831463" y="373634"/>
                  </a:lnTo>
                  <a:lnTo>
                    <a:pt x="3841877" y="373634"/>
                  </a:lnTo>
                  <a:lnTo>
                    <a:pt x="3841877" y="311404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8" name="object 118" descr=""/>
            <p:cNvSpPr/>
            <p:nvPr/>
          </p:nvSpPr>
          <p:spPr>
            <a:xfrm>
              <a:off x="9283445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5" h="0">
                  <a:moveTo>
                    <a:pt x="0" y="0"/>
                  </a:moveTo>
                  <a:lnTo>
                    <a:pt x="10414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9" name="object 119" descr=""/>
            <p:cNvSpPr/>
            <p:nvPr/>
          </p:nvSpPr>
          <p:spPr>
            <a:xfrm>
              <a:off x="9341485" y="8475599"/>
              <a:ext cx="1171575" cy="187325"/>
            </a:xfrm>
            <a:custGeom>
              <a:avLst/>
              <a:gdLst/>
              <a:ahLst/>
              <a:cxnLst/>
              <a:rect l="l" t="t" r="r" b="b"/>
              <a:pathLst>
                <a:path w="1171575" h="187325">
                  <a:moveTo>
                    <a:pt x="10414" y="93472"/>
                  </a:moveTo>
                  <a:lnTo>
                    <a:pt x="0" y="93472"/>
                  </a:lnTo>
                  <a:lnTo>
                    <a:pt x="0" y="186817"/>
                  </a:lnTo>
                  <a:lnTo>
                    <a:pt x="10414" y="186817"/>
                  </a:lnTo>
                  <a:lnTo>
                    <a:pt x="10414" y="93472"/>
                  </a:lnTo>
                  <a:close/>
                </a:path>
                <a:path w="1171575" h="187325">
                  <a:moveTo>
                    <a:pt x="68453" y="124587"/>
                  </a:moveTo>
                  <a:lnTo>
                    <a:pt x="58039" y="124587"/>
                  </a:lnTo>
                  <a:lnTo>
                    <a:pt x="58039" y="186817"/>
                  </a:lnTo>
                  <a:lnTo>
                    <a:pt x="68453" y="186817"/>
                  </a:lnTo>
                  <a:lnTo>
                    <a:pt x="68453" y="124587"/>
                  </a:lnTo>
                  <a:close/>
                </a:path>
                <a:path w="1171575" h="187325">
                  <a:moveTo>
                    <a:pt x="126492" y="124587"/>
                  </a:moveTo>
                  <a:lnTo>
                    <a:pt x="116078" y="124587"/>
                  </a:lnTo>
                  <a:lnTo>
                    <a:pt x="116078" y="186817"/>
                  </a:lnTo>
                  <a:lnTo>
                    <a:pt x="126492" y="186817"/>
                  </a:lnTo>
                  <a:lnTo>
                    <a:pt x="126492" y="124587"/>
                  </a:lnTo>
                  <a:close/>
                </a:path>
                <a:path w="1171575" h="187325">
                  <a:moveTo>
                    <a:pt x="184531" y="62230"/>
                  </a:moveTo>
                  <a:lnTo>
                    <a:pt x="174117" y="62230"/>
                  </a:lnTo>
                  <a:lnTo>
                    <a:pt x="174117" y="186817"/>
                  </a:lnTo>
                  <a:lnTo>
                    <a:pt x="184531" y="186817"/>
                  </a:lnTo>
                  <a:lnTo>
                    <a:pt x="184531" y="62230"/>
                  </a:lnTo>
                  <a:close/>
                </a:path>
                <a:path w="1171575" h="187325">
                  <a:moveTo>
                    <a:pt x="242570" y="93472"/>
                  </a:moveTo>
                  <a:lnTo>
                    <a:pt x="232156" y="93472"/>
                  </a:lnTo>
                  <a:lnTo>
                    <a:pt x="232156" y="186817"/>
                  </a:lnTo>
                  <a:lnTo>
                    <a:pt x="242570" y="186817"/>
                  </a:lnTo>
                  <a:lnTo>
                    <a:pt x="242570" y="93472"/>
                  </a:lnTo>
                  <a:close/>
                </a:path>
                <a:path w="1171575" h="187325">
                  <a:moveTo>
                    <a:pt x="300609" y="93472"/>
                  </a:moveTo>
                  <a:lnTo>
                    <a:pt x="290195" y="93472"/>
                  </a:lnTo>
                  <a:lnTo>
                    <a:pt x="290195" y="186817"/>
                  </a:lnTo>
                  <a:lnTo>
                    <a:pt x="300609" y="186817"/>
                  </a:lnTo>
                  <a:lnTo>
                    <a:pt x="300609" y="93472"/>
                  </a:lnTo>
                  <a:close/>
                </a:path>
                <a:path w="1171575" h="187325">
                  <a:moveTo>
                    <a:pt x="358648" y="0"/>
                  </a:moveTo>
                  <a:lnTo>
                    <a:pt x="348234" y="0"/>
                  </a:lnTo>
                  <a:lnTo>
                    <a:pt x="348234" y="186817"/>
                  </a:lnTo>
                  <a:lnTo>
                    <a:pt x="358648" y="186817"/>
                  </a:lnTo>
                  <a:lnTo>
                    <a:pt x="358648" y="0"/>
                  </a:lnTo>
                  <a:close/>
                </a:path>
                <a:path w="1171575" h="187325">
                  <a:moveTo>
                    <a:pt x="416687" y="31115"/>
                  </a:moveTo>
                  <a:lnTo>
                    <a:pt x="406273" y="31115"/>
                  </a:lnTo>
                  <a:lnTo>
                    <a:pt x="406273" y="186817"/>
                  </a:lnTo>
                  <a:lnTo>
                    <a:pt x="416687" y="186817"/>
                  </a:lnTo>
                  <a:lnTo>
                    <a:pt x="416687" y="31115"/>
                  </a:lnTo>
                  <a:close/>
                </a:path>
                <a:path w="1171575" h="187325">
                  <a:moveTo>
                    <a:pt x="474853" y="62230"/>
                  </a:moveTo>
                  <a:lnTo>
                    <a:pt x="464439" y="62230"/>
                  </a:lnTo>
                  <a:lnTo>
                    <a:pt x="464439" y="186817"/>
                  </a:lnTo>
                  <a:lnTo>
                    <a:pt x="474853" y="186817"/>
                  </a:lnTo>
                  <a:lnTo>
                    <a:pt x="474853" y="62230"/>
                  </a:lnTo>
                  <a:close/>
                </a:path>
                <a:path w="1171575" h="187325">
                  <a:moveTo>
                    <a:pt x="532892" y="124587"/>
                  </a:moveTo>
                  <a:lnTo>
                    <a:pt x="522478" y="124587"/>
                  </a:lnTo>
                  <a:lnTo>
                    <a:pt x="522478" y="186817"/>
                  </a:lnTo>
                  <a:lnTo>
                    <a:pt x="532892" y="186817"/>
                  </a:lnTo>
                  <a:lnTo>
                    <a:pt x="532892" y="124587"/>
                  </a:lnTo>
                  <a:close/>
                </a:path>
                <a:path w="1171575" h="187325">
                  <a:moveTo>
                    <a:pt x="590931" y="62230"/>
                  </a:moveTo>
                  <a:lnTo>
                    <a:pt x="580517" y="62230"/>
                  </a:lnTo>
                  <a:lnTo>
                    <a:pt x="580517" y="186817"/>
                  </a:lnTo>
                  <a:lnTo>
                    <a:pt x="590931" y="186817"/>
                  </a:lnTo>
                  <a:lnTo>
                    <a:pt x="590931" y="62230"/>
                  </a:lnTo>
                  <a:close/>
                </a:path>
                <a:path w="1171575" h="187325">
                  <a:moveTo>
                    <a:pt x="648970" y="124587"/>
                  </a:moveTo>
                  <a:lnTo>
                    <a:pt x="638556" y="124587"/>
                  </a:lnTo>
                  <a:lnTo>
                    <a:pt x="638556" y="186817"/>
                  </a:lnTo>
                  <a:lnTo>
                    <a:pt x="648970" y="186817"/>
                  </a:lnTo>
                  <a:lnTo>
                    <a:pt x="648970" y="124587"/>
                  </a:lnTo>
                  <a:close/>
                </a:path>
                <a:path w="1171575" h="187325">
                  <a:moveTo>
                    <a:pt x="707009" y="124587"/>
                  </a:moveTo>
                  <a:lnTo>
                    <a:pt x="696595" y="124587"/>
                  </a:lnTo>
                  <a:lnTo>
                    <a:pt x="696595" y="186817"/>
                  </a:lnTo>
                  <a:lnTo>
                    <a:pt x="707009" y="186817"/>
                  </a:lnTo>
                  <a:lnTo>
                    <a:pt x="707009" y="124587"/>
                  </a:lnTo>
                  <a:close/>
                </a:path>
                <a:path w="1171575" h="187325">
                  <a:moveTo>
                    <a:pt x="775589" y="93472"/>
                  </a:moveTo>
                  <a:lnTo>
                    <a:pt x="762508" y="93472"/>
                  </a:lnTo>
                  <a:lnTo>
                    <a:pt x="762508" y="186817"/>
                  </a:lnTo>
                  <a:lnTo>
                    <a:pt x="775589" y="186817"/>
                  </a:lnTo>
                  <a:lnTo>
                    <a:pt x="775589" y="93472"/>
                  </a:lnTo>
                  <a:close/>
                </a:path>
                <a:path w="1171575" h="187325">
                  <a:moveTo>
                    <a:pt x="823087" y="155702"/>
                  </a:moveTo>
                  <a:lnTo>
                    <a:pt x="812673" y="155702"/>
                  </a:lnTo>
                  <a:lnTo>
                    <a:pt x="812673" y="186817"/>
                  </a:lnTo>
                  <a:lnTo>
                    <a:pt x="823087" y="186817"/>
                  </a:lnTo>
                  <a:lnTo>
                    <a:pt x="823087" y="155702"/>
                  </a:lnTo>
                  <a:close/>
                </a:path>
                <a:path w="1171575" h="187325">
                  <a:moveTo>
                    <a:pt x="881126" y="31115"/>
                  </a:moveTo>
                  <a:lnTo>
                    <a:pt x="870712" y="31115"/>
                  </a:lnTo>
                  <a:lnTo>
                    <a:pt x="870712" y="186817"/>
                  </a:lnTo>
                  <a:lnTo>
                    <a:pt x="881126" y="186817"/>
                  </a:lnTo>
                  <a:lnTo>
                    <a:pt x="881126" y="31115"/>
                  </a:lnTo>
                  <a:close/>
                </a:path>
                <a:path w="1171575" h="187325">
                  <a:moveTo>
                    <a:pt x="939165" y="62230"/>
                  </a:moveTo>
                  <a:lnTo>
                    <a:pt x="928751" y="62230"/>
                  </a:lnTo>
                  <a:lnTo>
                    <a:pt x="928751" y="186817"/>
                  </a:lnTo>
                  <a:lnTo>
                    <a:pt x="939165" y="186817"/>
                  </a:lnTo>
                  <a:lnTo>
                    <a:pt x="939165" y="62230"/>
                  </a:lnTo>
                  <a:close/>
                </a:path>
                <a:path w="1171575" h="187325">
                  <a:moveTo>
                    <a:pt x="997331" y="0"/>
                  </a:moveTo>
                  <a:lnTo>
                    <a:pt x="986917" y="0"/>
                  </a:lnTo>
                  <a:lnTo>
                    <a:pt x="986917" y="186817"/>
                  </a:lnTo>
                  <a:lnTo>
                    <a:pt x="997331" y="186817"/>
                  </a:lnTo>
                  <a:lnTo>
                    <a:pt x="997331" y="0"/>
                  </a:lnTo>
                  <a:close/>
                </a:path>
                <a:path w="1171575" h="187325">
                  <a:moveTo>
                    <a:pt x="1055370" y="155702"/>
                  </a:moveTo>
                  <a:lnTo>
                    <a:pt x="1044956" y="155702"/>
                  </a:lnTo>
                  <a:lnTo>
                    <a:pt x="1044956" y="186817"/>
                  </a:lnTo>
                  <a:lnTo>
                    <a:pt x="1055370" y="186817"/>
                  </a:lnTo>
                  <a:lnTo>
                    <a:pt x="1055370" y="155702"/>
                  </a:lnTo>
                  <a:close/>
                </a:path>
                <a:path w="1171575" h="187325">
                  <a:moveTo>
                    <a:pt x="1113409" y="155702"/>
                  </a:moveTo>
                  <a:lnTo>
                    <a:pt x="1102995" y="155702"/>
                  </a:lnTo>
                  <a:lnTo>
                    <a:pt x="1102995" y="186817"/>
                  </a:lnTo>
                  <a:lnTo>
                    <a:pt x="1113409" y="186817"/>
                  </a:lnTo>
                  <a:lnTo>
                    <a:pt x="1113409" y="155702"/>
                  </a:lnTo>
                  <a:close/>
                </a:path>
                <a:path w="1171575" h="187325">
                  <a:moveTo>
                    <a:pt x="1171448" y="31115"/>
                  </a:moveTo>
                  <a:lnTo>
                    <a:pt x="1161034" y="31115"/>
                  </a:lnTo>
                  <a:lnTo>
                    <a:pt x="1161034" y="186817"/>
                  </a:lnTo>
                  <a:lnTo>
                    <a:pt x="1171448" y="186817"/>
                  </a:lnTo>
                  <a:lnTo>
                    <a:pt x="1171448" y="31115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0" name="object 120" descr=""/>
            <p:cNvSpPr/>
            <p:nvPr/>
          </p:nvSpPr>
          <p:spPr>
            <a:xfrm>
              <a:off x="10618597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5" h="0">
                  <a:moveTo>
                    <a:pt x="0" y="0"/>
                  </a:moveTo>
                  <a:lnTo>
                    <a:pt x="10414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1" name="object 121" descr=""/>
            <p:cNvSpPr/>
            <p:nvPr/>
          </p:nvSpPr>
          <p:spPr>
            <a:xfrm>
              <a:off x="10676636" y="8475599"/>
              <a:ext cx="2390775" cy="187325"/>
            </a:xfrm>
            <a:custGeom>
              <a:avLst/>
              <a:gdLst/>
              <a:ahLst/>
              <a:cxnLst/>
              <a:rect l="l" t="t" r="r" b="b"/>
              <a:pathLst>
                <a:path w="2390775" h="187325">
                  <a:moveTo>
                    <a:pt x="10414" y="124587"/>
                  </a:moveTo>
                  <a:lnTo>
                    <a:pt x="0" y="124587"/>
                  </a:lnTo>
                  <a:lnTo>
                    <a:pt x="0" y="186817"/>
                  </a:lnTo>
                  <a:lnTo>
                    <a:pt x="10414" y="186817"/>
                  </a:lnTo>
                  <a:lnTo>
                    <a:pt x="10414" y="124587"/>
                  </a:lnTo>
                  <a:close/>
                </a:path>
                <a:path w="2390775" h="187325">
                  <a:moveTo>
                    <a:pt x="68453" y="93472"/>
                  </a:moveTo>
                  <a:lnTo>
                    <a:pt x="58039" y="93472"/>
                  </a:lnTo>
                  <a:lnTo>
                    <a:pt x="58039" y="186817"/>
                  </a:lnTo>
                  <a:lnTo>
                    <a:pt x="68453" y="186817"/>
                  </a:lnTo>
                  <a:lnTo>
                    <a:pt x="68453" y="93472"/>
                  </a:lnTo>
                  <a:close/>
                </a:path>
                <a:path w="2390775" h="187325">
                  <a:moveTo>
                    <a:pt x="126492" y="62230"/>
                  </a:moveTo>
                  <a:lnTo>
                    <a:pt x="116078" y="62230"/>
                  </a:lnTo>
                  <a:lnTo>
                    <a:pt x="116078" y="186817"/>
                  </a:lnTo>
                  <a:lnTo>
                    <a:pt x="126492" y="186817"/>
                  </a:lnTo>
                  <a:lnTo>
                    <a:pt x="126492" y="62230"/>
                  </a:lnTo>
                  <a:close/>
                </a:path>
                <a:path w="2390775" h="187325">
                  <a:moveTo>
                    <a:pt x="184531" y="155702"/>
                  </a:moveTo>
                  <a:lnTo>
                    <a:pt x="174117" y="155702"/>
                  </a:lnTo>
                  <a:lnTo>
                    <a:pt x="174117" y="186817"/>
                  </a:lnTo>
                  <a:lnTo>
                    <a:pt x="184531" y="186817"/>
                  </a:lnTo>
                  <a:lnTo>
                    <a:pt x="184531" y="155702"/>
                  </a:lnTo>
                  <a:close/>
                </a:path>
                <a:path w="2390775" h="187325">
                  <a:moveTo>
                    <a:pt x="242697" y="155702"/>
                  </a:moveTo>
                  <a:lnTo>
                    <a:pt x="232283" y="155702"/>
                  </a:lnTo>
                  <a:lnTo>
                    <a:pt x="232283" y="186817"/>
                  </a:lnTo>
                  <a:lnTo>
                    <a:pt x="242697" y="186817"/>
                  </a:lnTo>
                  <a:lnTo>
                    <a:pt x="242697" y="155702"/>
                  </a:lnTo>
                  <a:close/>
                </a:path>
                <a:path w="2390775" h="187325">
                  <a:moveTo>
                    <a:pt x="300736" y="124587"/>
                  </a:moveTo>
                  <a:lnTo>
                    <a:pt x="290322" y="124587"/>
                  </a:lnTo>
                  <a:lnTo>
                    <a:pt x="290322" y="186817"/>
                  </a:lnTo>
                  <a:lnTo>
                    <a:pt x="300736" y="186817"/>
                  </a:lnTo>
                  <a:lnTo>
                    <a:pt x="300736" y="124587"/>
                  </a:lnTo>
                  <a:close/>
                </a:path>
                <a:path w="2390775" h="187325">
                  <a:moveTo>
                    <a:pt x="358775" y="93472"/>
                  </a:moveTo>
                  <a:lnTo>
                    <a:pt x="348361" y="93472"/>
                  </a:lnTo>
                  <a:lnTo>
                    <a:pt x="348361" y="186817"/>
                  </a:lnTo>
                  <a:lnTo>
                    <a:pt x="358775" y="186817"/>
                  </a:lnTo>
                  <a:lnTo>
                    <a:pt x="358775" y="93472"/>
                  </a:lnTo>
                  <a:close/>
                </a:path>
                <a:path w="2390775" h="187325">
                  <a:moveTo>
                    <a:pt x="416814" y="93472"/>
                  </a:moveTo>
                  <a:lnTo>
                    <a:pt x="406400" y="93472"/>
                  </a:lnTo>
                  <a:lnTo>
                    <a:pt x="406400" y="186817"/>
                  </a:lnTo>
                  <a:lnTo>
                    <a:pt x="416814" y="186817"/>
                  </a:lnTo>
                  <a:lnTo>
                    <a:pt x="416814" y="93472"/>
                  </a:lnTo>
                  <a:close/>
                </a:path>
                <a:path w="2390775" h="187325">
                  <a:moveTo>
                    <a:pt x="532892" y="62230"/>
                  </a:moveTo>
                  <a:lnTo>
                    <a:pt x="522478" y="62230"/>
                  </a:lnTo>
                  <a:lnTo>
                    <a:pt x="522478" y="186817"/>
                  </a:lnTo>
                  <a:lnTo>
                    <a:pt x="532892" y="186817"/>
                  </a:lnTo>
                  <a:lnTo>
                    <a:pt x="532892" y="62230"/>
                  </a:lnTo>
                  <a:close/>
                </a:path>
                <a:path w="2390775" h="187325">
                  <a:moveTo>
                    <a:pt x="590931" y="62230"/>
                  </a:moveTo>
                  <a:lnTo>
                    <a:pt x="580517" y="62230"/>
                  </a:lnTo>
                  <a:lnTo>
                    <a:pt x="580517" y="186817"/>
                  </a:lnTo>
                  <a:lnTo>
                    <a:pt x="590931" y="186817"/>
                  </a:lnTo>
                  <a:lnTo>
                    <a:pt x="590931" y="62230"/>
                  </a:lnTo>
                  <a:close/>
                </a:path>
                <a:path w="2390775" h="187325">
                  <a:moveTo>
                    <a:pt x="648970" y="62230"/>
                  </a:moveTo>
                  <a:lnTo>
                    <a:pt x="638556" y="62230"/>
                  </a:lnTo>
                  <a:lnTo>
                    <a:pt x="638556" y="186817"/>
                  </a:lnTo>
                  <a:lnTo>
                    <a:pt x="648970" y="186817"/>
                  </a:lnTo>
                  <a:lnTo>
                    <a:pt x="648970" y="62230"/>
                  </a:lnTo>
                  <a:close/>
                </a:path>
                <a:path w="2390775" h="187325">
                  <a:moveTo>
                    <a:pt x="707009" y="62230"/>
                  </a:moveTo>
                  <a:lnTo>
                    <a:pt x="696595" y="62230"/>
                  </a:lnTo>
                  <a:lnTo>
                    <a:pt x="696595" y="186817"/>
                  </a:lnTo>
                  <a:lnTo>
                    <a:pt x="707009" y="186817"/>
                  </a:lnTo>
                  <a:lnTo>
                    <a:pt x="707009" y="62230"/>
                  </a:lnTo>
                  <a:close/>
                </a:path>
                <a:path w="2390775" h="187325">
                  <a:moveTo>
                    <a:pt x="765175" y="0"/>
                  </a:moveTo>
                  <a:lnTo>
                    <a:pt x="754761" y="0"/>
                  </a:lnTo>
                  <a:lnTo>
                    <a:pt x="754761" y="186817"/>
                  </a:lnTo>
                  <a:lnTo>
                    <a:pt x="765175" y="186817"/>
                  </a:lnTo>
                  <a:lnTo>
                    <a:pt x="765175" y="0"/>
                  </a:lnTo>
                  <a:close/>
                </a:path>
                <a:path w="2390775" h="187325">
                  <a:moveTo>
                    <a:pt x="823214" y="124587"/>
                  </a:moveTo>
                  <a:lnTo>
                    <a:pt x="812800" y="124587"/>
                  </a:lnTo>
                  <a:lnTo>
                    <a:pt x="812800" y="186817"/>
                  </a:lnTo>
                  <a:lnTo>
                    <a:pt x="823214" y="186817"/>
                  </a:lnTo>
                  <a:lnTo>
                    <a:pt x="823214" y="124587"/>
                  </a:lnTo>
                  <a:close/>
                </a:path>
                <a:path w="2390775" h="187325">
                  <a:moveTo>
                    <a:pt x="881253" y="93472"/>
                  </a:moveTo>
                  <a:lnTo>
                    <a:pt x="870839" y="93472"/>
                  </a:lnTo>
                  <a:lnTo>
                    <a:pt x="870839" y="186817"/>
                  </a:lnTo>
                  <a:lnTo>
                    <a:pt x="881253" y="186817"/>
                  </a:lnTo>
                  <a:lnTo>
                    <a:pt x="881253" y="93472"/>
                  </a:lnTo>
                  <a:close/>
                </a:path>
                <a:path w="2390775" h="187325">
                  <a:moveTo>
                    <a:pt x="939292" y="124587"/>
                  </a:moveTo>
                  <a:lnTo>
                    <a:pt x="928878" y="124587"/>
                  </a:lnTo>
                  <a:lnTo>
                    <a:pt x="928878" y="186817"/>
                  </a:lnTo>
                  <a:lnTo>
                    <a:pt x="939292" y="186817"/>
                  </a:lnTo>
                  <a:lnTo>
                    <a:pt x="939292" y="124587"/>
                  </a:lnTo>
                  <a:close/>
                </a:path>
                <a:path w="2390775" h="187325">
                  <a:moveTo>
                    <a:pt x="997331" y="93472"/>
                  </a:moveTo>
                  <a:lnTo>
                    <a:pt x="986917" y="93472"/>
                  </a:lnTo>
                  <a:lnTo>
                    <a:pt x="986917" y="186817"/>
                  </a:lnTo>
                  <a:lnTo>
                    <a:pt x="997331" y="186817"/>
                  </a:lnTo>
                  <a:lnTo>
                    <a:pt x="997331" y="93472"/>
                  </a:lnTo>
                  <a:close/>
                </a:path>
                <a:path w="2390775" h="187325">
                  <a:moveTo>
                    <a:pt x="1113409" y="124587"/>
                  </a:moveTo>
                  <a:lnTo>
                    <a:pt x="1102995" y="124587"/>
                  </a:lnTo>
                  <a:lnTo>
                    <a:pt x="1102995" y="186817"/>
                  </a:lnTo>
                  <a:lnTo>
                    <a:pt x="1113409" y="186817"/>
                  </a:lnTo>
                  <a:lnTo>
                    <a:pt x="1113409" y="124587"/>
                  </a:lnTo>
                  <a:close/>
                </a:path>
                <a:path w="2390775" h="187325">
                  <a:moveTo>
                    <a:pt x="1171448" y="155702"/>
                  </a:moveTo>
                  <a:lnTo>
                    <a:pt x="1161034" y="155702"/>
                  </a:lnTo>
                  <a:lnTo>
                    <a:pt x="1161034" y="186817"/>
                  </a:lnTo>
                  <a:lnTo>
                    <a:pt x="1171448" y="186817"/>
                  </a:lnTo>
                  <a:lnTo>
                    <a:pt x="1171448" y="155702"/>
                  </a:lnTo>
                  <a:close/>
                </a:path>
                <a:path w="2390775" h="187325">
                  <a:moveTo>
                    <a:pt x="1287653" y="93472"/>
                  </a:moveTo>
                  <a:lnTo>
                    <a:pt x="1277239" y="93472"/>
                  </a:lnTo>
                  <a:lnTo>
                    <a:pt x="1277239" y="186817"/>
                  </a:lnTo>
                  <a:lnTo>
                    <a:pt x="1287653" y="186817"/>
                  </a:lnTo>
                  <a:lnTo>
                    <a:pt x="1287653" y="93472"/>
                  </a:lnTo>
                  <a:close/>
                </a:path>
                <a:path w="2390775" h="187325">
                  <a:moveTo>
                    <a:pt x="1345692" y="124587"/>
                  </a:moveTo>
                  <a:lnTo>
                    <a:pt x="1335278" y="124587"/>
                  </a:lnTo>
                  <a:lnTo>
                    <a:pt x="1335278" y="186817"/>
                  </a:lnTo>
                  <a:lnTo>
                    <a:pt x="1345692" y="186817"/>
                  </a:lnTo>
                  <a:lnTo>
                    <a:pt x="1345692" y="124587"/>
                  </a:lnTo>
                  <a:close/>
                </a:path>
                <a:path w="2390775" h="187325">
                  <a:moveTo>
                    <a:pt x="1403731" y="93472"/>
                  </a:moveTo>
                  <a:lnTo>
                    <a:pt x="1393317" y="93472"/>
                  </a:lnTo>
                  <a:lnTo>
                    <a:pt x="1393317" y="186817"/>
                  </a:lnTo>
                  <a:lnTo>
                    <a:pt x="1403731" y="186817"/>
                  </a:lnTo>
                  <a:lnTo>
                    <a:pt x="1403731" y="93472"/>
                  </a:lnTo>
                  <a:close/>
                </a:path>
                <a:path w="2390775" h="187325">
                  <a:moveTo>
                    <a:pt x="1519809" y="124587"/>
                  </a:moveTo>
                  <a:lnTo>
                    <a:pt x="1509395" y="124587"/>
                  </a:lnTo>
                  <a:lnTo>
                    <a:pt x="1509395" y="186817"/>
                  </a:lnTo>
                  <a:lnTo>
                    <a:pt x="1519809" y="186817"/>
                  </a:lnTo>
                  <a:lnTo>
                    <a:pt x="1519809" y="124587"/>
                  </a:lnTo>
                  <a:close/>
                </a:path>
                <a:path w="2390775" h="187325">
                  <a:moveTo>
                    <a:pt x="1577848" y="124587"/>
                  </a:moveTo>
                  <a:lnTo>
                    <a:pt x="1567434" y="124587"/>
                  </a:lnTo>
                  <a:lnTo>
                    <a:pt x="1567434" y="186817"/>
                  </a:lnTo>
                  <a:lnTo>
                    <a:pt x="1577848" y="186817"/>
                  </a:lnTo>
                  <a:lnTo>
                    <a:pt x="1577848" y="124587"/>
                  </a:lnTo>
                  <a:close/>
                </a:path>
                <a:path w="2390775" h="187325">
                  <a:moveTo>
                    <a:pt x="1635887" y="124587"/>
                  </a:moveTo>
                  <a:lnTo>
                    <a:pt x="1625473" y="124587"/>
                  </a:lnTo>
                  <a:lnTo>
                    <a:pt x="1625473" y="186817"/>
                  </a:lnTo>
                  <a:lnTo>
                    <a:pt x="1635887" y="186817"/>
                  </a:lnTo>
                  <a:lnTo>
                    <a:pt x="1635887" y="124587"/>
                  </a:lnTo>
                  <a:close/>
                </a:path>
                <a:path w="2390775" h="187325">
                  <a:moveTo>
                    <a:pt x="1693926" y="155702"/>
                  </a:moveTo>
                  <a:lnTo>
                    <a:pt x="1683512" y="155702"/>
                  </a:lnTo>
                  <a:lnTo>
                    <a:pt x="1683512" y="186817"/>
                  </a:lnTo>
                  <a:lnTo>
                    <a:pt x="1693926" y="186817"/>
                  </a:lnTo>
                  <a:lnTo>
                    <a:pt x="1693926" y="155702"/>
                  </a:lnTo>
                  <a:close/>
                </a:path>
                <a:path w="2390775" h="187325">
                  <a:moveTo>
                    <a:pt x="1751965" y="155702"/>
                  </a:moveTo>
                  <a:lnTo>
                    <a:pt x="1741551" y="155702"/>
                  </a:lnTo>
                  <a:lnTo>
                    <a:pt x="1741551" y="186817"/>
                  </a:lnTo>
                  <a:lnTo>
                    <a:pt x="1751965" y="186817"/>
                  </a:lnTo>
                  <a:lnTo>
                    <a:pt x="1751965" y="155702"/>
                  </a:lnTo>
                  <a:close/>
                </a:path>
                <a:path w="2390775" h="187325">
                  <a:moveTo>
                    <a:pt x="1810004" y="31115"/>
                  </a:moveTo>
                  <a:lnTo>
                    <a:pt x="1799590" y="31115"/>
                  </a:lnTo>
                  <a:lnTo>
                    <a:pt x="1799590" y="186817"/>
                  </a:lnTo>
                  <a:lnTo>
                    <a:pt x="1810004" y="186817"/>
                  </a:lnTo>
                  <a:lnTo>
                    <a:pt x="1810004" y="31115"/>
                  </a:lnTo>
                  <a:close/>
                </a:path>
                <a:path w="2390775" h="187325">
                  <a:moveTo>
                    <a:pt x="1868170" y="93472"/>
                  </a:moveTo>
                  <a:lnTo>
                    <a:pt x="1857756" y="93472"/>
                  </a:lnTo>
                  <a:lnTo>
                    <a:pt x="1857756" y="186817"/>
                  </a:lnTo>
                  <a:lnTo>
                    <a:pt x="1868170" y="186817"/>
                  </a:lnTo>
                  <a:lnTo>
                    <a:pt x="1868170" y="93472"/>
                  </a:lnTo>
                  <a:close/>
                </a:path>
                <a:path w="2390775" h="187325">
                  <a:moveTo>
                    <a:pt x="2042287" y="62230"/>
                  </a:moveTo>
                  <a:lnTo>
                    <a:pt x="2031873" y="62230"/>
                  </a:lnTo>
                  <a:lnTo>
                    <a:pt x="2031873" y="186817"/>
                  </a:lnTo>
                  <a:lnTo>
                    <a:pt x="2042287" y="186817"/>
                  </a:lnTo>
                  <a:lnTo>
                    <a:pt x="2042287" y="62230"/>
                  </a:lnTo>
                  <a:close/>
                </a:path>
                <a:path w="2390775" h="187325">
                  <a:moveTo>
                    <a:pt x="2100326" y="155702"/>
                  </a:moveTo>
                  <a:lnTo>
                    <a:pt x="2089912" y="155702"/>
                  </a:lnTo>
                  <a:lnTo>
                    <a:pt x="2089912" y="186817"/>
                  </a:lnTo>
                  <a:lnTo>
                    <a:pt x="2100326" y="186817"/>
                  </a:lnTo>
                  <a:lnTo>
                    <a:pt x="2100326" y="155702"/>
                  </a:lnTo>
                  <a:close/>
                </a:path>
                <a:path w="2390775" h="187325">
                  <a:moveTo>
                    <a:pt x="2158365" y="124587"/>
                  </a:moveTo>
                  <a:lnTo>
                    <a:pt x="2147951" y="124587"/>
                  </a:lnTo>
                  <a:lnTo>
                    <a:pt x="2147951" y="186817"/>
                  </a:lnTo>
                  <a:lnTo>
                    <a:pt x="2158365" y="186817"/>
                  </a:lnTo>
                  <a:lnTo>
                    <a:pt x="2158365" y="124587"/>
                  </a:lnTo>
                  <a:close/>
                </a:path>
                <a:path w="2390775" h="187325">
                  <a:moveTo>
                    <a:pt x="2216404" y="155702"/>
                  </a:moveTo>
                  <a:lnTo>
                    <a:pt x="2205990" y="155702"/>
                  </a:lnTo>
                  <a:lnTo>
                    <a:pt x="2205990" y="186817"/>
                  </a:lnTo>
                  <a:lnTo>
                    <a:pt x="2216404" y="186817"/>
                  </a:lnTo>
                  <a:lnTo>
                    <a:pt x="2216404" y="155702"/>
                  </a:lnTo>
                  <a:close/>
                </a:path>
                <a:path w="2390775" h="187325">
                  <a:moveTo>
                    <a:pt x="2274443" y="155702"/>
                  </a:moveTo>
                  <a:lnTo>
                    <a:pt x="2264029" y="155702"/>
                  </a:lnTo>
                  <a:lnTo>
                    <a:pt x="2264029" y="186817"/>
                  </a:lnTo>
                  <a:lnTo>
                    <a:pt x="2274443" y="186817"/>
                  </a:lnTo>
                  <a:lnTo>
                    <a:pt x="2274443" y="155702"/>
                  </a:lnTo>
                  <a:close/>
                </a:path>
                <a:path w="2390775" h="187325">
                  <a:moveTo>
                    <a:pt x="2332469" y="124587"/>
                  </a:moveTo>
                  <a:lnTo>
                    <a:pt x="2322068" y="124587"/>
                  </a:lnTo>
                  <a:lnTo>
                    <a:pt x="2322068" y="186817"/>
                  </a:lnTo>
                  <a:lnTo>
                    <a:pt x="2332469" y="186817"/>
                  </a:lnTo>
                  <a:lnTo>
                    <a:pt x="2332469" y="124587"/>
                  </a:lnTo>
                  <a:close/>
                </a:path>
                <a:path w="2390775" h="187325">
                  <a:moveTo>
                    <a:pt x="2390635" y="124587"/>
                  </a:moveTo>
                  <a:lnTo>
                    <a:pt x="2380221" y="124587"/>
                  </a:lnTo>
                  <a:lnTo>
                    <a:pt x="2380221" y="186817"/>
                  </a:lnTo>
                  <a:lnTo>
                    <a:pt x="2390635" y="186817"/>
                  </a:lnTo>
                  <a:lnTo>
                    <a:pt x="2390635" y="124587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2" name="object 122" descr=""/>
            <p:cNvSpPr/>
            <p:nvPr/>
          </p:nvSpPr>
          <p:spPr>
            <a:xfrm>
              <a:off x="13172948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4" h="0">
                  <a:moveTo>
                    <a:pt x="0" y="0"/>
                  </a:moveTo>
                  <a:lnTo>
                    <a:pt x="10413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3" name="object 123" descr=""/>
            <p:cNvSpPr/>
            <p:nvPr/>
          </p:nvSpPr>
          <p:spPr>
            <a:xfrm>
              <a:off x="13238861" y="8569071"/>
              <a:ext cx="873760" cy="93345"/>
            </a:xfrm>
            <a:custGeom>
              <a:avLst/>
              <a:gdLst/>
              <a:ahLst/>
              <a:cxnLst/>
              <a:rect l="l" t="t" r="r" b="b"/>
              <a:pathLst>
                <a:path w="873759" h="93345">
                  <a:moveTo>
                    <a:pt x="13081" y="62230"/>
                  </a:moveTo>
                  <a:lnTo>
                    <a:pt x="0" y="62230"/>
                  </a:lnTo>
                  <a:lnTo>
                    <a:pt x="0" y="93345"/>
                  </a:lnTo>
                  <a:lnTo>
                    <a:pt x="13081" y="93345"/>
                  </a:lnTo>
                  <a:lnTo>
                    <a:pt x="13081" y="62230"/>
                  </a:lnTo>
                  <a:close/>
                </a:path>
                <a:path w="873759" h="93345">
                  <a:moveTo>
                    <a:pt x="70993" y="62230"/>
                  </a:moveTo>
                  <a:lnTo>
                    <a:pt x="53594" y="62230"/>
                  </a:lnTo>
                  <a:lnTo>
                    <a:pt x="53594" y="93345"/>
                  </a:lnTo>
                  <a:lnTo>
                    <a:pt x="70993" y="93345"/>
                  </a:lnTo>
                  <a:lnTo>
                    <a:pt x="70993" y="62230"/>
                  </a:lnTo>
                  <a:close/>
                </a:path>
                <a:path w="873759" h="93345">
                  <a:moveTo>
                    <a:pt x="176657" y="62230"/>
                  </a:moveTo>
                  <a:lnTo>
                    <a:pt x="166243" y="62230"/>
                  </a:lnTo>
                  <a:lnTo>
                    <a:pt x="166243" y="93345"/>
                  </a:lnTo>
                  <a:lnTo>
                    <a:pt x="176657" y="93345"/>
                  </a:lnTo>
                  <a:lnTo>
                    <a:pt x="176657" y="62230"/>
                  </a:lnTo>
                  <a:close/>
                </a:path>
                <a:path w="873759" h="93345">
                  <a:moveTo>
                    <a:pt x="234683" y="62230"/>
                  </a:moveTo>
                  <a:lnTo>
                    <a:pt x="224282" y="62230"/>
                  </a:lnTo>
                  <a:lnTo>
                    <a:pt x="224282" y="93345"/>
                  </a:lnTo>
                  <a:lnTo>
                    <a:pt x="234683" y="93345"/>
                  </a:lnTo>
                  <a:lnTo>
                    <a:pt x="234683" y="62230"/>
                  </a:lnTo>
                  <a:close/>
                </a:path>
                <a:path w="873759" h="93345">
                  <a:moveTo>
                    <a:pt x="303276" y="62230"/>
                  </a:moveTo>
                  <a:lnTo>
                    <a:pt x="290195" y="62230"/>
                  </a:lnTo>
                  <a:lnTo>
                    <a:pt x="290195" y="93345"/>
                  </a:lnTo>
                  <a:lnTo>
                    <a:pt x="303276" y="93345"/>
                  </a:lnTo>
                  <a:lnTo>
                    <a:pt x="303276" y="62230"/>
                  </a:lnTo>
                  <a:close/>
                </a:path>
                <a:path w="873759" h="93345">
                  <a:moveTo>
                    <a:pt x="361302" y="62230"/>
                  </a:moveTo>
                  <a:lnTo>
                    <a:pt x="348234" y="62230"/>
                  </a:lnTo>
                  <a:lnTo>
                    <a:pt x="348234" y="93345"/>
                  </a:lnTo>
                  <a:lnTo>
                    <a:pt x="361302" y="93345"/>
                  </a:lnTo>
                  <a:lnTo>
                    <a:pt x="361302" y="62230"/>
                  </a:lnTo>
                  <a:close/>
                </a:path>
                <a:path w="873759" h="93345">
                  <a:moveTo>
                    <a:pt x="464439" y="62230"/>
                  </a:moveTo>
                  <a:lnTo>
                    <a:pt x="451358" y="62230"/>
                  </a:lnTo>
                  <a:lnTo>
                    <a:pt x="451358" y="93345"/>
                  </a:lnTo>
                  <a:lnTo>
                    <a:pt x="464439" y="93345"/>
                  </a:lnTo>
                  <a:lnTo>
                    <a:pt x="464439" y="62230"/>
                  </a:lnTo>
                  <a:close/>
                </a:path>
                <a:path w="873759" h="93345">
                  <a:moveTo>
                    <a:pt x="593598" y="0"/>
                  </a:moveTo>
                  <a:lnTo>
                    <a:pt x="580517" y="0"/>
                  </a:lnTo>
                  <a:lnTo>
                    <a:pt x="580517" y="93345"/>
                  </a:lnTo>
                  <a:lnTo>
                    <a:pt x="593598" y="93345"/>
                  </a:lnTo>
                  <a:lnTo>
                    <a:pt x="593598" y="0"/>
                  </a:lnTo>
                  <a:close/>
                </a:path>
                <a:path w="873759" h="93345">
                  <a:moveTo>
                    <a:pt x="641083" y="62230"/>
                  </a:moveTo>
                  <a:lnTo>
                    <a:pt x="630682" y="62230"/>
                  </a:lnTo>
                  <a:lnTo>
                    <a:pt x="630682" y="93345"/>
                  </a:lnTo>
                  <a:lnTo>
                    <a:pt x="641083" y="93345"/>
                  </a:lnTo>
                  <a:lnTo>
                    <a:pt x="641083" y="62230"/>
                  </a:lnTo>
                  <a:close/>
                </a:path>
                <a:path w="873759" h="93345">
                  <a:moveTo>
                    <a:pt x="699135" y="62230"/>
                  </a:moveTo>
                  <a:lnTo>
                    <a:pt x="688721" y="62230"/>
                  </a:lnTo>
                  <a:lnTo>
                    <a:pt x="688721" y="93345"/>
                  </a:lnTo>
                  <a:lnTo>
                    <a:pt x="699135" y="93345"/>
                  </a:lnTo>
                  <a:lnTo>
                    <a:pt x="699135" y="62230"/>
                  </a:lnTo>
                  <a:close/>
                </a:path>
                <a:path w="873759" h="93345">
                  <a:moveTo>
                    <a:pt x="757174" y="62230"/>
                  </a:moveTo>
                  <a:lnTo>
                    <a:pt x="746760" y="62230"/>
                  </a:lnTo>
                  <a:lnTo>
                    <a:pt x="746760" y="93345"/>
                  </a:lnTo>
                  <a:lnTo>
                    <a:pt x="757174" y="93345"/>
                  </a:lnTo>
                  <a:lnTo>
                    <a:pt x="757174" y="62230"/>
                  </a:lnTo>
                  <a:close/>
                </a:path>
                <a:path w="873759" h="93345">
                  <a:moveTo>
                    <a:pt x="815213" y="62230"/>
                  </a:moveTo>
                  <a:lnTo>
                    <a:pt x="804799" y="62230"/>
                  </a:lnTo>
                  <a:lnTo>
                    <a:pt x="804799" y="93345"/>
                  </a:lnTo>
                  <a:lnTo>
                    <a:pt x="815213" y="93345"/>
                  </a:lnTo>
                  <a:lnTo>
                    <a:pt x="815213" y="62230"/>
                  </a:lnTo>
                  <a:close/>
                </a:path>
                <a:path w="873759" h="93345">
                  <a:moveTo>
                    <a:pt x="873239" y="31115"/>
                  </a:moveTo>
                  <a:lnTo>
                    <a:pt x="862838" y="31115"/>
                  </a:lnTo>
                  <a:lnTo>
                    <a:pt x="862838" y="93345"/>
                  </a:lnTo>
                  <a:lnTo>
                    <a:pt x="873239" y="93345"/>
                  </a:lnTo>
                  <a:lnTo>
                    <a:pt x="873239" y="31115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4" name="object 124" descr=""/>
            <p:cNvSpPr/>
            <p:nvPr/>
          </p:nvSpPr>
          <p:spPr>
            <a:xfrm>
              <a:off x="14159864" y="8662416"/>
              <a:ext cx="10795" cy="0"/>
            </a:xfrm>
            <a:custGeom>
              <a:avLst/>
              <a:gdLst/>
              <a:ahLst/>
              <a:cxnLst/>
              <a:rect l="l" t="t" r="r" b="b"/>
              <a:pathLst>
                <a:path w="10794" h="0">
                  <a:moveTo>
                    <a:pt x="0" y="0"/>
                  </a:moveTo>
                  <a:lnTo>
                    <a:pt x="10413" y="0"/>
                  </a:lnTo>
                  <a:lnTo>
                    <a:pt x="0" y="0"/>
                  </a:lnTo>
                  <a:close/>
                </a:path>
              </a:pathLst>
            </a:custGeom>
            <a:ln w="13589">
              <a:solidFill>
                <a:srgbClr val="4DCE6B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5" name="object 125" descr=""/>
            <p:cNvSpPr/>
            <p:nvPr/>
          </p:nvSpPr>
          <p:spPr>
            <a:xfrm>
              <a:off x="14217904" y="8569071"/>
              <a:ext cx="1182370" cy="93345"/>
            </a:xfrm>
            <a:custGeom>
              <a:avLst/>
              <a:gdLst/>
              <a:ahLst/>
              <a:cxnLst/>
              <a:rect l="l" t="t" r="r" b="b"/>
              <a:pathLst>
                <a:path w="1182369" h="93345">
                  <a:moveTo>
                    <a:pt x="10414" y="62230"/>
                  </a:moveTo>
                  <a:lnTo>
                    <a:pt x="0" y="62230"/>
                  </a:lnTo>
                  <a:lnTo>
                    <a:pt x="0" y="93345"/>
                  </a:lnTo>
                  <a:lnTo>
                    <a:pt x="10414" y="93345"/>
                  </a:lnTo>
                  <a:lnTo>
                    <a:pt x="10414" y="62230"/>
                  </a:lnTo>
                  <a:close/>
                </a:path>
                <a:path w="1182369" h="93345">
                  <a:moveTo>
                    <a:pt x="68440" y="62230"/>
                  </a:moveTo>
                  <a:lnTo>
                    <a:pt x="58039" y="62230"/>
                  </a:lnTo>
                  <a:lnTo>
                    <a:pt x="58039" y="93345"/>
                  </a:lnTo>
                  <a:lnTo>
                    <a:pt x="68440" y="93345"/>
                  </a:lnTo>
                  <a:lnTo>
                    <a:pt x="68440" y="62230"/>
                  </a:lnTo>
                  <a:close/>
                </a:path>
                <a:path w="1182369" h="93345">
                  <a:moveTo>
                    <a:pt x="137033" y="62230"/>
                  </a:moveTo>
                  <a:lnTo>
                    <a:pt x="123952" y="62230"/>
                  </a:lnTo>
                  <a:lnTo>
                    <a:pt x="123952" y="93345"/>
                  </a:lnTo>
                  <a:lnTo>
                    <a:pt x="137033" y="93345"/>
                  </a:lnTo>
                  <a:lnTo>
                    <a:pt x="137033" y="62230"/>
                  </a:lnTo>
                  <a:close/>
                </a:path>
                <a:path w="1182369" h="93345">
                  <a:moveTo>
                    <a:pt x="253111" y="62230"/>
                  </a:moveTo>
                  <a:lnTo>
                    <a:pt x="240030" y="62230"/>
                  </a:lnTo>
                  <a:lnTo>
                    <a:pt x="240030" y="93345"/>
                  </a:lnTo>
                  <a:lnTo>
                    <a:pt x="253111" y="93345"/>
                  </a:lnTo>
                  <a:lnTo>
                    <a:pt x="253111" y="62230"/>
                  </a:lnTo>
                  <a:close/>
                </a:path>
                <a:path w="1182369" h="93345">
                  <a:moveTo>
                    <a:pt x="300596" y="62230"/>
                  </a:moveTo>
                  <a:lnTo>
                    <a:pt x="290195" y="62230"/>
                  </a:lnTo>
                  <a:lnTo>
                    <a:pt x="290195" y="93345"/>
                  </a:lnTo>
                  <a:lnTo>
                    <a:pt x="300596" y="93345"/>
                  </a:lnTo>
                  <a:lnTo>
                    <a:pt x="300596" y="62230"/>
                  </a:lnTo>
                  <a:close/>
                </a:path>
                <a:path w="1182369" h="93345">
                  <a:moveTo>
                    <a:pt x="358648" y="0"/>
                  </a:moveTo>
                  <a:lnTo>
                    <a:pt x="348234" y="0"/>
                  </a:lnTo>
                  <a:lnTo>
                    <a:pt x="348234" y="93345"/>
                  </a:lnTo>
                  <a:lnTo>
                    <a:pt x="358648" y="93345"/>
                  </a:lnTo>
                  <a:lnTo>
                    <a:pt x="358648" y="0"/>
                  </a:lnTo>
                  <a:close/>
                </a:path>
                <a:path w="1182369" h="93345">
                  <a:moveTo>
                    <a:pt x="532892" y="62230"/>
                  </a:moveTo>
                  <a:lnTo>
                    <a:pt x="522478" y="62230"/>
                  </a:lnTo>
                  <a:lnTo>
                    <a:pt x="522478" y="93345"/>
                  </a:lnTo>
                  <a:lnTo>
                    <a:pt x="532892" y="93345"/>
                  </a:lnTo>
                  <a:lnTo>
                    <a:pt x="532892" y="62230"/>
                  </a:lnTo>
                  <a:close/>
                </a:path>
                <a:path w="1182369" h="93345">
                  <a:moveTo>
                    <a:pt x="601345" y="62230"/>
                  </a:moveTo>
                  <a:lnTo>
                    <a:pt x="588264" y="62230"/>
                  </a:lnTo>
                  <a:lnTo>
                    <a:pt x="588264" y="93345"/>
                  </a:lnTo>
                  <a:lnTo>
                    <a:pt x="601345" y="93345"/>
                  </a:lnTo>
                  <a:lnTo>
                    <a:pt x="601345" y="62230"/>
                  </a:lnTo>
                  <a:close/>
                </a:path>
                <a:path w="1182369" h="93345">
                  <a:moveTo>
                    <a:pt x="648970" y="0"/>
                  </a:moveTo>
                  <a:lnTo>
                    <a:pt x="638556" y="0"/>
                  </a:lnTo>
                  <a:lnTo>
                    <a:pt x="638556" y="93345"/>
                  </a:lnTo>
                  <a:lnTo>
                    <a:pt x="648970" y="93345"/>
                  </a:lnTo>
                  <a:lnTo>
                    <a:pt x="648970" y="0"/>
                  </a:lnTo>
                  <a:close/>
                </a:path>
                <a:path w="1182369" h="93345">
                  <a:moveTo>
                    <a:pt x="775589" y="62230"/>
                  </a:moveTo>
                  <a:lnTo>
                    <a:pt x="762508" y="62230"/>
                  </a:lnTo>
                  <a:lnTo>
                    <a:pt x="762508" y="93345"/>
                  </a:lnTo>
                  <a:lnTo>
                    <a:pt x="775589" y="93345"/>
                  </a:lnTo>
                  <a:lnTo>
                    <a:pt x="775589" y="62230"/>
                  </a:lnTo>
                  <a:close/>
                </a:path>
                <a:path w="1182369" h="93345">
                  <a:moveTo>
                    <a:pt x="833628" y="62230"/>
                  </a:moveTo>
                  <a:lnTo>
                    <a:pt x="820547" y="62230"/>
                  </a:lnTo>
                  <a:lnTo>
                    <a:pt x="820547" y="93345"/>
                  </a:lnTo>
                  <a:lnTo>
                    <a:pt x="833628" y="93345"/>
                  </a:lnTo>
                  <a:lnTo>
                    <a:pt x="833628" y="62230"/>
                  </a:lnTo>
                  <a:close/>
                </a:path>
                <a:path w="1182369" h="93345">
                  <a:moveTo>
                    <a:pt x="891654" y="31115"/>
                  </a:moveTo>
                  <a:lnTo>
                    <a:pt x="874268" y="31115"/>
                  </a:lnTo>
                  <a:lnTo>
                    <a:pt x="874268" y="93345"/>
                  </a:lnTo>
                  <a:lnTo>
                    <a:pt x="891654" y="93345"/>
                  </a:lnTo>
                  <a:lnTo>
                    <a:pt x="891654" y="31115"/>
                  </a:lnTo>
                  <a:close/>
                </a:path>
                <a:path w="1182369" h="93345">
                  <a:moveTo>
                    <a:pt x="949706" y="62230"/>
                  </a:moveTo>
                  <a:lnTo>
                    <a:pt x="936625" y="62230"/>
                  </a:lnTo>
                  <a:lnTo>
                    <a:pt x="936625" y="93345"/>
                  </a:lnTo>
                  <a:lnTo>
                    <a:pt x="949706" y="93345"/>
                  </a:lnTo>
                  <a:lnTo>
                    <a:pt x="949706" y="62230"/>
                  </a:lnTo>
                  <a:close/>
                </a:path>
                <a:path w="1182369" h="93345">
                  <a:moveTo>
                    <a:pt x="1007745" y="31115"/>
                  </a:moveTo>
                  <a:lnTo>
                    <a:pt x="994664" y="31115"/>
                  </a:lnTo>
                  <a:lnTo>
                    <a:pt x="994664" y="93345"/>
                  </a:lnTo>
                  <a:lnTo>
                    <a:pt x="1007745" y="93345"/>
                  </a:lnTo>
                  <a:lnTo>
                    <a:pt x="1007745" y="31115"/>
                  </a:lnTo>
                  <a:close/>
                </a:path>
                <a:path w="1182369" h="93345">
                  <a:moveTo>
                    <a:pt x="1123823" y="62230"/>
                  </a:moveTo>
                  <a:lnTo>
                    <a:pt x="1110742" y="62230"/>
                  </a:lnTo>
                  <a:lnTo>
                    <a:pt x="1110742" y="93345"/>
                  </a:lnTo>
                  <a:lnTo>
                    <a:pt x="1123823" y="93345"/>
                  </a:lnTo>
                  <a:lnTo>
                    <a:pt x="1123823" y="62230"/>
                  </a:lnTo>
                  <a:close/>
                </a:path>
                <a:path w="1182369" h="93345">
                  <a:moveTo>
                    <a:pt x="1181989" y="62230"/>
                  </a:moveTo>
                  <a:lnTo>
                    <a:pt x="1168908" y="62230"/>
                  </a:lnTo>
                  <a:lnTo>
                    <a:pt x="1168908" y="93345"/>
                  </a:lnTo>
                  <a:lnTo>
                    <a:pt x="1181989" y="93345"/>
                  </a:lnTo>
                  <a:lnTo>
                    <a:pt x="1181989" y="62230"/>
                  </a:lnTo>
                  <a:close/>
                </a:path>
              </a:pathLst>
            </a:custGeom>
            <a:solidFill>
              <a:srgbClr val="4DCE6B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6" name="object 126" descr=""/>
            <p:cNvSpPr/>
            <p:nvPr/>
          </p:nvSpPr>
          <p:spPr>
            <a:xfrm>
              <a:off x="1163828" y="7946390"/>
              <a:ext cx="4076700" cy="716280"/>
            </a:xfrm>
            <a:custGeom>
              <a:avLst/>
              <a:gdLst/>
              <a:ahLst/>
              <a:cxnLst/>
              <a:rect l="l" t="t" r="r" b="b"/>
              <a:pathLst>
                <a:path w="4076700" h="716279">
                  <a:moveTo>
                    <a:pt x="13081" y="684911"/>
                  </a:moveTo>
                  <a:lnTo>
                    <a:pt x="0" y="684911"/>
                  </a:lnTo>
                  <a:lnTo>
                    <a:pt x="0" y="716026"/>
                  </a:lnTo>
                  <a:lnTo>
                    <a:pt x="13081" y="716026"/>
                  </a:lnTo>
                  <a:lnTo>
                    <a:pt x="13081" y="684911"/>
                  </a:lnTo>
                  <a:close/>
                </a:path>
                <a:path w="4076700" h="716279">
                  <a:moveTo>
                    <a:pt x="71120" y="622681"/>
                  </a:moveTo>
                  <a:lnTo>
                    <a:pt x="58039" y="622681"/>
                  </a:lnTo>
                  <a:lnTo>
                    <a:pt x="58039" y="716026"/>
                  </a:lnTo>
                  <a:lnTo>
                    <a:pt x="71120" y="716026"/>
                  </a:lnTo>
                  <a:lnTo>
                    <a:pt x="71120" y="622681"/>
                  </a:lnTo>
                  <a:close/>
                </a:path>
                <a:path w="4076700" h="716279">
                  <a:moveTo>
                    <a:pt x="129286" y="653796"/>
                  </a:moveTo>
                  <a:lnTo>
                    <a:pt x="116205" y="653796"/>
                  </a:lnTo>
                  <a:lnTo>
                    <a:pt x="116205" y="716026"/>
                  </a:lnTo>
                  <a:lnTo>
                    <a:pt x="129286" y="716026"/>
                  </a:lnTo>
                  <a:lnTo>
                    <a:pt x="129286" y="653796"/>
                  </a:lnTo>
                  <a:close/>
                </a:path>
                <a:path w="4076700" h="716279">
                  <a:moveTo>
                    <a:pt x="187325" y="560324"/>
                  </a:moveTo>
                  <a:lnTo>
                    <a:pt x="174244" y="560324"/>
                  </a:lnTo>
                  <a:lnTo>
                    <a:pt x="174244" y="716026"/>
                  </a:lnTo>
                  <a:lnTo>
                    <a:pt x="187325" y="716026"/>
                  </a:lnTo>
                  <a:lnTo>
                    <a:pt x="187325" y="560324"/>
                  </a:lnTo>
                  <a:close/>
                </a:path>
                <a:path w="4076700" h="716279">
                  <a:moveTo>
                    <a:pt x="245364" y="560324"/>
                  </a:moveTo>
                  <a:lnTo>
                    <a:pt x="232283" y="560324"/>
                  </a:lnTo>
                  <a:lnTo>
                    <a:pt x="232283" y="716026"/>
                  </a:lnTo>
                  <a:lnTo>
                    <a:pt x="245364" y="716026"/>
                  </a:lnTo>
                  <a:lnTo>
                    <a:pt x="245364" y="560324"/>
                  </a:lnTo>
                  <a:close/>
                </a:path>
                <a:path w="4076700" h="716279">
                  <a:moveTo>
                    <a:pt x="303403" y="560324"/>
                  </a:moveTo>
                  <a:lnTo>
                    <a:pt x="290322" y="560324"/>
                  </a:lnTo>
                  <a:lnTo>
                    <a:pt x="290322" y="716026"/>
                  </a:lnTo>
                  <a:lnTo>
                    <a:pt x="303403" y="716026"/>
                  </a:lnTo>
                  <a:lnTo>
                    <a:pt x="303403" y="560324"/>
                  </a:lnTo>
                  <a:close/>
                </a:path>
                <a:path w="4076700" h="716279">
                  <a:moveTo>
                    <a:pt x="361442" y="404622"/>
                  </a:moveTo>
                  <a:lnTo>
                    <a:pt x="348361" y="404622"/>
                  </a:lnTo>
                  <a:lnTo>
                    <a:pt x="348361" y="716026"/>
                  </a:lnTo>
                  <a:lnTo>
                    <a:pt x="361442" y="716026"/>
                  </a:lnTo>
                  <a:lnTo>
                    <a:pt x="361442" y="404622"/>
                  </a:lnTo>
                  <a:close/>
                </a:path>
                <a:path w="4076700" h="716279">
                  <a:moveTo>
                    <a:pt x="419468" y="560324"/>
                  </a:moveTo>
                  <a:lnTo>
                    <a:pt x="409067" y="560324"/>
                  </a:lnTo>
                  <a:lnTo>
                    <a:pt x="409067" y="716026"/>
                  </a:lnTo>
                  <a:lnTo>
                    <a:pt x="419468" y="716026"/>
                  </a:lnTo>
                  <a:lnTo>
                    <a:pt x="419468" y="560324"/>
                  </a:lnTo>
                  <a:close/>
                </a:path>
                <a:path w="4076700" h="716279">
                  <a:moveTo>
                    <a:pt x="477520" y="404622"/>
                  </a:moveTo>
                  <a:lnTo>
                    <a:pt x="464439" y="404622"/>
                  </a:lnTo>
                  <a:lnTo>
                    <a:pt x="464439" y="716026"/>
                  </a:lnTo>
                  <a:lnTo>
                    <a:pt x="477520" y="716026"/>
                  </a:lnTo>
                  <a:lnTo>
                    <a:pt x="477520" y="404622"/>
                  </a:lnTo>
                  <a:close/>
                </a:path>
                <a:path w="4076700" h="716279">
                  <a:moveTo>
                    <a:pt x="535559" y="560324"/>
                  </a:moveTo>
                  <a:lnTo>
                    <a:pt x="525145" y="560324"/>
                  </a:lnTo>
                  <a:lnTo>
                    <a:pt x="525145" y="716026"/>
                  </a:lnTo>
                  <a:lnTo>
                    <a:pt x="535559" y="716026"/>
                  </a:lnTo>
                  <a:lnTo>
                    <a:pt x="535559" y="560324"/>
                  </a:lnTo>
                  <a:close/>
                </a:path>
                <a:path w="4076700" h="716279">
                  <a:moveTo>
                    <a:pt x="593598" y="622681"/>
                  </a:moveTo>
                  <a:lnTo>
                    <a:pt x="583184" y="622681"/>
                  </a:lnTo>
                  <a:lnTo>
                    <a:pt x="583184" y="716026"/>
                  </a:lnTo>
                  <a:lnTo>
                    <a:pt x="593598" y="716026"/>
                  </a:lnTo>
                  <a:lnTo>
                    <a:pt x="593598" y="622681"/>
                  </a:lnTo>
                  <a:close/>
                </a:path>
                <a:path w="4076700" h="716279">
                  <a:moveTo>
                    <a:pt x="651637" y="435864"/>
                  </a:moveTo>
                  <a:lnTo>
                    <a:pt x="641223" y="435864"/>
                  </a:lnTo>
                  <a:lnTo>
                    <a:pt x="641223" y="716026"/>
                  </a:lnTo>
                  <a:lnTo>
                    <a:pt x="651637" y="716026"/>
                  </a:lnTo>
                  <a:lnTo>
                    <a:pt x="651637" y="435864"/>
                  </a:lnTo>
                  <a:close/>
                </a:path>
                <a:path w="4076700" h="716279">
                  <a:moveTo>
                    <a:pt x="709663" y="249047"/>
                  </a:moveTo>
                  <a:lnTo>
                    <a:pt x="699262" y="249047"/>
                  </a:lnTo>
                  <a:lnTo>
                    <a:pt x="699262" y="716026"/>
                  </a:lnTo>
                  <a:lnTo>
                    <a:pt x="709663" y="716026"/>
                  </a:lnTo>
                  <a:lnTo>
                    <a:pt x="709663" y="249047"/>
                  </a:lnTo>
                  <a:close/>
                </a:path>
                <a:path w="4076700" h="716279">
                  <a:moveTo>
                    <a:pt x="767715" y="435864"/>
                  </a:moveTo>
                  <a:lnTo>
                    <a:pt x="757301" y="435864"/>
                  </a:lnTo>
                  <a:lnTo>
                    <a:pt x="757301" y="716026"/>
                  </a:lnTo>
                  <a:lnTo>
                    <a:pt x="767715" y="716026"/>
                  </a:lnTo>
                  <a:lnTo>
                    <a:pt x="767715" y="435864"/>
                  </a:lnTo>
                  <a:close/>
                </a:path>
                <a:path w="4076700" h="716279">
                  <a:moveTo>
                    <a:pt x="825754" y="124460"/>
                  </a:moveTo>
                  <a:lnTo>
                    <a:pt x="815340" y="124460"/>
                  </a:lnTo>
                  <a:lnTo>
                    <a:pt x="815340" y="716026"/>
                  </a:lnTo>
                  <a:lnTo>
                    <a:pt x="825754" y="716026"/>
                  </a:lnTo>
                  <a:lnTo>
                    <a:pt x="825754" y="124460"/>
                  </a:lnTo>
                  <a:close/>
                </a:path>
                <a:path w="4076700" h="716279">
                  <a:moveTo>
                    <a:pt x="883907" y="155575"/>
                  </a:moveTo>
                  <a:lnTo>
                    <a:pt x="873506" y="155575"/>
                  </a:lnTo>
                  <a:lnTo>
                    <a:pt x="873506" y="716026"/>
                  </a:lnTo>
                  <a:lnTo>
                    <a:pt x="883907" y="716026"/>
                  </a:lnTo>
                  <a:lnTo>
                    <a:pt x="883907" y="155575"/>
                  </a:lnTo>
                  <a:close/>
                </a:path>
                <a:path w="4076700" h="716279">
                  <a:moveTo>
                    <a:pt x="941959" y="311277"/>
                  </a:moveTo>
                  <a:lnTo>
                    <a:pt x="931545" y="311277"/>
                  </a:lnTo>
                  <a:lnTo>
                    <a:pt x="931545" y="716026"/>
                  </a:lnTo>
                  <a:lnTo>
                    <a:pt x="941959" y="716026"/>
                  </a:lnTo>
                  <a:lnTo>
                    <a:pt x="941959" y="311277"/>
                  </a:lnTo>
                  <a:close/>
                </a:path>
                <a:path w="4076700" h="716279">
                  <a:moveTo>
                    <a:pt x="999998" y="342392"/>
                  </a:moveTo>
                  <a:lnTo>
                    <a:pt x="989584" y="342392"/>
                  </a:lnTo>
                  <a:lnTo>
                    <a:pt x="989584" y="716026"/>
                  </a:lnTo>
                  <a:lnTo>
                    <a:pt x="999998" y="716026"/>
                  </a:lnTo>
                  <a:lnTo>
                    <a:pt x="999998" y="342392"/>
                  </a:lnTo>
                  <a:close/>
                </a:path>
                <a:path w="4076700" h="716279">
                  <a:moveTo>
                    <a:pt x="1058037" y="124460"/>
                  </a:moveTo>
                  <a:lnTo>
                    <a:pt x="1047623" y="124460"/>
                  </a:lnTo>
                  <a:lnTo>
                    <a:pt x="1047623" y="716026"/>
                  </a:lnTo>
                  <a:lnTo>
                    <a:pt x="1058037" y="716026"/>
                  </a:lnTo>
                  <a:lnTo>
                    <a:pt x="1058037" y="124460"/>
                  </a:lnTo>
                  <a:close/>
                </a:path>
                <a:path w="4076700" h="716279">
                  <a:moveTo>
                    <a:pt x="1116063" y="93345"/>
                  </a:moveTo>
                  <a:lnTo>
                    <a:pt x="1105662" y="93345"/>
                  </a:lnTo>
                  <a:lnTo>
                    <a:pt x="1105662" y="716026"/>
                  </a:lnTo>
                  <a:lnTo>
                    <a:pt x="1116063" y="716026"/>
                  </a:lnTo>
                  <a:lnTo>
                    <a:pt x="1116063" y="93345"/>
                  </a:lnTo>
                  <a:close/>
                </a:path>
                <a:path w="4076700" h="716279">
                  <a:moveTo>
                    <a:pt x="1174115" y="186690"/>
                  </a:moveTo>
                  <a:lnTo>
                    <a:pt x="1163701" y="186690"/>
                  </a:lnTo>
                  <a:lnTo>
                    <a:pt x="1163701" y="716026"/>
                  </a:lnTo>
                  <a:lnTo>
                    <a:pt x="1174115" y="716026"/>
                  </a:lnTo>
                  <a:lnTo>
                    <a:pt x="1174115" y="186690"/>
                  </a:lnTo>
                  <a:close/>
                </a:path>
                <a:path w="4076700" h="716279">
                  <a:moveTo>
                    <a:pt x="1232154" y="280162"/>
                  </a:moveTo>
                  <a:lnTo>
                    <a:pt x="1221740" y="280162"/>
                  </a:lnTo>
                  <a:lnTo>
                    <a:pt x="1221740" y="716026"/>
                  </a:lnTo>
                  <a:lnTo>
                    <a:pt x="1232154" y="716026"/>
                  </a:lnTo>
                  <a:lnTo>
                    <a:pt x="1232154" y="280162"/>
                  </a:lnTo>
                  <a:close/>
                </a:path>
                <a:path w="4076700" h="716279">
                  <a:moveTo>
                    <a:pt x="1290193" y="280162"/>
                  </a:moveTo>
                  <a:lnTo>
                    <a:pt x="1279779" y="280162"/>
                  </a:lnTo>
                  <a:lnTo>
                    <a:pt x="1279779" y="716026"/>
                  </a:lnTo>
                  <a:lnTo>
                    <a:pt x="1290193" y="716026"/>
                  </a:lnTo>
                  <a:lnTo>
                    <a:pt x="1290193" y="280162"/>
                  </a:lnTo>
                  <a:close/>
                </a:path>
                <a:path w="4076700" h="716279">
                  <a:moveTo>
                    <a:pt x="1348219" y="249047"/>
                  </a:moveTo>
                  <a:lnTo>
                    <a:pt x="1337818" y="249047"/>
                  </a:lnTo>
                  <a:lnTo>
                    <a:pt x="1337818" y="716026"/>
                  </a:lnTo>
                  <a:lnTo>
                    <a:pt x="1348219" y="716026"/>
                  </a:lnTo>
                  <a:lnTo>
                    <a:pt x="1348219" y="249047"/>
                  </a:lnTo>
                  <a:close/>
                </a:path>
                <a:path w="4076700" h="716279">
                  <a:moveTo>
                    <a:pt x="1406271" y="280162"/>
                  </a:moveTo>
                  <a:lnTo>
                    <a:pt x="1395857" y="280162"/>
                  </a:lnTo>
                  <a:lnTo>
                    <a:pt x="1395857" y="716026"/>
                  </a:lnTo>
                  <a:lnTo>
                    <a:pt x="1406271" y="716026"/>
                  </a:lnTo>
                  <a:lnTo>
                    <a:pt x="1406271" y="280162"/>
                  </a:lnTo>
                  <a:close/>
                </a:path>
                <a:path w="4076700" h="716279">
                  <a:moveTo>
                    <a:pt x="1464437" y="0"/>
                  </a:moveTo>
                  <a:lnTo>
                    <a:pt x="1454023" y="0"/>
                  </a:lnTo>
                  <a:lnTo>
                    <a:pt x="1454023" y="716026"/>
                  </a:lnTo>
                  <a:lnTo>
                    <a:pt x="1464437" y="716026"/>
                  </a:lnTo>
                  <a:lnTo>
                    <a:pt x="1464437" y="0"/>
                  </a:lnTo>
                  <a:close/>
                </a:path>
                <a:path w="4076700" h="716279">
                  <a:moveTo>
                    <a:pt x="1522463" y="217932"/>
                  </a:moveTo>
                  <a:lnTo>
                    <a:pt x="1512062" y="217932"/>
                  </a:lnTo>
                  <a:lnTo>
                    <a:pt x="1512062" y="716026"/>
                  </a:lnTo>
                  <a:lnTo>
                    <a:pt x="1522463" y="716026"/>
                  </a:lnTo>
                  <a:lnTo>
                    <a:pt x="1522463" y="217932"/>
                  </a:lnTo>
                  <a:close/>
                </a:path>
                <a:path w="4076700" h="716279">
                  <a:moveTo>
                    <a:pt x="1580515" y="342392"/>
                  </a:moveTo>
                  <a:lnTo>
                    <a:pt x="1570101" y="342392"/>
                  </a:lnTo>
                  <a:lnTo>
                    <a:pt x="1570101" y="716026"/>
                  </a:lnTo>
                  <a:lnTo>
                    <a:pt x="1580515" y="716026"/>
                  </a:lnTo>
                  <a:lnTo>
                    <a:pt x="1580515" y="342392"/>
                  </a:lnTo>
                  <a:close/>
                </a:path>
                <a:path w="4076700" h="716279">
                  <a:moveTo>
                    <a:pt x="1638554" y="435864"/>
                  </a:moveTo>
                  <a:lnTo>
                    <a:pt x="1628140" y="435864"/>
                  </a:lnTo>
                  <a:lnTo>
                    <a:pt x="1628140" y="716026"/>
                  </a:lnTo>
                  <a:lnTo>
                    <a:pt x="1638554" y="716026"/>
                  </a:lnTo>
                  <a:lnTo>
                    <a:pt x="1638554" y="435864"/>
                  </a:lnTo>
                  <a:close/>
                </a:path>
                <a:path w="4076700" h="716279">
                  <a:moveTo>
                    <a:pt x="1696593" y="311277"/>
                  </a:moveTo>
                  <a:lnTo>
                    <a:pt x="1686179" y="311277"/>
                  </a:lnTo>
                  <a:lnTo>
                    <a:pt x="1686179" y="716026"/>
                  </a:lnTo>
                  <a:lnTo>
                    <a:pt x="1696593" y="716026"/>
                  </a:lnTo>
                  <a:lnTo>
                    <a:pt x="1696593" y="311277"/>
                  </a:lnTo>
                  <a:close/>
                </a:path>
                <a:path w="4076700" h="716279">
                  <a:moveTo>
                    <a:pt x="1754619" y="280162"/>
                  </a:moveTo>
                  <a:lnTo>
                    <a:pt x="1744218" y="280162"/>
                  </a:lnTo>
                  <a:lnTo>
                    <a:pt x="1744218" y="716026"/>
                  </a:lnTo>
                  <a:lnTo>
                    <a:pt x="1754619" y="716026"/>
                  </a:lnTo>
                  <a:lnTo>
                    <a:pt x="1754619" y="280162"/>
                  </a:lnTo>
                  <a:close/>
                </a:path>
                <a:path w="4076700" h="716279">
                  <a:moveTo>
                    <a:pt x="1812671" y="0"/>
                  </a:moveTo>
                  <a:lnTo>
                    <a:pt x="1802257" y="0"/>
                  </a:lnTo>
                  <a:lnTo>
                    <a:pt x="1802257" y="716026"/>
                  </a:lnTo>
                  <a:lnTo>
                    <a:pt x="1812671" y="716026"/>
                  </a:lnTo>
                  <a:lnTo>
                    <a:pt x="1812671" y="0"/>
                  </a:lnTo>
                  <a:close/>
                </a:path>
                <a:path w="4076700" h="716279">
                  <a:moveTo>
                    <a:pt x="1870710" y="155575"/>
                  </a:moveTo>
                  <a:lnTo>
                    <a:pt x="1860296" y="155575"/>
                  </a:lnTo>
                  <a:lnTo>
                    <a:pt x="1860296" y="716026"/>
                  </a:lnTo>
                  <a:lnTo>
                    <a:pt x="1870710" y="716026"/>
                  </a:lnTo>
                  <a:lnTo>
                    <a:pt x="1870710" y="155575"/>
                  </a:lnTo>
                  <a:close/>
                </a:path>
                <a:path w="4076700" h="716279">
                  <a:moveTo>
                    <a:pt x="1928749" y="217932"/>
                  </a:moveTo>
                  <a:lnTo>
                    <a:pt x="1918335" y="217932"/>
                  </a:lnTo>
                  <a:lnTo>
                    <a:pt x="1918335" y="716026"/>
                  </a:lnTo>
                  <a:lnTo>
                    <a:pt x="1928749" y="716026"/>
                  </a:lnTo>
                  <a:lnTo>
                    <a:pt x="1928749" y="217932"/>
                  </a:lnTo>
                  <a:close/>
                </a:path>
                <a:path w="4076700" h="716279">
                  <a:moveTo>
                    <a:pt x="1986915" y="342392"/>
                  </a:moveTo>
                  <a:lnTo>
                    <a:pt x="1976501" y="342392"/>
                  </a:lnTo>
                  <a:lnTo>
                    <a:pt x="1976501" y="716026"/>
                  </a:lnTo>
                  <a:lnTo>
                    <a:pt x="1986915" y="716026"/>
                  </a:lnTo>
                  <a:lnTo>
                    <a:pt x="1986915" y="342392"/>
                  </a:lnTo>
                  <a:close/>
                </a:path>
                <a:path w="4076700" h="716279">
                  <a:moveTo>
                    <a:pt x="2044954" y="280162"/>
                  </a:moveTo>
                  <a:lnTo>
                    <a:pt x="2034540" y="280162"/>
                  </a:lnTo>
                  <a:lnTo>
                    <a:pt x="2034540" y="716026"/>
                  </a:lnTo>
                  <a:lnTo>
                    <a:pt x="2044954" y="716026"/>
                  </a:lnTo>
                  <a:lnTo>
                    <a:pt x="2044954" y="280162"/>
                  </a:lnTo>
                  <a:close/>
                </a:path>
                <a:path w="4076700" h="716279">
                  <a:moveTo>
                    <a:pt x="2102993" y="404622"/>
                  </a:moveTo>
                  <a:lnTo>
                    <a:pt x="2092579" y="404622"/>
                  </a:lnTo>
                  <a:lnTo>
                    <a:pt x="2092579" y="716026"/>
                  </a:lnTo>
                  <a:lnTo>
                    <a:pt x="2102993" y="716026"/>
                  </a:lnTo>
                  <a:lnTo>
                    <a:pt x="2102993" y="404622"/>
                  </a:lnTo>
                  <a:close/>
                </a:path>
                <a:path w="4076700" h="716279">
                  <a:moveTo>
                    <a:pt x="2161032" y="498094"/>
                  </a:moveTo>
                  <a:lnTo>
                    <a:pt x="2150618" y="498094"/>
                  </a:lnTo>
                  <a:lnTo>
                    <a:pt x="2150618" y="716026"/>
                  </a:lnTo>
                  <a:lnTo>
                    <a:pt x="2161032" y="716026"/>
                  </a:lnTo>
                  <a:lnTo>
                    <a:pt x="2161032" y="498094"/>
                  </a:lnTo>
                  <a:close/>
                </a:path>
                <a:path w="4076700" h="716279">
                  <a:moveTo>
                    <a:pt x="2219071" y="342392"/>
                  </a:moveTo>
                  <a:lnTo>
                    <a:pt x="2208657" y="342392"/>
                  </a:lnTo>
                  <a:lnTo>
                    <a:pt x="2208657" y="716026"/>
                  </a:lnTo>
                  <a:lnTo>
                    <a:pt x="2219071" y="716026"/>
                  </a:lnTo>
                  <a:lnTo>
                    <a:pt x="2219071" y="342392"/>
                  </a:lnTo>
                  <a:close/>
                </a:path>
                <a:path w="4076700" h="716279">
                  <a:moveTo>
                    <a:pt x="2277110" y="186690"/>
                  </a:moveTo>
                  <a:lnTo>
                    <a:pt x="2266696" y="186690"/>
                  </a:lnTo>
                  <a:lnTo>
                    <a:pt x="2266696" y="716026"/>
                  </a:lnTo>
                  <a:lnTo>
                    <a:pt x="2277110" y="716026"/>
                  </a:lnTo>
                  <a:lnTo>
                    <a:pt x="2277110" y="186690"/>
                  </a:lnTo>
                  <a:close/>
                </a:path>
                <a:path w="4076700" h="716279">
                  <a:moveTo>
                    <a:pt x="2335149" y="217932"/>
                  </a:moveTo>
                  <a:lnTo>
                    <a:pt x="2324735" y="217932"/>
                  </a:lnTo>
                  <a:lnTo>
                    <a:pt x="2324735" y="716026"/>
                  </a:lnTo>
                  <a:lnTo>
                    <a:pt x="2335149" y="716026"/>
                  </a:lnTo>
                  <a:lnTo>
                    <a:pt x="2335149" y="217932"/>
                  </a:lnTo>
                  <a:close/>
                </a:path>
                <a:path w="4076700" h="716279">
                  <a:moveTo>
                    <a:pt x="2393188" y="155575"/>
                  </a:moveTo>
                  <a:lnTo>
                    <a:pt x="2382774" y="155575"/>
                  </a:lnTo>
                  <a:lnTo>
                    <a:pt x="2382774" y="716026"/>
                  </a:lnTo>
                  <a:lnTo>
                    <a:pt x="2393188" y="716026"/>
                  </a:lnTo>
                  <a:lnTo>
                    <a:pt x="2393188" y="155575"/>
                  </a:lnTo>
                  <a:close/>
                </a:path>
                <a:path w="4076700" h="716279">
                  <a:moveTo>
                    <a:pt x="2451227" y="498094"/>
                  </a:moveTo>
                  <a:lnTo>
                    <a:pt x="2440813" y="498094"/>
                  </a:lnTo>
                  <a:lnTo>
                    <a:pt x="2440813" y="716026"/>
                  </a:lnTo>
                  <a:lnTo>
                    <a:pt x="2451227" y="716026"/>
                  </a:lnTo>
                  <a:lnTo>
                    <a:pt x="2451227" y="498094"/>
                  </a:lnTo>
                  <a:close/>
                </a:path>
                <a:path w="4076700" h="716279">
                  <a:moveTo>
                    <a:pt x="2509393" y="404622"/>
                  </a:moveTo>
                  <a:lnTo>
                    <a:pt x="2498979" y="404622"/>
                  </a:lnTo>
                  <a:lnTo>
                    <a:pt x="2498979" y="716026"/>
                  </a:lnTo>
                  <a:lnTo>
                    <a:pt x="2509393" y="716026"/>
                  </a:lnTo>
                  <a:lnTo>
                    <a:pt x="2509393" y="404622"/>
                  </a:lnTo>
                  <a:close/>
                </a:path>
                <a:path w="4076700" h="716279">
                  <a:moveTo>
                    <a:pt x="2567432" y="217932"/>
                  </a:moveTo>
                  <a:lnTo>
                    <a:pt x="2557018" y="217932"/>
                  </a:lnTo>
                  <a:lnTo>
                    <a:pt x="2557018" y="716026"/>
                  </a:lnTo>
                  <a:lnTo>
                    <a:pt x="2567432" y="716026"/>
                  </a:lnTo>
                  <a:lnTo>
                    <a:pt x="2567432" y="217932"/>
                  </a:lnTo>
                  <a:close/>
                </a:path>
                <a:path w="4076700" h="716279">
                  <a:moveTo>
                    <a:pt x="2625471" y="466979"/>
                  </a:moveTo>
                  <a:lnTo>
                    <a:pt x="2615057" y="466979"/>
                  </a:lnTo>
                  <a:lnTo>
                    <a:pt x="2615057" y="716026"/>
                  </a:lnTo>
                  <a:lnTo>
                    <a:pt x="2625471" y="716026"/>
                  </a:lnTo>
                  <a:lnTo>
                    <a:pt x="2625471" y="466979"/>
                  </a:lnTo>
                  <a:close/>
                </a:path>
                <a:path w="4076700" h="716279">
                  <a:moveTo>
                    <a:pt x="2683510" y="373507"/>
                  </a:moveTo>
                  <a:lnTo>
                    <a:pt x="2673096" y="373507"/>
                  </a:lnTo>
                  <a:lnTo>
                    <a:pt x="2673096" y="716026"/>
                  </a:lnTo>
                  <a:lnTo>
                    <a:pt x="2683510" y="716026"/>
                  </a:lnTo>
                  <a:lnTo>
                    <a:pt x="2683510" y="373507"/>
                  </a:lnTo>
                  <a:close/>
                </a:path>
                <a:path w="4076700" h="716279">
                  <a:moveTo>
                    <a:pt x="2741549" y="342392"/>
                  </a:moveTo>
                  <a:lnTo>
                    <a:pt x="2731135" y="342392"/>
                  </a:lnTo>
                  <a:lnTo>
                    <a:pt x="2731135" y="716026"/>
                  </a:lnTo>
                  <a:lnTo>
                    <a:pt x="2741549" y="716026"/>
                  </a:lnTo>
                  <a:lnTo>
                    <a:pt x="2741549" y="342392"/>
                  </a:lnTo>
                  <a:close/>
                </a:path>
                <a:path w="4076700" h="716279">
                  <a:moveTo>
                    <a:pt x="2799588" y="342392"/>
                  </a:moveTo>
                  <a:lnTo>
                    <a:pt x="2789174" y="342392"/>
                  </a:lnTo>
                  <a:lnTo>
                    <a:pt x="2789174" y="716026"/>
                  </a:lnTo>
                  <a:lnTo>
                    <a:pt x="2799588" y="716026"/>
                  </a:lnTo>
                  <a:lnTo>
                    <a:pt x="2799588" y="342392"/>
                  </a:lnTo>
                  <a:close/>
                </a:path>
                <a:path w="4076700" h="716279">
                  <a:moveTo>
                    <a:pt x="2857627" y="155575"/>
                  </a:moveTo>
                  <a:lnTo>
                    <a:pt x="2847213" y="155575"/>
                  </a:lnTo>
                  <a:lnTo>
                    <a:pt x="2847213" y="716026"/>
                  </a:lnTo>
                  <a:lnTo>
                    <a:pt x="2857627" y="716026"/>
                  </a:lnTo>
                  <a:lnTo>
                    <a:pt x="2857627" y="155575"/>
                  </a:lnTo>
                  <a:close/>
                </a:path>
                <a:path w="4076700" h="716279">
                  <a:moveTo>
                    <a:pt x="2915653" y="311277"/>
                  </a:moveTo>
                  <a:lnTo>
                    <a:pt x="2905252" y="311277"/>
                  </a:lnTo>
                  <a:lnTo>
                    <a:pt x="2905252" y="716026"/>
                  </a:lnTo>
                  <a:lnTo>
                    <a:pt x="2915653" y="716026"/>
                  </a:lnTo>
                  <a:lnTo>
                    <a:pt x="2915653" y="311277"/>
                  </a:lnTo>
                  <a:close/>
                </a:path>
                <a:path w="4076700" h="716279">
                  <a:moveTo>
                    <a:pt x="2973705" y="186690"/>
                  </a:moveTo>
                  <a:lnTo>
                    <a:pt x="2963291" y="186690"/>
                  </a:lnTo>
                  <a:lnTo>
                    <a:pt x="2963291" y="716026"/>
                  </a:lnTo>
                  <a:lnTo>
                    <a:pt x="2973705" y="716026"/>
                  </a:lnTo>
                  <a:lnTo>
                    <a:pt x="2973705" y="186690"/>
                  </a:lnTo>
                  <a:close/>
                </a:path>
                <a:path w="4076700" h="716279">
                  <a:moveTo>
                    <a:pt x="3031744" y="280162"/>
                  </a:moveTo>
                  <a:lnTo>
                    <a:pt x="3021330" y="280162"/>
                  </a:lnTo>
                  <a:lnTo>
                    <a:pt x="3021330" y="716026"/>
                  </a:lnTo>
                  <a:lnTo>
                    <a:pt x="3031744" y="716026"/>
                  </a:lnTo>
                  <a:lnTo>
                    <a:pt x="3031744" y="280162"/>
                  </a:lnTo>
                  <a:close/>
                </a:path>
                <a:path w="4076700" h="716279">
                  <a:moveTo>
                    <a:pt x="3089910" y="498094"/>
                  </a:moveTo>
                  <a:lnTo>
                    <a:pt x="3079496" y="498094"/>
                  </a:lnTo>
                  <a:lnTo>
                    <a:pt x="3079496" y="716026"/>
                  </a:lnTo>
                  <a:lnTo>
                    <a:pt x="3089910" y="716026"/>
                  </a:lnTo>
                  <a:lnTo>
                    <a:pt x="3089910" y="498094"/>
                  </a:lnTo>
                  <a:close/>
                </a:path>
                <a:path w="4076700" h="716279">
                  <a:moveTo>
                    <a:pt x="3147949" y="373507"/>
                  </a:moveTo>
                  <a:lnTo>
                    <a:pt x="3137535" y="373507"/>
                  </a:lnTo>
                  <a:lnTo>
                    <a:pt x="3137535" y="716026"/>
                  </a:lnTo>
                  <a:lnTo>
                    <a:pt x="3147949" y="716026"/>
                  </a:lnTo>
                  <a:lnTo>
                    <a:pt x="3147949" y="373507"/>
                  </a:lnTo>
                  <a:close/>
                </a:path>
                <a:path w="4076700" h="716279">
                  <a:moveTo>
                    <a:pt x="3205988" y="311277"/>
                  </a:moveTo>
                  <a:lnTo>
                    <a:pt x="3195574" y="311277"/>
                  </a:lnTo>
                  <a:lnTo>
                    <a:pt x="3195574" y="716026"/>
                  </a:lnTo>
                  <a:lnTo>
                    <a:pt x="3205988" y="716026"/>
                  </a:lnTo>
                  <a:lnTo>
                    <a:pt x="3205988" y="311277"/>
                  </a:lnTo>
                  <a:close/>
                </a:path>
                <a:path w="4076700" h="716279">
                  <a:moveTo>
                    <a:pt x="3264027" y="311277"/>
                  </a:moveTo>
                  <a:lnTo>
                    <a:pt x="3253613" y="311277"/>
                  </a:lnTo>
                  <a:lnTo>
                    <a:pt x="3253613" y="716026"/>
                  </a:lnTo>
                  <a:lnTo>
                    <a:pt x="3264027" y="716026"/>
                  </a:lnTo>
                  <a:lnTo>
                    <a:pt x="3264027" y="311277"/>
                  </a:lnTo>
                  <a:close/>
                </a:path>
                <a:path w="4076700" h="716279">
                  <a:moveTo>
                    <a:pt x="3322053" y="498094"/>
                  </a:moveTo>
                  <a:lnTo>
                    <a:pt x="3311652" y="498094"/>
                  </a:lnTo>
                  <a:lnTo>
                    <a:pt x="3311652" y="716026"/>
                  </a:lnTo>
                  <a:lnTo>
                    <a:pt x="3322053" y="716026"/>
                  </a:lnTo>
                  <a:lnTo>
                    <a:pt x="3322053" y="498094"/>
                  </a:lnTo>
                  <a:close/>
                </a:path>
                <a:path w="4076700" h="716279">
                  <a:moveTo>
                    <a:pt x="3380105" y="217932"/>
                  </a:moveTo>
                  <a:lnTo>
                    <a:pt x="3369691" y="217932"/>
                  </a:lnTo>
                  <a:lnTo>
                    <a:pt x="3369691" y="716026"/>
                  </a:lnTo>
                  <a:lnTo>
                    <a:pt x="3380105" y="716026"/>
                  </a:lnTo>
                  <a:lnTo>
                    <a:pt x="3380105" y="217932"/>
                  </a:lnTo>
                  <a:close/>
                </a:path>
                <a:path w="4076700" h="716279">
                  <a:moveTo>
                    <a:pt x="3438144" y="311277"/>
                  </a:moveTo>
                  <a:lnTo>
                    <a:pt x="3427730" y="311277"/>
                  </a:lnTo>
                  <a:lnTo>
                    <a:pt x="3427730" y="716026"/>
                  </a:lnTo>
                  <a:lnTo>
                    <a:pt x="3438144" y="716026"/>
                  </a:lnTo>
                  <a:lnTo>
                    <a:pt x="3438144" y="311277"/>
                  </a:lnTo>
                  <a:close/>
                </a:path>
                <a:path w="4076700" h="716279">
                  <a:moveTo>
                    <a:pt x="3496183" y="311277"/>
                  </a:moveTo>
                  <a:lnTo>
                    <a:pt x="3485769" y="311277"/>
                  </a:lnTo>
                  <a:lnTo>
                    <a:pt x="3485769" y="716026"/>
                  </a:lnTo>
                  <a:lnTo>
                    <a:pt x="3496183" y="716026"/>
                  </a:lnTo>
                  <a:lnTo>
                    <a:pt x="3496183" y="311277"/>
                  </a:lnTo>
                  <a:close/>
                </a:path>
                <a:path w="4076700" h="716279">
                  <a:moveTo>
                    <a:pt x="3554222" y="311277"/>
                  </a:moveTo>
                  <a:lnTo>
                    <a:pt x="3543808" y="311277"/>
                  </a:lnTo>
                  <a:lnTo>
                    <a:pt x="3543808" y="716026"/>
                  </a:lnTo>
                  <a:lnTo>
                    <a:pt x="3554222" y="716026"/>
                  </a:lnTo>
                  <a:lnTo>
                    <a:pt x="3554222" y="311277"/>
                  </a:lnTo>
                  <a:close/>
                </a:path>
                <a:path w="4076700" h="716279">
                  <a:moveTo>
                    <a:pt x="3612388" y="591439"/>
                  </a:moveTo>
                  <a:lnTo>
                    <a:pt x="3601974" y="591439"/>
                  </a:lnTo>
                  <a:lnTo>
                    <a:pt x="3601974" y="716026"/>
                  </a:lnTo>
                  <a:lnTo>
                    <a:pt x="3612388" y="716026"/>
                  </a:lnTo>
                  <a:lnTo>
                    <a:pt x="3612388" y="591439"/>
                  </a:lnTo>
                  <a:close/>
                </a:path>
                <a:path w="4076700" h="716279">
                  <a:moveTo>
                    <a:pt x="3670427" y="217932"/>
                  </a:moveTo>
                  <a:lnTo>
                    <a:pt x="3660013" y="217932"/>
                  </a:lnTo>
                  <a:lnTo>
                    <a:pt x="3660013" y="716026"/>
                  </a:lnTo>
                  <a:lnTo>
                    <a:pt x="3670427" y="716026"/>
                  </a:lnTo>
                  <a:lnTo>
                    <a:pt x="3670427" y="217932"/>
                  </a:lnTo>
                  <a:close/>
                </a:path>
                <a:path w="4076700" h="716279">
                  <a:moveTo>
                    <a:pt x="3728453" y="498094"/>
                  </a:moveTo>
                  <a:lnTo>
                    <a:pt x="3718052" y="498094"/>
                  </a:lnTo>
                  <a:lnTo>
                    <a:pt x="3718052" y="716026"/>
                  </a:lnTo>
                  <a:lnTo>
                    <a:pt x="3728453" y="716026"/>
                  </a:lnTo>
                  <a:lnTo>
                    <a:pt x="3728453" y="498094"/>
                  </a:lnTo>
                  <a:close/>
                </a:path>
                <a:path w="4076700" h="716279">
                  <a:moveTo>
                    <a:pt x="3786505" y="529209"/>
                  </a:moveTo>
                  <a:lnTo>
                    <a:pt x="3776091" y="529209"/>
                  </a:lnTo>
                  <a:lnTo>
                    <a:pt x="3776091" y="716026"/>
                  </a:lnTo>
                  <a:lnTo>
                    <a:pt x="3786505" y="716026"/>
                  </a:lnTo>
                  <a:lnTo>
                    <a:pt x="3786505" y="529209"/>
                  </a:lnTo>
                  <a:close/>
                </a:path>
                <a:path w="4076700" h="716279">
                  <a:moveTo>
                    <a:pt x="3844544" y="280162"/>
                  </a:moveTo>
                  <a:lnTo>
                    <a:pt x="3834130" y="280162"/>
                  </a:lnTo>
                  <a:lnTo>
                    <a:pt x="3834130" y="716026"/>
                  </a:lnTo>
                  <a:lnTo>
                    <a:pt x="3844544" y="716026"/>
                  </a:lnTo>
                  <a:lnTo>
                    <a:pt x="3844544" y="280162"/>
                  </a:lnTo>
                  <a:close/>
                </a:path>
                <a:path w="4076700" h="716279">
                  <a:moveTo>
                    <a:pt x="3902583" y="311277"/>
                  </a:moveTo>
                  <a:lnTo>
                    <a:pt x="3892169" y="311277"/>
                  </a:lnTo>
                  <a:lnTo>
                    <a:pt x="3892169" y="716026"/>
                  </a:lnTo>
                  <a:lnTo>
                    <a:pt x="3902583" y="716026"/>
                  </a:lnTo>
                  <a:lnTo>
                    <a:pt x="3902583" y="311277"/>
                  </a:lnTo>
                  <a:close/>
                </a:path>
                <a:path w="4076700" h="716279">
                  <a:moveTo>
                    <a:pt x="3960622" y="404622"/>
                  </a:moveTo>
                  <a:lnTo>
                    <a:pt x="3950208" y="404622"/>
                  </a:lnTo>
                  <a:lnTo>
                    <a:pt x="3950208" y="716026"/>
                  </a:lnTo>
                  <a:lnTo>
                    <a:pt x="3960622" y="716026"/>
                  </a:lnTo>
                  <a:lnTo>
                    <a:pt x="3960622" y="404622"/>
                  </a:lnTo>
                  <a:close/>
                </a:path>
                <a:path w="4076700" h="716279">
                  <a:moveTo>
                    <a:pt x="4018661" y="404622"/>
                  </a:moveTo>
                  <a:lnTo>
                    <a:pt x="4008247" y="404622"/>
                  </a:lnTo>
                  <a:lnTo>
                    <a:pt x="4008247" y="716026"/>
                  </a:lnTo>
                  <a:lnTo>
                    <a:pt x="4018661" y="716026"/>
                  </a:lnTo>
                  <a:lnTo>
                    <a:pt x="4018661" y="404622"/>
                  </a:lnTo>
                  <a:close/>
                </a:path>
                <a:path w="4076700" h="716279">
                  <a:moveTo>
                    <a:pt x="4076700" y="311277"/>
                  </a:moveTo>
                  <a:lnTo>
                    <a:pt x="4066286" y="311277"/>
                  </a:lnTo>
                  <a:lnTo>
                    <a:pt x="4066286" y="716026"/>
                  </a:lnTo>
                  <a:lnTo>
                    <a:pt x="4076700" y="716026"/>
                  </a:lnTo>
                  <a:lnTo>
                    <a:pt x="4076700" y="311277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7" name="object 127" descr=""/>
            <p:cNvSpPr/>
            <p:nvPr/>
          </p:nvSpPr>
          <p:spPr>
            <a:xfrm>
              <a:off x="5230114" y="7884033"/>
              <a:ext cx="4074160" cy="778510"/>
            </a:xfrm>
            <a:custGeom>
              <a:avLst/>
              <a:gdLst/>
              <a:ahLst/>
              <a:cxnLst/>
              <a:rect l="l" t="t" r="r" b="b"/>
              <a:pathLst>
                <a:path w="4074159" h="778509">
                  <a:moveTo>
                    <a:pt x="10414" y="373634"/>
                  </a:moveTo>
                  <a:lnTo>
                    <a:pt x="0" y="373634"/>
                  </a:lnTo>
                  <a:lnTo>
                    <a:pt x="0" y="778383"/>
                  </a:lnTo>
                  <a:lnTo>
                    <a:pt x="10414" y="778383"/>
                  </a:lnTo>
                  <a:lnTo>
                    <a:pt x="10414" y="373634"/>
                  </a:lnTo>
                  <a:close/>
                </a:path>
                <a:path w="4074159" h="778509">
                  <a:moveTo>
                    <a:pt x="68567" y="466979"/>
                  </a:moveTo>
                  <a:lnTo>
                    <a:pt x="58166" y="466979"/>
                  </a:lnTo>
                  <a:lnTo>
                    <a:pt x="58166" y="778383"/>
                  </a:lnTo>
                  <a:lnTo>
                    <a:pt x="68567" y="778383"/>
                  </a:lnTo>
                  <a:lnTo>
                    <a:pt x="68567" y="466979"/>
                  </a:lnTo>
                  <a:close/>
                </a:path>
                <a:path w="4074159" h="778509">
                  <a:moveTo>
                    <a:pt x="126619" y="529336"/>
                  </a:moveTo>
                  <a:lnTo>
                    <a:pt x="116205" y="529336"/>
                  </a:lnTo>
                  <a:lnTo>
                    <a:pt x="116205" y="778383"/>
                  </a:lnTo>
                  <a:lnTo>
                    <a:pt x="126619" y="778383"/>
                  </a:lnTo>
                  <a:lnTo>
                    <a:pt x="126619" y="529336"/>
                  </a:lnTo>
                  <a:close/>
                </a:path>
                <a:path w="4074159" h="778509">
                  <a:moveTo>
                    <a:pt x="184658" y="435864"/>
                  </a:moveTo>
                  <a:lnTo>
                    <a:pt x="174244" y="435864"/>
                  </a:lnTo>
                  <a:lnTo>
                    <a:pt x="174244" y="778383"/>
                  </a:lnTo>
                  <a:lnTo>
                    <a:pt x="184658" y="778383"/>
                  </a:lnTo>
                  <a:lnTo>
                    <a:pt x="184658" y="435864"/>
                  </a:lnTo>
                  <a:close/>
                </a:path>
                <a:path w="4074159" h="778509">
                  <a:moveTo>
                    <a:pt x="242697" y="529336"/>
                  </a:moveTo>
                  <a:lnTo>
                    <a:pt x="232283" y="529336"/>
                  </a:lnTo>
                  <a:lnTo>
                    <a:pt x="232283" y="778383"/>
                  </a:lnTo>
                  <a:lnTo>
                    <a:pt x="242697" y="778383"/>
                  </a:lnTo>
                  <a:lnTo>
                    <a:pt x="242697" y="529336"/>
                  </a:lnTo>
                  <a:close/>
                </a:path>
                <a:path w="4074159" h="778509">
                  <a:moveTo>
                    <a:pt x="300736" y="186817"/>
                  </a:moveTo>
                  <a:lnTo>
                    <a:pt x="290322" y="186817"/>
                  </a:lnTo>
                  <a:lnTo>
                    <a:pt x="290322" y="778383"/>
                  </a:lnTo>
                  <a:lnTo>
                    <a:pt x="300736" y="778383"/>
                  </a:lnTo>
                  <a:lnTo>
                    <a:pt x="300736" y="186817"/>
                  </a:lnTo>
                  <a:close/>
                </a:path>
                <a:path w="4074159" h="778509">
                  <a:moveTo>
                    <a:pt x="358775" y="466979"/>
                  </a:moveTo>
                  <a:lnTo>
                    <a:pt x="348361" y="466979"/>
                  </a:lnTo>
                  <a:lnTo>
                    <a:pt x="348361" y="778383"/>
                  </a:lnTo>
                  <a:lnTo>
                    <a:pt x="358775" y="778383"/>
                  </a:lnTo>
                  <a:lnTo>
                    <a:pt x="358775" y="466979"/>
                  </a:lnTo>
                  <a:close/>
                </a:path>
                <a:path w="4074159" h="778509">
                  <a:moveTo>
                    <a:pt x="416814" y="466979"/>
                  </a:moveTo>
                  <a:lnTo>
                    <a:pt x="406400" y="466979"/>
                  </a:lnTo>
                  <a:lnTo>
                    <a:pt x="406400" y="778383"/>
                  </a:lnTo>
                  <a:lnTo>
                    <a:pt x="416814" y="778383"/>
                  </a:lnTo>
                  <a:lnTo>
                    <a:pt x="416814" y="466979"/>
                  </a:lnTo>
                  <a:close/>
                </a:path>
                <a:path w="4074159" h="778509">
                  <a:moveTo>
                    <a:pt x="474853" y="311404"/>
                  </a:moveTo>
                  <a:lnTo>
                    <a:pt x="464439" y="311404"/>
                  </a:lnTo>
                  <a:lnTo>
                    <a:pt x="464439" y="778383"/>
                  </a:lnTo>
                  <a:lnTo>
                    <a:pt x="474853" y="778383"/>
                  </a:lnTo>
                  <a:lnTo>
                    <a:pt x="474853" y="311404"/>
                  </a:lnTo>
                  <a:close/>
                </a:path>
                <a:path w="4074159" h="778509">
                  <a:moveTo>
                    <a:pt x="532892" y="373634"/>
                  </a:moveTo>
                  <a:lnTo>
                    <a:pt x="522478" y="373634"/>
                  </a:lnTo>
                  <a:lnTo>
                    <a:pt x="522478" y="778383"/>
                  </a:lnTo>
                  <a:lnTo>
                    <a:pt x="532892" y="778383"/>
                  </a:lnTo>
                  <a:lnTo>
                    <a:pt x="532892" y="373634"/>
                  </a:lnTo>
                  <a:close/>
                </a:path>
                <a:path w="4074159" h="778509">
                  <a:moveTo>
                    <a:pt x="590918" y="404749"/>
                  </a:moveTo>
                  <a:lnTo>
                    <a:pt x="580517" y="404749"/>
                  </a:lnTo>
                  <a:lnTo>
                    <a:pt x="580517" y="778383"/>
                  </a:lnTo>
                  <a:lnTo>
                    <a:pt x="590918" y="778383"/>
                  </a:lnTo>
                  <a:lnTo>
                    <a:pt x="590918" y="404749"/>
                  </a:lnTo>
                  <a:close/>
                </a:path>
                <a:path w="4074159" h="778509">
                  <a:moveTo>
                    <a:pt x="649097" y="498221"/>
                  </a:moveTo>
                  <a:lnTo>
                    <a:pt x="638683" y="498221"/>
                  </a:lnTo>
                  <a:lnTo>
                    <a:pt x="638683" y="778383"/>
                  </a:lnTo>
                  <a:lnTo>
                    <a:pt x="649097" y="778383"/>
                  </a:lnTo>
                  <a:lnTo>
                    <a:pt x="649097" y="498221"/>
                  </a:lnTo>
                  <a:close/>
                </a:path>
                <a:path w="4074159" h="778509">
                  <a:moveTo>
                    <a:pt x="707136" y="342519"/>
                  </a:moveTo>
                  <a:lnTo>
                    <a:pt x="696722" y="342519"/>
                  </a:lnTo>
                  <a:lnTo>
                    <a:pt x="696722" y="778383"/>
                  </a:lnTo>
                  <a:lnTo>
                    <a:pt x="707136" y="778383"/>
                  </a:lnTo>
                  <a:lnTo>
                    <a:pt x="707136" y="342519"/>
                  </a:lnTo>
                  <a:close/>
                </a:path>
                <a:path w="4074159" h="778509">
                  <a:moveTo>
                    <a:pt x="765175" y="373634"/>
                  </a:moveTo>
                  <a:lnTo>
                    <a:pt x="754761" y="373634"/>
                  </a:lnTo>
                  <a:lnTo>
                    <a:pt x="754761" y="778383"/>
                  </a:lnTo>
                  <a:lnTo>
                    <a:pt x="765175" y="778383"/>
                  </a:lnTo>
                  <a:lnTo>
                    <a:pt x="765175" y="373634"/>
                  </a:lnTo>
                  <a:close/>
                </a:path>
                <a:path w="4074159" h="778509">
                  <a:moveTo>
                    <a:pt x="823214" y="373634"/>
                  </a:moveTo>
                  <a:lnTo>
                    <a:pt x="812800" y="373634"/>
                  </a:lnTo>
                  <a:lnTo>
                    <a:pt x="812800" y="778383"/>
                  </a:lnTo>
                  <a:lnTo>
                    <a:pt x="823214" y="778383"/>
                  </a:lnTo>
                  <a:lnTo>
                    <a:pt x="823214" y="373634"/>
                  </a:lnTo>
                  <a:close/>
                </a:path>
                <a:path w="4074159" h="778509">
                  <a:moveTo>
                    <a:pt x="881253" y="466979"/>
                  </a:moveTo>
                  <a:lnTo>
                    <a:pt x="870839" y="466979"/>
                  </a:lnTo>
                  <a:lnTo>
                    <a:pt x="870839" y="778383"/>
                  </a:lnTo>
                  <a:lnTo>
                    <a:pt x="881253" y="778383"/>
                  </a:lnTo>
                  <a:lnTo>
                    <a:pt x="881253" y="466979"/>
                  </a:lnTo>
                  <a:close/>
                </a:path>
                <a:path w="4074159" h="778509">
                  <a:moveTo>
                    <a:pt x="939292" y="435864"/>
                  </a:moveTo>
                  <a:lnTo>
                    <a:pt x="928878" y="435864"/>
                  </a:lnTo>
                  <a:lnTo>
                    <a:pt x="928878" y="778383"/>
                  </a:lnTo>
                  <a:lnTo>
                    <a:pt x="939292" y="778383"/>
                  </a:lnTo>
                  <a:lnTo>
                    <a:pt x="939292" y="435864"/>
                  </a:lnTo>
                  <a:close/>
                </a:path>
                <a:path w="4074159" h="778509">
                  <a:moveTo>
                    <a:pt x="997318" y="435864"/>
                  </a:moveTo>
                  <a:lnTo>
                    <a:pt x="986917" y="435864"/>
                  </a:lnTo>
                  <a:lnTo>
                    <a:pt x="986917" y="778383"/>
                  </a:lnTo>
                  <a:lnTo>
                    <a:pt x="997318" y="778383"/>
                  </a:lnTo>
                  <a:lnTo>
                    <a:pt x="997318" y="435864"/>
                  </a:lnTo>
                  <a:close/>
                </a:path>
                <a:path w="4074159" h="778509">
                  <a:moveTo>
                    <a:pt x="1055370" y="404749"/>
                  </a:moveTo>
                  <a:lnTo>
                    <a:pt x="1044956" y="404749"/>
                  </a:lnTo>
                  <a:lnTo>
                    <a:pt x="1044956" y="778383"/>
                  </a:lnTo>
                  <a:lnTo>
                    <a:pt x="1055370" y="778383"/>
                  </a:lnTo>
                  <a:lnTo>
                    <a:pt x="1055370" y="404749"/>
                  </a:lnTo>
                  <a:close/>
                </a:path>
                <a:path w="4074159" h="778509">
                  <a:moveTo>
                    <a:pt x="1113409" y="529336"/>
                  </a:moveTo>
                  <a:lnTo>
                    <a:pt x="1102995" y="529336"/>
                  </a:lnTo>
                  <a:lnTo>
                    <a:pt x="1102995" y="778383"/>
                  </a:lnTo>
                  <a:lnTo>
                    <a:pt x="1113409" y="778383"/>
                  </a:lnTo>
                  <a:lnTo>
                    <a:pt x="1113409" y="529336"/>
                  </a:lnTo>
                  <a:close/>
                </a:path>
                <a:path w="4074159" h="778509">
                  <a:moveTo>
                    <a:pt x="1171575" y="498221"/>
                  </a:moveTo>
                  <a:lnTo>
                    <a:pt x="1161161" y="498221"/>
                  </a:lnTo>
                  <a:lnTo>
                    <a:pt x="1161161" y="778383"/>
                  </a:lnTo>
                  <a:lnTo>
                    <a:pt x="1171575" y="778383"/>
                  </a:lnTo>
                  <a:lnTo>
                    <a:pt x="1171575" y="498221"/>
                  </a:lnTo>
                  <a:close/>
                </a:path>
                <a:path w="4074159" h="778509">
                  <a:moveTo>
                    <a:pt x="1229614" y="0"/>
                  </a:moveTo>
                  <a:lnTo>
                    <a:pt x="1219200" y="0"/>
                  </a:lnTo>
                  <a:lnTo>
                    <a:pt x="1219200" y="778383"/>
                  </a:lnTo>
                  <a:lnTo>
                    <a:pt x="1229614" y="778383"/>
                  </a:lnTo>
                  <a:lnTo>
                    <a:pt x="1229614" y="0"/>
                  </a:lnTo>
                  <a:close/>
                </a:path>
                <a:path w="4074159" h="778509">
                  <a:moveTo>
                    <a:pt x="1287653" y="498221"/>
                  </a:moveTo>
                  <a:lnTo>
                    <a:pt x="1277239" y="498221"/>
                  </a:lnTo>
                  <a:lnTo>
                    <a:pt x="1277239" y="778383"/>
                  </a:lnTo>
                  <a:lnTo>
                    <a:pt x="1287653" y="778383"/>
                  </a:lnTo>
                  <a:lnTo>
                    <a:pt x="1287653" y="498221"/>
                  </a:lnTo>
                  <a:close/>
                </a:path>
                <a:path w="4074159" h="778509">
                  <a:moveTo>
                    <a:pt x="1345692" y="466979"/>
                  </a:moveTo>
                  <a:lnTo>
                    <a:pt x="1335278" y="466979"/>
                  </a:lnTo>
                  <a:lnTo>
                    <a:pt x="1335278" y="778383"/>
                  </a:lnTo>
                  <a:lnTo>
                    <a:pt x="1345692" y="778383"/>
                  </a:lnTo>
                  <a:lnTo>
                    <a:pt x="1345692" y="466979"/>
                  </a:lnTo>
                  <a:close/>
                </a:path>
                <a:path w="4074159" h="778509">
                  <a:moveTo>
                    <a:pt x="1403731" y="529336"/>
                  </a:moveTo>
                  <a:lnTo>
                    <a:pt x="1393317" y="529336"/>
                  </a:lnTo>
                  <a:lnTo>
                    <a:pt x="1393317" y="778383"/>
                  </a:lnTo>
                  <a:lnTo>
                    <a:pt x="1403731" y="778383"/>
                  </a:lnTo>
                  <a:lnTo>
                    <a:pt x="1403731" y="529336"/>
                  </a:lnTo>
                  <a:close/>
                </a:path>
                <a:path w="4074159" h="778509">
                  <a:moveTo>
                    <a:pt x="1461770" y="498221"/>
                  </a:moveTo>
                  <a:lnTo>
                    <a:pt x="1451356" y="498221"/>
                  </a:lnTo>
                  <a:lnTo>
                    <a:pt x="1451356" y="778383"/>
                  </a:lnTo>
                  <a:lnTo>
                    <a:pt x="1461770" y="778383"/>
                  </a:lnTo>
                  <a:lnTo>
                    <a:pt x="1461770" y="498221"/>
                  </a:lnTo>
                  <a:close/>
                </a:path>
                <a:path w="4074159" h="778509">
                  <a:moveTo>
                    <a:pt x="1519809" y="498221"/>
                  </a:moveTo>
                  <a:lnTo>
                    <a:pt x="1509395" y="498221"/>
                  </a:lnTo>
                  <a:lnTo>
                    <a:pt x="1509395" y="778383"/>
                  </a:lnTo>
                  <a:lnTo>
                    <a:pt x="1519809" y="778383"/>
                  </a:lnTo>
                  <a:lnTo>
                    <a:pt x="1519809" y="498221"/>
                  </a:lnTo>
                  <a:close/>
                </a:path>
                <a:path w="4074159" h="778509">
                  <a:moveTo>
                    <a:pt x="1577848" y="466979"/>
                  </a:moveTo>
                  <a:lnTo>
                    <a:pt x="1567434" y="466979"/>
                  </a:lnTo>
                  <a:lnTo>
                    <a:pt x="1567434" y="778383"/>
                  </a:lnTo>
                  <a:lnTo>
                    <a:pt x="1577848" y="778383"/>
                  </a:lnTo>
                  <a:lnTo>
                    <a:pt x="1577848" y="466979"/>
                  </a:lnTo>
                  <a:close/>
                </a:path>
                <a:path w="4074159" h="778509">
                  <a:moveTo>
                    <a:pt x="1635887" y="560451"/>
                  </a:moveTo>
                  <a:lnTo>
                    <a:pt x="1625473" y="560451"/>
                  </a:lnTo>
                  <a:lnTo>
                    <a:pt x="1625473" y="778383"/>
                  </a:lnTo>
                  <a:lnTo>
                    <a:pt x="1635887" y="778383"/>
                  </a:lnTo>
                  <a:lnTo>
                    <a:pt x="1635887" y="560451"/>
                  </a:lnTo>
                  <a:close/>
                </a:path>
                <a:path w="4074159" h="778509">
                  <a:moveTo>
                    <a:pt x="1694053" y="342519"/>
                  </a:moveTo>
                  <a:lnTo>
                    <a:pt x="1683639" y="342519"/>
                  </a:lnTo>
                  <a:lnTo>
                    <a:pt x="1683639" y="778383"/>
                  </a:lnTo>
                  <a:lnTo>
                    <a:pt x="1694053" y="778383"/>
                  </a:lnTo>
                  <a:lnTo>
                    <a:pt x="1694053" y="342519"/>
                  </a:lnTo>
                  <a:close/>
                </a:path>
                <a:path w="4074159" h="778509">
                  <a:moveTo>
                    <a:pt x="1752092" y="404749"/>
                  </a:moveTo>
                  <a:lnTo>
                    <a:pt x="1741678" y="404749"/>
                  </a:lnTo>
                  <a:lnTo>
                    <a:pt x="1741678" y="778383"/>
                  </a:lnTo>
                  <a:lnTo>
                    <a:pt x="1752092" y="778383"/>
                  </a:lnTo>
                  <a:lnTo>
                    <a:pt x="1752092" y="404749"/>
                  </a:lnTo>
                  <a:close/>
                </a:path>
                <a:path w="4074159" h="778509">
                  <a:moveTo>
                    <a:pt x="1810131" y="591566"/>
                  </a:moveTo>
                  <a:lnTo>
                    <a:pt x="1799717" y="591566"/>
                  </a:lnTo>
                  <a:lnTo>
                    <a:pt x="1799717" y="778383"/>
                  </a:lnTo>
                  <a:lnTo>
                    <a:pt x="1810131" y="778383"/>
                  </a:lnTo>
                  <a:lnTo>
                    <a:pt x="1810131" y="591566"/>
                  </a:lnTo>
                  <a:close/>
                </a:path>
                <a:path w="4074159" h="778509">
                  <a:moveTo>
                    <a:pt x="1868170" y="466979"/>
                  </a:moveTo>
                  <a:lnTo>
                    <a:pt x="1857756" y="466979"/>
                  </a:lnTo>
                  <a:lnTo>
                    <a:pt x="1857756" y="778383"/>
                  </a:lnTo>
                  <a:lnTo>
                    <a:pt x="1868170" y="778383"/>
                  </a:lnTo>
                  <a:lnTo>
                    <a:pt x="1868170" y="466979"/>
                  </a:lnTo>
                  <a:close/>
                </a:path>
                <a:path w="4074159" h="778509">
                  <a:moveTo>
                    <a:pt x="1926209" y="498221"/>
                  </a:moveTo>
                  <a:lnTo>
                    <a:pt x="1915795" y="498221"/>
                  </a:lnTo>
                  <a:lnTo>
                    <a:pt x="1915795" y="778383"/>
                  </a:lnTo>
                  <a:lnTo>
                    <a:pt x="1926209" y="778383"/>
                  </a:lnTo>
                  <a:lnTo>
                    <a:pt x="1926209" y="498221"/>
                  </a:lnTo>
                  <a:close/>
                </a:path>
                <a:path w="4074159" h="778509">
                  <a:moveTo>
                    <a:pt x="1984248" y="249047"/>
                  </a:moveTo>
                  <a:lnTo>
                    <a:pt x="1973834" y="249047"/>
                  </a:lnTo>
                  <a:lnTo>
                    <a:pt x="1973834" y="778383"/>
                  </a:lnTo>
                  <a:lnTo>
                    <a:pt x="1984248" y="778383"/>
                  </a:lnTo>
                  <a:lnTo>
                    <a:pt x="1984248" y="249047"/>
                  </a:lnTo>
                  <a:close/>
                </a:path>
                <a:path w="4074159" h="778509">
                  <a:moveTo>
                    <a:pt x="2042287" y="560451"/>
                  </a:moveTo>
                  <a:lnTo>
                    <a:pt x="2031873" y="560451"/>
                  </a:lnTo>
                  <a:lnTo>
                    <a:pt x="2031873" y="778383"/>
                  </a:lnTo>
                  <a:lnTo>
                    <a:pt x="2042287" y="778383"/>
                  </a:lnTo>
                  <a:lnTo>
                    <a:pt x="2042287" y="560451"/>
                  </a:lnTo>
                  <a:close/>
                </a:path>
                <a:path w="4074159" h="778509">
                  <a:moveTo>
                    <a:pt x="2100326" y="435864"/>
                  </a:moveTo>
                  <a:lnTo>
                    <a:pt x="2089912" y="435864"/>
                  </a:lnTo>
                  <a:lnTo>
                    <a:pt x="2089912" y="778383"/>
                  </a:lnTo>
                  <a:lnTo>
                    <a:pt x="2100326" y="778383"/>
                  </a:lnTo>
                  <a:lnTo>
                    <a:pt x="2100326" y="435864"/>
                  </a:lnTo>
                  <a:close/>
                </a:path>
                <a:path w="4074159" h="778509">
                  <a:moveTo>
                    <a:pt x="2158365" y="653796"/>
                  </a:moveTo>
                  <a:lnTo>
                    <a:pt x="2147951" y="653796"/>
                  </a:lnTo>
                  <a:lnTo>
                    <a:pt x="2147951" y="778383"/>
                  </a:lnTo>
                  <a:lnTo>
                    <a:pt x="2158365" y="778383"/>
                  </a:lnTo>
                  <a:lnTo>
                    <a:pt x="2158365" y="653796"/>
                  </a:lnTo>
                  <a:close/>
                </a:path>
                <a:path w="4074159" h="778509">
                  <a:moveTo>
                    <a:pt x="2216404" y="622681"/>
                  </a:moveTo>
                  <a:lnTo>
                    <a:pt x="2205990" y="622681"/>
                  </a:lnTo>
                  <a:lnTo>
                    <a:pt x="2205990" y="778383"/>
                  </a:lnTo>
                  <a:lnTo>
                    <a:pt x="2216404" y="778383"/>
                  </a:lnTo>
                  <a:lnTo>
                    <a:pt x="2216404" y="622681"/>
                  </a:lnTo>
                  <a:close/>
                </a:path>
                <a:path w="4074159" h="778509">
                  <a:moveTo>
                    <a:pt x="2274570" y="529336"/>
                  </a:moveTo>
                  <a:lnTo>
                    <a:pt x="2264156" y="529336"/>
                  </a:lnTo>
                  <a:lnTo>
                    <a:pt x="2264156" y="778383"/>
                  </a:lnTo>
                  <a:lnTo>
                    <a:pt x="2274570" y="778383"/>
                  </a:lnTo>
                  <a:lnTo>
                    <a:pt x="2274570" y="529336"/>
                  </a:lnTo>
                  <a:close/>
                </a:path>
                <a:path w="4074159" h="778509">
                  <a:moveTo>
                    <a:pt x="2332609" y="591566"/>
                  </a:moveTo>
                  <a:lnTo>
                    <a:pt x="2322195" y="591566"/>
                  </a:lnTo>
                  <a:lnTo>
                    <a:pt x="2322195" y="778383"/>
                  </a:lnTo>
                  <a:lnTo>
                    <a:pt x="2332609" y="778383"/>
                  </a:lnTo>
                  <a:lnTo>
                    <a:pt x="2332609" y="591566"/>
                  </a:lnTo>
                  <a:close/>
                </a:path>
                <a:path w="4074159" h="778509">
                  <a:moveTo>
                    <a:pt x="2390648" y="622681"/>
                  </a:moveTo>
                  <a:lnTo>
                    <a:pt x="2380234" y="622681"/>
                  </a:lnTo>
                  <a:lnTo>
                    <a:pt x="2380234" y="778383"/>
                  </a:lnTo>
                  <a:lnTo>
                    <a:pt x="2390648" y="778383"/>
                  </a:lnTo>
                  <a:lnTo>
                    <a:pt x="2390648" y="622681"/>
                  </a:lnTo>
                  <a:close/>
                </a:path>
                <a:path w="4074159" h="778509">
                  <a:moveTo>
                    <a:pt x="2448687" y="622681"/>
                  </a:moveTo>
                  <a:lnTo>
                    <a:pt x="2438273" y="622681"/>
                  </a:lnTo>
                  <a:lnTo>
                    <a:pt x="2438273" y="778383"/>
                  </a:lnTo>
                  <a:lnTo>
                    <a:pt x="2448687" y="778383"/>
                  </a:lnTo>
                  <a:lnTo>
                    <a:pt x="2448687" y="622681"/>
                  </a:lnTo>
                  <a:close/>
                </a:path>
                <a:path w="4074159" h="778509">
                  <a:moveTo>
                    <a:pt x="2506726" y="529336"/>
                  </a:moveTo>
                  <a:lnTo>
                    <a:pt x="2496312" y="529336"/>
                  </a:lnTo>
                  <a:lnTo>
                    <a:pt x="2496312" y="778383"/>
                  </a:lnTo>
                  <a:lnTo>
                    <a:pt x="2506726" y="778383"/>
                  </a:lnTo>
                  <a:lnTo>
                    <a:pt x="2506726" y="529336"/>
                  </a:lnTo>
                  <a:close/>
                </a:path>
                <a:path w="4074159" h="778509">
                  <a:moveTo>
                    <a:pt x="2564765" y="560451"/>
                  </a:moveTo>
                  <a:lnTo>
                    <a:pt x="2554351" y="560451"/>
                  </a:lnTo>
                  <a:lnTo>
                    <a:pt x="2554351" y="778383"/>
                  </a:lnTo>
                  <a:lnTo>
                    <a:pt x="2564765" y="778383"/>
                  </a:lnTo>
                  <a:lnTo>
                    <a:pt x="2564765" y="560451"/>
                  </a:lnTo>
                  <a:close/>
                </a:path>
                <a:path w="4074159" h="778509">
                  <a:moveTo>
                    <a:pt x="2622804" y="622681"/>
                  </a:moveTo>
                  <a:lnTo>
                    <a:pt x="2612390" y="622681"/>
                  </a:lnTo>
                  <a:lnTo>
                    <a:pt x="2612390" y="778383"/>
                  </a:lnTo>
                  <a:lnTo>
                    <a:pt x="2622804" y="778383"/>
                  </a:lnTo>
                  <a:lnTo>
                    <a:pt x="2622804" y="622681"/>
                  </a:lnTo>
                  <a:close/>
                </a:path>
                <a:path w="4074159" h="778509">
                  <a:moveTo>
                    <a:pt x="2680843" y="560451"/>
                  </a:moveTo>
                  <a:lnTo>
                    <a:pt x="2670429" y="560451"/>
                  </a:lnTo>
                  <a:lnTo>
                    <a:pt x="2670429" y="778383"/>
                  </a:lnTo>
                  <a:lnTo>
                    <a:pt x="2680843" y="778383"/>
                  </a:lnTo>
                  <a:lnTo>
                    <a:pt x="2680843" y="560451"/>
                  </a:lnTo>
                  <a:close/>
                </a:path>
                <a:path w="4074159" h="778509">
                  <a:moveTo>
                    <a:pt x="2738882" y="591566"/>
                  </a:moveTo>
                  <a:lnTo>
                    <a:pt x="2728468" y="591566"/>
                  </a:lnTo>
                  <a:lnTo>
                    <a:pt x="2728468" y="778383"/>
                  </a:lnTo>
                  <a:lnTo>
                    <a:pt x="2738882" y="778383"/>
                  </a:lnTo>
                  <a:lnTo>
                    <a:pt x="2738882" y="591566"/>
                  </a:lnTo>
                  <a:close/>
                </a:path>
                <a:path w="4074159" h="778509">
                  <a:moveTo>
                    <a:pt x="2797048" y="685038"/>
                  </a:moveTo>
                  <a:lnTo>
                    <a:pt x="2786634" y="685038"/>
                  </a:lnTo>
                  <a:lnTo>
                    <a:pt x="2786634" y="778383"/>
                  </a:lnTo>
                  <a:lnTo>
                    <a:pt x="2797048" y="778383"/>
                  </a:lnTo>
                  <a:lnTo>
                    <a:pt x="2797048" y="685038"/>
                  </a:lnTo>
                  <a:close/>
                </a:path>
                <a:path w="4074159" h="778509">
                  <a:moveTo>
                    <a:pt x="2855087" y="622681"/>
                  </a:moveTo>
                  <a:lnTo>
                    <a:pt x="2842006" y="622681"/>
                  </a:lnTo>
                  <a:lnTo>
                    <a:pt x="2842006" y="778383"/>
                  </a:lnTo>
                  <a:lnTo>
                    <a:pt x="2855087" y="778383"/>
                  </a:lnTo>
                  <a:lnTo>
                    <a:pt x="2855087" y="622681"/>
                  </a:lnTo>
                  <a:close/>
                </a:path>
                <a:path w="4074159" h="778509">
                  <a:moveTo>
                    <a:pt x="2913126" y="498221"/>
                  </a:moveTo>
                  <a:lnTo>
                    <a:pt x="2902712" y="498221"/>
                  </a:lnTo>
                  <a:lnTo>
                    <a:pt x="2902712" y="778383"/>
                  </a:lnTo>
                  <a:lnTo>
                    <a:pt x="2913126" y="778383"/>
                  </a:lnTo>
                  <a:lnTo>
                    <a:pt x="2913126" y="498221"/>
                  </a:lnTo>
                  <a:close/>
                </a:path>
                <a:path w="4074159" h="778509">
                  <a:moveTo>
                    <a:pt x="2971165" y="498221"/>
                  </a:moveTo>
                  <a:lnTo>
                    <a:pt x="2960751" y="498221"/>
                  </a:lnTo>
                  <a:lnTo>
                    <a:pt x="2960751" y="778383"/>
                  </a:lnTo>
                  <a:lnTo>
                    <a:pt x="2971165" y="778383"/>
                  </a:lnTo>
                  <a:lnTo>
                    <a:pt x="2971165" y="498221"/>
                  </a:lnTo>
                  <a:close/>
                </a:path>
                <a:path w="4074159" h="778509">
                  <a:moveTo>
                    <a:pt x="3029204" y="498221"/>
                  </a:moveTo>
                  <a:lnTo>
                    <a:pt x="3018790" y="498221"/>
                  </a:lnTo>
                  <a:lnTo>
                    <a:pt x="3018790" y="778383"/>
                  </a:lnTo>
                  <a:lnTo>
                    <a:pt x="3029204" y="778383"/>
                  </a:lnTo>
                  <a:lnTo>
                    <a:pt x="3029204" y="498221"/>
                  </a:lnTo>
                  <a:close/>
                </a:path>
                <a:path w="4074159" h="778509">
                  <a:moveTo>
                    <a:pt x="3087243" y="529336"/>
                  </a:moveTo>
                  <a:lnTo>
                    <a:pt x="3076829" y="529336"/>
                  </a:lnTo>
                  <a:lnTo>
                    <a:pt x="3076829" y="778383"/>
                  </a:lnTo>
                  <a:lnTo>
                    <a:pt x="3087243" y="778383"/>
                  </a:lnTo>
                  <a:lnTo>
                    <a:pt x="3087243" y="529336"/>
                  </a:lnTo>
                  <a:close/>
                </a:path>
                <a:path w="4074159" h="778509">
                  <a:moveTo>
                    <a:pt x="3145282" y="560451"/>
                  </a:moveTo>
                  <a:lnTo>
                    <a:pt x="3134868" y="560451"/>
                  </a:lnTo>
                  <a:lnTo>
                    <a:pt x="3134868" y="778383"/>
                  </a:lnTo>
                  <a:lnTo>
                    <a:pt x="3145282" y="778383"/>
                  </a:lnTo>
                  <a:lnTo>
                    <a:pt x="3145282" y="560451"/>
                  </a:lnTo>
                  <a:close/>
                </a:path>
                <a:path w="4074159" h="778509">
                  <a:moveTo>
                    <a:pt x="3203321" y="622681"/>
                  </a:moveTo>
                  <a:lnTo>
                    <a:pt x="3192907" y="622681"/>
                  </a:lnTo>
                  <a:lnTo>
                    <a:pt x="3192907" y="778383"/>
                  </a:lnTo>
                  <a:lnTo>
                    <a:pt x="3203321" y="778383"/>
                  </a:lnTo>
                  <a:lnTo>
                    <a:pt x="3203321" y="622681"/>
                  </a:lnTo>
                  <a:close/>
                </a:path>
                <a:path w="4074159" h="778509">
                  <a:moveTo>
                    <a:pt x="3261360" y="591566"/>
                  </a:moveTo>
                  <a:lnTo>
                    <a:pt x="3250946" y="591566"/>
                  </a:lnTo>
                  <a:lnTo>
                    <a:pt x="3250946" y="778383"/>
                  </a:lnTo>
                  <a:lnTo>
                    <a:pt x="3261360" y="778383"/>
                  </a:lnTo>
                  <a:lnTo>
                    <a:pt x="3261360" y="591566"/>
                  </a:lnTo>
                  <a:close/>
                </a:path>
                <a:path w="4074159" h="778509">
                  <a:moveTo>
                    <a:pt x="3319399" y="529336"/>
                  </a:moveTo>
                  <a:lnTo>
                    <a:pt x="3308985" y="529336"/>
                  </a:lnTo>
                  <a:lnTo>
                    <a:pt x="3308985" y="778383"/>
                  </a:lnTo>
                  <a:lnTo>
                    <a:pt x="3319399" y="778383"/>
                  </a:lnTo>
                  <a:lnTo>
                    <a:pt x="3319399" y="529336"/>
                  </a:lnTo>
                  <a:close/>
                </a:path>
                <a:path w="4074159" h="778509">
                  <a:moveTo>
                    <a:pt x="3377565" y="560451"/>
                  </a:moveTo>
                  <a:lnTo>
                    <a:pt x="3367151" y="560451"/>
                  </a:lnTo>
                  <a:lnTo>
                    <a:pt x="3367151" y="778383"/>
                  </a:lnTo>
                  <a:lnTo>
                    <a:pt x="3377565" y="778383"/>
                  </a:lnTo>
                  <a:lnTo>
                    <a:pt x="3377565" y="560451"/>
                  </a:lnTo>
                  <a:close/>
                </a:path>
                <a:path w="4074159" h="778509">
                  <a:moveTo>
                    <a:pt x="3435604" y="529336"/>
                  </a:moveTo>
                  <a:lnTo>
                    <a:pt x="3425190" y="529336"/>
                  </a:lnTo>
                  <a:lnTo>
                    <a:pt x="3425190" y="778383"/>
                  </a:lnTo>
                  <a:lnTo>
                    <a:pt x="3435604" y="778383"/>
                  </a:lnTo>
                  <a:lnTo>
                    <a:pt x="3435604" y="529336"/>
                  </a:lnTo>
                  <a:close/>
                </a:path>
                <a:path w="4074159" h="778509">
                  <a:moveTo>
                    <a:pt x="3493643" y="560451"/>
                  </a:moveTo>
                  <a:lnTo>
                    <a:pt x="3483229" y="560451"/>
                  </a:lnTo>
                  <a:lnTo>
                    <a:pt x="3483229" y="778383"/>
                  </a:lnTo>
                  <a:lnTo>
                    <a:pt x="3493643" y="778383"/>
                  </a:lnTo>
                  <a:lnTo>
                    <a:pt x="3493643" y="560451"/>
                  </a:lnTo>
                  <a:close/>
                </a:path>
                <a:path w="4074159" h="778509">
                  <a:moveTo>
                    <a:pt x="3551682" y="653796"/>
                  </a:moveTo>
                  <a:lnTo>
                    <a:pt x="3541268" y="653796"/>
                  </a:lnTo>
                  <a:lnTo>
                    <a:pt x="3541268" y="778383"/>
                  </a:lnTo>
                  <a:lnTo>
                    <a:pt x="3551682" y="778383"/>
                  </a:lnTo>
                  <a:lnTo>
                    <a:pt x="3551682" y="653796"/>
                  </a:lnTo>
                  <a:close/>
                </a:path>
                <a:path w="4074159" h="778509">
                  <a:moveTo>
                    <a:pt x="3609721" y="622681"/>
                  </a:moveTo>
                  <a:lnTo>
                    <a:pt x="3599307" y="622681"/>
                  </a:lnTo>
                  <a:lnTo>
                    <a:pt x="3599307" y="778383"/>
                  </a:lnTo>
                  <a:lnTo>
                    <a:pt x="3609721" y="778383"/>
                  </a:lnTo>
                  <a:lnTo>
                    <a:pt x="3609721" y="622681"/>
                  </a:lnTo>
                  <a:close/>
                </a:path>
                <a:path w="4074159" h="778509">
                  <a:moveTo>
                    <a:pt x="3667760" y="466979"/>
                  </a:moveTo>
                  <a:lnTo>
                    <a:pt x="3657346" y="466979"/>
                  </a:lnTo>
                  <a:lnTo>
                    <a:pt x="3657346" y="778383"/>
                  </a:lnTo>
                  <a:lnTo>
                    <a:pt x="3667760" y="778383"/>
                  </a:lnTo>
                  <a:lnTo>
                    <a:pt x="3667760" y="466979"/>
                  </a:lnTo>
                  <a:close/>
                </a:path>
                <a:path w="4074159" h="778509">
                  <a:moveTo>
                    <a:pt x="3725799" y="529336"/>
                  </a:moveTo>
                  <a:lnTo>
                    <a:pt x="3715385" y="529336"/>
                  </a:lnTo>
                  <a:lnTo>
                    <a:pt x="3715385" y="778383"/>
                  </a:lnTo>
                  <a:lnTo>
                    <a:pt x="3725799" y="778383"/>
                  </a:lnTo>
                  <a:lnTo>
                    <a:pt x="3725799" y="529336"/>
                  </a:lnTo>
                  <a:close/>
                </a:path>
                <a:path w="4074159" h="778509">
                  <a:moveTo>
                    <a:pt x="3783838" y="529336"/>
                  </a:moveTo>
                  <a:lnTo>
                    <a:pt x="3773424" y="529336"/>
                  </a:lnTo>
                  <a:lnTo>
                    <a:pt x="3773424" y="778383"/>
                  </a:lnTo>
                  <a:lnTo>
                    <a:pt x="3783838" y="778383"/>
                  </a:lnTo>
                  <a:lnTo>
                    <a:pt x="3783838" y="529336"/>
                  </a:lnTo>
                  <a:close/>
                </a:path>
                <a:path w="4074159" h="778509">
                  <a:moveTo>
                    <a:pt x="3841877" y="498221"/>
                  </a:moveTo>
                  <a:lnTo>
                    <a:pt x="3831463" y="498221"/>
                  </a:lnTo>
                  <a:lnTo>
                    <a:pt x="3831463" y="778383"/>
                  </a:lnTo>
                  <a:lnTo>
                    <a:pt x="3841877" y="778383"/>
                  </a:lnTo>
                  <a:lnTo>
                    <a:pt x="3841877" y="498221"/>
                  </a:lnTo>
                  <a:close/>
                </a:path>
                <a:path w="4074159" h="778509">
                  <a:moveTo>
                    <a:pt x="3900043" y="529336"/>
                  </a:moveTo>
                  <a:lnTo>
                    <a:pt x="3889629" y="529336"/>
                  </a:lnTo>
                  <a:lnTo>
                    <a:pt x="3889629" y="778383"/>
                  </a:lnTo>
                  <a:lnTo>
                    <a:pt x="3900043" y="778383"/>
                  </a:lnTo>
                  <a:lnTo>
                    <a:pt x="3900043" y="529336"/>
                  </a:lnTo>
                  <a:close/>
                </a:path>
                <a:path w="4074159" h="778509">
                  <a:moveTo>
                    <a:pt x="3958082" y="560451"/>
                  </a:moveTo>
                  <a:lnTo>
                    <a:pt x="3947668" y="560451"/>
                  </a:lnTo>
                  <a:lnTo>
                    <a:pt x="3947668" y="778383"/>
                  </a:lnTo>
                  <a:lnTo>
                    <a:pt x="3958082" y="778383"/>
                  </a:lnTo>
                  <a:lnTo>
                    <a:pt x="3958082" y="560451"/>
                  </a:lnTo>
                  <a:close/>
                </a:path>
                <a:path w="4074159" h="778509">
                  <a:moveTo>
                    <a:pt x="4016121" y="435864"/>
                  </a:moveTo>
                  <a:lnTo>
                    <a:pt x="4005707" y="435864"/>
                  </a:lnTo>
                  <a:lnTo>
                    <a:pt x="4005707" y="778383"/>
                  </a:lnTo>
                  <a:lnTo>
                    <a:pt x="4016121" y="778383"/>
                  </a:lnTo>
                  <a:lnTo>
                    <a:pt x="4016121" y="435864"/>
                  </a:lnTo>
                  <a:close/>
                </a:path>
                <a:path w="4074159" h="778509">
                  <a:moveTo>
                    <a:pt x="4074160" y="435864"/>
                  </a:moveTo>
                  <a:lnTo>
                    <a:pt x="4063746" y="435864"/>
                  </a:lnTo>
                  <a:lnTo>
                    <a:pt x="4063746" y="778383"/>
                  </a:lnTo>
                  <a:lnTo>
                    <a:pt x="4074160" y="778383"/>
                  </a:lnTo>
                  <a:lnTo>
                    <a:pt x="4074160" y="435864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8" name="object 128" descr=""/>
            <p:cNvSpPr/>
            <p:nvPr/>
          </p:nvSpPr>
          <p:spPr>
            <a:xfrm>
              <a:off x="9293860" y="8319897"/>
              <a:ext cx="4364355" cy="342900"/>
            </a:xfrm>
            <a:custGeom>
              <a:avLst/>
              <a:gdLst/>
              <a:ahLst/>
              <a:cxnLst/>
              <a:rect l="l" t="t" r="r" b="b"/>
              <a:pathLst>
                <a:path w="4364355" h="342900">
                  <a:moveTo>
                    <a:pt x="10414" y="0"/>
                  </a:moveTo>
                  <a:lnTo>
                    <a:pt x="0" y="0"/>
                  </a:lnTo>
                  <a:lnTo>
                    <a:pt x="0" y="342519"/>
                  </a:lnTo>
                  <a:lnTo>
                    <a:pt x="10414" y="342519"/>
                  </a:lnTo>
                  <a:lnTo>
                    <a:pt x="10414" y="0"/>
                  </a:lnTo>
                  <a:close/>
                </a:path>
                <a:path w="4364355" h="342900">
                  <a:moveTo>
                    <a:pt x="68453" y="93472"/>
                  </a:moveTo>
                  <a:lnTo>
                    <a:pt x="58039" y="93472"/>
                  </a:lnTo>
                  <a:lnTo>
                    <a:pt x="58039" y="342519"/>
                  </a:lnTo>
                  <a:lnTo>
                    <a:pt x="68453" y="342519"/>
                  </a:lnTo>
                  <a:lnTo>
                    <a:pt x="68453" y="93472"/>
                  </a:lnTo>
                  <a:close/>
                </a:path>
                <a:path w="4364355" h="342900">
                  <a:moveTo>
                    <a:pt x="126492" y="217932"/>
                  </a:moveTo>
                  <a:lnTo>
                    <a:pt x="116078" y="217932"/>
                  </a:lnTo>
                  <a:lnTo>
                    <a:pt x="116078" y="342519"/>
                  </a:lnTo>
                  <a:lnTo>
                    <a:pt x="126492" y="342519"/>
                  </a:lnTo>
                  <a:lnTo>
                    <a:pt x="126492" y="217932"/>
                  </a:lnTo>
                  <a:close/>
                </a:path>
                <a:path w="4364355" h="342900">
                  <a:moveTo>
                    <a:pt x="184531" y="186817"/>
                  </a:moveTo>
                  <a:lnTo>
                    <a:pt x="174117" y="186817"/>
                  </a:lnTo>
                  <a:lnTo>
                    <a:pt x="174117" y="342519"/>
                  </a:lnTo>
                  <a:lnTo>
                    <a:pt x="184531" y="342519"/>
                  </a:lnTo>
                  <a:lnTo>
                    <a:pt x="184531" y="186817"/>
                  </a:lnTo>
                  <a:close/>
                </a:path>
                <a:path w="4364355" h="342900">
                  <a:moveTo>
                    <a:pt x="242570" y="186817"/>
                  </a:moveTo>
                  <a:lnTo>
                    <a:pt x="232156" y="186817"/>
                  </a:lnTo>
                  <a:lnTo>
                    <a:pt x="232156" y="342519"/>
                  </a:lnTo>
                  <a:lnTo>
                    <a:pt x="242570" y="342519"/>
                  </a:lnTo>
                  <a:lnTo>
                    <a:pt x="242570" y="186817"/>
                  </a:lnTo>
                  <a:close/>
                </a:path>
                <a:path w="4364355" h="342900">
                  <a:moveTo>
                    <a:pt x="300609" y="155702"/>
                  </a:moveTo>
                  <a:lnTo>
                    <a:pt x="290195" y="155702"/>
                  </a:lnTo>
                  <a:lnTo>
                    <a:pt x="290195" y="342519"/>
                  </a:lnTo>
                  <a:lnTo>
                    <a:pt x="300609" y="342519"/>
                  </a:lnTo>
                  <a:lnTo>
                    <a:pt x="300609" y="155702"/>
                  </a:lnTo>
                  <a:close/>
                </a:path>
                <a:path w="4364355" h="342900">
                  <a:moveTo>
                    <a:pt x="358775" y="155702"/>
                  </a:moveTo>
                  <a:lnTo>
                    <a:pt x="348361" y="155702"/>
                  </a:lnTo>
                  <a:lnTo>
                    <a:pt x="348361" y="342519"/>
                  </a:lnTo>
                  <a:lnTo>
                    <a:pt x="358775" y="342519"/>
                  </a:lnTo>
                  <a:lnTo>
                    <a:pt x="358775" y="155702"/>
                  </a:lnTo>
                  <a:close/>
                </a:path>
                <a:path w="4364355" h="342900">
                  <a:moveTo>
                    <a:pt x="416814" y="93472"/>
                  </a:moveTo>
                  <a:lnTo>
                    <a:pt x="406400" y="93472"/>
                  </a:lnTo>
                  <a:lnTo>
                    <a:pt x="406400" y="342519"/>
                  </a:lnTo>
                  <a:lnTo>
                    <a:pt x="416814" y="342519"/>
                  </a:lnTo>
                  <a:lnTo>
                    <a:pt x="416814" y="93472"/>
                  </a:lnTo>
                  <a:close/>
                </a:path>
                <a:path w="4364355" h="342900">
                  <a:moveTo>
                    <a:pt x="474853" y="93472"/>
                  </a:moveTo>
                  <a:lnTo>
                    <a:pt x="464439" y="93472"/>
                  </a:lnTo>
                  <a:lnTo>
                    <a:pt x="464439" y="342519"/>
                  </a:lnTo>
                  <a:lnTo>
                    <a:pt x="474853" y="342519"/>
                  </a:lnTo>
                  <a:lnTo>
                    <a:pt x="474853" y="93472"/>
                  </a:lnTo>
                  <a:close/>
                </a:path>
                <a:path w="4364355" h="342900">
                  <a:moveTo>
                    <a:pt x="532892" y="155702"/>
                  </a:moveTo>
                  <a:lnTo>
                    <a:pt x="522478" y="155702"/>
                  </a:lnTo>
                  <a:lnTo>
                    <a:pt x="522478" y="342519"/>
                  </a:lnTo>
                  <a:lnTo>
                    <a:pt x="532892" y="342519"/>
                  </a:lnTo>
                  <a:lnTo>
                    <a:pt x="532892" y="155702"/>
                  </a:lnTo>
                  <a:close/>
                </a:path>
                <a:path w="4364355" h="342900">
                  <a:moveTo>
                    <a:pt x="590931" y="280289"/>
                  </a:moveTo>
                  <a:lnTo>
                    <a:pt x="580517" y="280289"/>
                  </a:lnTo>
                  <a:lnTo>
                    <a:pt x="580517" y="342519"/>
                  </a:lnTo>
                  <a:lnTo>
                    <a:pt x="590931" y="342519"/>
                  </a:lnTo>
                  <a:lnTo>
                    <a:pt x="590931" y="280289"/>
                  </a:lnTo>
                  <a:close/>
                </a:path>
                <a:path w="4364355" h="342900">
                  <a:moveTo>
                    <a:pt x="648970" y="124587"/>
                  </a:moveTo>
                  <a:lnTo>
                    <a:pt x="638556" y="124587"/>
                  </a:lnTo>
                  <a:lnTo>
                    <a:pt x="638556" y="342519"/>
                  </a:lnTo>
                  <a:lnTo>
                    <a:pt x="648970" y="342519"/>
                  </a:lnTo>
                  <a:lnTo>
                    <a:pt x="648970" y="124587"/>
                  </a:lnTo>
                  <a:close/>
                </a:path>
                <a:path w="4364355" h="342900">
                  <a:moveTo>
                    <a:pt x="707009" y="217932"/>
                  </a:moveTo>
                  <a:lnTo>
                    <a:pt x="696595" y="217932"/>
                  </a:lnTo>
                  <a:lnTo>
                    <a:pt x="696595" y="342519"/>
                  </a:lnTo>
                  <a:lnTo>
                    <a:pt x="707009" y="342519"/>
                  </a:lnTo>
                  <a:lnTo>
                    <a:pt x="707009" y="217932"/>
                  </a:lnTo>
                  <a:close/>
                </a:path>
                <a:path w="4364355" h="342900">
                  <a:moveTo>
                    <a:pt x="765048" y="155702"/>
                  </a:moveTo>
                  <a:lnTo>
                    <a:pt x="754634" y="155702"/>
                  </a:lnTo>
                  <a:lnTo>
                    <a:pt x="754634" y="342519"/>
                  </a:lnTo>
                  <a:lnTo>
                    <a:pt x="765048" y="342519"/>
                  </a:lnTo>
                  <a:lnTo>
                    <a:pt x="765048" y="155702"/>
                  </a:lnTo>
                  <a:close/>
                </a:path>
                <a:path w="4364355" h="342900">
                  <a:moveTo>
                    <a:pt x="881126" y="249174"/>
                  </a:moveTo>
                  <a:lnTo>
                    <a:pt x="870712" y="249174"/>
                  </a:lnTo>
                  <a:lnTo>
                    <a:pt x="870712" y="342519"/>
                  </a:lnTo>
                  <a:lnTo>
                    <a:pt x="881126" y="342519"/>
                  </a:lnTo>
                  <a:lnTo>
                    <a:pt x="881126" y="249174"/>
                  </a:lnTo>
                  <a:close/>
                </a:path>
                <a:path w="4364355" h="342900">
                  <a:moveTo>
                    <a:pt x="939292" y="31115"/>
                  </a:moveTo>
                  <a:lnTo>
                    <a:pt x="928878" y="31115"/>
                  </a:lnTo>
                  <a:lnTo>
                    <a:pt x="928878" y="342519"/>
                  </a:lnTo>
                  <a:lnTo>
                    <a:pt x="939292" y="342519"/>
                  </a:lnTo>
                  <a:lnTo>
                    <a:pt x="939292" y="31115"/>
                  </a:lnTo>
                  <a:close/>
                </a:path>
                <a:path w="4364355" h="342900">
                  <a:moveTo>
                    <a:pt x="997331" y="311404"/>
                  </a:moveTo>
                  <a:lnTo>
                    <a:pt x="986917" y="311404"/>
                  </a:lnTo>
                  <a:lnTo>
                    <a:pt x="986917" y="342519"/>
                  </a:lnTo>
                  <a:lnTo>
                    <a:pt x="997331" y="342519"/>
                  </a:lnTo>
                  <a:lnTo>
                    <a:pt x="997331" y="311404"/>
                  </a:lnTo>
                  <a:close/>
                </a:path>
                <a:path w="4364355" h="342900">
                  <a:moveTo>
                    <a:pt x="1055370" y="155702"/>
                  </a:moveTo>
                  <a:lnTo>
                    <a:pt x="1044956" y="155702"/>
                  </a:lnTo>
                  <a:lnTo>
                    <a:pt x="1044956" y="342519"/>
                  </a:lnTo>
                  <a:lnTo>
                    <a:pt x="1055370" y="342519"/>
                  </a:lnTo>
                  <a:lnTo>
                    <a:pt x="1055370" y="155702"/>
                  </a:lnTo>
                  <a:close/>
                </a:path>
                <a:path w="4364355" h="342900">
                  <a:moveTo>
                    <a:pt x="1113409" y="124587"/>
                  </a:moveTo>
                  <a:lnTo>
                    <a:pt x="1102995" y="124587"/>
                  </a:lnTo>
                  <a:lnTo>
                    <a:pt x="1102995" y="342519"/>
                  </a:lnTo>
                  <a:lnTo>
                    <a:pt x="1113409" y="342519"/>
                  </a:lnTo>
                  <a:lnTo>
                    <a:pt x="1113409" y="124587"/>
                  </a:lnTo>
                  <a:close/>
                </a:path>
                <a:path w="4364355" h="342900">
                  <a:moveTo>
                    <a:pt x="1171448" y="155702"/>
                  </a:moveTo>
                  <a:lnTo>
                    <a:pt x="1161034" y="155702"/>
                  </a:lnTo>
                  <a:lnTo>
                    <a:pt x="1161034" y="342519"/>
                  </a:lnTo>
                  <a:lnTo>
                    <a:pt x="1171448" y="342519"/>
                  </a:lnTo>
                  <a:lnTo>
                    <a:pt x="1171448" y="155702"/>
                  </a:lnTo>
                  <a:close/>
                </a:path>
                <a:path w="4364355" h="342900">
                  <a:moveTo>
                    <a:pt x="1229487" y="217932"/>
                  </a:moveTo>
                  <a:lnTo>
                    <a:pt x="1219073" y="217932"/>
                  </a:lnTo>
                  <a:lnTo>
                    <a:pt x="1219073" y="342519"/>
                  </a:lnTo>
                  <a:lnTo>
                    <a:pt x="1229487" y="342519"/>
                  </a:lnTo>
                  <a:lnTo>
                    <a:pt x="1229487" y="217932"/>
                  </a:lnTo>
                  <a:close/>
                </a:path>
                <a:path w="4364355" h="342900">
                  <a:moveTo>
                    <a:pt x="1287640" y="186817"/>
                  </a:moveTo>
                  <a:lnTo>
                    <a:pt x="1274572" y="186817"/>
                  </a:lnTo>
                  <a:lnTo>
                    <a:pt x="1274572" y="342519"/>
                  </a:lnTo>
                  <a:lnTo>
                    <a:pt x="1287640" y="342519"/>
                  </a:lnTo>
                  <a:lnTo>
                    <a:pt x="1287640" y="186817"/>
                  </a:lnTo>
                  <a:close/>
                </a:path>
                <a:path w="4364355" h="342900">
                  <a:moveTo>
                    <a:pt x="1345565" y="249174"/>
                  </a:moveTo>
                  <a:lnTo>
                    <a:pt x="1335151" y="249174"/>
                  </a:lnTo>
                  <a:lnTo>
                    <a:pt x="1335151" y="342519"/>
                  </a:lnTo>
                  <a:lnTo>
                    <a:pt x="1345565" y="342519"/>
                  </a:lnTo>
                  <a:lnTo>
                    <a:pt x="1345565" y="249174"/>
                  </a:lnTo>
                  <a:close/>
                </a:path>
                <a:path w="4364355" h="342900">
                  <a:moveTo>
                    <a:pt x="1403604" y="249174"/>
                  </a:moveTo>
                  <a:lnTo>
                    <a:pt x="1393190" y="249174"/>
                  </a:lnTo>
                  <a:lnTo>
                    <a:pt x="1393190" y="342519"/>
                  </a:lnTo>
                  <a:lnTo>
                    <a:pt x="1403604" y="342519"/>
                  </a:lnTo>
                  <a:lnTo>
                    <a:pt x="1403604" y="249174"/>
                  </a:lnTo>
                  <a:close/>
                </a:path>
                <a:path w="4364355" h="342900">
                  <a:moveTo>
                    <a:pt x="1461770" y="155702"/>
                  </a:moveTo>
                  <a:lnTo>
                    <a:pt x="1451356" y="155702"/>
                  </a:lnTo>
                  <a:lnTo>
                    <a:pt x="1451356" y="342519"/>
                  </a:lnTo>
                  <a:lnTo>
                    <a:pt x="1461770" y="342519"/>
                  </a:lnTo>
                  <a:lnTo>
                    <a:pt x="1461770" y="155702"/>
                  </a:lnTo>
                  <a:close/>
                </a:path>
                <a:path w="4364355" h="342900">
                  <a:moveTo>
                    <a:pt x="1519809" y="249174"/>
                  </a:moveTo>
                  <a:lnTo>
                    <a:pt x="1509395" y="249174"/>
                  </a:lnTo>
                  <a:lnTo>
                    <a:pt x="1509395" y="342519"/>
                  </a:lnTo>
                  <a:lnTo>
                    <a:pt x="1519809" y="342519"/>
                  </a:lnTo>
                  <a:lnTo>
                    <a:pt x="1519809" y="249174"/>
                  </a:lnTo>
                  <a:close/>
                </a:path>
                <a:path w="4364355" h="342900">
                  <a:moveTo>
                    <a:pt x="1577848" y="280289"/>
                  </a:moveTo>
                  <a:lnTo>
                    <a:pt x="1567434" y="280289"/>
                  </a:lnTo>
                  <a:lnTo>
                    <a:pt x="1567434" y="342519"/>
                  </a:lnTo>
                  <a:lnTo>
                    <a:pt x="1577848" y="342519"/>
                  </a:lnTo>
                  <a:lnTo>
                    <a:pt x="1577848" y="280289"/>
                  </a:lnTo>
                  <a:close/>
                </a:path>
                <a:path w="4364355" h="342900">
                  <a:moveTo>
                    <a:pt x="1635887" y="280289"/>
                  </a:moveTo>
                  <a:lnTo>
                    <a:pt x="1625473" y="280289"/>
                  </a:lnTo>
                  <a:lnTo>
                    <a:pt x="1625473" y="342519"/>
                  </a:lnTo>
                  <a:lnTo>
                    <a:pt x="1635887" y="342519"/>
                  </a:lnTo>
                  <a:lnTo>
                    <a:pt x="1635887" y="280289"/>
                  </a:lnTo>
                  <a:close/>
                </a:path>
                <a:path w="4364355" h="342900">
                  <a:moveTo>
                    <a:pt x="1693926" y="124587"/>
                  </a:moveTo>
                  <a:lnTo>
                    <a:pt x="1683512" y="124587"/>
                  </a:lnTo>
                  <a:lnTo>
                    <a:pt x="1683512" y="342519"/>
                  </a:lnTo>
                  <a:lnTo>
                    <a:pt x="1693926" y="342519"/>
                  </a:lnTo>
                  <a:lnTo>
                    <a:pt x="1693926" y="124587"/>
                  </a:lnTo>
                  <a:close/>
                </a:path>
                <a:path w="4364355" h="342900">
                  <a:moveTo>
                    <a:pt x="1751965" y="186817"/>
                  </a:moveTo>
                  <a:lnTo>
                    <a:pt x="1741551" y="186817"/>
                  </a:lnTo>
                  <a:lnTo>
                    <a:pt x="1741551" y="342519"/>
                  </a:lnTo>
                  <a:lnTo>
                    <a:pt x="1751965" y="342519"/>
                  </a:lnTo>
                  <a:lnTo>
                    <a:pt x="1751965" y="186817"/>
                  </a:lnTo>
                  <a:close/>
                </a:path>
                <a:path w="4364355" h="342900">
                  <a:moveTo>
                    <a:pt x="1810004" y="249174"/>
                  </a:moveTo>
                  <a:lnTo>
                    <a:pt x="1799590" y="249174"/>
                  </a:lnTo>
                  <a:lnTo>
                    <a:pt x="1799590" y="342519"/>
                  </a:lnTo>
                  <a:lnTo>
                    <a:pt x="1810004" y="342519"/>
                  </a:lnTo>
                  <a:lnTo>
                    <a:pt x="1810004" y="249174"/>
                  </a:lnTo>
                  <a:close/>
                </a:path>
                <a:path w="4364355" h="342900">
                  <a:moveTo>
                    <a:pt x="1868170" y="217932"/>
                  </a:moveTo>
                  <a:lnTo>
                    <a:pt x="1855089" y="217932"/>
                  </a:lnTo>
                  <a:lnTo>
                    <a:pt x="1855089" y="342519"/>
                  </a:lnTo>
                  <a:lnTo>
                    <a:pt x="1868170" y="342519"/>
                  </a:lnTo>
                  <a:lnTo>
                    <a:pt x="1868170" y="217932"/>
                  </a:lnTo>
                  <a:close/>
                </a:path>
                <a:path w="4364355" h="342900">
                  <a:moveTo>
                    <a:pt x="1926082" y="311404"/>
                  </a:moveTo>
                  <a:lnTo>
                    <a:pt x="1915668" y="311404"/>
                  </a:lnTo>
                  <a:lnTo>
                    <a:pt x="1915668" y="342519"/>
                  </a:lnTo>
                  <a:lnTo>
                    <a:pt x="1926082" y="342519"/>
                  </a:lnTo>
                  <a:lnTo>
                    <a:pt x="1926082" y="311404"/>
                  </a:lnTo>
                  <a:close/>
                </a:path>
                <a:path w="4364355" h="342900">
                  <a:moveTo>
                    <a:pt x="1984248" y="217932"/>
                  </a:moveTo>
                  <a:lnTo>
                    <a:pt x="1973834" y="217932"/>
                  </a:lnTo>
                  <a:lnTo>
                    <a:pt x="1973834" y="342519"/>
                  </a:lnTo>
                  <a:lnTo>
                    <a:pt x="1984248" y="342519"/>
                  </a:lnTo>
                  <a:lnTo>
                    <a:pt x="1984248" y="217932"/>
                  </a:lnTo>
                  <a:close/>
                </a:path>
                <a:path w="4364355" h="342900">
                  <a:moveTo>
                    <a:pt x="2042287" y="217932"/>
                  </a:moveTo>
                  <a:lnTo>
                    <a:pt x="2031873" y="217932"/>
                  </a:lnTo>
                  <a:lnTo>
                    <a:pt x="2031873" y="342519"/>
                  </a:lnTo>
                  <a:lnTo>
                    <a:pt x="2042287" y="342519"/>
                  </a:lnTo>
                  <a:lnTo>
                    <a:pt x="2042287" y="217932"/>
                  </a:lnTo>
                  <a:close/>
                </a:path>
                <a:path w="4364355" h="342900">
                  <a:moveTo>
                    <a:pt x="2100326" y="155702"/>
                  </a:moveTo>
                  <a:lnTo>
                    <a:pt x="2089912" y="155702"/>
                  </a:lnTo>
                  <a:lnTo>
                    <a:pt x="2089912" y="342519"/>
                  </a:lnTo>
                  <a:lnTo>
                    <a:pt x="2100326" y="342519"/>
                  </a:lnTo>
                  <a:lnTo>
                    <a:pt x="2100326" y="155702"/>
                  </a:lnTo>
                  <a:close/>
                </a:path>
                <a:path w="4364355" h="342900">
                  <a:moveTo>
                    <a:pt x="2158365" y="217932"/>
                  </a:moveTo>
                  <a:lnTo>
                    <a:pt x="2147951" y="217932"/>
                  </a:lnTo>
                  <a:lnTo>
                    <a:pt x="2147951" y="342519"/>
                  </a:lnTo>
                  <a:lnTo>
                    <a:pt x="2158365" y="342519"/>
                  </a:lnTo>
                  <a:lnTo>
                    <a:pt x="2158365" y="217932"/>
                  </a:lnTo>
                  <a:close/>
                </a:path>
                <a:path w="4364355" h="342900">
                  <a:moveTo>
                    <a:pt x="2216404" y="249174"/>
                  </a:moveTo>
                  <a:lnTo>
                    <a:pt x="2205990" y="249174"/>
                  </a:lnTo>
                  <a:lnTo>
                    <a:pt x="2205990" y="342519"/>
                  </a:lnTo>
                  <a:lnTo>
                    <a:pt x="2216404" y="342519"/>
                  </a:lnTo>
                  <a:lnTo>
                    <a:pt x="2216404" y="249174"/>
                  </a:lnTo>
                  <a:close/>
                </a:path>
                <a:path w="4364355" h="342900">
                  <a:moveTo>
                    <a:pt x="2274443" y="217932"/>
                  </a:moveTo>
                  <a:lnTo>
                    <a:pt x="2264029" y="217932"/>
                  </a:lnTo>
                  <a:lnTo>
                    <a:pt x="2264029" y="342519"/>
                  </a:lnTo>
                  <a:lnTo>
                    <a:pt x="2274443" y="342519"/>
                  </a:lnTo>
                  <a:lnTo>
                    <a:pt x="2274443" y="217932"/>
                  </a:lnTo>
                  <a:close/>
                </a:path>
                <a:path w="4364355" h="342900">
                  <a:moveTo>
                    <a:pt x="2332482" y="217932"/>
                  </a:moveTo>
                  <a:lnTo>
                    <a:pt x="2322068" y="217932"/>
                  </a:lnTo>
                  <a:lnTo>
                    <a:pt x="2322068" y="342519"/>
                  </a:lnTo>
                  <a:lnTo>
                    <a:pt x="2332482" y="342519"/>
                  </a:lnTo>
                  <a:lnTo>
                    <a:pt x="2332482" y="217932"/>
                  </a:lnTo>
                  <a:close/>
                </a:path>
                <a:path w="4364355" h="342900">
                  <a:moveTo>
                    <a:pt x="2390521" y="249174"/>
                  </a:moveTo>
                  <a:lnTo>
                    <a:pt x="2380107" y="249174"/>
                  </a:lnTo>
                  <a:lnTo>
                    <a:pt x="2380107" y="342519"/>
                  </a:lnTo>
                  <a:lnTo>
                    <a:pt x="2390521" y="342519"/>
                  </a:lnTo>
                  <a:lnTo>
                    <a:pt x="2390521" y="249174"/>
                  </a:lnTo>
                  <a:close/>
                </a:path>
                <a:path w="4364355" h="342900">
                  <a:moveTo>
                    <a:pt x="2448687" y="249174"/>
                  </a:moveTo>
                  <a:lnTo>
                    <a:pt x="2435606" y="249174"/>
                  </a:lnTo>
                  <a:lnTo>
                    <a:pt x="2435606" y="342519"/>
                  </a:lnTo>
                  <a:lnTo>
                    <a:pt x="2448687" y="342519"/>
                  </a:lnTo>
                  <a:lnTo>
                    <a:pt x="2448687" y="249174"/>
                  </a:lnTo>
                  <a:close/>
                </a:path>
                <a:path w="4364355" h="342900">
                  <a:moveTo>
                    <a:pt x="2506599" y="311404"/>
                  </a:moveTo>
                  <a:lnTo>
                    <a:pt x="2496185" y="311404"/>
                  </a:lnTo>
                  <a:lnTo>
                    <a:pt x="2496185" y="342519"/>
                  </a:lnTo>
                  <a:lnTo>
                    <a:pt x="2506599" y="342519"/>
                  </a:lnTo>
                  <a:lnTo>
                    <a:pt x="2506599" y="311404"/>
                  </a:lnTo>
                  <a:close/>
                </a:path>
                <a:path w="4364355" h="342900">
                  <a:moveTo>
                    <a:pt x="2564765" y="280289"/>
                  </a:moveTo>
                  <a:lnTo>
                    <a:pt x="2554351" y="280289"/>
                  </a:lnTo>
                  <a:lnTo>
                    <a:pt x="2554351" y="342519"/>
                  </a:lnTo>
                  <a:lnTo>
                    <a:pt x="2564765" y="342519"/>
                  </a:lnTo>
                  <a:lnTo>
                    <a:pt x="2564765" y="280289"/>
                  </a:lnTo>
                  <a:close/>
                </a:path>
                <a:path w="4364355" h="342900">
                  <a:moveTo>
                    <a:pt x="2622791" y="249174"/>
                  </a:moveTo>
                  <a:lnTo>
                    <a:pt x="2609723" y="249174"/>
                  </a:lnTo>
                  <a:lnTo>
                    <a:pt x="2609723" y="342519"/>
                  </a:lnTo>
                  <a:lnTo>
                    <a:pt x="2622791" y="342519"/>
                  </a:lnTo>
                  <a:lnTo>
                    <a:pt x="2622791" y="249174"/>
                  </a:lnTo>
                  <a:close/>
                </a:path>
                <a:path w="4364355" h="342900">
                  <a:moveTo>
                    <a:pt x="2680843" y="280289"/>
                  </a:moveTo>
                  <a:lnTo>
                    <a:pt x="2670429" y="280289"/>
                  </a:lnTo>
                  <a:lnTo>
                    <a:pt x="2670429" y="342519"/>
                  </a:lnTo>
                  <a:lnTo>
                    <a:pt x="2680843" y="342519"/>
                  </a:lnTo>
                  <a:lnTo>
                    <a:pt x="2680843" y="280289"/>
                  </a:lnTo>
                  <a:close/>
                </a:path>
                <a:path w="4364355" h="342900">
                  <a:moveTo>
                    <a:pt x="2738882" y="155702"/>
                  </a:moveTo>
                  <a:lnTo>
                    <a:pt x="2728468" y="155702"/>
                  </a:lnTo>
                  <a:lnTo>
                    <a:pt x="2728468" y="342519"/>
                  </a:lnTo>
                  <a:lnTo>
                    <a:pt x="2738882" y="342519"/>
                  </a:lnTo>
                  <a:lnTo>
                    <a:pt x="2738882" y="155702"/>
                  </a:lnTo>
                  <a:close/>
                </a:path>
                <a:path w="4364355" h="342900">
                  <a:moveTo>
                    <a:pt x="2796921" y="186817"/>
                  </a:moveTo>
                  <a:lnTo>
                    <a:pt x="2786507" y="186817"/>
                  </a:lnTo>
                  <a:lnTo>
                    <a:pt x="2786507" y="342519"/>
                  </a:lnTo>
                  <a:lnTo>
                    <a:pt x="2796921" y="342519"/>
                  </a:lnTo>
                  <a:lnTo>
                    <a:pt x="2796921" y="186817"/>
                  </a:lnTo>
                  <a:close/>
                </a:path>
                <a:path w="4364355" h="342900">
                  <a:moveTo>
                    <a:pt x="2855087" y="311404"/>
                  </a:moveTo>
                  <a:lnTo>
                    <a:pt x="2842006" y="311404"/>
                  </a:lnTo>
                  <a:lnTo>
                    <a:pt x="2842006" y="342519"/>
                  </a:lnTo>
                  <a:lnTo>
                    <a:pt x="2855087" y="342519"/>
                  </a:lnTo>
                  <a:lnTo>
                    <a:pt x="2855087" y="311404"/>
                  </a:lnTo>
                  <a:close/>
                </a:path>
                <a:path w="4364355" h="342900">
                  <a:moveTo>
                    <a:pt x="2912999" y="217932"/>
                  </a:moveTo>
                  <a:lnTo>
                    <a:pt x="2902585" y="217932"/>
                  </a:lnTo>
                  <a:lnTo>
                    <a:pt x="2902585" y="342519"/>
                  </a:lnTo>
                  <a:lnTo>
                    <a:pt x="2912999" y="342519"/>
                  </a:lnTo>
                  <a:lnTo>
                    <a:pt x="2912999" y="217932"/>
                  </a:lnTo>
                  <a:close/>
                </a:path>
                <a:path w="4364355" h="342900">
                  <a:moveTo>
                    <a:pt x="2971038" y="217932"/>
                  </a:moveTo>
                  <a:lnTo>
                    <a:pt x="2960624" y="217932"/>
                  </a:lnTo>
                  <a:lnTo>
                    <a:pt x="2960624" y="342519"/>
                  </a:lnTo>
                  <a:lnTo>
                    <a:pt x="2971038" y="342519"/>
                  </a:lnTo>
                  <a:lnTo>
                    <a:pt x="2971038" y="217932"/>
                  </a:lnTo>
                  <a:close/>
                </a:path>
                <a:path w="4364355" h="342900">
                  <a:moveTo>
                    <a:pt x="3029077" y="249174"/>
                  </a:moveTo>
                  <a:lnTo>
                    <a:pt x="3018663" y="249174"/>
                  </a:lnTo>
                  <a:lnTo>
                    <a:pt x="3018663" y="342519"/>
                  </a:lnTo>
                  <a:lnTo>
                    <a:pt x="3029077" y="342519"/>
                  </a:lnTo>
                  <a:lnTo>
                    <a:pt x="3029077" y="249174"/>
                  </a:lnTo>
                  <a:close/>
                </a:path>
                <a:path w="4364355" h="342900">
                  <a:moveTo>
                    <a:pt x="3087243" y="280289"/>
                  </a:moveTo>
                  <a:lnTo>
                    <a:pt x="3076829" y="280289"/>
                  </a:lnTo>
                  <a:lnTo>
                    <a:pt x="3076829" y="342519"/>
                  </a:lnTo>
                  <a:lnTo>
                    <a:pt x="3087243" y="342519"/>
                  </a:lnTo>
                  <a:lnTo>
                    <a:pt x="3087243" y="280289"/>
                  </a:lnTo>
                  <a:close/>
                </a:path>
                <a:path w="4364355" h="342900">
                  <a:moveTo>
                    <a:pt x="3145282" y="217932"/>
                  </a:moveTo>
                  <a:lnTo>
                    <a:pt x="3134868" y="217932"/>
                  </a:lnTo>
                  <a:lnTo>
                    <a:pt x="3134868" y="342519"/>
                  </a:lnTo>
                  <a:lnTo>
                    <a:pt x="3145282" y="342519"/>
                  </a:lnTo>
                  <a:lnTo>
                    <a:pt x="3145282" y="217932"/>
                  </a:lnTo>
                  <a:close/>
                </a:path>
                <a:path w="4364355" h="342900">
                  <a:moveTo>
                    <a:pt x="3203321" y="124587"/>
                  </a:moveTo>
                  <a:lnTo>
                    <a:pt x="3192907" y="124587"/>
                  </a:lnTo>
                  <a:lnTo>
                    <a:pt x="3192907" y="342519"/>
                  </a:lnTo>
                  <a:lnTo>
                    <a:pt x="3203321" y="342519"/>
                  </a:lnTo>
                  <a:lnTo>
                    <a:pt x="3203321" y="124587"/>
                  </a:lnTo>
                  <a:close/>
                </a:path>
                <a:path w="4364355" h="342900">
                  <a:moveTo>
                    <a:pt x="3261360" y="186817"/>
                  </a:moveTo>
                  <a:lnTo>
                    <a:pt x="3250946" y="186817"/>
                  </a:lnTo>
                  <a:lnTo>
                    <a:pt x="3250946" y="342519"/>
                  </a:lnTo>
                  <a:lnTo>
                    <a:pt x="3261360" y="342519"/>
                  </a:lnTo>
                  <a:lnTo>
                    <a:pt x="3261360" y="186817"/>
                  </a:lnTo>
                  <a:close/>
                </a:path>
                <a:path w="4364355" h="342900">
                  <a:moveTo>
                    <a:pt x="3319399" y="249174"/>
                  </a:moveTo>
                  <a:lnTo>
                    <a:pt x="3306318" y="249174"/>
                  </a:lnTo>
                  <a:lnTo>
                    <a:pt x="3306318" y="342519"/>
                  </a:lnTo>
                  <a:lnTo>
                    <a:pt x="3319399" y="342519"/>
                  </a:lnTo>
                  <a:lnTo>
                    <a:pt x="3319399" y="249174"/>
                  </a:lnTo>
                  <a:close/>
                </a:path>
                <a:path w="4364355" h="342900">
                  <a:moveTo>
                    <a:pt x="3377565" y="249174"/>
                  </a:moveTo>
                  <a:lnTo>
                    <a:pt x="3364484" y="249174"/>
                  </a:lnTo>
                  <a:lnTo>
                    <a:pt x="3364484" y="342519"/>
                  </a:lnTo>
                  <a:lnTo>
                    <a:pt x="3377565" y="342519"/>
                  </a:lnTo>
                  <a:lnTo>
                    <a:pt x="3377565" y="249174"/>
                  </a:lnTo>
                  <a:close/>
                </a:path>
                <a:path w="4364355" h="342900">
                  <a:moveTo>
                    <a:pt x="3435477" y="217932"/>
                  </a:moveTo>
                  <a:lnTo>
                    <a:pt x="3425063" y="217932"/>
                  </a:lnTo>
                  <a:lnTo>
                    <a:pt x="3425063" y="342519"/>
                  </a:lnTo>
                  <a:lnTo>
                    <a:pt x="3435477" y="342519"/>
                  </a:lnTo>
                  <a:lnTo>
                    <a:pt x="3435477" y="217932"/>
                  </a:lnTo>
                  <a:close/>
                </a:path>
                <a:path w="4364355" h="342900">
                  <a:moveTo>
                    <a:pt x="3493516" y="249174"/>
                  </a:moveTo>
                  <a:lnTo>
                    <a:pt x="3483102" y="249174"/>
                  </a:lnTo>
                  <a:lnTo>
                    <a:pt x="3483102" y="342519"/>
                  </a:lnTo>
                  <a:lnTo>
                    <a:pt x="3493516" y="342519"/>
                  </a:lnTo>
                  <a:lnTo>
                    <a:pt x="3493516" y="249174"/>
                  </a:lnTo>
                  <a:close/>
                </a:path>
                <a:path w="4364355" h="342900">
                  <a:moveTo>
                    <a:pt x="3551555" y="249174"/>
                  </a:moveTo>
                  <a:lnTo>
                    <a:pt x="3541141" y="249174"/>
                  </a:lnTo>
                  <a:lnTo>
                    <a:pt x="3541141" y="342519"/>
                  </a:lnTo>
                  <a:lnTo>
                    <a:pt x="3551555" y="342519"/>
                  </a:lnTo>
                  <a:lnTo>
                    <a:pt x="3551555" y="249174"/>
                  </a:lnTo>
                  <a:close/>
                </a:path>
                <a:path w="4364355" h="342900">
                  <a:moveTo>
                    <a:pt x="3609721" y="217932"/>
                  </a:moveTo>
                  <a:lnTo>
                    <a:pt x="3599307" y="217932"/>
                  </a:lnTo>
                  <a:lnTo>
                    <a:pt x="3599307" y="342519"/>
                  </a:lnTo>
                  <a:lnTo>
                    <a:pt x="3609721" y="342519"/>
                  </a:lnTo>
                  <a:lnTo>
                    <a:pt x="3609721" y="217932"/>
                  </a:lnTo>
                  <a:close/>
                </a:path>
                <a:path w="4364355" h="342900">
                  <a:moveTo>
                    <a:pt x="3667760" y="186817"/>
                  </a:moveTo>
                  <a:lnTo>
                    <a:pt x="3657346" y="186817"/>
                  </a:lnTo>
                  <a:lnTo>
                    <a:pt x="3657346" y="342519"/>
                  </a:lnTo>
                  <a:lnTo>
                    <a:pt x="3667760" y="342519"/>
                  </a:lnTo>
                  <a:lnTo>
                    <a:pt x="3667760" y="186817"/>
                  </a:lnTo>
                  <a:close/>
                </a:path>
                <a:path w="4364355" h="342900">
                  <a:moveTo>
                    <a:pt x="3725786" y="186817"/>
                  </a:moveTo>
                  <a:lnTo>
                    <a:pt x="3715372" y="186817"/>
                  </a:lnTo>
                  <a:lnTo>
                    <a:pt x="3715372" y="342519"/>
                  </a:lnTo>
                  <a:lnTo>
                    <a:pt x="3725786" y="342519"/>
                  </a:lnTo>
                  <a:lnTo>
                    <a:pt x="3725786" y="186817"/>
                  </a:lnTo>
                  <a:close/>
                </a:path>
                <a:path w="4364355" h="342900">
                  <a:moveTo>
                    <a:pt x="3783838" y="311404"/>
                  </a:moveTo>
                  <a:lnTo>
                    <a:pt x="3773424" y="311404"/>
                  </a:lnTo>
                  <a:lnTo>
                    <a:pt x="3773424" y="342519"/>
                  </a:lnTo>
                  <a:lnTo>
                    <a:pt x="3783838" y="342519"/>
                  </a:lnTo>
                  <a:lnTo>
                    <a:pt x="3783838" y="311404"/>
                  </a:lnTo>
                  <a:close/>
                </a:path>
                <a:path w="4364355" h="342900">
                  <a:moveTo>
                    <a:pt x="3841877" y="217932"/>
                  </a:moveTo>
                  <a:lnTo>
                    <a:pt x="3828796" y="217932"/>
                  </a:lnTo>
                  <a:lnTo>
                    <a:pt x="3828796" y="342519"/>
                  </a:lnTo>
                  <a:lnTo>
                    <a:pt x="3841877" y="342519"/>
                  </a:lnTo>
                  <a:lnTo>
                    <a:pt x="3841877" y="217932"/>
                  </a:lnTo>
                  <a:close/>
                </a:path>
                <a:path w="4364355" h="342900">
                  <a:moveTo>
                    <a:pt x="3899903" y="280289"/>
                  </a:moveTo>
                  <a:lnTo>
                    <a:pt x="3889502" y="280289"/>
                  </a:lnTo>
                  <a:lnTo>
                    <a:pt x="3889502" y="342519"/>
                  </a:lnTo>
                  <a:lnTo>
                    <a:pt x="3899903" y="342519"/>
                  </a:lnTo>
                  <a:lnTo>
                    <a:pt x="3899903" y="280289"/>
                  </a:lnTo>
                  <a:close/>
                </a:path>
                <a:path w="4364355" h="342900">
                  <a:moveTo>
                    <a:pt x="4074160" y="217932"/>
                  </a:moveTo>
                  <a:lnTo>
                    <a:pt x="4061079" y="217932"/>
                  </a:lnTo>
                  <a:lnTo>
                    <a:pt x="4061079" y="342519"/>
                  </a:lnTo>
                  <a:lnTo>
                    <a:pt x="4074160" y="342519"/>
                  </a:lnTo>
                  <a:lnTo>
                    <a:pt x="4074160" y="217932"/>
                  </a:lnTo>
                  <a:close/>
                </a:path>
                <a:path w="4364355" h="342900">
                  <a:moveTo>
                    <a:pt x="4132059" y="280289"/>
                  </a:moveTo>
                  <a:lnTo>
                    <a:pt x="4121658" y="280289"/>
                  </a:lnTo>
                  <a:lnTo>
                    <a:pt x="4121658" y="342519"/>
                  </a:lnTo>
                  <a:lnTo>
                    <a:pt x="4132059" y="342519"/>
                  </a:lnTo>
                  <a:lnTo>
                    <a:pt x="4132059" y="280289"/>
                  </a:lnTo>
                  <a:close/>
                </a:path>
                <a:path w="4364355" h="342900">
                  <a:moveTo>
                    <a:pt x="4190238" y="249174"/>
                  </a:moveTo>
                  <a:lnTo>
                    <a:pt x="4179824" y="249174"/>
                  </a:lnTo>
                  <a:lnTo>
                    <a:pt x="4179824" y="342519"/>
                  </a:lnTo>
                  <a:lnTo>
                    <a:pt x="4190238" y="342519"/>
                  </a:lnTo>
                  <a:lnTo>
                    <a:pt x="4190238" y="249174"/>
                  </a:lnTo>
                  <a:close/>
                </a:path>
                <a:path w="4364355" h="342900">
                  <a:moveTo>
                    <a:pt x="4364355" y="249174"/>
                  </a:moveTo>
                  <a:lnTo>
                    <a:pt x="4351274" y="249174"/>
                  </a:lnTo>
                  <a:lnTo>
                    <a:pt x="4351274" y="342519"/>
                  </a:lnTo>
                  <a:lnTo>
                    <a:pt x="4364355" y="342519"/>
                  </a:lnTo>
                  <a:lnTo>
                    <a:pt x="4364355" y="249174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9" name="object 129" descr=""/>
            <p:cNvSpPr/>
            <p:nvPr/>
          </p:nvSpPr>
          <p:spPr>
            <a:xfrm>
              <a:off x="13645134" y="8537829"/>
              <a:ext cx="1929130" cy="125095"/>
            </a:xfrm>
            <a:custGeom>
              <a:avLst/>
              <a:gdLst/>
              <a:ahLst/>
              <a:cxnLst/>
              <a:rect l="l" t="t" r="r" b="b"/>
              <a:pathLst>
                <a:path w="1929130" h="125095">
                  <a:moveTo>
                    <a:pt x="13081" y="31242"/>
                  </a:moveTo>
                  <a:lnTo>
                    <a:pt x="0" y="31242"/>
                  </a:lnTo>
                  <a:lnTo>
                    <a:pt x="0" y="124587"/>
                  </a:lnTo>
                  <a:lnTo>
                    <a:pt x="13081" y="124587"/>
                  </a:lnTo>
                  <a:lnTo>
                    <a:pt x="13081" y="31242"/>
                  </a:lnTo>
                  <a:close/>
                </a:path>
                <a:path w="1929130" h="125095">
                  <a:moveTo>
                    <a:pt x="71120" y="31242"/>
                  </a:moveTo>
                  <a:lnTo>
                    <a:pt x="58039" y="31242"/>
                  </a:lnTo>
                  <a:lnTo>
                    <a:pt x="58039" y="124587"/>
                  </a:lnTo>
                  <a:lnTo>
                    <a:pt x="71120" y="124587"/>
                  </a:lnTo>
                  <a:lnTo>
                    <a:pt x="71120" y="31242"/>
                  </a:lnTo>
                  <a:close/>
                </a:path>
                <a:path w="1929130" h="125095">
                  <a:moveTo>
                    <a:pt x="129286" y="93472"/>
                  </a:moveTo>
                  <a:lnTo>
                    <a:pt x="116205" y="93472"/>
                  </a:lnTo>
                  <a:lnTo>
                    <a:pt x="116205" y="124587"/>
                  </a:lnTo>
                  <a:lnTo>
                    <a:pt x="129286" y="124587"/>
                  </a:lnTo>
                  <a:lnTo>
                    <a:pt x="129286" y="93472"/>
                  </a:lnTo>
                  <a:close/>
                </a:path>
                <a:path w="1929130" h="125095">
                  <a:moveTo>
                    <a:pt x="245237" y="31242"/>
                  </a:moveTo>
                  <a:lnTo>
                    <a:pt x="234823" y="31242"/>
                  </a:lnTo>
                  <a:lnTo>
                    <a:pt x="234823" y="124587"/>
                  </a:lnTo>
                  <a:lnTo>
                    <a:pt x="245237" y="124587"/>
                  </a:lnTo>
                  <a:lnTo>
                    <a:pt x="245237" y="31242"/>
                  </a:lnTo>
                  <a:close/>
                </a:path>
                <a:path w="1929130" h="125095">
                  <a:moveTo>
                    <a:pt x="303276" y="93472"/>
                  </a:moveTo>
                  <a:lnTo>
                    <a:pt x="292862" y="93472"/>
                  </a:lnTo>
                  <a:lnTo>
                    <a:pt x="292862" y="124587"/>
                  </a:lnTo>
                  <a:lnTo>
                    <a:pt x="303276" y="124587"/>
                  </a:lnTo>
                  <a:lnTo>
                    <a:pt x="303276" y="93472"/>
                  </a:lnTo>
                  <a:close/>
                </a:path>
                <a:path w="1929130" h="125095">
                  <a:moveTo>
                    <a:pt x="361429" y="62357"/>
                  </a:moveTo>
                  <a:lnTo>
                    <a:pt x="351028" y="62357"/>
                  </a:lnTo>
                  <a:lnTo>
                    <a:pt x="351028" y="124587"/>
                  </a:lnTo>
                  <a:lnTo>
                    <a:pt x="361429" y="124587"/>
                  </a:lnTo>
                  <a:lnTo>
                    <a:pt x="361429" y="62357"/>
                  </a:lnTo>
                  <a:close/>
                </a:path>
                <a:path w="1929130" h="125095">
                  <a:moveTo>
                    <a:pt x="419481" y="31242"/>
                  </a:moveTo>
                  <a:lnTo>
                    <a:pt x="409067" y="31242"/>
                  </a:lnTo>
                  <a:lnTo>
                    <a:pt x="409067" y="124587"/>
                  </a:lnTo>
                  <a:lnTo>
                    <a:pt x="419481" y="124587"/>
                  </a:lnTo>
                  <a:lnTo>
                    <a:pt x="419481" y="31242"/>
                  </a:lnTo>
                  <a:close/>
                </a:path>
                <a:path w="1929130" h="125095">
                  <a:moveTo>
                    <a:pt x="477520" y="0"/>
                  </a:moveTo>
                  <a:lnTo>
                    <a:pt x="467106" y="0"/>
                  </a:lnTo>
                  <a:lnTo>
                    <a:pt x="467106" y="124587"/>
                  </a:lnTo>
                  <a:lnTo>
                    <a:pt x="477520" y="124587"/>
                  </a:lnTo>
                  <a:lnTo>
                    <a:pt x="477520" y="0"/>
                  </a:lnTo>
                  <a:close/>
                </a:path>
                <a:path w="1929130" h="125095">
                  <a:moveTo>
                    <a:pt x="535559" y="62357"/>
                  </a:moveTo>
                  <a:lnTo>
                    <a:pt x="525145" y="62357"/>
                  </a:lnTo>
                  <a:lnTo>
                    <a:pt x="525145" y="124587"/>
                  </a:lnTo>
                  <a:lnTo>
                    <a:pt x="535559" y="124587"/>
                  </a:lnTo>
                  <a:lnTo>
                    <a:pt x="535559" y="62357"/>
                  </a:lnTo>
                  <a:close/>
                </a:path>
                <a:path w="1929130" h="125095">
                  <a:moveTo>
                    <a:pt x="593585" y="62357"/>
                  </a:moveTo>
                  <a:lnTo>
                    <a:pt x="583184" y="62357"/>
                  </a:lnTo>
                  <a:lnTo>
                    <a:pt x="583184" y="124587"/>
                  </a:lnTo>
                  <a:lnTo>
                    <a:pt x="593585" y="124587"/>
                  </a:lnTo>
                  <a:lnTo>
                    <a:pt x="593585" y="62357"/>
                  </a:lnTo>
                  <a:close/>
                </a:path>
                <a:path w="1929130" h="125095">
                  <a:moveTo>
                    <a:pt x="651637" y="0"/>
                  </a:moveTo>
                  <a:lnTo>
                    <a:pt x="641223" y="0"/>
                  </a:lnTo>
                  <a:lnTo>
                    <a:pt x="641223" y="124587"/>
                  </a:lnTo>
                  <a:lnTo>
                    <a:pt x="651637" y="124587"/>
                  </a:lnTo>
                  <a:lnTo>
                    <a:pt x="651637" y="0"/>
                  </a:lnTo>
                  <a:close/>
                </a:path>
                <a:path w="1929130" h="125095">
                  <a:moveTo>
                    <a:pt x="767715" y="93472"/>
                  </a:moveTo>
                  <a:lnTo>
                    <a:pt x="750316" y="93472"/>
                  </a:lnTo>
                  <a:lnTo>
                    <a:pt x="750316" y="124587"/>
                  </a:lnTo>
                  <a:lnTo>
                    <a:pt x="767715" y="124587"/>
                  </a:lnTo>
                  <a:lnTo>
                    <a:pt x="767715" y="93472"/>
                  </a:lnTo>
                  <a:close/>
                </a:path>
                <a:path w="1929130" h="125095">
                  <a:moveTo>
                    <a:pt x="883920" y="62357"/>
                  </a:moveTo>
                  <a:lnTo>
                    <a:pt x="873506" y="62357"/>
                  </a:lnTo>
                  <a:lnTo>
                    <a:pt x="873506" y="124587"/>
                  </a:lnTo>
                  <a:lnTo>
                    <a:pt x="883920" y="124587"/>
                  </a:lnTo>
                  <a:lnTo>
                    <a:pt x="883920" y="62357"/>
                  </a:lnTo>
                  <a:close/>
                </a:path>
                <a:path w="1929130" h="125095">
                  <a:moveTo>
                    <a:pt x="941959" y="93472"/>
                  </a:moveTo>
                  <a:lnTo>
                    <a:pt x="931545" y="93472"/>
                  </a:lnTo>
                  <a:lnTo>
                    <a:pt x="931545" y="124587"/>
                  </a:lnTo>
                  <a:lnTo>
                    <a:pt x="941959" y="124587"/>
                  </a:lnTo>
                  <a:lnTo>
                    <a:pt x="941959" y="93472"/>
                  </a:lnTo>
                  <a:close/>
                </a:path>
                <a:path w="1929130" h="125095">
                  <a:moveTo>
                    <a:pt x="1058037" y="93472"/>
                  </a:moveTo>
                  <a:lnTo>
                    <a:pt x="1044956" y="93472"/>
                  </a:lnTo>
                  <a:lnTo>
                    <a:pt x="1044956" y="124587"/>
                  </a:lnTo>
                  <a:lnTo>
                    <a:pt x="1058037" y="124587"/>
                  </a:lnTo>
                  <a:lnTo>
                    <a:pt x="1058037" y="93472"/>
                  </a:lnTo>
                  <a:close/>
                </a:path>
                <a:path w="1929130" h="125095">
                  <a:moveTo>
                    <a:pt x="1116076" y="93472"/>
                  </a:moveTo>
                  <a:lnTo>
                    <a:pt x="1105662" y="93472"/>
                  </a:lnTo>
                  <a:lnTo>
                    <a:pt x="1105662" y="124587"/>
                  </a:lnTo>
                  <a:lnTo>
                    <a:pt x="1116076" y="124587"/>
                  </a:lnTo>
                  <a:lnTo>
                    <a:pt x="1116076" y="93472"/>
                  </a:lnTo>
                  <a:close/>
                </a:path>
                <a:path w="1929130" h="125095">
                  <a:moveTo>
                    <a:pt x="1232141" y="62357"/>
                  </a:moveTo>
                  <a:lnTo>
                    <a:pt x="1221740" y="62357"/>
                  </a:lnTo>
                  <a:lnTo>
                    <a:pt x="1221740" y="124587"/>
                  </a:lnTo>
                  <a:lnTo>
                    <a:pt x="1232141" y="124587"/>
                  </a:lnTo>
                  <a:lnTo>
                    <a:pt x="1232141" y="62357"/>
                  </a:lnTo>
                  <a:close/>
                </a:path>
                <a:path w="1929130" h="125095">
                  <a:moveTo>
                    <a:pt x="1870697" y="93472"/>
                  </a:moveTo>
                  <a:lnTo>
                    <a:pt x="1853311" y="93472"/>
                  </a:lnTo>
                  <a:lnTo>
                    <a:pt x="1853311" y="124587"/>
                  </a:lnTo>
                  <a:lnTo>
                    <a:pt x="1870697" y="124587"/>
                  </a:lnTo>
                  <a:lnTo>
                    <a:pt x="1870697" y="93472"/>
                  </a:lnTo>
                  <a:close/>
                </a:path>
                <a:path w="1929130" h="125095">
                  <a:moveTo>
                    <a:pt x="1928876" y="93472"/>
                  </a:moveTo>
                  <a:lnTo>
                    <a:pt x="1911477" y="93472"/>
                  </a:lnTo>
                  <a:lnTo>
                    <a:pt x="1911477" y="124587"/>
                  </a:lnTo>
                  <a:lnTo>
                    <a:pt x="1928876" y="124587"/>
                  </a:lnTo>
                  <a:lnTo>
                    <a:pt x="1928876" y="93472"/>
                  </a:lnTo>
                  <a:close/>
                </a:path>
              </a:pathLst>
            </a:custGeom>
            <a:solidFill>
              <a:srgbClr val="BCA7E8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130" name="object 130" descr=""/>
          <p:cNvSpPr txBox="1"/>
          <p:nvPr/>
        </p:nvSpPr>
        <p:spPr>
          <a:xfrm>
            <a:off x="286258" y="8576436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31" name="object 131" descr=""/>
          <p:cNvSpPr txBox="1"/>
          <p:nvPr/>
        </p:nvSpPr>
        <p:spPr>
          <a:xfrm>
            <a:off x="260858" y="8483092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82">
                <a:solidFill>
                  <a:srgbClr val="4D4D4D"/>
                </a:solidFill>
                <a:latin typeface="Arial"/>
                <a:cs typeface="Arial"/>
              </a:rPr>
              <a:t>1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32" name="object 132" descr=""/>
          <p:cNvSpPr txBox="1"/>
          <p:nvPr/>
        </p:nvSpPr>
        <p:spPr>
          <a:xfrm>
            <a:off x="260858" y="8389746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baseline="-30864" sz="1350" spc="-82">
                <a:solidFill>
                  <a:srgbClr val="4D4D4D"/>
                </a:solidFill>
                <a:latin typeface="Arial"/>
                <a:cs typeface="Arial"/>
              </a:rPr>
              <a:t>4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33" name="object 133" descr=""/>
          <p:cNvSpPr txBox="1"/>
          <p:nvPr/>
        </p:nvSpPr>
        <p:spPr>
          <a:xfrm>
            <a:off x="260858" y="8296275"/>
            <a:ext cx="1403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60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baseline="-15432" sz="1350" spc="-839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30864" sz="1350" spc="-82">
                <a:solidFill>
                  <a:srgbClr val="4D4D4D"/>
                </a:solidFill>
                <a:latin typeface="Arial"/>
                <a:cs typeface="Arial"/>
              </a:rPr>
              <a:t>7</a:t>
            </a:r>
            <a:endParaRPr baseline="-30864" sz="1350">
              <a:latin typeface="Arial"/>
              <a:cs typeface="Arial"/>
            </a:endParaRPr>
          </a:p>
        </p:txBody>
      </p:sp>
      <p:sp>
        <p:nvSpPr>
          <p:cNvPr id="134" name="object 134" descr=""/>
          <p:cNvSpPr txBox="1"/>
          <p:nvPr/>
        </p:nvSpPr>
        <p:spPr>
          <a:xfrm>
            <a:off x="197357" y="8202930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0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1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35" name="object 135" descr=""/>
          <p:cNvSpPr txBox="1"/>
          <p:nvPr/>
        </p:nvSpPr>
        <p:spPr>
          <a:xfrm>
            <a:off x="197357" y="810945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4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36" name="object 136" descr=""/>
          <p:cNvSpPr txBox="1"/>
          <p:nvPr/>
        </p:nvSpPr>
        <p:spPr>
          <a:xfrm>
            <a:off x="197357" y="8016113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7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37" name="object 137" descr=""/>
          <p:cNvSpPr txBox="1"/>
          <p:nvPr/>
        </p:nvSpPr>
        <p:spPr>
          <a:xfrm>
            <a:off x="197357" y="7922641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44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38" name="object 138" descr=""/>
          <p:cNvSpPr txBox="1"/>
          <p:nvPr/>
        </p:nvSpPr>
        <p:spPr>
          <a:xfrm>
            <a:off x="197357" y="7829295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3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39" name="object 139" descr=""/>
          <p:cNvSpPr txBox="1"/>
          <p:nvPr/>
        </p:nvSpPr>
        <p:spPr>
          <a:xfrm>
            <a:off x="197357" y="7735823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5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7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6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0" name="object 140" descr=""/>
          <p:cNvSpPr txBox="1"/>
          <p:nvPr/>
        </p:nvSpPr>
        <p:spPr>
          <a:xfrm>
            <a:off x="197357" y="7642479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0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8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9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1" name="object 141" descr=""/>
          <p:cNvSpPr txBox="1"/>
          <p:nvPr/>
        </p:nvSpPr>
        <p:spPr>
          <a:xfrm>
            <a:off x="197357" y="754900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2" name="object 142" descr=""/>
          <p:cNvSpPr txBox="1"/>
          <p:nvPr/>
        </p:nvSpPr>
        <p:spPr>
          <a:xfrm>
            <a:off x="197357" y="7455661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6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5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3" name="object 143" descr=""/>
          <p:cNvSpPr txBox="1"/>
          <p:nvPr/>
        </p:nvSpPr>
        <p:spPr>
          <a:xfrm>
            <a:off x="197357" y="7362317"/>
            <a:ext cx="2038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7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9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8</a:t>
            </a:r>
            <a:endParaRPr baseline="-15432" sz="1350">
              <a:latin typeface="Arial"/>
              <a:cs typeface="Arial"/>
            </a:endParaRPr>
          </a:p>
        </p:txBody>
      </p:sp>
      <p:sp>
        <p:nvSpPr>
          <p:cNvPr id="144" name="object 144" descr=""/>
          <p:cNvSpPr txBox="1"/>
          <p:nvPr/>
        </p:nvSpPr>
        <p:spPr>
          <a:xfrm>
            <a:off x="1106297" y="8756395"/>
            <a:ext cx="89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5" name="object 145" descr=""/>
          <p:cNvSpPr txBox="1"/>
          <p:nvPr/>
        </p:nvSpPr>
        <p:spPr>
          <a:xfrm>
            <a:off x="3977132" y="8756395"/>
            <a:ext cx="1530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6" name="object 146" descr=""/>
          <p:cNvSpPr txBox="1"/>
          <p:nvPr/>
        </p:nvSpPr>
        <p:spPr>
          <a:xfrm>
            <a:off x="6848093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7" name="object 147" descr=""/>
          <p:cNvSpPr txBox="1"/>
          <p:nvPr/>
        </p:nvSpPr>
        <p:spPr>
          <a:xfrm>
            <a:off x="9750679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1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8" name="object 148" descr=""/>
          <p:cNvSpPr txBox="1"/>
          <p:nvPr/>
        </p:nvSpPr>
        <p:spPr>
          <a:xfrm>
            <a:off x="12653264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00</a:t>
            </a:r>
            <a:endParaRPr sz="900">
              <a:latin typeface="Arial"/>
              <a:cs typeface="Arial"/>
            </a:endParaRPr>
          </a:p>
        </p:txBody>
      </p:sp>
      <p:sp>
        <p:nvSpPr>
          <p:cNvPr id="149" name="object 149" descr=""/>
          <p:cNvSpPr txBox="1"/>
          <p:nvPr/>
        </p:nvSpPr>
        <p:spPr>
          <a:xfrm>
            <a:off x="15555976" y="8756395"/>
            <a:ext cx="216535" cy="1625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250</a:t>
            </a:r>
            <a:endParaRPr sz="900">
              <a:latin typeface="Arial"/>
              <a:cs typeface="Arial"/>
            </a:endParaRPr>
          </a:p>
        </p:txBody>
      </p:sp>
      <p:sp>
        <p:nvSpPr>
          <p:cNvPr id="150" name="object 150" descr=""/>
          <p:cNvSpPr txBox="1"/>
          <p:nvPr/>
        </p:nvSpPr>
        <p:spPr>
          <a:xfrm>
            <a:off x="8239506" y="8891269"/>
            <a:ext cx="335915" cy="19304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100" spc="-20">
                <a:latin typeface="Arial"/>
                <a:cs typeface="Arial"/>
              </a:rPr>
              <a:t>Time</a:t>
            </a:r>
            <a:endParaRPr sz="1100">
              <a:latin typeface="Arial"/>
              <a:cs typeface="Arial"/>
            </a:endParaRPr>
          </a:p>
        </p:txBody>
      </p:sp>
      <p:sp>
        <p:nvSpPr>
          <p:cNvPr id="151" name="object 151" descr=""/>
          <p:cNvSpPr txBox="1"/>
          <p:nvPr/>
        </p:nvSpPr>
        <p:spPr>
          <a:xfrm>
            <a:off x="30759" y="7618984"/>
            <a:ext cx="181610" cy="56134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315"/>
              </a:lnSpc>
            </a:pPr>
            <a:r>
              <a:rPr dirty="0" sz="1100" spc="-10">
                <a:latin typeface="Arial"/>
                <a:cs typeface="Arial"/>
              </a:rPr>
              <a:t>n.censor</a:t>
            </a:r>
            <a:endParaRPr sz="1100">
              <a:latin typeface="Arial"/>
              <a:cs typeface="Arial"/>
            </a:endParaRPr>
          </a:p>
        </p:txBody>
      </p:sp>
      <p:sp>
        <p:nvSpPr>
          <p:cNvPr id="152" name="object 152" descr=""/>
          <p:cNvSpPr txBox="1"/>
          <p:nvPr/>
        </p:nvSpPr>
        <p:spPr>
          <a:xfrm>
            <a:off x="184657" y="6667147"/>
            <a:ext cx="1801495" cy="733425"/>
          </a:xfrm>
          <a:prstGeom prst="rect">
            <a:avLst/>
          </a:prstGeom>
        </p:spPr>
        <p:txBody>
          <a:bodyPr wrap="square" lIns="0" tIns="121920" rIns="0" bIns="0" rtlCol="0" vert="horz">
            <a:spAutoFit/>
          </a:bodyPr>
          <a:lstStyle/>
          <a:p>
            <a:pPr marL="240029">
              <a:lnSpc>
                <a:spcPct val="100000"/>
              </a:lnSpc>
              <a:spcBef>
                <a:spcPts val="960"/>
              </a:spcBef>
            </a:pPr>
            <a:r>
              <a:rPr dirty="0" sz="1300">
                <a:latin typeface="Arial"/>
                <a:cs typeface="Arial"/>
              </a:rPr>
              <a:t>Number of </a:t>
            </a:r>
            <a:r>
              <a:rPr dirty="0" sz="1300" spc="-10">
                <a:latin typeface="Arial"/>
                <a:cs typeface="Arial"/>
              </a:rPr>
              <a:t>censoring</a:t>
            </a:r>
            <a:endParaRPr sz="1300">
              <a:latin typeface="Arial"/>
              <a:cs typeface="Arial"/>
            </a:endParaRPr>
          </a:p>
          <a:p>
            <a:pPr marL="50800">
              <a:lnSpc>
                <a:spcPct val="100000"/>
              </a:lnSpc>
              <a:spcBef>
                <a:spcPts val="600"/>
              </a:spcBef>
            </a:pPr>
            <a:r>
              <a:rPr dirty="0" sz="900" spc="-25">
                <a:solidFill>
                  <a:srgbClr val="4D4D4D"/>
                </a:solidFill>
                <a:latin typeface="Arial"/>
                <a:cs typeface="Arial"/>
              </a:rPr>
              <a:t>49</a:t>
            </a:r>
            <a:endParaRPr sz="900">
              <a:latin typeface="Arial"/>
              <a:cs typeface="Arial"/>
            </a:endParaRPr>
          </a:p>
          <a:p>
            <a:pPr marL="50800">
              <a:lnSpc>
                <a:spcPct val="100000"/>
              </a:lnSpc>
              <a:spcBef>
                <a:spcPts val="390"/>
              </a:spcBef>
            </a:pPr>
            <a:r>
              <a:rPr dirty="0" sz="900" spc="-30">
                <a:solidFill>
                  <a:srgbClr val="4D4D4D"/>
                </a:solidFill>
                <a:latin typeface="Arial"/>
                <a:cs typeface="Arial"/>
              </a:rPr>
              <a:t>4</a:t>
            </a:r>
            <a:r>
              <a:rPr dirty="0" baseline="-30864" sz="1350" spc="-802">
                <a:solidFill>
                  <a:srgbClr val="4D4D4D"/>
                </a:solidFill>
                <a:latin typeface="Arial"/>
                <a:cs typeface="Arial"/>
              </a:rPr>
              <a:t>1</a:t>
            </a:r>
            <a:r>
              <a:rPr dirty="0" sz="900" spc="-535">
                <a:solidFill>
                  <a:srgbClr val="4D4D4D"/>
                </a:solidFill>
                <a:latin typeface="Arial"/>
                <a:cs typeface="Arial"/>
              </a:rPr>
              <a:t>3</a:t>
            </a:r>
            <a:r>
              <a:rPr dirty="0" baseline="-15432" sz="1350" spc="-44">
                <a:solidFill>
                  <a:srgbClr val="4D4D4D"/>
                </a:solidFill>
                <a:latin typeface="Arial"/>
                <a:cs typeface="Arial"/>
              </a:rPr>
              <a:t>2</a:t>
            </a:r>
            <a:endParaRPr baseline="-15432" sz="135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 Graphics Output</dc:title>
  <dcterms:created xsi:type="dcterms:W3CDTF">2025-11-12T03:35:02Z</dcterms:created>
  <dcterms:modified xsi:type="dcterms:W3CDTF">2025-11-12T03:35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8-12T00:00:00Z</vt:filetime>
  </property>
  <property fmtid="{D5CDD505-2E9C-101B-9397-08002B2CF9AE}" pid="3" name="Creator">
    <vt:lpwstr>R</vt:lpwstr>
  </property>
  <property fmtid="{D5CDD505-2E9C-101B-9397-08002B2CF9AE}" pid="4" name="LastSaved">
    <vt:filetime>2025-11-12T00:00:00Z</vt:filetime>
  </property>
  <property fmtid="{D5CDD505-2E9C-101B-9397-08002B2CF9AE}" pid="5" name="Producer">
    <vt:lpwstr>R 4.5.0</vt:lpwstr>
  </property>
</Properties>
</file>